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150"/>
    <p:restoredTop sz="94648"/>
  </p:normalViewPr>
  <p:slideViewPr>
    <p:cSldViewPr snapToGrid="0" snapToObjects="1">
      <p:cViewPr varScale="1">
        <p:scale>
          <a:sx n="84" d="100"/>
          <a:sy n="84" d="100"/>
        </p:scale>
        <p:origin x="3200" y="1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cholas Skiados" clId="Web-{FCCDC3E0-5678-4F40-A2D6-0EB089DB3C91}"/>
    <pc:docChg chg="addSld delSld modSld">
      <pc:chgData name="Nicholas Skiados" userId="" providerId="" clId="Web-{FCCDC3E0-5678-4F40-A2D6-0EB089DB3C91}" dt="2021-06-17T03:58:11.852" v="458" actId="1076"/>
      <pc:docMkLst>
        <pc:docMk/>
      </pc:docMkLst>
      <pc:sldChg chg="modSp">
        <pc:chgData name="Nicholas Skiados" userId="" providerId="" clId="Web-{FCCDC3E0-5678-4F40-A2D6-0EB089DB3C91}" dt="2021-06-17T03:53:05.281" v="409" actId="20577"/>
        <pc:sldMkLst>
          <pc:docMk/>
          <pc:sldMk cId="1997077850" sldId="279"/>
        </pc:sldMkLst>
        <pc:spChg chg="mod">
          <ac:chgData name="Nicholas Skiados" userId="" providerId="" clId="Web-{FCCDC3E0-5678-4F40-A2D6-0EB089DB3C91}" dt="2021-06-17T03:53:05.281" v="409" actId="20577"/>
          <ac:spMkLst>
            <pc:docMk/>
            <pc:sldMk cId="1997077850" sldId="279"/>
            <ac:spMk id="120" creationId="{BED92353-28E4-4643-90D3-4560DD628D3F}"/>
          </ac:spMkLst>
        </pc:spChg>
      </pc:sldChg>
      <pc:sldChg chg="addSp delSp modSp new del">
        <pc:chgData name="Nicholas Skiados" userId="" providerId="" clId="Web-{FCCDC3E0-5678-4F40-A2D6-0EB089DB3C91}" dt="2021-06-17T03:24:22.638" v="103"/>
        <pc:sldMkLst>
          <pc:docMk/>
          <pc:sldMk cId="1576788558" sldId="291"/>
        </pc:sldMkLst>
        <pc:spChg chg="del">
          <ac:chgData name="Nicholas Skiados" userId="" providerId="" clId="Web-{FCCDC3E0-5678-4F40-A2D6-0EB089DB3C91}" dt="2021-06-17T03:13:30.630" v="1"/>
          <ac:spMkLst>
            <pc:docMk/>
            <pc:sldMk cId="1576788558" sldId="291"/>
            <ac:spMk id="2" creationId="{9DB8D4AF-DB1E-4308-B919-5B9F89D5D42C}"/>
          </ac:spMkLst>
        </pc:spChg>
        <pc:spChg chg="del">
          <ac:chgData name="Nicholas Skiados" userId="" providerId="" clId="Web-{FCCDC3E0-5678-4F40-A2D6-0EB089DB3C91}" dt="2021-06-17T03:13:40.224" v="2"/>
          <ac:spMkLst>
            <pc:docMk/>
            <pc:sldMk cId="1576788558" sldId="291"/>
            <ac:spMk id="3" creationId="{D79B8341-0CF4-48BC-BF2A-FB29DDFB4DF3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4" creationId="{70BB5739-E3D8-4C7A-965E-C0BD60C81E79}"/>
          </ac:spMkLst>
        </pc:spChg>
        <pc:spChg chg="add mod">
          <ac:chgData name="Nicholas Skiados" userId="" providerId="" clId="Web-{FCCDC3E0-5678-4F40-A2D6-0EB089DB3C91}" dt="2021-06-17T03:22:06.806" v="83" actId="1076"/>
          <ac:spMkLst>
            <pc:docMk/>
            <pc:sldMk cId="1576788558" sldId="291"/>
            <ac:spMk id="5" creationId="{3B134AC1-1B3D-4C0F-88AB-EB53502773A6}"/>
          </ac:spMkLst>
        </pc:spChg>
        <pc:spChg chg="add mod">
          <ac:chgData name="Nicholas Skiados" userId="" providerId="" clId="Web-{FCCDC3E0-5678-4F40-A2D6-0EB089DB3C91}" dt="2021-06-17T03:22:42.542" v="89" actId="1076"/>
          <ac:spMkLst>
            <pc:docMk/>
            <pc:sldMk cId="1576788558" sldId="291"/>
            <ac:spMk id="7" creationId="{FED8F2E5-BFC3-4DA6-A852-FB60A86D99E3}"/>
          </ac:spMkLst>
        </pc:spChg>
        <pc:spChg chg="add mod">
          <ac:chgData name="Nicholas Skiados" userId="" providerId="" clId="Web-{FCCDC3E0-5678-4F40-A2D6-0EB089DB3C91}" dt="2021-06-17T03:23:09.808" v="94" actId="1076"/>
          <ac:spMkLst>
            <pc:docMk/>
            <pc:sldMk cId="1576788558" sldId="291"/>
            <ac:spMk id="9" creationId="{E14B676D-34E4-4C8F-AD89-1084A02AE1CB}"/>
          </ac:spMkLst>
        </pc:spChg>
        <pc:spChg chg="add mod">
          <ac:chgData name="Nicholas Skiados" userId="" providerId="" clId="Web-{FCCDC3E0-5678-4F40-A2D6-0EB089DB3C91}" dt="2021-06-17T03:23:26.324" v="97" actId="1076"/>
          <ac:spMkLst>
            <pc:docMk/>
            <pc:sldMk cId="1576788558" sldId="291"/>
            <ac:spMk id="10" creationId="{EE40515E-B158-4A4A-8A3C-EFB925B67258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16" creationId="{BED3AACC-89BD-4DF5-9DBD-6BBE626CDD2C}"/>
          </ac:spMkLst>
        </pc:spChg>
        <pc:spChg chg="add mod">
          <ac:chgData name="Nicholas Skiados" userId="" providerId="" clId="Web-{FCCDC3E0-5678-4F40-A2D6-0EB089DB3C91}" dt="2021-06-17T03:18:01.856" v="46" actId="688"/>
          <ac:spMkLst>
            <pc:docMk/>
            <pc:sldMk cId="1576788558" sldId="291"/>
            <ac:spMk id="17" creationId="{219A400A-CA5C-49AF-A05C-2B27519A3889}"/>
          </ac:spMkLst>
        </pc:spChg>
        <pc:spChg chg="add mod">
          <ac:chgData name="Nicholas Skiados" userId="" providerId="" clId="Web-{FCCDC3E0-5678-4F40-A2D6-0EB089DB3C91}" dt="2021-06-17T03:22:28.651" v="86" actId="1076"/>
          <ac:spMkLst>
            <pc:docMk/>
            <pc:sldMk cId="1576788558" sldId="291"/>
            <ac:spMk id="20" creationId="{C53C3884-51BB-43E9-8EE2-B0D9E9D04E02}"/>
          </ac:spMkLst>
        </pc:spChg>
        <pc:spChg chg="add mod">
          <ac:chgData name="Nicholas Skiados" userId="" providerId="" clId="Web-{FCCDC3E0-5678-4F40-A2D6-0EB089DB3C91}" dt="2021-06-17T03:22:56.761" v="92" actId="1076"/>
          <ac:spMkLst>
            <pc:docMk/>
            <pc:sldMk cId="1576788558" sldId="291"/>
            <ac:spMk id="21" creationId="{35A18532-E487-4C1F-9FE6-F969BA6C2C73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4" creationId="{096A2636-9FD2-4C3B-8D25-9CAAC4AA2E94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5" creationId="{352338D5-D0F0-4B8E-8214-1316DFA00D6F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6" creationId="{B559BD79-BCF6-456A-82D3-F2FBB163BD61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7" creationId="{416EA103-F42A-4D18-929C-3B5563D02A4C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28" creationId="{A96D5001-692E-4A14-905D-689FA194360F}"/>
          </ac:spMkLst>
        </pc:spChg>
        <pc:spChg chg="add mod">
          <ac:chgData name="Nicholas Skiados" userId="" providerId="" clId="Web-{FCCDC3E0-5678-4F40-A2D6-0EB089DB3C91}" dt="2021-06-17T03:23:14.699" v="95" actId="688"/>
          <ac:spMkLst>
            <pc:docMk/>
            <pc:sldMk cId="1576788558" sldId="291"/>
            <ac:spMk id="29" creationId="{34F0327C-4119-4453-B980-9D65F263EBD8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0" creationId="{6478726D-9B06-4A4F-91D6-783BD3390C71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1" creationId="{B66C2641-A7BE-4048-9171-C2D171C942BD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4" creationId="{0FE2931C-53AA-4AE6-A944-C753E05EE9B4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5" creationId="{CE92AC8F-7E95-4127-8B26-DEA6B4F24701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8" creationId="{9F13A5F6-5DD4-4A71-B102-482081056B54}"/>
          </ac:spMkLst>
        </pc:spChg>
        <pc:spChg chg="add">
          <ac:chgData name="Nicholas Skiados" userId="" providerId="" clId="Web-{FCCDC3E0-5678-4F40-A2D6-0EB089DB3C91}" dt="2021-06-17T03:14:02.974" v="3"/>
          <ac:spMkLst>
            <pc:docMk/>
            <pc:sldMk cId="1576788558" sldId="291"/>
            <ac:spMk id="39" creationId="{4E0EBEF9-16CD-441C-8344-1825D94FC6F2}"/>
          </ac:spMkLst>
        </pc:spChg>
        <pc:spChg chg="add del">
          <ac:chgData name="Nicholas Skiados" userId="" providerId="" clId="Web-{FCCDC3E0-5678-4F40-A2D6-0EB089DB3C91}" dt="2021-06-17T03:19:27.146" v="61"/>
          <ac:spMkLst>
            <pc:docMk/>
            <pc:sldMk cId="1576788558" sldId="291"/>
            <ac:spMk id="40" creationId="{70BB5739-E3D8-4C7A-965E-C0BD60C81E79}"/>
          </ac:spMkLst>
        </pc:spChg>
        <pc:spChg chg="add del">
          <ac:chgData name="Nicholas Skiados" userId="" providerId="" clId="Web-{FCCDC3E0-5678-4F40-A2D6-0EB089DB3C91}" dt="2021-06-17T03:20:12.319" v="64"/>
          <ac:spMkLst>
            <pc:docMk/>
            <pc:sldMk cId="1576788558" sldId="291"/>
            <ac:spMk id="41" creationId="{3B134AC1-1B3D-4C0F-88AB-EB53502773A6}"/>
          </ac:spMkLst>
        </pc:spChg>
        <pc:spChg chg="add del">
          <ac:chgData name="Nicholas Skiados" userId="" providerId="" clId="Web-{FCCDC3E0-5678-4F40-A2D6-0EB089DB3C91}" dt="2021-06-17T03:20:30.491" v="67"/>
          <ac:spMkLst>
            <pc:docMk/>
            <pc:sldMk cId="1576788558" sldId="291"/>
            <ac:spMk id="43" creationId="{FED8F2E5-BFC3-4DA6-A852-FB60A86D99E3}"/>
          </ac:spMkLst>
        </pc:spChg>
        <pc:spChg chg="add del">
          <ac:chgData name="Nicholas Skiados" userId="" providerId="" clId="Web-{FCCDC3E0-5678-4F40-A2D6-0EB089DB3C91}" dt="2021-06-17T03:20:59.758" v="71"/>
          <ac:spMkLst>
            <pc:docMk/>
            <pc:sldMk cId="1576788558" sldId="291"/>
            <ac:spMk id="45" creationId="{E14B676D-34E4-4C8F-AD89-1084A02AE1CB}"/>
          </ac:spMkLst>
        </pc:spChg>
        <pc:spChg chg="add del">
          <ac:chgData name="Nicholas Skiados" userId="" providerId="" clId="Web-{FCCDC3E0-5678-4F40-A2D6-0EB089DB3C91}" dt="2021-06-17T03:20:55.258" v="70"/>
          <ac:spMkLst>
            <pc:docMk/>
            <pc:sldMk cId="1576788558" sldId="291"/>
            <ac:spMk id="46" creationId="{EE40515E-B158-4A4A-8A3C-EFB925B67258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2" creationId="{BED3AACC-89BD-4DF5-9DBD-6BBE626CDD2C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3" creationId="{219A400A-CA5C-49AF-A05C-2B27519A3889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6" creationId="{C53C3884-51BB-43E9-8EE2-B0D9E9D04E02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57" creationId="{35A18532-E487-4C1F-9FE6-F969BA6C2C73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0" creationId="{096A2636-9FD2-4C3B-8D25-9CAAC4AA2E94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1" creationId="{352338D5-D0F0-4B8E-8214-1316DFA00D6F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2" creationId="{B559BD79-BCF6-456A-82D3-F2FBB163BD61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3" creationId="{416EA103-F42A-4D18-929C-3B5563D02A4C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4" creationId="{A96D5001-692E-4A14-905D-689FA194360F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65" creationId="{34F0327C-4119-4453-B980-9D65F263EBD8}"/>
          </ac:spMkLst>
        </pc:spChg>
        <pc:spChg chg="add del mod topLvl">
          <ac:chgData name="Nicholas Skiados" userId="" providerId="" clId="Web-{FCCDC3E0-5678-4F40-A2D6-0EB089DB3C91}" dt="2021-06-17T03:19:22.380" v="60" actId="20577"/>
          <ac:spMkLst>
            <pc:docMk/>
            <pc:sldMk cId="1576788558" sldId="291"/>
            <ac:spMk id="66" creationId="{6478726D-9B06-4A4F-91D6-783BD3390C71}"/>
          </ac:spMkLst>
        </pc:spChg>
        <pc:spChg chg="add del topLvl">
          <ac:chgData name="Nicholas Skiados" userId="" providerId="" clId="Web-{FCCDC3E0-5678-4F40-A2D6-0EB089DB3C91}" dt="2021-06-17T03:19:19.099" v="58"/>
          <ac:spMkLst>
            <pc:docMk/>
            <pc:sldMk cId="1576788558" sldId="291"/>
            <ac:spMk id="67" creationId="{B66C2641-A7BE-4048-9171-C2D171C942BD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0" creationId="{0FE2931C-53AA-4AE6-A944-C753E05EE9B4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1" creationId="{CE92AC8F-7E95-4127-8B26-DEA6B4F24701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4" creationId="{9F13A5F6-5DD4-4A71-B102-482081056B54}"/>
          </ac:spMkLst>
        </pc:spChg>
        <pc:spChg chg="add">
          <ac:chgData name="Nicholas Skiados" userId="" providerId="" clId="Web-{FCCDC3E0-5678-4F40-A2D6-0EB089DB3C91}" dt="2021-06-17T03:16:37.166" v="23"/>
          <ac:spMkLst>
            <pc:docMk/>
            <pc:sldMk cId="1576788558" sldId="291"/>
            <ac:spMk id="75" creationId="{4E0EBEF9-16CD-441C-8344-1825D94FC6F2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76" creationId="{70BB5739-E3D8-4C7A-965E-C0BD60C81E79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77" creationId="{3B134AC1-1B3D-4C0F-88AB-EB53502773A6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79" creationId="{FED8F2E5-BFC3-4DA6-A852-FB60A86D99E3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1" creationId="{E14B676D-34E4-4C8F-AD89-1084A02AE1CB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2" creationId="{EE40515E-B158-4A4A-8A3C-EFB925B67258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8" creationId="{BED3AACC-89BD-4DF5-9DBD-6BBE626CDD2C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89" creationId="{219A400A-CA5C-49AF-A05C-2B27519A3889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2" creationId="{C53C3884-51BB-43E9-8EE2-B0D9E9D04E02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3" creationId="{35A18532-E487-4C1F-9FE6-F969BA6C2C73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6" creationId="{096A2636-9FD2-4C3B-8D25-9CAAC4AA2E94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7" creationId="{352338D5-D0F0-4B8E-8214-1316DFA00D6F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8" creationId="{B559BD79-BCF6-456A-82D3-F2FBB163BD61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99" creationId="{416EA103-F42A-4D18-929C-3B5563D02A4C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0" creationId="{A96D5001-692E-4A14-905D-689FA194360F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1" creationId="{34F0327C-4119-4453-B980-9D65F263EBD8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2" creationId="{6478726D-9B06-4A4F-91D6-783BD3390C71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3" creationId="{B66C2641-A7BE-4048-9171-C2D171C942BD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6" creationId="{0FE2931C-53AA-4AE6-A944-C753E05EE9B4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07" creationId="{CE92AC8F-7E95-4127-8B26-DEA6B4F24701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10" creationId="{9F13A5F6-5DD4-4A71-B102-482081056B54}"/>
          </ac:spMkLst>
        </pc:spChg>
        <pc:spChg chg="add">
          <ac:chgData name="Nicholas Skiados" userId="" providerId="" clId="Web-{FCCDC3E0-5678-4F40-A2D6-0EB089DB3C91}" dt="2021-06-17T03:23:49.997" v="99"/>
          <ac:spMkLst>
            <pc:docMk/>
            <pc:sldMk cId="1576788558" sldId="291"/>
            <ac:spMk id="111" creationId="{4E0EBEF9-16CD-441C-8344-1825D94FC6F2}"/>
          </ac:spMkLst>
        </pc:spChg>
        <pc:grpChg chg="add mod">
          <ac:chgData name="Nicholas Skiados" userId="" providerId="" clId="Web-{FCCDC3E0-5678-4F40-A2D6-0EB089DB3C91}" dt="2021-06-17T03:22:32.229" v="87" actId="1076"/>
          <ac:grpSpMkLst>
            <pc:docMk/>
            <pc:sldMk cId="1576788558" sldId="291"/>
            <ac:grpSpMk id="6" creationId="{C312BB04-078D-4DFE-AC89-8D753B0DEB75}"/>
          </ac:grpSpMkLst>
        </pc:grpChg>
        <pc:grpChg chg="add mod">
          <ac:chgData name="Nicholas Skiados" userId="" providerId="" clId="Web-{FCCDC3E0-5678-4F40-A2D6-0EB089DB3C91}" dt="2021-06-17T03:21:40.681" v="78" actId="1076"/>
          <ac:grpSpMkLst>
            <pc:docMk/>
            <pc:sldMk cId="1576788558" sldId="291"/>
            <ac:grpSpMk id="8" creationId="{0D59AF1D-6F97-4679-9EC0-BAED9496458A}"/>
          </ac:grpSpMkLst>
        </pc:grpChg>
        <pc:grpChg chg="add mod">
          <ac:chgData name="Nicholas Skiados" userId="" providerId="" clId="Web-{FCCDC3E0-5678-4F40-A2D6-0EB089DB3C91}" dt="2021-06-17T03:22:03.244" v="82" actId="1076"/>
          <ac:grpSpMkLst>
            <pc:docMk/>
            <pc:sldMk cId="1576788558" sldId="291"/>
            <ac:grpSpMk id="11" creationId="{358E008F-CA40-410C-9B22-4F26FEB5931E}"/>
          </ac:grpSpMkLst>
        </pc:grpChg>
        <pc:grpChg chg="add mod">
          <ac:chgData name="Nicholas Skiados" userId="" providerId="" clId="Web-{FCCDC3E0-5678-4F40-A2D6-0EB089DB3C91}" dt="2021-06-17T03:23:17.887" v="96" actId="1076"/>
          <ac:grpSpMkLst>
            <pc:docMk/>
            <pc:sldMk cId="1576788558" sldId="291"/>
            <ac:grpSpMk id="12" creationId="{F317E095-E954-4C7D-A976-D2B724EC75FD}"/>
          </ac:grpSpMkLst>
        </pc:grpChg>
        <pc:grpChg chg="add mod">
          <ac:chgData name="Nicholas Skiados" userId="" providerId="" clId="Web-{FCCDC3E0-5678-4F40-A2D6-0EB089DB3C91}" dt="2021-06-17T03:24:01.528" v="100" actId="1076"/>
          <ac:grpSpMkLst>
            <pc:docMk/>
            <pc:sldMk cId="1576788558" sldId="291"/>
            <ac:grpSpMk id="13" creationId="{359959D0-4278-438F-9F53-0471CD7F3B2B}"/>
          </ac:grpSpMkLst>
        </pc:grpChg>
        <pc:grpChg chg="add mod">
          <ac:chgData name="Nicholas Skiados" userId="" providerId="" clId="Web-{FCCDC3E0-5678-4F40-A2D6-0EB089DB3C91}" dt="2021-06-17T03:22:53.605" v="91" actId="1076"/>
          <ac:grpSpMkLst>
            <pc:docMk/>
            <pc:sldMk cId="1576788558" sldId="291"/>
            <ac:grpSpMk id="14" creationId="{0FC3A0AE-576F-477A-8704-D965151CC787}"/>
          </ac:grpSpMkLst>
        </pc:grpChg>
        <pc:grpChg chg="add mod">
          <ac:chgData name="Nicholas Skiados" userId="" providerId="" clId="Web-{FCCDC3E0-5678-4F40-A2D6-0EB089DB3C91}" dt="2021-06-17T03:22:11.119" v="84" actId="1076"/>
          <ac:grpSpMkLst>
            <pc:docMk/>
            <pc:sldMk cId="1576788558" sldId="291"/>
            <ac:grpSpMk id="15" creationId="{87F1893F-0FA2-4FC3-A607-FDEA261C1C0B}"/>
          </ac:grpSpMkLst>
        </pc:grpChg>
        <pc:grpChg chg="add del">
          <ac:chgData name="Nicholas Skiados" userId="" providerId="" clId="Web-{FCCDC3E0-5678-4F40-A2D6-0EB089DB3C91}" dt="2021-06-17T03:22:22.182" v="85"/>
          <ac:grpSpMkLst>
            <pc:docMk/>
            <pc:sldMk cId="1576788558" sldId="291"/>
            <ac:grpSpMk id="18" creationId="{D3531835-2ADC-411E-905B-7AA364B40B16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19" creationId="{2AA08928-88E8-4CE7-B880-74723C69292B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22" creationId="{B6CF1BF0-EC71-4FEC-886C-13152B985E7B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33" creationId="{2092C0D9-DBEF-4115-89CD-A6DCAF1D3FBC}"/>
          </ac:grpSpMkLst>
        </pc:grpChg>
        <pc:grpChg chg="add">
          <ac:chgData name="Nicholas Skiados" userId="" providerId="" clId="Web-{FCCDC3E0-5678-4F40-A2D6-0EB089DB3C91}" dt="2021-06-17T03:14:02.974" v="3"/>
          <ac:grpSpMkLst>
            <pc:docMk/>
            <pc:sldMk cId="1576788558" sldId="291"/>
            <ac:grpSpMk id="37" creationId="{AC72D14B-55EF-43DB-99FA-3BB7002C228F}"/>
          </ac:grpSpMkLst>
        </pc:grpChg>
        <pc:grpChg chg="add del mod">
          <ac:chgData name="Nicholas Skiados" userId="" providerId="" clId="Web-{FCCDC3E0-5678-4F40-A2D6-0EB089DB3C91}" dt="2021-06-17T03:19:03.186" v="56" actId="1076"/>
          <ac:grpSpMkLst>
            <pc:docMk/>
            <pc:sldMk cId="1576788558" sldId="291"/>
            <ac:grpSpMk id="42" creationId="{C312BB04-078D-4DFE-AC89-8D753B0DEB75}"/>
          </ac:grpSpMkLst>
        </pc:grpChg>
        <pc:grpChg chg="add del">
          <ac:chgData name="Nicholas Skiados" userId="" providerId="" clId="Web-{FCCDC3E0-5678-4F40-A2D6-0EB089DB3C91}" dt="2021-06-17T03:20:40.945" v="68"/>
          <ac:grpSpMkLst>
            <pc:docMk/>
            <pc:sldMk cId="1576788558" sldId="291"/>
            <ac:grpSpMk id="44" creationId="{0D59AF1D-6F97-4679-9EC0-BAED9496458A}"/>
          </ac:grpSpMkLst>
        </pc:grpChg>
        <pc:grpChg chg="add del mod">
          <ac:chgData name="Nicholas Skiados" userId="" providerId="" clId="Web-{FCCDC3E0-5678-4F40-A2D6-0EB089DB3C91}" dt="2021-06-17T03:19:19.099" v="58"/>
          <ac:grpSpMkLst>
            <pc:docMk/>
            <pc:sldMk cId="1576788558" sldId="291"/>
            <ac:grpSpMk id="47" creationId="{358E008F-CA40-410C-9B22-4F26FEB5931E}"/>
          </ac:grpSpMkLst>
        </pc:grpChg>
        <pc:grpChg chg="add del">
          <ac:chgData name="Nicholas Skiados" userId="" providerId="" clId="Web-{FCCDC3E0-5678-4F40-A2D6-0EB089DB3C91}" dt="2021-06-17T03:21:04.711" v="72"/>
          <ac:grpSpMkLst>
            <pc:docMk/>
            <pc:sldMk cId="1576788558" sldId="291"/>
            <ac:grpSpMk id="48" creationId="{F317E095-E954-4C7D-A976-D2B724EC75FD}"/>
          </ac:grpSpMkLst>
        </pc:grpChg>
        <pc:grpChg chg="add del">
          <ac:chgData name="Nicholas Skiados" userId="" providerId="" clId="Web-{FCCDC3E0-5678-4F40-A2D6-0EB089DB3C91}" dt="2021-06-17T03:20:48.461" v="69"/>
          <ac:grpSpMkLst>
            <pc:docMk/>
            <pc:sldMk cId="1576788558" sldId="291"/>
            <ac:grpSpMk id="49" creationId="{359959D0-4278-438F-9F53-0471CD7F3B2B}"/>
          </ac:grpSpMkLst>
        </pc:grpChg>
        <pc:grpChg chg="add del">
          <ac:chgData name="Nicholas Skiados" userId="" providerId="" clId="Web-{FCCDC3E0-5678-4F40-A2D6-0EB089DB3C91}" dt="2021-06-17T03:20:21.600" v="65"/>
          <ac:grpSpMkLst>
            <pc:docMk/>
            <pc:sldMk cId="1576788558" sldId="291"/>
            <ac:grpSpMk id="50" creationId="{0FC3A0AE-576F-477A-8704-D965151CC787}"/>
          </ac:grpSpMkLst>
        </pc:grpChg>
        <pc:grpChg chg="add del">
          <ac:chgData name="Nicholas Skiados" userId="" providerId="" clId="Web-{FCCDC3E0-5678-4F40-A2D6-0EB089DB3C91}" dt="2021-06-17T03:20:26.429" v="66"/>
          <ac:grpSpMkLst>
            <pc:docMk/>
            <pc:sldMk cId="1576788558" sldId="291"/>
            <ac:grpSpMk id="51" creationId="{87F1893F-0FA2-4FC3-A607-FDEA261C1C0B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54" creationId="{D3531835-2ADC-411E-905B-7AA364B40B16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55" creationId="{2AA08928-88E8-4CE7-B880-74723C69292B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58" creationId="{B6CF1BF0-EC71-4FEC-886C-13152B985E7B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69" creationId="{2092C0D9-DBEF-4115-89CD-A6DCAF1D3FBC}"/>
          </ac:grpSpMkLst>
        </pc:grpChg>
        <pc:grpChg chg="add">
          <ac:chgData name="Nicholas Skiados" userId="" providerId="" clId="Web-{FCCDC3E0-5678-4F40-A2D6-0EB089DB3C91}" dt="2021-06-17T03:16:37.166" v="23"/>
          <ac:grpSpMkLst>
            <pc:docMk/>
            <pc:sldMk cId="1576788558" sldId="291"/>
            <ac:grpSpMk id="73" creationId="{AC72D14B-55EF-43DB-99FA-3BB7002C228F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78" creationId="{C312BB04-078D-4DFE-AC89-8D753B0DEB75}"/>
          </ac:grpSpMkLst>
        </pc:grpChg>
        <pc:grpChg chg="add del">
          <ac:chgData name="Nicholas Skiados" userId="" providerId="" clId="Web-{FCCDC3E0-5678-4F40-A2D6-0EB089DB3C91}" dt="2021-06-17T03:24:16.185" v="102"/>
          <ac:grpSpMkLst>
            <pc:docMk/>
            <pc:sldMk cId="1576788558" sldId="291"/>
            <ac:grpSpMk id="80" creationId="{0D59AF1D-6F97-4679-9EC0-BAED9496458A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3" creationId="{358E008F-CA40-410C-9B22-4F26FEB5931E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4" creationId="{F317E095-E954-4C7D-A976-D2B724EC75FD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5" creationId="{359959D0-4278-438F-9F53-0471CD7F3B2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6" creationId="{0FC3A0AE-576F-477A-8704-D965151CC787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87" creationId="{87F1893F-0FA2-4FC3-A607-FDEA261C1C0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90" creationId="{D3531835-2ADC-411E-905B-7AA364B40B16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91" creationId="{2AA08928-88E8-4CE7-B880-74723C69292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94" creationId="{B6CF1BF0-EC71-4FEC-886C-13152B985E7B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105" creationId="{2092C0D9-DBEF-4115-89CD-A6DCAF1D3FBC}"/>
          </ac:grpSpMkLst>
        </pc:grpChg>
        <pc:grpChg chg="add">
          <ac:chgData name="Nicholas Skiados" userId="" providerId="" clId="Web-{FCCDC3E0-5678-4F40-A2D6-0EB089DB3C91}" dt="2021-06-17T03:23:49.997" v="99"/>
          <ac:grpSpMkLst>
            <pc:docMk/>
            <pc:sldMk cId="1576788558" sldId="291"/>
            <ac:grpSpMk id="109" creationId="{AC72D14B-55EF-43DB-99FA-3BB7002C228F}"/>
          </ac:grpSpMkLst>
        </pc:grpChg>
        <pc:picChg chg="add del mod">
          <ac:chgData name="Nicholas Skiados" userId="" providerId="" clId="Web-{FCCDC3E0-5678-4F40-A2D6-0EB089DB3C91}" dt="2021-06-17T03:22:22.182" v="85"/>
          <ac:picMkLst>
            <pc:docMk/>
            <pc:sldMk cId="1576788558" sldId="291"/>
            <ac:picMk id="23" creationId="{BECB9342-641E-4D90-84D2-C61439E2F29E}"/>
          </ac:picMkLst>
        </pc:picChg>
        <pc:picChg chg="add">
          <ac:chgData name="Nicholas Skiados" userId="" providerId="" clId="Web-{FCCDC3E0-5678-4F40-A2D6-0EB089DB3C91}" dt="2021-06-17T03:14:02.974" v="3"/>
          <ac:picMkLst>
            <pc:docMk/>
            <pc:sldMk cId="1576788558" sldId="291"/>
            <ac:picMk id="32" creationId="{75B4FC8F-EF47-480A-A7C3-DFE11CC2CF3B}"/>
          </ac:picMkLst>
        </pc:picChg>
        <pc:picChg chg="add">
          <ac:chgData name="Nicholas Skiados" userId="" providerId="" clId="Web-{FCCDC3E0-5678-4F40-A2D6-0EB089DB3C91}" dt="2021-06-17T03:14:02.974" v="3"/>
          <ac:picMkLst>
            <pc:docMk/>
            <pc:sldMk cId="1576788558" sldId="291"/>
            <ac:picMk id="36" creationId="{84E3B135-6C09-4CB6-8830-8A5EA74DFBF0}"/>
          </ac:picMkLst>
        </pc:picChg>
        <pc:picChg chg="add">
          <ac:chgData name="Nicholas Skiados" userId="" providerId="" clId="Web-{FCCDC3E0-5678-4F40-A2D6-0EB089DB3C91}" dt="2021-06-17T03:16:37.166" v="23"/>
          <ac:picMkLst>
            <pc:docMk/>
            <pc:sldMk cId="1576788558" sldId="291"/>
            <ac:picMk id="59" creationId="{BECB9342-641E-4D90-84D2-C61439E2F29E}"/>
          </ac:picMkLst>
        </pc:picChg>
        <pc:picChg chg="add">
          <ac:chgData name="Nicholas Skiados" userId="" providerId="" clId="Web-{FCCDC3E0-5678-4F40-A2D6-0EB089DB3C91}" dt="2021-06-17T03:16:37.166" v="23"/>
          <ac:picMkLst>
            <pc:docMk/>
            <pc:sldMk cId="1576788558" sldId="291"/>
            <ac:picMk id="68" creationId="{75B4FC8F-EF47-480A-A7C3-DFE11CC2CF3B}"/>
          </ac:picMkLst>
        </pc:picChg>
        <pc:picChg chg="add">
          <ac:chgData name="Nicholas Skiados" userId="" providerId="" clId="Web-{FCCDC3E0-5678-4F40-A2D6-0EB089DB3C91}" dt="2021-06-17T03:16:37.166" v="23"/>
          <ac:picMkLst>
            <pc:docMk/>
            <pc:sldMk cId="1576788558" sldId="291"/>
            <ac:picMk id="72" creationId="{84E3B135-6C09-4CB6-8830-8A5EA74DFBF0}"/>
          </ac:picMkLst>
        </pc:picChg>
        <pc:picChg chg="add">
          <ac:chgData name="Nicholas Skiados" userId="" providerId="" clId="Web-{FCCDC3E0-5678-4F40-A2D6-0EB089DB3C91}" dt="2021-06-17T03:23:49.997" v="99"/>
          <ac:picMkLst>
            <pc:docMk/>
            <pc:sldMk cId="1576788558" sldId="291"/>
            <ac:picMk id="95" creationId="{BECB9342-641E-4D90-84D2-C61439E2F29E}"/>
          </ac:picMkLst>
        </pc:picChg>
        <pc:picChg chg="add">
          <ac:chgData name="Nicholas Skiados" userId="" providerId="" clId="Web-{FCCDC3E0-5678-4F40-A2D6-0EB089DB3C91}" dt="2021-06-17T03:23:49.997" v="99"/>
          <ac:picMkLst>
            <pc:docMk/>
            <pc:sldMk cId="1576788558" sldId="291"/>
            <ac:picMk id="104" creationId="{75B4FC8F-EF47-480A-A7C3-DFE11CC2CF3B}"/>
          </ac:picMkLst>
        </pc:picChg>
        <pc:picChg chg="add">
          <ac:chgData name="Nicholas Skiados" userId="" providerId="" clId="Web-{FCCDC3E0-5678-4F40-A2D6-0EB089DB3C91}" dt="2021-06-17T03:23:49.997" v="99"/>
          <ac:picMkLst>
            <pc:docMk/>
            <pc:sldMk cId="1576788558" sldId="291"/>
            <ac:picMk id="108" creationId="{84E3B135-6C09-4CB6-8830-8A5EA74DFBF0}"/>
          </ac:picMkLst>
        </pc:picChg>
      </pc:sldChg>
      <pc:sldChg chg="addSp delSp modSp new">
        <pc:chgData name="Nicholas Skiados" userId="" providerId="" clId="Web-{FCCDC3E0-5678-4F40-A2D6-0EB089DB3C91}" dt="2021-06-17T03:58:11.852" v="458" actId="1076"/>
        <pc:sldMkLst>
          <pc:docMk/>
          <pc:sldMk cId="4133689721" sldId="291"/>
        </pc:sldMkLst>
        <pc:spChg chg="add del mod">
          <ac:chgData name="Nicholas Skiados" userId="" providerId="" clId="Web-{FCCDC3E0-5678-4F40-A2D6-0EB089DB3C91}" dt="2021-06-17T03:24:52.170" v="107"/>
          <ac:spMkLst>
            <pc:docMk/>
            <pc:sldMk cId="4133689721" sldId="291"/>
            <ac:spMk id="2" creationId="{E7A1628F-79EF-4AF0-9FE4-09DEF1849CA8}"/>
          </ac:spMkLst>
        </pc:spChg>
        <pc:spChg chg="add mod">
          <ac:chgData name="Nicholas Skiados" userId="" providerId="" clId="Web-{FCCDC3E0-5678-4F40-A2D6-0EB089DB3C91}" dt="2021-06-17T03:25:08.530" v="109" actId="1076"/>
          <ac:spMkLst>
            <pc:docMk/>
            <pc:sldMk cId="4133689721" sldId="291"/>
            <ac:spMk id="3" creationId="{0E974834-8482-4440-809E-90B06CCA30F4}"/>
          </ac:spMkLst>
        </pc:spChg>
        <pc:spChg chg="add mod">
          <ac:chgData name="Nicholas Skiados" userId="" providerId="" clId="Web-{FCCDC3E0-5678-4F40-A2D6-0EB089DB3C91}" dt="2021-06-17T03:58:11.852" v="458" actId="1076"/>
          <ac:spMkLst>
            <pc:docMk/>
            <pc:sldMk cId="4133689721" sldId="291"/>
            <ac:spMk id="4" creationId="{02092AE9-CFD4-4AC6-A393-F3990B5343F2}"/>
          </ac:spMkLst>
        </pc:spChg>
        <pc:spChg chg="add mod">
          <ac:chgData name="Nicholas Skiados" userId="" providerId="" clId="Web-{FCCDC3E0-5678-4F40-A2D6-0EB089DB3C91}" dt="2021-06-17T03:57:13.882" v="448" actId="1076"/>
          <ac:spMkLst>
            <pc:docMk/>
            <pc:sldMk cId="4133689721" sldId="291"/>
            <ac:spMk id="6" creationId="{89E84565-00A9-4750-B41B-2E8C35E6E19E}"/>
          </ac:spMkLst>
        </pc:spChg>
        <pc:spChg chg="add mod">
          <ac:chgData name="Nicholas Skiados" userId="" providerId="" clId="Web-{FCCDC3E0-5678-4F40-A2D6-0EB089DB3C91}" dt="2021-06-17T03:56:50.115" v="444" actId="20577"/>
          <ac:spMkLst>
            <pc:docMk/>
            <pc:sldMk cId="4133689721" sldId="291"/>
            <ac:spMk id="8" creationId="{8F2B740F-1420-4373-B1FC-3589A02F06D8}"/>
          </ac:spMkLst>
        </pc:spChg>
        <pc:spChg chg="add del mod">
          <ac:chgData name="Nicholas Skiados" userId="" providerId="" clId="Web-{FCCDC3E0-5678-4F40-A2D6-0EB089DB3C91}" dt="2021-06-17T03:56:15.364" v="438"/>
          <ac:spMkLst>
            <pc:docMk/>
            <pc:sldMk cId="4133689721" sldId="291"/>
            <ac:spMk id="9" creationId="{806ADAB2-CFA3-43E8-A15B-51C758229914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15" creationId="{B4549EF8-2279-41EB-8843-5ADF033F19E9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16" creationId="{9F54605D-8411-4EDC-A2B2-CC4882E85DBC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19" creationId="{8FC308FE-67D9-462A-8257-A4D83AB04510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20" creationId="{A63A11BB-DB3A-4A54-BAF1-74AE2A54977B}"/>
          </ac:spMkLst>
        </pc:spChg>
        <pc:spChg chg="add mod">
          <ac:chgData name="Nicholas Skiados" userId="" providerId="" clId="Web-{FCCDC3E0-5678-4F40-A2D6-0EB089DB3C91}" dt="2021-06-17T03:57:44.257" v="454" actId="1076"/>
          <ac:spMkLst>
            <pc:docMk/>
            <pc:sldMk cId="4133689721" sldId="291"/>
            <ac:spMk id="23" creationId="{BF22E72B-2A8D-41E6-ACA0-C367E0060262}"/>
          </ac:spMkLst>
        </pc:spChg>
        <pc:spChg chg="add mod">
          <ac:chgData name="Nicholas Skiados" userId="" providerId="" clId="Web-{FCCDC3E0-5678-4F40-A2D6-0EB089DB3C91}" dt="2021-06-17T03:57:51.617" v="455" actId="1076"/>
          <ac:spMkLst>
            <pc:docMk/>
            <pc:sldMk cId="4133689721" sldId="291"/>
            <ac:spMk id="24" creationId="{3E97C167-C4E6-4114-A077-39E0D0186BBE}"/>
          </ac:spMkLst>
        </pc:spChg>
        <pc:spChg chg="add mod">
          <ac:chgData name="Nicholas Skiados" userId="" providerId="" clId="Web-{FCCDC3E0-5678-4F40-A2D6-0EB089DB3C91}" dt="2021-06-17T03:29:40.679" v="230" actId="20577"/>
          <ac:spMkLst>
            <pc:docMk/>
            <pc:sldMk cId="4133689721" sldId="291"/>
            <ac:spMk id="25" creationId="{9FADD988-7CAE-4652-A4C8-A108F755D14E}"/>
          </ac:spMkLst>
        </pc:spChg>
        <pc:spChg chg="add mod">
          <ac:chgData name="Nicholas Skiados" userId="" providerId="" clId="Web-{FCCDC3E0-5678-4F40-A2D6-0EB089DB3C91}" dt="2021-06-17T03:29:47.413" v="248" actId="20577"/>
          <ac:spMkLst>
            <pc:docMk/>
            <pc:sldMk cId="4133689721" sldId="291"/>
            <ac:spMk id="26" creationId="{670C50EC-545F-4E7E-86DD-FA1A6F60C4B5}"/>
          </ac:spMkLst>
        </pc:spChg>
        <pc:spChg chg="add mod">
          <ac:chgData name="Nicholas Skiados" userId="" providerId="" clId="Web-{FCCDC3E0-5678-4F40-A2D6-0EB089DB3C91}" dt="2021-06-17T03:28:09.582" v="180" actId="20577"/>
          <ac:spMkLst>
            <pc:docMk/>
            <pc:sldMk cId="4133689721" sldId="291"/>
            <ac:spMk id="27" creationId="{9D18CD14-F22C-490A-BC60-EF3F7F6A3B6F}"/>
          </ac:spMkLst>
        </pc:spChg>
        <pc:spChg chg="add mod">
          <ac:chgData name="Nicholas Skiados" userId="" providerId="" clId="Web-{FCCDC3E0-5678-4F40-A2D6-0EB089DB3C91}" dt="2021-06-17T03:28:21.114" v="190" actId="20577"/>
          <ac:spMkLst>
            <pc:docMk/>
            <pc:sldMk cId="4133689721" sldId="291"/>
            <ac:spMk id="28" creationId="{D0F03D68-8732-4362-B872-1741EF2AF2CF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29" creationId="{F387714F-CDC2-4E5A-BE9D-AF13BEC34BB1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30" creationId="{D5B30FC7-48B8-4D31-AA13-80D8BBB0B300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33" creationId="{8395A7A3-D4C7-4072-82B5-3E916F072FF5}"/>
          </ac:spMkLst>
        </pc:spChg>
        <pc:spChg chg="add">
          <ac:chgData name="Nicholas Skiados" userId="" providerId="" clId="Web-{FCCDC3E0-5678-4F40-A2D6-0EB089DB3C91}" dt="2021-06-17T03:25:02.077" v="108"/>
          <ac:spMkLst>
            <pc:docMk/>
            <pc:sldMk cId="4133689721" sldId="291"/>
            <ac:spMk id="34" creationId="{59E5F861-39B0-48D8-B76B-0B8A7D5825F6}"/>
          </ac:spMkLst>
        </pc:spChg>
        <pc:spChg chg="add mod">
          <ac:chgData name="Nicholas Skiados" userId="" providerId="" clId="Web-{FCCDC3E0-5678-4F40-A2D6-0EB089DB3C91}" dt="2021-06-17T03:33:58.811" v="279" actId="1076"/>
          <ac:spMkLst>
            <pc:docMk/>
            <pc:sldMk cId="4133689721" sldId="291"/>
            <ac:spMk id="37" creationId="{C575F0B6-82C8-4927-ABC9-EBB2EB0DA34E}"/>
          </ac:spMkLst>
        </pc:spChg>
        <pc:spChg chg="add mod">
          <ac:chgData name="Nicholas Skiados" userId="" providerId="" clId="Web-{FCCDC3E0-5678-4F40-A2D6-0EB089DB3C91}" dt="2021-06-17T03:34:08.577" v="280" actId="1076"/>
          <ac:spMkLst>
            <pc:docMk/>
            <pc:sldMk cId="4133689721" sldId="291"/>
            <ac:spMk id="38" creationId="{ED0197A4-F764-4E5D-BA43-47AD777A2F71}"/>
          </ac:spMkLst>
        </pc:spChg>
        <pc:spChg chg="add del">
          <ac:chgData name="Nicholas Skiados" userId="" providerId="" clId="Web-{FCCDC3E0-5678-4F40-A2D6-0EB089DB3C91}" dt="2021-06-17T03:30:43.524" v="258"/>
          <ac:spMkLst>
            <pc:docMk/>
            <pc:sldMk cId="4133689721" sldId="291"/>
            <ac:spMk id="39" creationId="{0E974834-8482-4440-809E-90B06CCA30F4}"/>
          </ac:spMkLst>
        </pc:spChg>
        <pc:spChg chg="add del mod">
          <ac:chgData name="Nicholas Skiados" userId="" providerId="" clId="Web-{FCCDC3E0-5678-4F40-A2D6-0EB089DB3C91}" dt="2021-06-17T03:25:27.765" v="139"/>
          <ac:spMkLst>
            <pc:docMk/>
            <pc:sldMk cId="4133689721" sldId="291"/>
            <ac:spMk id="40" creationId="{02092AE9-CFD4-4AC6-A393-F3990B5343F2}"/>
          </ac:spMkLst>
        </pc:spChg>
        <pc:spChg chg="add del mod">
          <ac:chgData name="Nicholas Skiados" userId="" providerId="" clId="Web-{FCCDC3E0-5678-4F40-A2D6-0EB089DB3C91}" dt="2021-06-17T03:25:27.765" v="137"/>
          <ac:spMkLst>
            <pc:docMk/>
            <pc:sldMk cId="4133689721" sldId="291"/>
            <ac:spMk id="42" creationId="{89E84565-00A9-4750-B41B-2E8C35E6E19E}"/>
          </ac:spMkLst>
        </pc:spChg>
        <pc:spChg chg="add del mod">
          <ac:chgData name="Nicholas Skiados" userId="" providerId="" clId="Web-{FCCDC3E0-5678-4F40-A2D6-0EB089DB3C91}" dt="2021-06-17T03:25:27.765" v="135"/>
          <ac:spMkLst>
            <pc:docMk/>
            <pc:sldMk cId="4133689721" sldId="291"/>
            <ac:spMk id="44" creationId="{8F2B740F-1420-4373-B1FC-3589A02F06D8}"/>
          </ac:spMkLst>
        </pc:spChg>
        <pc:spChg chg="add del mod">
          <ac:chgData name="Nicholas Skiados" userId="" providerId="" clId="Web-{FCCDC3E0-5678-4F40-A2D6-0EB089DB3C91}" dt="2021-06-17T03:56:42.428" v="442"/>
          <ac:spMkLst>
            <pc:docMk/>
            <pc:sldMk cId="4133689721" sldId="291"/>
            <ac:spMk id="45" creationId="{806ADAB2-CFA3-43E8-A15B-51C758229914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1" creationId="{B4549EF8-2279-41EB-8843-5ADF033F19E9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2" creationId="{9F54605D-8411-4EDC-A2B2-CC4882E85DBC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5" creationId="{8FC308FE-67D9-462A-8257-A4D83AB04510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6" creationId="{A63A11BB-DB3A-4A54-BAF1-74AE2A54977B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59" creationId="{BF22E72B-2A8D-41E6-ACA0-C367E0060262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0" creationId="{3E97C167-C4E6-4114-A077-39E0D0186BBE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1" creationId="{9FADD988-7CAE-4652-A4C8-A108F755D14E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2" creationId="{670C50EC-545F-4E7E-86DD-FA1A6F60C4B5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3" creationId="{9D18CD14-F22C-490A-BC60-EF3F7F6A3B6F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4" creationId="{D0F03D68-8732-4362-B872-1741EF2AF2CF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5" creationId="{F387714F-CDC2-4E5A-BE9D-AF13BEC34BB1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6" creationId="{D5B30FC7-48B8-4D31-AA13-80D8BBB0B300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69" creationId="{8395A7A3-D4C7-4072-82B5-3E916F072FF5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70" creationId="{59E5F861-39B0-48D8-B76B-0B8A7D5825F6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73" creationId="{C575F0B6-82C8-4927-ABC9-EBB2EB0DA34E}"/>
          </ac:spMkLst>
        </pc:spChg>
        <pc:spChg chg="add">
          <ac:chgData name="Nicholas Skiados" userId="" providerId="" clId="Web-{FCCDC3E0-5678-4F40-A2D6-0EB089DB3C91}" dt="2021-06-17T03:25:22.171" v="119"/>
          <ac:spMkLst>
            <pc:docMk/>
            <pc:sldMk cId="4133689721" sldId="291"/>
            <ac:spMk id="74" creationId="{ED0197A4-F764-4E5D-BA43-47AD777A2F71}"/>
          </ac:spMkLst>
        </pc:spChg>
        <pc:spChg chg="add del">
          <ac:chgData name="Nicholas Skiados" userId="" providerId="" clId="Web-{FCCDC3E0-5678-4F40-A2D6-0EB089DB3C91}" dt="2021-06-17T03:25:43.391" v="141"/>
          <ac:spMkLst>
            <pc:docMk/>
            <pc:sldMk cId="4133689721" sldId="291"/>
            <ac:spMk id="75" creationId="{2C6FDA1F-69DD-4D82-9A32-5731EA403D98}"/>
          </ac:spMkLst>
        </pc:spChg>
        <pc:spChg chg="add del mod">
          <ac:chgData name="Nicholas Skiados" userId="" providerId="" clId="Web-{FCCDC3E0-5678-4F40-A2D6-0EB089DB3C91}" dt="2021-06-17T03:29:04.959" v="209"/>
          <ac:spMkLst>
            <pc:docMk/>
            <pc:sldMk cId="4133689721" sldId="291"/>
            <ac:spMk id="77" creationId="{FD0FE062-262E-485F-9ECE-C5204A0FFE6E}"/>
          </ac:spMkLst>
        </pc:spChg>
        <pc:spChg chg="add del mod">
          <ac:chgData name="Nicholas Skiados" userId="" providerId="" clId="Web-{FCCDC3E0-5678-4F40-A2D6-0EB089DB3C91}" dt="2021-06-17T03:56:11.302" v="437"/>
          <ac:spMkLst>
            <pc:docMk/>
            <pc:sldMk cId="4133689721" sldId="291"/>
            <ac:spMk id="79" creationId="{64D688B1-C718-41C5-88FA-6DB0053A9198}"/>
          </ac:spMkLst>
        </pc:spChg>
        <pc:spChg chg="add del mod">
          <ac:chgData name="Nicholas Skiados" userId="" providerId="" clId="Web-{FCCDC3E0-5678-4F40-A2D6-0EB089DB3C91}" dt="2021-06-17T03:56:05.317" v="436"/>
          <ac:spMkLst>
            <pc:docMk/>
            <pc:sldMk cId="4133689721" sldId="291"/>
            <ac:spMk id="80" creationId="{64675362-EEB4-4605-AA65-FE45DC7D4E1E}"/>
          </ac:spMkLst>
        </pc:spChg>
        <pc:spChg chg="add mod">
          <ac:chgData name="Nicholas Skiados" userId="" providerId="" clId="Web-{FCCDC3E0-5678-4F40-A2D6-0EB089DB3C91}" dt="2021-06-17T03:40:17.572" v="319" actId="1076"/>
          <ac:spMkLst>
            <pc:docMk/>
            <pc:sldMk cId="4133689721" sldId="291"/>
            <ac:spMk id="82" creationId="{64CE77AD-5AE7-486C-BB91-85E1CD16181D}"/>
          </ac:spMkLst>
        </pc:spChg>
        <pc:spChg chg="add mod">
          <ac:chgData name="Nicholas Skiados" userId="" providerId="" clId="Web-{FCCDC3E0-5678-4F40-A2D6-0EB089DB3C91}" dt="2021-06-17T03:57:01.553" v="446" actId="1076"/>
          <ac:spMkLst>
            <pc:docMk/>
            <pc:sldMk cId="4133689721" sldId="291"/>
            <ac:spMk id="87" creationId="{10943836-76F0-4359-8724-99CA98811398}"/>
          </ac:spMkLst>
        </pc:spChg>
        <pc:spChg chg="add mod">
          <ac:chgData name="Nicholas Skiados" userId="" providerId="" clId="Web-{FCCDC3E0-5678-4F40-A2D6-0EB089DB3C91}" dt="2021-06-17T03:46:07.175" v="380" actId="20577"/>
          <ac:spMkLst>
            <pc:docMk/>
            <pc:sldMk cId="4133689721" sldId="291"/>
            <ac:spMk id="89" creationId="{9FA0D867-354A-43A2-8F5A-E8679F2BBCDE}"/>
          </ac:spMkLst>
        </pc:spChg>
        <pc:spChg chg="add del">
          <ac:chgData name="Nicholas Skiados" userId="" providerId="" clId="Web-{FCCDC3E0-5678-4F40-A2D6-0EB089DB3C91}" dt="2021-06-17T03:54:20.174" v="420"/>
          <ac:spMkLst>
            <pc:docMk/>
            <pc:sldMk cId="4133689721" sldId="291"/>
            <ac:spMk id="90" creationId="{674DBABC-E97B-475A-8DEC-7B7C83BC5C12}"/>
          </ac:spMkLst>
        </pc:spChg>
        <pc:spChg chg="add del">
          <ac:chgData name="Nicholas Skiados" userId="" providerId="" clId="Web-{FCCDC3E0-5678-4F40-A2D6-0EB089DB3C91}" dt="2021-06-17T03:53:54.548" v="415"/>
          <ac:spMkLst>
            <pc:docMk/>
            <pc:sldMk cId="4133689721" sldId="291"/>
            <ac:spMk id="91" creationId="{946C3DF4-8A83-452A-A6CA-73BB171EF4B7}"/>
          </ac:spMkLst>
        </pc:spChg>
        <pc:spChg chg="add del">
          <ac:chgData name="Nicholas Skiados" userId="" providerId="" clId="Web-{FCCDC3E0-5678-4F40-A2D6-0EB089DB3C91}" dt="2021-06-17T03:53:54.532" v="414"/>
          <ac:spMkLst>
            <pc:docMk/>
            <pc:sldMk cId="4133689721" sldId="291"/>
            <ac:spMk id="92" creationId="{06B36AFD-042E-4FCF-BDB3-6F5871308EAE}"/>
          </ac:spMkLst>
        </pc:spChg>
        <pc:spChg chg="add del mod">
          <ac:chgData name="Nicholas Skiados" userId="" providerId="" clId="Web-{FCCDC3E0-5678-4F40-A2D6-0EB089DB3C91}" dt="2021-06-17T03:53:54.532" v="413"/>
          <ac:spMkLst>
            <pc:docMk/>
            <pc:sldMk cId="4133689721" sldId="291"/>
            <ac:spMk id="94" creationId="{3AC226F7-79CC-430F-8004-2F9A729FF602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0" creationId="{0AA9A54A-7C36-4D51-AC12-CA6048AD339E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1" creationId="{FC620F30-C813-464D-8EDB-C888B92E7792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2" creationId="{EF1303BD-AC9F-47B3-A49A-BB54EA2B6520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3" creationId="{99CB34AD-869B-4C64-B5EB-129439D71337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4" creationId="{43902FC3-E49A-4F63-A9B6-700743A4146F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5" creationId="{98474070-AF39-4F8A-B6B2-1EC86538CBFF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6" creationId="{BF722318-83F3-4CF3-BC24-27211AEDFFD7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7" creationId="{7D7A7AA6-BBD9-415C-A07F-0EF3108B0A09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08" creationId="{1491534C-C02A-4DFD-B12C-00E9DFB1C8D1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1" creationId="{43EFF219-548D-4478-9FEC-ED1B6CC3B11C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2" creationId="{97A352AC-6C19-4457-A3A0-471915144A28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5" creationId="{C0B23AE3-A451-417A-830A-C0E764B473B7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6" creationId="{9CC9D50D-AACE-41CE-8E2F-25419A57FA41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19" creationId="{2C8D6958-A069-4E6F-BEFF-5EC154DD47E5}"/>
          </ac:spMkLst>
        </pc:spChg>
        <pc:spChg chg="add">
          <ac:chgData name="Nicholas Skiados" userId="" providerId="" clId="Web-{FCCDC3E0-5678-4F40-A2D6-0EB089DB3C91}" dt="2021-06-17T03:50:02.807" v="382"/>
          <ac:spMkLst>
            <pc:docMk/>
            <pc:sldMk cId="4133689721" sldId="291"/>
            <ac:spMk id="120" creationId="{E5DB6C9A-2D50-4385-9868-6626C8C7003B}"/>
          </ac:spMkLst>
        </pc:spChg>
        <pc:spChg chg="add mod">
          <ac:chgData name="Nicholas Skiados" userId="" providerId="" clId="Web-{FCCDC3E0-5678-4F40-A2D6-0EB089DB3C91}" dt="2021-06-17T03:54:35.674" v="422" actId="1076"/>
          <ac:spMkLst>
            <pc:docMk/>
            <pc:sldMk cId="4133689721" sldId="291"/>
            <ac:spMk id="121" creationId="{D6CB511F-139C-41D4-8250-3CE8C1C529A2}"/>
          </ac:spMkLst>
        </pc:spChg>
        <pc:spChg chg="add del mod">
          <ac:chgData name="Nicholas Skiados" userId="" providerId="" clId="Web-{FCCDC3E0-5678-4F40-A2D6-0EB089DB3C91}" dt="2021-06-17T03:55:54.161" v="434"/>
          <ac:spMkLst>
            <pc:docMk/>
            <pc:sldMk cId="4133689721" sldId="291"/>
            <ac:spMk id="123" creationId="{A8D75981-0EA4-4AF0-B1F2-25151DDAB094}"/>
          </ac:spMkLst>
        </pc:spChg>
        <pc:spChg chg="add mod">
          <ac:chgData name="Nicholas Skiados" userId="" providerId="" clId="Web-{FCCDC3E0-5678-4F40-A2D6-0EB089DB3C91}" dt="2021-06-17T03:55:12.019" v="428" actId="1076"/>
          <ac:spMkLst>
            <pc:docMk/>
            <pc:sldMk cId="4133689721" sldId="291"/>
            <ac:spMk id="124" creationId="{9DD241D0-FA5A-46DA-805C-C56E7116101A}"/>
          </ac:spMkLst>
        </pc:spChg>
        <pc:spChg chg="add mod">
          <ac:chgData name="Nicholas Skiados" userId="" providerId="" clId="Web-{FCCDC3E0-5678-4F40-A2D6-0EB089DB3C91}" dt="2021-06-17T03:55:32.113" v="430" actId="1076"/>
          <ac:spMkLst>
            <pc:docMk/>
            <pc:sldMk cId="4133689721" sldId="291"/>
            <ac:spMk id="125" creationId="{5949CED8-518B-4502-9EFE-E1900364B0C4}"/>
          </ac:spMkLst>
        </pc:spChg>
        <pc:spChg chg="add del">
          <ac:chgData name="Nicholas Skiados" userId="" providerId="" clId="Web-{FCCDC3E0-5678-4F40-A2D6-0EB089DB3C91}" dt="2021-06-17T03:55:57.129" v="435"/>
          <ac:spMkLst>
            <pc:docMk/>
            <pc:sldMk cId="4133689721" sldId="291"/>
            <ac:spMk id="126" creationId="{092460A6-5B83-446D-A473-2A0199C8C0CB}"/>
          </ac:spMkLst>
        </pc:spChg>
        <pc:spChg chg="add mod">
          <ac:chgData name="Nicholas Skiados" userId="" providerId="" clId="Web-{FCCDC3E0-5678-4F40-A2D6-0EB089DB3C91}" dt="2021-06-17T03:55:52.442" v="433" actId="1076"/>
          <ac:spMkLst>
            <pc:docMk/>
            <pc:sldMk cId="4133689721" sldId="291"/>
            <ac:spMk id="127" creationId="{855AF6B0-3ACF-44FA-9737-1415FC3FF6CF}"/>
          </ac:spMkLst>
        </pc:spChg>
        <pc:spChg chg="add mod">
          <ac:chgData name="Nicholas Skiados" userId="" providerId="" clId="Web-{FCCDC3E0-5678-4F40-A2D6-0EB089DB3C91}" dt="2021-06-17T03:56:28.474" v="440" actId="1076"/>
          <ac:spMkLst>
            <pc:docMk/>
            <pc:sldMk cId="4133689721" sldId="291"/>
            <ac:spMk id="128" creationId="{E1E6E364-D220-4501-AFB7-E5A4AE205604}"/>
          </ac:spMkLst>
        </pc:spChg>
        <pc:grpChg chg="add del mod">
          <ac:chgData name="Nicholas Skiados" userId="" providerId="" clId="Web-{FCCDC3E0-5678-4F40-A2D6-0EB089DB3C91}" dt="2021-06-17T03:30:49.681" v="259"/>
          <ac:grpSpMkLst>
            <pc:docMk/>
            <pc:sldMk cId="4133689721" sldId="291"/>
            <ac:grpSpMk id="5" creationId="{2D98C8F7-ED96-4BD4-A9E5-2149B79FC508}"/>
          </ac:grpSpMkLst>
        </pc:grpChg>
        <pc:grpChg chg="add del mod">
          <ac:chgData name="Nicholas Skiados" userId="" providerId="" clId="Web-{FCCDC3E0-5678-4F40-A2D6-0EB089DB3C91}" dt="2021-06-17T03:44:30.391" v="343"/>
          <ac:grpSpMkLst>
            <pc:docMk/>
            <pc:sldMk cId="4133689721" sldId="291"/>
            <ac:grpSpMk id="7" creationId="{9945593C-FA9A-4B69-96FB-B1A6FB623C86}"/>
          </ac:grpSpMkLst>
        </pc:grpChg>
        <pc:grpChg chg="add mod">
          <ac:chgData name="Nicholas Skiados" userId="" providerId="" clId="Web-{FCCDC3E0-5678-4F40-A2D6-0EB089DB3C91}" dt="2021-06-17T03:25:15.062" v="118" actId="1076"/>
          <ac:grpSpMkLst>
            <pc:docMk/>
            <pc:sldMk cId="4133689721" sldId="291"/>
            <ac:grpSpMk id="10" creationId="{5FFDB581-28EA-4CF8-9D80-C21FAA8AD78B}"/>
          </ac:grpSpMkLst>
        </pc:grpChg>
        <pc:grpChg chg="add mod">
          <ac:chgData name="Nicholas Skiados" userId="" providerId="" clId="Web-{FCCDC3E0-5678-4F40-A2D6-0EB089DB3C91}" dt="2021-06-17T03:55:00.534" v="426" actId="1076"/>
          <ac:grpSpMkLst>
            <pc:docMk/>
            <pc:sldMk cId="4133689721" sldId="291"/>
            <ac:grpSpMk id="11" creationId="{9B6EA788-4148-4A0F-B9B5-A47882718B60}"/>
          </ac:grpSpMkLst>
        </pc:grpChg>
        <pc:grpChg chg="add mod">
          <ac:chgData name="Nicholas Skiados" userId="" providerId="" clId="Web-{FCCDC3E0-5678-4F40-A2D6-0EB089DB3C91}" dt="2021-06-17T03:56:34.380" v="441" actId="1076"/>
          <ac:grpSpMkLst>
            <pc:docMk/>
            <pc:sldMk cId="4133689721" sldId="291"/>
            <ac:grpSpMk id="12" creationId="{3AF54EC6-A750-467B-91D8-C4F39AB6EC99}"/>
          </ac:grpSpMkLst>
        </pc:grpChg>
        <pc:grpChg chg="add mod">
          <ac:chgData name="Nicholas Skiados" userId="" providerId="" clId="Web-{FCCDC3E0-5678-4F40-A2D6-0EB089DB3C91}" dt="2021-06-17T03:57:18.163" v="449" actId="1076"/>
          <ac:grpSpMkLst>
            <pc:docMk/>
            <pc:sldMk cId="4133689721" sldId="291"/>
            <ac:grpSpMk id="13" creationId="{EFFB9AEE-3FB8-499F-8081-641918985D0B}"/>
          </ac:grpSpMkLst>
        </pc:grpChg>
        <pc:grpChg chg="add mod">
          <ac:chgData name="Nicholas Skiados" userId="" providerId="" clId="Web-{FCCDC3E0-5678-4F40-A2D6-0EB089DB3C91}" dt="2021-06-17T03:58:08.633" v="457" actId="1076"/>
          <ac:grpSpMkLst>
            <pc:docMk/>
            <pc:sldMk cId="4133689721" sldId="291"/>
            <ac:grpSpMk id="14" creationId="{D5F7F827-893F-4BC5-B898-F40FAFF99A29}"/>
          </ac:grpSpMkLst>
        </pc:grpChg>
        <pc:grpChg chg="add del">
          <ac:chgData name="Nicholas Skiados" userId="" providerId="" clId="Web-{FCCDC3E0-5678-4F40-A2D6-0EB089DB3C91}" dt="2021-06-17T03:36:01.643" v="299"/>
          <ac:grpSpMkLst>
            <pc:docMk/>
            <pc:sldMk cId="4133689721" sldId="291"/>
            <ac:grpSpMk id="17" creationId="{177168DB-1796-4A1D-8CC8-3569414F8084}"/>
          </ac:grpSpMkLst>
        </pc:grpChg>
        <pc:grpChg chg="add">
          <ac:chgData name="Nicholas Skiados" userId="" providerId="" clId="Web-{FCCDC3E0-5678-4F40-A2D6-0EB089DB3C91}" dt="2021-06-17T03:25:02.077" v="108"/>
          <ac:grpSpMkLst>
            <pc:docMk/>
            <pc:sldMk cId="4133689721" sldId="291"/>
            <ac:grpSpMk id="18" creationId="{32F8F691-DF1F-4A4D-A271-FA806BC9446C}"/>
          </ac:grpSpMkLst>
        </pc:grpChg>
        <pc:grpChg chg="add">
          <ac:chgData name="Nicholas Skiados" userId="" providerId="" clId="Web-{FCCDC3E0-5678-4F40-A2D6-0EB089DB3C91}" dt="2021-06-17T03:25:02.077" v="108"/>
          <ac:grpSpMkLst>
            <pc:docMk/>
            <pc:sldMk cId="4133689721" sldId="291"/>
            <ac:grpSpMk id="21" creationId="{6044538C-078A-4B35-9A20-801DF003B17B}"/>
          </ac:grpSpMkLst>
        </pc:grpChg>
        <pc:grpChg chg="add">
          <ac:chgData name="Nicholas Skiados" userId="" providerId="" clId="Web-{FCCDC3E0-5678-4F40-A2D6-0EB089DB3C91}" dt="2021-06-17T03:25:02.077" v="108"/>
          <ac:grpSpMkLst>
            <pc:docMk/>
            <pc:sldMk cId="4133689721" sldId="291"/>
            <ac:grpSpMk id="32" creationId="{D54D6DDC-8645-43D5-BDC6-CF981C811C67}"/>
          </ac:grpSpMkLst>
        </pc:grpChg>
        <pc:grpChg chg="add mod topLvl">
          <ac:chgData name="Nicholas Skiados" userId="" providerId="" clId="Web-{FCCDC3E0-5678-4F40-A2D6-0EB089DB3C91}" dt="2021-06-17T03:36:14.690" v="300" actId="1076"/>
          <ac:grpSpMkLst>
            <pc:docMk/>
            <pc:sldMk cId="4133689721" sldId="291"/>
            <ac:grpSpMk id="36" creationId="{00308009-BF9B-40C1-BBA6-2AF3C82A16A4}"/>
          </ac:grpSpMkLst>
        </pc:grpChg>
        <pc:grpChg chg="add del mod">
          <ac:chgData name="Nicholas Skiados" userId="" providerId="" clId="Web-{FCCDC3E0-5678-4F40-A2D6-0EB089DB3C91}" dt="2021-06-17T03:25:27.765" v="138"/>
          <ac:grpSpMkLst>
            <pc:docMk/>
            <pc:sldMk cId="4133689721" sldId="291"/>
            <ac:grpSpMk id="41" creationId="{2D98C8F7-ED96-4BD4-A9E5-2149B79FC508}"/>
          </ac:grpSpMkLst>
        </pc:grpChg>
        <pc:grpChg chg="add del mod">
          <ac:chgData name="Nicholas Skiados" userId="" providerId="" clId="Web-{FCCDC3E0-5678-4F40-A2D6-0EB089DB3C91}" dt="2021-06-17T03:25:27.765" v="136"/>
          <ac:grpSpMkLst>
            <pc:docMk/>
            <pc:sldMk cId="4133689721" sldId="291"/>
            <ac:grpSpMk id="43" creationId="{9945593C-FA9A-4B69-96FB-B1A6FB623C86}"/>
          </ac:grpSpMkLst>
        </pc:grpChg>
        <pc:grpChg chg="add del mod">
          <ac:chgData name="Nicholas Skiados" userId="" providerId="" clId="Web-{FCCDC3E0-5678-4F40-A2D6-0EB089DB3C91}" dt="2021-06-17T03:25:27.765" v="134"/>
          <ac:grpSpMkLst>
            <pc:docMk/>
            <pc:sldMk cId="4133689721" sldId="291"/>
            <ac:grpSpMk id="46" creationId="{5FFDB581-28EA-4CF8-9D80-C21FAA8AD78B}"/>
          </ac:grpSpMkLst>
        </pc:grpChg>
        <pc:grpChg chg="add del mod">
          <ac:chgData name="Nicholas Skiados" userId="" providerId="" clId="Web-{FCCDC3E0-5678-4F40-A2D6-0EB089DB3C91}" dt="2021-06-17T03:25:27.765" v="133"/>
          <ac:grpSpMkLst>
            <pc:docMk/>
            <pc:sldMk cId="4133689721" sldId="291"/>
            <ac:grpSpMk id="47" creationId="{9B6EA788-4148-4A0F-B9B5-A47882718B60}"/>
          </ac:grpSpMkLst>
        </pc:grpChg>
        <pc:grpChg chg="add del mod">
          <ac:chgData name="Nicholas Skiados" userId="" providerId="" clId="Web-{FCCDC3E0-5678-4F40-A2D6-0EB089DB3C91}" dt="2021-06-17T03:25:27.765" v="132"/>
          <ac:grpSpMkLst>
            <pc:docMk/>
            <pc:sldMk cId="4133689721" sldId="291"/>
            <ac:grpSpMk id="48" creationId="{3AF54EC6-A750-467B-91D8-C4F39AB6EC99}"/>
          </ac:grpSpMkLst>
        </pc:grpChg>
        <pc:grpChg chg="add del mod">
          <ac:chgData name="Nicholas Skiados" userId="" providerId="" clId="Web-{FCCDC3E0-5678-4F40-A2D6-0EB089DB3C91}" dt="2021-06-17T03:25:27.765" v="131"/>
          <ac:grpSpMkLst>
            <pc:docMk/>
            <pc:sldMk cId="4133689721" sldId="291"/>
            <ac:grpSpMk id="49" creationId="{EFFB9AEE-3FB8-499F-8081-641918985D0B}"/>
          </ac:grpSpMkLst>
        </pc:grpChg>
        <pc:grpChg chg="add del mod">
          <ac:chgData name="Nicholas Skiados" userId="" providerId="" clId="Web-{FCCDC3E0-5678-4F40-A2D6-0EB089DB3C91}" dt="2021-06-17T03:25:27.765" v="130"/>
          <ac:grpSpMkLst>
            <pc:docMk/>
            <pc:sldMk cId="4133689721" sldId="291"/>
            <ac:grpSpMk id="50" creationId="{D5F7F827-893F-4BC5-B898-F40FAFF99A29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53" creationId="{177168DB-1796-4A1D-8CC8-3569414F8084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54" creationId="{32F8F691-DF1F-4A4D-A271-FA806BC9446C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57" creationId="{6044538C-078A-4B35-9A20-801DF003B17B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68" creationId="{D54D6DDC-8645-43D5-BDC6-CF981C811C67}"/>
          </ac:grpSpMkLst>
        </pc:grpChg>
        <pc:grpChg chg="add">
          <ac:chgData name="Nicholas Skiados" userId="" providerId="" clId="Web-{FCCDC3E0-5678-4F40-A2D6-0EB089DB3C91}" dt="2021-06-17T03:25:22.171" v="119"/>
          <ac:grpSpMkLst>
            <pc:docMk/>
            <pc:sldMk cId="4133689721" sldId="291"/>
            <ac:grpSpMk id="72" creationId="{00308009-BF9B-40C1-BBA6-2AF3C82A16A4}"/>
          </ac:grpSpMkLst>
        </pc:grpChg>
        <pc:grpChg chg="add del mod">
          <ac:chgData name="Nicholas Skiados" userId="" providerId="" clId="Web-{FCCDC3E0-5678-4F40-A2D6-0EB089DB3C91}" dt="2021-06-17T03:54:01.126" v="418"/>
          <ac:grpSpMkLst>
            <pc:docMk/>
            <pc:sldMk cId="4133689721" sldId="291"/>
            <ac:grpSpMk id="93" creationId="{81F93F40-8D19-4CFD-9A89-40D8F9A3E9D5}"/>
          </ac:grpSpMkLst>
        </pc:grpChg>
        <pc:grpChg chg="add del mod">
          <ac:chgData name="Nicholas Skiados" userId="" providerId="" clId="Web-{FCCDC3E0-5678-4F40-A2D6-0EB089DB3C91}" dt="2021-06-17T03:53:59.767" v="417"/>
          <ac:grpSpMkLst>
            <pc:docMk/>
            <pc:sldMk cId="4133689721" sldId="291"/>
            <ac:grpSpMk id="95" creationId="{49BDA04E-D73B-4DA3-AF96-A09581AB2652}"/>
          </ac:grpSpMkLst>
        </pc:grpChg>
        <pc:grpChg chg="add del mod">
          <ac:chgData name="Nicholas Skiados" userId="" providerId="" clId="Web-{FCCDC3E0-5678-4F40-A2D6-0EB089DB3C91}" dt="2021-06-17T03:53:58.376" v="416"/>
          <ac:grpSpMkLst>
            <pc:docMk/>
            <pc:sldMk cId="4133689721" sldId="291"/>
            <ac:grpSpMk id="96" creationId="{950F85A3-5727-4ECF-B170-9CAF00A2EE26}"/>
          </ac:grpSpMkLst>
        </pc:grpChg>
        <pc:grpChg chg="add del mod">
          <ac:chgData name="Nicholas Skiados" userId="" providerId="" clId="Web-{FCCDC3E0-5678-4F40-A2D6-0EB089DB3C91}" dt="2021-06-17T03:53:54.532" v="412"/>
          <ac:grpSpMkLst>
            <pc:docMk/>
            <pc:sldMk cId="4133689721" sldId="291"/>
            <ac:grpSpMk id="97" creationId="{CFCDEC3D-7AB0-4975-90A4-7A1E480EDE1E}"/>
          </ac:grpSpMkLst>
        </pc:grpChg>
        <pc:grpChg chg="add del mod">
          <ac:chgData name="Nicholas Skiados" userId="" providerId="" clId="Web-{FCCDC3E0-5678-4F40-A2D6-0EB089DB3C91}" dt="2021-06-17T03:53:54.532" v="411"/>
          <ac:grpSpMkLst>
            <pc:docMk/>
            <pc:sldMk cId="4133689721" sldId="291"/>
            <ac:grpSpMk id="98" creationId="{A4A7BF91-77CF-4EEE-A5A0-DA9B4A896BC2}"/>
          </ac:grpSpMkLst>
        </pc:grpChg>
        <pc:grpChg chg="add del mod">
          <ac:chgData name="Nicholas Skiados" userId="" providerId="" clId="Web-{FCCDC3E0-5678-4F40-A2D6-0EB089DB3C91}" dt="2021-06-17T03:53:54.532" v="410"/>
          <ac:grpSpMkLst>
            <pc:docMk/>
            <pc:sldMk cId="4133689721" sldId="291"/>
            <ac:grpSpMk id="99" creationId="{ADFC27EB-88F5-4AD6-8CD5-A36CF48FA596}"/>
          </ac:grpSpMkLst>
        </pc:grpChg>
        <pc:grpChg chg="add">
          <ac:chgData name="Nicholas Skiados" userId="" providerId="" clId="Web-{FCCDC3E0-5678-4F40-A2D6-0EB089DB3C91}" dt="2021-06-17T03:50:02.807" v="382"/>
          <ac:grpSpMkLst>
            <pc:docMk/>
            <pc:sldMk cId="4133689721" sldId="291"/>
            <ac:grpSpMk id="110" creationId="{E28FA590-AA29-4FC0-8E5D-655100D07F14}"/>
          </ac:grpSpMkLst>
        </pc:grpChg>
        <pc:grpChg chg="add del topLvl">
          <ac:chgData name="Nicholas Skiados" userId="" providerId="" clId="Web-{FCCDC3E0-5678-4F40-A2D6-0EB089DB3C91}" dt="2021-06-17T03:54:17.252" v="419"/>
          <ac:grpSpMkLst>
            <pc:docMk/>
            <pc:sldMk cId="4133689721" sldId="291"/>
            <ac:grpSpMk id="114" creationId="{5B9101B6-2CDF-418E-A3A4-A0DDF2EF36FF}"/>
          </ac:grpSpMkLst>
        </pc:grpChg>
        <pc:grpChg chg="add">
          <ac:chgData name="Nicholas Skiados" userId="" providerId="" clId="Web-{FCCDC3E0-5678-4F40-A2D6-0EB089DB3C91}" dt="2021-06-17T03:50:02.807" v="382"/>
          <ac:grpSpMkLst>
            <pc:docMk/>
            <pc:sldMk cId="4133689721" sldId="291"/>
            <ac:grpSpMk id="117" creationId="{95F63EAC-2B93-463F-87F1-267FA5C51DC9}"/>
          </ac:grpSpMkLst>
        </pc:grpChg>
        <pc:picChg chg="add del">
          <ac:chgData name="Nicholas Skiados" userId="" providerId="" clId="Web-{FCCDC3E0-5678-4F40-A2D6-0EB089DB3C91}" dt="2021-06-17T03:36:01.643" v="299"/>
          <ac:picMkLst>
            <pc:docMk/>
            <pc:sldMk cId="4133689721" sldId="291"/>
            <ac:picMk id="22" creationId="{32774065-0938-4672-974B-BF75C5C0D323}"/>
          </ac:picMkLst>
        </pc:picChg>
        <pc:picChg chg="add">
          <ac:chgData name="Nicholas Skiados" userId="" providerId="" clId="Web-{FCCDC3E0-5678-4F40-A2D6-0EB089DB3C91}" dt="2021-06-17T03:25:02.077" v="108"/>
          <ac:picMkLst>
            <pc:docMk/>
            <pc:sldMk cId="4133689721" sldId="291"/>
            <ac:picMk id="31" creationId="{093F1502-C1E2-4B2B-9826-B1BC865F6D12}"/>
          </ac:picMkLst>
        </pc:picChg>
        <pc:picChg chg="add del topLvl">
          <ac:chgData name="Nicholas Skiados" userId="" providerId="" clId="Web-{FCCDC3E0-5678-4F40-A2D6-0EB089DB3C91}" dt="2021-06-17T03:30:49.681" v="259"/>
          <ac:picMkLst>
            <pc:docMk/>
            <pc:sldMk cId="4133689721" sldId="291"/>
            <ac:picMk id="35" creationId="{CAF06F1F-95BD-458A-A58E-D390B1F7A7FB}"/>
          </ac:picMkLst>
        </pc:picChg>
        <pc:picChg chg="add">
          <ac:chgData name="Nicholas Skiados" userId="" providerId="" clId="Web-{FCCDC3E0-5678-4F40-A2D6-0EB089DB3C91}" dt="2021-06-17T03:25:22.171" v="119"/>
          <ac:picMkLst>
            <pc:docMk/>
            <pc:sldMk cId="4133689721" sldId="291"/>
            <ac:picMk id="58" creationId="{32774065-0938-4672-974B-BF75C5C0D323}"/>
          </ac:picMkLst>
        </pc:picChg>
        <pc:picChg chg="add">
          <ac:chgData name="Nicholas Skiados" userId="" providerId="" clId="Web-{FCCDC3E0-5678-4F40-A2D6-0EB089DB3C91}" dt="2021-06-17T03:25:22.171" v="119"/>
          <ac:picMkLst>
            <pc:docMk/>
            <pc:sldMk cId="4133689721" sldId="291"/>
            <ac:picMk id="67" creationId="{093F1502-C1E2-4B2B-9826-B1BC865F6D12}"/>
          </ac:picMkLst>
        </pc:picChg>
        <pc:picChg chg="add">
          <ac:chgData name="Nicholas Skiados" userId="" providerId="" clId="Web-{FCCDC3E0-5678-4F40-A2D6-0EB089DB3C91}" dt="2021-06-17T03:25:22.171" v="119"/>
          <ac:picMkLst>
            <pc:docMk/>
            <pc:sldMk cId="4133689721" sldId="291"/>
            <ac:picMk id="71" creationId="{CAF06F1F-95BD-458A-A58E-D390B1F7A7FB}"/>
          </ac:picMkLst>
        </pc:picChg>
        <pc:picChg chg="add mod">
          <ac:chgData name="Nicholas Skiados" userId="" providerId="" clId="Web-{FCCDC3E0-5678-4F40-A2D6-0EB089DB3C91}" dt="2021-06-17T03:36:19.565" v="301" actId="1076"/>
          <ac:picMkLst>
            <pc:docMk/>
            <pc:sldMk cId="4133689721" sldId="291"/>
            <ac:picMk id="81" creationId="{BE92BD88-DCA3-4340-A32C-86E24907DA79}"/>
          </ac:picMkLst>
        </pc:picChg>
        <pc:picChg chg="add del mod">
          <ac:chgData name="Nicholas Skiados" userId="" providerId="" clId="Web-{FCCDC3E0-5678-4F40-A2D6-0EB089DB3C91}" dt="2021-06-17T03:39:23.539" v="309"/>
          <ac:picMkLst>
            <pc:docMk/>
            <pc:sldMk cId="4133689721" sldId="291"/>
            <ac:picMk id="83" creationId="{A4462DDA-028E-4B46-A397-B62DDA36E0A5}"/>
          </ac:picMkLst>
        </pc:picChg>
        <pc:picChg chg="add mod modCrop">
          <ac:chgData name="Nicholas Skiados" userId="" providerId="" clId="Web-{FCCDC3E0-5678-4F40-A2D6-0EB089DB3C91}" dt="2021-06-17T03:57:54.476" v="456" actId="1076"/>
          <ac:picMkLst>
            <pc:docMk/>
            <pc:sldMk cId="4133689721" sldId="291"/>
            <ac:picMk id="84" creationId="{9F2AA289-39DA-4F8F-A3F6-9329A4DB85F7}"/>
          </ac:picMkLst>
        </pc:picChg>
        <pc:picChg chg="add mod modCrop">
          <ac:chgData name="Nicholas Skiados" userId="" providerId="" clId="Web-{FCCDC3E0-5678-4F40-A2D6-0EB089DB3C91}" dt="2021-06-17T03:57:40.164" v="453" actId="1076"/>
          <ac:picMkLst>
            <pc:docMk/>
            <pc:sldMk cId="4133689721" sldId="291"/>
            <ac:picMk id="85" creationId="{BC52D881-4878-435B-835B-02EB8A51FBC2}"/>
          </ac:picMkLst>
        </pc:picChg>
        <pc:picChg chg="add">
          <ac:chgData name="Nicholas Skiados" userId="" providerId="" clId="Web-{FCCDC3E0-5678-4F40-A2D6-0EB089DB3C91}" dt="2021-06-17T03:50:02.807" v="382"/>
          <ac:picMkLst>
            <pc:docMk/>
            <pc:sldMk cId="4133689721" sldId="291"/>
            <ac:picMk id="109" creationId="{D6C5561E-139C-410B-B241-57623EABCE20}"/>
          </ac:picMkLst>
        </pc:picChg>
        <pc:picChg chg="add del topLvl">
          <ac:chgData name="Nicholas Skiados" userId="" providerId="" clId="Web-{FCCDC3E0-5678-4F40-A2D6-0EB089DB3C91}" dt="2021-06-17T03:53:59.767" v="417"/>
          <ac:picMkLst>
            <pc:docMk/>
            <pc:sldMk cId="4133689721" sldId="291"/>
            <ac:picMk id="113" creationId="{ED8674CF-87F2-4AE7-9D74-398DE70F1F5F}"/>
          </ac:picMkLst>
        </pc:picChg>
        <pc:picChg chg="add">
          <ac:chgData name="Nicholas Skiados" userId="" providerId="" clId="Web-{FCCDC3E0-5678-4F40-A2D6-0EB089DB3C91}" dt="2021-06-17T03:50:02.807" v="382"/>
          <ac:picMkLst>
            <pc:docMk/>
            <pc:sldMk cId="4133689721" sldId="291"/>
            <ac:picMk id="118" creationId="{BC86FA1B-87E3-4060-8FD4-4CBE9104E4C2}"/>
          </ac:picMkLst>
        </pc:picChg>
      </pc:sldChg>
    </pc:docChg>
  </pc:docChgLst>
  <pc:docChgLst>
    <pc:chgData name="Wencai Zhang" userId="4a86a1d0-2108-4707-8228-1110f3c1be85" providerId="ADAL" clId="{0E9FBDE7-7504-E948-96F8-38AF79E2A691}"/>
    <pc:docChg chg="undo custSel addSld delSld modSld sldOrd">
      <pc:chgData name="Wencai Zhang" userId="4a86a1d0-2108-4707-8228-1110f3c1be85" providerId="ADAL" clId="{0E9FBDE7-7504-E948-96F8-38AF79E2A691}" dt="2021-06-07T16:10:58.261" v="6984" actId="1036"/>
      <pc:docMkLst>
        <pc:docMk/>
      </pc:docMkLst>
      <pc:sldChg chg="addSp delSp modSp mod">
        <pc:chgData name="Wencai Zhang" userId="4a86a1d0-2108-4707-8228-1110f3c1be85" providerId="ADAL" clId="{0E9FBDE7-7504-E948-96F8-38AF79E2A691}" dt="2021-06-07T16:10:58.261" v="6984" actId="1036"/>
        <pc:sldMkLst>
          <pc:docMk/>
          <pc:sldMk cId="3242017852" sldId="272"/>
        </pc:sldMkLst>
        <pc:spChg chg="add del mod">
          <ac:chgData name="Wencai Zhang" userId="4a86a1d0-2108-4707-8228-1110f3c1be85" providerId="ADAL" clId="{0E9FBDE7-7504-E948-96F8-38AF79E2A691}" dt="2021-06-04T13:29:57.519" v="632"/>
          <ac:spMkLst>
            <pc:docMk/>
            <pc:sldMk cId="3242017852" sldId="272"/>
            <ac:spMk id="2" creationId="{5F257640-1672-1448-BF01-AB194C29CDE5}"/>
          </ac:spMkLst>
        </pc:spChg>
        <pc:spChg chg="add 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6" creationId="{25E80C11-7600-E44D-81B5-5295CE52183F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10" creationId="{37E76EB7-6695-2942-A4DD-33687AD229B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1" creationId="{61353381-AC7D-E848-A714-0811467522BE}"/>
          </ac:spMkLst>
        </pc:spChg>
        <pc:spChg chg="add del mod">
          <ac:chgData name="Wencai Zhang" userId="4a86a1d0-2108-4707-8228-1110f3c1be85" providerId="ADAL" clId="{0E9FBDE7-7504-E948-96F8-38AF79E2A691}" dt="2021-06-06T18:06:07.561" v="5881"/>
          <ac:spMkLst>
            <pc:docMk/>
            <pc:sldMk cId="3242017852" sldId="272"/>
            <ac:spMk id="14" creationId="{CC171099-367E-5341-9BE0-47394C53E414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5" creationId="{73A0757A-AC74-43FC-BBB2-E91DD12F5CD5}"/>
          </ac:spMkLst>
        </pc:spChg>
        <pc:spChg chg="add mod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7" creationId="{F7169A32-322E-B048-8904-C6E23785AA6B}"/>
          </ac:spMkLst>
        </pc:spChg>
        <pc:spChg chg="add del mod">
          <ac:chgData name="Wencai Zhang" userId="4a86a1d0-2108-4707-8228-1110f3c1be85" providerId="ADAL" clId="{0E9FBDE7-7504-E948-96F8-38AF79E2A691}" dt="2021-06-07T15:25:46.730" v="6533"/>
          <ac:spMkLst>
            <pc:docMk/>
            <pc:sldMk cId="3242017852" sldId="272"/>
            <ac:spMk id="18" creationId="{7095BA33-72EE-1C4E-8D4C-68F2B65BBEA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2" creationId="{119C059E-C733-4742-A0D4-D02B0A0755A1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3" creationId="{19318E2F-9580-484A-A2E4-97CB1BA629D3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4" creationId="{0743C9DB-C2C3-4D68-9AC6-CC11265D5C6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6" creationId="{C4308320-9356-44DD-9CD7-D86A1D1F07E5}"/>
          </ac:spMkLst>
        </pc:spChg>
        <pc:spChg chg="add del mod">
          <ac:chgData name="Wencai Zhang" userId="4a86a1d0-2108-4707-8228-1110f3c1be85" providerId="ADAL" clId="{0E9FBDE7-7504-E948-96F8-38AF79E2A691}" dt="2021-06-04T13:47:54.760" v="1029" actId="478"/>
          <ac:spMkLst>
            <pc:docMk/>
            <pc:sldMk cId="3242017852" sldId="272"/>
            <ac:spMk id="27" creationId="{B8BB5661-578C-3449-81F6-A18D256DC1F0}"/>
          </ac:spMkLst>
        </pc:spChg>
        <pc:spChg chg="add del mod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28" creationId="{4F6A7040-8CF6-FE42-A9B1-8FE2A1B785AF}"/>
          </ac:spMkLst>
        </pc:spChg>
        <pc:spChg chg="add del mod">
          <ac:chgData name="Wencai Zhang" userId="4a86a1d0-2108-4707-8228-1110f3c1be85" providerId="ADAL" clId="{0E9FBDE7-7504-E948-96F8-38AF79E2A691}" dt="2021-06-04T13:11:40.620" v="111" actId="478"/>
          <ac:spMkLst>
            <pc:docMk/>
            <pc:sldMk cId="3242017852" sldId="272"/>
            <ac:spMk id="30" creationId="{262C642B-3E85-8041-98B6-F8977DF03FE7}"/>
          </ac:spMkLst>
        </pc:spChg>
        <pc:spChg chg="add del mod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31" creationId="{CFB14A73-1FED-A84E-A774-270B22968B9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2" creationId="{E7D8A89C-5DD3-434D-B0F9-4FFE362E8493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3" creationId="{AD8D757C-C30A-EB43-B121-3175844E2FA4}"/>
          </ac:spMkLst>
        </pc:spChg>
        <pc:spChg chg="add del mod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34" creationId="{523A8D83-B69F-6A4A-A32A-DEC4D5AB989F}"/>
          </ac:spMkLst>
        </pc:spChg>
        <pc:spChg chg="del">
          <ac:chgData name="Wencai Zhang" userId="4a86a1d0-2108-4707-8228-1110f3c1be85" providerId="ADAL" clId="{0E9FBDE7-7504-E948-96F8-38AF79E2A691}" dt="2021-06-04T14:09:10.733" v="1794" actId="478"/>
          <ac:spMkLst>
            <pc:docMk/>
            <pc:sldMk cId="3242017852" sldId="272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38" creationId="{98E3AEB7-E4F5-9641-BA6E-0981E5B19A0C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9" creationId="{551B349F-03B8-DC44-85FE-1EE2F30F37B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1" creationId="{05C57CC4-2015-234E-8A6B-3FD17DD61D97}"/>
          </ac:spMkLst>
        </pc:spChg>
        <pc:spChg chg="del mod topLvl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41" creationId="{52E39B38-76C3-2E40-ACFF-B7344B631EF8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2" creationId="{37CC8807-4F76-1947-AC19-60B810D99851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2" creationId="{B6BBFF1F-DD97-8A45-A1BE-EFFC7A1DBE17}"/>
          </ac:spMkLst>
        </pc:spChg>
        <pc:spChg chg="del mod topLvl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43" creationId="{31D8A5C9-0774-2F4B-A5A1-34437DAF3AA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4" creationId="{89BCA8F2-1741-1740-A4FA-E39C34601AD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5" creationId="{144FF4C7-47D0-254C-B9B6-542992DC4A4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6" creationId="{2FD6981F-D417-BF40-B127-245C841203C0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6" creationId="{666E4FE3-E6F6-1242-B0B6-D127D01063C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7" creationId="{7573BBB2-B64F-A649-A186-CB45101E4CA4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47" creationId="{EF36298A-CA3E-CD4F-A886-5289E3E6EEC3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48" creationId="{BCDE73A0-A105-2442-9DB2-CA24027665D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9" creationId="{D82F64E3-B693-3E47-B639-B6C918AB91C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0" creationId="{A0C95532-2C22-7343-AC27-F297CE1BECB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1" creationId="{009F4F04-6D19-564F-9123-4184998AE4C7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51" creationId="{9A29C4EA-29C5-DF4A-B73B-D243E8335F18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2" creationId="{4EBE9D99-D109-1544-BFB0-DCDC5827BCC9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52" creationId="{E4178DFB-BFB3-0743-AC13-BA8DBDE8CFA9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53" creationId="{C924241F-3BC8-594B-8905-B561F9D0020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4" creationId="{85EE4A3E-131F-154D-A684-CD6E595E2ADB}"/>
          </ac:spMkLst>
        </pc:spChg>
        <pc:spChg chg="add del mod">
          <ac:chgData name="Wencai Zhang" userId="4a86a1d0-2108-4707-8228-1110f3c1be85" providerId="ADAL" clId="{0E9FBDE7-7504-E948-96F8-38AF79E2A691}" dt="2021-06-04T14:08:45.107" v="1792" actId="478"/>
          <ac:spMkLst>
            <pc:docMk/>
            <pc:sldMk cId="3242017852" sldId="272"/>
            <ac:spMk id="54" creationId="{D0892F71-2B40-C746-B966-53E260EE01F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9" creationId="{EB44D005-E90D-074C-AD4E-F55FC9DDD341}"/>
          </ac:spMkLst>
        </pc:spChg>
        <pc:spChg chg="add del mod topLvl">
          <ac:chgData name="Wencai Zhang" userId="4a86a1d0-2108-4707-8228-1110f3c1be85" providerId="ADAL" clId="{0E9FBDE7-7504-E948-96F8-38AF79E2A691}" dt="2021-06-06T16:21:06.513" v="5821" actId="478"/>
          <ac:spMkLst>
            <pc:docMk/>
            <pc:sldMk cId="3242017852" sldId="272"/>
            <ac:spMk id="60" creationId="{3973D982-89C4-A14A-BEBC-B02DD2F41896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1" creationId="{83D4EDD7-402D-C44E-8C12-80E5C60B6F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2" creationId="{1E261997-15B1-5B47-9CD8-5196E34E590B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3" creationId="{8C377F89-DAB3-D644-9397-AA6C264B158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3" creationId="{9B3209CC-5380-0F46-9A05-D1DAC4FEDF2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4" creationId="{B4837D33-AA29-F44E-B82F-CF018DE447A1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4" creationId="{B59ABC73-B9E9-044A-A395-B63AC5CD14D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5" creationId="{3DFB711B-8B90-1240-B6A8-D19F09136C23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6" creationId="{FF517956-7D11-5045-BAB3-D0FBDAA68E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7" creationId="{5A88E887-9896-2742-9FBE-A90372B280F9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8" creationId="{E76224F7-D762-6B4A-8132-BE95ED59A120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9" creationId="{1B56E517-81CF-064C-95B9-BB828A0B3D29}"/>
          </ac:spMkLst>
        </pc:spChg>
        <pc:spChg chg="add del mod topLvl">
          <ac:chgData name="Wencai Zhang" userId="4a86a1d0-2108-4707-8228-1110f3c1be85" providerId="ADAL" clId="{0E9FBDE7-7504-E948-96F8-38AF79E2A691}" dt="2021-06-06T16:21:02.367" v="5820" actId="478"/>
          <ac:spMkLst>
            <pc:docMk/>
            <pc:sldMk cId="3242017852" sldId="272"/>
            <ac:spMk id="70" creationId="{555DC667-6217-A340-9E57-41A9F9AFCDD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1" creationId="{9B63982C-9423-B641-9499-4AB2C87BF98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6" creationId="{9A59F463-DF57-BD49-8378-B4332DE229CE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8" creationId="{4CA5DA5A-A6B5-B141-850D-A3D9742277BC}"/>
          </ac:spMkLst>
        </pc:spChg>
        <pc:spChg chg="del">
          <ac:chgData name="Wencai Zhang" userId="4a86a1d0-2108-4707-8228-1110f3c1be85" providerId="ADAL" clId="{0E9FBDE7-7504-E948-96F8-38AF79E2A691}" dt="2021-06-04T14:22:23.066" v="1931" actId="478"/>
          <ac:spMkLst>
            <pc:docMk/>
            <pc:sldMk cId="3242017852" sldId="272"/>
            <ac:spMk id="78" creationId="{73A0757A-AC74-43FC-BBB2-E91DD12F5CD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9" creationId="{F0A85EFF-8CA7-4595-8ED1-A933E3DC9B9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1" creationId="{FB416D89-ADA2-8E40-A639-5D4FC6FE107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3" creationId="{B6BA3F67-07C4-2E43-B61A-70A5D59F196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5" creationId="{08BD4463-344C-AD42-BFF9-D2126DB12D85}"/>
          </ac:spMkLst>
        </pc:spChg>
        <pc:spChg chg="mod">
          <ac:chgData name="Wencai Zhang" userId="4a86a1d0-2108-4707-8228-1110f3c1be85" providerId="ADAL" clId="{0E9FBDE7-7504-E948-96F8-38AF79E2A691}" dt="2021-06-06T16:10:45.337" v="5757" actId="1076"/>
          <ac:spMkLst>
            <pc:docMk/>
            <pc:sldMk cId="3242017852" sldId="272"/>
            <ac:spMk id="86" creationId="{00000000-0000-0000-0000-00000000000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8" creationId="{EA35BA7A-194E-2B4D-BA54-51FA2F74DF4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2" creationId="{8B05DB7D-9BE7-8F4A-BF0F-B1DD9C85DA7D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4" creationId="{F1468978-1A99-DF42-B2DA-37AEC9EE9B6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7" creationId="{B827967C-2BC7-8C4D-BBC4-52F213E60DA9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8" creationId="{74880200-7BB5-E749-A573-0A31C9D273B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9" creationId="{757384F2-F6BF-F240-AAAD-73516C30413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0" creationId="{5CEABA1C-48AB-8647-8F28-62E420DDE20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1" creationId="{4B94BE8B-572F-5C4C-ABF9-ECCCD1ED301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3" creationId="{49A8B912-C125-EB4C-9D89-4E536C209009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5" creationId="{324671B9-B13B-7E46-B282-DD567A3D528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6" creationId="{039B60E9-071E-A547-9286-C0869E41AE35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7" creationId="{FA29B9EF-BE13-FD4B-994F-ECE9F7A1D168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8" creationId="{1582FA05-1A7C-F54A-ACE3-44D7C27E476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9" creationId="{AD56C4DF-9A1E-7A4E-AC09-EBD168137DA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0" creationId="{57F85060-372F-594C-9196-16A46479B30B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1" creationId="{55B8ABC8-1071-8F46-8EC7-3E72A05B2F3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2" creationId="{F1CAEAA9-F980-DC4E-853A-198ED52C1077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14" creationId="{560F9739-AE91-E14F-A72C-229CB273C2C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5" creationId="{CF6CD96D-1E3B-2648-B127-72770E0C05B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7" creationId="{7486C78F-C24F-9246-A8D3-C3B4808B817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19" creationId="{6AF6553F-3C31-EE44-8578-7CFE050FF54B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0" creationId="{2C4FD043-317B-A949-B9FD-AFD5D529F261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5" creationId="{B8241A98-BD3C-2B44-B42F-E00E91B351C9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6" creationId="{3B37581F-4FE7-2044-848A-A0B20CF5AF9F}"/>
          </ac:spMkLst>
        </pc:spChg>
        <pc:spChg chg="del mod">
          <ac:chgData name="Wencai Zhang" userId="4a86a1d0-2108-4707-8228-1110f3c1be85" providerId="ADAL" clId="{0E9FBDE7-7504-E948-96F8-38AF79E2A691}" dt="2021-06-05T00:41:06.771" v="2748" actId="478"/>
          <ac:spMkLst>
            <pc:docMk/>
            <pc:sldMk cId="3242017852" sldId="272"/>
            <ac:spMk id="127" creationId="{9634DDBD-B0EB-3149-8A4D-BC00C4CB5ED4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8" creationId="{5E907FC5-52AF-4643-9EC3-69405E989E4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31" creationId="{550FE903-1811-EF48-A1B8-FF735FB9F49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2" creationId="{3DF5FE96-AD62-ED4E-91F2-27C62CC21035}"/>
          </ac:spMkLst>
        </pc:spChg>
        <pc:spChg chg="del mod">
          <ac:chgData name="Wencai Zhang" userId="4a86a1d0-2108-4707-8228-1110f3c1be85" providerId="ADAL" clId="{0E9FBDE7-7504-E948-96F8-38AF79E2A691}" dt="2021-06-05T00:37:04.225" v="2635" actId="478"/>
          <ac:spMkLst>
            <pc:docMk/>
            <pc:sldMk cId="3242017852" sldId="272"/>
            <ac:spMk id="133" creationId="{54602C90-2E14-B244-9CCC-B04A0598F554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4" creationId="{047EABF3-31AE-FB43-B5DD-1604602B48C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5" creationId="{B48D9B35-7E39-2E49-8EE5-821BFC4661C9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6" creationId="{9346785B-AFE6-2144-BA16-D060A7E0DE3A}"/>
          </ac:spMkLst>
        </pc:spChg>
        <pc:spChg chg="add del mod">
          <ac:chgData name="Wencai Zhang" userId="4a86a1d0-2108-4707-8228-1110f3c1be85" providerId="ADAL" clId="{0E9FBDE7-7504-E948-96F8-38AF79E2A691}" dt="2021-06-05T18:50:08.581" v="4008" actId="478"/>
          <ac:spMkLst>
            <pc:docMk/>
            <pc:sldMk cId="3242017852" sldId="272"/>
            <ac:spMk id="138" creationId="{A4F88564-FB45-494F-A500-F3EAA217FC1E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8" creationId="{C4FFD44A-0376-3849-8336-6A99E0C21B51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9" creationId="{17643FC6-9E5E-E746-8A91-FE38DACD16A7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41" creationId="{EF23DE7A-3432-7B4A-8838-F65287D4ADD5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4" creationId="{26E32EED-1551-7448-A92A-85AE4FD33D86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45" creationId="{1C6065E1-6EF7-5D47-9010-FBAD30FA814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6" creationId="{0143FAEC-2918-7642-B01E-B1C62000098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9" creationId="{BDE54864-131E-C449-B5C3-100A2A0DD68D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1" creationId="{8D588FF3-C5B7-EB4C-92AF-E20C07CDDD47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2" creationId="{B2996674-BD81-A944-A187-6112C872B32E}"/>
          </ac:spMkLst>
        </pc:spChg>
        <pc:spChg chg="mod">
          <ac:chgData name="Wencai Zhang" userId="4a86a1d0-2108-4707-8228-1110f3c1be85" providerId="ADAL" clId="{0E9FBDE7-7504-E948-96F8-38AF79E2A691}" dt="2021-06-06T16:15:35.490" v="5772" actId="207"/>
          <ac:spMkLst>
            <pc:docMk/>
            <pc:sldMk cId="3242017852" sldId="272"/>
            <ac:spMk id="154" creationId="{19BDB247-BCE1-DD40-8FDE-8E727BFCA7C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5" creationId="{A98A02D4-5713-B941-9FEC-ED4FF54BD66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7" creationId="{2CDE7BEB-9ED7-B64B-AFE7-6473F16F45FF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9" creationId="{84AFAC13-E366-DE4C-AB5B-9B492483659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0" creationId="{F4B28066-6EC4-4F4B-BEDE-E392D7F685D9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2" creationId="{21D2D76C-1D04-C947-BDD6-0B1A2EDD76DD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4" creationId="{82DBD88E-2361-4D44-B048-37A892383F0A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5" creationId="{73FD3E4E-E4E8-454A-BCEB-B1A1CDF3702F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7" creationId="{A4CCA9F6-B1D3-0544-8359-DF7ABA905F4C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8" creationId="{1C2C655F-993D-3F4D-9974-FADCE177E5D2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9" creationId="{97C01C85-E7DE-A342-91FC-AA200FC3706B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0" creationId="{53D34576-2342-5A4E-AFCD-084DEE683CE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1" creationId="{2A6C052A-4168-414A-AC07-BC078F9103B3}"/>
          </ac:spMkLst>
        </pc:spChg>
        <pc:spChg chg="add mod topLvl">
          <ac:chgData name="Wencai Zhang" userId="4a86a1d0-2108-4707-8228-1110f3c1be85" providerId="ADAL" clId="{0E9FBDE7-7504-E948-96F8-38AF79E2A691}" dt="2021-06-06T16:19:11.523" v="5819" actId="1076"/>
          <ac:spMkLst>
            <pc:docMk/>
            <pc:sldMk cId="3242017852" sldId="272"/>
            <ac:spMk id="172" creationId="{ED09868F-F3BC-F748-82C8-DE2537285D1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3" creationId="{E6F050D7-3FB5-B84C-A0A4-13CC5032B4B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4" creationId="{772C2F64-D0CB-794D-A688-AE5D87C04FC4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5" creationId="{0A4D0736-69FB-A241-BBB9-1C5D73309A51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6" creationId="{8AC0A7E0-85AB-1B40-BF4F-68B6AC3286C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7" creationId="{7B9A2A0A-A737-8249-8285-20EEE828D37B}"/>
          </ac:spMkLst>
        </pc:spChg>
        <pc:spChg chg="add mod topLvl">
          <ac:chgData name="Wencai Zhang" userId="4a86a1d0-2108-4707-8228-1110f3c1be85" providerId="ADAL" clId="{0E9FBDE7-7504-E948-96F8-38AF79E2A691}" dt="2021-06-06T16:15:29.258" v="5771" actId="207"/>
          <ac:spMkLst>
            <pc:docMk/>
            <pc:sldMk cId="3242017852" sldId="272"/>
            <ac:spMk id="180" creationId="{65144C8B-EE53-1E4C-ABB8-FCFC397D08F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1" creationId="{4A10CFC8-E628-1345-9CC9-1E154CC7592B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2" creationId="{3E61F479-3743-E445-8731-64B72FBA76CD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3" creationId="{8749B5D8-1F1C-954A-8E0E-3C6B9A601745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5" creationId="{0F4F80C2-6B31-3040-8127-2AFE0638B79C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6" creationId="{F01D7D07-280E-2D4F-84ED-471D1302D822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7" creationId="{10232C51-24EA-A149-A73A-7906819B1C4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8" creationId="{1707996F-23E9-4E44-835F-DC88C35D7D9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9" creationId="{264229A6-C908-A546-80B8-F5E94AEBFC9D}"/>
          </ac:spMkLst>
        </pc:spChg>
        <pc:spChg chg="add del mod">
          <ac:chgData name="Wencai Zhang" userId="4a86a1d0-2108-4707-8228-1110f3c1be85" providerId="ADAL" clId="{0E9FBDE7-7504-E948-96F8-38AF79E2A691}" dt="2021-06-07T12:55:16.840" v="6317" actId="478"/>
          <ac:spMkLst>
            <pc:docMk/>
            <pc:sldMk cId="3242017852" sldId="272"/>
            <ac:spMk id="191" creationId="{0C7B1819-565D-B247-98A6-27C91595DF19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4" creationId="{E0560FE1-75FC-EB4E-BFE2-A7B9DC321D51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5" creationId="{FCFF7300-7F73-F447-B3FE-91DD5B517B3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6" creationId="{93957E41-D61D-A846-BBC9-1804DC6F7B8A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7" creationId="{4EEA38C4-D915-2D4A-99E4-AADCE4B8A3C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8" creationId="{05670B73-5C63-6544-9B4C-D79BB9DABF5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9" creationId="{B1299830-EE68-D742-A511-A841846D2E7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0" creationId="{0F8A25C4-05A0-B649-9001-85E2E57D77D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4" creationId="{8DD94CE5-3FDF-8D49-B907-928FD99BAC7E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5" creationId="{888FCFE7-5505-4741-8BB8-A84C1F3CB558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09" creationId="{5016763D-2A7E-EC45-A36D-27C149ECF8D6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13" creationId="{F00BDF11-FD76-9E4D-92DD-65342E85E5EE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19" creationId="{4DFFC7C1-C262-D84B-B37D-D418CC2B44D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0" creationId="{C753CA9A-24DE-1448-8C84-5FBCD56DA6A2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1" creationId="{2F98D0C5-1C90-A948-AEBD-807BB9C093AA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2" creationId="{3F3FBA2E-6E41-494A-B4AA-433133A70710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4" creationId="{73A922F8-B8F6-0E49-87B5-BE3FC4BA48C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6" creationId="{F628E4D9-F7A3-3241-AA59-0B4702E3F498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7" creationId="{6834918A-E009-BD4A-BA9A-DF084F1CE0EE}"/>
          </ac:spMkLst>
        </pc:spChg>
        <pc:spChg chg="mod">
          <ac:chgData name="Wencai Zhang" userId="4a86a1d0-2108-4707-8228-1110f3c1be85" providerId="ADAL" clId="{0E9FBDE7-7504-E948-96F8-38AF79E2A691}" dt="2021-06-07T16:05:24.201" v="6892" actId="1035"/>
          <ac:spMkLst>
            <pc:docMk/>
            <pc:sldMk cId="3242017852" sldId="272"/>
            <ac:spMk id="230" creationId="{CCF939D2-A404-3D4A-8F4A-5AF08A395C1F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2" creationId="{FD920D99-A7D1-AA4B-A83B-34CF13351773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3" creationId="{00C045AB-36C3-6743-86B8-8EBBC7E7A178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4" creationId="{1F39223C-EE50-0E43-BAE0-84D214654983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5" creationId="{EA10B2EF-CACD-FB43-A830-753F266192DC}"/>
          </ac:spMkLst>
        </pc:spChg>
        <pc:spChg chg="mod">
          <ac:chgData name="Wencai Zhang" userId="4a86a1d0-2108-4707-8228-1110f3c1be85" providerId="ADAL" clId="{0E9FBDE7-7504-E948-96F8-38AF79E2A691}" dt="2021-06-07T16:09:31.988" v="6956" actId="20577"/>
          <ac:spMkLst>
            <pc:docMk/>
            <pc:sldMk cId="3242017852" sldId="272"/>
            <ac:spMk id="236" creationId="{6600A3DD-2531-D849-AF84-78DC1C920A61}"/>
          </ac:spMkLst>
        </pc:spChg>
        <pc:spChg chg="add mod">
          <ac:chgData name="Wencai Zhang" userId="4a86a1d0-2108-4707-8228-1110f3c1be85" providerId="ADAL" clId="{0E9FBDE7-7504-E948-96F8-38AF79E2A691}" dt="2021-06-07T15:47:53.455" v="6800" actId="20577"/>
          <ac:spMkLst>
            <pc:docMk/>
            <pc:sldMk cId="3242017852" sldId="272"/>
            <ac:spMk id="237" creationId="{EDCFD7CC-11F9-934C-BC9A-B9EA0F24D49B}"/>
          </ac:spMkLst>
        </pc:spChg>
        <pc:spChg chg="add mod">
          <ac:chgData name="Wencai Zhang" userId="4a86a1d0-2108-4707-8228-1110f3c1be85" providerId="ADAL" clId="{0E9FBDE7-7504-E948-96F8-38AF79E2A691}" dt="2021-06-07T16:08:13.752" v="6944" actId="20577"/>
          <ac:spMkLst>
            <pc:docMk/>
            <pc:sldMk cId="3242017852" sldId="272"/>
            <ac:spMk id="238" creationId="{464C8492-EDEF-994E-83AC-252A679BC9CB}"/>
          </ac:spMkLst>
        </pc:spChg>
        <pc:spChg chg="add mod">
          <ac:chgData name="Wencai Zhang" userId="4a86a1d0-2108-4707-8228-1110f3c1be85" providerId="ADAL" clId="{0E9FBDE7-7504-E948-96F8-38AF79E2A691}" dt="2021-06-07T16:09:26.565" v="6955" actId="1038"/>
          <ac:spMkLst>
            <pc:docMk/>
            <pc:sldMk cId="3242017852" sldId="272"/>
            <ac:spMk id="239" creationId="{57252B6C-EA1C-2849-A41E-B14B57B362DA}"/>
          </ac:spMkLst>
        </pc:s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2" creationId="{96451E40-1371-C64D-9BFA-6472B2ABF063}"/>
          </ac:grpSpMkLst>
        </pc:grpChg>
        <pc:grpChg chg="add del mod">
          <ac:chgData name="Wencai Zhang" userId="4a86a1d0-2108-4707-8228-1110f3c1be85" providerId="ADAL" clId="{0E9FBDE7-7504-E948-96F8-38AF79E2A691}" dt="2021-06-05T01:23:04.363" v="3713" actId="165"/>
          <ac:grpSpMkLst>
            <pc:docMk/>
            <pc:sldMk cId="3242017852" sldId="272"/>
            <ac:grpSpMk id="2" creationId="{E9F47427-BF8B-E346-8F2B-B3E11EDCFE17}"/>
          </ac:grpSpMkLst>
        </pc:grpChg>
        <pc:grpChg chg="add del mod topLvl">
          <ac:chgData name="Wencai Zhang" userId="4a86a1d0-2108-4707-8228-1110f3c1be85" providerId="ADAL" clId="{0E9FBDE7-7504-E948-96F8-38AF79E2A691}" dt="2021-06-05T19:01:36.967" v="4380" actId="165"/>
          <ac:grpSpMkLst>
            <pc:docMk/>
            <pc:sldMk cId="3242017852" sldId="272"/>
            <ac:grpSpMk id="4" creationId="{354ADFBC-4B3E-9440-8050-E1F2783F16F1}"/>
          </ac:grpSpMkLst>
        </pc:grpChg>
        <pc:grpChg chg="add del mod topLvl">
          <ac:chgData name="Wencai Zhang" userId="4a86a1d0-2108-4707-8228-1110f3c1be85" providerId="ADAL" clId="{0E9FBDE7-7504-E948-96F8-38AF79E2A691}" dt="2021-06-05T19:01:28.780" v="4379" actId="165"/>
          <ac:grpSpMkLst>
            <pc:docMk/>
            <pc:sldMk cId="3242017852" sldId="272"/>
            <ac:grpSpMk id="6" creationId="{49492A4F-6FB3-9949-A6F2-BE64FD8C9307}"/>
          </ac:grpSpMkLst>
        </pc:grpChg>
        <pc:grpChg chg="add del mod topLvl">
          <ac:chgData name="Wencai Zhang" userId="4a86a1d0-2108-4707-8228-1110f3c1be85" providerId="ADAL" clId="{0E9FBDE7-7504-E948-96F8-38AF79E2A691}" dt="2021-06-05T19:01:22.877" v="4378" actId="165"/>
          <ac:grpSpMkLst>
            <pc:docMk/>
            <pc:sldMk cId="3242017852" sldId="272"/>
            <ac:grpSpMk id="7" creationId="{E14CDA51-E599-5944-8FA0-53FEF6C2AB13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8" creationId="{63650F43-37FA-564D-A530-06A0FD37A9AC}"/>
          </ac:grpSpMkLst>
        </pc:grpChg>
        <pc:grpChg chg="add del mod topLvl">
          <ac:chgData name="Wencai Zhang" userId="4a86a1d0-2108-4707-8228-1110f3c1be85" providerId="ADAL" clId="{0E9FBDE7-7504-E948-96F8-38AF79E2A691}" dt="2021-06-05T01:23:10.018" v="3714" actId="165"/>
          <ac:grpSpMkLst>
            <pc:docMk/>
            <pc:sldMk cId="3242017852" sldId="272"/>
            <ac:grpSpMk id="8" creationId="{8CA837C9-C190-1B40-9256-1EE947A6FD86}"/>
          </ac:grpSpMkLst>
        </pc:grpChg>
        <pc:grpChg chg="add del mod">
          <ac:chgData name="Wencai Zhang" userId="4a86a1d0-2108-4707-8228-1110f3c1be85" providerId="ADAL" clId="{0E9FBDE7-7504-E948-96F8-38AF79E2A691}" dt="2021-06-05T19:01:16.441" v="4377" actId="165"/>
          <ac:grpSpMkLst>
            <pc:docMk/>
            <pc:sldMk cId="3242017852" sldId="272"/>
            <ac:grpSpMk id="9" creationId="{5E67DB86-5AD0-C24C-A32C-4ACEFCBD5689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0" creationId="{A3DB4826-253E-FC4D-B80F-75E9B031D921}"/>
          </ac:grpSpMkLst>
        </pc:grpChg>
        <pc:grpChg chg="add del 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2" creationId="{2B060A58-0D67-D54F-942B-E894016554BF}"/>
          </ac:grpSpMkLst>
        </pc:grpChg>
        <pc:grpChg chg="add mod">
          <ac:chgData name="Wencai Zhang" userId="4a86a1d0-2108-4707-8228-1110f3c1be85" providerId="ADAL" clId="{0E9FBDE7-7504-E948-96F8-38AF79E2A691}" dt="2021-06-06T16:17:34.680" v="5800" actId="1076"/>
          <ac:grpSpMkLst>
            <pc:docMk/>
            <pc:sldMk cId="3242017852" sldId="272"/>
            <ac:grpSpMk id="13" creationId="{AC403E60-D88B-BB4F-B665-75038169A67A}"/>
          </ac:grpSpMkLst>
        </pc:grpChg>
        <pc:grpChg chg="add del mod">
          <ac:chgData name="Wencai Zhang" userId="4a86a1d0-2108-4707-8228-1110f3c1be85" providerId="ADAL" clId="{0E9FBDE7-7504-E948-96F8-38AF79E2A691}" dt="2021-06-07T13:35:37.394" v="6319" actId="21"/>
          <ac:grpSpMkLst>
            <pc:docMk/>
            <pc:sldMk cId="3242017852" sldId="272"/>
            <ac:grpSpMk id="16" creationId="{5740A042-AE64-E947-B96B-5C275F8FD348}"/>
          </ac:grpSpMkLst>
        </pc:grpChg>
        <pc:grpChg chg="add del 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19" creationId="{9B075010-9D16-7A4A-9810-5D275D15574B}"/>
          </ac:grpSpMkLst>
        </pc:grpChg>
        <pc:grpChg chg="add mod">
          <ac:chgData name="Wencai Zhang" userId="4a86a1d0-2108-4707-8228-1110f3c1be85" providerId="ADAL" clId="{0E9FBDE7-7504-E948-96F8-38AF79E2A691}" dt="2021-06-07T16:10:58.261" v="6984" actId="1036"/>
          <ac:grpSpMkLst>
            <pc:docMk/>
            <pc:sldMk cId="3242017852" sldId="272"/>
            <ac:grpSpMk id="20" creationId="{321DAD19-E9D0-234C-821C-5E044A313399}"/>
          </ac:grpSpMkLst>
        </pc:grpChg>
        <pc:grpChg chg="del">
          <ac:chgData name="Wencai Zhang" userId="4a86a1d0-2108-4707-8228-1110f3c1be85" providerId="ADAL" clId="{0E9FBDE7-7504-E948-96F8-38AF79E2A691}" dt="2021-06-04T13:38:40.507" v="888" actId="165"/>
          <ac:grpSpMkLst>
            <pc:docMk/>
            <pc:sldMk cId="3242017852" sldId="272"/>
            <ac:grpSpMk id="20" creationId="{FB81241A-3117-4851-B42E-B4314B35BAC6}"/>
          </ac:grpSpMkLst>
        </pc:grpChg>
        <pc:grpChg chg="add mod">
          <ac:chgData name="Wencai Zhang" userId="4a86a1d0-2108-4707-8228-1110f3c1be85" providerId="ADAL" clId="{0E9FBDE7-7504-E948-96F8-38AF79E2A691}" dt="2021-06-07T16:10:48.760" v="6970" actId="1037"/>
          <ac:grpSpMkLst>
            <pc:docMk/>
            <pc:sldMk cId="3242017852" sldId="272"/>
            <ac:grpSpMk id="21" creationId="{610A4869-03EC-1B41-8D3D-3FB9BFEF5751}"/>
          </ac:grpSpMkLst>
        </pc:grpChg>
        <pc:grpChg chg="add del mod">
          <ac:chgData name="Wencai Zhang" userId="4a86a1d0-2108-4707-8228-1110f3c1be85" providerId="ADAL" clId="{0E9FBDE7-7504-E948-96F8-38AF79E2A691}" dt="2021-06-04T13:27:58.918" v="564" actId="165"/>
          <ac:grpSpMkLst>
            <pc:docMk/>
            <pc:sldMk cId="3242017852" sldId="272"/>
            <ac:grpSpMk id="35" creationId="{51063E9A-67AF-2943-B19E-150E559E81F5}"/>
          </ac:grpSpMkLst>
        </pc:grpChg>
        <pc:grpChg chg="add del mod topLvl">
          <ac:chgData name="Wencai Zhang" userId="4a86a1d0-2108-4707-8228-1110f3c1be85" providerId="ADAL" clId="{0E9FBDE7-7504-E948-96F8-38AF79E2A691}" dt="2021-06-05T19:01:42.825" v="4381" actId="165"/>
          <ac:grpSpMkLst>
            <pc:docMk/>
            <pc:sldMk cId="3242017852" sldId="272"/>
            <ac:grpSpMk id="38" creationId="{65E445E1-A66F-214E-9561-6DF2106F128A}"/>
          </ac:grpSpMkLst>
        </pc:grpChg>
        <pc:grpChg chg="add del mod">
          <ac:chgData name="Wencai Zhang" userId="4a86a1d0-2108-4707-8228-1110f3c1be85" providerId="ADAL" clId="{0E9FBDE7-7504-E948-96F8-38AF79E2A691}" dt="2021-06-04T13:30:07.520" v="634" actId="165"/>
          <ac:grpSpMkLst>
            <pc:docMk/>
            <pc:sldMk cId="3242017852" sldId="272"/>
            <ac:grpSpMk id="44" creationId="{10DEF4D6-8D8A-3D4B-A3D3-FECD9DAC3138}"/>
          </ac:grpSpMkLst>
        </pc:grpChg>
        <pc:grpChg chg="add del mod">
          <ac:chgData name="Wencai Zhang" userId="4a86a1d0-2108-4707-8228-1110f3c1be85" providerId="ADAL" clId="{0E9FBDE7-7504-E948-96F8-38AF79E2A691}" dt="2021-06-04T13:30:03.365" v="633" actId="165"/>
          <ac:grpSpMkLst>
            <pc:docMk/>
            <pc:sldMk cId="3242017852" sldId="272"/>
            <ac:grpSpMk id="49" creationId="{3495787A-4630-0E4B-B552-D7D4B8720C7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72" creationId="{AD5D29D9-F224-7442-82B6-47A39739BDE3}"/>
          </ac:grpSpMkLst>
        </pc:grpChg>
        <pc:grpChg chg="add del mod">
          <ac:chgData name="Wencai Zhang" userId="4a86a1d0-2108-4707-8228-1110f3c1be85" providerId="ADAL" clId="{0E9FBDE7-7504-E948-96F8-38AF79E2A691}" dt="2021-06-05T01:33:44.073" v="3865" actId="478"/>
          <ac:grpSpMkLst>
            <pc:docMk/>
            <pc:sldMk cId="3242017852" sldId="272"/>
            <ac:grpSpMk id="104" creationId="{E7BE4163-42DD-C746-AC41-13DAEDE4DDA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3" creationId="{2CFCACE0-7922-9447-8B15-77999B4E56B8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8" creationId="{C1E4D236-88F6-DB40-85DC-62A33FB83DA5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3" creationId="{59F927BF-74AD-C041-96FC-5652C77AD954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9" creationId="{9A82BBAA-EAAC-F540-9A33-A6469F4B6949}"/>
          </ac:grpSpMkLst>
        </pc:grpChg>
        <pc:grpChg chg="add del mod">
          <ac:chgData name="Wencai Zhang" userId="4a86a1d0-2108-4707-8228-1110f3c1be85" providerId="ADAL" clId="{0E9FBDE7-7504-E948-96F8-38AF79E2A691}" dt="2021-06-05T01:10:06.874" v="3339" actId="478"/>
          <ac:grpSpMkLst>
            <pc:docMk/>
            <pc:sldMk cId="3242017852" sldId="272"/>
            <ac:grpSpMk id="137" creationId="{5251AE5F-A5A4-D64B-A651-B5932CD3874D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2" creationId="{7E5599CF-FFA7-3C47-A32C-1C8928C6A9B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48" creationId="{85FA1841-1F1B-6346-901B-3D9BA860663C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3" creationId="{20EA76E5-E707-784F-87C5-7744178C06F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8" creationId="{A27194E5-D149-6A41-8DF8-77D640F31ED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3" creationId="{01406731-5A2F-DE48-90BD-80BF3AE9D6A0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8" creationId="{A09C9EB4-CD43-1043-8733-F82B55937457}"/>
          </ac:grpSpMkLst>
        </pc:grpChg>
        <pc:grpChg chg="add del mod">
          <ac:chgData name="Wencai Zhang" userId="4a86a1d0-2108-4707-8228-1110f3c1be85" providerId="ADAL" clId="{0E9FBDE7-7504-E948-96F8-38AF79E2A691}" dt="2021-06-07T15:43:42.743" v="6616" actId="165"/>
          <ac:grpSpMkLst>
            <pc:docMk/>
            <pc:sldMk cId="3242017852" sldId="272"/>
            <ac:grpSpMk id="192" creationId="{18599102-6043-BD4A-8386-ECEE87DF803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193" creationId="{B28A1FD1-A220-654D-A3D3-A59446D3E45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6" creationId="{1AE4CE81-DAC5-224C-8545-40891CE139F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7" creationId="{AD9B821E-C422-E04A-A103-D3A5ED9BAAED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8" creationId="{73C4B178-CF0D-5C47-9FAC-E0CA86EFB7CA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0" creationId="{88DCF839-11FB-4343-BE18-49AD2DB34376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4" creationId="{7B7A8594-ADCC-6C45-AB93-BE6A34224418}"/>
          </ac:grpSpMkLst>
        </pc:grpChg>
        <pc:grpChg chg="add mod">
          <ac:chgData name="Wencai Zhang" userId="4a86a1d0-2108-4707-8228-1110f3c1be85" providerId="ADAL" clId="{0E9FBDE7-7504-E948-96F8-38AF79E2A691}" dt="2021-06-07T16:06:27.931" v="6930" actId="164"/>
          <ac:grpSpMkLst>
            <pc:docMk/>
            <pc:sldMk cId="3242017852" sldId="272"/>
            <ac:grpSpMk id="229" creationId="{081F240A-0520-F947-946F-1B69E677B2E7}"/>
          </ac:grpSpMkLst>
        </pc:grpChg>
        <pc:graphicFrameChg chg="del">
          <ac:chgData name="Wencai Zhang" userId="4a86a1d0-2108-4707-8228-1110f3c1be85" providerId="ADAL" clId="{0E9FBDE7-7504-E948-96F8-38AF79E2A691}" dt="2021-06-04T14:09:00.784" v="1793" actId="478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4:09:10.733" v="1794" actId="478"/>
          <ac:picMkLst>
            <pc:docMk/>
            <pc:sldMk cId="3242017852" sldId="272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9" creationId="{7CD51EEB-0F0E-8542-9C48-FB9B0B640A5D}"/>
          </ac:picMkLst>
        </pc:picChg>
        <pc:picChg chg="add del mod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25" creationId="{6CF135FB-0FEA-7641-877D-EAE1F4677D03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36" creationId="{28EA12E2-17C6-7745-9E2A-9138B1617D0C}"/>
          </ac:picMkLst>
        </pc:picChg>
        <pc:picChg chg="del mod topLvl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39" creationId="{100FF277-AC44-A94C-AD78-D5C585294C55}"/>
          </ac:picMkLst>
        </pc:pic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40" creationId="{5CFBCABC-16A3-9847-9416-3CD86F952992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45" creationId="{C26E25BE-C4AF-1D40-8062-9375CB098F27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50" creationId="{731EDD23-444E-DD41-A9F3-C44F09DACFE7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5" creationId="{63F65AE1-44E9-354E-BE26-AA103449E57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6" creationId="{BDB44C3F-FDD4-FE45-AC56-0381B726E574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7" creationId="{2CAC91D8-819A-3A43-9836-57CCE57CEE92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8" creationId="{35932F72-055A-784A-B589-B30EEFC75F1A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5" creationId="{E62CEEFD-4CA1-864B-8692-4445BAA180CE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16" creationId="{842C16C1-2569-2B41-9BE7-A76C8801DE2F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21" creationId="{3832138C-BC52-E444-98C2-D355BA3C8434}"/>
          </ac:picMkLst>
        </pc:picChg>
        <pc:picChg chg="mod modCrop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24" creationId="{EE43A61C-6170-E24B-8AF5-77D6B46599E2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30" creationId="{65980DD0-A155-014F-ACE3-B39C7F3E2B32}"/>
          </ac:picMkLst>
        </pc:picChg>
        <pc:picChg chg="mod">
          <ac:chgData name="Wencai Zhang" userId="4a86a1d0-2108-4707-8228-1110f3c1be85" providerId="ADAL" clId="{0E9FBDE7-7504-E948-96F8-38AF79E2A691}" dt="2021-06-05T01:09:54.662" v="3337"/>
          <ac:picMkLst>
            <pc:docMk/>
            <pc:sldMk cId="3242017852" sldId="272"/>
            <ac:picMk id="140" creationId="{A3925FB5-BB12-1D4E-AFB9-B9247A56D9F8}"/>
          </ac:picMkLst>
        </pc:picChg>
        <pc:picChg chg="mod modCrop">
          <ac:chgData name="Wencai Zhang" userId="4a86a1d0-2108-4707-8228-1110f3c1be85" providerId="ADAL" clId="{0E9FBDE7-7504-E948-96F8-38AF79E2A691}" dt="2021-06-07T11:56:11.853" v="5889" actId="732"/>
          <ac:picMkLst>
            <pc:docMk/>
            <pc:sldMk cId="3242017852" sldId="272"/>
            <ac:picMk id="143" creationId="{B4693310-C7E5-024B-8516-9417A988DDAB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0" creationId="{D5AB19CC-3D12-E641-AD09-16D58ADAEE64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6" creationId="{AFC9541E-22AC-6247-87F3-F8023E249043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61" creationId="{C2C57B83-5DBB-9C44-8647-89191A234E61}"/>
          </ac:picMkLst>
        </pc:picChg>
        <pc:picChg chg="mod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66" creationId="{5DE39962-B321-8847-83CF-4797A1FEFE2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179" creationId="{F7C78185-D3B8-504F-BCE0-FD60C3AB1152}"/>
          </ac:picMkLst>
        </pc:picChg>
        <pc:picChg chg="add mod">
          <ac:chgData name="Wencai Zhang" userId="4a86a1d0-2108-4707-8228-1110f3c1be85" providerId="ADAL" clId="{0E9FBDE7-7504-E948-96F8-38AF79E2A691}" dt="2021-06-07T13:35:36.368" v="6318" actId="164"/>
          <ac:picMkLst>
            <pc:docMk/>
            <pc:sldMk cId="3242017852" sldId="272"/>
            <ac:picMk id="184" creationId="{872EAAD3-B3C8-3A44-BB32-783CEA163018}"/>
          </ac:picMkLst>
        </pc:picChg>
        <pc:picChg chg="add del mod">
          <ac:chgData name="Wencai Zhang" userId="4a86a1d0-2108-4707-8228-1110f3c1be85" providerId="ADAL" clId="{0E9FBDE7-7504-E948-96F8-38AF79E2A691}" dt="2021-06-07T12:55:11.813" v="6316" actId="478"/>
          <ac:picMkLst>
            <pc:docMk/>
            <pc:sldMk cId="3242017852" sldId="272"/>
            <ac:picMk id="190" creationId="{C57CF5F0-9C90-E440-9CE5-77508583607E}"/>
          </ac:picMkLst>
        </pc:picChg>
        <pc:picChg chg="mod modCrop">
          <ac:chgData name="Wencai Zhang" userId="4a86a1d0-2108-4707-8228-1110f3c1be85" providerId="ADAL" clId="{0E9FBDE7-7504-E948-96F8-38AF79E2A691}" dt="2021-06-07T16:09:48.853" v="6957" actId="732"/>
          <ac:picMkLst>
            <pc:docMk/>
            <pc:sldMk cId="3242017852" sldId="272"/>
            <ac:picMk id="231" creationId="{F554A9D2-829E-5A40-AE3F-524E7DA73D43}"/>
          </ac:picMkLst>
        </pc:pic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43" creationId="{C53D76DB-1155-F449-806E-53F568A2C4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77" creationId="{5A7E62BA-C034-144E-8A6A-82CC38F0CF4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0" creationId="{A68C37E1-752F-7C4D-A462-101B4D123DFC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2" creationId="{20BA9E32-C552-6A47-A1E6-2635F0E9C27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4" creationId="{27B71BF1-DE97-F648-8132-12A52C38A03A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7" creationId="{3A491FC2-8DFB-1241-87D5-23685ECAB70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9" creationId="{D4CFF19D-24E4-6F43-9AE6-9F40BC969EEF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0" creationId="{455DAA09-CF83-8741-8D7E-8973DB4A7D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1" creationId="{33792D80-0AF4-B54D-B8A6-F72F6BA2B113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3" creationId="{1D296288-8E52-C44E-825D-2C923756ECB4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5" creationId="{9E54B641-E0BC-C245-BCFC-A02A5F66F396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6" creationId="{F527164E-A74E-A446-B42B-21AE64DC949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102" creationId="{29B0EBBF-6CCF-B149-A3EE-15537DB1DB55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39" creationId="{BED8EE18-AED1-0540-B77C-18931F979303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78" creationId="{CEB9F77B-ACEE-1F40-8660-2BE6D852A4A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1" creationId="{7CDC6360-F5A1-BC43-9C68-003166952969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2" creationId="{7FD91790-6098-D649-A0AC-62BF8996C8D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3" creationId="{4A20504A-CF42-4542-B64B-4303C7240501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1" creationId="{37403CBC-16DD-CE4D-92AC-E19A7336698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2" creationId="{B10B1444-6C6D-8340-87EB-C7629ED21D5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5" creationId="{C6670227-7C6C-104C-9AE3-9D7808751395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6" creationId="{9217C763-EE36-274C-8B9E-4BF643EA642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7" creationId="{8EA9B624-AE16-8449-8026-2C1A2DAF9D4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8" creationId="{723F6CA6-DC96-4E42-9D7C-327307DF103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3" creationId="{AB150517-08B8-604F-A70E-7F49DB9896A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5" creationId="{ED5377DB-B748-224F-AB70-939916D83ABC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8" creationId="{258DFB78-793C-854F-877B-B462DDCB44FD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56.526" v="5646" actId="478"/>
        <pc:sldMkLst>
          <pc:docMk/>
          <pc:sldMk cId="1245431894" sldId="274"/>
        </pc:sldMkLst>
        <pc:spChg chg="del">
          <ac:chgData name="Wencai Zhang" userId="4a86a1d0-2108-4707-8228-1110f3c1be85" providerId="ADAL" clId="{0E9FBDE7-7504-E948-96F8-38AF79E2A691}" dt="2021-06-04T13:50:43.786" v="1085" actId="478"/>
          <ac:spMkLst>
            <pc:docMk/>
            <pc:sldMk cId="1245431894" sldId="274"/>
            <ac:spMk id="6" creationId="{25E80C11-7600-E44D-81B5-5295CE52183F}"/>
          </ac:spMkLst>
        </pc:spChg>
        <pc:spChg chg="add mod">
          <ac:chgData name="Wencai Zhang" userId="4a86a1d0-2108-4707-8228-1110f3c1be85" providerId="ADAL" clId="{0E9FBDE7-7504-E948-96F8-38AF79E2A691}" dt="2021-06-04T13:58:38.199" v="1457" actId="20577"/>
          <ac:spMkLst>
            <pc:docMk/>
            <pc:sldMk cId="1245431894" sldId="274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10" creationId="{37E76EB7-6695-2942-A4DD-33687AD229BE}"/>
          </ac:spMkLst>
        </pc:spChg>
        <pc:spChg chg="add mod">
          <ac:chgData name="Wencai Zhang" userId="4a86a1d0-2108-4707-8228-1110f3c1be85" providerId="ADAL" clId="{0E9FBDE7-7504-E948-96F8-38AF79E2A691}" dt="2021-06-04T13:58:30.574" v="1453" actId="20577"/>
          <ac:spMkLst>
            <pc:docMk/>
            <pc:sldMk cId="1245431894" sldId="274"/>
            <ac:spMk id="11" creationId="{8B1765C8-9FB9-4242-ACE4-959BEBC359FE}"/>
          </ac:spMkLst>
        </pc:spChg>
        <pc:spChg chg="add mod">
          <ac:chgData name="Wencai Zhang" userId="4a86a1d0-2108-4707-8228-1110f3c1be85" providerId="ADAL" clId="{0E9FBDE7-7504-E948-96F8-38AF79E2A691}" dt="2021-06-04T13:58:33.415" v="1455" actId="20577"/>
          <ac:spMkLst>
            <pc:docMk/>
            <pc:sldMk cId="1245431894" sldId="274"/>
            <ac:spMk id="12" creationId="{453A5F83-5877-764F-ADD5-5D6844B2FDF7}"/>
          </ac:spMkLst>
        </pc:spChg>
        <pc:spChg chg="del mod">
          <ac:chgData name="Wencai Zhang" userId="4a86a1d0-2108-4707-8228-1110f3c1be85" providerId="ADAL" clId="{0E9FBDE7-7504-E948-96F8-38AF79E2A691}" dt="2021-06-04T14:09:43.169" v="1796" actId="478"/>
          <ac:spMkLst>
            <pc:docMk/>
            <pc:sldMk cId="1245431894" sldId="274"/>
            <ac:spMk id="15" creationId="{73A0757A-AC74-43FC-BBB2-E91DD12F5CD5}"/>
          </ac:spMkLst>
        </pc:spChg>
        <pc:spChg chg="mod">
          <ac:chgData name="Wencai Zhang" userId="4a86a1d0-2108-4707-8228-1110f3c1be85" providerId="ADAL" clId="{0E9FBDE7-7504-E948-96F8-38AF79E2A691}" dt="2021-06-04T13:53:28.429" v="1214" actId="1076"/>
          <ac:spMkLst>
            <pc:docMk/>
            <pc:sldMk cId="1245431894" sldId="274"/>
            <ac:spMk id="22" creationId="{119C059E-C733-4742-A0D4-D02B0A0755A1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3" creationId="{19318E2F-9580-484A-A2E4-97CB1BA629D3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26" creationId="{C4308320-9356-44DD-9CD7-D86A1D1F07E5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2" creationId="{E7D8A89C-5DD3-434D-B0F9-4FFE362E849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3" creationId="{AD8D757C-C30A-EB43-B121-3175844E2FA4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8" creationId="{98E3AEB7-E4F5-9641-BA6E-0981E5B19A0C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1" creationId="{0D6658A2-778F-9740-94C6-A58514B11EB7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2" creationId="{908DF873-890F-4A4C-A816-4F309556B8B9}"/>
          </ac:spMkLst>
        </pc:spChg>
        <pc:spChg chg="add del mod">
          <ac:chgData name="Wencai Zhang" userId="4a86a1d0-2108-4707-8228-1110f3c1be85" providerId="ADAL" clId="{0E9FBDE7-7504-E948-96F8-38AF79E2A691}" dt="2021-06-06T16:08:51.085" v="5645" actId="478"/>
          <ac:spMkLst>
            <pc:docMk/>
            <pc:sldMk cId="1245431894" sldId="274"/>
            <ac:spMk id="43" creationId="{127A0DD9-744A-7541-A433-69329D1C027A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48" creationId="{BCDE73A0-A105-2442-9DB2-CA24027665D0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49" creationId="{FF95B0F2-7C17-7643-B9F6-6A1744873DF4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0" creationId="{1185AA34-8ABA-0647-95BE-BB701E60C952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1" creationId="{D6168116-A21A-4547-A3A6-874E4F2FC8F6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2" creationId="{58BD06B3-A6AC-3946-81BB-D7DB344761C7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53" creationId="{C924241F-3BC8-594B-8905-B561F9D0020A}"/>
          </ac:spMkLst>
        </pc:spChg>
        <pc:spChg chg="del">
          <ac:chgData name="Wencai Zhang" userId="4a86a1d0-2108-4707-8228-1110f3c1be85" providerId="ADAL" clId="{0E9FBDE7-7504-E948-96F8-38AF79E2A691}" dt="2021-06-04T13:50:46.527" v="1086" actId="478"/>
          <ac:spMkLst>
            <pc:docMk/>
            <pc:sldMk cId="1245431894" sldId="274"/>
            <ac:spMk id="54" creationId="{D0892F71-2B40-C746-B966-53E260EE01F7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9" creationId="{EB44D005-E90D-074C-AD4E-F55FC9DDD341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4T13:53:38.067" v="1216" actId="1076"/>
          <ac:spMkLst>
            <pc:docMk/>
            <pc:sldMk cId="1245431894" sldId="274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62" creationId="{1E261997-15B1-5B47-9CD8-5196E34E590B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8" creationId="{E76224F7-D762-6B4A-8132-BE95ED59A120}"/>
          </ac:spMkLst>
        </pc:spChg>
        <pc:spChg chg="del mod">
          <ac:chgData name="Wencai Zhang" userId="4a86a1d0-2108-4707-8228-1110f3c1be85" providerId="ADAL" clId="{0E9FBDE7-7504-E948-96F8-38AF79E2A691}" dt="2021-06-04T13:55:37.220" v="1348" actId="478"/>
          <ac:spMkLst>
            <pc:docMk/>
            <pc:sldMk cId="1245431894" sldId="274"/>
            <ac:spMk id="69" creationId="{1B56E517-81CF-064C-95B9-BB828A0B3D29}"/>
          </ac:spMkLst>
        </pc:spChg>
        <pc:spChg chg="del mod">
          <ac:chgData name="Wencai Zhang" userId="4a86a1d0-2108-4707-8228-1110f3c1be85" providerId="ADAL" clId="{0E9FBDE7-7504-E948-96F8-38AF79E2A691}" dt="2021-06-06T16:08:56.526" v="5646" actId="478"/>
          <ac:spMkLst>
            <pc:docMk/>
            <pc:sldMk cId="1245431894" sldId="274"/>
            <ac:spMk id="70" creationId="{555DC667-6217-A340-9E57-41A9F9AFCDDC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8" creationId="{73A0757A-AC74-43FC-BBB2-E91DD12F5CD5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9" creationId="{F0A85EFF-8CA7-4595-8ED1-A933E3DC9B9B}"/>
          </ac:spMkLst>
        </pc:spChg>
        <pc:grpChg chg="add mod">
          <ac:chgData name="Wencai Zhang" userId="4a86a1d0-2108-4707-8228-1110f3c1be85" providerId="ADAL" clId="{0E9FBDE7-7504-E948-96F8-38AF79E2A691}" dt="2021-06-04T13:58:07.682" v="1419" actId="164"/>
          <ac:grpSpMkLst>
            <pc:docMk/>
            <pc:sldMk cId="1245431894" sldId="274"/>
            <ac:grpSpMk id="2" creationId="{23522517-C292-8C40-8C84-B30913B1168A}"/>
          </ac:grpSpMkLst>
        </pc:grpChg>
        <pc:graphicFrameChg chg="del">
          <ac:chgData name="Wencai Zhang" userId="4a86a1d0-2108-4707-8228-1110f3c1be85" providerId="ADAL" clId="{0E9FBDE7-7504-E948-96F8-38AF79E2A691}" dt="2021-06-04T13:50:39.785" v="1084" actId="478"/>
          <ac:graphicFrameMkLst>
            <pc:docMk/>
            <pc:sldMk cId="1245431894" sldId="274"/>
            <ac:graphicFrameMk id="4" creationId="{AA5CFEED-EC2B-7C49-A61B-8C26F0A49198}"/>
          </ac:graphicFrameMkLst>
        </pc:graphicFrame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9" creationId="{7CD51EEB-0F0E-8542-9C48-FB9B0B640A5D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3:50:46.527" v="1086" actId="478"/>
          <ac:picMkLst>
            <pc:docMk/>
            <pc:sldMk cId="1245431894" sldId="274"/>
            <ac:picMk id="36" creationId="{28EA12E2-17C6-7745-9E2A-9138B1617D0C}"/>
          </ac:picMkLst>
        </pc:pic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40" creationId="{5CFBCABC-16A3-9847-9416-3CD86F952992}"/>
          </ac:picMkLst>
        </pc:picChg>
        <pc:picChg chg="mod modCrop">
          <ac:chgData name="Wencai Zhang" userId="4a86a1d0-2108-4707-8228-1110f3c1be85" providerId="ADAL" clId="{0E9FBDE7-7504-E948-96F8-38AF79E2A691}" dt="2021-06-04T13:58:07.682" v="1419" actId="164"/>
          <ac:picMkLst>
            <pc:docMk/>
            <pc:sldMk cId="1245431894" sldId="274"/>
            <ac:picMk id="55" creationId="{63F65AE1-44E9-354E-BE26-AA103449E57C}"/>
          </ac:picMkLst>
        </pc:picChg>
        <pc:picChg chg="mod modCrop">
          <ac:chgData name="Wencai Zhang" userId="4a86a1d0-2108-4707-8228-1110f3c1be85" providerId="ADAL" clId="{0E9FBDE7-7504-E948-96F8-38AF79E2A691}" dt="2021-06-04T13:53:33.986" v="1215" actId="1076"/>
          <ac:picMkLst>
            <pc:docMk/>
            <pc:sldMk cId="1245431894" sldId="274"/>
            <ac:picMk id="56" creationId="{BDB44C3F-FDD4-FE45-AC56-0381B726E574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7" creationId="{2CAC91D8-819A-3A43-9836-57CCE57CEE92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8" creationId="{35932F72-055A-784A-B589-B30EEFC75F1A}"/>
          </ac:picMkLst>
        </pc:picChg>
      </pc:sldChg>
      <pc:sldChg chg="addSp delSp modSp new mod">
        <pc:chgData name="Wencai Zhang" userId="4a86a1d0-2108-4707-8228-1110f3c1be85" providerId="ADAL" clId="{0E9FBDE7-7504-E948-96F8-38AF79E2A691}" dt="2021-06-05T01:20:49.329" v="3630" actId="14100"/>
        <pc:sldMkLst>
          <pc:docMk/>
          <pc:sldMk cId="2222079663" sldId="275"/>
        </pc:sldMkLst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2" creationId="{4AE60809-9F1F-5847-ACF8-B3BEF6E23C88}"/>
          </ac:spMkLst>
        </pc:spChg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3" creationId="{9E47FCC1-F1CA-7746-9C37-D51F0AE1F552}"/>
          </ac:spMkLst>
        </pc:spChg>
        <pc:spChg chg="add del mod">
          <ac:chgData name="Wencai Zhang" userId="4a86a1d0-2108-4707-8228-1110f3c1be85" providerId="ADAL" clId="{0E9FBDE7-7504-E948-96F8-38AF79E2A691}" dt="2021-06-05T01:05:45.192" v="3235" actId="478"/>
          <ac:spMkLst>
            <pc:docMk/>
            <pc:sldMk cId="2222079663" sldId="275"/>
            <ac:spMk id="5" creationId="{4208F0FF-0FC3-F341-8727-3D62EBB44E0E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8" creationId="{9583305E-3306-054B-8ED7-660D172D6294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9" creationId="{92F03AA0-F106-7E4F-90B3-D8E657C27D8F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0" creationId="{9A77A089-B374-6645-BBDC-FF3E835A9C17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3" creationId="{BF4D14DF-A68A-4845-B71E-387CEBD98DEA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4" creationId="{205745EF-6B7D-1040-8E5D-3A8A2FF3FF51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5" creationId="{75610384-15A3-3A41-B5EB-0B285E33CAD8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6" creationId="{A523C20A-2543-7448-ADBF-CE304AAFD9D7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7" creationId="{94954991-CAA0-BF46-BB2B-44C9D3AF43C8}"/>
          </ac:spMkLst>
        </pc:spChg>
        <pc:spChg chg="del mod">
          <ac:chgData name="Wencai Zhang" userId="4a86a1d0-2108-4707-8228-1110f3c1be85" providerId="ADAL" clId="{0E9FBDE7-7504-E948-96F8-38AF79E2A691}" dt="2021-06-05T01:03:10.652" v="3147" actId="478"/>
          <ac:spMkLst>
            <pc:docMk/>
            <pc:sldMk cId="2222079663" sldId="275"/>
            <ac:spMk id="20" creationId="{015FEBFD-87EE-E04E-AF07-50FE8DE2CF69}"/>
          </ac:spMkLst>
        </pc:spChg>
        <pc:spChg chg="mod">
          <ac:chgData name="Wencai Zhang" userId="4a86a1d0-2108-4707-8228-1110f3c1be85" providerId="ADAL" clId="{0E9FBDE7-7504-E948-96F8-38AF79E2A691}" dt="2021-06-05T01:06:29.436" v="3264" actId="255"/>
          <ac:spMkLst>
            <pc:docMk/>
            <pc:sldMk cId="2222079663" sldId="275"/>
            <ac:spMk id="21" creationId="{A844291E-FA69-1D4A-9D86-A86C5582C718}"/>
          </ac:spMkLst>
        </pc:spChg>
        <pc:spChg chg="mod">
          <ac:chgData name="Wencai Zhang" userId="4a86a1d0-2108-4707-8228-1110f3c1be85" providerId="ADAL" clId="{0E9FBDE7-7504-E948-96F8-38AF79E2A691}" dt="2021-06-05T01:08:06.030" v="3321" actId="1076"/>
          <ac:spMkLst>
            <pc:docMk/>
            <pc:sldMk cId="2222079663" sldId="275"/>
            <ac:spMk id="22" creationId="{D762C1C7-DF62-9D48-831C-3E80C35F9624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3" creationId="{C5035860-6BE3-324A-8327-77ED32299622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4" creationId="{C75DF9EC-8E06-634D-8F0A-BE858255B088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6" creationId="{2DE3D3F9-2287-7748-A10E-252DE43E83AF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7" creationId="{D235BEA7-0770-ED44-BCBB-C92C9108E5C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29" creationId="{8AF93907-EEFF-A34C-AFEE-45D5884E5EC9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30" creationId="{A030730D-E79E-514E-BA9E-B57391BF434E}"/>
          </ac:spMkLst>
        </pc:spChg>
        <pc:spChg chg="add del mod">
          <ac:chgData name="Wencai Zhang" userId="4a86a1d0-2108-4707-8228-1110f3c1be85" providerId="ADAL" clId="{0E9FBDE7-7504-E948-96F8-38AF79E2A691}" dt="2021-06-05T01:17:18.503" v="3457" actId="478"/>
          <ac:spMkLst>
            <pc:docMk/>
            <pc:sldMk cId="2222079663" sldId="275"/>
            <ac:spMk id="32" creationId="{6EC2D070-9660-F141-9913-A11A1BC80AEA}"/>
          </ac:spMkLst>
        </pc:spChg>
        <pc:spChg chg="add del mod">
          <ac:chgData name="Wencai Zhang" userId="4a86a1d0-2108-4707-8228-1110f3c1be85" providerId="ADAL" clId="{0E9FBDE7-7504-E948-96F8-38AF79E2A691}" dt="2021-06-05T01:04:23.139" v="3177" actId="478"/>
          <ac:spMkLst>
            <pc:docMk/>
            <pc:sldMk cId="2222079663" sldId="275"/>
            <ac:spMk id="33" creationId="{EE2FB837-7439-CE49-9CFC-AA0573E1C8CF}"/>
          </ac:spMkLst>
        </pc:spChg>
        <pc:spChg chg="add del mod">
          <ac:chgData name="Wencai Zhang" userId="4a86a1d0-2108-4707-8228-1110f3c1be85" providerId="ADAL" clId="{0E9FBDE7-7504-E948-96F8-38AF79E2A691}" dt="2021-06-05T00:58:55.477" v="3035" actId="478"/>
          <ac:spMkLst>
            <pc:docMk/>
            <pc:sldMk cId="2222079663" sldId="275"/>
            <ac:spMk id="34" creationId="{BDA64682-6E1E-4A41-8792-16E6A0BCA1B4}"/>
          </ac:spMkLst>
        </pc:spChg>
        <pc:spChg chg="add del mod">
          <ac:chgData name="Wencai Zhang" userId="4a86a1d0-2108-4707-8228-1110f3c1be85" providerId="ADAL" clId="{0E9FBDE7-7504-E948-96F8-38AF79E2A691}" dt="2021-06-05T00:52:13.769" v="2875" actId="478"/>
          <ac:spMkLst>
            <pc:docMk/>
            <pc:sldMk cId="2222079663" sldId="275"/>
            <ac:spMk id="35" creationId="{237C814D-504F-0E48-BDC1-FACA423068E0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36" creationId="{C1723BF5-D8AC-634A-80FC-A2B56C522F06}"/>
          </ac:spMkLst>
        </pc:spChg>
        <pc:spChg chg="add mod">
          <ac:chgData name="Wencai Zhang" userId="4a86a1d0-2108-4707-8228-1110f3c1be85" providerId="ADAL" clId="{0E9FBDE7-7504-E948-96F8-38AF79E2A691}" dt="2021-06-05T01:08:12.519" v="3322" actId="164"/>
          <ac:spMkLst>
            <pc:docMk/>
            <pc:sldMk cId="2222079663" sldId="275"/>
            <ac:spMk id="37" creationId="{DF74EE03-1095-0F48-8DDE-B62F85F030E1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38" creationId="{CD8849B0-73E8-FF4C-9938-4AC5DB8B48C7}"/>
          </ac:spMkLst>
        </pc:spChg>
        <pc:spChg chg="add mod">
          <ac:chgData name="Wencai Zhang" userId="4a86a1d0-2108-4707-8228-1110f3c1be85" providerId="ADAL" clId="{0E9FBDE7-7504-E948-96F8-38AF79E2A691}" dt="2021-06-05T01:10:45.988" v="3349" actId="1036"/>
          <ac:spMkLst>
            <pc:docMk/>
            <pc:sldMk cId="2222079663" sldId="275"/>
            <ac:spMk id="39" creationId="{78F5B8F3-24DA-D048-A532-3F158844F18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40" creationId="{97D7089A-0228-5249-BFE3-2A364BAA45DC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1" creationId="{1635B3C4-E34F-1D40-8B20-BC320AF81ED6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3" creationId="{98D32CD0-8154-ED4B-87F8-F3EB96190EF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5" creationId="{B61FE4C6-6F28-B04E-89E0-1BF7C9D80D5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6" creationId="{67BF7CE7-23EC-FB48-AE75-615756B0E03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7" creationId="{63871B88-E2B2-2D4C-B430-FE11693052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9" creationId="{7D860766-A5A3-704E-A64E-DA5EF7F3D54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0" creationId="{E3B5C0D3-DA45-4A40-AF14-3A1FBA650C07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1" creationId="{47058210-A285-DD42-AE7F-430CA8DFC7C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2" creationId="{128E2AA2-1A02-8947-BD13-2C8AD3E4FA1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3" creationId="{6064BB4A-37E2-F04E-B899-03F287483E4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4" creationId="{49E5B02B-A729-3147-8B57-E9772BA6B63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5" creationId="{0533DB57-7DF6-A142-8D8A-96CA13F08A9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6" creationId="{1240633E-6357-6246-B140-3E509707522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7" creationId="{79C49E5D-F773-CC47-B06B-138EBCC46A75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8" creationId="{E57D8E59-68B5-CD4E-9F61-D82A001E021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9" creationId="{E02A27EB-3934-D344-87B0-CB369DC838E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1" creationId="{E8CEF1DE-7817-8440-9591-86870797FAA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3" creationId="{53316A91-3EAA-E04B-9D2E-C09A6786CC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5" creationId="{CA719E23-C54A-CB40-A4B1-BFBD8DB61706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7" creationId="{F7D6C629-AC00-BD41-B4C4-F19324AF4CC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9" creationId="{E9727722-8F42-1845-9AF7-647C4DDDCA5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3" creationId="{06DADBE9-6A12-A643-95AE-EE052390870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5" creationId="{40062CFE-E422-B94E-9B02-026E7288D379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8" creationId="{28BE0684-3ABD-ED4A-A357-030A7866A97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9" creationId="{6F41E546-9732-A649-B1A7-50063A7F6EA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0" creationId="{0EBD5DEA-A66C-7B47-A1F6-F669F03CA1E1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1" creationId="{566AD5EF-D31E-C640-A1FF-26370FBF3838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2" creationId="{27BD48FF-560A-FD49-803D-D3AF2B9143F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4" creationId="{E1AC6A34-4CF9-2847-ABFA-14CF10A78F68}"/>
          </ac:spMkLst>
        </pc:spChg>
        <pc:spChg chg="add mod">
          <ac:chgData name="Wencai Zhang" userId="4a86a1d0-2108-4707-8228-1110f3c1be85" providerId="ADAL" clId="{0E9FBDE7-7504-E948-96F8-38AF79E2A691}" dt="2021-06-05T01:20:40.927" v="3605" actId="14100"/>
          <ac:spMkLst>
            <pc:docMk/>
            <pc:sldMk cId="2222079663" sldId="275"/>
            <ac:spMk id="85" creationId="{672E39D6-BC17-5140-BEA6-9A172404D8FA}"/>
          </ac:spMkLst>
        </pc:spChg>
        <pc:spChg chg="add mod">
          <ac:chgData name="Wencai Zhang" userId="4a86a1d0-2108-4707-8228-1110f3c1be85" providerId="ADAL" clId="{0E9FBDE7-7504-E948-96F8-38AF79E2A691}" dt="2021-06-05T01:20:49.329" v="3630" actId="14100"/>
          <ac:spMkLst>
            <pc:docMk/>
            <pc:sldMk cId="2222079663" sldId="275"/>
            <ac:spMk id="86" creationId="{CD5190E2-B578-B14A-93BD-37DDB6EA5B5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8" creationId="{CFF41558-B2F1-BB4E-ADD0-3E642359015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9" creationId="{981DA7AC-606E-4F4A-BE20-654738421F1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0" creationId="{885F3A18-9365-B441-9824-C35D62C8186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2" creationId="{EE7330A9-7FE1-C843-9ABA-120F9F1E8BA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3" creationId="{C892543F-6F0B-E34F-8C60-EEE313CDD1E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4" creationId="{D5D18BE9-DE66-754C-A22F-95C164BFF74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5" creationId="{A0B61923-1978-D341-8304-677DF3403157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6" creationId="{C66E3D89-01AE-2E4C-B2CB-495E86927E2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7" creationId="{3D19C088-2E6D-5D45-8D24-1B21AA38763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8" creationId="{44D5B8F6-B30F-694C-B638-725D5DD0722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9" creationId="{09D21520-11BE-2749-889A-6C3A3A90B9F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0" creationId="{0DBACF7E-8056-0C49-B17C-0BE109D79BD2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1" creationId="{E017F137-5D14-7C48-A2E7-D2DB5584D03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2" creationId="{34005E84-34AD-3343-8240-1D0D3CB442B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4" creationId="{343DBAFE-C85C-B04E-BFDE-24870900FF4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6" creationId="{5D1DE8C9-2D9A-554B-A8FF-F67445957A4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8" creationId="{F34440D5-A3C6-1A48-BA5E-E5115E55091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0" creationId="{352105DC-91DB-BB43-97B3-C24D3ACEE5D5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2" creationId="{6F6BA50C-2910-724F-8C0D-B42DA6DAC54C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6" creationId="{AAF7BC2C-8504-704E-85CC-6CAA2E8193F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8" creationId="{A58B8EBC-B53C-5E48-9A60-45482140C2C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1" creationId="{593A87B1-00F1-4A49-9163-60B962791293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2" creationId="{1F5AFB84-7E75-9E4D-88B4-7EABE9AAD364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3" creationId="{27B68382-37BF-E348-BF3C-92059DBD9F7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4" creationId="{AF457CD7-28CB-8246-8C83-2749800A687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5" creationId="{0B84029B-D0FF-414D-95CA-B9DE1ABFC71E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7" creationId="{B0C9D321-7A5E-2147-888A-54D4E5B9D84D}"/>
          </ac:spMkLst>
        </pc:spChg>
        <pc:grpChg chg="add mod">
          <ac:chgData name="Wencai Zhang" userId="4a86a1d0-2108-4707-8228-1110f3c1be85" providerId="ADAL" clId="{0E9FBDE7-7504-E948-96F8-38AF79E2A691}" dt="2021-06-05T00:50:10.079" v="2859" actId="1076"/>
          <ac:grpSpMkLst>
            <pc:docMk/>
            <pc:sldMk cId="2222079663" sldId="275"/>
            <ac:grpSpMk id="2" creationId="{39EDF6FE-038B-2745-A0B2-5DCDFD9FE626}"/>
          </ac:grpSpMkLst>
        </pc:grpChg>
        <pc:grpChg chg="add mod">
          <ac:chgData name="Wencai Zhang" userId="4a86a1d0-2108-4707-8228-1110f3c1be85" providerId="ADAL" clId="{0E9FBDE7-7504-E948-96F8-38AF79E2A691}" dt="2021-06-05T01:02:40.859" v="3146" actId="1076"/>
          <ac:grpSpMkLst>
            <pc:docMk/>
            <pc:sldMk cId="2222079663" sldId="275"/>
            <ac:grpSpMk id="3" creationId="{0445B0AA-E3C0-4143-9101-CCCF8F7A6354}"/>
          </ac:grpSpMkLst>
        </pc:grpChg>
        <pc:grpChg chg="add del mod">
          <ac:chgData name="Wencai Zhang" userId="4a86a1d0-2108-4707-8228-1110f3c1be85" providerId="ADAL" clId="{0E9FBDE7-7504-E948-96F8-38AF79E2A691}" dt="2021-06-05T00:52:57.290" v="2876" actId="478"/>
          <ac:grpSpMkLst>
            <pc:docMk/>
            <pc:sldMk cId="2222079663" sldId="275"/>
            <ac:grpSpMk id="6" creationId="{E495AE60-262E-CF45-82B8-F04756722410}"/>
          </ac:grpSpMkLst>
        </pc:grpChg>
        <pc:grpChg chg="add del mod">
          <ac:chgData name="Wencai Zhang" userId="4a86a1d0-2108-4707-8228-1110f3c1be85" providerId="ADAL" clId="{0E9FBDE7-7504-E948-96F8-38AF79E2A691}" dt="2021-06-05T00:52:13.769" v="2875" actId="478"/>
          <ac:grpSpMkLst>
            <pc:docMk/>
            <pc:sldMk cId="2222079663" sldId="275"/>
            <ac:grpSpMk id="11" creationId="{7ADEBC67-E805-1F46-85F2-D1A2C02EF7C5}"/>
          </ac:grpSpMkLst>
        </pc:grpChg>
        <pc:grpChg chg="add mod">
          <ac:chgData name="Wencai Zhang" userId="4a86a1d0-2108-4707-8228-1110f3c1be85" providerId="ADAL" clId="{0E9FBDE7-7504-E948-96F8-38AF79E2A691}" dt="2021-06-05T01:08:12.519" v="3322" actId="164"/>
          <ac:grpSpMkLst>
            <pc:docMk/>
            <pc:sldMk cId="2222079663" sldId="275"/>
            <ac:grpSpMk id="18" creationId="{76C9C4BE-DCC3-5542-B96D-2530022CCEEB}"/>
          </ac:grpSpMkLst>
        </pc:grpChg>
        <pc:grpChg chg="add del mod">
          <ac:chgData name="Wencai Zhang" userId="4a86a1d0-2108-4707-8228-1110f3c1be85" providerId="ADAL" clId="{0E9FBDE7-7504-E948-96F8-38AF79E2A691}" dt="2021-06-05T01:02:26.047" v="3142" actId="478"/>
          <ac:grpSpMkLst>
            <pc:docMk/>
            <pc:sldMk cId="2222079663" sldId="275"/>
            <ac:grpSpMk id="44" creationId="{B092A35D-E260-7448-AEFD-D27DA68CF7CE}"/>
          </ac:grpSpMkLst>
        </pc:grpChg>
        <pc:grpChg chg="add mod">
          <ac:chgData name="Wencai Zhang" userId="4a86a1d0-2108-4707-8228-1110f3c1be85" providerId="ADAL" clId="{0E9FBDE7-7504-E948-96F8-38AF79E2A691}" dt="2021-06-05T01:02:32.097" v="3145" actId="1076"/>
          <ac:grpSpMkLst>
            <pc:docMk/>
            <pc:sldMk cId="2222079663" sldId="275"/>
            <ac:grpSpMk id="87" creationId="{D0E9D44A-DBCD-4E4C-BCA9-99B7A06D6AF3}"/>
          </ac:grpSpMkLst>
        </pc:grpChg>
        <pc:grpChg chg="add mod">
          <ac:chgData name="Wencai Zhang" userId="4a86a1d0-2108-4707-8228-1110f3c1be85" providerId="ADAL" clId="{0E9FBDE7-7504-E948-96F8-38AF79E2A691}" dt="2021-06-05T01:08:21.346" v="3323" actId="1076"/>
          <ac:grpSpMkLst>
            <pc:docMk/>
            <pc:sldMk cId="2222079663" sldId="275"/>
            <ac:grpSpMk id="128" creationId="{7F039C8D-39AD-5745-B879-CC4D1E59CE15}"/>
          </ac:grpSpMkLst>
        </pc:grpChg>
        <pc:grpChg chg="add mod">
          <ac:chgData name="Wencai Zhang" userId="4a86a1d0-2108-4707-8228-1110f3c1be85" providerId="ADAL" clId="{0E9FBDE7-7504-E948-96F8-38AF79E2A691}" dt="2021-06-05T01:13:04.981" v="3386" actId="1076"/>
          <ac:grpSpMkLst>
            <pc:docMk/>
            <pc:sldMk cId="2222079663" sldId="275"/>
            <ac:grpSpMk id="129" creationId="{D9665304-5DCE-8A4C-970A-EF4BA349B357}"/>
          </ac:grpSpMkLst>
        </pc:grpChg>
        <pc:grpChg chg="add mod">
          <ac:chgData name="Wencai Zhang" userId="4a86a1d0-2108-4707-8228-1110f3c1be85" providerId="ADAL" clId="{0E9FBDE7-7504-E948-96F8-38AF79E2A691}" dt="2021-06-05T01:15:48.741" v="3456" actId="1076"/>
          <ac:grpSpMkLst>
            <pc:docMk/>
            <pc:sldMk cId="2222079663" sldId="275"/>
            <ac:grpSpMk id="130" creationId="{105330CD-5844-8846-9356-4974ED933874}"/>
          </ac:grpSpMkLst>
        </pc:grpChg>
        <pc:grpChg chg="add mod">
          <ac:chgData name="Wencai Zhang" userId="4a86a1d0-2108-4707-8228-1110f3c1be85" providerId="ADAL" clId="{0E9FBDE7-7504-E948-96F8-38AF79E2A691}" dt="2021-06-05T01:19:55.468" v="3580" actId="1076"/>
          <ac:grpSpMkLst>
            <pc:docMk/>
            <pc:sldMk cId="2222079663" sldId="275"/>
            <ac:grpSpMk id="131" creationId="{543F7BB7-6E74-2044-B2EB-EB016583A315}"/>
          </ac:grpSpMkLst>
        </pc:grpChg>
        <pc:picChg chg="add mod modCrop">
          <ac:chgData name="Wencai Zhang" userId="4a86a1d0-2108-4707-8228-1110f3c1be85" providerId="ADAL" clId="{0E9FBDE7-7504-E948-96F8-38AF79E2A691}" dt="2021-06-05T01:15:34.274" v="3455" actId="164"/>
          <ac:picMkLst>
            <pc:docMk/>
            <pc:sldMk cId="2222079663" sldId="275"/>
            <ac:picMk id="4" creationId="{1314CFD3-BA93-6445-BCBD-AC7ED92D9200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7" creationId="{72175423-574D-A34C-B519-40B80E38407D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12" creationId="{369919CE-AF01-A44F-A0C4-6F43AFE59FB5}"/>
          </ac:picMkLst>
        </pc:picChg>
        <pc:picChg chg="mod modCrop">
          <ac:chgData name="Wencai Zhang" userId="4a86a1d0-2108-4707-8228-1110f3c1be85" providerId="ADAL" clId="{0E9FBDE7-7504-E948-96F8-38AF79E2A691}" dt="2021-06-05T01:11:10.659" v="3354" actId="14100"/>
          <ac:picMkLst>
            <pc:docMk/>
            <pc:sldMk cId="2222079663" sldId="275"/>
            <ac:picMk id="19" creationId="{BB158964-3ED7-BD44-B8AC-FC4BCA4F43CC}"/>
          </ac:picMkLst>
        </pc:picChg>
        <pc:picChg chg="add mod modCrop">
          <ac:chgData name="Wencai Zhang" userId="4a86a1d0-2108-4707-8228-1110f3c1be85" providerId="ADAL" clId="{0E9FBDE7-7504-E948-96F8-38AF79E2A691}" dt="2021-06-05T01:12:53.065" v="3385" actId="164"/>
          <ac:picMkLst>
            <pc:docMk/>
            <pc:sldMk cId="2222079663" sldId="275"/>
            <ac:picMk id="25" creationId="{28FC6969-75CD-5A44-88C2-BB14559D3295}"/>
          </ac:picMkLst>
        </pc:picChg>
        <pc:picChg chg="add mod modCrop">
          <ac:chgData name="Wencai Zhang" userId="4a86a1d0-2108-4707-8228-1110f3c1be85" providerId="ADAL" clId="{0E9FBDE7-7504-E948-96F8-38AF79E2A691}" dt="2021-06-05T01:10:30.030" v="3342" actId="14100"/>
          <ac:picMkLst>
            <pc:docMk/>
            <pc:sldMk cId="2222079663" sldId="275"/>
            <ac:picMk id="28" creationId="{FAC94C53-B559-F744-8282-A802CCCB0F34}"/>
          </ac:picMkLst>
        </pc:picChg>
        <pc:picChg chg="add mod modCrop">
          <ac:chgData name="Wencai Zhang" userId="4a86a1d0-2108-4707-8228-1110f3c1be85" providerId="ADAL" clId="{0E9FBDE7-7504-E948-96F8-38AF79E2A691}" dt="2021-06-05T01:19:49.999" v="3579" actId="164"/>
          <ac:picMkLst>
            <pc:docMk/>
            <pc:sldMk cId="2222079663" sldId="275"/>
            <ac:picMk id="31" creationId="{C9DA43F6-FD5F-DD40-A3CB-512F98656512}"/>
          </ac:picMkLst>
        </pc:picChg>
        <pc:picChg chg="add mod">
          <ac:chgData name="Wencai Zhang" userId="4a86a1d0-2108-4707-8228-1110f3c1be85" providerId="ADAL" clId="{0E9FBDE7-7504-E948-96F8-38AF79E2A691}" dt="2021-06-05T00:50:08.080" v="2858" actId="164"/>
          <ac:picMkLst>
            <pc:docMk/>
            <pc:sldMk cId="2222079663" sldId="275"/>
            <ac:picMk id="42" creationId="{A485CABA-DD09-0343-8967-4F1D5BBAA9C0}"/>
          </ac:picMkLst>
        </pc:pic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48" creationId="{A610B051-DD07-AC45-95FF-9D0055DDA87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0" creationId="{319D9D10-FC52-C64E-BF67-865CCF5DE265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2" creationId="{E6B68C37-8EB7-3349-B879-D1981CA188D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4" creationId="{12B8800F-C5F6-874C-AB9D-AB075CC9A06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6" creationId="{402CBC2F-B63B-7246-89F9-1E5221B686E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8" creationId="{D1512C3B-67F0-1349-BE69-BD3A0C150D2F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0" creationId="{958051B3-1603-6C41-8FC7-97BC11AE166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1" creationId="{FC8C1CD7-9A37-F54C-A76A-00DBA095408E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2" creationId="{8C7D9D49-92E7-F941-AD9F-907AE825353C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4" creationId="{B54B6781-F772-5044-8804-4385C3CEEE33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6" creationId="{18F1ADA2-6C0B-DB4C-B2F1-54E324B14B97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7" creationId="{2FF5095B-5391-124A-8B0B-B21E052151E1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83" creationId="{E4BF2052-58EB-CA4A-8453-0BBF195F554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91" creationId="{D4544732-B76F-9B41-9CCE-7676A5958B4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3" creationId="{403D0B94-5743-1E40-ADFE-1B446CD554C4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5" creationId="{70032D2C-38C0-F84B-BC74-A28A8057A665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7" creationId="{40F8A3FB-C676-BA48-980D-E0D8B088438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9" creationId="{F592DD83-C678-8A4D-A948-35241A71CE86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1" creationId="{7DD0D207-FC14-4646-A17E-5C955238388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3" creationId="{698ED407-7C2C-C749-83F3-F0F02F5767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4" creationId="{B49EBDB6-F54E-3149-A92E-01326062FAE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5" creationId="{42D06004-3A6D-9F4C-9BBA-0910FD6694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7" creationId="{3E042DE1-A106-D54B-96F5-DD9D1B742BCA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9" creationId="{ECD6D14A-8F12-6D49-92C8-3DF9A89BA21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0" creationId="{C0C9BFFD-FFE2-C74C-8251-F5405C449E5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6" creationId="{46C968DA-709B-EC41-9F73-3E70A622C157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22.735" v="5644" actId="1038"/>
        <pc:sldMkLst>
          <pc:docMk/>
          <pc:sldMk cId="1904142445" sldId="276"/>
        </pc:sldMkLst>
        <pc:spChg chg="mod">
          <ac:chgData name="Wencai Zhang" userId="4a86a1d0-2108-4707-8228-1110f3c1be85" providerId="ADAL" clId="{0E9FBDE7-7504-E948-96F8-38AF79E2A691}" dt="2021-06-06T15:46:48.806" v="5045" actId="20577"/>
          <ac:spMkLst>
            <pc:docMk/>
            <pc:sldMk cId="1904142445" sldId="276"/>
            <ac:spMk id="5" creationId="{C9676FCD-1B75-674C-B612-D1EA39A39093}"/>
          </ac:spMkLst>
        </pc:spChg>
        <pc:spChg chg="mod">
          <ac:chgData name="Wencai Zhang" userId="4a86a1d0-2108-4707-8228-1110f3c1be85" providerId="ADAL" clId="{0E9FBDE7-7504-E948-96F8-38AF79E2A691}" dt="2021-06-06T15:20:58.283" v="4831" actId="20577"/>
          <ac:spMkLst>
            <pc:docMk/>
            <pc:sldMk cId="1904142445" sldId="276"/>
            <ac:spMk id="8" creationId="{81905F88-24A2-A84D-B6CE-2B4573951169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1" creationId="{8B1765C8-9FB9-4242-ACE4-959BEBC359FE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2" creationId="{453A5F83-5877-764F-ADD5-5D6844B2FDF7}"/>
          </ac:spMkLst>
        </pc:spChg>
        <pc:spChg chg="mod">
          <ac:chgData name="Wencai Zhang" userId="4a86a1d0-2108-4707-8228-1110f3c1be85" providerId="ADAL" clId="{0E9FBDE7-7504-E948-96F8-38AF79E2A691}" dt="2021-06-06T15:59:39.677" v="5317" actId="1035"/>
          <ac:spMkLst>
            <pc:docMk/>
            <pc:sldMk cId="1904142445" sldId="276"/>
            <ac:spMk id="22" creationId="{119C059E-C733-4742-A0D4-D02B0A0755A1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3" creationId="{19318E2F-9580-484A-A2E4-97CB1BA629D3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6T15:59:16.472" v="5274" actId="1036"/>
          <ac:spMkLst>
            <pc:docMk/>
            <pc:sldMk cId="1904142445" sldId="276"/>
            <ac:spMk id="26" creationId="{C4308320-9356-44DD-9CD7-D86A1D1F07E5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2" creationId="{E7D8A89C-5DD3-434D-B0F9-4FFE362E8493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3" creationId="{AD8D757C-C30A-EB43-B121-3175844E2FA4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1" creationId="{0D6658A2-778F-9740-94C6-A58514B11EB7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41:18.543" v="5002" actId="478"/>
          <ac:spMkLst>
            <pc:docMk/>
            <pc:sldMk cId="1904142445" sldId="276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44" creationId="{1F682268-4461-BD4E-8D8E-720C57FF2ED2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47" creationId="{65BDBD14-8EDC-FF43-ACEC-7B2892235D53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49" creationId="{FF95B0F2-7C17-7643-B9F6-6A1744873DF4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50" creationId="{1185AA34-8ABA-0647-95BE-BB701E60C952}"/>
          </ac:spMkLst>
        </pc:spChg>
        <pc:spChg chg="mod">
          <ac:chgData name="Wencai Zhang" userId="4a86a1d0-2108-4707-8228-1110f3c1be85" providerId="ADAL" clId="{0E9FBDE7-7504-E948-96F8-38AF79E2A691}" dt="2021-06-06T15:56:40.372" v="5148" actId="1076"/>
          <ac:spMkLst>
            <pc:docMk/>
            <pc:sldMk cId="1904142445" sldId="276"/>
            <ac:spMk id="51" creationId="{D6168116-A21A-4547-A3A6-874E4F2FC8F6}"/>
          </ac:spMkLst>
        </pc:spChg>
        <pc:spChg chg="mod">
          <ac:chgData name="Wencai Zhang" userId="4a86a1d0-2108-4707-8228-1110f3c1be85" providerId="ADAL" clId="{0E9FBDE7-7504-E948-96F8-38AF79E2A691}" dt="2021-06-06T16:08:02.179" v="5634" actId="1037"/>
          <ac:spMkLst>
            <pc:docMk/>
            <pc:sldMk cId="1904142445" sldId="276"/>
            <ac:spMk id="52" creationId="{58BD06B3-A6AC-3946-81BB-D7DB344761C7}"/>
          </ac:spMkLst>
        </pc:spChg>
        <pc:spChg chg="mod">
          <ac:chgData name="Wencai Zhang" userId="4a86a1d0-2108-4707-8228-1110f3c1be85" providerId="ADAL" clId="{0E9FBDE7-7504-E948-96F8-38AF79E2A691}" dt="2021-06-06T16:01:13.143" v="5429" actId="1037"/>
          <ac:spMkLst>
            <pc:docMk/>
            <pc:sldMk cId="1904142445" sldId="276"/>
            <ac:spMk id="54" creationId="{EF292290-87B0-9E4F-912E-C5AC48BE8F43}"/>
          </ac:spMkLst>
        </pc:spChg>
        <pc:spChg chg="del">
          <ac:chgData name="Wencai Zhang" userId="4a86a1d0-2108-4707-8228-1110f3c1be85" providerId="ADAL" clId="{0E9FBDE7-7504-E948-96F8-38AF79E2A691}" dt="2021-06-06T15:31:47.705" v="4922" actId="478"/>
          <ac:spMkLst>
            <pc:docMk/>
            <pc:sldMk cId="1904142445" sldId="276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32:00.509" v="4923" actId="478"/>
          <ac:spMkLst>
            <pc:docMk/>
            <pc:sldMk cId="1904142445" sldId="276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6T15:59:44.368" v="5328" actId="1037"/>
          <ac:spMkLst>
            <pc:docMk/>
            <pc:sldMk cId="1904142445" sldId="276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6T15:59:27.532" v="5289" actId="20577"/>
          <ac:spMkLst>
            <pc:docMk/>
            <pc:sldMk cId="1904142445" sldId="276"/>
            <ac:spMk id="62" creationId="{1E261997-15B1-5B47-9CD8-5196E34E590B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6T16:01:08.161" v="5417" actId="1038"/>
          <ac:spMkLst>
            <pc:docMk/>
            <pc:sldMk cId="1904142445" sldId="276"/>
            <ac:spMk id="64" creationId="{C72A5816-F776-884C-B5E0-414FC2A02EC2}"/>
          </ac:spMkLst>
        </pc:spChg>
        <pc:spChg chg="del">
          <ac:chgData name="Wencai Zhang" userId="4a86a1d0-2108-4707-8228-1110f3c1be85" providerId="ADAL" clId="{0E9FBDE7-7504-E948-96F8-38AF79E2A691}" dt="2021-06-06T15:31:45.014" v="4921" actId="478"/>
          <ac:spMkLst>
            <pc:docMk/>
            <pc:sldMk cId="1904142445" sldId="276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8" creationId="{E76224F7-D762-6B4A-8132-BE95ED59A120}"/>
          </ac:spMkLst>
        </pc:spChg>
        <pc:spChg chg="del">
          <ac:chgData name="Wencai Zhang" userId="4a86a1d0-2108-4707-8228-1110f3c1be85" providerId="ADAL" clId="{0E9FBDE7-7504-E948-96F8-38AF79E2A691}" dt="2021-06-06T15:21:12.457" v="4834" actId="478"/>
          <ac:spMkLst>
            <pc:docMk/>
            <pc:sldMk cId="1904142445" sldId="276"/>
            <ac:spMk id="70" creationId="{555DC667-6217-A340-9E57-41A9F9AFCDDC}"/>
          </ac:spMkLst>
        </pc:spChg>
        <pc:spChg chg="add mod">
          <ac:chgData name="Wencai Zhang" userId="4a86a1d0-2108-4707-8228-1110f3c1be85" providerId="ADAL" clId="{0E9FBDE7-7504-E948-96F8-38AF79E2A691}" dt="2021-06-06T15:59:54.258" v="5346" actId="1036"/>
          <ac:spMkLst>
            <pc:docMk/>
            <pc:sldMk cId="1904142445" sldId="276"/>
            <ac:spMk id="72" creationId="{01E6CBBD-975D-684C-8F3B-F6E617F4614D}"/>
          </ac:spMkLst>
        </pc:spChg>
        <pc:spChg chg="add mod">
          <ac:chgData name="Wencai Zhang" userId="4a86a1d0-2108-4707-8228-1110f3c1be85" providerId="ADAL" clId="{0E9FBDE7-7504-E948-96F8-38AF79E2A691}" dt="2021-06-06T16:00:00.323" v="5365" actId="1037"/>
          <ac:spMkLst>
            <pc:docMk/>
            <pc:sldMk cId="1904142445" sldId="276"/>
            <ac:spMk id="73" creationId="{682628A6-CA67-524D-B834-77C4B1F2480D}"/>
          </ac:spMkLst>
        </pc:spChg>
        <pc:spChg chg="mod">
          <ac:chgData name="Wencai Zhang" userId="4a86a1d0-2108-4707-8228-1110f3c1be85" providerId="ADAL" clId="{0E9FBDE7-7504-E948-96F8-38AF79E2A691}" dt="2021-06-06T16:01:21.036" v="5433" actId="1038"/>
          <ac:spMkLst>
            <pc:docMk/>
            <pc:sldMk cId="1904142445" sldId="276"/>
            <ac:spMk id="75" creationId="{E77E68DC-7BCF-5C47-A988-940C4054E7C3}"/>
          </ac:spMkLst>
        </pc:spChg>
        <pc:spChg chg="mod">
          <ac:chgData name="Wencai Zhang" userId="4a86a1d0-2108-4707-8228-1110f3c1be85" providerId="ADAL" clId="{0E9FBDE7-7504-E948-96F8-38AF79E2A691}" dt="2021-06-06T16:01:24.759" v="5434" actId="1037"/>
          <ac:spMkLst>
            <pc:docMk/>
            <pc:sldMk cId="1904142445" sldId="276"/>
            <ac:spMk id="76" creationId="{47C3A48E-7DD0-E64C-839D-4CC80EF741CE}"/>
          </ac:spMkLst>
        </pc:spChg>
        <pc:spChg chg="mod">
          <ac:chgData name="Wencai Zhang" userId="4a86a1d0-2108-4707-8228-1110f3c1be85" providerId="ADAL" clId="{0E9FBDE7-7504-E948-96F8-38AF79E2A691}" dt="2021-06-06T15:58:35.268" v="5249" actId="1038"/>
          <ac:spMkLst>
            <pc:docMk/>
            <pc:sldMk cId="1904142445" sldId="276"/>
            <ac:spMk id="81" creationId="{B11A44CD-AB09-E540-9980-026812E6FB54}"/>
          </ac:spMkLst>
        </pc:spChg>
        <pc:spChg chg="mod">
          <ac:chgData name="Wencai Zhang" userId="4a86a1d0-2108-4707-8228-1110f3c1be85" providerId="ADAL" clId="{0E9FBDE7-7504-E948-96F8-38AF79E2A691}" dt="2021-06-06T15:58:17.891" v="5243" actId="1036"/>
          <ac:spMkLst>
            <pc:docMk/>
            <pc:sldMk cId="1904142445" sldId="276"/>
            <ac:spMk id="82" creationId="{6BFEB4B0-080D-8B41-A6FC-9830DD816FA1}"/>
          </ac:spMkLst>
        </pc:spChg>
        <pc:spChg chg="del mod">
          <ac:chgData name="Wencai Zhang" userId="4a86a1d0-2108-4707-8228-1110f3c1be85" providerId="ADAL" clId="{0E9FBDE7-7504-E948-96F8-38AF79E2A691}" dt="2021-06-06T15:36:03.915" v="4944" actId="478"/>
          <ac:spMkLst>
            <pc:docMk/>
            <pc:sldMk cId="1904142445" sldId="276"/>
            <ac:spMk id="83" creationId="{03C19FF2-DBDE-9D43-B9F5-C7B9D96798C5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5" creationId="{AA38FC35-F87B-EB4B-BFFC-7E18705C1366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7" creationId="{DAC73636-0B0D-3442-B619-CBAB1C91EB5A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9" creationId="{10A2058D-E914-C245-AEB2-BF8A03B80101}"/>
          </ac:spMkLst>
        </pc:spChg>
        <pc:spChg chg="mod">
          <ac:chgData name="Wencai Zhang" userId="4a86a1d0-2108-4707-8228-1110f3c1be85" providerId="ADAL" clId="{0E9FBDE7-7504-E948-96F8-38AF79E2A691}" dt="2021-06-06T15:36:21.855" v="4947"/>
          <ac:spMkLst>
            <pc:docMk/>
            <pc:sldMk cId="1904142445" sldId="276"/>
            <ac:spMk id="91" creationId="{0D4D7E8F-DAE6-FA4C-9C54-233B4375D7E2}"/>
          </ac:spMkLst>
        </pc:spChg>
        <pc:spChg chg="mod">
          <ac:chgData name="Wencai Zhang" userId="4a86a1d0-2108-4707-8228-1110f3c1be85" providerId="ADAL" clId="{0E9FBDE7-7504-E948-96F8-38AF79E2A691}" dt="2021-06-06T16:01:00.674" v="5411" actId="1035"/>
          <ac:spMkLst>
            <pc:docMk/>
            <pc:sldMk cId="1904142445" sldId="276"/>
            <ac:spMk id="92" creationId="{69B34F8C-CEBF-6B4B-BE47-D2E514474584}"/>
          </ac:spMkLst>
        </pc:spChg>
        <pc:spChg chg="mod">
          <ac:chgData name="Wencai Zhang" userId="4a86a1d0-2108-4707-8228-1110f3c1be85" providerId="ADAL" clId="{0E9FBDE7-7504-E948-96F8-38AF79E2A691}" dt="2021-06-06T16:00:05.951" v="5380" actId="1038"/>
          <ac:spMkLst>
            <pc:docMk/>
            <pc:sldMk cId="1904142445" sldId="276"/>
            <ac:spMk id="97" creationId="{274E4200-55E5-7041-8D4B-3EAC2573EA7F}"/>
          </ac:spMkLst>
        </pc:spChg>
        <pc:spChg chg="mod">
          <ac:chgData name="Wencai Zhang" userId="4a86a1d0-2108-4707-8228-1110f3c1be85" providerId="ADAL" clId="{0E9FBDE7-7504-E948-96F8-38AF79E2A691}" dt="2021-06-06T16:00:21.395" v="5398" actId="14100"/>
          <ac:spMkLst>
            <pc:docMk/>
            <pc:sldMk cId="1904142445" sldId="276"/>
            <ac:spMk id="98" creationId="{E17D2348-CFEC-6240-984F-7853BD0A9B90}"/>
          </ac:spMkLst>
        </pc:spChg>
        <pc:spChg chg="del mod">
          <ac:chgData name="Wencai Zhang" userId="4a86a1d0-2108-4707-8228-1110f3c1be85" providerId="ADAL" clId="{0E9FBDE7-7504-E948-96F8-38AF79E2A691}" dt="2021-06-06T15:39:24.484" v="4970" actId="478"/>
          <ac:spMkLst>
            <pc:docMk/>
            <pc:sldMk cId="1904142445" sldId="276"/>
            <ac:spMk id="99" creationId="{74C0D7C1-8DCF-DB4D-949E-5E6FBC15ADA0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1" creationId="{536BEA61-7836-4944-9F3B-A41F89908BB7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2" creationId="{CF33D9E9-1318-4F46-AED2-735530EAEB61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4" creationId="{5DE8AF71-ECCA-7B42-812D-FD10C2FC530B}"/>
          </ac:spMkLst>
        </pc:spChg>
        <pc:spChg chg="mod">
          <ac:chgData name="Wencai Zhang" userId="4a86a1d0-2108-4707-8228-1110f3c1be85" providerId="ADAL" clId="{0E9FBDE7-7504-E948-96F8-38AF79E2A691}" dt="2021-06-06T15:39:52.004" v="4977"/>
          <ac:spMkLst>
            <pc:docMk/>
            <pc:sldMk cId="1904142445" sldId="276"/>
            <ac:spMk id="106" creationId="{4793BD6F-8972-BE41-A3A5-4B8D0B7E9242}"/>
          </ac:spMkLst>
        </pc:spChg>
        <pc:spChg chg="mod">
          <ac:chgData name="Wencai Zhang" userId="4a86a1d0-2108-4707-8228-1110f3c1be85" providerId="ADAL" clId="{0E9FBDE7-7504-E948-96F8-38AF79E2A691}" dt="2021-06-06T15:40:23.317" v="4992" actId="1038"/>
          <ac:spMkLst>
            <pc:docMk/>
            <pc:sldMk cId="1904142445" sldId="276"/>
            <ac:spMk id="107" creationId="{6675E637-4138-C341-958A-75BBFD7CCCCE}"/>
          </ac:spMkLst>
        </pc:spChg>
        <pc:spChg chg="add mod">
          <ac:chgData name="Wencai Zhang" userId="4a86a1d0-2108-4707-8228-1110f3c1be85" providerId="ADAL" clId="{0E9FBDE7-7504-E948-96F8-38AF79E2A691}" dt="2021-06-06T16:06:19.934" v="5570" actId="1038"/>
          <ac:spMkLst>
            <pc:docMk/>
            <pc:sldMk cId="1904142445" sldId="276"/>
            <ac:spMk id="108" creationId="{89C89FAF-4842-524D-AF98-F3FFA64F9BD1}"/>
          </ac:spMkLst>
        </pc:spChg>
        <pc:spChg chg="add mod">
          <ac:chgData name="Wencai Zhang" userId="4a86a1d0-2108-4707-8228-1110f3c1be85" providerId="ADAL" clId="{0E9FBDE7-7504-E948-96F8-38AF79E2A691}" dt="2021-06-06T16:06:24.786" v="5576" actId="1038"/>
          <ac:spMkLst>
            <pc:docMk/>
            <pc:sldMk cId="1904142445" sldId="276"/>
            <ac:spMk id="109" creationId="{C8C783A9-671D-BF47-AF61-592D0BA8F627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110" creationId="{40F21ACF-2347-C940-B4D2-47BE3EB32F1D}"/>
          </ac:spMkLst>
        </pc:spChg>
        <pc:spChg chg="add 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111" creationId="{4605A341-82E6-B544-96DA-F7011F58BBBE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3" creationId="{254A5957-4623-3D46-88D5-2014304F92A3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4" creationId="{1EC7AE5A-F01D-504C-A283-879EB4AB0576}"/>
          </ac:spMkLst>
        </pc:spChg>
        <pc:spChg chg="mod">
          <ac:chgData name="Wencai Zhang" userId="4a86a1d0-2108-4707-8228-1110f3c1be85" providerId="ADAL" clId="{0E9FBDE7-7504-E948-96F8-38AF79E2A691}" dt="2021-06-06T16:02:04.123" v="5478" actId="1076"/>
          <ac:spMkLst>
            <pc:docMk/>
            <pc:sldMk cId="1904142445" sldId="276"/>
            <ac:spMk id="115" creationId="{B42B0DA9-1F0C-AB42-9E21-6FC8CB756208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7" creationId="{37607B02-5747-474F-AF29-F5B829055DB3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8" creationId="{E33F51B8-945B-A643-B33B-A6684C7435AF}"/>
          </ac:spMkLst>
        </pc:spChg>
        <pc:spChg chg="mod">
          <ac:chgData name="Wencai Zhang" userId="4a86a1d0-2108-4707-8228-1110f3c1be85" providerId="ADAL" clId="{0E9FBDE7-7504-E948-96F8-38AF79E2A691}" dt="2021-06-06T16:02:01.007" v="5477" actId="1076"/>
          <ac:spMkLst>
            <pc:docMk/>
            <pc:sldMk cId="1904142445" sldId="276"/>
            <ac:spMk id="119" creationId="{2FB215A4-9A00-F743-AAE7-2644B28DE74E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1" creationId="{9787A2A8-D360-E34E-A29A-57B86E0A4499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2" creationId="{CC9814A4-CB59-AF4B-9E78-13180EFC970D}"/>
          </ac:spMkLst>
        </pc:spChg>
        <pc:spChg chg="mod">
          <ac:chgData name="Wencai Zhang" userId="4a86a1d0-2108-4707-8228-1110f3c1be85" providerId="ADAL" clId="{0E9FBDE7-7504-E948-96F8-38AF79E2A691}" dt="2021-06-06T16:02:08.702" v="5479" actId="1076"/>
          <ac:spMkLst>
            <pc:docMk/>
            <pc:sldMk cId="1904142445" sldId="276"/>
            <ac:spMk id="123" creationId="{D2486B6F-45FA-8C4E-BBBF-D82610E4701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5" creationId="{DE379A3A-CD96-874E-80AB-6E5022DFFF8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6" creationId="{D708DC3F-6D5B-8443-A04E-E53DACE280C0}"/>
          </ac:spMkLst>
        </pc:spChg>
        <pc:spChg chg="mod">
          <ac:chgData name="Wencai Zhang" userId="4a86a1d0-2108-4707-8228-1110f3c1be85" providerId="ADAL" clId="{0E9FBDE7-7504-E948-96F8-38AF79E2A691}" dt="2021-06-06T16:02:22.681" v="5492" actId="1076"/>
          <ac:spMkLst>
            <pc:docMk/>
            <pc:sldMk cId="1904142445" sldId="276"/>
            <ac:spMk id="127" creationId="{F34E7A16-DAF5-AE4D-BD0C-80B7678C7FAF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29" creationId="{6F2F89A8-A67D-2C41-897D-7F0C4752CEC3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30" creationId="{AE3E9EF6-27CD-3045-B302-5E1597AEABDE}"/>
          </ac:spMkLst>
        </pc:spChg>
        <pc:spChg chg="mod">
          <ac:chgData name="Wencai Zhang" userId="4a86a1d0-2108-4707-8228-1110f3c1be85" providerId="ADAL" clId="{0E9FBDE7-7504-E948-96F8-38AF79E2A691}" dt="2021-06-06T16:02:36.062" v="5493" actId="1076"/>
          <ac:spMkLst>
            <pc:docMk/>
            <pc:sldMk cId="1904142445" sldId="276"/>
            <ac:spMk id="131" creationId="{10B11A69-798D-3E44-B109-3978C3137D24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3" creationId="{80BF018F-851D-3643-B082-08D0465A0363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4" creationId="{FE8EB68A-FB70-2643-8192-72EAAF04FAD4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6" creationId="{7590D5F9-89B2-C346-A97B-A9C5D03B9003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7" creationId="{1FFE7580-2B18-DE46-9E7D-DC5E37B7829D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39" creationId="{26003011-45A7-9948-A2BF-07E5B632C3C0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40" creationId="{09511290-1431-E140-99F3-39D6194AC21C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2" creationId="{2C1C9B51-93D8-9245-956D-0070F2AACD78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3" creationId="{3CF8D50B-BD9C-664F-B713-4868B6361225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5" creationId="{E76BC32A-7046-7749-9D44-3E94A61D2DA7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6" creationId="{4E722359-596D-2C45-9BBF-09A7B259A82F}"/>
          </ac:spMkLst>
        </pc:spChg>
        <pc:grpChg chg="mod">
          <ac:chgData name="Wencai Zhang" userId="4a86a1d0-2108-4707-8228-1110f3c1be85" providerId="ADAL" clId="{0E9FBDE7-7504-E948-96F8-38AF79E2A691}" dt="2021-06-06T15:40:49.401" v="4995" actId="164"/>
          <ac:grpSpMkLst>
            <pc:docMk/>
            <pc:sldMk cId="1904142445" sldId="276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6T15:29:16.679" v="4903" actId="164"/>
          <ac:grpSpMkLst>
            <pc:docMk/>
            <pc:sldMk cId="1904142445" sldId="276"/>
            <ac:grpSpMk id="3" creationId="{B836CDE8-D276-B14C-8317-FF755C7FD67B}"/>
          </ac:grpSpMkLst>
        </pc:grpChg>
        <pc:grpChg chg="add del mod">
          <ac:chgData name="Wencai Zhang" userId="4a86a1d0-2108-4707-8228-1110f3c1be85" providerId="ADAL" clId="{0E9FBDE7-7504-E948-96F8-38AF79E2A691}" dt="2021-06-06T15:54:25.514" v="5108" actId="478"/>
          <ac:grpSpMkLst>
            <pc:docMk/>
            <pc:sldMk cId="1904142445" sldId="276"/>
            <ac:grpSpMk id="4" creationId="{9DDD58B9-7E0B-744E-9BCF-FC0B93CF9BFD}"/>
          </ac:grpSpMkLst>
        </pc:grpChg>
        <pc:grpChg chg="add del mod">
          <ac:chgData name="Wencai Zhang" userId="4a86a1d0-2108-4707-8228-1110f3c1be85" providerId="ADAL" clId="{0E9FBDE7-7504-E948-96F8-38AF79E2A691}" dt="2021-06-06T15:55:37.623" v="5120" actId="478"/>
          <ac:grpSpMkLst>
            <pc:docMk/>
            <pc:sldMk cId="1904142445" sldId="276"/>
            <ac:grpSpMk id="6" creationId="{2B6AC6BB-A102-C745-9D0A-4447A3D74C22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7" creationId="{2655B5AC-157E-D44E-8BAF-1F9F9C5FBBF4}"/>
          </ac:grpSpMkLst>
        </pc:grpChg>
        <pc:grpChg chg="add del mod">
          <ac:chgData name="Wencai Zhang" userId="4a86a1d0-2108-4707-8228-1110f3c1be85" providerId="ADAL" clId="{0E9FBDE7-7504-E948-96F8-38AF79E2A691}" dt="2021-06-06T15:52:53.615" v="5073" actId="478"/>
          <ac:grpSpMkLst>
            <pc:docMk/>
            <pc:sldMk cId="1904142445" sldId="276"/>
            <ac:grpSpMk id="9" creationId="{24C2EBF9-D50B-9245-A4A6-81A1AFD31791}"/>
          </ac:grpSpMkLst>
        </pc:grpChg>
        <pc:grpChg chg="add mod">
          <ac:chgData name="Wencai Zhang" userId="4a86a1d0-2108-4707-8228-1110f3c1be85" providerId="ADAL" clId="{0E9FBDE7-7504-E948-96F8-38AF79E2A691}" dt="2021-06-06T15:30:03.944" v="4907" actId="164"/>
          <ac:grpSpMkLst>
            <pc:docMk/>
            <pc:sldMk cId="1904142445" sldId="276"/>
            <ac:grpSpMk id="10" creationId="{50CA3344-D289-054B-B7B4-72C93FDBEC39}"/>
          </ac:grpSpMkLst>
        </pc:grpChg>
        <pc:grpChg chg="add mod">
          <ac:chgData name="Wencai Zhang" userId="4a86a1d0-2108-4707-8228-1110f3c1be85" providerId="ADAL" clId="{0E9FBDE7-7504-E948-96F8-38AF79E2A691}" dt="2021-06-06T16:01:41.219" v="5460" actId="1038"/>
          <ac:grpSpMkLst>
            <pc:docMk/>
            <pc:sldMk cId="1904142445" sldId="276"/>
            <ac:grpSpMk id="13" creationId="{30D750A9-F43F-DB4F-AEEB-8C2FE02E18ED}"/>
          </ac:grpSpMkLst>
        </pc:grpChg>
        <pc:grpChg chg="add del mod">
          <ac:chgData name="Wencai Zhang" userId="4a86a1d0-2108-4707-8228-1110f3c1be85" providerId="ADAL" clId="{0E9FBDE7-7504-E948-96F8-38AF79E2A691}" dt="2021-06-06T15:52:43.239" v="5070" actId="478"/>
          <ac:grpSpMkLst>
            <pc:docMk/>
            <pc:sldMk cId="1904142445" sldId="276"/>
            <ac:grpSpMk id="14" creationId="{C3CB11A9-EB5C-3743-85AB-19C9D1A2BBEF}"/>
          </ac:grpSpMkLst>
        </pc:grpChg>
        <pc:grpChg chg="add mod">
          <ac:chgData name="Wencai Zhang" userId="4a86a1d0-2108-4707-8228-1110f3c1be85" providerId="ADAL" clId="{0E9FBDE7-7504-E948-96F8-38AF79E2A691}" dt="2021-06-06T15:43:17.198" v="5014" actId="164"/>
          <ac:grpSpMkLst>
            <pc:docMk/>
            <pc:sldMk cId="1904142445" sldId="276"/>
            <ac:grpSpMk id="15" creationId="{E278F67A-D9C4-CA4E-9338-EBAE27291E00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6" creationId="{000DF15E-C10B-3740-9FBD-82FE31A0DB47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7" creationId="{CC64A505-9742-AA47-B25B-E2657D796EF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8" creationId="{A2CAB50E-7BCD-8943-B2BF-B3ADC66177A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9" creationId="{205A5C64-FDFE-4D40-AD17-6E7D958EFE1C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0" creationId="{A6DAA4FE-2820-2041-A490-E3491E68F991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1" creationId="{A08E21AA-65D0-904C-A117-A07CC56DBB2D}"/>
          </ac:grpSpMkLst>
        </pc:grpChg>
        <pc:grpChg chg="add mod">
          <ac:chgData name="Wencai Zhang" userId="4a86a1d0-2108-4707-8228-1110f3c1be85" providerId="ADAL" clId="{0E9FBDE7-7504-E948-96F8-38AF79E2A691}" dt="2021-06-06T16:01:33.814" v="5446" actId="1037"/>
          <ac:grpSpMkLst>
            <pc:docMk/>
            <pc:sldMk cId="1904142445" sldId="276"/>
            <ac:grpSpMk id="25" creationId="{1711E9A0-9690-7B4F-88B5-37979F6E7C8F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27" creationId="{085EE8EB-9254-814C-8B70-E0651E3C2E51}"/>
          </ac:grpSpMkLst>
        </pc:grpChg>
        <pc:grpChg chg="add mod">
          <ac:chgData name="Wencai Zhang" userId="4a86a1d0-2108-4707-8228-1110f3c1be85" providerId="ADAL" clId="{0E9FBDE7-7504-E948-96F8-38AF79E2A691}" dt="2021-06-06T16:08:22.735" v="5644" actId="1038"/>
          <ac:grpSpMkLst>
            <pc:docMk/>
            <pc:sldMk cId="1904142445" sldId="276"/>
            <ac:grpSpMk id="28" creationId="{9CB1D8B0-F590-104D-A25D-BE274576AAFE}"/>
          </ac:grpSpMkLst>
        </pc:grpChg>
        <pc:grpChg chg="add mod">
          <ac:chgData name="Wencai Zhang" userId="4a86a1d0-2108-4707-8228-1110f3c1be85" providerId="ADAL" clId="{0E9FBDE7-7504-E948-96F8-38AF79E2A691}" dt="2021-06-06T15:41:11.443" v="5000" actId="164"/>
          <ac:grpSpMkLst>
            <pc:docMk/>
            <pc:sldMk cId="1904142445" sldId="276"/>
            <ac:grpSpMk id="53" creationId="{1415EA90-2626-A143-8E38-EA5B82C9E028}"/>
          </ac:grpSpMkLst>
        </pc:grpChg>
        <pc:grpChg chg="add mod">
          <ac:chgData name="Wencai Zhang" userId="4a86a1d0-2108-4707-8228-1110f3c1be85" providerId="ADAL" clId="{0E9FBDE7-7504-E948-96F8-38AF79E2A691}" dt="2021-06-06T15:44:05.863" v="5020" actId="164"/>
          <ac:grpSpMkLst>
            <pc:docMk/>
            <pc:sldMk cId="1904142445" sldId="276"/>
            <ac:grpSpMk id="74" creationId="{AEE54D5D-8AEB-D34C-9C94-0B014FF08BDD}"/>
          </ac:grpSpMkLst>
        </pc:grpChg>
        <pc:grpChg chg="add mod">
          <ac:chgData name="Wencai Zhang" userId="4a86a1d0-2108-4707-8228-1110f3c1be85" providerId="ADAL" clId="{0E9FBDE7-7504-E948-96F8-38AF79E2A691}" dt="2021-06-06T15:38:14.691" v="4963" actId="164"/>
          <ac:grpSpMkLst>
            <pc:docMk/>
            <pc:sldMk cId="1904142445" sldId="276"/>
            <ac:grpSpMk id="79" creationId="{BCAD6698-7ABF-9143-B78D-400EA289BEFB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84" creationId="{7F17BAEC-63BF-1344-8312-34E74E297F5D}"/>
          </ac:grpSpMkLst>
        </pc:grpChg>
        <pc:grpChg chg="add mod">
          <ac:chgData name="Wencai Zhang" userId="4a86a1d0-2108-4707-8228-1110f3c1be85" providerId="ADAL" clId="{0E9FBDE7-7504-E948-96F8-38AF79E2A691}" dt="2021-06-06T15:41:01.856" v="4998" actId="164"/>
          <ac:grpSpMkLst>
            <pc:docMk/>
            <pc:sldMk cId="1904142445" sldId="276"/>
            <ac:grpSpMk id="90" creationId="{913957B1-5B21-B047-8073-3ECABBBD5AAF}"/>
          </ac:grpSpMkLst>
        </pc:grpChg>
        <pc:grpChg chg="add mod">
          <ac:chgData name="Wencai Zhang" userId="4a86a1d0-2108-4707-8228-1110f3c1be85" providerId="ADAL" clId="{0E9FBDE7-7504-E948-96F8-38AF79E2A691}" dt="2021-06-06T15:43:35.162" v="5016" actId="164"/>
          <ac:grpSpMkLst>
            <pc:docMk/>
            <pc:sldMk cId="1904142445" sldId="276"/>
            <ac:grpSpMk id="95" creationId="{5AA2CBDC-65C0-7B40-85C9-DB0CFAB62EC0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100" creationId="{B2129D68-A35B-2A44-90D1-196CECB31AC8}"/>
          </ac:grpSpMkLst>
        </pc:grpChg>
        <pc:grpChg chg="add mod">
          <ac:chgData name="Wencai Zhang" userId="4a86a1d0-2108-4707-8228-1110f3c1be85" providerId="ADAL" clId="{0E9FBDE7-7504-E948-96F8-38AF79E2A691}" dt="2021-06-06T15:44:15.426" v="5022" actId="164"/>
          <ac:grpSpMkLst>
            <pc:docMk/>
            <pc:sldMk cId="1904142445" sldId="276"/>
            <ac:grpSpMk id="105" creationId="{1337AA02-3BEF-5048-A5F7-CDBFE552582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2" creationId="{39482E35-DF26-3448-858B-B50EFC7DAC6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6" creationId="{1843893F-CE16-6444-BE47-0C91696F4DFF}"/>
          </ac:grpSpMkLst>
        </pc:grpChg>
        <pc:grpChg chg="add mod">
          <ac:chgData name="Wencai Zhang" userId="4a86a1d0-2108-4707-8228-1110f3c1be85" providerId="ADAL" clId="{0E9FBDE7-7504-E948-96F8-38AF79E2A691}" dt="2021-06-06T16:01:46.651" v="5475" actId="1038"/>
          <ac:grpSpMkLst>
            <pc:docMk/>
            <pc:sldMk cId="1904142445" sldId="276"/>
            <ac:grpSpMk id="120" creationId="{2D8B4FF8-62C0-9A43-81EA-1FE793657B09}"/>
          </ac:grpSpMkLst>
        </pc:grpChg>
        <pc:grpChg chg="add mod">
          <ac:chgData name="Wencai Zhang" userId="4a86a1d0-2108-4707-8228-1110f3c1be85" providerId="ADAL" clId="{0E9FBDE7-7504-E948-96F8-38AF79E2A691}" dt="2021-06-06T16:02:16.369" v="5491" actId="1037"/>
          <ac:grpSpMkLst>
            <pc:docMk/>
            <pc:sldMk cId="1904142445" sldId="276"/>
            <ac:grpSpMk id="124" creationId="{4FCC834F-CECB-AF4B-9F01-A2A3D26C34A6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28" creationId="{66634B15-676C-0B4E-B19A-18F6C83564C5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2" creationId="{81FAAE4C-7A36-4D46-B842-EAE07CDE7A9A}"/>
          </ac:grpSpMkLst>
        </pc:grpChg>
        <pc:grpChg chg="add mod">
          <ac:chgData name="Wencai Zhang" userId="4a86a1d0-2108-4707-8228-1110f3c1be85" providerId="ADAL" clId="{0E9FBDE7-7504-E948-96F8-38AF79E2A691}" dt="2021-06-06T16:06:19.934" v="5570" actId="1038"/>
          <ac:grpSpMkLst>
            <pc:docMk/>
            <pc:sldMk cId="1904142445" sldId="276"/>
            <ac:grpSpMk id="135" creationId="{F11AF4E8-2724-9846-8729-FAE7825758D6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8" creationId="{8AFBAF9F-21D0-5B48-BCC7-6D901F8A1A2C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141" creationId="{98C8C63A-26BC-B141-BFB8-3BEB7C0E603D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44" creationId="{597C946A-64D0-7642-B871-7E546D0E3197}"/>
          </ac:grpSpMkLst>
        </pc:grpChg>
        <pc:picChg chg="add mod modCrop">
          <ac:chgData name="Wencai Zhang" userId="4a86a1d0-2108-4707-8228-1110f3c1be85" providerId="ADAL" clId="{0E9FBDE7-7504-E948-96F8-38AF79E2A691}" dt="2021-06-06T15:54:07.988" v="5107" actId="732"/>
          <ac:picMkLst>
            <pc:docMk/>
            <pc:sldMk cId="1904142445" sldId="276"/>
            <ac:picMk id="35" creationId="{DAB56067-C9D8-544A-8F0D-3D5A77A0C7B1}"/>
          </ac:picMkLst>
        </pc:picChg>
        <pc:picChg chg="add mod modCrop">
          <ac:chgData name="Wencai Zhang" userId="4a86a1d0-2108-4707-8228-1110f3c1be85" providerId="ADAL" clId="{0E9FBDE7-7504-E948-96F8-38AF79E2A691}" dt="2021-06-06T16:07:25.095" v="5594" actId="732"/>
          <ac:picMkLst>
            <pc:docMk/>
            <pc:sldMk cId="1904142445" sldId="276"/>
            <ac:picMk id="36" creationId="{C08BB6F6-03CA-5647-A634-7F697ACA4D94}"/>
          </ac:picMkLst>
        </pc:picChg>
        <pc:picChg chg="add mod modCrop">
          <ac:chgData name="Wencai Zhang" userId="4a86a1d0-2108-4707-8228-1110f3c1be85" providerId="ADAL" clId="{0E9FBDE7-7504-E948-96F8-38AF79E2A691}" dt="2021-06-06T15:55:34.522" v="5119" actId="167"/>
          <ac:picMkLst>
            <pc:docMk/>
            <pc:sldMk cId="1904142445" sldId="276"/>
            <ac:picMk id="37" creationId="{5733B46C-0A78-6E47-9CA7-D72DE37C5B5B}"/>
          </ac:picMkLst>
        </pc:picChg>
        <pc:picChg chg="add mod modCrop">
          <ac:chgData name="Wencai Zhang" userId="4a86a1d0-2108-4707-8228-1110f3c1be85" providerId="ADAL" clId="{0E9FBDE7-7504-E948-96F8-38AF79E2A691}" dt="2021-06-06T16:04:14.519" v="5525" actId="732"/>
          <ac:picMkLst>
            <pc:docMk/>
            <pc:sldMk cId="1904142445" sldId="276"/>
            <ac:picMk id="38" creationId="{46CC6C68-B684-AD44-A1DC-26AC9D29900B}"/>
          </ac:picMkLst>
        </pc:picChg>
        <pc:picChg chg="del">
          <ac:chgData name="Wencai Zhang" userId="4a86a1d0-2108-4707-8228-1110f3c1be85" providerId="ADAL" clId="{0E9FBDE7-7504-E948-96F8-38AF79E2A691}" dt="2021-06-06T15:21:06.715" v="4833" actId="478"/>
          <ac:picMkLst>
            <pc:docMk/>
            <pc:sldMk cId="1904142445" sldId="276"/>
            <ac:picMk id="55" creationId="{63F65AE1-44E9-354E-BE26-AA103449E57C}"/>
          </ac:picMkLst>
        </pc:picChg>
        <pc:picChg chg="del">
          <ac:chgData name="Wencai Zhang" userId="4a86a1d0-2108-4707-8228-1110f3c1be85" providerId="ADAL" clId="{0E9FBDE7-7504-E948-96F8-38AF79E2A691}" dt="2021-06-06T15:21:02.507" v="4832" actId="478"/>
          <ac:picMkLst>
            <pc:docMk/>
            <pc:sldMk cId="1904142445" sldId="276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2:09.619" v="4838" actId="478"/>
          <ac:picMkLst>
            <pc:docMk/>
            <pc:sldMk cId="1904142445" sldId="276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2:11.470" v="4839" actId="478"/>
          <ac:picMkLst>
            <pc:docMk/>
            <pc:sldMk cId="1904142445" sldId="276"/>
            <ac:picMk id="58" creationId="{35932F72-055A-784A-B589-B30EEFC75F1A}"/>
          </ac:picMkLst>
        </pc:picChg>
        <pc:picChg chg="add mod modCrop">
          <ac:chgData name="Wencai Zhang" userId="4a86a1d0-2108-4707-8228-1110f3c1be85" providerId="ADAL" clId="{0E9FBDE7-7504-E948-96F8-38AF79E2A691}" dt="2021-06-06T15:54:39.579" v="5110" actId="732"/>
          <ac:picMkLst>
            <pc:docMk/>
            <pc:sldMk cId="1904142445" sldId="276"/>
            <ac:picMk id="69" creationId="{72B762D0-D956-2545-B9FE-55271B7E715D}"/>
          </ac:picMkLst>
        </pc:picChg>
        <pc:picChg chg="add mod modCrop">
          <ac:chgData name="Wencai Zhang" userId="4a86a1d0-2108-4707-8228-1110f3c1be85" providerId="ADAL" clId="{0E9FBDE7-7504-E948-96F8-38AF79E2A691}" dt="2021-06-06T15:51:33.464" v="5063" actId="732"/>
          <ac:picMkLst>
            <pc:docMk/>
            <pc:sldMk cId="1904142445" sldId="276"/>
            <ac:picMk id="71" creationId="{E303F32A-22A7-E845-8E1D-26F4AB261195}"/>
          </ac:picMkLst>
        </pc:picChg>
        <pc:picChg chg="add mod modCrop">
          <ac:chgData name="Wencai Zhang" userId="4a86a1d0-2108-4707-8228-1110f3c1be85" providerId="ADAL" clId="{0E9FBDE7-7504-E948-96F8-38AF79E2A691}" dt="2021-06-06T15:38:14.691" v="4963" actId="164"/>
          <ac:picMkLst>
            <pc:docMk/>
            <pc:sldMk cId="1904142445" sldId="276"/>
            <ac:picMk id="77" creationId="{044309F2-5B00-714A-91B7-DBDFA966F19F}"/>
          </ac:picMkLst>
        </pc:picChg>
        <pc:picChg chg="add mod modCrop">
          <ac:chgData name="Wencai Zhang" userId="4a86a1d0-2108-4707-8228-1110f3c1be85" providerId="ADAL" clId="{0E9FBDE7-7504-E948-96F8-38AF79E2A691}" dt="2021-06-06T15:41:01.856" v="4998" actId="164"/>
          <ac:picMkLst>
            <pc:docMk/>
            <pc:sldMk cId="1904142445" sldId="276"/>
            <ac:picMk id="78" creationId="{4E5F5627-9396-1E4A-8E7E-490E36050DD7}"/>
          </ac:picMkLst>
        </pc:picChg>
        <pc:picChg chg="del mod">
          <ac:chgData name="Wencai Zhang" userId="4a86a1d0-2108-4707-8228-1110f3c1be85" providerId="ADAL" clId="{0E9FBDE7-7504-E948-96F8-38AF79E2A691}" dt="2021-06-06T15:36:03.915" v="4944" actId="478"/>
          <ac:picMkLst>
            <pc:docMk/>
            <pc:sldMk cId="1904142445" sldId="276"/>
            <ac:picMk id="80" creationId="{C0037B3C-7D4A-9F4D-AE61-AB7242CDB5D1}"/>
          </ac:picMkLst>
        </pc:picChg>
        <pc:picChg chg="mod">
          <ac:chgData name="Wencai Zhang" userId="4a86a1d0-2108-4707-8228-1110f3c1be85" providerId="ADAL" clId="{0E9FBDE7-7504-E948-96F8-38AF79E2A691}" dt="2021-06-06T15:35:20.861" v="4942"/>
          <ac:picMkLst>
            <pc:docMk/>
            <pc:sldMk cId="1904142445" sldId="276"/>
            <ac:picMk id="88" creationId="{1F519345-535F-AC4B-9DC6-89110D676615}"/>
          </ac:picMkLst>
        </pc:picChg>
        <pc:picChg chg="add mod modCrop">
          <ac:chgData name="Wencai Zhang" userId="4a86a1d0-2108-4707-8228-1110f3c1be85" providerId="ADAL" clId="{0E9FBDE7-7504-E948-96F8-38AF79E2A691}" dt="2021-06-06T15:58:55.609" v="5251" actId="732"/>
          <ac:picMkLst>
            <pc:docMk/>
            <pc:sldMk cId="1904142445" sldId="276"/>
            <ac:picMk id="93" creationId="{2E2022A4-2B4E-B149-92D3-14BE7FB3152D}"/>
          </ac:picMkLst>
        </pc:picChg>
        <pc:picChg chg="add mod modCrop">
          <ac:chgData name="Wencai Zhang" userId="4a86a1d0-2108-4707-8228-1110f3c1be85" providerId="ADAL" clId="{0E9FBDE7-7504-E948-96F8-38AF79E2A691}" dt="2021-06-06T16:04:49.100" v="5528" actId="732"/>
          <ac:picMkLst>
            <pc:docMk/>
            <pc:sldMk cId="1904142445" sldId="276"/>
            <ac:picMk id="94" creationId="{9CB03E26-80D4-1F46-9E82-7CA54CA24B2D}"/>
          </ac:picMkLst>
        </pc:picChg>
        <pc:picChg chg="del mod">
          <ac:chgData name="Wencai Zhang" userId="4a86a1d0-2108-4707-8228-1110f3c1be85" providerId="ADAL" clId="{0E9FBDE7-7504-E948-96F8-38AF79E2A691}" dt="2021-06-06T15:39:24.484" v="4970" actId="478"/>
          <ac:picMkLst>
            <pc:docMk/>
            <pc:sldMk cId="1904142445" sldId="276"/>
            <ac:picMk id="96" creationId="{003A6F16-8A05-8643-BF1C-3C4BD04B635D}"/>
          </ac:picMkLst>
        </pc:picChg>
        <pc:picChg chg="mod">
          <ac:chgData name="Wencai Zhang" userId="4a86a1d0-2108-4707-8228-1110f3c1be85" providerId="ADAL" clId="{0E9FBDE7-7504-E948-96F8-38AF79E2A691}" dt="2021-06-06T15:38:56.821" v="4968"/>
          <ac:picMkLst>
            <pc:docMk/>
            <pc:sldMk cId="1904142445" sldId="276"/>
            <ac:picMk id="103" creationId="{09236D4C-04FF-204C-A782-DA094660C71E}"/>
          </ac:picMkLst>
        </pc:picChg>
      </pc:sldChg>
      <pc:sldChg chg="add del">
        <pc:chgData name="Wencai Zhang" userId="4a86a1d0-2108-4707-8228-1110f3c1be85" providerId="ADAL" clId="{0E9FBDE7-7504-E948-96F8-38AF79E2A691}" dt="2021-06-06T15:26:12.604" v="4871" actId="2696"/>
        <pc:sldMkLst>
          <pc:docMk/>
          <pc:sldMk cId="2067902666" sldId="277"/>
        </pc:sldMkLst>
      </pc:sldChg>
      <pc:sldChg chg="addSp delSp modSp add mod ord">
        <pc:chgData name="Wencai Zhang" userId="4a86a1d0-2108-4707-8228-1110f3c1be85" providerId="ADAL" clId="{0E9FBDE7-7504-E948-96F8-38AF79E2A691}" dt="2021-06-07T15:23:38.913" v="6494" actId="1037"/>
        <pc:sldMkLst>
          <pc:docMk/>
          <pc:sldMk cId="2045228985" sldId="278"/>
        </pc:sldMkLst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1" creationId="{8B1765C8-9FB9-4242-ACE4-959BEBC359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2" creationId="{453A5F83-5877-764F-ADD5-5D6844B2FDF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2" creationId="{119C059E-C733-4742-A0D4-D02B0A0755A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3" creationId="{19318E2F-9580-484A-A2E4-97CB1BA629D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4" creationId="{0743C9DB-C2C3-4D68-9AC6-CC11265D5C6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2" creationId="{E7D8A89C-5DD3-434D-B0F9-4FFE362E84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3" creationId="{AD8D757C-C30A-EB43-B121-3175844E2FA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5" creationId="{673ED031-E5A1-294F-B4EA-8553D284268F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6" creationId="{D6199A9D-514E-6649-895F-8DDDB50CE36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7" creationId="{A860A7CF-7FB4-B940-9199-3A5B19AECF97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8" creationId="{8F9392CD-5FB4-F344-B5B6-CC334E28C9CC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0" creationId="{45037DEE-D65D-F945-A5A1-B34D686D4CDA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1" creationId="{0D6658A2-778F-9740-94C6-A58514B11EB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5" creationId="{646AAA43-6529-8644-A13A-FABF2EE17090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6" creationId="{223FC95C-5073-F047-A466-B9B75661E246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48" creationId="{58BCA732-1779-5248-B69E-17D50E58EAD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9" creationId="{FF95B0F2-7C17-7643-B9F6-6A1744873DF4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0" creationId="{1185AA34-8ABA-0647-95BE-BB701E60C95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1" creationId="{D6168116-A21A-4547-A3A6-874E4F2FC8F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2" creationId="{58BD06B3-A6AC-3946-81BB-D7DB344761C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3" creationId="{ED33AD5C-C06D-0F4F-92A2-7963F999A75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4" creationId="{82AD871C-04A2-E340-B553-F577CD682F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0" creationId="{3973D982-89C4-A14A-BEBC-B02DD2F4189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1" creationId="{83D4EDD7-402D-C44E-8C12-80E5C60B6F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3" creationId="{C963CAC6-C6D1-CB4C-A32F-6FEF6482636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4" creationId="{89022B8D-34D9-514A-B27D-E610848B006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5" creationId="{3DFB711B-8B90-1240-B6A8-D19F09136C2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6" creationId="{FF517956-7D11-5045-BAB3-D0FBDAA68E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7" creationId="{5A88E887-9896-2742-9FBE-A90372B280F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8" creationId="{E76224F7-D762-6B4A-8132-BE95ED59A12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9" creationId="{0CE087B0-C8AF-3141-88E1-32DE1192E6B3}"/>
          </ac:spMkLst>
        </pc:spChg>
        <pc:spChg chg="add del mod">
          <ac:chgData name="Wencai Zhang" userId="4a86a1d0-2108-4707-8228-1110f3c1be85" providerId="ADAL" clId="{0E9FBDE7-7504-E948-96F8-38AF79E2A691}" dt="2021-06-07T12:04:38.920" v="6065" actId="478"/>
          <ac:spMkLst>
            <pc:docMk/>
            <pc:sldMk cId="2045228985" sldId="278"/>
            <ac:spMk id="71" creationId="{7864EAF3-86A9-B540-83F9-40756F00466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2" creationId="{1B92AF9C-7B74-F24A-8C93-1581798FB261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3" creationId="{9E59B2C0-F7F7-7B4D-A31B-F632E312A51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7" creationId="{71414430-3BAA-D147-96F8-BE77792F7298}"/>
          </ac:spMkLst>
        </pc:spChg>
        <pc:spChg chg="add mod">
          <ac:chgData name="Wencai Zhang" userId="4a86a1d0-2108-4707-8228-1110f3c1be85" providerId="ADAL" clId="{0E9FBDE7-7504-E948-96F8-38AF79E2A691}" dt="2021-06-07T12:49:18.598" v="6293" actId="1037"/>
          <ac:spMkLst>
            <pc:docMk/>
            <pc:sldMk cId="2045228985" sldId="278"/>
            <ac:spMk id="78" creationId="{512C921C-3DFB-BF44-9558-F29D16049CF3}"/>
          </ac:spMkLst>
        </pc:spChg>
        <pc:spChg chg="add mod topLvl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9" creationId="{18A4F61C-F7D5-6942-A5CA-1258A30E6F9D}"/>
          </ac:spMkLst>
        </pc:spChg>
        <pc:spChg chg="mod">
          <ac:chgData name="Wencai Zhang" userId="4a86a1d0-2108-4707-8228-1110f3c1be85" providerId="ADAL" clId="{0E9FBDE7-7504-E948-96F8-38AF79E2A691}" dt="2021-06-07T12:12:32.527" v="6216"/>
          <ac:spMkLst>
            <pc:docMk/>
            <pc:sldMk cId="2045228985" sldId="278"/>
            <ac:spMk id="85" creationId="{EEF60387-ACAF-5041-9FD8-50A1B4B9CEB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6" creationId="{00000000-0000-0000-0000-000000000000}"/>
          </ac:spMkLst>
        </pc:spChg>
        <pc:spChg chg="mod">
          <ac:chgData name="Wencai Zhang" userId="4a86a1d0-2108-4707-8228-1110f3c1be85" providerId="ADAL" clId="{0E9FBDE7-7504-E948-96F8-38AF79E2A691}" dt="2021-06-07T15:23:38.913" v="6494" actId="1037"/>
          <ac:spMkLst>
            <pc:docMk/>
            <pc:sldMk cId="2045228985" sldId="278"/>
            <ac:spMk id="91" creationId="{01715B91-A957-A04A-90C2-8547B7D81167}"/>
          </ac:spMkLst>
        </pc:spChg>
        <pc:spChg chg="mod">
          <ac:chgData name="Wencai Zhang" userId="4a86a1d0-2108-4707-8228-1110f3c1be85" providerId="ADAL" clId="{0E9FBDE7-7504-E948-96F8-38AF79E2A691}" dt="2021-06-07T15:23:23.818" v="6441" actId="14100"/>
          <ac:spMkLst>
            <pc:docMk/>
            <pc:sldMk cId="2045228985" sldId="278"/>
            <ac:spMk id="93" creationId="{83540293-26E7-9042-BE7C-9660758842C2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4" creationId="{E94762CD-9A89-AD41-9779-FBA12F4B0B10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5" creationId="{75957521-2D37-6B46-BD3C-95F2F9EF9683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6" creationId="{E25D03DC-466F-5C45-9655-0E4D698A093D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7" creationId="{ACCDAEC5-D07C-FC46-BD71-AF0070C9776E}"/>
          </ac:spMkLst>
        </pc:spChg>
        <pc:grpChg chg="del">
          <ac:chgData name="Wencai Zhang" userId="4a86a1d0-2108-4707-8228-1110f3c1be85" providerId="ADAL" clId="{0E9FBDE7-7504-E948-96F8-38AF79E2A691}" dt="2021-06-06T15:26:31.568" v="4872" actId="478"/>
          <ac:grpSpMkLst>
            <pc:docMk/>
            <pc:sldMk cId="2045228985" sldId="278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3" creationId="{CDB113D3-E308-8A44-8F17-1B4556C5E374}"/>
          </ac:grpSpMkLst>
        </pc:grpChg>
        <pc:grpChg chg="add mod">
          <ac:chgData name="Wencai Zhang" userId="4a86a1d0-2108-4707-8228-1110f3c1be85" providerId="ADAL" clId="{0E9FBDE7-7504-E948-96F8-38AF79E2A691}" dt="2021-06-07T12:12:00.144" v="6212" actId="164"/>
          <ac:grpSpMkLst>
            <pc:docMk/>
            <pc:sldMk cId="2045228985" sldId="278"/>
            <ac:grpSpMk id="4" creationId="{B456626B-D685-1A48-BF59-17F056B5F8C5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6" creationId="{781B7FD8-211C-F340-B6DA-A48DCF866596}"/>
          </ac:grpSpMkLst>
        </pc:grpChg>
        <pc:grpChg chg="add mod topLvl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7" creationId="{067D0D9E-0133-B447-AEF2-53DD3A55A1B1}"/>
          </ac:grpSpMkLst>
        </pc:grpChg>
        <pc:grpChg chg="add del mod">
          <ac:chgData name="Wencai Zhang" userId="4a86a1d0-2108-4707-8228-1110f3c1be85" providerId="ADAL" clId="{0E9FBDE7-7504-E948-96F8-38AF79E2A691}" dt="2021-06-07T12:12:54.342" v="6219" actId="165"/>
          <ac:grpSpMkLst>
            <pc:docMk/>
            <pc:sldMk cId="2045228985" sldId="278"/>
            <ac:grpSpMk id="9" creationId="{1DDCAB76-4B3A-FA43-9A7A-ADFA43529143}"/>
          </ac:grpSpMkLst>
        </pc:grpChg>
        <pc:grpChg chg="add mod">
          <ac:chgData name="Wencai Zhang" userId="4a86a1d0-2108-4707-8228-1110f3c1be85" providerId="ADAL" clId="{0E9FBDE7-7504-E948-96F8-38AF79E2A691}" dt="2021-06-07T12:51:46.139" v="6295" actId="1076"/>
          <ac:grpSpMkLst>
            <pc:docMk/>
            <pc:sldMk cId="2045228985" sldId="278"/>
            <ac:grpSpMk id="10" creationId="{CBAE5C45-A501-B646-B027-69E1A9B7C103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84" creationId="{1AFFF9C8-82B8-9E44-8BE5-660903079A26}"/>
          </ac:grpSpMkLst>
        </pc:grpChg>
        <pc:grpChg chg="mod">
          <ac:chgData name="Wencai Zhang" userId="4a86a1d0-2108-4707-8228-1110f3c1be85" providerId="ADAL" clId="{0E9FBDE7-7504-E948-96F8-38AF79E2A691}" dt="2021-06-07T12:12:32.527" v="6216"/>
          <ac:grpSpMkLst>
            <pc:docMk/>
            <pc:sldMk cId="2045228985" sldId="278"/>
            <ac:grpSpMk id="87" creationId="{154C5EB3-687B-0F44-9699-32ABD2CCD24A}"/>
          </ac:grpSpMkLst>
        </pc:grpChg>
        <pc:grpChg chg="add mod">
          <ac:chgData name="Wencai Zhang" userId="4a86a1d0-2108-4707-8228-1110f3c1be85" providerId="ADAL" clId="{0E9FBDE7-7504-E948-96F8-38AF79E2A691}" dt="2021-06-07T13:35:46.324" v="6321" actId="1076"/>
          <ac:grpSpMkLst>
            <pc:docMk/>
            <pc:sldMk cId="2045228985" sldId="278"/>
            <ac:grpSpMk id="90" creationId="{928B9537-0813-2A4E-8322-595CDB2EC21B}"/>
          </ac:grpSpMkLst>
        </pc:grp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8" creationId="{35932F72-055A-784A-B589-B30EEFC75F1A}"/>
          </ac:picMkLst>
        </pc:picChg>
        <pc:picChg chg="mod modCrop">
          <ac:chgData name="Wencai Zhang" userId="4a86a1d0-2108-4707-8228-1110f3c1be85" providerId="ADAL" clId="{0E9FBDE7-7504-E948-96F8-38AF79E2A691}" dt="2021-06-07T15:23:07.830" v="6416" actId="732"/>
          <ac:picMkLst>
            <pc:docMk/>
            <pc:sldMk cId="2045228985" sldId="278"/>
            <ac:picMk id="92" creationId="{11175EF9-B5D5-5842-BA6C-85C80540B73E}"/>
          </ac:picMkLst>
        </pc:pic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39" creationId="{3B6C14AC-1584-A74B-9704-689D2347C132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4" creationId="{B43C4E78-B0A2-8648-AA3D-94F4D464A4F7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7" creationId="{81FDF722-0F7C-4C4F-81CC-725A55005E85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4" creationId="{DFEE4C10-A3A9-9D41-92D4-B8263B0F5653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5" creationId="{774593F7-3B8C-3643-827E-DE2C4FB9ACDF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6" creationId="{B53EF7CE-4A94-E446-8837-C0A4D19B70A7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0" creationId="{8ECE492F-E3A0-D243-9FDC-ED602DDDB175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1" creationId="{C93D785D-4ED9-B549-9BBB-45E46FDF0573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2" creationId="{78B2B893-3E36-4A44-9DA7-FD9C34A3F50B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3" creationId="{F0C522DF-BC4A-7044-B63D-5F578CBB9B0D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8" creationId="{354A7B08-EED0-9E4A-963B-89EA6570AB30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9" creationId="{725654B9-539A-0A47-9561-0567BC1AC555}"/>
          </ac:cxnSpMkLst>
        </pc:cxnChg>
      </pc:sldChg>
      <pc:sldChg chg="add del">
        <pc:chgData name="Wencai Zhang" userId="4a86a1d0-2108-4707-8228-1110f3c1be85" providerId="ADAL" clId="{0E9FBDE7-7504-E948-96F8-38AF79E2A691}" dt="2021-06-06T15:46:12.593" v="5025" actId="2696"/>
        <pc:sldMkLst>
          <pc:docMk/>
          <pc:sldMk cId="1850129879" sldId="279"/>
        </pc:sldMkLst>
      </pc:sldChg>
    </pc:docChg>
  </pc:docChgLst>
  <pc:docChgLst>
    <pc:chgData name="Wencai Zhang" userId="4a86a1d0-2108-4707-8228-1110f3c1be85" providerId="ADAL" clId="{92F21252-1024-CC49-A093-A0F2C80F68C5}"/>
    <pc:docChg chg="custSel modSld">
      <pc:chgData name="Wencai Zhang" userId="4a86a1d0-2108-4707-8228-1110f3c1be85" providerId="ADAL" clId="{92F21252-1024-CC49-A093-A0F2C80F68C5}" dt="2021-04-12T19:51:22.291" v="607" actId="14100"/>
      <pc:docMkLst>
        <pc:docMk/>
      </pc:docMkLst>
      <pc:sldChg chg="addSp delSp modSp mod">
        <pc:chgData name="Wencai Zhang" userId="4a86a1d0-2108-4707-8228-1110f3c1be85" providerId="ADAL" clId="{92F21252-1024-CC49-A093-A0F2C80F68C5}" dt="2021-04-12T19:51:22.291" v="607" actId="14100"/>
        <pc:sldMkLst>
          <pc:docMk/>
          <pc:sldMk cId="3242017852" sldId="272"/>
        </pc:sldMkLst>
        <pc:spChg chg="del">
          <ac:chgData name="Wencai Zhang" userId="4a86a1d0-2108-4707-8228-1110f3c1be85" providerId="ADAL" clId="{92F21252-1024-CC49-A093-A0F2C80F68C5}" dt="2021-04-12T19:37:55.872" v="276" actId="478"/>
          <ac:spMkLst>
            <pc:docMk/>
            <pc:sldMk cId="3242017852" sldId="272"/>
            <ac:spMk id="6" creationId="{38A45B98-2BB6-4466-848B-161CCFD89384}"/>
          </ac:spMkLst>
        </pc:spChg>
        <pc:spChg chg="mod">
          <ac:chgData name="Wencai Zhang" userId="4a86a1d0-2108-4707-8228-1110f3c1be85" providerId="ADAL" clId="{92F21252-1024-CC49-A093-A0F2C80F68C5}" dt="2021-04-12T19:34:07.813" v="90" actId="1038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92F21252-1024-CC49-A093-A0F2C80F68C5}" dt="2021-04-12T19:35:03.827" v="112" actId="1037"/>
          <ac:spMkLst>
            <pc:docMk/>
            <pc:sldMk cId="3242017852" sldId="272"/>
            <ac:spMk id="22" creationId="{119C059E-C733-4742-A0D4-D02B0A0755A1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3" creationId="{19318E2F-9580-484A-A2E4-97CB1BA629D3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4" creationId="{0743C9DB-C2C3-4D68-9AC6-CC11265D5C66}"/>
          </ac:spMkLst>
        </pc:spChg>
        <pc:spChg chg="add mod">
          <ac:chgData name="Wencai Zhang" userId="4a86a1d0-2108-4707-8228-1110f3c1be85" providerId="ADAL" clId="{92F21252-1024-CC49-A093-A0F2C80F68C5}" dt="2021-04-12T19:36:16.046" v="231" actId="1037"/>
          <ac:spMkLst>
            <pc:docMk/>
            <pc:sldMk cId="3242017852" sldId="272"/>
            <ac:spMk id="32" creationId="{E7D8A89C-5DD3-434D-B0F9-4FFE362E8493}"/>
          </ac:spMkLst>
        </pc:spChg>
        <pc:spChg chg="add mod">
          <ac:chgData name="Wencai Zhang" userId="4a86a1d0-2108-4707-8228-1110f3c1be85" providerId="ADAL" clId="{92F21252-1024-CC49-A093-A0F2C80F68C5}" dt="2021-04-12T19:36:42.793" v="273" actId="1037"/>
          <ac:spMkLst>
            <pc:docMk/>
            <pc:sldMk cId="3242017852" sldId="272"/>
            <ac:spMk id="33" creationId="{AD8D757C-C30A-EB43-B121-3175844E2FA4}"/>
          </ac:spMkLst>
        </pc:spChg>
        <pc:spChg chg="add mod">
          <ac:chgData name="Wencai Zhang" userId="4a86a1d0-2108-4707-8228-1110f3c1be85" providerId="ADAL" clId="{92F21252-1024-CC49-A093-A0F2C80F68C5}" dt="2021-04-12T19:38:00.497" v="278" actId="1076"/>
          <ac:spMkLst>
            <pc:docMk/>
            <pc:sldMk cId="3242017852" sldId="272"/>
            <ac:spMk id="34" creationId="{5F985DB3-3403-4941-9802-68C8B7909CD4}"/>
          </ac:spMkLst>
        </pc:spChg>
        <pc:spChg chg="add mod">
          <ac:chgData name="Wencai Zhang" userId="4a86a1d0-2108-4707-8228-1110f3c1be85" providerId="ADAL" clId="{92F21252-1024-CC49-A093-A0F2C80F68C5}" dt="2021-04-12T19:38:53.406" v="297" actId="1038"/>
          <ac:spMkLst>
            <pc:docMk/>
            <pc:sldMk cId="3242017852" sldId="272"/>
            <ac:spMk id="35" creationId="{0B95831C-C370-F744-8A10-16CF3693E325}"/>
          </ac:spMkLst>
        </pc:spChg>
        <pc:spChg chg="mod">
          <ac:chgData name="Wencai Zhang" userId="4a86a1d0-2108-4707-8228-1110f3c1be85" providerId="ADAL" clId="{92F21252-1024-CC49-A093-A0F2C80F68C5}" dt="2021-04-12T19:12:42.521" v="55" actId="20577"/>
          <ac:spMkLst>
            <pc:docMk/>
            <pc:sldMk cId="3242017852" sldId="272"/>
            <ac:spMk id="86" creationId="{00000000-0000-0000-0000-000000000000}"/>
          </ac:spMkLst>
        </pc:spChg>
        <pc:grpChg chg="del 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13" creationId="{AEE435E5-BE70-4F07-87F7-62456330E616}"/>
          </ac:grpSpMkLst>
        </pc:grpChg>
        <pc:grpChg chg="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20" creationId="{FB81241A-3117-4851-B42E-B4314B35BAC6}"/>
          </ac:grpSpMkLst>
        </pc:grpChg>
        <pc:graphicFrameChg chg="add mod modGraphic">
          <ac:chgData name="Wencai Zhang" userId="4a86a1d0-2108-4707-8228-1110f3c1be85" providerId="ADAL" clId="{92F21252-1024-CC49-A093-A0F2C80F68C5}" dt="2021-04-12T19:51:22.291" v="607" actId="14100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8" creationId="{DD6977C2-65A1-453B-90EB-A94719B37F09}"/>
          </ac:graphicFrameMkLst>
        </pc:graphicFrameChg>
        <pc:graphicFrameChg chg="add del">
          <ac:chgData name="Wencai Zhang" userId="4a86a1d0-2108-4707-8228-1110f3c1be85" providerId="ADAL" clId="{92F21252-1024-CC49-A093-A0F2C80F68C5}" dt="2021-04-12T19:16:51.159" v="66" actId="478"/>
          <ac:graphicFrameMkLst>
            <pc:docMk/>
            <pc:sldMk cId="3242017852" sldId="272"/>
            <ac:graphicFrameMk id="29" creationId="{BA16A328-50C7-5C48-B75F-1A72DC364D15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77" creationId="{DAD699E2-49CA-4599-8AF5-98F1B0369F7F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39.808" v="93" actId="478"/>
          <ac:graphicFrameMkLst>
            <pc:docMk/>
            <pc:sldMk cId="3242017852" sldId="272"/>
            <ac:graphicFrameMk id="90" creationId="{994B051E-B11B-4B72-9860-278B39873FC5}"/>
          </ac:graphicFrameMkLst>
        </pc:graphicFrameChg>
        <pc:graphicFrameChg chg="del">
          <ac:chgData name="Wencai Zhang" userId="4a86a1d0-2108-4707-8228-1110f3c1be85" providerId="ADAL" clId="{92F21252-1024-CC49-A093-A0F2C80F68C5}" dt="2021-04-12T19:36:20.023" v="232" actId="478"/>
          <ac:graphicFrameMkLst>
            <pc:docMk/>
            <pc:sldMk cId="3242017852" sldId="272"/>
            <ac:graphicFrameMk id="95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9.194" v="57" actId="478"/>
          <ac:graphicFrameMkLst>
            <pc:docMk/>
            <pc:sldMk cId="3242017852" sldId="272"/>
            <ac:graphicFrameMk id="97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42.384" v="94" actId="478"/>
          <ac:graphicFrameMkLst>
            <pc:docMk/>
            <pc:sldMk cId="3242017852" sldId="272"/>
            <ac:graphicFrameMk id="115" creationId="{00000000-0000-0000-0000-000000000000}"/>
          </ac:graphicFrameMkLst>
        </pc:graphicFrameChg>
        <pc:picChg chg="add del mod">
          <ac:chgData name="Wencai Zhang" userId="4a86a1d0-2108-4707-8228-1110f3c1be85" providerId="ADAL" clId="{92F21252-1024-CC49-A093-A0F2C80F68C5}" dt="2021-04-12T19:33:40.205" v="71" actId="478"/>
          <ac:picMkLst>
            <pc:docMk/>
            <pc:sldMk cId="3242017852" sldId="272"/>
            <ac:picMk id="2" creationId="{4E96C3A1-6F98-4D49-857A-562BB60FC57D}"/>
          </ac:picMkLst>
        </pc:picChg>
        <pc:picChg chg="add mod">
          <ac:chgData name="Wencai Zhang" userId="4a86a1d0-2108-4707-8228-1110f3c1be85" providerId="ADAL" clId="{92F21252-1024-CC49-A093-A0F2C80F68C5}" dt="2021-04-12T19:34:13.956" v="92" actId="1076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1" creationId="{4C99E0B5-77D2-4968-99C3-7FF7FFCDEC84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5" creationId="{3987ED77-7F2F-475B-8C7D-F45366B58B1C}"/>
          </ac:picMkLst>
        </pc:picChg>
        <pc:picChg chg="mod">
          <ac:chgData name="Wencai Zhang" userId="4a86a1d0-2108-4707-8228-1110f3c1be85" providerId="ADAL" clId="{92F21252-1024-CC49-A093-A0F2C80F68C5}" dt="2021-04-12T19:37:00.642" v="275" actId="1076"/>
          <ac:picMkLst>
            <pc:docMk/>
            <pc:sldMk cId="3242017852" sldId="272"/>
            <ac:picMk id="71" creationId="{00000000-0000-0000-0000-000000000000}"/>
          </ac:picMkLst>
        </pc:picChg>
      </pc:sldChg>
    </pc:docChg>
  </pc:docChgLst>
  <pc:docChgLst>
    <pc:chgData name="Nicholas Skiados" userId="gyL5hJDrj+hZHFpDSneZU1h6zJeED3y/2O9IVXLr5ag=" providerId="None" clId="Web-{A984A472-A32E-442A-8EA6-D6EAFB10DD87}"/>
    <pc:docChg chg="modSld">
      <pc:chgData name="Nicholas Skiados" userId="gyL5hJDrj+hZHFpDSneZU1h6zJeED3y/2O9IVXLr5ag=" providerId="None" clId="Web-{A984A472-A32E-442A-8EA6-D6EAFB10DD87}" dt="2021-06-17T16:08:45.328" v="3"/>
      <pc:docMkLst>
        <pc:docMk/>
      </pc:docMkLst>
      <pc:sldChg chg="modSp">
        <pc:chgData name="Nicholas Skiados" userId="gyL5hJDrj+hZHFpDSneZU1h6zJeED3y/2O9IVXLr5ag=" providerId="None" clId="Web-{A984A472-A32E-442A-8EA6-D6EAFB10DD87}" dt="2021-06-17T16:08:45.328" v="3"/>
        <pc:sldMkLst>
          <pc:docMk/>
          <pc:sldMk cId="4133689721" sldId="291"/>
        </pc:sldMkLst>
        <pc:picChg chg="mod modCrop">
          <ac:chgData name="Nicholas Skiados" userId="gyL5hJDrj+hZHFpDSneZU1h6zJeED3y/2O9IVXLr5ag=" providerId="None" clId="Web-{A984A472-A32E-442A-8EA6-D6EAFB10DD87}" dt="2021-06-17T16:08:45.328" v="3"/>
          <ac:picMkLst>
            <pc:docMk/>
            <pc:sldMk cId="4133689721" sldId="291"/>
            <ac:picMk id="17" creationId="{90A3123D-C2FB-423C-A515-4FEAD3B6BCF7}"/>
          </ac:picMkLst>
        </pc:picChg>
      </pc:sldChg>
    </pc:docChg>
  </pc:docChgLst>
  <pc:docChgLst>
    <pc:chgData name="Nicholas Skiados" clId="Web-{D4EA0971-6E17-4D37-BB93-291A8CFE9B33}"/>
    <pc:docChg chg="modSld">
      <pc:chgData name="Nicholas Skiados" userId="" providerId="" clId="Web-{D4EA0971-6E17-4D37-BB93-291A8CFE9B33}" dt="2021-06-17T16:02:06.527" v="13"/>
      <pc:docMkLst>
        <pc:docMk/>
      </pc:docMkLst>
      <pc:sldChg chg="addSp delSp modSp">
        <pc:chgData name="Nicholas Skiados" userId="" providerId="" clId="Web-{D4EA0971-6E17-4D37-BB93-291A8CFE9B33}" dt="2021-06-17T16:02:06.527" v="13"/>
        <pc:sldMkLst>
          <pc:docMk/>
          <pc:sldMk cId="4133689721" sldId="291"/>
        </pc:sldMkLst>
        <pc:spChg chg="add mod">
          <ac:chgData name="Nicholas Skiados" userId="" providerId="" clId="Web-{D4EA0971-6E17-4D37-BB93-291A8CFE9B33}" dt="2021-06-17T16:01:50.870" v="12" actId="1076"/>
          <ac:spMkLst>
            <pc:docMk/>
            <pc:sldMk cId="4133689721" sldId="291"/>
            <ac:spMk id="7" creationId="{28103BD3-1973-4A86-86AF-E873CD0F2C5B}"/>
          </ac:spMkLst>
        </pc:spChg>
        <pc:spChg chg="add">
          <ac:chgData name="Nicholas Skiados" userId="" providerId="" clId="Web-{D4EA0971-6E17-4D37-BB93-291A8CFE9B33}" dt="2021-06-17T16:02:06.527" v="13"/>
          <ac:spMkLst>
            <pc:docMk/>
            <pc:sldMk cId="4133689721" sldId="291"/>
            <ac:spMk id="9" creationId="{100E022D-2076-479C-A701-6B009140F160}"/>
          </ac:spMkLst>
        </pc:spChg>
        <pc:spChg chg="mod">
          <ac:chgData name="Nicholas Skiados" userId="" providerId="" clId="Web-{D4EA0971-6E17-4D37-BB93-291A8CFE9B33}" dt="2021-06-17T15:55:37.320" v="2" actId="1076"/>
          <ac:spMkLst>
            <pc:docMk/>
            <pc:sldMk cId="4133689721" sldId="291"/>
            <ac:spMk id="82" creationId="{64CE77AD-5AE7-486C-BB91-85E1CD16181D}"/>
          </ac:spMkLst>
        </pc:spChg>
        <pc:spChg chg="del">
          <ac:chgData name="Nicholas Skiados" userId="" providerId="" clId="Web-{D4EA0971-6E17-4D37-BB93-291A8CFE9B33}" dt="2021-06-17T15:55:32.117" v="1"/>
          <ac:spMkLst>
            <pc:docMk/>
            <pc:sldMk cId="4133689721" sldId="291"/>
            <ac:spMk id="89" creationId="{9FA0D867-354A-43A2-8F5A-E8679F2BBCDE}"/>
          </ac:spMkLst>
        </pc:spChg>
        <pc:picChg chg="add mod modCrop">
          <ac:chgData name="Nicholas Skiados" userId="" providerId="" clId="Web-{D4EA0971-6E17-4D37-BB93-291A8CFE9B33}" dt="2021-06-17T16:01:23.713" v="9" actId="1076"/>
          <ac:picMkLst>
            <pc:docMk/>
            <pc:sldMk cId="4133689721" sldId="291"/>
            <ac:picMk id="5" creationId="{22F69510-3952-44E9-A333-35C4129A0F35}"/>
          </ac:picMkLst>
        </pc:picChg>
      </pc:sldChg>
    </pc:docChg>
  </pc:docChgLst>
  <pc:docChgLst>
    <pc:chgData name="Wencai Zhang" userId="4a86a1d0-2108-4707-8228-1110f3c1be85" providerId="ADAL" clId="{8D7A2434-4802-1C43-9895-8424B0E243DD}"/>
    <pc:docChg chg="undo redo custSel addSld delSld modSld">
      <pc:chgData name="Wencai Zhang" userId="4a86a1d0-2108-4707-8228-1110f3c1be85" providerId="ADAL" clId="{8D7A2434-4802-1C43-9895-8424B0E243DD}" dt="2022-05-13T18:23:06.235" v="187" actId="1076"/>
      <pc:docMkLst>
        <pc:docMk/>
      </pc:docMkLst>
      <pc:sldChg chg="modSp">
        <pc:chgData name="Wencai Zhang" userId="4a86a1d0-2108-4707-8228-1110f3c1be85" providerId="ADAL" clId="{8D7A2434-4802-1C43-9895-8424B0E243DD}" dt="2022-05-13T18:22:09.828" v="146" actId="1076"/>
        <pc:sldMkLst>
          <pc:docMk/>
          <pc:sldMk cId="2771812490" sldId="275"/>
        </pc:sldMkLst>
        <pc:spChg chg="mod">
          <ac:chgData name="Wencai Zhang" userId="4a86a1d0-2108-4707-8228-1110f3c1be85" providerId="ADAL" clId="{8D7A2434-4802-1C43-9895-8424B0E243DD}" dt="2022-05-13T18:22:09.828" v="146" actId="1076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8D7A2434-4802-1C43-9895-8424B0E243DD}" dt="2022-04-28T20:12:30.385" v="89" actId="20577"/>
          <ac:spMkLst>
            <pc:docMk/>
            <pc:sldMk cId="2771812490" sldId="275"/>
            <ac:spMk id="32" creationId="{3E547D2F-565F-A84D-A2CA-22C354291393}"/>
          </ac:spMkLst>
        </pc:spChg>
      </pc:sldChg>
      <pc:sldChg chg="del">
        <pc:chgData name="Wencai Zhang" userId="4a86a1d0-2108-4707-8228-1110f3c1be85" providerId="ADAL" clId="{8D7A2434-4802-1C43-9895-8424B0E243DD}" dt="2022-04-28T18:30:55.121" v="2" actId="2696"/>
        <pc:sldMkLst>
          <pc:docMk/>
          <pc:sldMk cId="1997077850" sldId="279"/>
        </pc:sldMkLst>
      </pc:sldChg>
      <pc:sldChg chg="modSp">
        <pc:chgData name="Wencai Zhang" userId="4a86a1d0-2108-4707-8228-1110f3c1be85" providerId="ADAL" clId="{8D7A2434-4802-1C43-9895-8424B0E243DD}" dt="2022-05-13T18:22:14.756" v="150" actId="403"/>
        <pc:sldMkLst>
          <pc:docMk/>
          <pc:sldMk cId="1043719466" sldId="281"/>
        </pc:sldMkLst>
        <pc:spChg chg="mod">
          <ac:chgData name="Wencai Zhang" userId="4a86a1d0-2108-4707-8228-1110f3c1be85" providerId="ADAL" clId="{8D7A2434-4802-1C43-9895-8424B0E243DD}" dt="2022-05-13T18:22:14.756" v="150" actId="403"/>
          <ac:spMkLst>
            <pc:docMk/>
            <pc:sldMk cId="1043719466" sldId="281"/>
            <ac:spMk id="2" creationId="{51F54C20-E8DC-D04F-BBA3-37DC2057E256}"/>
          </ac:spMkLst>
        </pc:spChg>
      </pc:sldChg>
      <pc:sldChg chg="del">
        <pc:chgData name="Wencai Zhang" userId="4a86a1d0-2108-4707-8228-1110f3c1be85" providerId="ADAL" clId="{8D7A2434-4802-1C43-9895-8424B0E243DD}" dt="2022-04-28T18:30:50.430" v="1" actId="2696"/>
        <pc:sldMkLst>
          <pc:docMk/>
          <pc:sldMk cId="826150303" sldId="282"/>
        </pc:sldMkLst>
      </pc:sldChg>
      <pc:sldChg chg="addSp modSp">
        <pc:chgData name="Wencai Zhang" userId="4a86a1d0-2108-4707-8228-1110f3c1be85" providerId="ADAL" clId="{8D7A2434-4802-1C43-9895-8424B0E243DD}" dt="2022-04-28T20:11:56.173" v="86" actId="20577"/>
        <pc:sldMkLst>
          <pc:docMk/>
          <pc:sldMk cId="3169542940" sldId="289"/>
        </pc:sldMkLst>
        <pc:spChg chg="mod">
          <ac:chgData name="Wencai Zhang" userId="4a86a1d0-2108-4707-8228-1110f3c1be85" providerId="ADAL" clId="{8D7A2434-4802-1C43-9895-8424B0E243DD}" dt="2022-04-28T20:11:56.173" v="86" actId="20577"/>
          <ac:spMkLst>
            <pc:docMk/>
            <pc:sldMk cId="3169542940" sldId="289"/>
            <ac:spMk id="2" creationId="{086BC700-3805-7D4C-A7D6-71D52151F333}"/>
          </ac:spMkLst>
        </pc:spChg>
        <pc:spChg chg="add mod">
          <ac:chgData name="Wencai Zhang" userId="4a86a1d0-2108-4707-8228-1110f3c1be85" providerId="ADAL" clId="{8D7A2434-4802-1C43-9895-8424B0E243DD}" dt="2022-04-28T20:11:41.120" v="77" actId="20577"/>
          <ac:spMkLst>
            <pc:docMk/>
            <pc:sldMk cId="3169542940" sldId="289"/>
            <ac:spMk id="9" creationId="{C166CB11-3208-B14A-9C10-6BB2460A7766}"/>
          </ac:spMkLst>
        </pc:spChg>
      </pc:sldChg>
      <pc:sldChg chg="addSp modSp">
        <pc:chgData name="Wencai Zhang" userId="4a86a1d0-2108-4707-8228-1110f3c1be85" providerId="ADAL" clId="{8D7A2434-4802-1C43-9895-8424B0E243DD}" dt="2022-05-13T18:22:58" v="182" actId="1076"/>
        <pc:sldMkLst>
          <pc:docMk/>
          <pc:sldMk cId="3497662403" sldId="290"/>
        </pc:sldMkLst>
        <pc:spChg chg="mod">
          <ac:chgData name="Wencai Zhang" userId="4a86a1d0-2108-4707-8228-1110f3c1be85" providerId="ADAL" clId="{8D7A2434-4802-1C43-9895-8424B0E243DD}" dt="2022-04-28T20:11:52.291" v="83" actId="20577"/>
          <ac:spMkLst>
            <pc:docMk/>
            <pc:sldMk cId="3497662403" sldId="290"/>
            <ac:spMk id="8" creationId="{A4F20A6F-D30A-9040-ACD4-2B63464D1625}"/>
          </ac:spMkLst>
        </pc:spChg>
        <pc:spChg chg="add mod">
          <ac:chgData name="Wencai Zhang" userId="4a86a1d0-2108-4707-8228-1110f3c1be85" providerId="ADAL" clId="{8D7A2434-4802-1C43-9895-8424B0E243DD}" dt="2022-05-13T18:22:58" v="182" actId="1076"/>
          <ac:spMkLst>
            <pc:docMk/>
            <pc:sldMk cId="3497662403" sldId="290"/>
            <ac:spMk id="11" creationId="{D0DA81A9-2BB4-2740-B8BB-D967AA6C6C1E}"/>
          </ac:spMkLst>
        </pc:spChg>
      </pc:sldChg>
      <pc:sldChg chg="delSp modSp">
        <pc:chgData name="Wencai Zhang" userId="4a86a1d0-2108-4707-8228-1110f3c1be85" providerId="ADAL" clId="{8D7A2434-4802-1C43-9895-8424B0E243DD}" dt="2022-05-13T18:22:32.230" v="172" actId="1037"/>
        <pc:sldMkLst>
          <pc:docMk/>
          <pc:sldMk cId="4133689721" sldId="291"/>
        </pc:sldMkLst>
        <pc:spChg chg="mod">
          <ac:chgData name="Wencai Zhang" userId="4a86a1d0-2108-4707-8228-1110f3c1be85" providerId="ADAL" clId="{8D7A2434-4802-1C43-9895-8424B0E243DD}" dt="2022-05-13T18:22:32.230" v="172" actId="1037"/>
          <ac:spMkLst>
            <pc:docMk/>
            <pc:sldMk cId="4133689721" sldId="291"/>
            <ac:spMk id="49" creationId="{393B87F7-0301-414F-A165-54A34714662C}"/>
          </ac:spMkLst>
        </pc:spChg>
        <pc:spChg chg="mod">
          <ac:chgData name="Wencai Zhang" userId="4a86a1d0-2108-4707-8228-1110f3c1be85" providerId="ADAL" clId="{8D7A2434-4802-1C43-9895-8424B0E243DD}" dt="2022-05-13T18:18:10.968" v="141" actId="1035"/>
          <ac:spMkLst>
            <pc:docMk/>
            <pc:sldMk cId="4133689721" sldId="291"/>
            <ac:spMk id="99" creationId="{ADED19B6-A914-5B40-BAD0-EBC312EBBF5D}"/>
          </ac:spMkLst>
        </pc:spChg>
        <pc:spChg chg="del">
          <ac:chgData name="Wencai Zhang" userId="4a86a1d0-2108-4707-8228-1110f3c1be85" providerId="ADAL" clId="{8D7A2434-4802-1C43-9895-8424B0E243DD}" dt="2022-04-28T20:14:01.610" v="108" actId="478"/>
          <ac:spMkLst>
            <pc:docMk/>
            <pc:sldMk cId="4133689721" sldId="291"/>
            <ac:spMk id="105" creationId="{87CA0DA1-7C85-1E43-BB31-4F7DFF1B556A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07" creationId="{F393D83C-06E7-C24C-B7C7-1FC995136C1C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08" creationId="{33C4E2A0-AB1C-BD4B-AD9D-7818CF0169CD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09" creationId="{F54ED270-1D3C-C340-8A9C-A148C0FAD655}"/>
          </ac:spMkLst>
        </pc:spChg>
        <pc:spChg chg="del">
          <ac:chgData name="Wencai Zhang" userId="4a86a1d0-2108-4707-8228-1110f3c1be85" providerId="ADAL" clId="{8D7A2434-4802-1C43-9895-8424B0E243DD}" dt="2022-04-28T20:13:39.931" v="103" actId="478"/>
          <ac:spMkLst>
            <pc:docMk/>
            <pc:sldMk cId="4133689721" sldId="291"/>
            <ac:spMk id="118" creationId="{F56F3AC5-7BED-D649-88B1-AC6C8F24AF83}"/>
          </ac:spMkLst>
        </pc:spChg>
        <pc:spChg chg="del">
          <ac:chgData name="Wencai Zhang" userId="4a86a1d0-2108-4707-8228-1110f3c1be85" providerId="ADAL" clId="{8D7A2434-4802-1C43-9895-8424B0E243DD}" dt="2022-04-28T20:13:39.931" v="103" actId="478"/>
          <ac:spMkLst>
            <pc:docMk/>
            <pc:sldMk cId="4133689721" sldId="291"/>
            <ac:spMk id="131" creationId="{69FF5C3B-B7EA-D64A-8ADB-24EA315DDE63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32" creationId="{BBC77043-615E-044C-B621-BE7E0519A1FB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33" creationId="{2AC73E87-EFB3-9941-93B7-33BD189F296C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34" creationId="{A53A9AE6-32BE-0D47-ACCD-EA61CFD330CB}"/>
          </ac:spMkLst>
        </pc:spChg>
        <pc:spChg chg="del">
          <ac:chgData name="Wencai Zhang" userId="4a86a1d0-2108-4707-8228-1110f3c1be85" providerId="ADAL" clId="{8D7A2434-4802-1C43-9895-8424B0E243DD}" dt="2022-04-28T20:13:45.635" v="104" actId="478"/>
          <ac:spMkLst>
            <pc:docMk/>
            <pc:sldMk cId="4133689721" sldId="291"/>
            <ac:spMk id="141" creationId="{9BEAAF36-C230-344B-ADE6-EF4D247BFDA5}"/>
          </ac:spMkLst>
        </pc:spChg>
        <pc:grpChg chg="del">
          <ac:chgData name="Wencai Zhang" userId="4a86a1d0-2108-4707-8228-1110f3c1be85" providerId="ADAL" clId="{8D7A2434-4802-1C43-9895-8424B0E243DD}" dt="2022-04-28T20:13:39.931" v="103" actId="478"/>
          <ac:grpSpMkLst>
            <pc:docMk/>
            <pc:sldMk cId="4133689721" sldId="291"/>
            <ac:grpSpMk id="135" creationId="{7BFB725C-F2E7-974C-8C72-BBC0B2BFE55A}"/>
          </ac:grpSpMkLst>
        </pc:grpChg>
        <pc:grpChg chg="del">
          <ac:chgData name="Wencai Zhang" userId="4a86a1d0-2108-4707-8228-1110f3c1be85" providerId="ADAL" clId="{8D7A2434-4802-1C43-9895-8424B0E243DD}" dt="2022-04-28T20:13:45.635" v="104" actId="478"/>
          <ac:grpSpMkLst>
            <pc:docMk/>
            <pc:sldMk cId="4133689721" sldId="291"/>
            <ac:grpSpMk id="148" creationId="{00FC342B-ADB8-C648-A8B2-C8ECB8FAB7F2}"/>
          </ac:grpSpMkLst>
        </pc:grpChg>
        <pc:picChg chg="del">
          <ac:chgData name="Wencai Zhang" userId="4a86a1d0-2108-4707-8228-1110f3c1be85" providerId="ADAL" clId="{8D7A2434-4802-1C43-9895-8424B0E243DD}" dt="2022-04-28T20:13:54.848" v="106" actId="478"/>
          <ac:picMkLst>
            <pc:docMk/>
            <pc:sldMk cId="4133689721" sldId="291"/>
            <ac:picMk id="54" creationId="{C0CB6ABD-8B3D-B145-B7FC-F88644741EC1}"/>
          </ac:picMkLst>
        </pc:picChg>
        <pc:picChg chg="del">
          <ac:chgData name="Wencai Zhang" userId="4a86a1d0-2108-4707-8228-1110f3c1be85" providerId="ADAL" clId="{8D7A2434-4802-1C43-9895-8424B0E243DD}" dt="2022-04-28T20:13:56.694" v="107" actId="478"/>
          <ac:picMkLst>
            <pc:docMk/>
            <pc:sldMk cId="4133689721" sldId="291"/>
            <ac:picMk id="75" creationId="{2331D386-E1C3-B246-B8A8-197098E47CF1}"/>
          </ac:picMkLst>
        </pc:picChg>
        <pc:picChg chg="del">
          <ac:chgData name="Wencai Zhang" userId="4a86a1d0-2108-4707-8228-1110f3c1be85" providerId="ADAL" clId="{8D7A2434-4802-1C43-9895-8424B0E243DD}" dt="2022-04-28T20:13:48.245" v="105" actId="478"/>
          <ac:picMkLst>
            <pc:docMk/>
            <pc:sldMk cId="4133689721" sldId="291"/>
            <ac:picMk id="103" creationId="{9870E93B-6C4B-2C4B-8D77-BB5CFD1397F6}"/>
          </ac:picMkLst>
        </pc:picChg>
        <pc:picChg chg="del">
          <ac:chgData name="Wencai Zhang" userId="4a86a1d0-2108-4707-8228-1110f3c1be85" providerId="ADAL" clId="{8D7A2434-4802-1C43-9895-8424B0E243DD}" dt="2022-04-28T20:13:39.931" v="103" actId="478"/>
          <ac:picMkLst>
            <pc:docMk/>
            <pc:sldMk cId="4133689721" sldId="291"/>
            <ac:picMk id="129" creationId="{2BD61A97-DEC8-DD4C-84C9-0EAC6A03CDC5}"/>
          </ac:picMkLst>
        </pc:picChg>
      </pc:sldChg>
      <pc:sldChg chg="addSp delSp modSp">
        <pc:chgData name="Wencai Zhang" userId="4a86a1d0-2108-4707-8228-1110f3c1be85" providerId="ADAL" clId="{8D7A2434-4802-1C43-9895-8424B0E243DD}" dt="2022-05-13T18:23:06.235" v="187" actId="1076"/>
        <pc:sldMkLst>
          <pc:docMk/>
          <pc:sldMk cId="472844202" sldId="292"/>
        </pc:sldMkLst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2" creationId="{531A11DB-C16A-474F-B52F-315BD512D03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3" creationId="{0E974834-8482-4440-809E-90B06CCA30F4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" creationId="{02092AE9-CFD4-4AC6-A393-F3990B5343F2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" creationId="{89E84565-00A9-4750-B41B-2E8C35E6E19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" creationId="{28103BD3-1973-4A86-86AF-E873CD0F2C5B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" creationId="{8F2B740F-1420-4373-B1FC-3589A02F06D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22" creationId="{4FBC6A88-627F-407D-A159-D386F6F67CF7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31" creationId="{FA424362-9542-421D-95CE-97EF263215FD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3" creationId="{2AA9094F-D7AB-4950-B7FC-5E87D4F75296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4" creationId="{1620750B-9206-4AD3-BA74-C9087006A6E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5" creationId="{17320253-C946-43AF-9A81-5DE075E93EE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48" creationId="{F084C199-BBA2-484E-843D-EFEBEEB053D5}"/>
          </ac:spMkLst>
        </pc:spChg>
        <pc:spChg chg="mod">
          <ac:chgData name="Wencai Zhang" userId="4a86a1d0-2108-4707-8228-1110f3c1be85" providerId="ADAL" clId="{8D7A2434-4802-1C43-9895-8424B0E243DD}" dt="2022-04-28T20:05:59.188" v="10" actId="20577"/>
          <ac:spMkLst>
            <pc:docMk/>
            <pc:sldMk cId="472844202" sldId="292"/>
            <ac:spMk id="50" creationId="{0704502B-B3B5-C948-8785-14C6AEF7E4C3}"/>
          </ac:spMkLst>
        </pc:spChg>
        <pc:spChg chg="del">
          <ac:chgData name="Wencai Zhang" userId="4a86a1d0-2108-4707-8228-1110f3c1be85" providerId="ADAL" clId="{8D7A2434-4802-1C43-9895-8424B0E243DD}" dt="2022-04-28T20:06:19.796" v="14" actId="478"/>
          <ac:spMkLst>
            <pc:docMk/>
            <pc:sldMk cId="472844202" sldId="292"/>
            <ac:spMk id="52" creationId="{BC29B8A4-03F1-F349-ACD0-E53D40C497E9}"/>
          </ac:spMkLst>
        </pc:spChg>
        <pc:spChg chg="mod">
          <ac:chgData name="Wencai Zhang" userId="4a86a1d0-2108-4707-8228-1110f3c1be85" providerId="ADAL" clId="{8D7A2434-4802-1C43-9895-8424B0E243DD}" dt="2022-04-28T20:09:25.373" v="57" actId="1035"/>
          <ac:spMkLst>
            <pc:docMk/>
            <pc:sldMk cId="472844202" sldId="292"/>
            <ac:spMk id="54" creationId="{B0626892-32B4-3C42-A1E6-5FE31E225DB7}"/>
          </ac:spMkLst>
        </pc:spChg>
        <pc:spChg chg="del">
          <ac:chgData name="Wencai Zhang" userId="4a86a1d0-2108-4707-8228-1110f3c1be85" providerId="ADAL" clId="{8D7A2434-4802-1C43-9895-8424B0E243DD}" dt="2022-04-28T20:06:19.796" v="14" actId="478"/>
          <ac:spMkLst>
            <pc:docMk/>
            <pc:sldMk cId="472844202" sldId="292"/>
            <ac:spMk id="55" creationId="{3045B372-7550-A94A-B67F-0EB774E1B8BC}"/>
          </ac:spMkLst>
        </pc:spChg>
        <pc:spChg chg="mod">
          <ac:chgData name="Wencai Zhang" userId="4a86a1d0-2108-4707-8228-1110f3c1be85" providerId="ADAL" clId="{8D7A2434-4802-1C43-9895-8424B0E243DD}" dt="2022-04-28T20:09:25.373" v="57" actId="1035"/>
          <ac:spMkLst>
            <pc:docMk/>
            <pc:sldMk cId="472844202" sldId="292"/>
            <ac:spMk id="56" creationId="{6E8B1600-BDFD-3F4E-8D21-B3C5CD3B5C9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58" creationId="{6F84CF85-847D-4B52-AFF1-71D8499C5EE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59" creationId="{08A5BC4F-86E2-4AC0-97E7-3C1FC3E244C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0" creationId="{BCCC01D9-0889-4228-92CD-6A8D3A46442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1" creationId="{56CE78CA-20D4-47AC-B5C5-0DD42964A07D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2" creationId="{001EBA8A-742C-41E7-9F55-3D7E9FDB3E75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3" creationId="{97248771-2563-4EEB-B477-5C1A5C921CC1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4" creationId="{A3BA44A5-84D2-4999-A2C5-B65DB02C10A0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5" creationId="{E73D8148-CD43-4DBD-92EF-7995CEC9F396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6" creationId="{A166829D-9F77-4052-AA55-7EF9D3DEC77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7" creationId="{DC578E13-9094-4401-9507-40C5A2B2E0A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8" creationId="{07406E8A-1CFB-409D-9F54-B4FC1830020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69" creationId="{1B786E6E-8E06-432B-B8DD-8EA401D9633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0" creationId="{C135386D-BE94-415A-85C2-74489EB649D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1" creationId="{4F702210-5D73-49A5-ACCE-E129C8FDD940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72" creationId="{DDA653B7-4286-4FD5-AF60-F051FF0ADE35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0" creationId="{3EA26D17-B6C8-41F9-B7CE-3EF35279A69F}"/>
          </ac:spMkLst>
        </pc:spChg>
        <pc:spChg chg="add mod">
          <ac:chgData name="Wencai Zhang" userId="4a86a1d0-2108-4707-8228-1110f3c1be85" providerId="ADAL" clId="{8D7A2434-4802-1C43-9895-8424B0E243DD}" dt="2022-05-13T18:23:06.235" v="187" actId="1076"/>
          <ac:spMkLst>
            <pc:docMk/>
            <pc:sldMk cId="472844202" sldId="292"/>
            <ac:spMk id="81" creationId="{869179CE-BA14-5D41-9FF2-43903C401B9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3" creationId="{88D60685-B94B-42D7-B3C2-9DED2A4C7DEA}"/>
          </ac:spMkLst>
        </pc:spChg>
        <pc:spChg chg="mod">
          <ac:chgData name="Wencai Zhang" userId="4a86a1d0-2108-4707-8228-1110f3c1be85" providerId="ADAL" clId="{8D7A2434-4802-1C43-9895-8424B0E243DD}" dt="2022-04-28T20:10:49.189" v="74" actId="20577"/>
          <ac:spMkLst>
            <pc:docMk/>
            <pc:sldMk cId="472844202" sldId="292"/>
            <ac:spMk id="84" creationId="{33159AC4-1C23-FF4D-876F-FB7DC20209F6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87" creationId="{10943836-76F0-4359-8724-99CA98811398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90" creationId="{8E5FB1D0-1D3E-413C-BF50-9B0C50EA0004}"/>
          </ac:spMkLst>
        </pc:spChg>
        <pc:spChg chg="mod">
          <ac:chgData name="Wencai Zhang" userId="4a86a1d0-2108-4707-8228-1110f3c1be85" providerId="ADAL" clId="{8D7A2434-4802-1C43-9895-8424B0E243DD}" dt="2022-04-28T20:09:39.395" v="71" actId="1035"/>
          <ac:spMkLst>
            <pc:docMk/>
            <pc:sldMk cId="472844202" sldId="292"/>
            <ac:spMk id="92" creationId="{163BD752-8006-7F47-925B-5DF29B3CEBB5}"/>
          </ac:spMkLst>
        </pc:spChg>
        <pc:spChg chg="del">
          <ac:chgData name="Wencai Zhang" userId="4a86a1d0-2108-4707-8228-1110f3c1be85" providerId="ADAL" clId="{8D7A2434-4802-1C43-9895-8424B0E243DD}" dt="2022-04-28T20:06:51.072" v="17" actId="478"/>
          <ac:spMkLst>
            <pc:docMk/>
            <pc:sldMk cId="472844202" sldId="292"/>
            <ac:spMk id="94" creationId="{39E9E7DF-DC29-3848-995E-C9AE5847078A}"/>
          </ac:spMkLst>
        </pc:spChg>
        <pc:spChg chg="mod">
          <ac:chgData name="Wencai Zhang" userId="4a86a1d0-2108-4707-8228-1110f3c1be85" providerId="ADAL" clId="{8D7A2434-4802-1C43-9895-8424B0E243DD}" dt="2022-04-28T20:09:39.395" v="71" actId="1035"/>
          <ac:spMkLst>
            <pc:docMk/>
            <pc:sldMk cId="472844202" sldId="292"/>
            <ac:spMk id="95" creationId="{04C39503-EB9D-ED49-8550-E1D79E001977}"/>
          </ac:spMkLst>
        </pc:spChg>
        <pc:spChg chg="del">
          <ac:chgData name="Wencai Zhang" userId="4a86a1d0-2108-4707-8228-1110f3c1be85" providerId="ADAL" clId="{8D7A2434-4802-1C43-9895-8424B0E243DD}" dt="2022-04-28T20:06:51.072" v="17" actId="478"/>
          <ac:spMkLst>
            <pc:docMk/>
            <pc:sldMk cId="472844202" sldId="292"/>
            <ac:spMk id="96" creationId="{5A956423-2A45-2F4B-A2F8-B12E099B6E2E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121" creationId="{D6CB511F-139C-41D4-8250-3CE8C1C529A2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124" creationId="{9DD241D0-FA5A-46DA-805C-C56E7116101A}"/>
          </ac:spMkLst>
        </pc:spChg>
        <pc:spChg chg="del">
          <ac:chgData name="Wencai Zhang" userId="4a86a1d0-2108-4707-8228-1110f3c1be85" providerId="ADAL" clId="{8D7A2434-4802-1C43-9895-8424B0E243DD}" dt="2022-04-28T20:05:38.049" v="5" actId="478"/>
          <ac:spMkLst>
            <pc:docMk/>
            <pc:sldMk cId="472844202" sldId="292"/>
            <ac:spMk id="128" creationId="{E1E6E364-D220-4501-AFB7-E5A4AE205604}"/>
          </ac:spMkLst>
        </pc:spChg>
        <pc:grpChg chg="del">
          <ac:chgData name="Wencai Zhang" userId="4a86a1d0-2108-4707-8228-1110f3c1be85" providerId="ADAL" clId="{8D7A2434-4802-1C43-9895-8424B0E243DD}" dt="2022-04-28T20:05:38.049" v="5" actId="478"/>
          <ac:grpSpMkLst>
            <pc:docMk/>
            <pc:sldMk cId="472844202" sldId="292"/>
            <ac:grpSpMk id="21" creationId="{6044538C-078A-4B35-9A20-801DF003B17B}"/>
          </ac:grpSpMkLst>
        </pc:grpChg>
        <pc:grpChg chg="del">
          <ac:chgData name="Wencai Zhang" userId="4a86a1d0-2108-4707-8228-1110f3c1be85" providerId="ADAL" clId="{8D7A2434-4802-1C43-9895-8424B0E243DD}" dt="2022-04-28T20:05:38.049" v="5" actId="478"/>
          <ac:grpSpMkLst>
            <pc:docMk/>
            <pc:sldMk cId="472844202" sldId="292"/>
            <ac:grpSpMk id="36" creationId="{00308009-BF9B-40C1-BBA6-2AF3C82A16A4}"/>
          </ac:grpSpMkLst>
        </pc:grpChg>
        <pc:grpChg chg="add mod">
          <ac:chgData name="Wencai Zhang" userId="4a86a1d0-2108-4707-8228-1110f3c1be85" providerId="ADAL" clId="{8D7A2434-4802-1C43-9895-8424B0E243DD}" dt="2022-04-28T20:06:03.881" v="11" actId="1076"/>
          <ac:grpSpMkLst>
            <pc:docMk/>
            <pc:sldMk cId="472844202" sldId="292"/>
            <ac:grpSpMk id="49" creationId="{A073D633-CCD7-FA46-A35F-914773CDEC7D}"/>
          </ac:grpSpMkLst>
        </pc:grpChg>
        <pc:grpChg chg="add mod">
          <ac:chgData name="Wencai Zhang" userId="4a86a1d0-2108-4707-8228-1110f3c1be85" providerId="ADAL" clId="{8D7A2434-4802-1C43-9895-8424B0E243DD}" dt="2022-04-28T20:07:41.573" v="23" actId="1036"/>
          <ac:grpSpMkLst>
            <pc:docMk/>
            <pc:sldMk cId="472844202" sldId="292"/>
            <ac:grpSpMk id="82" creationId="{95834E53-3BA1-0749-9321-A5634C20B413}"/>
          </ac:grpSpMkLst>
        </pc:grpChg>
        <pc:grpChg chg="mod">
          <ac:chgData name="Wencai Zhang" userId="4a86a1d0-2108-4707-8228-1110f3c1be85" providerId="ADAL" clId="{8D7A2434-4802-1C43-9895-8424B0E243DD}" dt="2022-04-28T20:06:05.951" v="12"/>
          <ac:grpSpMkLst>
            <pc:docMk/>
            <pc:sldMk cId="472844202" sldId="292"/>
            <ac:grpSpMk id="85" creationId="{5445F782-DCC7-204B-818E-490A37131760}"/>
          </ac:grpSpMkLst>
        </pc:grpChg>
        <pc:grpChg chg="mod">
          <ac:chgData name="Wencai Zhang" userId="4a86a1d0-2108-4707-8228-1110f3c1be85" providerId="ADAL" clId="{8D7A2434-4802-1C43-9895-8424B0E243DD}" dt="2022-04-28T20:06:05.951" v="12"/>
          <ac:grpSpMkLst>
            <pc:docMk/>
            <pc:sldMk cId="472844202" sldId="292"/>
            <ac:grpSpMk id="102" creationId="{0B57C01B-A228-734F-9D70-25BE716C7553}"/>
          </ac:grpSpMkLst>
        </pc:grp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33" creationId="{58EA2CBF-925E-4C2B-8B51-D6E8183BA81F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35" creationId="{7FB48481-D1F9-4BDA-A8AB-39B7C0955AE5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40" creationId="{15068538-6481-468B-919B-24E4077E74A3}"/>
          </ac:picMkLst>
        </pc:picChg>
        <pc:picChg chg="mod modCrop">
          <ac:chgData name="Wencai Zhang" userId="4a86a1d0-2108-4707-8228-1110f3c1be85" providerId="ADAL" clId="{8D7A2434-4802-1C43-9895-8424B0E243DD}" dt="2022-04-28T20:09:25.373" v="57" actId="1035"/>
          <ac:picMkLst>
            <pc:docMk/>
            <pc:sldMk cId="472844202" sldId="292"/>
            <ac:picMk id="73" creationId="{042CD843-2F1E-8944-B840-4D4831106CDE}"/>
          </ac:picMkLst>
        </pc:picChg>
        <pc:picChg chg="del">
          <ac:chgData name="Wencai Zhang" userId="4a86a1d0-2108-4707-8228-1110f3c1be85" providerId="ADAL" clId="{8D7A2434-4802-1C43-9895-8424B0E243DD}" dt="2022-04-28T20:06:19.796" v="14" actId="478"/>
          <ac:picMkLst>
            <pc:docMk/>
            <pc:sldMk cId="472844202" sldId="292"/>
            <ac:picMk id="74" creationId="{A254F354-5308-F043-9352-6332080A0E1E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86" creationId="{EFB1C8A4-B30A-490E-B308-5D1C10A3FDC0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88" creationId="{7767E5D9-D6DB-4E24-8CEA-D3F22E3D34F7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89" creationId="{DE90E117-4A05-4266-B4F4-A83C1FB0E6CA}"/>
          </ac:picMkLst>
        </pc:picChg>
        <pc:picChg chg="del">
          <ac:chgData name="Wencai Zhang" userId="4a86a1d0-2108-4707-8228-1110f3c1be85" providerId="ADAL" clId="{8D7A2434-4802-1C43-9895-8424B0E243DD}" dt="2022-04-28T20:05:38.049" v="5" actId="478"/>
          <ac:picMkLst>
            <pc:docMk/>
            <pc:sldMk cId="472844202" sldId="292"/>
            <ac:picMk id="91" creationId="{0B4A2F64-A360-48B5-99AE-4369A419FE9C}"/>
          </ac:picMkLst>
        </pc:picChg>
        <pc:picChg chg="del">
          <ac:chgData name="Wencai Zhang" userId="4a86a1d0-2108-4707-8228-1110f3c1be85" providerId="ADAL" clId="{8D7A2434-4802-1C43-9895-8424B0E243DD}" dt="2022-04-28T20:06:51.072" v="17" actId="478"/>
          <ac:picMkLst>
            <pc:docMk/>
            <pc:sldMk cId="472844202" sldId="292"/>
            <ac:picMk id="98" creationId="{D17AD353-A377-4B48-9927-C39BCD51E8E9}"/>
          </ac:picMkLst>
        </pc:picChg>
        <pc:picChg chg="mod modCrop">
          <ac:chgData name="Wencai Zhang" userId="4a86a1d0-2108-4707-8228-1110f3c1be85" providerId="ADAL" clId="{8D7A2434-4802-1C43-9895-8424B0E243DD}" dt="2022-04-28T20:08:55.545" v="49" actId="1076"/>
          <ac:picMkLst>
            <pc:docMk/>
            <pc:sldMk cId="472844202" sldId="292"/>
            <ac:picMk id="99" creationId="{DFA00951-0BF3-584A-90F2-D71313D5C9CF}"/>
          </ac:picMkLst>
        </pc:picChg>
      </pc:sldChg>
      <pc:sldChg chg="modSp add">
        <pc:chgData name="Wencai Zhang" userId="4a86a1d0-2108-4707-8228-1110f3c1be85" providerId="ADAL" clId="{8D7A2434-4802-1C43-9895-8424B0E243DD}" dt="2022-05-13T18:22:42.881" v="177" actId="1076"/>
        <pc:sldMkLst>
          <pc:docMk/>
          <pc:sldMk cId="492363108" sldId="293"/>
        </pc:sldMkLst>
        <pc:spChg chg="mod">
          <ac:chgData name="Wencai Zhang" userId="4a86a1d0-2108-4707-8228-1110f3c1be85" providerId="ADAL" clId="{8D7A2434-4802-1C43-9895-8424B0E243DD}" dt="2022-05-13T18:22:42.881" v="177" actId="1076"/>
          <ac:spMkLst>
            <pc:docMk/>
            <pc:sldMk cId="492363108" sldId="293"/>
            <ac:spMk id="49" creationId="{393B87F7-0301-414F-A165-54A34714662C}"/>
          </ac:spMkLst>
        </pc:spChg>
      </pc:sldChg>
      <pc:sldChg chg="del">
        <pc:chgData name="Wencai Zhang" userId="4a86a1d0-2108-4707-8228-1110f3c1be85" providerId="ADAL" clId="{8D7A2434-4802-1C43-9895-8424B0E243DD}" dt="2022-04-28T20:10:26.560" v="72" actId="2696"/>
        <pc:sldMkLst>
          <pc:docMk/>
          <pc:sldMk cId="4268985042" sldId="293"/>
        </pc:sldMkLst>
      </pc:sldChg>
      <pc:sldChg chg="del">
        <pc:chgData name="Wencai Zhang" userId="4a86a1d0-2108-4707-8228-1110f3c1be85" providerId="ADAL" clId="{8D7A2434-4802-1C43-9895-8424B0E243DD}" dt="2022-04-28T18:30:50.342" v="0" actId="2696"/>
        <pc:sldMkLst>
          <pc:docMk/>
          <pc:sldMk cId="2865805187" sldId="294"/>
        </pc:sldMkLst>
      </pc:sldChg>
    </pc:docChg>
  </pc:docChgLst>
  <pc:docChgLst>
    <pc:chgData name="Wencai Zhang" userId="4a86a1d0-2108-4707-8228-1110f3c1be85" providerId="ADAL" clId="{91B4D225-D160-1747-A759-68FB97FA1A78}"/>
    <pc:docChg chg="delSld">
      <pc:chgData name="Wencai Zhang" userId="4a86a1d0-2108-4707-8228-1110f3c1be85" providerId="ADAL" clId="{91B4D225-D160-1747-A759-68FB97FA1A78}" dt="2022-06-23T12:26:02.067" v="1" actId="2696"/>
      <pc:docMkLst>
        <pc:docMk/>
      </pc:docMkLst>
      <pc:sldChg chg="del">
        <pc:chgData name="Wencai Zhang" userId="4a86a1d0-2108-4707-8228-1110f3c1be85" providerId="ADAL" clId="{91B4D225-D160-1747-A759-68FB97FA1A78}" dt="2022-06-23T12:26:02.067" v="1" actId="2696"/>
        <pc:sldMkLst>
          <pc:docMk/>
          <pc:sldMk cId="2771812490" sldId="275"/>
        </pc:sldMkLst>
      </pc:sldChg>
      <pc:sldChg chg="del">
        <pc:chgData name="Wencai Zhang" userId="4a86a1d0-2108-4707-8228-1110f3c1be85" providerId="ADAL" clId="{91B4D225-D160-1747-A759-68FB97FA1A78}" dt="2022-06-23T12:26:02.067" v="1" actId="2696"/>
        <pc:sldMkLst>
          <pc:docMk/>
          <pc:sldMk cId="3497662403" sldId="290"/>
        </pc:sldMkLst>
      </pc:sldChg>
      <pc:sldChg chg="del">
        <pc:chgData name="Wencai Zhang" userId="4a86a1d0-2108-4707-8228-1110f3c1be85" providerId="ADAL" clId="{91B4D225-D160-1747-A759-68FB97FA1A78}" dt="2022-06-23T12:25:58.606" v="0" actId="2696"/>
        <pc:sldMkLst>
          <pc:docMk/>
          <pc:sldMk cId="4133689721" sldId="291"/>
        </pc:sldMkLst>
      </pc:sldChg>
      <pc:sldChg chg="del">
        <pc:chgData name="Wencai Zhang" userId="4a86a1d0-2108-4707-8228-1110f3c1be85" providerId="ADAL" clId="{91B4D225-D160-1747-A759-68FB97FA1A78}" dt="2022-06-23T12:26:02.067" v="1" actId="2696"/>
        <pc:sldMkLst>
          <pc:docMk/>
          <pc:sldMk cId="472844202" sldId="292"/>
        </pc:sldMkLst>
      </pc:sldChg>
      <pc:sldChg chg="del">
        <pc:chgData name="Wencai Zhang" userId="4a86a1d0-2108-4707-8228-1110f3c1be85" providerId="ADAL" clId="{91B4D225-D160-1747-A759-68FB97FA1A78}" dt="2022-06-23T12:25:58.606" v="0" actId="2696"/>
        <pc:sldMkLst>
          <pc:docMk/>
          <pc:sldMk cId="492363108" sldId="293"/>
        </pc:sldMkLst>
      </pc:sldChg>
    </pc:docChg>
  </pc:docChgLst>
  <pc:docChgLst>
    <pc:chgData name="Nicholas Skiados" clId="Web-{A984A472-A32E-442A-8EA6-D6EAFB10DD87}"/>
    <pc:docChg chg="modSld">
      <pc:chgData name="Nicholas Skiados" userId="" providerId="" clId="Web-{A984A472-A32E-442A-8EA6-D6EAFB10DD87}" dt="2021-06-17T18:39:44.812" v="41"/>
      <pc:docMkLst>
        <pc:docMk/>
      </pc:docMkLst>
      <pc:sldChg chg="addSp delSp modSp">
        <pc:chgData name="Nicholas Skiados" userId="" providerId="" clId="Web-{A984A472-A32E-442A-8EA6-D6EAFB10DD87}" dt="2021-06-17T18:39:44.812" v="41"/>
        <pc:sldMkLst>
          <pc:docMk/>
          <pc:sldMk cId="4133689721" sldId="291"/>
        </pc:sldMkLst>
        <pc:spChg chg="add mod">
          <ac:chgData name="Nicholas Skiados" userId="" providerId="" clId="Web-{A984A472-A32E-442A-8EA6-D6EAFB10DD87}" dt="2021-06-17T16:14:57.729" v="35" actId="1076"/>
          <ac:spMkLst>
            <pc:docMk/>
            <pc:sldMk cId="4133689721" sldId="291"/>
            <ac:spMk id="22" creationId="{4FBC6A88-627F-407D-A159-D386F6F67CF7}"/>
          </ac:spMkLst>
        </pc:spChg>
        <pc:spChg chg="add mod">
          <ac:chgData name="Nicholas Skiados" userId="" providerId="" clId="Web-{A984A472-A32E-442A-8EA6-D6EAFB10DD87}" dt="2021-06-17T16:15:15.589" v="38" actId="1076"/>
          <ac:spMkLst>
            <pc:docMk/>
            <pc:sldMk cId="4133689721" sldId="291"/>
            <ac:spMk id="31" creationId="{FA424362-9542-421D-95CE-97EF263215FD}"/>
          </ac:spMkLst>
        </pc:spChg>
        <pc:spChg chg="add del mod">
          <ac:chgData name="Nicholas Skiados" userId="" providerId="" clId="Web-{A984A472-A32E-442A-8EA6-D6EAFB10DD87}" dt="2021-06-17T18:39:44.812" v="41"/>
          <ac:spMkLst>
            <pc:docMk/>
            <pc:sldMk cId="4133689721" sldId="291"/>
            <ac:spMk id="32" creationId="{125A0430-F697-4F9D-9724-15CB81AFA247}"/>
          </ac:spMkLst>
        </pc:spChg>
        <pc:spChg chg="add mod">
          <ac:chgData name="Nicholas Skiados" userId="" providerId="" clId="Web-{A984A472-A32E-442A-8EA6-D6EAFB10DD87}" dt="2021-06-17T16:10:18.596" v="10" actId="1076"/>
          <ac:spMkLst>
            <pc:docMk/>
            <pc:sldMk cId="4133689721" sldId="291"/>
            <ac:spMk id="44" creationId="{1620750B-9206-4AD3-BA74-C9087006A6EA}"/>
          </ac:spMkLst>
        </pc:spChg>
        <pc:spChg chg="add mod">
          <ac:chgData name="Nicholas Skiados" userId="" providerId="" clId="Web-{A984A472-A32E-442A-8EA6-D6EAFB10DD87}" dt="2021-06-17T16:10:25.815" v="12" actId="1076"/>
          <ac:spMkLst>
            <pc:docMk/>
            <pc:sldMk cId="4133689721" sldId="291"/>
            <ac:spMk id="45" creationId="{17320253-C946-43AF-9A81-5DE075E93EE8}"/>
          </ac:spMkLst>
        </pc:spChg>
        <pc:picChg chg="add mod modCrop">
          <ac:chgData name="Nicholas Skiados" userId="" providerId="" clId="Web-{A984A472-A32E-442A-8EA6-D6EAFB10DD87}" dt="2021-06-17T16:14:25.666" v="32" actId="14100"/>
          <ac:picMkLst>
            <pc:docMk/>
            <pc:sldMk cId="4133689721" sldId="291"/>
            <ac:picMk id="9" creationId="{3258128A-403C-4AE9-8E99-C30DA2F06EF5}"/>
          </ac:picMkLst>
        </pc:picChg>
        <pc:picChg chg="mod modCrop">
          <ac:chgData name="Nicholas Skiados" userId="" providerId="" clId="Web-{A984A472-A32E-442A-8EA6-D6EAFB10DD87}" dt="2021-06-17T16:09:58.830" v="8" actId="14100"/>
          <ac:picMkLst>
            <pc:docMk/>
            <pc:sldMk cId="4133689721" sldId="291"/>
            <ac:picMk id="17" creationId="{90A3123D-C2FB-423C-A515-4FEAD3B6BCF7}"/>
          </ac:picMkLst>
        </pc:picChg>
      </pc:sldChg>
    </pc:docChg>
  </pc:docChgLst>
  <pc:docChgLst>
    <pc:chgData name="Wencai Zhang" userId="4a86a1d0-2108-4707-8228-1110f3c1be85" providerId="ADAL" clId="{1A0C98BE-4594-2A42-8F09-E2BB07B25A05}"/>
    <pc:docChg chg="undo custSel addSld modSld">
      <pc:chgData name="Wencai Zhang" userId="4a86a1d0-2108-4707-8228-1110f3c1be85" providerId="ADAL" clId="{1A0C98BE-4594-2A42-8F09-E2BB07B25A05}" dt="2022-04-21T01:21:48.743" v="2319" actId="1038"/>
      <pc:docMkLst>
        <pc:docMk/>
      </pc:docMkLst>
      <pc:sldChg chg="addSp delSp modSp mod">
        <pc:chgData name="Wencai Zhang" userId="4a86a1d0-2108-4707-8228-1110f3c1be85" providerId="ADAL" clId="{1A0C98BE-4594-2A42-8F09-E2BB07B25A05}" dt="2022-04-21T01:21:48.743" v="2319" actId="1038"/>
        <pc:sldMkLst>
          <pc:docMk/>
          <pc:sldMk cId="1997077850" sldId="279"/>
        </pc:sldMkLst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3" creationId="{7C8F372B-FAE8-CE44-A95C-EFB214B632AE}"/>
          </ac:spMkLst>
        </pc:spChg>
        <pc:spChg chg="mod">
          <ac:chgData name="Wencai Zhang" userId="4a86a1d0-2108-4707-8228-1110f3c1be85" providerId="ADAL" clId="{1A0C98BE-4594-2A42-8F09-E2BB07B25A05}" dt="2022-04-20T11:51:59.656" v="321" actId="404"/>
          <ac:spMkLst>
            <pc:docMk/>
            <pc:sldMk cId="1997077850" sldId="279"/>
            <ac:spMk id="4" creationId="{95DB8146-6CC5-F741-B46A-A5EEAEB4D010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6" creationId="{F3DB81E6-B77D-A343-8DE3-1FFFD129AA77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7" creationId="{4ACF2E7E-671D-2F4E-95DD-D9C3675AA963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9" creationId="{FA090E52-A893-CF42-A4D8-3792727F0876}"/>
          </ac:spMkLst>
        </pc:spChg>
        <pc:spChg chg="mod">
          <ac:chgData name="Wencai Zhang" userId="4a86a1d0-2108-4707-8228-1110f3c1be85" providerId="ADAL" clId="{1A0C98BE-4594-2A42-8F09-E2BB07B25A05}" dt="2022-04-21T01:21:48.743" v="2319" actId="1038"/>
          <ac:spMkLst>
            <pc:docMk/>
            <pc:sldMk cId="1997077850" sldId="279"/>
            <ac:spMk id="114" creationId="{1F05BE06-5426-114D-88A9-20E85CD03830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20" creationId="{BED92353-28E4-4643-90D3-4560DD628D3F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22" creationId="{0CC7DB87-FD1B-9A46-95DD-3CB778F2DEFB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23" creationId="{F8879FD2-5F0B-ED4B-9872-81F5DD67350C}"/>
          </ac:spMkLst>
        </pc:spChg>
        <pc:spChg chg="mod">
          <ac:chgData name="Wencai Zhang" userId="4a86a1d0-2108-4707-8228-1110f3c1be85" providerId="ADAL" clId="{1A0C98BE-4594-2A42-8F09-E2BB07B25A05}" dt="2022-04-20T20:42:03.802" v="1065" actId="403"/>
          <ac:spMkLst>
            <pc:docMk/>
            <pc:sldMk cId="1997077850" sldId="279"/>
            <ac:spMk id="156" creationId="{3012C7EF-C392-D040-953D-7C0BC0A4D9DB}"/>
          </ac:spMkLst>
        </pc:spChg>
        <pc:spChg chg="mod">
          <ac:chgData name="Wencai Zhang" userId="4a86a1d0-2108-4707-8228-1110f3c1be85" providerId="ADAL" clId="{1A0C98BE-4594-2A42-8F09-E2BB07B25A05}" dt="2022-04-20T20:41:55.808" v="1063" actId="113"/>
          <ac:spMkLst>
            <pc:docMk/>
            <pc:sldMk cId="1997077850" sldId="279"/>
            <ac:spMk id="159" creationId="{D773FF50-8FC5-DB40-B5D1-1C7BB51DA99F}"/>
          </ac:spMkLst>
        </pc:spChg>
        <pc:spChg chg="mod">
          <ac:chgData name="Wencai Zhang" userId="4a86a1d0-2108-4707-8228-1110f3c1be85" providerId="ADAL" clId="{1A0C98BE-4594-2A42-8F09-E2BB07B25A05}" dt="2022-04-21T01:01:58.280" v="1614" actId="1037"/>
          <ac:spMkLst>
            <pc:docMk/>
            <pc:sldMk cId="1997077850" sldId="279"/>
            <ac:spMk id="160" creationId="{4ACB04AC-6584-F145-ADEB-8DCE33FFED73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1" creationId="{EE2F4E35-1C90-FC4B-A1EF-38D6074BBB14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2" creationId="{EA247580-D60C-CC44-AD96-F72D39815C41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3" creationId="{6492B21C-2371-A240-8008-081FEE14107E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66" creationId="{B6F5231E-3128-434A-B4BA-793D62577317}"/>
          </ac:spMkLst>
        </pc:spChg>
        <pc:spChg chg="del mod">
          <ac:chgData name="Wencai Zhang" userId="4a86a1d0-2108-4707-8228-1110f3c1be85" providerId="ADAL" clId="{1A0C98BE-4594-2A42-8F09-E2BB07B25A05}" dt="2022-04-21T01:12:37.906" v="1783" actId="478"/>
          <ac:spMkLst>
            <pc:docMk/>
            <pc:sldMk cId="1997077850" sldId="279"/>
            <ac:spMk id="167" creationId="{A8F89C04-90D8-9440-B0F8-8FFCA9BFD855}"/>
          </ac:spMkLst>
        </pc:spChg>
        <pc:spChg chg="del mod">
          <ac:chgData name="Wencai Zhang" userId="4a86a1d0-2108-4707-8228-1110f3c1be85" providerId="ADAL" clId="{1A0C98BE-4594-2A42-8F09-E2BB07B25A05}" dt="2022-04-21T01:12:35.275" v="1782" actId="478"/>
          <ac:spMkLst>
            <pc:docMk/>
            <pc:sldMk cId="1997077850" sldId="279"/>
            <ac:spMk id="168" creationId="{5C89201E-6609-654B-977D-63BA903881E0}"/>
          </ac:spMkLst>
        </pc:spChg>
        <pc:spChg chg="del mod">
          <ac:chgData name="Wencai Zhang" userId="4a86a1d0-2108-4707-8228-1110f3c1be85" providerId="ADAL" clId="{1A0C98BE-4594-2A42-8F09-E2BB07B25A05}" dt="2022-04-21T01:12:49.227" v="1787" actId="478"/>
          <ac:spMkLst>
            <pc:docMk/>
            <pc:sldMk cId="1997077850" sldId="279"/>
            <ac:spMk id="169" creationId="{317683C1-D6CE-E746-BE57-2D817D93B423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75" creationId="{661D67CF-6A75-FD43-83F6-C3F5D4888B5B}"/>
          </ac:spMkLst>
        </pc:spChg>
        <pc:spChg chg="del">
          <ac:chgData name="Wencai Zhang" userId="4a86a1d0-2108-4707-8228-1110f3c1be85" providerId="ADAL" clId="{1A0C98BE-4594-2A42-8F09-E2BB07B25A05}" dt="2022-04-21T01:09:55.676" v="1749" actId="478"/>
          <ac:spMkLst>
            <pc:docMk/>
            <pc:sldMk cId="1997077850" sldId="279"/>
            <ac:spMk id="177" creationId="{812A3430-EA51-3D4A-AA3A-D616F34983F2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78" creationId="{46A18E8F-78B3-BE4B-B3C0-6B8225DE2C3B}"/>
          </ac:spMkLst>
        </pc:spChg>
        <pc:spChg chg="del">
          <ac:chgData name="Wencai Zhang" userId="4a86a1d0-2108-4707-8228-1110f3c1be85" providerId="ADAL" clId="{1A0C98BE-4594-2A42-8F09-E2BB07B25A05}" dt="2022-04-21T01:09:47.703" v="1746" actId="478"/>
          <ac:spMkLst>
            <pc:docMk/>
            <pc:sldMk cId="1997077850" sldId="279"/>
            <ac:spMk id="180" creationId="{EA9B25E5-5180-C844-ADE8-742A88BE6203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81" creationId="{C17BAEB2-5FA0-FB4D-9F46-A0367E78068F}"/>
          </ac:spMkLst>
        </pc:spChg>
        <pc:spChg chg="del">
          <ac:chgData name="Wencai Zhang" userId="4a86a1d0-2108-4707-8228-1110f3c1be85" providerId="ADAL" clId="{1A0C98BE-4594-2A42-8F09-E2BB07B25A05}" dt="2022-04-21T01:09:50.337" v="1747" actId="478"/>
          <ac:spMkLst>
            <pc:docMk/>
            <pc:sldMk cId="1997077850" sldId="279"/>
            <ac:spMk id="183" creationId="{8E06D3B3-A7E2-0E4C-B5BB-63692AD83434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84" creationId="{DC72FB93-5DA3-2D4F-86BF-483FBC0740A6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185" creationId="{28607748-A014-6F44-BAB4-C799B9F11564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87" creationId="{BBEAC129-AB26-7046-8CE0-54908C16A21B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88" creationId="{AAF8C4B3-30B5-694F-BB8B-4069AE9CA965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90" creationId="{556E584D-6252-3549-A4B1-A0BAB1C69F35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191" creationId="{A6297FEE-2F1D-C642-93BE-526E770BAD8C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198" creationId="{EF53831F-FAC6-B74D-9E68-DBBEA9D481FA}"/>
          </ac:spMkLst>
        </pc:spChg>
        <pc:spChg chg="del mod">
          <ac:chgData name="Wencai Zhang" userId="4a86a1d0-2108-4707-8228-1110f3c1be85" providerId="ADAL" clId="{1A0C98BE-4594-2A42-8F09-E2BB07B25A05}" dt="2022-04-21T01:19:34.490" v="2194" actId="478"/>
          <ac:spMkLst>
            <pc:docMk/>
            <pc:sldMk cId="1997077850" sldId="279"/>
            <ac:spMk id="200" creationId="{E79AFD42-F33E-C74D-A683-D982697E8D25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02" creationId="{D1ACC8AD-74F3-974F-AB90-503CD686C986}"/>
          </ac:spMkLst>
        </pc:spChg>
        <pc:spChg chg="del mod">
          <ac:chgData name="Wencai Zhang" userId="4a86a1d0-2108-4707-8228-1110f3c1be85" providerId="ADAL" clId="{1A0C98BE-4594-2A42-8F09-E2BB07B25A05}" dt="2022-04-21T01:20:26.201" v="2290" actId="478"/>
          <ac:spMkLst>
            <pc:docMk/>
            <pc:sldMk cId="1997077850" sldId="279"/>
            <ac:spMk id="203" creationId="{9ABA88B1-D450-494D-B39D-D6D81D24CD98}"/>
          </ac:spMkLst>
        </pc:spChg>
        <pc:spChg chg="del mod">
          <ac:chgData name="Wencai Zhang" userId="4a86a1d0-2108-4707-8228-1110f3c1be85" providerId="ADAL" clId="{1A0C98BE-4594-2A42-8F09-E2BB07B25A05}" dt="2022-04-21T01:19:27.113" v="2191" actId="478"/>
          <ac:spMkLst>
            <pc:docMk/>
            <pc:sldMk cId="1997077850" sldId="279"/>
            <ac:spMk id="205" creationId="{90A09E17-5AC6-2947-80B3-8B33CB4EB21C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07" creationId="{1D4697A6-3AE4-864A-9AC3-CE4F6474A003}"/>
          </ac:spMkLst>
        </pc:spChg>
        <pc:spChg chg="del mod">
          <ac:chgData name="Wencai Zhang" userId="4a86a1d0-2108-4707-8228-1110f3c1be85" providerId="ADAL" clId="{1A0C98BE-4594-2A42-8F09-E2BB07B25A05}" dt="2022-04-21T01:20:16.872" v="2287" actId="478"/>
          <ac:spMkLst>
            <pc:docMk/>
            <pc:sldMk cId="1997077850" sldId="279"/>
            <ac:spMk id="208" creationId="{B68B1913-C9F1-F944-8EC7-A5D5935B0DDC}"/>
          </ac:spMkLst>
        </pc:spChg>
        <pc:spChg chg="del mod">
          <ac:chgData name="Wencai Zhang" userId="4a86a1d0-2108-4707-8228-1110f3c1be85" providerId="ADAL" clId="{1A0C98BE-4594-2A42-8F09-E2BB07B25A05}" dt="2022-04-21T01:19:29.652" v="2192" actId="478"/>
          <ac:spMkLst>
            <pc:docMk/>
            <pc:sldMk cId="1997077850" sldId="279"/>
            <ac:spMk id="210" creationId="{C4CB92BF-C61E-7E4E-94B8-4218A510E48A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2" creationId="{E6907C81-330E-244C-AD31-DE3C00AB4423}"/>
          </ac:spMkLst>
        </pc:spChg>
        <pc:spChg chg="del mod">
          <ac:chgData name="Wencai Zhang" userId="4a86a1d0-2108-4707-8228-1110f3c1be85" providerId="ADAL" clId="{1A0C98BE-4594-2A42-8F09-E2BB07B25A05}" dt="2022-04-21T01:20:19.851" v="2288" actId="478"/>
          <ac:spMkLst>
            <pc:docMk/>
            <pc:sldMk cId="1997077850" sldId="279"/>
            <ac:spMk id="213" creationId="{224C71C3-D91B-7B48-AAA1-6C2864F6C3DA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6" creationId="{D37293E6-CE2A-EC4B-90BE-8E03F4C62D6D}"/>
          </ac:spMkLst>
        </pc:spChg>
        <pc:spChg chg="del mod">
          <ac:chgData name="Wencai Zhang" userId="4a86a1d0-2108-4707-8228-1110f3c1be85" providerId="ADAL" clId="{1A0C98BE-4594-2A42-8F09-E2BB07B25A05}" dt="2022-04-21T01:19:42.550" v="2197" actId="478"/>
          <ac:spMkLst>
            <pc:docMk/>
            <pc:sldMk cId="1997077850" sldId="279"/>
            <ac:spMk id="217" creationId="{D0342AE8-F5A0-994E-A3CC-A3D0B6275EB6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8" creationId="{44C4FBF7-7E83-EB41-A758-811B6DFD08D7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19" creationId="{7A0F4416-22AD-3B44-9A2C-4CD3265FF016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21" creationId="{EEB5E179-7CE1-0843-B5E4-AF198BE81FD0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22" creationId="{8E8D7268-A887-9844-B56B-69220329BC3D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23" creationId="{1069A7EB-D519-314B-B073-8E217A616EB9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224" creationId="{7957ABCD-52EA-574E-8E5F-1847FF566FE1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225" creationId="{672C5019-AE7E-294E-9673-34EA7EC0E9D9}"/>
          </ac:spMkLst>
        </pc:spChg>
        <pc:spChg chg="mod">
          <ac:chgData name="Wencai Zhang" userId="4a86a1d0-2108-4707-8228-1110f3c1be85" providerId="ADAL" clId="{1A0C98BE-4594-2A42-8F09-E2BB07B25A05}" dt="2022-04-21T00:57:33.112" v="1366" actId="164"/>
          <ac:spMkLst>
            <pc:docMk/>
            <pc:sldMk cId="1997077850" sldId="279"/>
            <ac:spMk id="226" creationId="{A863BAE8-AA5D-E74A-B2AA-2B41B71E0322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32" creationId="{20C039F8-4FE6-4ED7-B690-81C56CA93C6B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233" creationId="{F839E342-6FD4-469F-825B-8828C7EC5CD3}"/>
          </ac:spMkLst>
        </pc:spChg>
        <pc:spChg chg="del mod">
          <ac:chgData name="Wencai Zhang" userId="4a86a1d0-2108-4707-8228-1110f3c1be85" providerId="ADAL" clId="{1A0C98BE-4594-2A42-8F09-E2BB07B25A05}" dt="2022-04-21T01:19:36.805" v="2195" actId="478"/>
          <ac:spMkLst>
            <pc:docMk/>
            <pc:sldMk cId="1997077850" sldId="279"/>
            <ac:spMk id="235" creationId="{A0A80919-6654-4084-A5B4-EB95DE3617D2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36" creationId="{D9FFA7F4-798C-4839-A861-E847F8726B1F}"/>
          </ac:spMkLst>
        </pc:spChg>
        <pc:spChg chg="del">
          <ac:chgData name="Wencai Zhang" userId="4a86a1d0-2108-4707-8228-1110f3c1be85" providerId="ADAL" clId="{1A0C98BE-4594-2A42-8F09-E2BB07B25A05}" dt="2022-04-21T01:09:58.103" v="1750" actId="478"/>
          <ac:spMkLst>
            <pc:docMk/>
            <pc:sldMk cId="1997077850" sldId="279"/>
            <ac:spMk id="240" creationId="{7E45722A-8A48-4967-91CC-C5143A8CFEFE}"/>
          </ac:spMkLst>
        </pc:spChg>
        <pc:spChg chg="del">
          <ac:chgData name="Wencai Zhang" userId="4a86a1d0-2108-4707-8228-1110f3c1be85" providerId="ADAL" clId="{1A0C98BE-4594-2A42-8F09-E2BB07B25A05}" dt="2022-04-21T01:09:52.787" v="1748" actId="478"/>
          <ac:spMkLst>
            <pc:docMk/>
            <pc:sldMk cId="1997077850" sldId="279"/>
            <ac:spMk id="243" creationId="{A278CEC8-AF77-044C-99C5-80FB3C96473A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44" creationId="{EC3F7204-7F00-B343-AF5D-8D7FE14A606E}"/>
          </ac:spMkLst>
        </pc:spChg>
        <pc:spChg chg="mod topLvl">
          <ac:chgData name="Wencai Zhang" userId="4a86a1d0-2108-4707-8228-1110f3c1be85" providerId="ADAL" clId="{1A0C98BE-4594-2A42-8F09-E2BB07B25A05}" dt="2022-04-21T01:19:05.002" v="2189" actId="1035"/>
          <ac:spMkLst>
            <pc:docMk/>
            <pc:sldMk cId="1997077850" sldId="279"/>
            <ac:spMk id="245" creationId="{6685693A-A025-2C4B-ABF4-5B2FFF9B1AFB}"/>
          </ac:spMkLst>
        </pc:spChg>
        <pc:spChg chg="del">
          <ac:chgData name="Wencai Zhang" userId="4a86a1d0-2108-4707-8228-1110f3c1be85" providerId="ADAL" clId="{1A0C98BE-4594-2A42-8F09-E2BB07B25A05}" dt="2022-04-21T01:10:00.367" v="1751" actId="478"/>
          <ac:spMkLst>
            <pc:docMk/>
            <pc:sldMk cId="1997077850" sldId="279"/>
            <ac:spMk id="246" creationId="{A1716AC8-DC91-3146-A541-009E330E9EAA}"/>
          </ac:spMkLst>
        </pc:spChg>
        <pc:spChg chg="mod">
          <ac:chgData name="Wencai Zhang" userId="4a86a1d0-2108-4707-8228-1110f3c1be85" providerId="ADAL" clId="{1A0C98BE-4594-2A42-8F09-E2BB07B25A05}" dt="2022-04-21T01:14:25.416" v="1882" actId="165"/>
          <ac:spMkLst>
            <pc:docMk/>
            <pc:sldMk cId="1997077850" sldId="279"/>
            <ac:spMk id="257" creationId="{7D0C7E51-11B9-9A41-9850-0C62D8AA8253}"/>
          </ac:spMkLst>
        </pc:spChg>
        <pc:spChg chg="del mod">
          <ac:chgData name="Wencai Zhang" userId="4a86a1d0-2108-4707-8228-1110f3c1be85" providerId="ADAL" clId="{1A0C98BE-4594-2A42-8F09-E2BB07B25A05}" dt="2022-04-21T01:19:39.273" v="2196" actId="478"/>
          <ac:spMkLst>
            <pc:docMk/>
            <pc:sldMk cId="1997077850" sldId="279"/>
            <ac:spMk id="258" creationId="{DE24DF3C-173D-D644-9B05-F5FCC6B6FD9C}"/>
          </ac:spMkLst>
        </pc:spChg>
        <pc:spChg chg="del mod">
          <ac:chgData name="Wencai Zhang" userId="4a86a1d0-2108-4707-8228-1110f3c1be85" providerId="ADAL" clId="{1A0C98BE-4594-2A42-8F09-E2BB07B25A05}" dt="2022-04-21T01:20:31.803" v="2292" actId="478"/>
          <ac:spMkLst>
            <pc:docMk/>
            <pc:sldMk cId="1997077850" sldId="279"/>
            <ac:spMk id="259" creationId="{2DB4B70A-D0F3-B446-9983-B720EFC8CF79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60" creationId="{BD846D07-7E76-2E4C-A33B-F5BA32052A6C}"/>
          </ac:spMkLst>
        </pc:spChg>
        <pc:spChg chg="mod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61" creationId="{AD46C664-415F-BE4C-9BB0-70AC4BFAD948}"/>
          </ac:spMkLst>
        </pc:spChg>
        <pc:spChg chg="del">
          <ac:chgData name="Wencai Zhang" userId="4a86a1d0-2108-4707-8228-1110f3c1be85" providerId="ADAL" clId="{1A0C98BE-4594-2A42-8F09-E2BB07B25A05}" dt="2022-04-21T01:12:45.832" v="1786" actId="478"/>
          <ac:spMkLst>
            <pc:docMk/>
            <pc:sldMk cId="1997077850" sldId="279"/>
            <ac:spMk id="262" creationId="{7C67F0CE-6C6B-6249-92DB-C1B082A64FAF}"/>
          </ac:spMkLst>
        </pc:spChg>
        <pc:spChg chg="del mod topLvl">
          <ac:chgData name="Wencai Zhang" userId="4a86a1d0-2108-4707-8228-1110f3c1be85" providerId="ADAL" clId="{1A0C98BE-4594-2A42-8F09-E2BB07B25A05}" dt="2022-04-21T01:20:22.542" v="2289" actId="478"/>
          <ac:spMkLst>
            <pc:docMk/>
            <pc:sldMk cId="1997077850" sldId="279"/>
            <ac:spMk id="264" creationId="{58ADC441-464E-464B-BE90-985EE9255BBC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65" creationId="{F8AE2272-8DA6-1E49-B76B-21B95C786D57}"/>
          </ac:spMkLst>
        </pc:spChg>
        <pc:spChg chg="del mod">
          <ac:chgData name="Wencai Zhang" userId="4a86a1d0-2108-4707-8228-1110f3c1be85" providerId="ADAL" clId="{1A0C98BE-4594-2A42-8F09-E2BB07B25A05}" dt="2022-04-21T01:19:32.042" v="2193" actId="478"/>
          <ac:spMkLst>
            <pc:docMk/>
            <pc:sldMk cId="1997077850" sldId="279"/>
            <ac:spMk id="266" creationId="{F9E3350B-512B-F54D-B3AE-5486D55B5198}"/>
          </ac:spMkLst>
        </pc:spChg>
        <pc:spChg chg="del mod topLvl">
          <ac:chgData name="Wencai Zhang" userId="4a86a1d0-2108-4707-8228-1110f3c1be85" providerId="ADAL" clId="{1A0C98BE-4594-2A42-8F09-E2BB07B25A05}" dt="2022-04-21T01:20:29.212" v="2291" actId="478"/>
          <ac:spMkLst>
            <pc:docMk/>
            <pc:sldMk cId="1997077850" sldId="279"/>
            <ac:spMk id="268" creationId="{421BA127-217C-4AAD-9D5E-ED813DBA8669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76" creationId="{2DDF264B-565C-F04C-8AF2-F6BE3EE1FD8B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78" creationId="{5BF9E3DB-7A91-6A4F-8D68-735D97739534}"/>
          </ac:spMkLst>
        </pc:spChg>
        <pc:spChg chg="mod">
          <ac:chgData name="Wencai Zhang" userId="4a86a1d0-2108-4707-8228-1110f3c1be85" providerId="ADAL" clId="{1A0C98BE-4594-2A42-8F09-E2BB07B25A05}" dt="2022-04-20T20:41:47.601" v="1061" actId="113"/>
          <ac:spMkLst>
            <pc:docMk/>
            <pc:sldMk cId="1997077850" sldId="279"/>
            <ac:spMk id="279" creationId="{4FAF0AD1-0B87-2741-B8C2-3C91CF44A68D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79" creationId="{DE206415-E22E-B849-B7BA-9813DA48FFAF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81" creationId="{40973FCB-9097-1644-BC8A-1B825F7437AF}"/>
          </ac:spMkLst>
        </pc:spChg>
        <pc:spChg chg="mod">
          <ac:chgData name="Wencai Zhang" userId="4a86a1d0-2108-4707-8228-1110f3c1be85" providerId="ADAL" clId="{1A0C98BE-4594-2A42-8F09-E2BB07B25A05}" dt="2022-04-20T20:41:41.995" v="1059" actId="113"/>
          <ac:spMkLst>
            <pc:docMk/>
            <pc:sldMk cId="1997077850" sldId="279"/>
            <ac:spMk id="282" creationId="{4547362A-9D9E-A243-845E-59670FE14E5B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82" creationId="{D4EF85CB-A984-C044-8FFD-684CCBB500A2}"/>
          </ac:spMkLst>
        </pc:spChg>
        <pc:spChg chg="mod">
          <ac:chgData name="Wencai Zhang" userId="4a86a1d0-2108-4707-8228-1110f3c1be85" providerId="ADAL" clId="{1A0C98BE-4594-2A42-8F09-E2BB07B25A05}" dt="2022-04-19T21:26:51.958" v="4"/>
          <ac:spMkLst>
            <pc:docMk/>
            <pc:sldMk cId="1997077850" sldId="279"/>
            <ac:spMk id="283" creationId="{7CEF25A5-3100-494C-B46A-254C115505E8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84" creationId="{2ECAF76D-9186-3E46-B298-5F5393D15BF6}"/>
          </ac:spMkLst>
        </pc:spChg>
        <pc:spChg chg="mod">
          <ac:chgData name="Wencai Zhang" userId="4a86a1d0-2108-4707-8228-1110f3c1be85" providerId="ADAL" clId="{1A0C98BE-4594-2A42-8F09-E2BB07B25A05}" dt="2022-04-20T11:59:58.014" v="685" actId="404"/>
          <ac:spMkLst>
            <pc:docMk/>
            <pc:sldMk cId="1997077850" sldId="279"/>
            <ac:spMk id="287" creationId="{AABF23A2-52BC-CF43-8FC9-DCA2D9F74B6C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88" creationId="{359DBBE1-2DB4-444A-8B65-D3C9007AF13E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89" creationId="{2917E2D8-D94E-EE4F-AB42-DC1079F0209A}"/>
          </ac:spMkLst>
        </pc:spChg>
        <pc:spChg chg="mod">
          <ac:chgData name="Wencai Zhang" userId="4a86a1d0-2108-4707-8228-1110f3c1be85" providerId="ADAL" clId="{1A0C98BE-4594-2A42-8F09-E2BB07B25A05}" dt="2022-04-20T12:00:04.646" v="686" actId="404"/>
          <ac:spMkLst>
            <pc:docMk/>
            <pc:sldMk cId="1997077850" sldId="279"/>
            <ac:spMk id="289" creationId="{6973AAB4-8735-9C4D-87AD-ADD160F8ADB1}"/>
          </ac:spMkLst>
        </pc:spChg>
        <pc:spChg chg="mod">
          <ac:chgData name="Wencai Zhang" userId="4a86a1d0-2108-4707-8228-1110f3c1be85" providerId="ADAL" clId="{1A0C98BE-4594-2A42-8F09-E2BB07B25A05}" dt="2022-04-20T11:59:18.196" v="681" actId="404"/>
          <ac:spMkLst>
            <pc:docMk/>
            <pc:sldMk cId="1997077850" sldId="279"/>
            <ac:spMk id="290" creationId="{09C407E1-26CE-4646-AEF7-22E6862113D4}"/>
          </ac:spMkLst>
        </pc:spChg>
        <pc:spChg chg="mod">
          <ac:chgData name="Wencai Zhang" userId="4a86a1d0-2108-4707-8228-1110f3c1be85" providerId="ADAL" clId="{1A0C98BE-4594-2A42-8F09-E2BB07B25A05}" dt="2022-04-20T11:59:47.751" v="683" actId="404"/>
          <ac:spMkLst>
            <pc:docMk/>
            <pc:sldMk cId="1997077850" sldId="279"/>
            <ac:spMk id="292" creationId="{37FA3D05-0A0B-EF44-B124-4A875E38E127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92" creationId="{F16E9723-AC66-204C-A014-77309EEBD1CF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93" creationId="{8BE95C67-0894-3344-8D93-13F04FE0E824}"/>
          </ac:spMkLst>
        </pc:spChg>
        <pc:spChg chg="mod">
          <ac:chgData name="Wencai Zhang" userId="4a86a1d0-2108-4707-8228-1110f3c1be85" providerId="ADAL" clId="{1A0C98BE-4594-2A42-8F09-E2BB07B25A05}" dt="2022-04-20T11:59:52.095" v="684" actId="404"/>
          <ac:spMkLst>
            <pc:docMk/>
            <pc:sldMk cId="1997077850" sldId="279"/>
            <ac:spMk id="293" creationId="{B1EDEA80-1384-A643-A97B-79E2C3C910F0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294" creationId="{0FF28632-EBD1-A44A-8603-CC55EF0C0194}"/>
          </ac:spMkLst>
        </pc:spChg>
        <pc:spChg chg="mod">
          <ac:chgData name="Wencai Zhang" userId="4a86a1d0-2108-4707-8228-1110f3c1be85" providerId="ADAL" clId="{1A0C98BE-4594-2A42-8F09-E2BB07B25A05}" dt="2022-04-20T11:59:42.370" v="682" actId="404"/>
          <ac:spMkLst>
            <pc:docMk/>
            <pc:sldMk cId="1997077850" sldId="279"/>
            <ac:spMk id="294" creationId="{90BA9F3F-25B2-C243-8727-D8F5BCCE02A7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295" creationId="{ECC2C9E7-1D8E-4B49-97EC-748F31BBE8B4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298" creationId="{F03955AB-400D-9A4B-9A39-F1F3CEA1FC01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0" creationId="{10EF3669-4E39-2446-963B-141D83DC97B8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1" creationId="{882B1A0F-41D7-554C-AF1B-F6FA1C6B27FF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3" creationId="{015B1A78-3071-5B4B-851F-C66A05869658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4" creationId="{214DEDCC-3755-A345-89FB-1F941E0635C7}"/>
          </ac:spMkLst>
        </pc:spChg>
        <pc:spChg chg="mod">
          <ac:chgData name="Wencai Zhang" userId="4a86a1d0-2108-4707-8228-1110f3c1be85" providerId="ADAL" clId="{1A0C98BE-4594-2A42-8F09-E2BB07B25A05}" dt="2022-04-20T12:01:59.966" v="721"/>
          <ac:spMkLst>
            <pc:docMk/>
            <pc:sldMk cId="1997077850" sldId="279"/>
            <ac:spMk id="305" creationId="{F3582AF5-7AC8-E843-93BF-07DA0836136E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306" creationId="{4E46714E-112B-2948-A768-E37FA7B0C338}"/>
          </ac:spMkLst>
        </pc:spChg>
        <pc:spChg chg="mod topLvl">
          <ac:chgData name="Wencai Zhang" userId="4a86a1d0-2108-4707-8228-1110f3c1be85" providerId="ADAL" clId="{1A0C98BE-4594-2A42-8F09-E2BB07B25A05}" dt="2022-04-21T01:21:42.311" v="2312" actId="1036"/>
          <ac:spMkLst>
            <pc:docMk/>
            <pc:sldMk cId="1997077850" sldId="279"/>
            <ac:spMk id="307" creationId="{FD2DDB5E-B367-1946-97AD-7305D65FF126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08" creationId="{20193A51-E41D-6448-8ACA-D15B7EE455B9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09" creationId="{85DC6B92-A728-FB4A-9B8A-54C966DBAE87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10" creationId="{2B88C0DA-0060-6E48-B2C3-536F1C9507E3}"/>
          </ac:spMkLst>
        </pc:spChg>
        <pc:spChg chg="mod topLvl">
          <ac:chgData name="Wencai Zhang" userId="4a86a1d0-2108-4707-8228-1110f3c1be85" providerId="ADAL" clId="{1A0C98BE-4594-2A42-8F09-E2BB07B25A05}" dt="2022-04-21T01:11:46.503" v="1761" actId="164"/>
          <ac:spMkLst>
            <pc:docMk/>
            <pc:sldMk cId="1997077850" sldId="279"/>
            <ac:spMk id="311" creationId="{0E216C9B-108E-D14E-933A-DFF8D03BF47D}"/>
          </ac:spMkLst>
        </pc:spChg>
        <pc:spChg chg="add del">
          <ac:chgData name="Wencai Zhang" userId="4a86a1d0-2108-4707-8228-1110f3c1be85" providerId="ADAL" clId="{1A0C98BE-4594-2A42-8F09-E2BB07B25A05}" dt="2022-04-20T23:29:27.274" v="1069" actId="22"/>
          <ac:spMkLst>
            <pc:docMk/>
            <pc:sldMk cId="1997077850" sldId="279"/>
            <ac:spMk id="312" creationId="{79155F74-34D2-7643-8C09-3F30D1000F8F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4" creationId="{1804D3F5-6969-1D45-BE28-FE8B9DEB1F8E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5" creationId="{DB435C10-75F7-6C43-B32C-061E3EA074FF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6" creationId="{71C9F3E4-F1B3-0942-9839-F8C0CD45B0CD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7" creationId="{1167C684-7EFE-7A47-BF98-ADDE9CFAB46B}"/>
          </ac:spMkLst>
        </pc:spChg>
        <pc:spChg chg="mod topLvl">
          <ac:chgData name="Wencai Zhang" userId="4a86a1d0-2108-4707-8228-1110f3c1be85" providerId="ADAL" clId="{1A0C98BE-4594-2A42-8F09-E2BB07B25A05}" dt="2022-04-21T01:15:14.193" v="1887" actId="164"/>
          <ac:spMkLst>
            <pc:docMk/>
            <pc:sldMk cId="1997077850" sldId="279"/>
            <ac:spMk id="318" creationId="{F4062654-141D-2C41-B089-8BDCFBE5C2FD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0" creationId="{680053D8-23F5-2F46-A843-FC088B363CAD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1" creationId="{A433E2CE-2D13-5E48-82CA-61D1CEFC8A49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2" creationId="{221A6BBE-1DBA-744B-97B4-8A26B3464D78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3" creationId="{121EEEA2-5936-A34D-8013-19E94558BFB4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4" creationId="{9CFE270D-C6DD-6F44-A037-305D154B84C4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5" creationId="{909A0D46-8FAF-1C47-A059-BC72A6A41CA8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6" creationId="{1E7CE490-49CF-2642-9C37-E28C5CA1E1FA}"/>
          </ac:spMkLst>
        </pc:spChg>
        <pc:spChg chg="mod">
          <ac:chgData name="Wencai Zhang" userId="4a86a1d0-2108-4707-8228-1110f3c1be85" providerId="ADAL" clId="{1A0C98BE-4594-2A42-8F09-E2BB07B25A05}" dt="2022-04-21T01:15:29.929" v="1888"/>
          <ac:spMkLst>
            <pc:docMk/>
            <pc:sldMk cId="1997077850" sldId="279"/>
            <ac:spMk id="327" creationId="{8015926F-89F2-954E-BE7B-FFC706E295A4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29" creationId="{D289ECA7-B1AA-3A4F-BCE6-767D3CD51792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0" creationId="{E0837DF6-49B2-9740-8BF7-9A1BFAE60F5A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1" creationId="{3BA58964-D64F-6F49-8150-935F6713673C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2" creationId="{1E8FE0C5-80E0-AD47-A0A3-55EB7BADEA9D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3" creationId="{CA12C39A-3152-D346-B3B5-6ED98B2687F5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4" creationId="{930C0BCF-FE27-F141-BEFF-B7AB1952671F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5" creationId="{B33582D7-4696-D843-83DF-1F56192986C6}"/>
          </ac:spMkLst>
        </pc:spChg>
        <pc:spChg chg="mod">
          <ac:chgData name="Wencai Zhang" userId="4a86a1d0-2108-4707-8228-1110f3c1be85" providerId="ADAL" clId="{1A0C98BE-4594-2A42-8F09-E2BB07B25A05}" dt="2022-04-21T01:19:46.551" v="2198"/>
          <ac:spMkLst>
            <pc:docMk/>
            <pc:sldMk cId="1997077850" sldId="279"/>
            <ac:spMk id="336" creationId="{E9F4A065-5DA6-0C4E-831A-93ACD7FFD6F7}"/>
          </ac:spMkLst>
        </pc:spChg>
        <pc:grpChg chg="del mod topLvl">
          <ac:chgData name="Wencai Zhang" userId="4a86a1d0-2108-4707-8228-1110f3c1be85" providerId="ADAL" clId="{1A0C98BE-4594-2A42-8F09-E2BB07B25A05}" dt="2022-04-21T01:14:49.779" v="1885" actId="165"/>
          <ac:grpSpMkLst>
            <pc:docMk/>
            <pc:sldMk cId="1997077850" sldId="279"/>
            <ac:grpSpMk id="2" creationId="{68179CDE-26CC-AE46-A792-A605CA655776}"/>
          </ac:grpSpMkLst>
        </pc:grpChg>
        <pc:grpChg chg="del mod">
          <ac:chgData name="Wencai Zhang" userId="4a86a1d0-2108-4707-8228-1110f3c1be85" providerId="ADAL" clId="{1A0C98BE-4594-2A42-8F09-E2BB07B25A05}" dt="2022-04-21T01:12:45.832" v="1786" actId="478"/>
          <ac:grpSpMkLst>
            <pc:docMk/>
            <pc:sldMk cId="1997077850" sldId="279"/>
            <ac:grpSpMk id="5" creationId="{DF93B195-F799-DC4D-9017-9227DFD88F27}"/>
          </ac:grpSpMkLst>
        </pc:grpChg>
        <pc:grpChg chg="mod">
          <ac:chgData name="Wencai Zhang" userId="4a86a1d0-2108-4707-8228-1110f3c1be85" providerId="ADAL" clId="{1A0C98BE-4594-2A42-8F09-E2BB07B25A05}" dt="2022-04-21T00:57:33.112" v="1366" actId="164"/>
          <ac:grpSpMkLst>
            <pc:docMk/>
            <pc:sldMk cId="1997077850" sldId="279"/>
            <ac:grpSpMk id="8" creationId="{447B76B8-20C0-6D42-949E-E331C653DE5F}"/>
          </ac:grpSpMkLst>
        </pc:grpChg>
        <pc:grpChg chg="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0" creationId="{1B523065-556E-D94A-B8C0-DB5FF1F9710E}"/>
          </ac:grpSpMkLst>
        </pc:grpChg>
        <pc:grpChg chg="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1" creationId="{A976ED9E-9E74-114A-AC13-9E39131E6EBE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3" creationId="{05BEAB5F-EC92-E54C-8F95-0C1F5F6CA55E}"/>
          </ac:grpSpMkLst>
        </pc:grpChg>
        <pc:grpChg chg="del mod topLvl">
          <ac:chgData name="Wencai Zhang" userId="4a86a1d0-2108-4707-8228-1110f3c1be85" providerId="ADAL" clId="{1A0C98BE-4594-2A42-8F09-E2BB07B25A05}" dt="2022-04-21T01:14:40.480" v="1884" actId="165"/>
          <ac:grpSpMkLst>
            <pc:docMk/>
            <pc:sldMk cId="1997077850" sldId="279"/>
            <ac:grpSpMk id="17" creationId="{17D41CD5-132C-7D41-88B0-C32B45B35F78}"/>
          </ac:grpSpMkLst>
        </pc:grpChg>
        <pc:grpChg chg="del mod topLvl">
          <ac:chgData name="Wencai Zhang" userId="4a86a1d0-2108-4707-8228-1110f3c1be85" providerId="ADAL" clId="{1A0C98BE-4594-2A42-8F09-E2BB07B25A05}" dt="2022-04-21T01:20:29.212" v="2291" actId="478"/>
          <ac:grpSpMkLst>
            <pc:docMk/>
            <pc:sldMk cId="1997077850" sldId="279"/>
            <ac:grpSpMk id="19" creationId="{195A3B47-E418-DC45-91B5-0D6EE931A316}"/>
          </ac:grpSpMkLst>
        </pc:grpChg>
        <pc:grpChg chg="add del mod">
          <ac:chgData name="Wencai Zhang" userId="4a86a1d0-2108-4707-8228-1110f3c1be85" providerId="ADAL" clId="{1A0C98BE-4594-2A42-8F09-E2BB07B25A05}" dt="2022-04-21T01:11:20.769" v="1758" actId="165"/>
          <ac:grpSpMkLst>
            <pc:docMk/>
            <pc:sldMk cId="1997077850" sldId="279"/>
            <ac:grpSpMk id="20" creationId="{B02F0272-2C94-5647-AAEF-0068AF528B52}"/>
          </ac:grpSpMkLst>
        </pc:grpChg>
        <pc:grpChg chg="mod">
          <ac:chgData name="Wencai Zhang" userId="4a86a1d0-2108-4707-8228-1110f3c1be85" providerId="ADAL" clId="{1A0C98BE-4594-2A42-8F09-E2BB07B25A05}" dt="2022-04-20T21:38:32.730" v="1067" actId="164"/>
          <ac:grpSpMkLst>
            <pc:docMk/>
            <pc:sldMk cId="1997077850" sldId="279"/>
            <ac:grpSpMk id="22" creationId="{B05BB5C9-1699-684A-912A-702460E1570F}"/>
          </ac:grpSpMkLst>
        </pc:grpChg>
        <pc:grpChg chg="mod">
          <ac:chgData name="Wencai Zhang" userId="4a86a1d0-2108-4707-8228-1110f3c1be85" providerId="ADAL" clId="{1A0C98BE-4594-2A42-8F09-E2BB07B25A05}" dt="2022-04-19T21:02:43.799" v="2" actId="164"/>
          <ac:grpSpMkLst>
            <pc:docMk/>
            <pc:sldMk cId="1997077850" sldId="279"/>
            <ac:grpSpMk id="23" creationId="{BFCE707F-5725-FC41-A3B0-057D21D414EC}"/>
          </ac:grpSpMkLst>
        </pc:grpChg>
        <pc:grpChg chg="del mod topLvl">
          <ac:chgData name="Wencai Zhang" userId="4a86a1d0-2108-4707-8228-1110f3c1be85" providerId="ADAL" clId="{1A0C98BE-4594-2A42-8F09-E2BB07B25A05}" dt="2022-04-21T01:14:34.013" v="1883" actId="165"/>
          <ac:grpSpMkLst>
            <pc:docMk/>
            <pc:sldMk cId="1997077850" sldId="279"/>
            <ac:grpSpMk id="24" creationId="{89A7D3DD-3D93-A84C-B48A-23282A3DE11F}"/>
          </ac:grpSpMkLst>
        </pc:grpChg>
        <pc:grpChg chg="mod">
          <ac:chgData name="Wencai Zhang" userId="4a86a1d0-2108-4707-8228-1110f3c1be85" providerId="ADAL" clId="{1A0C98BE-4594-2A42-8F09-E2BB07B25A05}" dt="2022-04-20T21:38:32.730" v="1067" actId="164"/>
          <ac:grpSpMkLst>
            <pc:docMk/>
            <pc:sldMk cId="1997077850" sldId="279"/>
            <ac:grpSpMk id="25" creationId="{AD9A5DAE-FE9B-5549-B60C-71AA747CE4F0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26" creationId="{DC3A6F18-42A4-2648-9DE2-7817988EE9EB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27" creationId="{DBFCF960-B4F6-FE4A-83B0-A70FC62233BA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1" creationId="{C305F800-B55C-3142-AA19-1181DEAFA8EB}"/>
          </ac:grpSpMkLst>
        </pc:grpChg>
        <pc:grpChg chg="add del 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32" creationId="{704A2AAA-7297-6645-8914-0DDA00217C42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3" creationId="{16F91CFF-0111-0B4C-9C9C-7A3950D4CFA5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4" creationId="{6BCF8669-D046-B848-B187-B43F6E5B9A57}"/>
          </ac:grpSpMkLst>
        </pc:grpChg>
        <pc:grpChg chg="mod">
          <ac:chgData name="Wencai Zhang" userId="4a86a1d0-2108-4707-8228-1110f3c1be85" providerId="ADAL" clId="{1A0C98BE-4594-2A42-8F09-E2BB07B25A05}" dt="2022-04-21T00:57:33.112" v="1366" actId="164"/>
          <ac:grpSpMkLst>
            <pc:docMk/>
            <pc:sldMk cId="1997077850" sldId="279"/>
            <ac:grpSpMk id="155" creationId="{8CA149AD-4572-E64D-B4EA-7329D2DC2F84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0" creationId="{1F56A997-5B1D-0E42-8166-3B7495A9F80E}"/>
          </ac:grpSpMkLst>
        </pc:grpChg>
        <pc:grpChg chg="del mod topLvl">
          <ac:chgData name="Wencai Zhang" userId="4a86a1d0-2108-4707-8228-1110f3c1be85" providerId="ADAL" clId="{1A0C98BE-4594-2A42-8F09-E2BB07B25A05}" dt="2022-04-21T01:14:56.113" v="1886" actId="165"/>
          <ac:grpSpMkLst>
            <pc:docMk/>
            <pc:sldMk cId="1997077850" sldId="279"/>
            <ac:grpSpMk id="171" creationId="{A711D4DC-5BDA-6F4E-96ED-F10DF2924F64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2" creationId="{04F75B7C-4C5B-EC44-94F0-80A48FD8E8E3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3" creationId="{EB191E7E-12D3-6144-AD4E-5EB77CC64589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74" creationId="{4A64262C-29B0-0F4F-9F5D-2F04A33294A9}"/>
          </ac:grpSpMkLst>
        </pc:grpChg>
        <pc:grpChg chg="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189" creationId="{57B618FE-00B3-FC4B-902A-F719732D7CD2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3" creationId="{2C962FB6-4588-664E-9502-4552389B770B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4" creationId="{7FEC941E-0C3D-F14C-8227-0EAEBFE4D084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5" creationId="{A80E09AE-7C92-484B-AD81-E52463D9452A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6" creationId="{3A6C2602-B4F6-9E4E-9ECF-CEE8F8F9D38C}"/>
          </ac:grpSpMkLst>
        </pc:grpChg>
        <pc:grpChg chg="mod topLvl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197" creationId="{0D998B61-A34F-B04E-BF80-CC347A427353}"/>
          </ac:grpSpMkLst>
        </pc:grpChg>
        <pc:grpChg chg="del mod">
          <ac:chgData name="Wencai Zhang" userId="4a86a1d0-2108-4707-8228-1110f3c1be85" providerId="ADAL" clId="{1A0C98BE-4594-2A42-8F09-E2BB07B25A05}" dt="2022-04-21T01:20:26.201" v="2290" actId="478"/>
          <ac:grpSpMkLst>
            <pc:docMk/>
            <pc:sldMk cId="1997077850" sldId="279"/>
            <ac:grpSpMk id="201" creationId="{21201A42-EC1C-884A-B944-ADB25EA28720}"/>
          </ac:grpSpMkLst>
        </pc:grpChg>
        <pc:grpChg chg="del mod">
          <ac:chgData name="Wencai Zhang" userId="4a86a1d0-2108-4707-8228-1110f3c1be85" providerId="ADAL" clId="{1A0C98BE-4594-2A42-8F09-E2BB07B25A05}" dt="2022-04-21T01:20:16.872" v="2287" actId="478"/>
          <ac:grpSpMkLst>
            <pc:docMk/>
            <pc:sldMk cId="1997077850" sldId="279"/>
            <ac:grpSpMk id="206" creationId="{1C3945D5-036F-BD4A-AAC5-7EE360D86FCA}"/>
          </ac:grpSpMkLst>
        </pc:grpChg>
        <pc:grpChg chg="del mod">
          <ac:chgData name="Wencai Zhang" userId="4a86a1d0-2108-4707-8228-1110f3c1be85" providerId="ADAL" clId="{1A0C98BE-4594-2A42-8F09-E2BB07B25A05}" dt="2022-04-21T01:20:19.851" v="2288" actId="478"/>
          <ac:grpSpMkLst>
            <pc:docMk/>
            <pc:sldMk cId="1997077850" sldId="279"/>
            <ac:grpSpMk id="211" creationId="{511C7747-3F27-7A46-937C-CA36400FD7EE}"/>
          </ac:grpSpMkLst>
        </pc:grpChg>
        <pc:grpChg chg="del mod">
          <ac:chgData name="Wencai Zhang" userId="4a86a1d0-2108-4707-8228-1110f3c1be85" providerId="ADAL" clId="{1A0C98BE-4594-2A42-8F09-E2BB07B25A05}" dt="2022-04-21T01:19:42.550" v="2197" actId="478"/>
          <ac:grpSpMkLst>
            <pc:docMk/>
            <pc:sldMk cId="1997077850" sldId="279"/>
            <ac:grpSpMk id="215" creationId="{6CAFCC16-CD2D-944C-9AC9-28E67537C206}"/>
          </ac:grpSpMkLst>
        </pc:grpChg>
        <pc:grpChg chg="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220" creationId="{773D0557-2F3F-4E48-97EB-AA3601081CBE}"/>
          </ac:grpSpMkLst>
        </pc:grpChg>
        <pc:grpChg chg="del mod">
          <ac:chgData name="Wencai Zhang" userId="4a86a1d0-2108-4707-8228-1110f3c1be85" providerId="ADAL" clId="{1A0C98BE-4594-2A42-8F09-E2BB07B25A05}" dt="2022-04-21T01:20:31.803" v="2292" actId="478"/>
          <ac:grpSpMkLst>
            <pc:docMk/>
            <pc:sldMk cId="1997077850" sldId="279"/>
            <ac:grpSpMk id="252" creationId="{6E3E3AF6-E4A4-D947-8EBA-29486007CF2F}"/>
          </ac:grpSpMkLst>
        </pc:grpChg>
        <pc:grpChg chg="del mod topLvl">
          <ac:chgData name="Wencai Zhang" userId="4a86a1d0-2108-4707-8228-1110f3c1be85" providerId="ADAL" clId="{1A0C98BE-4594-2A42-8F09-E2BB07B25A05}" dt="2022-04-21T01:20:22.542" v="2289" actId="478"/>
          <ac:grpSpMkLst>
            <pc:docMk/>
            <pc:sldMk cId="1997077850" sldId="279"/>
            <ac:grpSpMk id="263" creationId="{B947E33E-5CBB-0E48-875E-1E09E8D5987A}"/>
          </ac:grpSpMkLst>
        </pc:grpChg>
        <pc:grpChg chg="add del mod">
          <ac:chgData name="Wencai Zhang" userId="4a86a1d0-2108-4707-8228-1110f3c1be85" providerId="ADAL" clId="{1A0C98BE-4594-2A42-8F09-E2BB07B25A05}" dt="2022-04-19T21:28:13.871" v="11"/>
          <ac:grpSpMkLst>
            <pc:docMk/>
            <pc:sldMk cId="1997077850" sldId="279"/>
            <ac:grpSpMk id="274" creationId="{8362EF96-30DE-5444-AE34-DAF39D0DFA38}"/>
          </ac:grpSpMkLst>
        </pc:grpChg>
        <pc:grpChg chg="mod">
          <ac:chgData name="Wencai Zhang" userId="4a86a1d0-2108-4707-8228-1110f3c1be85" providerId="ADAL" clId="{1A0C98BE-4594-2A42-8F09-E2BB07B25A05}" dt="2022-04-19T21:26:51.958" v="4"/>
          <ac:grpSpMkLst>
            <pc:docMk/>
            <pc:sldMk cId="1997077850" sldId="279"/>
            <ac:grpSpMk id="280" creationId="{A4B87345-C452-0042-8BAD-ABB17E754EFE}"/>
          </ac:grpSpMkLst>
        </pc:grpChg>
        <pc:grpChg chg="add del mod topLvl">
          <ac:chgData name="Wencai Zhang" userId="4a86a1d0-2108-4707-8228-1110f3c1be85" providerId="ADAL" clId="{1A0C98BE-4594-2A42-8F09-E2BB07B25A05}" dt="2022-04-21T01:11:28.271" v="1759" actId="165"/>
          <ac:grpSpMkLst>
            <pc:docMk/>
            <pc:sldMk cId="1997077850" sldId="279"/>
            <ac:grpSpMk id="283" creationId="{D142E165-DD0B-A443-88F8-31E2487AD8F7}"/>
          </ac:grpSpMkLst>
        </pc:grpChg>
        <pc:grpChg chg="add del mod">
          <ac:chgData name="Wencai Zhang" userId="4a86a1d0-2108-4707-8228-1110f3c1be85" providerId="ADAL" clId="{1A0C98BE-4594-2A42-8F09-E2BB07B25A05}" dt="2022-04-20T12:02:17.629" v="724" actId="478"/>
          <ac:grpSpMkLst>
            <pc:docMk/>
            <pc:sldMk cId="1997077850" sldId="279"/>
            <ac:grpSpMk id="285" creationId="{5482563D-550B-FC47-8406-2DBA04EFF644}"/>
          </ac:grpSpMkLst>
        </pc:grpChg>
        <pc:grpChg chg="del mod topLvl">
          <ac:chgData name="Wencai Zhang" userId="4a86a1d0-2108-4707-8228-1110f3c1be85" providerId="ADAL" clId="{1A0C98BE-4594-2A42-8F09-E2BB07B25A05}" dt="2022-04-21T01:11:35.050" v="1760" actId="165"/>
          <ac:grpSpMkLst>
            <pc:docMk/>
            <pc:sldMk cId="1997077850" sldId="279"/>
            <ac:grpSpMk id="285" creationId="{664531E3-79D6-4544-B056-9EA3E8D5C3FD}"/>
          </ac:grpSpMkLst>
        </pc:grpChg>
        <pc:grpChg chg="mod">
          <ac:chgData name="Wencai Zhang" userId="4a86a1d0-2108-4707-8228-1110f3c1be85" providerId="ADAL" clId="{1A0C98BE-4594-2A42-8F09-E2BB07B25A05}" dt="2022-04-19T21:28:51.212" v="28"/>
          <ac:grpSpMkLst>
            <pc:docMk/>
            <pc:sldMk cId="1997077850" sldId="279"/>
            <ac:grpSpMk id="291" creationId="{56B882AB-90EE-D24A-8AAF-E5DAF4074CC1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296" creationId="{CAC570FD-0345-7044-AB2C-8B2ACD0023B4}"/>
          </ac:grpSpMkLst>
        </pc:grpChg>
        <pc:grpChg chg="mod">
          <ac:chgData name="Wencai Zhang" userId="4a86a1d0-2108-4707-8228-1110f3c1be85" providerId="ADAL" clId="{1A0C98BE-4594-2A42-8F09-E2BB07B25A05}" dt="2022-04-20T12:01:59.966" v="721"/>
          <ac:grpSpMkLst>
            <pc:docMk/>
            <pc:sldMk cId="1997077850" sldId="279"/>
            <ac:grpSpMk id="302" creationId="{B6ADAB78-997E-CD40-8972-DD29CF9F3B68}"/>
          </ac:grpSpMkLst>
        </pc:grpChg>
        <pc:grpChg chg="add del mod">
          <ac:chgData name="Wencai Zhang" userId="4a86a1d0-2108-4707-8228-1110f3c1be85" providerId="ADAL" clId="{1A0C98BE-4594-2A42-8F09-E2BB07B25A05}" dt="2022-04-21T01:14:25.416" v="1882" actId="165"/>
          <ac:grpSpMkLst>
            <pc:docMk/>
            <pc:sldMk cId="1997077850" sldId="279"/>
            <ac:grpSpMk id="313" creationId="{96C0809B-A36D-5343-A7FD-D3443D40C5D0}"/>
          </ac:grpSpMkLst>
        </pc:grpChg>
        <pc:grpChg chg="add del mod">
          <ac:chgData name="Wencai Zhang" userId="4a86a1d0-2108-4707-8228-1110f3c1be85" providerId="ADAL" clId="{1A0C98BE-4594-2A42-8F09-E2BB07B25A05}" dt="2022-04-21T01:19:23.938" v="2190" actId="478"/>
          <ac:grpSpMkLst>
            <pc:docMk/>
            <pc:sldMk cId="1997077850" sldId="279"/>
            <ac:grpSpMk id="319" creationId="{4A76F24F-3AC0-F44B-A080-BEDC476A0C4B}"/>
          </ac:grpSpMkLst>
        </pc:grpChg>
        <pc:grpChg chg="add mod">
          <ac:chgData name="Wencai Zhang" userId="4a86a1d0-2108-4707-8228-1110f3c1be85" providerId="ADAL" clId="{1A0C98BE-4594-2A42-8F09-E2BB07B25A05}" dt="2022-04-21T01:21:42.311" v="2312" actId="1036"/>
          <ac:grpSpMkLst>
            <pc:docMk/>
            <pc:sldMk cId="1997077850" sldId="279"/>
            <ac:grpSpMk id="328" creationId="{11B70FFD-671A-6342-A97A-F392F09DBD6A}"/>
          </ac:grpSpMkLst>
        </pc:grpChg>
        <pc:graphicFrameChg chg="mod">
          <ac:chgData name="Wencai Zhang" userId="4a86a1d0-2108-4707-8228-1110f3c1be85" providerId="ADAL" clId="{1A0C98BE-4594-2A42-8F09-E2BB07B25A05}" dt="2022-04-21T01:21:42.311" v="2312" actId="1036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mod">
          <ac:chgData name="Wencai Zhang" userId="4a86a1d0-2108-4707-8228-1110f3c1be85" providerId="ADAL" clId="{1A0C98BE-4594-2A42-8F09-E2BB07B25A05}" dt="2022-04-21T01:21:42.311" v="2312" actId="1036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graphicFrameChg chg="add del mod">
          <ac:chgData name="Wencai Zhang" userId="4a86a1d0-2108-4707-8228-1110f3c1be85" providerId="ADAL" clId="{1A0C98BE-4594-2A42-8F09-E2BB07B25A05}" dt="2022-04-19T21:28:13.871" v="11"/>
          <ac:graphicFrameMkLst>
            <pc:docMk/>
            <pc:sldMk cId="1997077850" sldId="279"/>
            <ac:graphicFrameMk id="284" creationId="{71368D56-AE0B-B745-B2AD-6C2EC3E5F883}"/>
          </ac:graphicFrameMkLst>
        </pc:graphicFrameChg>
        <pc:graphicFrameChg chg="add mod">
          <ac:chgData name="Wencai Zhang" userId="4a86a1d0-2108-4707-8228-1110f3c1be85" providerId="ADAL" clId="{1A0C98BE-4594-2A42-8F09-E2BB07B25A05}" dt="2022-04-20T12:04:12.890" v="795" actId="1076"/>
          <ac:graphicFrameMkLst>
            <pc:docMk/>
            <pc:sldMk cId="1997077850" sldId="279"/>
            <ac:graphicFrameMk id="295" creationId="{FE607F22-4EC2-5348-95FB-D3D643439361}"/>
          </ac:graphicFrameMkLst>
        </pc:graphicFrame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12" creationId="{8D48EFAF-0B0B-614C-94DF-D55F672F6773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14" creationId="{64717BB5-8A3B-C847-9C0E-331DCF4393DE}"/>
          </ac:picMkLst>
        </pc:picChg>
        <pc:picChg chg="mod">
          <ac:chgData name="Wencai Zhang" userId="4a86a1d0-2108-4707-8228-1110f3c1be85" providerId="ADAL" clId="{1A0C98BE-4594-2A42-8F09-E2BB07B25A05}" dt="2022-04-21T00:57:33.112" v="1366" actId="164"/>
          <ac:picMkLst>
            <pc:docMk/>
            <pc:sldMk cId="1997077850" sldId="279"/>
            <ac:picMk id="15" creationId="{9CCBEE8A-65FE-7A4C-A5DE-75F4D2587227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1" creationId="{8715F9B0-F678-A043-9E1D-272F3B299417}"/>
          </ac:picMkLst>
        </pc:picChg>
        <pc:picChg chg="add 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9" creationId="{3980863E-2997-8D46-BC6A-E97ADA6F6309}"/>
          </ac:picMkLst>
        </pc:picChg>
        <pc:picChg chg="add 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30" creationId="{D85E43A3-2AC4-DB4A-B32A-AEDCC750B937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76" creationId="{1BE18E9F-BAF1-B241-BEF7-0CBFCFCCE3AA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79" creationId="{FFB0F5CC-7A8E-D54E-B439-A1B19A2750DE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82" creationId="{A30CF00C-7CA8-C649-AEE9-D32E24C7273B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186" creationId="{657AA00D-2EEB-8A4A-ACBF-F334F6992849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199" creationId="{B8B08B51-3FCD-9D4C-9068-C48F3A5498EE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04" creationId="{CF27BFE2-BCCA-D942-917D-4E875E3E882B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09" creationId="{EC17928E-7AA3-544B-8860-0CB9BAF04570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14" creationId="{82BDA35F-8661-534B-94A0-EB721CFE93BF}"/>
          </ac:picMkLst>
        </pc:picChg>
        <pc:picChg chg="mod">
          <ac:chgData name="Wencai Zhang" userId="4a86a1d0-2108-4707-8228-1110f3c1be85" providerId="ADAL" clId="{1A0C98BE-4594-2A42-8F09-E2BB07B25A05}" dt="2022-04-19T21:02:43.799" v="2" actId="164"/>
          <ac:picMkLst>
            <pc:docMk/>
            <pc:sldMk cId="1997077850" sldId="279"/>
            <ac:picMk id="231" creationId="{DA8C3D4F-1C6A-324F-96EA-B2FBBB842E89}"/>
          </ac:picMkLst>
        </pc:picChg>
        <pc:picChg chg="mod topLvl modCrop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34" creationId="{8ECD7F06-6619-6948-975E-4874003590B8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37" creationId="{DB524C63-1BDC-4AFB-8504-645D6BBD2E96}"/>
          </ac:picMkLst>
        </pc:picChg>
        <pc:picChg chg="mod">
          <ac:chgData name="Wencai Zhang" userId="4a86a1d0-2108-4707-8228-1110f3c1be85" providerId="ADAL" clId="{1A0C98BE-4594-2A42-8F09-E2BB07B25A05}" dt="2022-04-21T01:14:25.416" v="1882" actId="165"/>
          <ac:picMkLst>
            <pc:docMk/>
            <pc:sldMk cId="1997077850" sldId="279"/>
            <ac:picMk id="238" creationId="{B360B700-1DD9-3544-BE20-BABFB3ACAB69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41" creationId="{10093908-948F-4C27-B057-DC3F75727BF5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42" creationId="{0DADD5D4-55AF-5442-9E75-0AA5DDA4D1BA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67" creationId="{6303280E-8560-614F-99A9-CD6BBF21DDF2}"/>
          </ac:picMkLst>
        </pc:picChg>
        <pc:picChg chg="mod">
          <ac:chgData name="Wencai Zhang" userId="4a86a1d0-2108-4707-8228-1110f3c1be85" providerId="ADAL" clId="{1A0C98BE-4594-2A42-8F09-E2BB07B25A05}" dt="2022-04-19T21:26:51.958" v="4"/>
          <ac:picMkLst>
            <pc:docMk/>
            <pc:sldMk cId="1997077850" sldId="279"/>
            <ac:picMk id="275" creationId="{8281E3E4-7917-5647-9778-7D45A50BDCBE}"/>
          </ac:picMkLst>
        </pc:picChg>
        <pc:picChg chg="mod">
          <ac:chgData name="Wencai Zhang" userId="4a86a1d0-2108-4707-8228-1110f3c1be85" providerId="ADAL" clId="{1A0C98BE-4594-2A42-8F09-E2BB07B25A05}" dt="2022-04-19T21:26:51.958" v="4"/>
          <ac:picMkLst>
            <pc:docMk/>
            <pc:sldMk cId="1997077850" sldId="279"/>
            <ac:picMk id="277" creationId="{57CB9941-0962-E948-8B79-3526FF8B0F39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77" creationId="{AEEF61E3-1190-5647-B769-EF2B53660EA3}"/>
          </ac:picMkLst>
        </pc:picChg>
        <pc:picChg chg="mod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78" creationId="{183201BA-0C87-D44D-9CDD-4EB7065A07D8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86" creationId="{2C9E5C93-79AB-D544-9C9E-5BB71EC57C00}"/>
          </ac:picMkLst>
        </pc:picChg>
        <pc:picChg chg="mod">
          <ac:chgData name="Wencai Zhang" userId="4a86a1d0-2108-4707-8228-1110f3c1be85" providerId="ADAL" clId="{1A0C98BE-4594-2A42-8F09-E2BB07B25A05}" dt="2022-04-19T21:28:51.212" v="28"/>
          <ac:picMkLst>
            <pc:docMk/>
            <pc:sldMk cId="1997077850" sldId="279"/>
            <ac:picMk id="286" creationId="{EA4D0B3D-147E-824F-96D7-A7D6AE18211F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87" creationId="{E7E50969-0D74-2347-A960-177B8655DB10}"/>
          </ac:picMkLst>
        </pc:picChg>
        <pc:picChg chg="mod">
          <ac:chgData name="Wencai Zhang" userId="4a86a1d0-2108-4707-8228-1110f3c1be85" providerId="ADAL" clId="{1A0C98BE-4594-2A42-8F09-E2BB07B25A05}" dt="2022-04-19T21:28:51.212" v="28"/>
          <ac:picMkLst>
            <pc:docMk/>
            <pc:sldMk cId="1997077850" sldId="279"/>
            <ac:picMk id="288" creationId="{9828E9AB-6A1E-9A4C-BF14-7DED1D8612ED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90" creationId="{235197B1-DE0B-3047-A19B-85765CB8DFB1}"/>
          </ac:picMkLst>
        </pc:picChg>
        <pc:picChg chg="mod topLvl">
          <ac:chgData name="Wencai Zhang" userId="4a86a1d0-2108-4707-8228-1110f3c1be85" providerId="ADAL" clId="{1A0C98BE-4594-2A42-8F09-E2BB07B25A05}" dt="2022-04-21T01:21:42.311" v="2312" actId="1036"/>
          <ac:picMkLst>
            <pc:docMk/>
            <pc:sldMk cId="1997077850" sldId="279"/>
            <ac:picMk id="291" creationId="{521C34CC-E8BD-EE42-BC28-6BBF28D8CF48}"/>
          </ac:picMkLst>
        </pc:picChg>
        <pc:picChg chg="mod">
          <ac:chgData name="Wencai Zhang" userId="4a86a1d0-2108-4707-8228-1110f3c1be85" providerId="ADAL" clId="{1A0C98BE-4594-2A42-8F09-E2BB07B25A05}" dt="2022-04-20T12:01:59.966" v="721"/>
          <ac:picMkLst>
            <pc:docMk/>
            <pc:sldMk cId="1997077850" sldId="279"/>
            <ac:picMk id="297" creationId="{D0C8E8CB-5A29-2049-96C9-DEBBDB50A062}"/>
          </ac:picMkLst>
        </pc:picChg>
        <pc:picChg chg="mod">
          <ac:chgData name="Wencai Zhang" userId="4a86a1d0-2108-4707-8228-1110f3c1be85" providerId="ADAL" clId="{1A0C98BE-4594-2A42-8F09-E2BB07B25A05}" dt="2022-04-20T12:01:59.966" v="721"/>
          <ac:picMkLst>
            <pc:docMk/>
            <pc:sldMk cId="1997077850" sldId="279"/>
            <ac:picMk id="299" creationId="{2BB95728-E0BD-3846-AB96-4B34B0020151}"/>
          </ac:picMkLst>
        </pc:picChg>
        <pc:cxnChg chg="mod">
          <ac:chgData name="Wencai Zhang" userId="4a86a1d0-2108-4707-8228-1110f3c1be85" providerId="ADAL" clId="{1A0C98BE-4594-2A42-8F09-E2BB07B25A05}" dt="2022-04-21T01:21:42.311" v="2312" actId="1036"/>
          <ac:cxnSpMkLst>
            <pc:docMk/>
            <pc:sldMk cId="1997077850" sldId="279"/>
            <ac:cxnSpMk id="16" creationId="{A8D2D1C6-A25F-3E46-AAE8-02AFD46CEDAE}"/>
          </ac:cxnSpMkLst>
        </pc:cxnChg>
        <pc:cxnChg chg="mod">
          <ac:chgData name="Wencai Zhang" userId="4a86a1d0-2108-4707-8228-1110f3c1be85" providerId="ADAL" clId="{1A0C98BE-4594-2A42-8F09-E2BB07B25A05}" dt="2022-04-21T01:21:42.311" v="2312" actId="1036"/>
          <ac:cxnSpMkLst>
            <pc:docMk/>
            <pc:sldMk cId="1997077850" sldId="279"/>
            <ac:cxnSpMk id="273" creationId="{39F6224B-BDD2-4F4E-8CDC-0638BD759875}"/>
          </ac:cxnSpMkLst>
        </pc:cxnChg>
      </pc:sldChg>
      <pc:sldChg chg="add">
        <pc:chgData name="Wencai Zhang" userId="4a86a1d0-2108-4707-8228-1110f3c1be85" providerId="ADAL" clId="{1A0C98BE-4594-2A42-8F09-E2BB07B25A05}" dt="2022-04-21T00:55:11.230" v="1184"/>
        <pc:sldMkLst>
          <pc:docMk/>
          <pc:sldMk cId="2865805187" sldId="294"/>
        </pc:sldMkLst>
      </pc:sldChg>
    </pc:docChg>
  </pc:docChgLst>
  <pc:docChgLst>
    <pc:chgData name="Wencai Zhang" userId="4a86a1d0-2108-4707-8228-1110f3c1be85" providerId="ADAL" clId="{E2A8B6DA-8827-0C46-90CC-326C4459EA46}"/>
    <pc:docChg chg="undo custSel addSld delSld modSld sldOrd">
      <pc:chgData name="Wencai Zhang" userId="4a86a1d0-2108-4707-8228-1110f3c1be85" providerId="ADAL" clId="{E2A8B6DA-8827-0C46-90CC-326C4459EA46}" dt="2021-06-16T14:23:38.802" v="4663" actId="20577"/>
      <pc:docMkLst>
        <pc:docMk/>
      </pc:docMkLst>
      <pc:sldChg chg="addSp delSp modSp del">
        <pc:chgData name="Wencai Zhang" userId="4a86a1d0-2108-4707-8228-1110f3c1be85" providerId="ADAL" clId="{E2A8B6DA-8827-0C46-90CC-326C4459EA46}" dt="2021-06-16T14:18:23.917" v="4489" actId="2696"/>
        <pc:sldMkLst>
          <pc:docMk/>
          <pc:sldMk cId="3242017852" sldId="272"/>
        </pc:sldMkLst>
        <pc:spChg chg="mod">
          <ac:chgData name="Wencai Zhang" userId="4a86a1d0-2108-4707-8228-1110f3c1be85" providerId="ADAL" clId="{E2A8B6DA-8827-0C46-90CC-326C4459EA46}" dt="2021-06-08T14:02:05.611" v="581" actId="20577"/>
          <ac:spMkLst>
            <pc:docMk/>
            <pc:sldMk cId="3242017852" sldId="272"/>
            <ac:spMk id="71" creationId="{9B63982C-9423-B641-9499-4AB2C87BF98E}"/>
          </ac:spMkLst>
        </pc:spChg>
        <pc:spChg chg="mod">
          <ac:chgData name="Wencai Zhang" userId="4a86a1d0-2108-4707-8228-1110f3c1be85" providerId="ADAL" clId="{E2A8B6DA-8827-0C46-90CC-326C4459EA46}" dt="2021-06-08T14:12:13.581" v="747" actId="20577"/>
          <ac:spMkLst>
            <pc:docMk/>
            <pc:sldMk cId="3242017852" sldId="272"/>
            <ac:spMk id="86" creationId="{00000000-0000-0000-0000-000000000000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98" creationId="{8CBD07ED-64F1-FC4C-9D72-D2A2234C2AEE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99" creationId="{55C40B1B-13C4-5D4D-99E2-57029F2A0929}"/>
          </ac:spMkLst>
        </pc:spChg>
        <pc:spChg chg="add del mod">
          <ac:chgData name="Wencai Zhang" userId="4a86a1d0-2108-4707-8228-1110f3c1be85" providerId="ADAL" clId="{E2A8B6DA-8827-0C46-90CC-326C4459EA46}" dt="2021-06-08T13:32:55.347" v="70" actId="478"/>
          <ac:spMkLst>
            <pc:docMk/>
            <pc:sldMk cId="3242017852" sldId="272"/>
            <ac:spMk id="100" creationId="{FE1D4D2E-CBC2-1045-A775-FFFD42315435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1" creationId="{34FB853B-1D1D-3945-A885-41C7FC5F024A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2" creationId="{8E3D140E-2318-EF4F-AD04-CC190851465E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4" creationId="{D32393F7-CA76-E141-8865-300CA418CC5D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6" creationId="{4C582E78-BA6E-E546-A545-8769093B7824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7" creationId="{CA7B6F31-2F57-BA4F-B59C-817FA9DB9FE8}"/>
          </ac:spMkLst>
        </pc:spChg>
        <pc:spChg chg="add del mod">
          <ac:chgData name="Wencai Zhang" userId="4a86a1d0-2108-4707-8228-1110f3c1be85" providerId="ADAL" clId="{E2A8B6DA-8827-0C46-90CC-326C4459EA46}" dt="2021-06-08T14:01:45.517" v="576" actId="478"/>
          <ac:spMkLst>
            <pc:docMk/>
            <pc:sldMk cId="3242017852" sldId="272"/>
            <ac:spMk id="108" creationId="{9B33FD02-DFD9-6A44-BBBE-EC4BA3BF6B13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09" creationId="{A87961EC-E7C5-4C41-852E-AE3904FC625F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0" creationId="{51BC3C53-A978-FA4C-AEEC-56FE213206C6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2" creationId="{E0910A90-54EB-7A45-9517-4B0703388094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4" creationId="{8A9D620C-EFB4-5848-915D-B83A0EAEC30C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5" creationId="{861980F4-92A8-8D48-849A-B5F1DD98E5EB}"/>
          </ac:spMkLst>
        </pc:spChg>
        <pc:spChg chg="add mod">
          <ac:chgData name="Wencai Zhang" userId="4a86a1d0-2108-4707-8228-1110f3c1be85" providerId="ADAL" clId="{E2A8B6DA-8827-0C46-90CC-326C4459EA46}" dt="2021-06-08T14:01:50.965" v="578" actId="164"/>
          <ac:spMkLst>
            <pc:docMk/>
            <pc:sldMk cId="3242017852" sldId="272"/>
            <ac:spMk id="116" creationId="{F0E74AA7-10D5-6047-A22B-02E4B0C8D5F8}"/>
          </ac:spMkLst>
        </pc:spChg>
        <pc:spChg chg="add mod">
          <ac:chgData name="Wencai Zhang" userId="4a86a1d0-2108-4707-8228-1110f3c1be85" providerId="ADAL" clId="{E2A8B6DA-8827-0C46-90CC-326C4459EA46}" dt="2021-06-08T15:18:54.769" v="810" actId="1076"/>
          <ac:spMkLst>
            <pc:docMk/>
            <pc:sldMk cId="3242017852" sldId="272"/>
            <ac:spMk id="118" creationId="{C08858EC-7EBE-3246-B2A7-933D5AD8B609}"/>
          </ac:spMkLst>
        </pc:spChg>
        <pc:spChg chg="mod">
          <ac:chgData name="Wencai Zhang" userId="4a86a1d0-2108-4707-8228-1110f3c1be85" providerId="ADAL" clId="{E2A8B6DA-8827-0C46-90CC-326C4459EA46}" dt="2021-06-08T13:33:08.881" v="73" actId="1076"/>
          <ac:spMkLst>
            <pc:docMk/>
            <pc:sldMk cId="3242017852" sldId="272"/>
            <ac:spMk id="237" creationId="{EDCFD7CC-11F9-934C-BC9A-B9EA0F24D49B}"/>
          </ac:spMkLst>
        </pc:spChg>
        <pc:grpChg chg="add mod">
          <ac:chgData name="Wencai Zhang" userId="4a86a1d0-2108-4707-8228-1110f3c1be85" providerId="ADAL" clId="{E2A8B6DA-8827-0C46-90CC-326C4459EA46}" dt="2021-06-08T14:01:57.083" v="579" actId="1076"/>
          <ac:grpSpMkLst>
            <pc:docMk/>
            <pc:sldMk cId="3242017852" sldId="272"/>
            <ac:grpSpMk id="3" creationId="{ED7158F8-7588-FD41-903B-3AC0BBBCFFCF}"/>
          </ac:grpSpMkLst>
        </pc:grpChg>
        <pc:grpChg chg="mod">
          <ac:chgData name="Wencai Zhang" userId="4a86a1d0-2108-4707-8228-1110f3c1be85" providerId="ADAL" clId="{E2A8B6DA-8827-0C46-90CC-326C4459EA46}" dt="2021-06-08T14:02:27.986" v="582" actId="1076"/>
          <ac:grpSpMkLst>
            <pc:docMk/>
            <pc:sldMk cId="3242017852" sldId="272"/>
            <ac:grpSpMk id="317" creationId="{9E41850B-428F-AD48-A0A5-55EE77FE1719}"/>
          </ac:grpSpMkLst>
        </pc:grpChg>
        <pc:picChg chg="add del mod">
          <ac:chgData name="Wencai Zhang" userId="4a86a1d0-2108-4707-8228-1110f3c1be85" providerId="ADAL" clId="{E2A8B6DA-8827-0C46-90CC-326C4459EA46}" dt="2021-06-08T14:01:45.517" v="576" actId="478"/>
          <ac:picMkLst>
            <pc:docMk/>
            <pc:sldMk cId="3242017852" sldId="272"/>
            <ac:picMk id="103" creationId="{54DD671F-35A7-BD4F-AFA4-C4B6F6922EDB}"/>
          </ac:picMkLst>
        </pc:picChg>
        <pc:picChg chg="add del mod">
          <ac:chgData name="Wencai Zhang" userId="4a86a1d0-2108-4707-8228-1110f3c1be85" providerId="ADAL" clId="{E2A8B6DA-8827-0C46-90CC-326C4459EA46}" dt="2021-06-08T14:01:45.517" v="576" actId="478"/>
          <ac:picMkLst>
            <pc:docMk/>
            <pc:sldMk cId="3242017852" sldId="272"/>
            <ac:picMk id="105" creationId="{38C6832B-77B1-6748-87D7-7D7CBB8C9F14}"/>
          </ac:picMkLst>
        </pc:picChg>
        <pc:picChg chg="add mod">
          <ac:chgData name="Wencai Zhang" userId="4a86a1d0-2108-4707-8228-1110f3c1be85" providerId="ADAL" clId="{E2A8B6DA-8827-0C46-90CC-326C4459EA46}" dt="2021-06-08T14:01:50.965" v="578" actId="164"/>
          <ac:picMkLst>
            <pc:docMk/>
            <pc:sldMk cId="3242017852" sldId="272"/>
            <ac:picMk id="111" creationId="{B985929D-7AF8-424F-9D18-AB1D3C0E456F}"/>
          </ac:picMkLst>
        </pc:picChg>
        <pc:picChg chg="add mod">
          <ac:chgData name="Wencai Zhang" userId="4a86a1d0-2108-4707-8228-1110f3c1be85" providerId="ADAL" clId="{E2A8B6DA-8827-0C46-90CC-326C4459EA46}" dt="2021-06-08T14:01:50.965" v="578" actId="164"/>
          <ac:picMkLst>
            <pc:docMk/>
            <pc:sldMk cId="3242017852" sldId="272"/>
            <ac:picMk id="113" creationId="{912E6637-1C20-0E42-8C93-11FE70FB8395}"/>
          </ac:picMkLst>
        </pc:picChg>
      </pc:sldChg>
      <pc:sldChg chg="del">
        <pc:chgData name="Wencai Zhang" userId="4a86a1d0-2108-4707-8228-1110f3c1be85" providerId="ADAL" clId="{E2A8B6DA-8827-0C46-90CC-326C4459EA46}" dt="2021-06-16T14:18:09.934" v="4487" actId="2696"/>
        <pc:sldMkLst>
          <pc:docMk/>
          <pc:sldMk cId="3709575207" sldId="273"/>
        </pc:sldMkLst>
      </pc:sldChg>
      <pc:sldChg chg="del">
        <pc:chgData name="Wencai Zhang" userId="4a86a1d0-2108-4707-8228-1110f3c1be85" providerId="ADAL" clId="{E2A8B6DA-8827-0C46-90CC-326C4459EA46}" dt="2021-06-16T14:18:09.873" v="4486" actId="2696"/>
        <pc:sldMkLst>
          <pc:docMk/>
          <pc:sldMk cId="1245431894" sldId="274"/>
        </pc:sldMkLst>
      </pc:sldChg>
      <pc:sldChg chg="addSp delSp modSp add del ord">
        <pc:chgData name="Wencai Zhang" userId="4a86a1d0-2108-4707-8228-1110f3c1be85" providerId="ADAL" clId="{E2A8B6DA-8827-0C46-90CC-326C4459EA46}" dt="2021-06-10T16:07:56.928" v="3710" actId="2696"/>
        <pc:sldMkLst>
          <pc:docMk/>
          <pc:sldMk cId="1939339040" sldId="275"/>
        </pc:sldMkLst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5" creationId="{A14DCC92-3781-2B4B-83FC-B4FA8E3ED01A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7" creationId="{F7B64FFE-149B-DA4F-BC07-A703D744398B}"/>
          </ac:spMkLst>
        </pc:spChg>
        <pc:spChg chg="del mod">
          <ac:chgData name="Wencai Zhang" userId="4a86a1d0-2108-4707-8228-1110f3c1be85" providerId="ADAL" clId="{E2A8B6DA-8827-0C46-90CC-326C4459EA46}" dt="2021-06-08T14:13:59.072" v="793" actId="478"/>
          <ac:spMkLst>
            <pc:docMk/>
            <pc:sldMk cId="1939339040" sldId="275"/>
            <ac:spMk id="8" creationId="{49B5EA8F-0046-7848-B892-F1552D802D6F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0" creationId="{85645E7A-20F4-2D41-ABD5-3E0285FE36A2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2" creationId="{2C2518B1-A002-2949-81EA-F499A0923506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3" creationId="{B237090F-C43E-904F-95A5-8B9FEB742FB9}"/>
          </ac:spMkLst>
        </pc:spChg>
        <pc:spChg chg="del">
          <ac:chgData name="Wencai Zhang" userId="4a86a1d0-2108-4707-8228-1110f3c1be85" providerId="ADAL" clId="{E2A8B6DA-8827-0C46-90CC-326C4459EA46}" dt="2021-06-08T14:13:55.788" v="791" actId="478"/>
          <ac:spMkLst>
            <pc:docMk/>
            <pc:sldMk cId="1939339040" sldId="275"/>
            <ac:spMk id="14" creationId="{48CD3953-487F-A842-8D9A-0F8BAF5B3E70}"/>
          </ac:spMkLst>
        </pc:spChg>
        <pc:spChg chg="mod">
          <ac:chgData name="Wencai Zhang" userId="4a86a1d0-2108-4707-8228-1110f3c1be85" providerId="ADAL" clId="{E2A8B6DA-8827-0C46-90CC-326C4459EA46}" dt="2021-06-08T14:13:29.688" v="786" actId="20577"/>
          <ac:spMkLst>
            <pc:docMk/>
            <pc:sldMk cId="1939339040" sldId="275"/>
            <ac:spMk id="32" creationId="{3E547D2F-565F-A84D-A2CA-22C354291393}"/>
          </ac:spMkLst>
        </pc:spChg>
        <pc:spChg chg="add mod">
          <ac:chgData name="Wencai Zhang" userId="4a86a1d0-2108-4707-8228-1110f3c1be85" providerId="ADAL" clId="{E2A8B6DA-8827-0C46-90CC-326C4459EA46}" dt="2021-06-08T14:13:23.175" v="784" actId="1037"/>
          <ac:spMkLst>
            <pc:docMk/>
            <pc:sldMk cId="1939339040" sldId="275"/>
            <ac:spMk id="33" creationId="{CEA624C1-1221-BC49-A143-8E4CFF8B66F4}"/>
          </ac:spMkLst>
        </pc:spChg>
        <pc:spChg chg="add mod">
          <ac:chgData name="Wencai Zhang" userId="4a86a1d0-2108-4707-8228-1110f3c1be85" providerId="ADAL" clId="{E2A8B6DA-8827-0C46-90CC-326C4459EA46}" dt="2021-06-08T14:13:02.452" v="761" actId="1035"/>
          <ac:spMkLst>
            <pc:docMk/>
            <pc:sldMk cId="1939339040" sldId="275"/>
            <ac:spMk id="34" creationId="{E0DFD16F-74D2-A54D-9BBA-F47CA120E99E}"/>
          </ac:spMkLst>
        </pc:spChg>
        <pc:spChg chg="add mod">
          <ac:chgData name="Wencai Zhang" userId="4a86a1d0-2108-4707-8228-1110f3c1be85" providerId="ADAL" clId="{E2A8B6DA-8827-0C46-90CC-326C4459EA46}" dt="2021-06-08T14:13:39.565" v="790" actId="20577"/>
          <ac:spMkLst>
            <pc:docMk/>
            <pc:sldMk cId="1939339040" sldId="275"/>
            <ac:spMk id="35" creationId="{E8B40CD3-5131-344E-9652-E3E0972A75A1}"/>
          </ac:spMkLst>
        </pc:spChg>
        <pc:picChg chg="del">
          <ac:chgData name="Wencai Zhang" userId="4a86a1d0-2108-4707-8228-1110f3c1be85" providerId="ADAL" clId="{E2A8B6DA-8827-0C46-90CC-326C4459EA46}" dt="2021-06-08T14:13:55.788" v="791" actId="478"/>
          <ac:picMkLst>
            <pc:docMk/>
            <pc:sldMk cId="1939339040" sldId="275"/>
            <ac:picMk id="9" creationId="{A310120B-4A52-B34A-BC9E-6F51464EC6F5}"/>
          </ac:picMkLst>
        </pc:picChg>
        <pc:picChg chg="del">
          <ac:chgData name="Wencai Zhang" userId="4a86a1d0-2108-4707-8228-1110f3c1be85" providerId="ADAL" clId="{E2A8B6DA-8827-0C46-90CC-326C4459EA46}" dt="2021-06-08T14:13:55.788" v="791" actId="478"/>
          <ac:picMkLst>
            <pc:docMk/>
            <pc:sldMk cId="1939339040" sldId="275"/>
            <ac:picMk id="11" creationId="{F7D1E114-4C9D-964B-A033-877096F683EB}"/>
          </ac:picMkLst>
        </pc:picChg>
      </pc:sldChg>
      <pc:sldChg chg="addSp delSp modSp del">
        <pc:chgData name="Wencai Zhang" userId="4a86a1d0-2108-4707-8228-1110f3c1be85" providerId="ADAL" clId="{E2A8B6DA-8827-0C46-90CC-326C4459EA46}" dt="2021-06-08T14:03:38.636" v="625" actId="2696"/>
        <pc:sldMkLst>
          <pc:docMk/>
          <pc:sldMk cId="2222079663" sldId="275"/>
        </pc:sldMkLst>
        <pc:spChg chg="add del mod">
          <ac:chgData name="Wencai Zhang" userId="4a86a1d0-2108-4707-8228-1110f3c1be85" providerId="ADAL" clId="{E2A8B6DA-8827-0C46-90CC-326C4459EA46}" dt="2021-06-08T13:50:45.726" v="376" actId="478"/>
          <ac:spMkLst>
            <pc:docMk/>
            <pc:sldMk cId="2222079663" sldId="275"/>
            <ac:spMk id="3" creationId="{2E95D281-7654-134C-818D-9946E8534055}"/>
          </ac:spMkLst>
        </pc:spChg>
        <pc:spChg chg="add del mod">
          <ac:chgData name="Wencai Zhang" userId="4a86a1d0-2108-4707-8228-1110f3c1be85" providerId="ADAL" clId="{E2A8B6DA-8827-0C46-90CC-326C4459EA46}" dt="2021-06-08T13:50:45.726" v="376" actId="478"/>
          <ac:spMkLst>
            <pc:docMk/>
            <pc:sldMk cId="2222079663" sldId="275"/>
            <ac:spMk id="4" creationId="{8AAD750B-EDB2-EF4D-A688-97A0B5030957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5" creationId="{A14DCC92-3781-2B4B-83FC-B4FA8E3ED01A}"/>
          </ac:spMkLst>
        </pc:spChg>
        <pc:spChg chg="add del mod">
          <ac:chgData name="Wencai Zhang" userId="4a86a1d0-2108-4707-8228-1110f3c1be85" providerId="ADAL" clId="{E2A8B6DA-8827-0C46-90CC-326C4459EA46}" dt="2021-06-08T13:59:38.864" v="547" actId="478"/>
          <ac:spMkLst>
            <pc:docMk/>
            <pc:sldMk cId="2222079663" sldId="275"/>
            <ac:spMk id="6" creationId="{4BB66FCC-5AE7-7D4D-9BE2-DC76615A264D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7" creationId="{F7B64FFE-149B-DA4F-BC07-A703D744398B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8" creationId="{49B5EA8F-0046-7848-B892-F1552D802D6F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0" creationId="{85645E7A-20F4-2D41-ABD5-3E0285FE36A2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2" creationId="{2C2518B1-A002-2949-81EA-F499A0923506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3" creationId="{B237090F-C43E-904F-95A5-8B9FEB742FB9}"/>
          </ac:spMkLst>
        </pc:spChg>
        <pc:spChg chg="add mod">
          <ac:chgData name="Wencai Zhang" userId="4a86a1d0-2108-4707-8228-1110f3c1be85" providerId="ADAL" clId="{E2A8B6DA-8827-0C46-90CC-326C4459EA46}" dt="2021-06-08T13:53:29.033" v="387" actId="1076"/>
          <ac:spMkLst>
            <pc:docMk/>
            <pc:sldMk cId="2222079663" sldId="275"/>
            <ac:spMk id="14" creationId="{48CD3953-487F-A842-8D9A-0F8BAF5B3E70}"/>
          </ac:spMkLst>
        </pc:spChg>
        <pc:spChg chg="add del mod">
          <ac:chgData name="Wencai Zhang" userId="4a86a1d0-2108-4707-8228-1110f3c1be85" providerId="ADAL" clId="{E2A8B6DA-8827-0C46-90CC-326C4459EA46}" dt="2021-06-08T13:57:21.355" v="479" actId="478"/>
          <ac:spMkLst>
            <pc:docMk/>
            <pc:sldMk cId="2222079663" sldId="275"/>
            <ac:spMk id="16" creationId="{094892F7-FB5A-4042-BBA1-F4F4FCE6F7DD}"/>
          </ac:spMkLst>
        </pc:spChg>
        <pc:spChg chg="add del mod">
          <ac:chgData name="Wencai Zhang" userId="4a86a1d0-2108-4707-8228-1110f3c1be85" providerId="ADAL" clId="{E2A8B6DA-8827-0C46-90CC-326C4459EA46}" dt="2021-06-08T13:57:21.355" v="479" actId="478"/>
          <ac:spMkLst>
            <pc:docMk/>
            <pc:sldMk cId="2222079663" sldId="275"/>
            <ac:spMk id="17" creationId="{600EC027-46FE-E34C-9960-70FF9A456D64}"/>
          </ac:spMkLst>
        </pc:spChg>
        <pc:spChg chg="add del mod">
          <ac:chgData name="Wencai Zhang" userId="4a86a1d0-2108-4707-8228-1110f3c1be85" providerId="ADAL" clId="{E2A8B6DA-8827-0C46-90CC-326C4459EA46}" dt="2021-06-08T13:56:07.037" v="417" actId="478"/>
          <ac:spMkLst>
            <pc:docMk/>
            <pc:sldMk cId="2222079663" sldId="275"/>
            <ac:spMk id="19" creationId="{3F4B935B-2757-1546-AA1C-DB7B5FF54294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0" creationId="{FA96DC20-EDBD-7341-9177-7FA923904D43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1" creationId="{4519CED9-A862-0D44-AB8F-436395CF39BE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2" creationId="{A2E04F8F-9935-E34E-AC08-AE7AC9B0FF9D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3" creationId="{95FD9F0A-26F5-4149-89EC-4E909A353725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4" creationId="{BF95736E-AF10-6E42-89C3-BC9C45E298BB}"/>
          </ac:spMkLst>
        </pc:spChg>
        <pc:spChg chg="add mod">
          <ac:chgData name="Wencai Zhang" userId="4a86a1d0-2108-4707-8228-1110f3c1be85" providerId="ADAL" clId="{E2A8B6DA-8827-0C46-90CC-326C4459EA46}" dt="2021-06-08T14:00:05.508" v="549" actId="164"/>
          <ac:spMkLst>
            <pc:docMk/>
            <pc:sldMk cId="2222079663" sldId="275"/>
            <ac:spMk id="25" creationId="{F25CF819-ED37-974A-91A4-D7A8C843F386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6" creationId="{7F28199F-72D6-EA40-B672-2DFFD6F1F77A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7" creationId="{0502B03E-0263-074A-85C5-8948D8FA6F45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8" creationId="{C448F69F-1DF8-174F-BC9B-04ABFA1E100D}"/>
          </ac:spMkLst>
        </pc:spChg>
        <pc:spChg chg="add mod">
          <ac:chgData name="Wencai Zhang" userId="4a86a1d0-2108-4707-8228-1110f3c1be85" providerId="ADAL" clId="{E2A8B6DA-8827-0C46-90CC-326C4459EA46}" dt="2021-06-08T13:59:54.641" v="548" actId="164"/>
          <ac:spMkLst>
            <pc:docMk/>
            <pc:sldMk cId="2222079663" sldId="275"/>
            <ac:spMk id="29" creationId="{911DA5AF-E904-C141-A61B-0776CBA0C870}"/>
          </ac:spMkLst>
        </pc:spChg>
        <pc:spChg chg="add mod">
          <ac:chgData name="Wencai Zhang" userId="4a86a1d0-2108-4707-8228-1110f3c1be85" providerId="ADAL" clId="{E2A8B6DA-8827-0C46-90CC-326C4459EA46}" dt="2021-06-08T14:03:35.677" v="624" actId="1076"/>
          <ac:spMkLst>
            <pc:docMk/>
            <pc:sldMk cId="2222079663" sldId="275"/>
            <ac:spMk id="32" creationId="{3E547D2F-565F-A84D-A2CA-22C354291393}"/>
          </ac:spMkLst>
        </pc:spChg>
        <pc:grpChg chg="add mod">
          <ac:chgData name="Wencai Zhang" userId="4a86a1d0-2108-4707-8228-1110f3c1be85" providerId="ADAL" clId="{E2A8B6DA-8827-0C46-90CC-326C4459EA46}" dt="2021-06-08T14:01:31.814" v="575" actId="1038"/>
          <ac:grpSpMkLst>
            <pc:docMk/>
            <pc:sldMk cId="2222079663" sldId="275"/>
            <ac:grpSpMk id="30" creationId="{4C2F5E41-1829-A144-AC15-D2A2437327F8}"/>
          </ac:grpSpMkLst>
        </pc:grpChg>
        <pc:grpChg chg="add mod">
          <ac:chgData name="Wencai Zhang" userId="4a86a1d0-2108-4707-8228-1110f3c1be85" providerId="ADAL" clId="{E2A8B6DA-8827-0C46-90CC-326C4459EA46}" dt="2021-06-08T14:01:28.732" v="566" actId="1037"/>
          <ac:grpSpMkLst>
            <pc:docMk/>
            <pc:sldMk cId="2222079663" sldId="275"/>
            <ac:grpSpMk id="31" creationId="{3BFBB084-5CE7-8F41-A2EF-B6E2D67C36D2}"/>
          </ac:grpSpMkLst>
        </pc:grpChg>
        <pc:picChg chg="add del mod">
          <ac:chgData name="Wencai Zhang" userId="4a86a1d0-2108-4707-8228-1110f3c1be85" providerId="ADAL" clId="{E2A8B6DA-8827-0C46-90CC-326C4459EA46}" dt="2021-06-08T13:50:45.726" v="376" actId="478"/>
          <ac:picMkLst>
            <pc:docMk/>
            <pc:sldMk cId="2222079663" sldId="275"/>
            <ac:picMk id="2" creationId="{64140709-368B-3740-879C-36AA6C194909}"/>
          </ac:picMkLst>
        </pc:picChg>
        <pc:picChg chg="add mod">
          <ac:chgData name="Wencai Zhang" userId="4a86a1d0-2108-4707-8228-1110f3c1be85" providerId="ADAL" clId="{E2A8B6DA-8827-0C46-90CC-326C4459EA46}" dt="2021-06-08T13:59:02.155" v="512"/>
          <ac:picMkLst>
            <pc:docMk/>
            <pc:sldMk cId="2222079663" sldId="275"/>
            <ac:picMk id="9" creationId="{A310120B-4A52-B34A-BC9E-6F51464EC6F5}"/>
          </ac:picMkLst>
        </pc:picChg>
        <pc:picChg chg="add mod">
          <ac:chgData name="Wencai Zhang" userId="4a86a1d0-2108-4707-8228-1110f3c1be85" providerId="ADAL" clId="{E2A8B6DA-8827-0C46-90CC-326C4459EA46}" dt="2021-06-08T13:59:18.951" v="546"/>
          <ac:picMkLst>
            <pc:docMk/>
            <pc:sldMk cId="2222079663" sldId="275"/>
            <ac:picMk id="11" creationId="{F7D1E114-4C9D-964B-A033-877096F683EB}"/>
          </ac:picMkLst>
        </pc:picChg>
        <pc:picChg chg="add mod modCrop">
          <ac:chgData name="Wencai Zhang" userId="4a86a1d0-2108-4707-8228-1110f3c1be85" providerId="ADAL" clId="{E2A8B6DA-8827-0C46-90CC-326C4459EA46}" dt="2021-06-08T14:00:38.042" v="553" actId="732"/>
          <ac:picMkLst>
            <pc:docMk/>
            <pc:sldMk cId="2222079663" sldId="275"/>
            <ac:picMk id="15" creationId="{49C793B9-0D56-9948-A388-E4A900C461AF}"/>
          </ac:picMkLst>
        </pc:picChg>
        <pc:picChg chg="add mod modCrop">
          <ac:chgData name="Wencai Zhang" userId="4a86a1d0-2108-4707-8228-1110f3c1be85" providerId="ADAL" clId="{E2A8B6DA-8827-0C46-90CC-326C4459EA46}" dt="2021-06-08T14:00:58.909" v="554" actId="732"/>
          <ac:picMkLst>
            <pc:docMk/>
            <pc:sldMk cId="2222079663" sldId="275"/>
            <ac:picMk id="18" creationId="{3BFB62E5-6614-0C43-91AE-0AA037616993}"/>
          </ac:picMkLst>
        </pc:picChg>
      </pc:sldChg>
      <pc:sldChg chg="addSp delSp modSp add">
        <pc:chgData name="Wencai Zhang" userId="4a86a1d0-2108-4707-8228-1110f3c1be85" providerId="ADAL" clId="{E2A8B6DA-8827-0C46-90CC-326C4459EA46}" dt="2021-06-16T14:19:50.178" v="4501" actId="20577"/>
        <pc:sldMkLst>
          <pc:docMk/>
          <pc:sldMk cId="2771812490" sldId="275"/>
        </pc:sldMkLst>
        <pc:spChg chg="mod">
          <ac:chgData name="Wencai Zhang" userId="4a86a1d0-2108-4707-8228-1110f3c1be85" providerId="ADAL" clId="{E2A8B6DA-8827-0C46-90CC-326C4459EA46}" dt="2021-06-10T16:35:30.910" v="3836" actId="1035"/>
          <ac:spMkLst>
            <pc:docMk/>
            <pc:sldMk cId="2771812490" sldId="275"/>
            <ac:spMk id="28" creationId="{C448F69F-1DF8-174F-BC9B-04ABFA1E100D}"/>
          </ac:spMkLst>
        </pc:spChg>
        <pc:spChg chg="mod">
          <ac:chgData name="Wencai Zhang" userId="4a86a1d0-2108-4707-8228-1110f3c1be85" providerId="ADAL" clId="{E2A8B6DA-8827-0C46-90CC-326C4459EA46}" dt="2021-06-10T16:35:30.910" v="3836" actId="1035"/>
          <ac:spMkLst>
            <pc:docMk/>
            <pc:sldMk cId="2771812490" sldId="275"/>
            <ac:spMk id="29" creationId="{911DA5AF-E904-C141-A61B-0776CBA0C870}"/>
          </ac:spMkLst>
        </pc:spChg>
        <pc:spChg chg="mod">
          <ac:chgData name="Wencai Zhang" userId="4a86a1d0-2108-4707-8228-1110f3c1be85" providerId="ADAL" clId="{E2A8B6DA-8827-0C46-90CC-326C4459EA46}" dt="2021-06-16T14:19:50.178" v="4501" actId="20577"/>
          <ac:spMkLst>
            <pc:docMk/>
            <pc:sldMk cId="2771812490" sldId="275"/>
            <ac:spMk id="32" creationId="{3E547D2F-565F-A84D-A2CA-22C354291393}"/>
          </ac:spMkLst>
        </pc:spChg>
        <pc:spChg chg="mod">
          <ac:chgData name="Wencai Zhang" userId="4a86a1d0-2108-4707-8228-1110f3c1be85" providerId="ADAL" clId="{E2A8B6DA-8827-0C46-90CC-326C4459EA46}" dt="2021-06-10T17:00:41.823" v="3919" actId="164"/>
          <ac:spMkLst>
            <pc:docMk/>
            <pc:sldMk cId="2771812490" sldId="275"/>
            <ac:spMk id="33" creationId="{CEA624C1-1221-BC49-A143-8E4CFF8B66F4}"/>
          </ac:spMkLst>
        </pc:spChg>
        <pc:spChg chg="mod">
          <ac:chgData name="Wencai Zhang" userId="4a86a1d0-2108-4707-8228-1110f3c1be85" providerId="ADAL" clId="{E2A8B6DA-8827-0C46-90CC-326C4459EA46}" dt="2021-06-10T17:00:41.823" v="3919" actId="164"/>
          <ac:spMkLst>
            <pc:docMk/>
            <pc:sldMk cId="2771812490" sldId="275"/>
            <ac:spMk id="34" creationId="{E0DFD16F-74D2-A54D-9BBA-F47CA120E99E}"/>
          </ac:spMkLst>
        </pc:spChg>
        <pc:spChg chg="del">
          <ac:chgData name="Wencai Zhang" userId="4a86a1d0-2108-4707-8228-1110f3c1be85" providerId="ADAL" clId="{E2A8B6DA-8827-0C46-90CC-326C4459EA46}" dt="2021-06-10T17:00:23.571" v="3918" actId="478"/>
          <ac:spMkLst>
            <pc:docMk/>
            <pc:sldMk cId="2771812490" sldId="275"/>
            <ac:spMk id="35" creationId="{E8B40CD3-5131-344E-9652-E3E0972A75A1}"/>
          </ac:spMkLst>
        </pc:spChg>
        <pc:grpChg chg="add mod">
          <ac:chgData name="Wencai Zhang" userId="4a86a1d0-2108-4707-8228-1110f3c1be85" providerId="ADAL" clId="{E2A8B6DA-8827-0C46-90CC-326C4459EA46}" dt="2021-06-10T17:00:41.823" v="3919" actId="164"/>
          <ac:grpSpMkLst>
            <pc:docMk/>
            <pc:sldMk cId="2771812490" sldId="275"/>
            <ac:grpSpMk id="2" creationId="{44A38F47-97D3-0A4D-BCD9-2FD70A1DB48D}"/>
          </ac:grpSpMkLst>
        </pc:grpChg>
        <pc:grpChg chg="mod">
          <ac:chgData name="Wencai Zhang" userId="4a86a1d0-2108-4707-8228-1110f3c1be85" providerId="ADAL" clId="{E2A8B6DA-8827-0C46-90CC-326C4459EA46}" dt="2021-06-10T17:00:41.823" v="3919" actId="164"/>
          <ac:grpSpMkLst>
            <pc:docMk/>
            <pc:sldMk cId="2771812490" sldId="275"/>
            <ac:grpSpMk id="30" creationId="{4C2F5E41-1829-A144-AC15-D2A2437327F8}"/>
          </ac:grpSpMkLst>
        </pc:grpChg>
        <pc:grpChg chg="mod">
          <ac:chgData name="Wencai Zhang" userId="4a86a1d0-2108-4707-8228-1110f3c1be85" providerId="ADAL" clId="{E2A8B6DA-8827-0C46-90CC-326C4459EA46}" dt="2021-06-10T17:00:41.823" v="3919" actId="164"/>
          <ac:grpSpMkLst>
            <pc:docMk/>
            <pc:sldMk cId="2771812490" sldId="275"/>
            <ac:grpSpMk id="31" creationId="{3BFBB084-5CE7-8F41-A2EF-B6E2D67C36D2}"/>
          </ac:grpSpMkLst>
        </pc:grpChg>
        <pc:picChg chg="add mod modCrop">
          <ac:chgData name="Wencai Zhang" userId="4a86a1d0-2108-4707-8228-1110f3c1be85" providerId="ADAL" clId="{E2A8B6DA-8827-0C46-90CC-326C4459EA46}" dt="2021-06-10T17:00:41.823" v="3919" actId="164"/>
          <ac:picMkLst>
            <pc:docMk/>
            <pc:sldMk cId="2771812490" sldId="275"/>
            <ac:picMk id="3" creationId="{838C87E9-E1E0-1C42-B55B-D40D7516F38C}"/>
          </ac:picMkLst>
        </pc:picChg>
        <pc:picChg chg="del mod modCrop">
          <ac:chgData name="Wencai Zhang" userId="4a86a1d0-2108-4707-8228-1110f3c1be85" providerId="ADAL" clId="{E2A8B6DA-8827-0C46-90CC-326C4459EA46}" dt="2021-06-10T16:35:21.697" v="3806" actId="478"/>
          <ac:picMkLst>
            <pc:docMk/>
            <pc:sldMk cId="2771812490" sldId="275"/>
            <ac:picMk id="15" creationId="{49C793B9-0D56-9948-A388-E4A900C461AF}"/>
          </ac:picMkLst>
        </pc:picChg>
      </pc:sldChg>
      <pc:sldChg chg="addSp modSp del">
        <pc:chgData name="Wencai Zhang" userId="4a86a1d0-2108-4707-8228-1110f3c1be85" providerId="ADAL" clId="{E2A8B6DA-8827-0C46-90CC-326C4459EA46}" dt="2021-06-16T14:18:21.977" v="4488" actId="2696"/>
        <pc:sldMkLst>
          <pc:docMk/>
          <pc:sldMk cId="2045228985" sldId="278"/>
        </pc:sldMkLst>
        <pc:spChg chg="add mod">
          <ac:chgData name="Wencai Zhang" userId="4a86a1d0-2108-4707-8228-1110f3c1be85" providerId="ADAL" clId="{E2A8B6DA-8827-0C46-90CC-326C4459EA46}" dt="2021-06-08T14:03:19.409" v="597" actId="20577"/>
          <ac:spMkLst>
            <pc:docMk/>
            <pc:sldMk cId="2045228985" sldId="278"/>
            <ac:spMk id="20" creationId="{60DCBE46-DA67-744B-B366-B1E9E1BECB5D}"/>
          </ac:spMkLst>
        </pc:spChg>
      </pc:sldChg>
      <pc:sldChg chg="add del ord">
        <pc:chgData name="Wencai Zhang" userId="4a86a1d0-2108-4707-8228-1110f3c1be85" providerId="ADAL" clId="{E2A8B6DA-8827-0C46-90CC-326C4459EA46}" dt="2021-06-08T14:02:58.782" v="586" actId="2696"/>
        <pc:sldMkLst>
          <pc:docMk/>
          <pc:sldMk cId="87383462" sldId="279"/>
        </pc:sldMkLst>
      </pc:sldChg>
      <pc:sldChg chg="addSp delSp modSp add ord">
        <pc:chgData name="Wencai Zhang" userId="4a86a1d0-2108-4707-8228-1110f3c1be85" providerId="ADAL" clId="{E2A8B6DA-8827-0C46-90CC-326C4459EA46}" dt="2021-06-16T14:17:37.405" v="4485" actId="478"/>
        <pc:sldMkLst>
          <pc:docMk/>
          <pc:sldMk cId="1997077850" sldId="279"/>
        </pc:sldMkLst>
        <pc:spChg chg="mod">
          <ac:chgData name="Wencai Zhang" userId="4a86a1d0-2108-4707-8228-1110f3c1be85" providerId="ADAL" clId="{E2A8B6DA-8827-0C46-90CC-326C4459EA46}" dt="2021-06-09T20:22:53.395" v="2592" actId="1035"/>
          <ac:spMkLst>
            <pc:docMk/>
            <pc:sldMk cId="1997077850" sldId="279"/>
            <ac:spMk id="3" creationId="{7C8F372B-FAE8-CE44-A95C-EFB214B632AE}"/>
          </ac:spMkLst>
        </pc:spChg>
        <pc:spChg chg="add mod topLvl">
          <ac:chgData name="Wencai Zhang" userId="4a86a1d0-2108-4707-8228-1110f3c1be85" providerId="ADAL" clId="{E2A8B6DA-8827-0C46-90CC-326C4459EA46}" dt="2021-06-10T16:00:46.465" v="3633" actId="164"/>
          <ac:spMkLst>
            <pc:docMk/>
            <pc:sldMk cId="1997077850" sldId="279"/>
            <ac:spMk id="4" creationId="{95DB8146-6CC5-F741-B46A-A5EEAEB4D010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6" creationId="{F3DB81E6-B77D-A343-8DE3-1FFFD129AA77}"/>
          </ac:spMkLst>
        </pc:spChg>
        <pc:spChg chg="add mod">
          <ac:chgData name="Wencai Zhang" userId="4a86a1d0-2108-4707-8228-1110f3c1be85" providerId="ADAL" clId="{E2A8B6DA-8827-0C46-90CC-326C4459EA46}" dt="2021-06-15T16:49:06.193" v="4235" actId="20577"/>
          <ac:spMkLst>
            <pc:docMk/>
            <pc:sldMk cId="1997077850" sldId="279"/>
            <ac:spMk id="7" creationId="{4ACF2E7E-671D-2F4E-95DD-D9C3675AA963}"/>
          </ac:spMkLst>
        </pc:spChg>
        <pc:spChg chg="add mod">
          <ac:chgData name="Wencai Zhang" userId="4a86a1d0-2108-4707-8228-1110f3c1be85" providerId="ADAL" clId="{E2A8B6DA-8827-0C46-90CC-326C4459EA46}" dt="2021-06-15T16:49:09.287" v="4238" actId="20577"/>
          <ac:spMkLst>
            <pc:docMk/>
            <pc:sldMk cId="1997077850" sldId="279"/>
            <ac:spMk id="9" creationId="{FA090E52-A893-CF42-A4D8-3792727F0876}"/>
          </ac:spMkLst>
        </pc:spChg>
        <pc:spChg chg="del">
          <ac:chgData name="Wencai Zhang" userId="4a86a1d0-2108-4707-8228-1110f3c1be85" providerId="ADAL" clId="{E2A8B6DA-8827-0C46-90CC-326C4459EA46}" dt="2021-06-08T14:04:15.085" v="640" actId="478"/>
          <ac:spMkLst>
            <pc:docMk/>
            <pc:sldMk cId="1997077850" sldId="279"/>
            <ac:spMk id="49" creationId="{5D84001A-23E1-004F-A600-14E854FA58C3}"/>
          </ac:spMkLst>
        </pc:spChg>
        <pc:spChg chg="mod">
          <ac:chgData name="Wencai Zhang" userId="4a86a1d0-2108-4707-8228-1110f3c1be85" providerId="ADAL" clId="{E2A8B6DA-8827-0C46-90CC-326C4459EA46}" dt="2021-06-08T14:06:47.267" v="664" actId="164"/>
          <ac:spMkLst>
            <pc:docMk/>
            <pc:sldMk cId="1997077850" sldId="279"/>
            <ac:spMk id="72" creationId="{223FA3D5-BA87-E34A-B4DF-9CC0D6406B71}"/>
          </ac:spMkLst>
        </pc:spChg>
        <pc:spChg chg="mod">
          <ac:chgData name="Wencai Zhang" userId="4a86a1d0-2108-4707-8228-1110f3c1be85" providerId="ADAL" clId="{E2A8B6DA-8827-0C46-90CC-326C4459EA46}" dt="2021-06-08T14:06:47.267" v="664" actId="164"/>
          <ac:spMkLst>
            <pc:docMk/>
            <pc:sldMk cId="1997077850" sldId="279"/>
            <ac:spMk id="73" creationId="{445E3C3A-3850-6D40-9AB1-17803152274D}"/>
          </ac:spMkLst>
        </pc:spChg>
        <pc:spChg chg="mod">
          <ac:chgData name="Wencai Zhang" userId="4a86a1d0-2108-4707-8228-1110f3c1be85" providerId="ADAL" clId="{E2A8B6DA-8827-0C46-90CC-326C4459EA46}" dt="2021-06-09T13:10:36.030" v="1767" actId="1038"/>
          <ac:spMkLst>
            <pc:docMk/>
            <pc:sldMk cId="1997077850" sldId="279"/>
            <ac:spMk id="74" creationId="{C2791ACA-8F61-A44C-8156-2E191958E5DD}"/>
          </ac:spMkLst>
        </pc:spChg>
        <pc:spChg chg="mod">
          <ac:chgData name="Wencai Zhang" userId="4a86a1d0-2108-4707-8228-1110f3c1be85" providerId="ADAL" clId="{E2A8B6DA-8827-0C46-90CC-326C4459EA46}" dt="2021-06-09T13:01:54.471" v="1516" actId="1037"/>
          <ac:spMkLst>
            <pc:docMk/>
            <pc:sldMk cId="1997077850" sldId="279"/>
            <ac:spMk id="75" creationId="{121DBF52-16E2-AD44-B39B-96DC93EEA8D3}"/>
          </ac:spMkLst>
        </pc:spChg>
        <pc:spChg chg="mod">
          <ac:chgData name="Wencai Zhang" userId="4a86a1d0-2108-4707-8228-1110f3c1be85" providerId="ADAL" clId="{E2A8B6DA-8827-0C46-90CC-326C4459EA46}" dt="2021-06-09T20:17:46.420" v="2531" actId="1035"/>
          <ac:spMkLst>
            <pc:docMk/>
            <pc:sldMk cId="1997077850" sldId="279"/>
            <ac:spMk id="79" creationId="{2D15FE00-0512-5944-9E83-41DD767BDEE6}"/>
          </ac:spMkLst>
        </pc:spChg>
        <pc:spChg chg="mod">
          <ac:chgData name="Wencai Zhang" userId="4a86a1d0-2108-4707-8228-1110f3c1be85" providerId="ADAL" clId="{E2A8B6DA-8827-0C46-90CC-326C4459EA46}" dt="2021-06-09T20:17:52.985" v="2541" actId="1037"/>
          <ac:spMkLst>
            <pc:docMk/>
            <pc:sldMk cId="1997077850" sldId="279"/>
            <ac:spMk id="82" creationId="{65C824D1-31F5-1F42-91B5-75152B73ACF6}"/>
          </ac:spMkLst>
        </pc:spChg>
        <pc:spChg chg="mod">
          <ac:chgData name="Wencai Zhang" userId="4a86a1d0-2108-4707-8228-1110f3c1be85" providerId="ADAL" clId="{E2A8B6DA-8827-0C46-90CC-326C4459EA46}" dt="2021-06-09T20:12:45.223" v="2476" actId="1035"/>
          <ac:spMkLst>
            <pc:docMk/>
            <pc:sldMk cId="1997077850" sldId="279"/>
            <ac:spMk id="88" creationId="{303924A6-833C-BF46-9BE8-918D6429D292}"/>
          </ac:spMkLst>
        </pc:spChg>
        <pc:spChg chg="mod">
          <ac:chgData name="Wencai Zhang" userId="4a86a1d0-2108-4707-8228-1110f3c1be85" providerId="ADAL" clId="{E2A8B6DA-8827-0C46-90CC-326C4459EA46}" dt="2021-06-09T13:09:31.378" v="1722" actId="20577"/>
          <ac:spMkLst>
            <pc:docMk/>
            <pc:sldMk cId="1997077850" sldId="279"/>
            <ac:spMk id="94" creationId="{6810EC88-3A39-D14A-87EF-0AE63E9D570A}"/>
          </ac:spMkLst>
        </pc:spChg>
        <pc:spChg chg="mod">
          <ac:chgData name="Wencai Zhang" userId="4a86a1d0-2108-4707-8228-1110f3c1be85" providerId="ADAL" clId="{E2A8B6DA-8827-0C46-90CC-326C4459EA46}" dt="2021-06-09T20:17:59.856" v="2548" actId="1035"/>
          <ac:spMkLst>
            <pc:docMk/>
            <pc:sldMk cId="1997077850" sldId="279"/>
            <ac:spMk id="104" creationId="{765F1389-2585-6C49-B504-8C2EA8B7897C}"/>
          </ac:spMkLst>
        </pc:spChg>
        <pc:spChg chg="mod">
          <ac:chgData name="Wencai Zhang" userId="4a86a1d0-2108-4707-8228-1110f3c1be85" providerId="ADAL" clId="{E2A8B6DA-8827-0C46-90CC-326C4459EA46}" dt="2021-06-09T20:17:59.856" v="2548" actId="1035"/>
          <ac:spMkLst>
            <pc:docMk/>
            <pc:sldMk cId="1997077850" sldId="279"/>
            <ac:spMk id="105" creationId="{83EBEEEE-9971-7842-9451-CBDBF8776B8E}"/>
          </ac:spMkLst>
        </pc:spChg>
        <pc:spChg chg="mod">
          <ac:chgData name="Wencai Zhang" userId="4a86a1d0-2108-4707-8228-1110f3c1be85" providerId="ADAL" clId="{E2A8B6DA-8827-0C46-90CC-326C4459EA46}" dt="2021-06-09T20:15:07.350" v="2511" actId="1035"/>
          <ac:spMkLst>
            <pc:docMk/>
            <pc:sldMk cId="1997077850" sldId="279"/>
            <ac:spMk id="110" creationId="{BFD65373-A8C1-3045-8262-BEBFB0F691F4}"/>
          </ac:spMkLst>
        </pc:spChg>
        <pc:spChg chg="mod">
          <ac:chgData name="Wencai Zhang" userId="4a86a1d0-2108-4707-8228-1110f3c1be85" providerId="ADAL" clId="{E2A8B6DA-8827-0C46-90CC-326C4459EA46}" dt="2021-06-09T13:09:48.444" v="1740" actId="20577"/>
          <ac:spMkLst>
            <pc:docMk/>
            <pc:sldMk cId="1997077850" sldId="279"/>
            <ac:spMk id="112" creationId="{79768528-A358-2D49-8809-E14A1220D416}"/>
          </ac:spMkLst>
        </pc:spChg>
        <pc:spChg chg="add mod topLvl">
          <ac:chgData name="Wencai Zhang" userId="4a86a1d0-2108-4707-8228-1110f3c1be85" providerId="ADAL" clId="{E2A8B6DA-8827-0C46-90CC-326C4459EA46}" dt="2021-06-15T16:37:04.536" v="3924" actId="1076"/>
          <ac:spMkLst>
            <pc:docMk/>
            <pc:sldMk cId="1997077850" sldId="279"/>
            <ac:spMk id="114" creationId="{1F05BE06-5426-114D-88A9-20E85CD03830}"/>
          </ac:spMkLst>
        </pc:spChg>
        <pc:spChg chg="mod">
          <ac:chgData name="Wencai Zhang" userId="4a86a1d0-2108-4707-8228-1110f3c1be85" providerId="ADAL" clId="{E2A8B6DA-8827-0C46-90CC-326C4459EA46}" dt="2021-06-09T13:16:28.786" v="1884" actId="1038"/>
          <ac:spMkLst>
            <pc:docMk/>
            <pc:sldMk cId="1997077850" sldId="279"/>
            <ac:spMk id="116" creationId="{8DD2498C-F0E3-6342-A0F5-25324F8FED73}"/>
          </ac:spMkLst>
        </pc:spChg>
        <pc:spChg chg="mod">
          <ac:chgData name="Wencai Zhang" userId="4a86a1d0-2108-4707-8228-1110f3c1be85" providerId="ADAL" clId="{E2A8B6DA-8827-0C46-90CC-326C4459EA46}" dt="2021-06-09T20:12:45.223" v="2476" actId="1035"/>
          <ac:spMkLst>
            <pc:docMk/>
            <pc:sldMk cId="1997077850" sldId="279"/>
            <ac:spMk id="117" creationId="{FC33CF33-548D-E946-924C-B09E79AF305A}"/>
          </ac:spMkLst>
        </pc:spChg>
        <pc:spChg chg="mod">
          <ac:chgData name="Wencai Zhang" userId="4a86a1d0-2108-4707-8228-1110f3c1be85" providerId="ADAL" clId="{E2A8B6DA-8827-0C46-90CC-326C4459EA46}" dt="2021-06-09T13:17:06.859" v="1886" actId="1076"/>
          <ac:spMkLst>
            <pc:docMk/>
            <pc:sldMk cId="1997077850" sldId="279"/>
            <ac:spMk id="118" creationId="{E0813993-66DF-0840-8F4C-47DBBFD8966B}"/>
          </ac:spMkLst>
        </pc:spChg>
        <pc:spChg chg="mod">
          <ac:chgData name="Wencai Zhang" userId="4a86a1d0-2108-4707-8228-1110f3c1be85" providerId="ADAL" clId="{E2A8B6DA-8827-0C46-90CC-326C4459EA46}" dt="2021-06-09T20:15:07.350" v="2511" actId="1035"/>
          <ac:spMkLst>
            <pc:docMk/>
            <pc:sldMk cId="1997077850" sldId="279"/>
            <ac:spMk id="119" creationId="{8643EBF5-093B-734B-9442-8B2AD6E3F52D}"/>
          </ac:spMkLst>
        </pc:spChg>
        <pc:spChg chg="mod">
          <ac:chgData name="Wencai Zhang" userId="4a86a1d0-2108-4707-8228-1110f3c1be85" providerId="ADAL" clId="{E2A8B6DA-8827-0C46-90CC-326C4459EA46}" dt="2021-06-09T20:22:53.395" v="2592" actId="1035"/>
          <ac:spMkLst>
            <pc:docMk/>
            <pc:sldMk cId="1997077850" sldId="279"/>
            <ac:spMk id="120" creationId="{BED92353-28E4-4643-90D3-4560DD628D3F}"/>
          </ac:spMkLst>
        </pc:spChg>
        <pc:spChg chg="del">
          <ac:chgData name="Wencai Zhang" userId="4a86a1d0-2108-4707-8228-1110f3c1be85" providerId="ADAL" clId="{E2A8B6DA-8827-0C46-90CC-326C4459EA46}" dt="2021-06-08T14:04:15.085" v="640" actId="478"/>
          <ac:spMkLst>
            <pc:docMk/>
            <pc:sldMk cId="1997077850" sldId="279"/>
            <ac:spMk id="121" creationId="{DA452C9B-23D6-DC4F-9509-32DE6C78F7F5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22" creationId="{0CC7DB87-FD1B-9A46-95DD-3CB778F2DEFB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23" creationId="{F8879FD2-5F0B-ED4B-9872-81F5DD67350C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24" creationId="{017F509A-4319-5D49-8341-CA650D1A5238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25" creationId="{DCEC6160-24EB-2545-A956-8C55E330528C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26" creationId="{31EBA493-A59B-874B-BF7F-791C083AC5E0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49" creationId="{F41891F1-4257-B94D-AF5F-DF10FC5CE441}"/>
          </ac:spMkLst>
        </pc:spChg>
        <pc:spChg chg="add del mod">
          <ac:chgData name="Wencai Zhang" userId="4a86a1d0-2108-4707-8228-1110f3c1be85" providerId="ADAL" clId="{E2A8B6DA-8827-0C46-90CC-326C4459EA46}" dt="2021-06-08T14:09:02.040" v="721"/>
          <ac:spMkLst>
            <pc:docMk/>
            <pc:sldMk cId="1997077850" sldId="279"/>
            <ac:spMk id="150" creationId="{3C663084-8CC9-854D-9FF0-F26157F4A8AC}"/>
          </ac:spMkLst>
        </pc:spChg>
        <pc:spChg chg="mod">
          <ac:chgData name="Wencai Zhang" userId="4a86a1d0-2108-4707-8228-1110f3c1be85" providerId="ADAL" clId="{E2A8B6DA-8827-0C46-90CC-326C4459EA46}" dt="2021-06-09T13:17:19.666" v="1887" actId="207"/>
          <ac:spMkLst>
            <pc:docMk/>
            <pc:sldMk cId="1997077850" sldId="279"/>
            <ac:spMk id="156" creationId="{3012C7EF-C392-D040-953D-7C0BC0A4D9DB}"/>
          </ac:spMkLst>
        </pc:spChg>
        <pc:spChg chg="mod">
          <ac:chgData name="Wencai Zhang" userId="4a86a1d0-2108-4707-8228-1110f3c1be85" providerId="ADAL" clId="{E2A8B6DA-8827-0C46-90CC-326C4459EA46}" dt="2021-06-09T13:17:19.666" v="1887" actId="207"/>
          <ac:spMkLst>
            <pc:docMk/>
            <pc:sldMk cId="1997077850" sldId="279"/>
            <ac:spMk id="159" creationId="{D773FF50-8FC5-DB40-B5D1-1C7BB51DA99F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0" creationId="{4ACB04AC-6584-F145-ADEB-8DCE33FFED73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1" creationId="{EE2F4E35-1C90-FC4B-A1EF-38D6074BBB14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2" creationId="{EA247580-D60C-CC44-AD96-F72D39815C41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3" creationId="{6492B21C-2371-A240-8008-081FEE14107E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6" creationId="{B6F5231E-3128-434A-B4BA-793D62577317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7" creationId="{A8F89C04-90D8-9440-B0F8-8FFCA9BFD855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8" creationId="{5C89201E-6609-654B-977D-63BA903881E0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69" creationId="{317683C1-D6CE-E746-BE57-2D817D93B423}"/>
          </ac:spMkLst>
        </pc:spChg>
        <pc:spChg chg="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198" creationId="{EF53831F-FAC6-B74D-9E68-DBBEA9D481FA}"/>
          </ac:spMkLst>
        </pc:spChg>
        <pc:spChg chg="add mod topLvl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3" creationId="{1069A7EB-D519-314B-B073-8E217A616EB9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4" creationId="{7957ABCD-52EA-574E-8E5F-1847FF566FE1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5" creationId="{672C5019-AE7E-294E-9673-34EA7EC0E9D9}"/>
          </ac:spMkLst>
        </pc:spChg>
        <pc:spChg chg="add mod">
          <ac:chgData name="Wencai Zhang" userId="4a86a1d0-2108-4707-8228-1110f3c1be85" providerId="ADAL" clId="{E2A8B6DA-8827-0C46-90CC-326C4459EA46}" dt="2021-06-15T16:56:42.472" v="4481" actId="164"/>
          <ac:spMkLst>
            <pc:docMk/>
            <pc:sldMk cId="1997077850" sldId="279"/>
            <ac:spMk id="226" creationId="{A863BAE8-AA5D-E74A-B2AA-2B41B71E0322}"/>
          </ac:spMkLst>
        </pc:spChg>
        <pc:spChg chg="add del mod">
          <ac:chgData name="Wencai Zhang" userId="4a86a1d0-2108-4707-8228-1110f3c1be85" providerId="ADAL" clId="{E2A8B6DA-8827-0C46-90CC-326C4459EA46}" dt="2021-06-15T16:42:55.740" v="4055" actId="478"/>
          <ac:spMkLst>
            <pc:docMk/>
            <pc:sldMk cId="1997077850" sldId="279"/>
            <ac:spMk id="232" creationId="{B483A038-935F-2644-BCD0-22636E1C4B7B}"/>
          </ac:spMkLst>
        </pc:spChg>
        <pc:spChg chg="add del mod">
          <ac:chgData name="Wencai Zhang" userId="4a86a1d0-2108-4707-8228-1110f3c1be85" providerId="ADAL" clId="{E2A8B6DA-8827-0C46-90CC-326C4459EA46}" dt="2021-06-15T16:42:55.740" v="4055" actId="478"/>
          <ac:spMkLst>
            <pc:docMk/>
            <pc:sldMk cId="1997077850" sldId="279"/>
            <ac:spMk id="233" creationId="{C67F41FA-80CF-B641-BEFB-949F12703C33}"/>
          </ac:spMkLst>
        </pc:spChg>
        <pc:spChg chg="add del mod">
          <ac:chgData name="Wencai Zhang" userId="4a86a1d0-2108-4707-8228-1110f3c1be85" providerId="ADAL" clId="{E2A8B6DA-8827-0C46-90CC-326C4459EA46}" dt="2021-06-15T16:42:55.740" v="4055" actId="478"/>
          <ac:spMkLst>
            <pc:docMk/>
            <pc:sldMk cId="1997077850" sldId="279"/>
            <ac:spMk id="235" creationId="{E33A1537-B1C6-664F-B15A-0C72377CDA34}"/>
          </ac:spMkLst>
        </pc:spChg>
        <pc:spChg chg="add del mod">
          <ac:chgData name="Wencai Zhang" userId="4a86a1d0-2108-4707-8228-1110f3c1be85" providerId="ADAL" clId="{E2A8B6DA-8827-0C46-90CC-326C4459EA46}" dt="2021-06-16T14:17:37.405" v="4485" actId="478"/>
          <ac:spMkLst>
            <pc:docMk/>
            <pc:sldMk cId="1997077850" sldId="279"/>
            <ac:spMk id="236" creationId="{BB3215BF-A1D5-2744-B40C-BA94CF619321}"/>
          </ac:spMkLst>
        </pc:spChg>
        <pc:spChg chg="add del mod">
          <ac:chgData name="Wencai Zhang" userId="4a86a1d0-2108-4707-8228-1110f3c1be85" providerId="ADAL" clId="{E2A8B6DA-8827-0C46-90CC-326C4459EA46}" dt="2021-06-16T14:17:37.405" v="4485" actId="478"/>
          <ac:spMkLst>
            <pc:docMk/>
            <pc:sldMk cId="1997077850" sldId="279"/>
            <ac:spMk id="237" creationId="{692EE924-1D07-EB4A-AABA-74E07542B6F8}"/>
          </ac:spMkLst>
        </pc:spChg>
        <pc:spChg chg="add del mod">
          <ac:chgData name="Wencai Zhang" userId="4a86a1d0-2108-4707-8228-1110f3c1be85" providerId="ADAL" clId="{E2A8B6DA-8827-0C46-90CC-326C4459EA46}" dt="2021-06-15T16:52:55.987" v="4318" actId="478"/>
          <ac:spMkLst>
            <pc:docMk/>
            <pc:sldMk cId="1997077850" sldId="279"/>
            <ac:spMk id="239" creationId="{0484E16E-A642-FE48-8969-B838F04EB3DF}"/>
          </ac:spMkLst>
        </pc:spChg>
        <pc:spChg chg="add del mod">
          <ac:chgData name="Wencai Zhang" userId="4a86a1d0-2108-4707-8228-1110f3c1be85" providerId="ADAL" clId="{E2A8B6DA-8827-0C46-90CC-326C4459EA46}" dt="2021-06-15T16:56:31.381" v="4480" actId="478"/>
          <ac:spMkLst>
            <pc:docMk/>
            <pc:sldMk cId="1997077850" sldId="279"/>
            <ac:spMk id="240" creationId="{8ECCB646-31F2-C94D-BC83-2E68EC860606}"/>
          </ac:spMkLst>
        </pc:spChg>
        <pc:spChg chg="add del mod">
          <ac:chgData name="Wencai Zhang" userId="4a86a1d0-2108-4707-8228-1110f3c1be85" providerId="ADAL" clId="{E2A8B6DA-8827-0C46-90CC-326C4459EA46}" dt="2021-06-15T16:56:31.381" v="4480" actId="478"/>
          <ac:spMkLst>
            <pc:docMk/>
            <pc:sldMk cId="1997077850" sldId="279"/>
            <ac:spMk id="241" creationId="{FBAE21D9-DFF4-8245-9313-3D81619251AD}"/>
          </ac:spMkLst>
        </pc:spChg>
        <pc:spChg chg="add mod">
          <ac:chgData name="Wencai Zhang" userId="4a86a1d0-2108-4707-8228-1110f3c1be85" providerId="ADAL" clId="{E2A8B6DA-8827-0C46-90CC-326C4459EA46}" dt="2021-06-15T16:47:46.070" v="4207" actId="164"/>
          <ac:spMkLst>
            <pc:docMk/>
            <pc:sldMk cId="1997077850" sldId="279"/>
            <ac:spMk id="243" creationId="{A278CEC8-AF77-044C-99C5-80FB3C96473A}"/>
          </ac:spMkLst>
        </pc:spChg>
        <pc:spChg chg="add mod">
          <ac:chgData name="Wencai Zhang" userId="4a86a1d0-2108-4707-8228-1110f3c1be85" providerId="ADAL" clId="{E2A8B6DA-8827-0C46-90CC-326C4459EA46}" dt="2021-06-15T16:41:30.273" v="4015" actId="164"/>
          <ac:spMkLst>
            <pc:docMk/>
            <pc:sldMk cId="1997077850" sldId="279"/>
            <ac:spMk id="244" creationId="{EC3F7204-7F00-B343-AF5D-8D7FE14A606E}"/>
          </ac:spMkLst>
        </pc:spChg>
        <pc:spChg chg="add del mod">
          <ac:chgData name="Wencai Zhang" userId="4a86a1d0-2108-4707-8228-1110f3c1be85" providerId="ADAL" clId="{E2A8B6DA-8827-0C46-90CC-326C4459EA46}" dt="2021-06-09T13:03:30.744" v="1597"/>
          <ac:spMkLst>
            <pc:docMk/>
            <pc:sldMk cId="1997077850" sldId="279"/>
            <ac:spMk id="245" creationId="{314F8C31-0DB2-994D-ABA1-98B50E83E2A0}"/>
          </ac:spMkLst>
        </pc:spChg>
        <pc:spChg chg="add mod">
          <ac:chgData name="Wencai Zhang" userId="4a86a1d0-2108-4707-8228-1110f3c1be85" providerId="ADAL" clId="{E2A8B6DA-8827-0C46-90CC-326C4459EA46}" dt="2021-06-15T16:41:30.273" v="4015" actId="164"/>
          <ac:spMkLst>
            <pc:docMk/>
            <pc:sldMk cId="1997077850" sldId="279"/>
            <ac:spMk id="245" creationId="{6685693A-A025-2C4B-ABF4-5B2FFF9B1AFB}"/>
          </ac:spMkLst>
        </pc:spChg>
        <pc:spChg chg="add mod">
          <ac:chgData name="Wencai Zhang" userId="4a86a1d0-2108-4707-8228-1110f3c1be85" providerId="ADAL" clId="{E2A8B6DA-8827-0C46-90CC-326C4459EA46}" dt="2021-06-15T16:41:30.273" v="4015" actId="164"/>
          <ac:spMkLst>
            <pc:docMk/>
            <pc:sldMk cId="1997077850" sldId="279"/>
            <ac:spMk id="246" creationId="{A1716AC8-DC91-3146-A541-009E330E9EAA}"/>
          </ac:spMkLst>
        </pc:spChg>
        <pc:spChg chg="add mod">
          <ac:chgData name="Wencai Zhang" userId="4a86a1d0-2108-4707-8228-1110f3c1be85" providerId="ADAL" clId="{E2A8B6DA-8827-0C46-90CC-326C4459EA46}" dt="2021-06-08T14:11:23.140" v="742" actId="207"/>
          <ac:spMkLst>
            <pc:docMk/>
            <pc:sldMk cId="1997077850" sldId="279"/>
            <ac:spMk id="246" creationId="{A6F3F460-1C39-4A41-B6EA-9B08EAA99A0D}"/>
          </ac:spMkLst>
        </pc:spChg>
        <pc:spChg chg="mod">
          <ac:chgData name="Wencai Zhang" userId="4a86a1d0-2108-4707-8228-1110f3c1be85" providerId="ADAL" clId="{E2A8B6DA-8827-0C46-90CC-326C4459EA46}" dt="2021-06-09T13:05:37.183" v="1629" actId="1038"/>
          <ac:spMkLst>
            <pc:docMk/>
            <pc:sldMk cId="1997077850" sldId="279"/>
            <ac:spMk id="253" creationId="{55B4F33F-3F47-574D-8F43-8BFF46C71D55}"/>
          </ac:spMkLst>
        </pc:spChg>
        <pc:spChg chg="mod">
          <ac:chgData name="Wencai Zhang" userId="4a86a1d0-2108-4707-8228-1110f3c1be85" providerId="ADAL" clId="{E2A8B6DA-8827-0C46-90CC-326C4459EA46}" dt="2021-06-09T13:05:42.899" v="1630" actId="1037"/>
          <ac:spMkLst>
            <pc:docMk/>
            <pc:sldMk cId="1997077850" sldId="279"/>
            <ac:spMk id="254" creationId="{B45BB2E0-9CE2-0B4F-A328-A728DE931561}"/>
          </ac:spMkLst>
        </pc:spChg>
        <pc:spChg chg="mod">
          <ac:chgData name="Wencai Zhang" userId="4a86a1d0-2108-4707-8228-1110f3c1be85" providerId="ADAL" clId="{E2A8B6DA-8827-0C46-90CC-326C4459EA46}" dt="2021-06-09T13:17:19.666" v="1887" actId="207"/>
          <ac:spMkLst>
            <pc:docMk/>
            <pc:sldMk cId="1997077850" sldId="279"/>
            <ac:spMk id="255" creationId="{AC162F6B-0E19-CE45-A860-5A7921CBAE46}"/>
          </ac:spMkLst>
        </pc:spChg>
        <pc:spChg chg="add mod">
          <ac:chgData name="Wencai Zhang" userId="4a86a1d0-2108-4707-8228-1110f3c1be85" providerId="ADAL" clId="{E2A8B6DA-8827-0C46-90CC-326C4459EA46}" dt="2021-06-09T13:07:00.748" v="1654" actId="1038"/>
          <ac:spMkLst>
            <pc:docMk/>
            <pc:sldMk cId="1997077850" sldId="279"/>
            <ac:spMk id="256" creationId="{00731A5A-B01F-6942-B0EA-F8045597B627}"/>
          </ac:spMkLst>
        </pc:spChg>
        <pc:spChg chg="mod">
          <ac:chgData name="Wencai Zhang" userId="4a86a1d0-2108-4707-8228-1110f3c1be85" providerId="ADAL" clId="{E2A8B6DA-8827-0C46-90CC-326C4459EA46}" dt="2021-06-15T16:52:43.355" v="4313" actId="1036"/>
          <ac:spMkLst>
            <pc:docMk/>
            <pc:sldMk cId="1997077850" sldId="279"/>
            <ac:spMk id="259" creationId="{2DB4B70A-D0F3-B446-9983-B720EFC8CF79}"/>
          </ac:spMkLst>
        </pc:spChg>
        <pc:spChg chg="add mod">
          <ac:chgData name="Wencai Zhang" userId="4a86a1d0-2108-4707-8228-1110f3c1be85" providerId="ADAL" clId="{E2A8B6DA-8827-0C46-90CC-326C4459EA46}" dt="2021-06-15T16:47:46.070" v="4207" actId="164"/>
          <ac:spMkLst>
            <pc:docMk/>
            <pc:sldMk cId="1997077850" sldId="279"/>
            <ac:spMk id="260" creationId="{BD846D07-7E76-2E4C-A33B-F5BA32052A6C}"/>
          </ac:spMkLst>
        </pc:spChg>
        <pc:spChg chg="add mod topLvl">
          <ac:chgData name="Wencai Zhang" userId="4a86a1d0-2108-4707-8228-1110f3c1be85" providerId="ADAL" clId="{E2A8B6DA-8827-0C46-90CC-326C4459EA46}" dt="2021-06-10T16:33:05.763" v="3752" actId="1076"/>
          <ac:spMkLst>
            <pc:docMk/>
            <pc:sldMk cId="1997077850" sldId="279"/>
            <ac:spMk id="261" creationId="{AD46C664-415F-BE4C-9BB0-70AC4BFAD948}"/>
          </ac:spMkLst>
        </pc:spChg>
        <pc:spChg chg="add mod">
          <ac:chgData name="Wencai Zhang" userId="4a86a1d0-2108-4707-8228-1110f3c1be85" providerId="ADAL" clId="{E2A8B6DA-8827-0C46-90CC-326C4459EA46}" dt="2021-06-15T16:47:46.070" v="4207" actId="164"/>
          <ac:spMkLst>
            <pc:docMk/>
            <pc:sldMk cId="1997077850" sldId="279"/>
            <ac:spMk id="262" creationId="{7C67F0CE-6C6B-6249-92DB-C1B082A64FAF}"/>
          </ac:spMkLst>
        </pc:spChg>
        <pc:spChg chg="mod">
          <ac:chgData name="Wencai Zhang" userId="4a86a1d0-2108-4707-8228-1110f3c1be85" providerId="ADAL" clId="{E2A8B6DA-8827-0C46-90CC-326C4459EA46}" dt="2021-06-15T16:52:48.058" v="4314" actId="1036"/>
          <ac:spMkLst>
            <pc:docMk/>
            <pc:sldMk cId="1997077850" sldId="279"/>
            <ac:spMk id="264" creationId="{58ADC441-464E-464B-BE90-985EE9255BBC}"/>
          </ac:spMkLst>
        </pc:spChg>
        <pc:spChg chg="add del mod">
          <ac:chgData name="Wencai Zhang" userId="4a86a1d0-2108-4707-8228-1110f3c1be85" providerId="ADAL" clId="{E2A8B6DA-8827-0C46-90CC-326C4459EA46}" dt="2021-06-15T16:52:53.680" v="4317" actId="478"/>
          <ac:spMkLst>
            <pc:docMk/>
            <pc:sldMk cId="1997077850" sldId="279"/>
            <ac:spMk id="268" creationId="{07B8A3D1-A213-1D44-80B2-50EBC3E7192E}"/>
          </ac:spMkLst>
        </pc:spChg>
        <pc:grpChg chg="add del mod topLvl">
          <ac:chgData name="Wencai Zhang" userId="4a86a1d0-2108-4707-8228-1110f3c1be85" providerId="ADAL" clId="{E2A8B6DA-8827-0C46-90CC-326C4459EA46}" dt="2021-06-10T16:00:10.287" v="3626" actId="165"/>
          <ac:grpSpMkLst>
            <pc:docMk/>
            <pc:sldMk cId="1997077850" sldId="279"/>
            <ac:grpSpMk id="2" creationId="{52E4DE26-033D-CB43-A6D0-DEA0AA7090D3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" creationId="{68179CDE-26CC-AE46-A792-A605CA655776}"/>
          </ac:grpSpMkLst>
        </pc:grpChg>
        <pc:grpChg chg="add del mod topLvl">
          <ac:chgData name="Wencai Zhang" userId="4a86a1d0-2108-4707-8228-1110f3c1be85" providerId="ADAL" clId="{E2A8B6DA-8827-0C46-90CC-326C4459EA46}" dt="2021-06-10T16:00:04.380" v="3625" actId="165"/>
          <ac:grpSpMkLst>
            <pc:docMk/>
            <pc:sldMk cId="1997077850" sldId="279"/>
            <ac:grpSpMk id="5" creationId="{4255CE76-1D38-BF44-82E1-5D7769F72B99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5" creationId="{DF93B195-F799-DC4D-9017-9227DFD88F27}"/>
          </ac:grpSpMkLst>
        </pc:grpChg>
        <pc:grpChg chg="add del mod">
          <ac:chgData name="Wencai Zhang" userId="4a86a1d0-2108-4707-8228-1110f3c1be85" providerId="ADAL" clId="{E2A8B6DA-8827-0C46-90CC-326C4459EA46}" dt="2021-06-09T13:20:17.957" v="1888" actId="165"/>
          <ac:grpSpMkLst>
            <pc:docMk/>
            <pc:sldMk cId="1997077850" sldId="279"/>
            <ac:grpSpMk id="6" creationId="{16EAFE92-D4B2-E240-8FBA-18F28A271F22}"/>
          </ac:grpSpMkLst>
        </pc:grpChg>
        <pc:grpChg chg="add del mod">
          <ac:chgData name="Wencai Zhang" userId="4a86a1d0-2108-4707-8228-1110f3c1be85" providerId="ADAL" clId="{E2A8B6DA-8827-0C46-90CC-326C4459EA46}" dt="2021-06-10T13:59:51.297" v="2848" actId="165"/>
          <ac:grpSpMkLst>
            <pc:docMk/>
            <pc:sldMk cId="1997077850" sldId="279"/>
            <ac:grpSpMk id="7" creationId="{C30CD65F-0A36-A240-A067-71ADFF352E09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8" creationId="{447B76B8-20C0-6D42-949E-E331C653DE5F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0" creationId="{51D0DDE7-5A35-9C47-816B-D24198872E22}"/>
          </ac:grpSpMkLst>
        </pc:grpChg>
        <pc:grpChg chg="add del">
          <ac:chgData name="Wencai Zhang" userId="4a86a1d0-2108-4707-8228-1110f3c1be85" providerId="ADAL" clId="{E2A8B6DA-8827-0C46-90CC-326C4459EA46}" dt="2021-06-08T14:09:08.339" v="726" actId="478"/>
          <ac:grpSpMkLst>
            <pc:docMk/>
            <pc:sldMk cId="1997077850" sldId="279"/>
            <ac:grpSpMk id="14" creationId="{13303575-95DC-9C46-944A-55D1DD127963}"/>
          </ac:grpSpMkLst>
        </pc:grpChg>
        <pc:grpChg chg="del">
          <ac:chgData name="Wencai Zhang" userId="4a86a1d0-2108-4707-8228-1110f3c1be85" providerId="ADAL" clId="{E2A8B6DA-8827-0C46-90CC-326C4459EA46}" dt="2021-06-08T14:04:15.085" v="640" actId="478"/>
          <ac:grpSpMkLst>
            <pc:docMk/>
            <pc:sldMk cId="1997077850" sldId="279"/>
            <ac:grpSpMk id="17" creationId="{6E60DABA-1C1A-C040-85FC-ADEC9B0924CE}"/>
          </ac:grpSpMkLst>
        </pc:grpChg>
        <pc:grpChg chg="mod">
          <ac:chgData name="Wencai Zhang" userId="4a86a1d0-2108-4707-8228-1110f3c1be85" providerId="ADAL" clId="{E2A8B6DA-8827-0C46-90CC-326C4459EA46}" dt="2021-06-08T14:07:05.044" v="679" actId="164"/>
          <ac:grpSpMkLst>
            <pc:docMk/>
            <pc:sldMk cId="1997077850" sldId="279"/>
            <ac:grpSpMk id="18" creationId="{C60C65AD-2EBD-BD46-858D-EAF4332E4B5B}"/>
          </ac:grpSpMkLst>
        </pc:grpChg>
        <pc:grpChg chg="del">
          <ac:chgData name="Wencai Zhang" userId="4a86a1d0-2108-4707-8228-1110f3c1be85" providerId="ADAL" clId="{E2A8B6DA-8827-0C46-90CC-326C4459EA46}" dt="2021-06-08T14:04:15.085" v="640" actId="478"/>
          <ac:grpSpMkLst>
            <pc:docMk/>
            <pc:sldMk cId="1997077850" sldId="279"/>
            <ac:grpSpMk id="19" creationId="{AF214937-88ED-FC4C-84F1-4262D7E51D4F}"/>
          </ac:grpSpMkLst>
        </pc:grpChg>
        <pc:grpChg chg="add mod">
          <ac:chgData name="Wencai Zhang" userId="4a86a1d0-2108-4707-8228-1110f3c1be85" providerId="ADAL" clId="{E2A8B6DA-8827-0C46-90CC-326C4459EA46}" dt="2021-06-08T14:07:00.690" v="678" actId="164"/>
          <ac:grpSpMkLst>
            <pc:docMk/>
            <pc:sldMk cId="1997077850" sldId="279"/>
            <ac:grpSpMk id="20" creationId="{8B4F51E4-D37B-9449-86C1-EE0022A25483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1" creationId="{E22E3874-2990-6341-842B-A7CB8CDF9CF3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2" creationId="{583683FF-350F-534B-A8B6-93A4E9F3CC81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3" creationId="{BFCE707F-5725-FC41-A3B0-057D21D414EC}"/>
          </ac:grpSpMkLst>
        </pc:grpChg>
        <pc:grpChg chg="add del mod">
          <ac:chgData name="Wencai Zhang" userId="4a86a1d0-2108-4707-8228-1110f3c1be85" providerId="ADAL" clId="{E2A8B6DA-8827-0C46-90CC-326C4459EA46}" dt="2021-06-09T13:04:26.232" v="1606" actId="478"/>
          <ac:grpSpMkLst>
            <pc:docMk/>
            <pc:sldMk cId="1997077850" sldId="279"/>
            <ac:grpSpMk id="24" creationId="{54E935FB-D147-7F45-B64F-0891535D21E6}"/>
          </ac:grpSpMkLst>
        </pc:grpChg>
        <pc:grpChg chg="mod">
          <ac:chgData name="Wencai Zhang" userId="4a86a1d0-2108-4707-8228-1110f3c1be85" providerId="ADAL" clId="{E2A8B6DA-8827-0C46-90CC-326C4459EA46}" dt="2021-06-08T14:06:47.267" v="664" actId="164"/>
          <ac:grpSpMkLst>
            <pc:docMk/>
            <pc:sldMk cId="1997077850" sldId="279"/>
            <ac:grpSpMk id="95" creationId="{5A92389F-CB63-B84C-B2A1-0F4259666E50}"/>
          </ac:grpSpMkLst>
        </pc:grpChg>
        <pc:grpChg chg="add del mod">
          <ac:chgData name="Wencai Zhang" userId="4a86a1d0-2108-4707-8228-1110f3c1be85" providerId="ADAL" clId="{E2A8B6DA-8827-0C46-90CC-326C4459EA46}" dt="2021-06-08T14:09:02.040" v="721"/>
          <ac:grpSpMkLst>
            <pc:docMk/>
            <pc:sldMk cId="1997077850" sldId="279"/>
            <ac:grpSpMk id="128" creationId="{1B6B2861-3D91-3A4D-BCF5-145CFEA2F8CD}"/>
          </ac:grpSpMkLst>
        </pc:grpChg>
        <pc:grpChg chg="add del mod">
          <ac:chgData name="Wencai Zhang" userId="4a86a1d0-2108-4707-8228-1110f3c1be85" providerId="ADAL" clId="{E2A8B6DA-8827-0C46-90CC-326C4459EA46}" dt="2021-06-08T14:09:02.040" v="721"/>
          <ac:grpSpMkLst>
            <pc:docMk/>
            <pc:sldMk cId="1997077850" sldId="279"/>
            <ac:grpSpMk id="143" creationId="{9EBB4591-E6BC-024A-8D7E-B8E1E50B597D}"/>
          </ac:grpSpMkLst>
        </pc:grpChg>
        <pc:grpChg chg="add del mod">
          <ac:chgData name="Wencai Zhang" userId="4a86a1d0-2108-4707-8228-1110f3c1be85" providerId="ADAL" clId="{E2A8B6DA-8827-0C46-90CC-326C4459EA46}" dt="2021-06-08T14:09:02.040" v="721"/>
          <ac:grpSpMkLst>
            <pc:docMk/>
            <pc:sldMk cId="1997077850" sldId="279"/>
            <ac:grpSpMk id="151" creationId="{976B027A-9096-B44A-AEC1-83825F0BE126}"/>
          </ac:grpSpMkLst>
        </pc:grpChg>
        <pc:grpChg chg="add 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55" creationId="{8CA149AD-4572-E64D-B4EA-7329D2DC2F84}"/>
          </ac:grpSpMkLst>
        </pc:grpChg>
        <pc:grpChg chg="add del mod topLvl">
          <ac:chgData name="Wencai Zhang" userId="4a86a1d0-2108-4707-8228-1110f3c1be85" providerId="ADAL" clId="{E2A8B6DA-8827-0C46-90CC-326C4459EA46}" dt="2021-06-15T16:37:22.049" v="3925" actId="165"/>
          <ac:grpSpMkLst>
            <pc:docMk/>
            <pc:sldMk cId="1997077850" sldId="279"/>
            <ac:grpSpMk id="164" creationId="{41C9CC87-DCCB-AD4B-A1E6-B4E335297973}"/>
          </ac:grpSpMkLst>
        </pc:grpChg>
        <pc:grpChg chg="del mod topLvl">
          <ac:chgData name="Wencai Zhang" userId="4a86a1d0-2108-4707-8228-1110f3c1be85" providerId="ADAL" clId="{E2A8B6DA-8827-0C46-90CC-326C4459EA46}" dt="2021-06-15T16:37:26.795" v="3926" actId="165"/>
          <ac:grpSpMkLst>
            <pc:docMk/>
            <pc:sldMk cId="1997077850" sldId="279"/>
            <ac:grpSpMk id="165" creationId="{82EE6866-CE15-A046-A25A-F819262CE0DA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0" creationId="{1F56A997-5B1D-0E42-8166-3B7495A9F80E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1" creationId="{A711D4DC-5BDA-6F4E-96ED-F10DF2924F64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2" creationId="{04F75B7C-4C5B-EC44-94F0-80A48FD8E8E3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3" creationId="{EB191E7E-12D3-6144-AD4E-5EB77CC64589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74" creationId="{4A64262C-29B0-0F4F-9F5D-2F04A33294A9}"/>
          </ac:grpSpMkLst>
        </pc:grpChg>
        <pc:grpChg chg="add del mod topLvl">
          <ac:chgData name="Wencai Zhang" userId="4a86a1d0-2108-4707-8228-1110f3c1be85" providerId="ADAL" clId="{E2A8B6DA-8827-0C46-90CC-326C4459EA46}" dt="2021-06-15T16:41:48.126" v="4018" actId="165"/>
          <ac:grpSpMkLst>
            <pc:docMk/>
            <pc:sldMk cId="1997077850" sldId="279"/>
            <ac:grpSpMk id="192" creationId="{4AB23E5B-A1E6-4144-AFFA-935FAEA99AC4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3" creationId="{2C962FB6-4588-664E-9502-4552389B770B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4" creationId="{7FEC941E-0C3D-F14C-8227-0EAEBFE4D084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5" creationId="{A80E09AE-7C92-484B-AD81-E52463D9452A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6" creationId="{3A6C2602-B4F6-9E4E-9ECF-CEE8F8F9D38C}"/>
          </ac:grpSpMkLst>
        </pc:grpChg>
        <pc:grpChg chg="mod topLvl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197" creationId="{0D998B61-A34F-B04E-BF80-CC347A427353}"/>
          </ac:grpSpMkLst>
        </pc:grpChg>
        <pc:grpChg chg="add del mod">
          <ac:chgData name="Wencai Zhang" userId="4a86a1d0-2108-4707-8228-1110f3c1be85" providerId="ADAL" clId="{E2A8B6DA-8827-0C46-90CC-326C4459EA46}" dt="2021-06-09T12:56:07.138" v="1367" actId="478"/>
          <ac:grpSpMkLst>
            <pc:docMk/>
            <pc:sldMk cId="1997077850" sldId="279"/>
            <ac:grpSpMk id="224" creationId="{BCE7D351-A731-B449-936B-69A1BA0DF3B6}"/>
          </ac:grpSpMkLst>
        </pc:grpChg>
        <pc:grpChg chg="add del mod">
          <ac:chgData name="Wencai Zhang" userId="4a86a1d0-2108-4707-8228-1110f3c1be85" providerId="ADAL" clId="{E2A8B6DA-8827-0C46-90CC-326C4459EA46}" dt="2021-06-09T12:56:07.138" v="1367" actId="478"/>
          <ac:grpSpMkLst>
            <pc:docMk/>
            <pc:sldMk cId="1997077850" sldId="279"/>
            <ac:grpSpMk id="239" creationId="{D81119CD-7151-EF48-A4E3-4271D7A6C1B6}"/>
          </ac:grpSpMkLst>
        </pc:grpChg>
        <pc:grpChg chg="add del mod">
          <ac:chgData name="Wencai Zhang" userId="4a86a1d0-2108-4707-8228-1110f3c1be85" providerId="ADAL" clId="{E2A8B6DA-8827-0C46-90CC-326C4459EA46}" dt="2021-06-09T13:04:20.783" v="1605" actId="478"/>
          <ac:grpSpMkLst>
            <pc:docMk/>
            <pc:sldMk cId="1997077850" sldId="279"/>
            <ac:grpSpMk id="246" creationId="{897D2182-9D25-024E-84A4-65E5137D387C}"/>
          </ac:grpSpMkLst>
        </pc:grpChg>
        <pc:grpChg chg="add mod">
          <ac:chgData name="Wencai Zhang" userId="4a86a1d0-2108-4707-8228-1110f3c1be85" providerId="ADAL" clId="{E2A8B6DA-8827-0C46-90CC-326C4459EA46}" dt="2021-06-09T13:17:19.666" v="1887" actId="207"/>
          <ac:grpSpMkLst>
            <pc:docMk/>
            <pc:sldMk cId="1997077850" sldId="279"/>
            <ac:grpSpMk id="247" creationId="{C81F48F0-8E49-C345-B8EA-541E4DB341C8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52" creationId="{6E3E3AF6-E4A4-D947-8EBA-29486007CF2F}"/>
          </ac:grpSpMkLst>
        </pc:grpChg>
        <pc:grpChg chg="add mod">
          <ac:chgData name="Wencai Zhang" userId="4a86a1d0-2108-4707-8228-1110f3c1be85" providerId="ADAL" clId="{E2A8B6DA-8827-0C46-90CC-326C4459EA46}" dt="2021-06-15T16:56:42.472" v="4481" actId="164"/>
          <ac:grpSpMkLst>
            <pc:docMk/>
            <pc:sldMk cId="1997077850" sldId="279"/>
            <ac:grpSpMk id="263" creationId="{B947E33E-5CBB-0E48-875E-1E09E8D5987A}"/>
          </ac:grpSpMkLst>
        </pc:grpChg>
        <pc:graphicFrameChg chg="add del mod">
          <ac:chgData name="Wencai Zhang" userId="4a86a1d0-2108-4707-8228-1110f3c1be85" providerId="ADAL" clId="{E2A8B6DA-8827-0C46-90CC-326C4459EA46}" dt="2021-06-10T15:08:54.402" v="3148" actId="478"/>
          <ac:graphicFrameMkLst>
            <pc:docMk/>
            <pc:sldMk cId="1997077850" sldId="279"/>
            <ac:graphicFrameMk id="144" creationId="{85556146-13EB-FD4D-9A5E-A4F4781141D3}"/>
          </ac:graphicFrameMkLst>
        </pc:graphicFrameChg>
        <pc:graphicFrameChg chg="add del mod">
          <ac:chgData name="Wencai Zhang" userId="4a86a1d0-2108-4707-8228-1110f3c1be85" providerId="ADAL" clId="{E2A8B6DA-8827-0C46-90CC-326C4459EA46}" dt="2021-06-10T15:08:54.402" v="3148" actId="478"/>
          <ac:graphicFrameMkLst>
            <pc:docMk/>
            <pc:sldMk cId="1997077850" sldId="279"/>
            <ac:graphicFrameMk id="145" creationId="{7902E942-2766-8848-A1D9-A901C1604355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27" creationId="{4FD31E4B-C0F6-9C42-9C4A-07D16B71CE78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28" creationId="{26773B13-850E-2B46-866A-BC441E3DCA24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add mod">
          <ac:chgData name="Wencai Zhang" userId="4a86a1d0-2108-4707-8228-1110f3c1be85" providerId="ADAL" clId="{E2A8B6DA-8827-0C46-90CC-326C4459EA46}" dt="2021-06-15T16:56:42.472" v="4481" actId="164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picChg chg="mod">
          <ac:chgData name="Wencai Zhang" userId="4a86a1d0-2108-4707-8228-1110f3c1be85" providerId="ADAL" clId="{E2A8B6DA-8827-0C46-90CC-326C4459EA46}" dt="2021-06-09T20:17:46.420" v="2531" actId="1035"/>
          <ac:picMkLst>
            <pc:docMk/>
            <pc:sldMk cId="1997077850" sldId="279"/>
            <ac:picMk id="80" creationId="{C1AC867E-F558-4B4F-945F-11FC4DC3DBE6}"/>
          </ac:picMkLst>
        </pc:picChg>
        <pc:picChg chg="mod modCrop">
          <ac:chgData name="Wencai Zhang" userId="4a86a1d0-2108-4707-8228-1110f3c1be85" providerId="ADAL" clId="{E2A8B6DA-8827-0C46-90CC-326C4459EA46}" dt="2021-06-09T20:17:59.856" v="2548" actId="1035"/>
          <ac:picMkLst>
            <pc:docMk/>
            <pc:sldMk cId="1997077850" sldId="279"/>
            <ac:picMk id="103" creationId="{542CEB86-8C97-5D46-AFEB-583EAC11B9CC}"/>
          </ac:picMkLst>
        </pc:picChg>
        <pc:picChg chg="mod modCrop">
          <ac:chgData name="Wencai Zhang" userId="4a86a1d0-2108-4707-8228-1110f3c1be85" providerId="ADAL" clId="{E2A8B6DA-8827-0C46-90CC-326C4459EA46}" dt="2021-06-09T20:15:44.543" v="2518" actId="732"/>
          <ac:picMkLst>
            <pc:docMk/>
            <pc:sldMk cId="1997077850" sldId="279"/>
            <ac:picMk id="109" creationId="{549D7B5A-6C28-4C49-91BA-9E2E78758AE0}"/>
          </ac:picMkLst>
        </pc:picChg>
        <pc:picChg chg="mod modCrop">
          <ac:chgData name="Wencai Zhang" userId="4a86a1d0-2108-4707-8228-1110f3c1be85" providerId="ADAL" clId="{E2A8B6DA-8827-0C46-90CC-326C4459EA46}" dt="2021-06-09T20:17:29.634" v="2525" actId="732"/>
          <ac:picMkLst>
            <pc:docMk/>
            <pc:sldMk cId="1997077850" sldId="279"/>
            <ac:picMk id="111" creationId="{B0A817B9-7B93-364B-97A8-3729A26CF89F}"/>
          </ac:picMkLst>
        </pc:picChg>
        <pc:picChg chg="add del mod">
          <ac:chgData name="Wencai Zhang" userId="4a86a1d0-2108-4707-8228-1110f3c1be85" providerId="ADAL" clId="{E2A8B6DA-8827-0C46-90CC-326C4459EA46}" dt="2021-06-08T14:09:02.040" v="721"/>
          <ac:picMkLst>
            <pc:docMk/>
            <pc:sldMk cId="1997077850" sldId="279"/>
            <ac:picMk id="127" creationId="{988768A5-4351-5542-BB68-63CC0D059335}"/>
          </ac:picMkLst>
        </pc:picChg>
        <pc:picChg chg="add del mod">
          <ac:chgData name="Wencai Zhang" userId="4a86a1d0-2108-4707-8228-1110f3c1be85" providerId="ADAL" clId="{E2A8B6DA-8827-0C46-90CC-326C4459EA46}" dt="2021-06-08T14:09:02.040" v="721"/>
          <ac:picMkLst>
            <pc:docMk/>
            <pc:sldMk cId="1997077850" sldId="279"/>
            <ac:picMk id="142" creationId="{BA73ED88-9F7E-A44F-94E2-FC678075BAE9}"/>
          </ac:picMkLst>
        </pc:picChg>
        <pc:picChg chg="add del mod topLvl modCrop">
          <ac:chgData name="Wencai Zhang" userId="4a86a1d0-2108-4707-8228-1110f3c1be85" providerId="ADAL" clId="{E2A8B6DA-8827-0C46-90CC-326C4459EA46}" dt="2021-06-15T16:58:01.774" v="4484" actId="166"/>
          <ac:picMkLst>
            <pc:docMk/>
            <pc:sldMk cId="1997077850" sldId="279"/>
            <ac:picMk id="147" creationId="{40619D9C-9239-C84E-B369-2C612572AF11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48" creationId="{C967AA15-3E85-904C-B506-76D32595757D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49" creationId="{E853F779-0750-7346-B5FE-88BA0A6184E6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0" creationId="{C48CC221-0E50-2247-ADA2-72F6FA3DCD26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1" creationId="{827ED3F7-E2E9-304A-8DDC-571679CF790E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2" creationId="{9222E430-C16C-C244-A862-4AB08BA9C452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3" creationId="{13A58CAD-DA12-E245-9650-407850C2438E}"/>
          </ac:picMkLst>
        </pc:picChg>
        <pc:picChg chg="add mod topLvl modCrop">
          <ac:chgData name="Wencai Zhang" userId="4a86a1d0-2108-4707-8228-1110f3c1be85" providerId="ADAL" clId="{E2A8B6DA-8827-0C46-90CC-326C4459EA46}" dt="2021-06-10T16:00:46.465" v="3633" actId="164"/>
          <ac:picMkLst>
            <pc:docMk/>
            <pc:sldMk cId="1997077850" sldId="279"/>
            <ac:picMk id="154" creationId="{6C2A42FA-9A59-1B4F-B2BE-59BC3BA95514}"/>
          </ac:picMkLst>
        </pc:picChg>
        <pc:picChg chg="add del mod">
          <ac:chgData name="Wencai Zhang" userId="4a86a1d0-2108-4707-8228-1110f3c1be85" providerId="ADAL" clId="{E2A8B6DA-8827-0C46-90CC-326C4459EA46}" dt="2021-06-08T19:09:05.399" v="877" actId="478"/>
          <ac:picMkLst>
            <pc:docMk/>
            <pc:sldMk cId="1997077850" sldId="279"/>
            <ac:picMk id="223" creationId="{C855525A-E4EC-8F42-9DBC-D76EACEBAC40}"/>
          </ac:picMkLst>
        </pc:picChg>
        <pc:picChg chg="add mod modCrop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31" creationId="{DA8C3D4F-1C6A-324F-96EA-B2FBBB842E89}"/>
          </ac:picMkLst>
        </pc:picChg>
        <pc:picChg chg="add mod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34" creationId="{8ECD7F06-6619-6948-975E-4874003590B8}"/>
          </ac:picMkLst>
        </pc:picChg>
        <pc:picChg chg="add del mod topLvl modCrop">
          <ac:chgData name="Wencai Zhang" userId="4a86a1d0-2108-4707-8228-1110f3c1be85" providerId="ADAL" clId="{E2A8B6DA-8827-0C46-90CC-326C4459EA46}" dt="2021-06-10T16:40:44.278" v="3910" actId="478"/>
          <ac:picMkLst>
            <pc:docMk/>
            <pc:sldMk cId="1997077850" sldId="279"/>
            <ac:picMk id="238" creationId="{447E17A3-86EB-CB4B-834A-0A9B35FC6B45}"/>
          </ac:picMkLst>
        </pc:picChg>
        <pc:picChg chg="add mod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38" creationId="{B360B700-1DD9-3544-BE20-BABFB3ACAB69}"/>
          </ac:picMkLst>
        </pc:picChg>
        <pc:picChg chg="add mod modCrop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42" creationId="{0DADD5D4-55AF-5442-9E75-0AA5DDA4D1BA}"/>
          </ac:picMkLst>
        </pc:picChg>
        <pc:picChg chg="del">
          <ac:chgData name="Wencai Zhang" userId="4a86a1d0-2108-4707-8228-1110f3c1be85" providerId="ADAL" clId="{E2A8B6DA-8827-0C46-90CC-326C4459EA46}" dt="2021-06-10T16:40:02.183" v="3908" actId="478"/>
          <ac:picMkLst>
            <pc:docMk/>
            <pc:sldMk cId="1997077850" sldId="279"/>
            <ac:picMk id="252" creationId="{7CD8C9DD-B211-F34F-ABFD-C5E65905392F}"/>
          </ac:picMkLst>
        </pc:picChg>
        <pc:picChg chg="add del mod topLvl">
          <ac:chgData name="Wencai Zhang" userId="4a86a1d0-2108-4707-8228-1110f3c1be85" providerId="ADAL" clId="{E2A8B6DA-8827-0C46-90CC-326C4459EA46}" dt="2021-06-10T15:10:55.239" v="3149" actId="478"/>
          <ac:picMkLst>
            <pc:docMk/>
            <pc:sldMk cId="1997077850" sldId="279"/>
            <ac:picMk id="257" creationId="{0DBDC239-3E3D-F845-8AD8-88A708F5FFE4}"/>
          </ac:picMkLst>
        </pc:picChg>
        <pc:picChg chg="add del mod topLvl">
          <ac:chgData name="Wencai Zhang" userId="4a86a1d0-2108-4707-8228-1110f3c1be85" providerId="ADAL" clId="{E2A8B6DA-8827-0C46-90CC-326C4459EA46}" dt="2021-06-09T13:04:26.232" v="1606" actId="478"/>
          <ac:picMkLst>
            <pc:docMk/>
            <pc:sldMk cId="1997077850" sldId="279"/>
            <ac:picMk id="258" creationId="{11D7137A-4442-8144-9A09-CAA6028DE1CA}"/>
          </ac:picMkLst>
        </pc:picChg>
        <pc:picChg chg="del topLvl">
          <ac:chgData name="Wencai Zhang" userId="4a86a1d0-2108-4707-8228-1110f3c1be85" providerId="ADAL" clId="{E2A8B6DA-8827-0C46-90CC-326C4459EA46}" dt="2021-06-09T13:04:20.783" v="1605" actId="478"/>
          <ac:picMkLst>
            <pc:docMk/>
            <pc:sldMk cId="1997077850" sldId="279"/>
            <ac:picMk id="259" creationId="{132246FD-5299-1E46-8E57-F79D4281CA11}"/>
          </ac:picMkLst>
        </pc:picChg>
        <pc:picChg chg="del mod topLvl">
          <ac:chgData name="Wencai Zhang" userId="4a86a1d0-2108-4707-8228-1110f3c1be85" providerId="ADAL" clId="{E2A8B6DA-8827-0C46-90CC-326C4459EA46}" dt="2021-06-10T15:10:55.239" v="3149" actId="478"/>
          <ac:picMkLst>
            <pc:docMk/>
            <pc:sldMk cId="1997077850" sldId="279"/>
            <ac:picMk id="260" creationId="{14F23759-9818-CA45-8EA0-74F2DD1BEA2F}"/>
          </ac:picMkLst>
        </pc:picChg>
        <pc:picChg chg="add mod modCrop">
          <ac:chgData name="Wencai Zhang" userId="4a86a1d0-2108-4707-8228-1110f3c1be85" providerId="ADAL" clId="{E2A8B6DA-8827-0C46-90CC-326C4459EA46}" dt="2021-06-15T16:56:42.472" v="4481" actId="164"/>
          <ac:picMkLst>
            <pc:docMk/>
            <pc:sldMk cId="1997077850" sldId="279"/>
            <ac:picMk id="267" creationId="{6303280E-8560-614F-99A9-CD6BBF21DDF2}"/>
          </ac:picMkLst>
        </pc:picChg>
      </pc:sldChg>
      <pc:sldChg chg="addSp delSp modSp add del ord">
        <pc:chgData name="Wencai Zhang" userId="4a86a1d0-2108-4707-8228-1110f3c1be85" providerId="ADAL" clId="{E2A8B6DA-8827-0C46-90CC-326C4459EA46}" dt="2021-06-16T14:18:25.279" v="4490" actId="2696"/>
        <pc:sldMkLst>
          <pc:docMk/>
          <pc:sldMk cId="2824219672" sldId="280"/>
        </pc:sldMkLst>
        <pc:spChg chg="del">
          <ac:chgData name="Wencai Zhang" userId="4a86a1d0-2108-4707-8228-1110f3c1be85" providerId="ADAL" clId="{E2A8B6DA-8827-0C46-90CC-326C4459EA46}" dt="2021-06-08T19:14:29.703" v="890" actId="478"/>
          <ac:spMkLst>
            <pc:docMk/>
            <pc:sldMk cId="2824219672" sldId="280"/>
            <ac:spMk id="2" creationId="{3FD78007-5F21-0342-9CD3-903015460C3B}"/>
          </ac:spMkLst>
        </pc:spChg>
        <pc:spChg chg="del">
          <ac:chgData name="Wencai Zhang" userId="4a86a1d0-2108-4707-8228-1110f3c1be85" providerId="ADAL" clId="{E2A8B6DA-8827-0C46-90CC-326C4459EA46}" dt="2021-06-08T19:14:31.649" v="891" actId="478"/>
          <ac:spMkLst>
            <pc:docMk/>
            <pc:sldMk cId="2824219672" sldId="280"/>
            <ac:spMk id="3" creationId="{74889938-7EDB-8741-85DD-6BCDF76F78C4}"/>
          </ac:spMkLst>
        </pc:spChg>
        <pc:spChg chg="add mod">
          <ac:chgData name="Wencai Zhang" userId="4a86a1d0-2108-4707-8228-1110f3c1be85" providerId="ADAL" clId="{E2A8B6DA-8827-0C46-90CC-326C4459EA46}" dt="2021-06-09T19:38:08.644" v="1938" actId="1076"/>
          <ac:spMkLst>
            <pc:docMk/>
            <pc:sldMk cId="2824219672" sldId="280"/>
            <ac:spMk id="4" creationId="{F22C4911-713B-3D42-9EDC-8EFD2A97CA95}"/>
          </ac:spMkLst>
        </pc:spChg>
        <pc:spChg chg="add mod">
          <ac:chgData name="Wencai Zhang" userId="4a86a1d0-2108-4707-8228-1110f3c1be85" providerId="ADAL" clId="{E2A8B6DA-8827-0C46-90CC-326C4459EA46}" dt="2021-06-09T19:38:11.265" v="1939" actId="1076"/>
          <ac:spMkLst>
            <pc:docMk/>
            <pc:sldMk cId="2824219672" sldId="280"/>
            <ac:spMk id="5" creationId="{A61503D3-A798-A843-99DC-C0890B8EB90D}"/>
          </ac:spMkLst>
        </pc:spChg>
        <pc:spChg chg="add del mod">
          <ac:chgData name="Wencai Zhang" userId="4a86a1d0-2108-4707-8228-1110f3c1be85" providerId="ADAL" clId="{E2A8B6DA-8827-0C46-90CC-326C4459EA46}" dt="2021-06-08T19:16:36.445" v="994" actId="478"/>
          <ac:spMkLst>
            <pc:docMk/>
            <pc:sldMk cId="2824219672" sldId="280"/>
            <ac:spMk id="6" creationId="{68260CF7-AA10-4042-A712-98B7F8F5316E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18" creationId="{67337AD7-27D8-5F41-8918-197867B8E700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19" creationId="{8170302C-66AE-9648-8013-2F5505DBA477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20" creationId="{953746E3-794C-644A-AECC-8147CA5EF376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21" creationId="{6ABF6523-ADEF-FE40-A1BE-FF4DF0CAEDD2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22" creationId="{F84662E9-1D9C-4948-8B3E-1E3FCEA2EE22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23" creationId="{7910FDAA-0D6B-234C-AFBB-45F00AB1CB15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4" creationId="{4951B5A5-77E5-8B40-9305-DA48BCCF4DD2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5" creationId="{4B48F309-4B04-2849-9018-DAECA64A43E2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6" creationId="{1043C152-4BCF-7445-AFD0-921E1A980437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7" creationId="{5790295E-413D-B14D-9DC9-D39C68F1E4D8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28" creationId="{D0850219-AAE5-C748-992C-4B3D3CF45BBF}"/>
          </ac:spMkLst>
        </pc:spChg>
        <pc:spChg chg="add del mod">
          <ac:chgData name="Wencai Zhang" userId="4a86a1d0-2108-4707-8228-1110f3c1be85" providerId="ADAL" clId="{E2A8B6DA-8827-0C46-90CC-326C4459EA46}" dt="2021-06-08T19:17:11.646" v="1001" actId="478"/>
          <ac:spMkLst>
            <pc:docMk/>
            <pc:sldMk cId="2824219672" sldId="280"/>
            <ac:spMk id="29" creationId="{D08AF15F-AEE2-094F-AC77-20366BDC0FCE}"/>
          </ac:spMkLst>
        </pc:spChg>
        <pc:spChg chg="add mod">
          <ac:chgData name="Wencai Zhang" userId="4a86a1d0-2108-4707-8228-1110f3c1be85" providerId="ADAL" clId="{E2A8B6DA-8827-0C46-90CC-326C4459EA46}" dt="2021-06-08T19:26:12.759" v="1198" actId="164"/>
          <ac:spMkLst>
            <pc:docMk/>
            <pc:sldMk cId="2824219672" sldId="280"/>
            <ac:spMk id="30" creationId="{60F26F1D-B7E1-A947-9DE9-7982B0D36155}"/>
          </ac:spMkLst>
        </pc:spChg>
        <pc:spChg chg="add del mod">
          <ac:chgData name="Wencai Zhang" userId="4a86a1d0-2108-4707-8228-1110f3c1be85" providerId="ADAL" clId="{E2A8B6DA-8827-0C46-90CC-326C4459EA46}" dt="2021-06-08T19:27:03.924" v="1257" actId="478"/>
          <ac:spMkLst>
            <pc:docMk/>
            <pc:sldMk cId="2824219672" sldId="280"/>
            <ac:spMk id="31" creationId="{496AD352-31D9-314F-963D-78AACB08067D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32" creationId="{658FC33E-4323-AA45-B0A3-7A8CC5E9D87A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33" creationId="{5D4308A8-2240-2448-81D3-B5F43380ADFD}"/>
          </ac:spMkLst>
        </pc:spChg>
        <pc:spChg chg="add mod">
          <ac:chgData name="Wencai Zhang" userId="4a86a1d0-2108-4707-8228-1110f3c1be85" providerId="ADAL" clId="{E2A8B6DA-8827-0C46-90CC-326C4459EA46}" dt="2021-06-09T19:38:44.813" v="1941" actId="164"/>
          <ac:spMkLst>
            <pc:docMk/>
            <pc:sldMk cId="2824219672" sldId="280"/>
            <ac:spMk id="34" creationId="{92AC1D9B-603A-7640-A2F1-8A65E25A968E}"/>
          </ac:spMkLst>
        </pc:spChg>
        <pc:spChg chg="add mod">
          <ac:chgData name="Wencai Zhang" userId="4a86a1d0-2108-4707-8228-1110f3c1be85" providerId="ADAL" clId="{E2A8B6DA-8827-0C46-90CC-326C4459EA46}" dt="2021-06-08T19:24:09.762" v="1189" actId="164"/>
          <ac:spMkLst>
            <pc:docMk/>
            <pc:sldMk cId="2824219672" sldId="280"/>
            <ac:spMk id="35" creationId="{36BCAD8B-DC06-E546-94F7-1797892BFE75}"/>
          </ac:spMkLst>
        </pc:spChg>
        <pc:spChg chg="add mod">
          <ac:chgData name="Wencai Zhang" userId="4a86a1d0-2108-4707-8228-1110f3c1be85" providerId="ADAL" clId="{E2A8B6DA-8827-0C46-90CC-326C4459EA46}" dt="2021-06-08T19:24:09.762" v="1189" actId="164"/>
          <ac:spMkLst>
            <pc:docMk/>
            <pc:sldMk cId="2824219672" sldId="280"/>
            <ac:spMk id="39" creationId="{81C04827-8CF7-8042-9DB3-B9C02F3E494F}"/>
          </ac:spMkLst>
        </pc:s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2" creationId="{1335DFE6-B6BF-AA4E-9943-EC05DAE7BD90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0" creationId="{20A9FC90-A594-4A4B-BC2A-3B78A5A61189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1" creationId="{00E1E6B1-6FCB-A14C-AF72-9FD13F07BF02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6" creationId="{81678502-E7BD-9541-835C-3DA4A4E1E295}"/>
          </ac:grpSpMkLst>
        </pc:grpChg>
        <pc:grpChg chg="add mod">
          <ac:chgData name="Wencai Zhang" userId="4a86a1d0-2108-4707-8228-1110f3c1be85" providerId="ADAL" clId="{E2A8B6DA-8827-0C46-90CC-326C4459EA46}" dt="2021-06-09T19:38:44.813" v="1941" actId="164"/>
          <ac:grpSpMkLst>
            <pc:docMk/>
            <pc:sldMk cId="2824219672" sldId="280"/>
            <ac:grpSpMk id="47" creationId="{15D8C616-F46D-8440-9626-1D70E781C42B}"/>
          </ac:grpSpMkLst>
        </pc:grpChg>
        <pc:picChg chg="add del mod">
          <ac:chgData name="Wencai Zhang" userId="4a86a1d0-2108-4707-8228-1110f3c1be85" providerId="ADAL" clId="{E2A8B6DA-8827-0C46-90CC-326C4459EA46}" dt="2021-06-09T19:27:26.076" v="1894" actId="478"/>
          <ac:picMkLst>
            <pc:docMk/>
            <pc:sldMk cId="2824219672" sldId="280"/>
            <ac:picMk id="7" creationId="{D5C63A55-8EF7-3C4D-98C2-6108CCF32CA2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8" creationId="{BF7EC27B-9257-D849-B511-7D2ED7FD452E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9" creationId="{6D338AF6-47FC-F84A-8900-1C713BE86CBD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10" creationId="{6FF993BF-DF55-FE44-B745-6C2BC1DA2B89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11" creationId="{D4506099-8C38-5648-B7B4-1FFF06907631}"/>
          </ac:picMkLst>
        </pc:picChg>
        <pc:picChg chg="add del mod">
          <ac:chgData name="Wencai Zhang" userId="4a86a1d0-2108-4707-8228-1110f3c1be85" providerId="ADAL" clId="{E2A8B6DA-8827-0C46-90CC-326C4459EA46}" dt="2021-06-09T19:32:55.904" v="1910" actId="478"/>
          <ac:picMkLst>
            <pc:docMk/>
            <pc:sldMk cId="2824219672" sldId="280"/>
            <ac:picMk id="12" creationId="{3AA609E4-0CEE-1E47-88C2-4BB5814B3E7C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3" creationId="{2514F730-346C-7C4C-A488-8EF38493B1B0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4" creationId="{6DB95CD7-0EE9-F341-970E-CA0B693C4805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5" creationId="{E7F45566-FD26-B749-A04D-CD9173F12F8E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6" creationId="{BEA9963B-0505-C34F-A7E9-2586A27B8A0A}"/>
          </ac:picMkLst>
        </pc:picChg>
        <pc:picChg chg="add del mod">
          <ac:chgData name="Wencai Zhang" userId="4a86a1d0-2108-4707-8228-1110f3c1be85" providerId="ADAL" clId="{E2A8B6DA-8827-0C46-90CC-326C4459EA46}" dt="2021-06-09T19:34:48.403" v="1913" actId="478"/>
          <ac:picMkLst>
            <pc:docMk/>
            <pc:sldMk cId="2824219672" sldId="280"/>
            <ac:picMk id="17" creationId="{DB68301C-101F-5848-A32A-D8A65866A3C7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4" creationId="{63819DC4-D49C-F449-98DC-3D527B970395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5" creationId="{A17934B8-99E0-3E46-A1B9-C2C685161D92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6" creationId="{E87779B1-E25E-3B45-87CF-E635A8CD732D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7" creationId="{3B94F0D8-B628-D748-AC62-CB64DAAAF97A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8" creationId="{78F69994-2141-8E45-B2DA-BFE1B272FFEE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59" creationId="{17360B66-DAD4-E54B-9765-51C47A0C5EA1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0" creationId="{DE4F13E8-FA90-5E44-829B-55C64C3BD9BA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1" creationId="{A9EA0072-C7B0-F341-9C56-9CFF6AE95820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2" creationId="{5FDEAA58-144E-7E43-94C8-E5D327B109E0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3" creationId="{5E788D42-A2C4-D546-92D2-42486BB2C01A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4" creationId="{C018E525-0524-1943-848F-4CC6BB4ADF96}"/>
          </ac:picMkLst>
        </pc:picChg>
        <pc:picChg chg="add mod">
          <ac:chgData name="Wencai Zhang" userId="4a86a1d0-2108-4707-8228-1110f3c1be85" providerId="ADAL" clId="{E2A8B6DA-8827-0C46-90CC-326C4459EA46}" dt="2021-06-09T19:38:44.813" v="1941" actId="164"/>
          <ac:picMkLst>
            <pc:docMk/>
            <pc:sldMk cId="2824219672" sldId="280"/>
            <ac:picMk id="65" creationId="{F31B81FD-13A0-804B-8EAF-DFB65552072B}"/>
          </ac:picMkLst>
        </pc:picChg>
        <pc:cxnChg chg="add mod">
          <ac:chgData name="Wencai Zhang" userId="4a86a1d0-2108-4707-8228-1110f3c1be85" providerId="ADAL" clId="{E2A8B6DA-8827-0C46-90CC-326C4459EA46}" dt="2021-06-08T19:24:09.762" v="1189" actId="164"/>
          <ac:cxnSpMkLst>
            <pc:docMk/>
            <pc:sldMk cId="2824219672" sldId="280"/>
            <ac:cxnSpMk id="37" creationId="{AE2C0C51-E322-FE4F-9E93-1CC05E5B9E90}"/>
          </ac:cxnSpMkLst>
        </pc:cxnChg>
        <pc:cxnChg chg="add mod">
          <ac:chgData name="Wencai Zhang" userId="4a86a1d0-2108-4707-8228-1110f3c1be85" providerId="ADAL" clId="{E2A8B6DA-8827-0C46-90CC-326C4459EA46}" dt="2021-06-08T19:24:09.762" v="1189" actId="164"/>
          <ac:cxnSpMkLst>
            <pc:docMk/>
            <pc:sldMk cId="2824219672" sldId="280"/>
            <ac:cxnSpMk id="38" creationId="{4EC3A846-47BD-AF44-A355-26CBDF836BA5}"/>
          </ac:cxnSpMkLst>
        </pc:cxnChg>
      </pc:sldChg>
      <pc:sldChg chg="addSp delSp modSp add ord">
        <pc:chgData name="Wencai Zhang" userId="4a86a1d0-2108-4707-8228-1110f3c1be85" providerId="ADAL" clId="{E2A8B6DA-8827-0C46-90CC-326C4459EA46}" dt="2021-06-10T15:48:39.173" v="3533" actId="20577"/>
        <pc:sldMkLst>
          <pc:docMk/>
          <pc:sldMk cId="1043719466" sldId="281"/>
        </pc:sldMkLst>
        <pc:spChg chg="del mod">
          <ac:chgData name="Wencai Zhang" userId="4a86a1d0-2108-4707-8228-1110f3c1be85" providerId="ADAL" clId="{E2A8B6DA-8827-0C46-90CC-326C4459EA46}" dt="2021-06-09T20:24:28.566" v="2643" actId="478"/>
          <ac:spMkLst>
            <pc:docMk/>
            <pc:sldMk cId="1043719466" sldId="281"/>
            <ac:spMk id="4" creationId="{F22C4911-713B-3D42-9EDC-8EFD2A97CA95}"/>
          </ac:spMkLst>
        </pc:spChg>
        <pc:spChg chg="mod">
          <ac:chgData name="Wencai Zhang" userId="4a86a1d0-2108-4707-8228-1110f3c1be85" providerId="ADAL" clId="{E2A8B6DA-8827-0C46-90CC-326C4459EA46}" dt="2021-06-10T15:48:39.173" v="3533" actId="20577"/>
          <ac:spMkLst>
            <pc:docMk/>
            <pc:sldMk cId="1043719466" sldId="281"/>
            <ac:spMk id="5" creationId="{A61503D3-A798-A843-99DC-C0890B8EB90D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23" creationId="{7910FDAA-0D6B-234C-AFBB-45F00AB1CB15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32" creationId="{658FC33E-4323-AA45-B0A3-7A8CC5E9D87A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33" creationId="{5D4308A8-2240-2448-81D3-B5F43380ADFD}"/>
          </ac:spMkLst>
        </pc:spChg>
        <pc:spChg chg="mod topLvl">
          <ac:chgData name="Wencai Zhang" userId="4a86a1d0-2108-4707-8228-1110f3c1be85" providerId="ADAL" clId="{E2A8B6DA-8827-0C46-90CC-326C4459EA46}" dt="2021-06-09T20:24:00.816" v="2636" actId="164"/>
          <ac:spMkLst>
            <pc:docMk/>
            <pc:sldMk cId="1043719466" sldId="281"/>
            <ac:spMk id="34" creationId="{92AC1D9B-603A-7640-A2F1-8A65E25A968E}"/>
          </ac:spMkLst>
        </pc:spChg>
        <pc:spChg chg="mod">
          <ac:chgData name="Wencai Zhang" userId="4a86a1d0-2108-4707-8228-1110f3c1be85" providerId="ADAL" clId="{E2A8B6DA-8827-0C46-90CC-326C4459EA46}" dt="2021-06-09T20:04:49.626" v="2143" actId="1038"/>
          <ac:spMkLst>
            <pc:docMk/>
            <pc:sldMk cId="1043719466" sldId="281"/>
            <ac:spMk id="35" creationId="{36BCAD8B-DC06-E546-94F7-1797892BFE75}"/>
          </ac:spMkLst>
        </pc:spChg>
        <pc:spChg chg="mod">
          <ac:chgData name="Wencai Zhang" userId="4a86a1d0-2108-4707-8228-1110f3c1be85" providerId="ADAL" clId="{E2A8B6DA-8827-0C46-90CC-326C4459EA46}" dt="2021-06-09T20:05:04.934" v="2148" actId="404"/>
          <ac:spMkLst>
            <pc:docMk/>
            <pc:sldMk cId="1043719466" sldId="281"/>
            <ac:spMk id="39" creationId="{81C04827-8CF7-8042-9DB3-B9C02F3E494F}"/>
          </ac:spMkLst>
        </pc:spChg>
        <pc:spChg chg="mod">
          <ac:chgData name="Wencai Zhang" userId="4a86a1d0-2108-4707-8228-1110f3c1be85" providerId="ADAL" clId="{E2A8B6DA-8827-0C46-90CC-326C4459EA46}" dt="2021-06-09T20:04:56.272" v="2146" actId="1038"/>
          <ac:spMkLst>
            <pc:docMk/>
            <pc:sldMk cId="1043719466" sldId="281"/>
            <ac:spMk id="42" creationId="{A315C128-B9F9-0847-A821-612DDECB15D4}"/>
          </ac:spMkLst>
        </pc:spChg>
        <pc:spChg chg="mod">
          <ac:chgData name="Wencai Zhang" userId="4a86a1d0-2108-4707-8228-1110f3c1be85" providerId="ADAL" clId="{E2A8B6DA-8827-0C46-90CC-326C4459EA46}" dt="2021-06-09T20:05:01.514" v="2147" actId="404"/>
          <ac:spMkLst>
            <pc:docMk/>
            <pc:sldMk cId="1043719466" sldId="281"/>
            <ac:spMk id="45" creationId="{AD7D2E81-BD15-954F-B83A-EA6902809D5E}"/>
          </ac:spMkLst>
        </pc:spChg>
        <pc:spChg chg="mod">
          <ac:chgData name="Wencai Zhang" userId="4a86a1d0-2108-4707-8228-1110f3c1be85" providerId="ADAL" clId="{E2A8B6DA-8827-0C46-90CC-326C4459EA46}" dt="2021-06-09T20:11:34.409" v="2467" actId="1076"/>
          <ac:spMkLst>
            <pc:docMk/>
            <pc:sldMk cId="1043719466" sldId="281"/>
            <ac:spMk id="48" creationId="{B78FE28C-BC4A-5540-94A2-004C5D22FDFC}"/>
          </ac:spMkLst>
        </pc:spChg>
        <pc:spChg chg="mod">
          <ac:chgData name="Wencai Zhang" userId="4a86a1d0-2108-4707-8228-1110f3c1be85" providerId="ADAL" clId="{E2A8B6DA-8827-0C46-90CC-326C4459EA46}" dt="2021-06-09T20:11:19.908" v="2464" actId="1076"/>
          <ac:spMkLst>
            <pc:docMk/>
            <pc:sldMk cId="1043719466" sldId="281"/>
            <ac:spMk id="49" creationId="{AC93C394-E9A9-EC41-BEB0-61C70AD6CFA6}"/>
          </ac:spMkLst>
        </pc:spChg>
        <pc:spChg chg="mod">
          <ac:chgData name="Wencai Zhang" userId="4a86a1d0-2108-4707-8228-1110f3c1be85" providerId="ADAL" clId="{E2A8B6DA-8827-0C46-90CC-326C4459EA46}" dt="2021-06-09T20:11:14.688" v="2463" actId="1076"/>
          <ac:spMkLst>
            <pc:docMk/>
            <pc:sldMk cId="1043719466" sldId="281"/>
            <ac:spMk id="50" creationId="{9B2B4651-50FA-7E4A-A006-4A1C6FEDA233}"/>
          </ac:spMkLst>
        </pc:spChg>
        <pc:spChg chg="mod">
          <ac:chgData name="Wencai Zhang" userId="4a86a1d0-2108-4707-8228-1110f3c1be85" providerId="ADAL" clId="{E2A8B6DA-8827-0C46-90CC-326C4459EA46}" dt="2021-06-09T20:10:56.104" v="2460" actId="1038"/>
          <ac:spMkLst>
            <pc:docMk/>
            <pc:sldMk cId="1043719466" sldId="281"/>
            <ac:spMk id="51" creationId="{17ABAE6A-D181-2342-A9D0-281DE88FA40B}"/>
          </ac:spMkLst>
        </pc:spChg>
        <pc:spChg chg="mod">
          <ac:chgData name="Wencai Zhang" userId="4a86a1d0-2108-4707-8228-1110f3c1be85" providerId="ADAL" clId="{E2A8B6DA-8827-0C46-90CC-326C4459EA46}" dt="2021-06-09T20:10:52.616" v="2459" actId="1076"/>
          <ac:spMkLst>
            <pc:docMk/>
            <pc:sldMk cId="1043719466" sldId="281"/>
            <ac:spMk id="52" creationId="{EA961B00-9378-424C-8E06-05C140A84F95}"/>
          </ac:spMkLst>
        </pc:spChg>
        <pc:spChg chg="mod">
          <ac:chgData name="Wencai Zhang" userId="4a86a1d0-2108-4707-8228-1110f3c1be85" providerId="ADAL" clId="{E2A8B6DA-8827-0C46-90CC-326C4459EA46}" dt="2021-06-09T20:06:52.170" v="2251" actId="120"/>
          <ac:spMkLst>
            <pc:docMk/>
            <pc:sldMk cId="1043719466" sldId="281"/>
            <ac:spMk id="53" creationId="{1B7AF82B-51B9-6B43-9EA6-A6A59E9BD638}"/>
          </ac:spMkLst>
        </pc:spChg>
        <pc:spChg chg="mod">
          <ac:chgData name="Wencai Zhang" userId="4a86a1d0-2108-4707-8228-1110f3c1be85" providerId="ADAL" clId="{E2A8B6DA-8827-0C46-90CC-326C4459EA46}" dt="2021-06-09T20:11:28.145" v="2466" actId="1076"/>
          <ac:spMkLst>
            <pc:docMk/>
            <pc:sldMk cId="1043719466" sldId="281"/>
            <ac:spMk id="67" creationId="{C4F48574-5B08-3245-9ADE-2C21CEFC31E4}"/>
          </ac:spMkLst>
        </pc:spChg>
        <pc:spChg chg="mod">
          <ac:chgData name="Wencai Zhang" userId="4a86a1d0-2108-4707-8228-1110f3c1be85" providerId="ADAL" clId="{E2A8B6DA-8827-0C46-90CC-326C4459EA46}" dt="2021-06-09T20:11:23.958" v="2465" actId="1076"/>
          <ac:spMkLst>
            <pc:docMk/>
            <pc:sldMk cId="1043719466" sldId="281"/>
            <ac:spMk id="68" creationId="{DC9B6FC2-76F9-9A4D-9658-385686304F65}"/>
          </ac:spMkLst>
        </pc:spChg>
        <pc:spChg chg="mod">
          <ac:chgData name="Wencai Zhang" userId="4a86a1d0-2108-4707-8228-1110f3c1be85" providerId="ADAL" clId="{E2A8B6DA-8827-0C46-90CC-326C4459EA46}" dt="2021-06-09T20:11:08.163" v="2462" actId="1076"/>
          <ac:spMkLst>
            <pc:docMk/>
            <pc:sldMk cId="1043719466" sldId="281"/>
            <ac:spMk id="69" creationId="{BFCD2AAD-A335-EB4A-A313-C242CA8F467D}"/>
          </ac:spMkLst>
        </pc:spChg>
        <pc:spChg chg="mod">
          <ac:chgData name="Wencai Zhang" userId="4a86a1d0-2108-4707-8228-1110f3c1be85" providerId="ADAL" clId="{E2A8B6DA-8827-0C46-90CC-326C4459EA46}" dt="2021-06-09T20:10:59.209" v="2461" actId="1038"/>
          <ac:spMkLst>
            <pc:docMk/>
            <pc:sldMk cId="1043719466" sldId="281"/>
            <ac:spMk id="70" creationId="{30283875-A937-AC40-8079-D37A3C976280}"/>
          </ac:spMkLst>
        </pc:spChg>
        <pc:spChg chg="mod">
          <ac:chgData name="Wencai Zhang" userId="4a86a1d0-2108-4707-8228-1110f3c1be85" providerId="ADAL" clId="{E2A8B6DA-8827-0C46-90CC-326C4459EA46}" dt="2021-06-09T20:10:18.449" v="2457" actId="1076"/>
          <ac:spMkLst>
            <pc:docMk/>
            <pc:sldMk cId="1043719466" sldId="281"/>
            <ac:spMk id="71" creationId="{5BEB9EB0-79C2-C54E-B71F-F519C9569CB8}"/>
          </ac:spMkLst>
        </pc:spChg>
        <pc:grpChg chg="del mod">
          <ac:chgData name="Wencai Zhang" userId="4a86a1d0-2108-4707-8228-1110f3c1be85" providerId="ADAL" clId="{E2A8B6DA-8827-0C46-90CC-326C4459EA46}" dt="2021-06-09T20:03:53.254" v="2125" actId="165"/>
          <ac:grpSpMkLst>
            <pc:docMk/>
            <pc:sldMk cId="1043719466" sldId="281"/>
            <ac:grpSpMk id="2" creationId="{1335DFE6-B6BF-AA4E-9943-EC05DAE7BD90}"/>
          </ac:grpSpMkLst>
        </pc:grpChg>
        <pc:grpChg chg="add mod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3" creationId="{8D389290-6337-6040-8C38-CCDA20CAB5A5}"/>
          </ac:grpSpMkLst>
        </pc:grpChg>
        <pc:grpChg chg="mod topLvl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40" creationId="{20A9FC90-A594-4A4B-BC2A-3B78A5A61189}"/>
          </ac:grpSpMkLst>
        </pc:grpChg>
        <pc:grpChg chg="mod topLvl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41" creationId="{00E1E6B1-6FCB-A14C-AF72-9FD13F07BF02}"/>
          </ac:grpSpMkLst>
        </pc:grpChg>
        <pc:grpChg chg="del mod topLvl">
          <ac:chgData name="Wencai Zhang" userId="4a86a1d0-2108-4707-8228-1110f3c1be85" providerId="ADAL" clId="{E2A8B6DA-8827-0C46-90CC-326C4459EA46}" dt="2021-06-09T20:23:51.678" v="2635" actId="478"/>
          <ac:grpSpMkLst>
            <pc:docMk/>
            <pc:sldMk cId="1043719466" sldId="281"/>
            <ac:grpSpMk id="46" creationId="{81678502-E7BD-9541-835C-3DA4A4E1E295}"/>
          </ac:grpSpMkLst>
        </pc:grpChg>
        <pc:grpChg chg="mod topLvl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47" creationId="{15D8C616-F46D-8440-9626-1D70E781C42B}"/>
          </ac:grpSpMkLst>
        </pc:grpChg>
        <pc:grpChg chg="add mod">
          <ac:chgData name="Wencai Zhang" userId="4a86a1d0-2108-4707-8228-1110f3c1be85" providerId="ADAL" clId="{E2A8B6DA-8827-0C46-90CC-326C4459EA46}" dt="2021-06-09T20:24:00.816" v="2636" actId="164"/>
          <ac:grpSpMkLst>
            <pc:docMk/>
            <pc:sldMk cId="1043719466" sldId="281"/>
            <ac:grpSpMk id="66" creationId="{85758ED7-179F-D34D-AC84-D340A3B19340}"/>
          </ac:grpSpMkLst>
        </pc:grp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4" creationId="{63819DC4-D49C-F449-98DC-3D527B970395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5" creationId="{A17934B8-99E0-3E46-A1B9-C2C685161D92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6" creationId="{E87779B1-E25E-3B45-87CF-E635A8CD732D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7" creationId="{3B94F0D8-B628-D748-AC62-CB64DAAAF97A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8" creationId="{78F69994-2141-8E45-B2DA-BFE1B272FFEE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59" creationId="{17360B66-DAD4-E54B-9765-51C47A0C5EA1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0" creationId="{DE4F13E8-FA90-5E44-829B-55C64C3BD9BA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1" creationId="{A9EA0072-C7B0-F341-9C56-9CFF6AE95820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2" creationId="{5FDEAA58-144E-7E43-94C8-E5D327B109E0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3" creationId="{5E788D42-A2C4-D546-92D2-42486BB2C01A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4" creationId="{C018E525-0524-1943-848F-4CC6BB4ADF96}"/>
          </ac:picMkLst>
        </pc:picChg>
        <pc:picChg chg="mod topLvl modCrop">
          <ac:chgData name="Wencai Zhang" userId="4a86a1d0-2108-4707-8228-1110f3c1be85" providerId="ADAL" clId="{E2A8B6DA-8827-0C46-90CC-326C4459EA46}" dt="2021-06-09T20:24:00.816" v="2636" actId="164"/>
          <ac:picMkLst>
            <pc:docMk/>
            <pc:sldMk cId="1043719466" sldId="281"/>
            <ac:picMk id="65" creationId="{F31B81FD-13A0-804B-8EAF-DFB65552072B}"/>
          </ac:picMkLst>
        </pc:picChg>
      </pc:sldChg>
      <pc:sldChg chg="addSp delSp modSp add">
        <pc:chgData name="Wencai Zhang" userId="4a86a1d0-2108-4707-8228-1110f3c1be85" providerId="ADAL" clId="{E2A8B6DA-8827-0C46-90CC-326C4459EA46}" dt="2021-06-09T20:22:16.800" v="2558"/>
        <pc:sldMkLst>
          <pc:docMk/>
          <pc:sldMk cId="826150303" sldId="282"/>
        </pc:sldMkLst>
        <pc:spChg chg="del">
          <ac:chgData name="Wencai Zhang" userId="4a86a1d0-2108-4707-8228-1110f3c1be85" providerId="ADAL" clId="{E2A8B6DA-8827-0C46-90CC-326C4459EA46}" dt="2021-06-09T20:12:13.333" v="2469" actId="478"/>
          <ac:spMkLst>
            <pc:docMk/>
            <pc:sldMk cId="826150303" sldId="282"/>
            <ac:spMk id="2" creationId="{1CCE7F85-7EA3-0846-BBC8-991261CC1603}"/>
          </ac:spMkLst>
        </pc:spChg>
        <pc:spChg chg="del">
          <ac:chgData name="Wencai Zhang" userId="4a86a1d0-2108-4707-8228-1110f3c1be85" providerId="ADAL" clId="{E2A8B6DA-8827-0C46-90CC-326C4459EA46}" dt="2021-06-09T20:12:13.333" v="2469" actId="478"/>
          <ac:spMkLst>
            <pc:docMk/>
            <pc:sldMk cId="826150303" sldId="282"/>
            <ac:spMk id="3" creationId="{5E5D3C0C-94FF-A149-B763-7FB4B5881664}"/>
          </ac:spMkLst>
        </pc:spChg>
        <pc:spChg chg="add mod">
          <ac:chgData name="Wencai Zhang" userId="4a86a1d0-2108-4707-8228-1110f3c1be85" providerId="ADAL" clId="{E2A8B6DA-8827-0C46-90CC-326C4459EA46}" dt="2021-06-09T20:22:16.800" v="2558"/>
          <ac:spMkLst>
            <pc:docMk/>
            <pc:sldMk cId="826150303" sldId="282"/>
            <ac:spMk id="4" creationId="{13FA72D1-139A-4B4D-99B6-5005D8A8C6BA}"/>
          </ac:spMkLst>
        </pc:spChg>
      </pc:sldChg>
      <pc:sldChg chg="add del">
        <pc:chgData name="Wencai Zhang" userId="4a86a1d0-2108-4707-8228-1110f3c1be85" providerId="ADAL" clId="{E2A8B6DA-8827-0C46-90CC-326C4459EA46}" dt="2021-06-16T14:18:28.007" v="4493" actId="2696"/>
        <pc:sldMkLst>
          <pc:docMk/>
          <pc:sldMk cId="1147003491" sldId="283"/>
        </pc:sldMkLst>
      </pc:sldChg>
      <pc:sldChg chg="addSp modSp add del">
        <pc:chgData name="Wencai Zhang" userId="4a86a1d0-2108-4707-8228-1110f3c1be85" providerId="ADAL" clId="{E2A8B6DA-8827-0C46-90CC-326C4459EA46}" dt="2021-06-16T14:18:48.304" v="4494" actId="2696"/>
        <pc:sldMkLst>
          <pc:docMk/>
          <pc:sldMk cId="1782915022" sldId="284"/>
        </pc:sldMkLst>
        <pc:spChg chg="mod">
          <ac:chgData name="Wencai Zhang" userId="4a86a1d0-2108-4707-8228-1110f3c1be85" providerId="ADAL" clId="{E2A8B6DA-8827-0C46-90CC-326C4459EA46}" dt="2021-06-10T15:25:10.816" v="3163" actId="58"/>
          <ac:spMkLst>
            <pc:docMk/>
            <pc:sldMk cId="1782915022" sldId="284"/>
            <ac:spMk id="18" creationId="{48FE6B3E-2944-1240-BA2E-E892823E1BAD}"/>
          </ac:spMkLst>
        </pc:spChg>
        <pc:picChg chg="add mod">
          <ac:chgData name="Wencai Zhang" userId="4a86a1d0-2108-4707-8228-1110f3c1be85" providerId="ADAL" clId="{E2A8B6DA-8827-0C46-90CC-326C4459EA46}" dt="2021-06-09T20:52:34.203" v="2760" actId="1076"/>
          <ac:picMkLst>
            <pc:docMk/>
            <pc:sldMk cId="1782915022" sldId="284"/>
            <ac:picMk id="2" creationId="{2C1EC9AD-ED33-F94B-9696-22EF69C6D9A6}"/>
          </ac:picMkLst>
        </pc:picChg>
        <pc:picChg chg="add mod">
          <ac:chgData name="Wencai Zhang" userId="4a86a1d0-2108-4707-8228-1110f3c1be85" providerId="ADAL" clId="{E2A8B6DA-8827-0C46-90CC-326C4459EA46}" dt="2021-06-09T20:52:48.255" v="2779" actId="1037"/>
          <ac:picMkLst>
            <pc:docMk/>
            <pc:sldMk cId="1782915022" sldId="284"/>
            <ac:picMk id="3" creationId="{2566D67C-CDCD-2744-87B0-713B42FAC828}"/>
          </ac:picMkLst>
        </pc:picChg>
        <pc:picChg chg="add mod">
          <ac:chgData name="Wencai Zhang" userId="4a86a1d0-2108-4707-8228-1110f3c1be85" providerId="ADAL" clId="{E2A8B6DA-8827-0C46-90CC-326C4459EA46}" dt="2021-06-09T20:53:10.671" v="2845" actId="1038"/>
          <ac:picMkLst>
            <pc:docMk/>
            <pc:sldMk cId="1782915022" sldId="284"/>
            <ac:picMk id="4" creationId="{BC9A9B2F-09B2-C448-8BAF-2F393BBCA1B6}"/>
          </ac:picMkLst>
        </pc:picChg>
        <pc:picChg chg="add mod">
          <ac:chgData name="Wencai Zhang" userId="4a86a1d0-2108-4707-8228-1110f3c1be85" providerId="ADAL" clId="{E2A8B6DA-8827-0C46-90CC-326C4459EA46}" dt="2021-06-09T20:52:34.203" v="2760" actId="1076"/>
          <ac:picMkLst>
            <pc:docMk/>
            <pc:sldMk cId="1782915022" sldId="284"/>
            <ac:picMk id="5" creationId="{0ABF3894-792E-394D-B2EF-ABB4C73E18DF}"/>
          </ac:picMkLst>
        </pc:picChg>
        <pc:picChg chg="add mod">
          <ac:chgData name="Wencai Zhang" userId="4a86a1d0-2108-4707-8228-1110f3c1be85" providerId="ADAL" clId="{E2A8B6DA-8827-0C46-90CC-326C4459EA46}" dt="2021-06-09T20:52:48.255" v="2779" actId="1037"/>
          <ac:picMkLst>
            <pc:docMk/>
            <pc:sldMk cId="1782915022" sldId="284"/>
            <ac:picMk id="6" creationId="{0BF710C7-4FF2-4A4B-B31B-1BBC852ED67E}"/>
          </ac:picMkLst>
        </pc:picChg>
        <pc:picChg chg="add mod">
          <ac:chgData name="Wencai Zhang" userId="4a86a1d0-2108-4707-8228-1110f3c1be85" providerId="ADAL" clId="{E2A8B6DA-8827-0C46-90CC-326C4459EA46}" dt="2021-06-09T20:53:05.106" v="2825" actId="1038"/>
          <ac:picMkLst>
            <pc:docMk/>
            <pc:sldMk cId="1782915022" sldId="284"/>
            <ac:picMk id="7" creationId="{92FA73BC-DDF9-F04F-B100-825759AB81F1}"/>
          </ac:picMkLst>
        </pc:picChg>
        <pc:picChg chg="add mod">
          <ac:chgData name="Wencai Zhang" userId="4a86a1d0-2108-4707-8228-1110f3c1be85" providerId="ADAL" clId="{E2A8B6DA-8827-0C46-90CC-326C4459EA46}" dt="2021-06-09T20:53:10.671" v="2845" actId="1038"/>
          <ac:picMkLst>
            <pc:docMk/>
            <pc:sldMk cId="1782915022" sldId="284"/>
            <ac:picMk id="8" creationId="{389677E2-9393-A44D-B779-EDCD1A2FBFEE}"/>
          </ac:picMkLst>
        </pc:picChg>
        <pc:picChg chg="add mod">
          <ac:chgData name="Wencai Zhang" userId="4a86a1d0-2108-4707-8228-1110f3c1be85" providerId="ADAL" clId="{E2A8B6DA-8827-0C46-90CC-326C4459EA46}" dt="2021-06-09T20:53:05.106" v="2825" actId="1038"/>
          <ac:picMkLst>
            <pc:docMk/>
            <pc:sldMk cId="1782915022" sldId="284"/>
            <ac:picMk id="9" creationId="{28A200BF-BCD6-5E4E-9A21-23542AB65BD1}"/>
          </ac:picMkLst>
        </pc:picChg>
        <pc:picChg chg="add mod">
          <ac:chgData name="Wencai Zhang" userId="4a86a1d0-2108-4707-8228-1110f3c1be85" providerId="ADAL" clId="{E2A8B6DA-8827-0C46-90CC-326C4459EA46}" dt="2021-06-09T20:53:05.106" v="2825" actId="1038"/>
          <ac:picMkLst>
            <pc:docMk/>
            <pc:sldMk cId="1782915022" sldId="284"/>
            <ac:picMk id="10" creationId="{1A850E40-855F-B34C-BD6A-070A89DC0389}"/>
          </ac:picMkLst>
        </pc:picChg>
        <pc:picChg chg="add mod">
          <ac:chgData name="Wencai Zhang" userId="4a86a1d0-2108-4707-8228-1110f3c1be85" providerId="ADAL" clId="{E2A8B6DA-8827-0C46-90CC-326C4459EA46}" dt="2021-06-09T20:53:10.671" v="2845" actId="1038"/>
          <ac:picMkLst>
            <pc:docMk/>
            <pc:sldMk cId="1782915022" sldId="284"/>
            <ac:picMk id="11" creationId="{E5F9C5FD-9AFC-7346-96E9-45B48C209323}"/>
          </ac:picMkLst>
        </pc:picChg>
        <pc:picChg chg="add mod modCrop">
          <ac:chgData name="Wencai Zhang" userId="4a86a1d0-2108-4707-8228-1110f3c1be85" providerId="ADAL" clId="{E2A8B6DA-8827-0C46-90CC-326C4459EA46}" dt="2021-06-09T20:52:34.203" v="2760" actId="1076"/>
          <ac:picMkLst>
            <pc:docMk/>
            <pc:sldMk cId="1782915022" sldId="284"/>
            <ac:picMk id="12" creationId="{FE702057-0C5D-7E49-9C47-64FB1E3812B3}"/>
          </ac:picMkLst>
        </pc:picChg>
        <pc:picChg chg="add mod">
          <ac:chgData name="Wencai Zhang" userId="4a86a1d0-2108-4707-8228-1110f3c1be85" providerId="ADAL" clId="{E2A8B6DA-8827-0C46-90CC-326C4459EA46}" dt="2021-06-09T20:52:48.255" v="2779" actId="1037"/>
          <ac:picMkLst>
            <pc:docMk/>
            <pc:sldMk cId="1782915022" sldId="284"/>
            <ac:picMk id="13" creationId="{E52D5ED8-E1CA-4A48-9529-4B26A87788B4}"/>
          </ac:picMkLst>
        </pc:picChg>
      </pc:sldChg>
      <pc:sldChg chg="add del">
        <pc:chgData name="Wencai Zhang" userId="4a86a1d0-2108-4707-8228-1110f3c1be85" providerId="ADAL" clId="{E2A8B6DA-8827-0C46-90CC-326C4459EA46}" dt="2021-06-16T14:18:27.962" v="4491" actId="2696"/>
        <pc:sldMkLst>
          <pc:docMk/>
          <pc:sldMk cId="1770098428" sldId="285"/>
        </pc:sldMkLst>
      </pc:sldChg>
      <pc:sldChg chg="add del">
        <pc:chgData name="Wencai Zhang" userId="4a86a1d0-2108-4707-8228-1110f3c1be85" providerId="ADAL" clId="{E2A8B6DA-8827-0C46-90CC-326C4459EA46}" dt="2021-06-16T14:18:27.963" v="4492" actId="2696"/>
        <pc:sldMkLst>
          <pc:docMk/>
          <pc:sldMk cId="246191213" sldId="286"/>
        </pc:sldMkLst>
      </pc:sldChg>
      <pc:sldChg chg="del">
        <pc:chgData name="Wencai Zhang" userId="4a86a1d0-2108-4707-8228-1110f3c1be85" providerId="ADAL" clId="{E2A8B6DA-8827-0C46-90CC-326C4459EA46}" dt="2021-06-16T14:18:52.361" v="4495" actId="2696"/>
        <pc:sldMkLst>
          <pc:docMk/>
          <pc:sldMk cId="3018879732" sldId="287"/>
        </pc:sldMkLst>
      </pc:sldChg>
      <pc:sldChg chg="addSp delSp modSp del">
        <pc:chgData name="Wencai Zhang" userId="4a86a1d0-2108-4707-8228-1110f3c1be85" providerId="ADAL" clId="{E2A8B6DA-8827-0C46-90CC-326C4459EA46}" dt="2021-06-16T14:19:14.318" v="4496" actId="2696"/>
        <pc:sldMkLst>
          <pc:docMk/>
          <pc:sldMk cId="2618164597" sldId="288"/>
        </pc:sldMkLst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8" creationId="{AD425D30-180C-F44B-BC0F-AB46C2288541}"/>
          </ac:spMkLst>
        </pc:spChg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9" creationId="{F5074D09-7D1B-9A4C-9F87-B89F5A8C0BDC}"/>
          </ac:spMkLst>
        </pc:spChg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10" creationId="{0AD59A7C-F730-5349-83F5-4D2F6E3A95C9}"/>
          </ac:spMkLst>
        </pc:spChg>
        <pc:spChg chg="mod">
          <ac:chgData name="Wencai Zhang" userId="4a86a1d0-2108-4707-8228-1110f3c1be85" providerId="ADAL" clId="{E2A8B6DA-8827-0C46-90CC-326C4459EA46}" dt="2021-06-10T15:23:42.762" v="3151" actId="1076"/>
          <ac:spMkLst>
            <pc:docMk/>
            <pc:sldMk cId="2618164597" sldId="288"/>
            <ac:spMk id="11" creationId="{B8FCA430-4CE4-0F41-BE81-45E048AA3622}"/>
          </ac:spMkLst>
        </pc:spChg>
        <pc:spChg chg="add del mod">
          <ac:chgData name="Wencai Zhang" userId="4a86a1d0-2108-4707-8228-1110f3c1be85" providerId="ADAL" clId="{E2A8B6DA-8827-0C46-90CC-326C4459EA46}" dt="2021-06-10T15:32:38.216" v="3166" actId="478"/>
          <ac:spMkLst>
            <pc:docMk/>
            <pc:sldMk cId="2618164597" sldId="288"/>
            <ac:spMk id="16" creationId="{D964768E-61B8-784D-879F-E8FBA1A12639}"/>
          </ac:spMkLst>
        </pc:spChg>
        <pc:spChg chg="add mod">
          <ac:chgData name="Wencai Zhang" userId="4a86a1d0-2108-4707-8228-1110f3c1be85" providerId="ADAL" clId="{E2A8B6DA-8827-0C46-90CC-326C4459EA46}" dt="2021-06-10T15:48:54.642" v="3534" actId="1076"/>
          <ac:spMkLst>
            <pc:docMk/>
            <pc:sldMk cId="2618164597" sldId="288"/>
            <ac:spMk id="17" creationId="{F9094744-A254-ED4B-9412-1225C99C71C9}"/>
          </ac:spMkLst>
        </pc:spChg>
        <pc:spChg chg="add mod">
          <ac:chgData name="Wencai Zhang" userId="4a86a1d0-2108-4707-8228-1110f3c1be85" providerId="ADAL" clId="{E2A8B6DA-8827-0C46-90CC-326C4459EA46}" dt="2021-06-10T15:35:52.899" v="3199" actId="20577"/>
          <ac:spMkLst>
            <pc:docMk/>
            <pc:sldMk cId="2618164597" sldId="288"/>
            <ac:spMk id="18" creationId="{B6C9F7EF-F83E-7B4A-9AC4-ED7EC9C4A676}"/>
          </ac:spMkLst>
        </pc:sp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4" creationId="{A70378F2-6CD0-974D-A4C3-ABA532790D9B}"/>
          </ac:picMkLst>
        </pc:pic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5" creationId="{FC2009B2-EA92-5E44-8B5A-9FEE474B56F7}"/>
          </ac:picMkLst>
        </pc:pic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6" creationId="{407BB3E7-4046-6F4E-A52B-06BA09B282B6}"/>
          </ac:picMkLst>
        </pc:picChg>
        <pc:picChg chg="mod">
          <ac:chgData name="Wencai Zhang" userId="4a86a1d0-2108-4707-8228-1110f3c1be85" providerId="ADAL" clId="{E2A8B6DA-8827-0C46-90CC-326C4459EA46}" dt="2021-06-10T15:23:42.762" v="3151" actId="1076"/>
          <ac:picMkLst>
            <pc:docMk/>
            <pc:sldMk cId="2618164597" sldId="288"/>
            <ac:picMk id="7" creationId="{BCB39BBF-C93F-1E46-A842-94EC72E6811D}"/>
          </ac:picMkLst>
        </pc:picChg>
        <pc:picChg chg="mod">
          <ac:chgData name="Wencai Zhang" userId="4a86a1d0-2108-4707-8228-1110f3c1be85" providerId="ADAL" clId="{E2A8B6DA-8827-0C46-90CC-326C4459EA46}" dt="2021-06-10T15:36:42.423" v="3217" actId="1076"/>
          <ac:picMkLst>
            <pc:docMk/>
            <pc:sldMk cId="2618164597" sldId="288"/>
            <ac:picMk id="12" creationId="{88CCFCCA-6EA5-944C-BD29-5310C642C95A}"/>
          </ac:picMkLst>
        </pc:picChg>
        <pc:picChg chg="mod">
          <ac:chgData name="Wencai Zhang" userId="4a86a1d0-2108-4707-8228-1110f3c1be85" providerId="ADAL" clId="{E2A8B6DA-8827-0C46-90CC-326C4459EA46}" dt="2021-06-10T15:36:36.494" v="3216" actId="1076"/>
          <ac:picMkLst>
            <pc:docMk/>
            <pc:sldMk cId="2618164597" sldId="288"/>
            <ac:picMk id="13" creationId="{12413FC3-E88D-1A4B-B4C6-BE3208E1A414}"/>
          </ac:picMkLst>
        </pc:picChg>
        <pc:picChg chg="mod">
          <ac:chgData name="Wencai Zhang" userId="4a86a1d0-2108-4707-8228-1110f3c1be85" providerId="ADAL" clId="{E2A8B6DA-8827-0C46-90CC-326C4459EA46}" dt="2021-06-10T15:37:35.107" v="3222" actId="1076"/>
          <ac:picMkLst>
            <pc:docMk/>
            <pc:sldMk cId="2618164597" sldId="288"/>
            <ac:picMk id="14" creationId="{855AD729-0FA4-4B4A-95AC-7BC5C0283E08}"/>
          </ac:picMkLst>
        </pc:picChg>
        <pc:picChg chg="mod">
          <ac:chgData name="Wencai Zhang" userId="4a86a1d0-2108-4707-8228-1110f3c1be85" providerId="ADAL" clId="{E2A8B6DA-8827-0C46-90CC-326C4459EA46}" dt="2021-06-10T15:37:36.727" v="3223" actId="1076"/>
          <ac:picMkLst>
            <pc:docMk/>
            <pc:sldMk cId="2618164597" sldId="288"/>
            <ac:picMk id="15" creationId="{5222F7E0-9FDB-474D-99B8-9E4023F43408}"/>
          </ac:picMkLst>
        </pc:picChg>
        <pc:picChg chg="add mod">
          <ac:chgData name="Wencai Zhang" userId="4a86a1d0-2108-4707-8228-1110f3c1be85" providerId="ADAL" clId="{E2A8B6DA-8827-0C46-90CC-326C4459EA46}" dt="2021-06-10T15:37:11.222" v="3221" actId="1076"/>
          <ac:picMkLst>
            <pc:docMk/>
            <pc:sldMk cId="2618164597" sldId="288"/>
            <ac:picMk id="19" creationId="{2AB27531-117E-814D-BC03-92D623D8D5E0}"/>
          </ac:picMkLst>
        </pc:picChg>
        <pc:picChg chg="add mod">
          <ac:chgData name="Wencai Zhang" userId="4a86a1d0-2108-4707-8228-1110f3c1be85" providerId="ADAL" clId="{E2A8B6DA-8827-0C46-90CC-326C4459EA46}" dt="2021-06-10T15:37:06.700" v="3220" actId="1076"/>
          <ac:picMkLst>
            <pc:docMk/>
            <pc:sldMk cId="2618164597" sldId="288"/>
            <ac:picMk id="20" creationId="{0DBE94E7-E0B2-5C41-A759-787852130B5F}"/>
          </ac:picMkLst>
        </pc:picChg>
      </pc:sldChg>
      <pc:sldChg chg="addSp delSp modSp add ord">
        <pc:chgData name="Wencai Zhang" userId="4a86a1d0-2108-4707-8228-1110f3c1be85" providerId="ADAL" clId="{E2A8B6DA-8827-0C46-90CC-326C4459EA46}" dt="2021-06-16T14:23:38.802" v="4663" actId="20577"/>
        <pc:sldMkLst>
          <pc:docMk/>
          <pc:sldMk cId="3169542940" sldId="289"/>
        </pc:sldMkLst>
        <pc:spChg chg="add mod">
          <ac:chgData name="Wencai Zhang" userId="4a86a1d0-2108-4707-8228-1110f3c1be85" providerId="ADAL" clId="{E2A8B6DA-8827-0C46-90CC-326C4459EA46}" dt="2021-06-16T14:23:38.802" v="4663" actId="20577"/>
          <ac:spMkLst>
            <pc:docMk/>
            <pc:sldMk cId="3169542940" sldId="289"/>
            <ac:spMk id="2" creationId="{086BC700-3805-7D4C-A7D6-71D52151F333}"/>
          </ac:spMkLst>
        </pc:spChg>
        <pc:spChg chg="del">
          <ac:chgData name="Wencai Zhang" userId="4a86a1d0-2108-4707-8228-1110f3c1be85" providerId="ADAL" clId="{E2A8B6DA-8827-0C46-90CC-326C4459EA46}" dt="2021-06-10T15:24:41.800" v="3161" actId="478"/>
          <ac:spMkLst>
            <pc:docMk/>
            <pc:sldMk cId="3169542940" sldId="289"/>
            <ac:spMk id="2" creationId="{49418D4E-53A2-0B4D-8417-241E48BFE257}"/>
          </ac:spMkLst>
        </pc:spChg>
        <pc:spChg chg="del">
          <ac:chgData name="Wencai Zhang" userId="4a86a1d0-2108-4707-8228-1110f3c1be85" providerId="ADAL" clId="{E2A8B6DA-8827-0C46-90CC-326C4459EA46}" dt="2021-06-10T15:24:41.800" v="3161" actId="478"/>
          <ac:spMkLst>
            <pc:docMk/>
            <pc:sldMk cId="3169542940" sldId="289"/>
            <ac:spMk id="3" creationId="{04949BFA-6ACD-EA4D-B0B0-13064DB5F9C9}"/>
          </ac:spMkLst>
        </pc:spChg>
        <pc:spChg chg="add">
          <ac:chgData name="Wencai Zhang" userId="4a86a1d0-2108-4707-8228-1110f3c1be85" providerId="ADAL" clId="{E2A8B6DA-8827-0C46-90CC-326C4459EA46}" dt="2021-06-16T14:23:02.360" v="4657"/>
          <ac:spMkLst>
            <pc:docMk/>
            <pc:sldMk cId="3169542940" sldId="289"/>
            <ac:spMk id="7" creationId="{C8C8990A-8565-374C-8804-C5FBB15048CA}"/>
          </ac:spMkLst>
        </pc:spChg>
        <pc:spChg chg="add">
          <ac:chgData name="Wencai Zhang" userId="4a86a1d0-2108-4707-8228-1110f3c1be85" providerId="ADAL" clId="{E2A8B6DA-8827-0C46-90CC-326C4459EA46}" dt="2021-06-16T14:23:02.360" v="4657"/>
          <ac:spMkLst>
            <pc:docMk/>
            <pc:sldMk cId="3169542940" sldId="289"/>
            <ac:spMk id="8" creationId="{E8B59354-156E-5A4B-90D9-95FA6BDC0488}"/>
          </ac:spMkLst>
        </pc:sp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3" creationId="{3ABF22E1-7A07-C84C-8705-A0C68F3C260F}"/>
          </ac:picMkLst>
        </pc:pic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4" creationId="{A6AF6697-2ED6-8A42-890D-8A5CBBAE5C91}"/>
          </ac:picMkLst>
        </pc:pic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5" creationId="{919D6214-F343-234D-8E9B-0A5377F85DFA}"/>
          </ac:picMkLst>
        </pc:picChg>
        <pc:picChg chg="add mod">
          <ac:chgData name="Wencai Zhang" userId="4a86a1d0-2108-4707-8228-1110f3c1be85" providerId="ADAL" clId="{E2A8B6DA-8827-0C46-90CC-326C4459EA46}" dt="2021-06-16T14:22:53.171" v="4656" actId="1037"/>
          <ac:picMkLst>
            <pc:docMk/>
            <pc:sldMk cId="3169542940" sldId="289"/>
            <ac:picMk id="6" creationId="{B768EE85-561C-CF46-9C0E-8B9D94FBE23A}"/>
          </ac:picMkLst>
        </pc:picChg>
      </pc:sldChg>
      <pc:sldChg chg="modSp">
        <pc:chgData name="Wencai Zhang" userId="4a86a1d0-2108-4707-8228-1110f3c1be85" providerId="ADAL" clId="{E2A8B6DA-8827-0C46-90CC-326C4459EA46}" dt="2021-06-16T14:23:31.658" v="4660" actId="20577"/>
        <pc:sldMkLst>
          <pc:docMk/>
          <pc:sldMk cId="3497662403" sldId="290"/>
        </pc:sldMkLst>
        <pc:spChg chg="mod">
          <ac:chgData name="Wencai Zhang" userId="4a86a1d0-2108-4707-8228-1110f3c1be85" providerId="ADAL" clId="{E2A8B6DA-8827-0C46-90CC-326C4459EA46}" dt="2021-06-16T14:23:31.658" v="4660" actId="20577"/>
          <ac:spMkLst>
            <pc:docMk/>
            <pc:sldMk cId="3497662403" sldId="290"/>
            <ac:spMk id="8" creationId="{A4F20A6F-D30A-9040-ACD4-2B63464D1625}"/>
          </ac:spMkLst>
        </pc:spChg>
      </pc:sldChg>
    </pc:docChg>
  </pc:docChgLst>
  <pc:docChgLst>
    <pc:chgData name="Nicholas Skiados" userId="gyL5hJDrj+hZHFpDSneZU1h6zJeED3y/2O9IVXLr5ag=" providerId="None" clId="Web-{D4EA0971-6E17-4D37-BB93-291A8CFE9B33}"/>
    <pc:docChg chg="modSld">
      <pc:chgData name="Nicholas Skiados" userId="gyL5hJDrj+hZHFpDSneZU1h6zJeED3y/2O9IVXLr5ag=" providerId="None" clId="Web-{D4EA0971-6E17-4D37-BB93-291A8CFE9B33}" dt="2021-06-17T15:33:07.160" v="24" actId="1076"/>
      <pc:docMkLst>
        <pc:docMk/>
      </pc:docMkLst>
      <pc:sldChg chg="addSp modSp">
        <pc:chgData name="Nicholas Skiados" userId="gyL5hJDrj+hZHFpDSneZU1h6zJeED3y/2O9IVXLr5ag=" providerId="None" clId="Web-{D4EA0971-6E17-4D37-BB93-291A8CFE9B33}" dt="2021-06-17T15:33:07.160" v="24" actId="1076"/>
        <pc:sldMkLst>
          <pc:docMk/>
          <pc:sldMk cId="4133689721" sldId="291"/>
        </pc:sldMkLst>
        <pc:spChg chg="add mod">
          <ac:chgData name="Nicholas Skiados" userId="gyL5hJDrj+hZHFpDSneZU1h6zJeED3y/2O9IVXLr5ag=" providerId="None" clId="Web-{D4EA0971-6E17-4D37-BB93-291A8CFE9B33}" dt="2021-06-17T15:30:59.903" v="13" actId="1076"/>
          <ac:spMkLst>
            <pc:docMk/>
            <pc:sldMk cId="4133689721" sldId="291"/>
            <ac:spMk id="2" creationId="{531A11DB-C16A-474F-B52F-315BD512D038}"/>
          </ac:spMkLst>
        </pc:spChg>
        <pc:spChg chg="mod">
          <ac:chgData name="Nicholas Skiados" userId="gyL5hJDrj+hZHFpDSneZU1h6zJeED3y/2O9IVXLr5ag=" providerId="None" clId="Web-{D4EA0971-6E17-4D37-BB93-291A8CFE9B33}" dt="2021-06-17T15:31:26.967" v="17" actId="1076"/>
          <ac:spMkLst>
            <pc:docMk/>
            <pc:sldMk cId="4133689721" sldId="291"/>
            <ac:spMk id="3" creationId="{0E974834-8482-4440-809E-90B06CCA30F4}"/>
          </ac:spMkLst>
        </pc:spChg>
        <pc:spChg chg="mod">
          <ac:chgData name="Nicholas Skiados" userId="gyL5hJDrj+hZHFpDSneZU1h6zJeED3y/2O9IVXLr5ag=" providerId="None" clId="Web-{D4EA0971-6E17-4D37-BB93-291A8CFE9B33}" dt="2021-06-17T15:30:23.636" v="8" actId="1076"/>
          <ac:spMkLst>
            <pc:docMk/>
            <pc:sldMk cId="4133689721" sldId="291"/>
            <ac:spMk id="6" creationId="{89E84565-00A9-4750-B41B-2E8C35E6E19E}"/>
          </ac:spMkLst>
        </pc:spChg>
        <pc:spChg chg="mod">
          <ac:chgData name="Nicholas Skiados" userId="gyL5hJDrj+hZHFpDSneZU1h6zJeED3y/2O9IVXLr5ag=" providerId="None" clId="Web-{D4EA0971-6E17-4D37-BB93-291A8CFE9B33}" dt="2021-06-17T15:30:14.823" v="7" actId="1076"/>
          <ac:spMkLst>
            <pc:docMk/>
            <pc:sldMk cId="4133689721" sldId="291"/>
            <ac:spMk id="19" creationId="{8FC308FE-67D9-462A-8257-A4D83AB04510}"/>
          </ac:spMkLst>
        </pc:spChg>
        <pc:spChg chg="mod">
          <ac:chgData name="Nicholas Skiados" userId="gyL5hJDrj+hZHFpDSneZU1h6zJeED3y/2O9IVXLr5ag=" providerId="None" clId="Web-{D4EA0971-6E17-4D37-BB93-291A8CFE9B33}" dt="2021-06-17T15:30:05.228" v="6" actId="1076"/>
          <ac:spMkLst>
            <pc:docMk/>
            <pc:sldMk cId="4133689721" sldId="291"/>
            <ac:spMk id="20" creationId="{A63A11BB-DB3A-4A54-BAF1-74AE2A54977B}"/>
          </ac:spMkLst>
        </pc:spChg>
        <pc:spChg chg="mod">
          <ac:chgData name="Nicholas Skiados" userId="gyL5hJDrj+hZHFpDSneZU1h6zJeED3y/2O9IVXLr5ag=" providerId="None" clId="Web-{D4EA0971-6E17-4D37-BB93-291A8CFE9B33}" dt="2021-06-17T15:29:35.320" v="1" actId="1076"/>
          <ac:spMkLst>
            <pc:docMk/>
            <pc:sldMk cId="4133689721" sldId="291"/>
            <ac:spMk id="23" creationId="{BF22E72B-2A8D-41E6-ACA0-C367E0060262}"/>
          </ac:spMkLst>
        </pc:spChg>
        <pc:spChg chg="mod">
          <ac:chgData name="Nicholas Skiados" userId="gyL5hJDrj+hZHFpDSneZU1h6zJeED3y/2O9IVXLr5ag=" providerId="None" clId="Web-{D4EA0971-6E17-4D37-BB93-291A8CFE9B33}" dt="2021-06-17T15:30:45.684" v="11" actId="1076"/>
          <ac:spMkLst>
            <pc:docMk/>
            <pc:sldMk cId="4133689721" sldId="291"/>
            <ac:spMk id="24" creationId="{3E97C167-C4E6-4114-A077-39E0D0186BBE}"/>
          </ac:spMkLst>
        </pc:spChg>
        <pc:spChg chg="mod">
          <ac:chgData name="Nicholas Skiados" userId="gyL5hJDrj+hZHFpDSneZU1h6zJeED3y/2O9IVXLr5ag=" providerId="None" clId="Web-{D4EA0971-6E17-4D37-BB93-291A8CFE9B33}" dt="2021-06-17T15:29:44.212" v="3" actId="1076"/>
          <ac:spMkLst>
            <pc:docMk/>
            <pc:sldMk cId="4133689721" sldId="291"/>
            <ac:spMk id="87" creationId="{10943836-76F0-4359-8724-99CA98811398}"/>
          </ac:spMkLst>
        </pc:spChg>
        <pc:spChg chg="mod">
          <ac:chgData name="Nicholas Skiados" userId="gyL5hJDrj+hZHFpDSneZU1h6zJeED3y/2O9IVXLr5ag=" providerId="None" clId="Web-{D4EA0971-6E17-4D37-BB93-291A8CFE9B33}" dt="2021-06-17T15:33:07.160" v="24" actId="1076"/>
          <ac:spMkLst>
            <pc:docMk/>
            <pc:sldMk cId="4133689721" sldId="291"/>
            <ac:spMk id="121" creationId="{D6CB511F-139C-41D4-8250-3CE8C1C529A2}"/>
          </ac:spMkLst>
        </pc:spChg>
        <pc:spChg chg="mod">
          <ac:chgData name="Nicholas Skiados" userId="gyL5hJDrj+hZHFpDSneZU1h6zJeED3y/2O9IVXLr5ag=" providerId="None" clId="Web-{D4EA0971-6E17-4D37-BB93-291A8CFE9B33}" dt="2021-06-17T15:32:53.113" v="22" actId="1076"/>
          <ac:spMkLst>
            <pc:docMk/>
            <pc:sldMk cId="4133689721" sldId="291"/>
            <ac:spMk id="124" creationId="{9DD241D0-FA5A-46DA-805C-C56E7116101A}"/>
          </ac:spMkLst>
        </pc:spChg>
        <pc:spChg chg="mod">
          <ac:chgData name="Nicholas Skiados" userId="gyL5hJDrj+hZHFpDSneZU1h6zJeED3y/2O9IVXLr5ag=" providerId="None" clId="Web-{D4EA0971-6E17-4D37-BB93-291A8CFE9B33}" dt="2021-06-17T15:32:48.628" v="21" actId="1076"/>
          <ac:spMkLst>
            <pc:docMk/>
            <pc:sldMk cId="4133689721" sldId="291"/>
            <ac:spMk id="125" creationId="{5949CED8-518B-4502-9EFE-E1900364B0C4}"/>
          </ac:spMkLst>
        </pc:spChg>
        <pc:spChg chg="mod">
          <ac:chgData name="Nicholas Skiados" userId="gyL5hJDrj+hZHFpDSneZU1h6zJeED3y/2O9IVXLr5ag=" providerId="None" clId="Web-{D4EA0971-6E17-4D37-BB93-291A8CFE9B33}" dt="2021-06-17T15:32:44.487" v="20" actId="1076"/>
          <ac:spMkLst>
            <pc:docMk/>
            <pc:sldMk cId="4133689721" sldId="291"/>
            <ac:spMk id="127" creationId="{855AF6B0-3ACF-44FA-9737-1415FC3FF6CF}"/>
          </ac:spMkLst>
        </pc:spChg>
        <pc:spChg chg="mod">
          <ac:chgData name="Nicholas Skiados" userId="gyL5hJDrj+hZHFpDSneZU1h6zJeED3y/2O9IVXLr5ag=" providerId="None" clId="Web-{D4EA0971-6E17-4D37-BB93-291A8CFE9B33}" dt="2021-06-17T15:32:36.253" v="19" actId="1076"/>
          <ac:spMkLst>
            <pc:docMk/>
            <pc:sldMk cId="4133689721" sldId="291"/>
            <ac:spMk id="128" creationId="{E1E6E364-D220-4501-AFB7-E5A4AE205604}"/>
          </ac:spMkLst>
        </pc:spChg>
        <pc:grpChg chg="mod">
          <ac:chgData name="Nicholas Skiados" userId="gyL5hJDrj+hZHFpDSneZU1h6zJeED3y/2O9IVXLr5ag=" providerId="None" clId="Web-{D4EA0971-6E17-4D37-BB93-291A8CFE9B33}" dt="2021-06-17T15:31:22.639" v="16" actId="1076"/>
          <ac:grpSpMkLst>
            <pc:docMk/>
            <pc:sldMk cId="4133689721" sldId="291"/>
            <ac:grpSpMk id="10" creationId="{5FFDB581-28EA-4CF8-9D80-C21FAA8AD78B}"/>
          </ac:grpSpMkLst>
        </pc:grpChg>
        <pc:grpChg chg="mod">
          <ac:chgData name="Nicholas Skiados" userId="gyL5hJDrj+hZHFpDSneZU1h6zJeED3y/2O9IVXLr5ag=" providerId="None" clId="Web-{D4EA0971-6E17-4D37-BB93-291A8CFE9B33}" dt="2021-06-17T15:33:00.879" v="23" actId="1076"/>
          <ac:grpSpMkLst>
            <pc:docMk/>
            <pc:sldMk cId="4133689721" sldId="291"/>
            <ac:grpSpMk id="11" creationId="{9B6EA788-4148-4A0F-B9B5-A47882718B60}"/>
          </ac:grpSpMkLst>
        </pc:grpChg>
        <pc:grpChg chg="mod">
          <ac:chgData name="Nicholas Skiados" userId="gyL5hJDrj+hZHFpDSneZU1h6zJeED3y/2O9IVXLr5ag=" providerId="None" clId="Web-{D4EA0971-6E17-4D37-BB93-291A8CFE9B33}" dt="2021-06-17T15:32:30.362" v="18" actId="1076"/>
          <ac:grpSpMkLst>
            <pc:docMk/>
            <pc:sldMk cId="4133689721" sldId="291"/>
            <ac:grpSpMk id="12" creationId="{3AF54EC6-A750-467B-91D8-C4F39AB6EC99}"/>
          </ac:grpSpMkLst>
        </pc:grpChg>
        <pc:grpChg chg="mod">
          <ac:chgData name="Nicholas Skiados" userId="gyL5hJDrj+hZHFpDSneZU1h6zJeED3y/2O9IVXLr5ag=" providerId="None" clId="Web-{D4EA0971-6E17-4D37-BB93-291A8CFE9B33}" dt="2021-06-17T15:29:54.822" v="4" actId="1076"/>
          <ac:grpSpMkLst>
            <pc:docMk/>
            <pc:sldMk cId="4133689721" sldId="291"/>
            <ac:grpSpMk id="13" creationId="{EFFB9AEE-3FB8-499F-8081-641918985D0B}"/>
          </ac:grpSpMkLst>
        </pc:grpChg>
        <pc:grpChg chg="mod">
          <ac:chgData name="Nicholas Skiados" userId="gyL5hJDrj+hZHFpDSneZU1h6zJeED3y/2O9IVXLr5ag=" providerId="None" clId="Web-{D4EA0971-6E17-4D37-BB93-291A8CFE9B33}" dt="2021-06-17T15:30:30.620" v="9" actId="1076"/>
          <ac:grpSpMkLst>
            <pc:docMk/>
            <pc:sldMk cId="4133689721" sldId="291"/>
            <ac:grpSpMk id="14" creationId="{D5F7F827-893F-4BC5-B898-F40FAFF99A29}"/>
          </ac:grpSpMkLst>
        </pc:grpChg>
        <pc:grpChg chg="mod">
          <ac:chgData name="Nicholas Skiados" userId="gyL5hJDrj+hZHFpDSneZU1h6zJeED3y/2O9IVXLr5ag=" providerId="None" clId="Web-{D4EA0971-6E17-4D37-BB93-291A8CFE9B33}" dt="2021-06-17T15:31:09.060" v="14" actId="1076"/>
          <ac:grpSpMkLst>
            <pc:docMk/>
            <pc:sldMk cId="4133689721" sldId="291"/>
            <ac:grpSpMk id="36" creationId="{00308009-BF9B-40C1-BBA6-2AF3C82A16A4}"/>
          </ac:grpSpMkLst>
        </pc:grpChg>
        <pc:picChg chg="mod">
          <ac:chgData name="Nicholas Skiados" userId="gyL5hJDrj+hZHFpDSneZU1h6zJeED3y/2O9IVXLr5ag=" providerId="None" clId="Web-{D4EA0971-6E17-4D37-BB93-291A8CFE9B33}" dt="2021-06-17T15:31:14.560" v="15" actId="1076"/>
          <ac:picMkLst>
            <pc:docMk/>
            <pc:sldMk cId="4133689721" sldId="291"/>
            <ac:picMk id="81" creationId="{BE92BD88-DCA3-4340-A32C-86E24907DA79}"/>
          </ac:picMkLst>
        </pc:picChg>
        <pc:picChg chg="mod">
          <ac:chgData name="Nicholas Skiados" userId="gyL5hJDrj+hZHFpDSneZU1h6zJeED3y/2O9IVXLr5ag=" providerId="None" clId="Web-{D4EA0971-6E17-4D37-BB93-291A8CFE9B33}" dt="2021-06-17T15:30:35.574" v="10" actId="1076"/>
          <ac:picMkLst>
            <pc:docMk/>
            <pc:sldMk cId="4133689721" sldId="291"/>
            <ac:picMk id="84" creationId="{9F2AA289-39DA-4F8F-A3F6-9329A4DB85F7}"/>
          </ac:picMkLst>
        </pc:picChg>
        <pc:picChg chg="mod">
          <ac:chgData name="Nicholas Skiados" userId="gyL5hJDrj+hZHFpDSneZU1h6zJeED3y/2O9IVXLr5ag=" providerId="None" clId="Web-{D4EA0971-6E17-4D37-BB93-291A8CFE9B33}" dt="2021-06-17T15:29:38.977" v="2" actId="1076"/>
          <ac:picMkLst>
            <pc:docMk/>
            <pc:sldMk cId="4133689721" sldId="291"/>
            <ac:picMk id="85" creationId="{BC52D881-4878-435B-835B-02EB8A51FBC2}"/>
          </ac:picMkLst>
        </pc:picChg>
      </pc:sldChg>
    </pc:docChg>
  </pc:docChgLst>
  <pc:docChgLst>
    <pc:chgData name="Wencai Zhang" userId="4a86a1d0-2108-4707-8228-1110f3c1be85" providerId="ADAL" clId="{A45B31E0-981A-6046-8AF7-6AF718FF8717}"/>
    <pc:docChg chg="undo custSel delSld modSld sldOrd">
      <pc:chgData name="Wencai Zhang" userId="4a86a1d0-2108-4707-8228-1110f3c1be85" providerId="ADAL" clId="{A45B31E0-981A-6046-8AF7-6AF718FF8717}" dt="2022-05-02T01:13:36.365" v="1074" actId="20577"/>
      <pc:docMkLst>
        <pc:docMk/>
      </pc:docMkLst>
      <pc:sldChg chg="modSp mod">
        <pc:chgData name="Wencai Zhang" userId="4a86a1d0-2108-4707-8228-1110f3c1be85" providerId="ADAL" clId="{A45B31E0-981A-6046-8AF7-6AF718FF8717}" dt="2022-05-02T01:09:41.318" v="1070" actId="1036"/>
        <pc:sldMkLst>
          <pc:docMk/>
          <pc:sldMk cId="2771812490" sldId="275"/>
        </pc:sldMkLst>
        <pc:spChg chg="mod">
          <ac:chgData name="Wencai Zhang" userId="4a86a1d0-2108-4707-8228-1110f3c1be85" providerId="ADAL" clId="{A45B31E0-981A-6046-8AF7-6AF718FF8717}" dt="2022-05-02T01:09:41.318" v="1070" actId="1036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A45B31E0-981A-6046-8AF7-6AF718FF8717}" dt="2022-05-01T01:17:52.213" v="658" actId="20577"/>
          <ac:spMkLst>
            <pc:docMk/>
            <pc:sldMk cId="2771812490" sldId="275"/>
            <ac:spMk id="32" creationId="{3E547D2F-565F-A84D-A2CA-22C354291393}"/>
          </ac:spMkLst>
        </pc:spChg>
      </pc:sldChg>
      <pc:sldChg chg="modSp mod">
        <pc:chgData name="Wencai Zhang" userId="4a86a1d0-2108-4707-8228-1110f3c1be85" providerId="ADAL" clId="{A45B31E0-981A-6046-8AF7-6AF718FF8717}" dt="2022-05-01T01:30:20.303" v="736" actId="1036"/>
        <pc:sldMkLst>
          <pc:docMk/>
          <pc:sldMk cId="1043719466" sldId="281"/>
        </pc:sldMkLst>
        <pc:spChg chg="mod">
          <ac:chgData name="Wencai Zhang" userId="4a86a1d0-2108-4707-8228-1110f3c1be85" providerId="ADAL" clId="{A45B31E0-981A-6046-8AF7-6AF718FF8717}" dt="2022-05-01T01:30:20.303" v="736" actId="1036"/>
          <ac:spMkLst>
            <pc:docMk/>
            <pc:sldMk cId="1043719466" sldId="281"/>
            <ac:spMk id="2" creationId="{51F54C20-E8DC-D04F-BBA3-37DC2057E256}"/>
          </ac:spMkLst>
        </pc:spChg>
        <pc:spChg chg="mod">
          <ac:chgData name="Wencai Zhang" userId="4a86a1d0-2108-4707-8228-1110f3c1be85" providerId="ADAL" clId="{A45B31E0-981A-6046-8AF7-6AF718FF8717}" dt="2022-05-01T01:17:46.366" v="656" actId="20577"/>
          <ac:spMkLst>
            <pc:docMk/>
            <pc:sldMk cId="1043719466" sldId="281"/>
            <ac:spMk id="5" creationId="{A61503D3-A798-A843-99DC-C0890B8EB90D}"/>
          </ac:spMkLst>
        </pc:spChg>
      </pc:sldChg>
      <pc:sldChg chg="delSp modSp del mod">
        <pc:chgData name="Wencai Zhang" userId="4a86a1d0-2108-4707-8228-1110f3c1be85" providerId="ADAL" clId="{A45B31E0-981A-6046-8AF7-6AF718FF8717}" dt="2022-05-02T01:04:05.194" v="1040" actId="2696"/>
        <pc:sldMkLst>
          <pc:docMk/>
          <pc:sldMk cId="3169542940" sldId="289"/>
        </pc:sldMkLst>
        <pc:spChg chg="del mod">
          <ac:chgData name="Wencai Zhang" userId="4a86a1d0-2108-4707-8228-1110f3c1be85" providerId="ADAL" clId="{A45B31E0-981A-6046-8AF7-6AF718FF8717}" dt="2022-05-02T01:03:54.440" v="1039" actId="478"/>
          <ac:spMkLst>
            <pc:docMk/>
            <pc:sldMk cId="3169542940" sldId="289"/>
            <ac:spMk id="2" creationId="{086BC700-3805-7D4C-A7D6-71D52151F333}"/>
          </ac:spMkLst>
        </pc:spChg>
        <pc:spChg chg="mod">
          <ac:chgData name="Wencai Zhang" userId="4a86a1d0-2108-4707-8228-1110f3c1be85" providerId="ADAL" clId="{A45B31E0-981A-6046-8AF7-6AF718FF8717}" dt="2022-05-01T13:01:33.669" v="907" actId="1038"/>
          <ac:spMkLst>
            <pc:docMk/>
            <pc:sldMk cId="3169542940" sldId="289"/>
            <ac:spMk id="9" creationId="{C166CB11-3208-B14A-9C10-6BB2460A7766}"/>
          </ac:spMkLst>
        </pc:sp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3" creationId="{3ABF22E1-7A07-C84C-8705-A0C68F3C260F}"/>
          </ac:picMkLst>
        </pc:pic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4" creationId="{A6AF6697-2ED6-8A42-890D-8A5CBBAE5C91}"/>
          </ac:picMkLst>
        </pc:pic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5" creationId="{919D6214-F343-234D-8E9B-0A5377F85DFA}"/>
          </ac:picMkLst>
        </pc:picChg>
        <pc:picChg chg="del">
          <ac:chgData name="Wencai Zhang" userId="4a86a1d0-2108-4707-8228-1110f3c1be85" providerId="ADAL" clId="{A45B31E0-981A-6046-8AF7-6AF718FF8717}" dt="2022-05-02T00:59:30.889" v="964" actId="21"/>
          <ac:picMkLst>
            <pc:docMk/>
            <pc:sldMk cId="3169542940" sldId="289"/>
            <ac:picMk id="6" creationId="{B768EE85-561C-CF46-9C0E-8B9D94FBE23A}"/>
          </ac:picMkLst>
        </pc:picChg>
      </pc:sldChg>
      <pc:sldChg chg="addSp delSp modSp mod">
        <pc:chgData name="Wencai Zhang" userId="4a86a1d0-2108-4707-8228-1110f3c1be85" providerId="ADAL" clId="{A45B31E0-981A-6046-8AF7-6AF718FF8717}" dt="2022-05-02T01:09:16.360" v="1053" actId="58"/>
        <pc:sldMkLst>
          <pc:docMk/>
          <pc:sldMk cId="3497662403" sldId="290"/>
        </pc:sldMkLst>
        <pc:spChg chg="mod">
          <ac:chgData name="Wencai Zhang" userId="4a86a1d0-2108-4707-8228-1110f3c1be85" providerId="ADAL" clId="{A45B31E0-981A-6046-8AF7-6AF718FF8717}" dt="2022-05-02T01:09:16.360" v="1053" actId="58"/>
          <ac:spMkLst>
            <pc:docMk/>
            <pc:sldMk cId="3497662403" sldId="290"/>
            <ac:spMk id="8" creationId="{A4F20A6F-D30A-9040-ACD4-2B63464D1625}"/>
          </ac:spMkLst>
        </pc:spChg>
        <pc:spChg chg="mod">
          <ac:chgData name="Wencai Zhang" userId="4a86a1d0-2108-4707-8228-1110f3c1be85" providerId="ADAL" clId="{A45B31E0-981A-6046-8AF7-6AF718FF8717}" dt="2022-05-01T13:04:12.575" v="914" actId="166"/>
          <ac:spMkLst>
            <pc:docMk/>
            <pc:sldMk cId="3497662403" sldId="290"/>
            <ac:spMk id="9" creationId="{77B42230-FC3D-594E-A8D3-BB1B8D18B024}"/>
          </ac:spMkLst>
        </pc:spChg>
        <pc:spChg chg="mod">
          <ac:chgData name="Wencai Zhang" userId="4a86a1d0-2108-4707-8228-1110f3c1be85" providerId="ADAL" clId="{A45B31E0-981A-6046-8AF7-6AF718FF8717}" dt="2022-05-02T01:06:51.936" v="1049" actId="1037"/>
          <ac:spMkLst>
            <pc:docMk/>
            <pc:sldMk cId="3497662403" sldId="290"/>
            <ac:spMk id="11" creationId="{D0DA81A9-2BB4-2740-B8BB-D967AA6C6C1E}"/>
          </ac:spMkLst>
        </pc:spChg>
        <pc:spChg chg="add mod">
          <ac:chgData name="Wencai Zhang" userId="4a86a1d0-2108-4707-8228-1110f3c1be85" providerId="ADAL" clId="{A45B31E0-981A-6046-8AF7-6AF718FF8717}" dt="2022-05-02T00:59:09.116" v="962" actId="20577"/>
          <ac:spMkLst>
            <pc:docMk/>
            <pc:sldMk cId="3497662403" sldId="290"/>
            <ac:spMk id="16" creationId="{B0FCD4AA-DCD7-F646-8F0F-5C0DD062716A}"/>
          </ac:spMkLst>
        </pc:spChg>
        <pc:spChg chg="add mod">
          <ac:chgData name="Wencai Zhang" userId="4a86a1d0-2108-4707-8228-1110f3c1be85" providerId="ADAL" clId="{A45B31E0-981A-6046-8AF7-6AF718FF8717}" dt="2022-05-02T00:59:05.299" v="960" actId="20577"/>
          <ac:spMkLst>
            <pc:docMk/>
            <pc:sldMk cId="3497662403" sldId="290"/>
            <ac:spMk id="17" creationId="{CCF1783A-FF0A-CF4A-80BC-1F851E7564D9}"/>
          </ac:spMkLst>
        </pc:sp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4" creationId="{D5F8969C-47D5-434A-8A0D-423C2F88D584}"/>
          </ac:picMkLst>
        </pc:pic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5" creationId="{D144485F-EAA4-DA4E-B968-FF93264A69A5}"/>
          </ac:picMkLst>
        </pc:pic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6" creationId="{EE7D6119-E5DE-244C-AF97-EA4FB4619828}"/>
          </ac:picMkLst>
        </pc:picChg>
        <pc:picChg chg="del">
          <ac:chgData name="Wencai Zhang" userId="4a86a1d0-2108-4707-8228-1110f3c1be85" providerId="ADAL" clId="{A45B31E0-981A-6046-8AF7-6AF718FF8717}" dt="2022-05-02T00:59:17.489" v="963" actId="478"/>
          <ac:picMkLst>
            <pc:docMk/>
            <pc:sldMk cId="3497662403" sldId="290"/>
            <ac:picMk id="7" creationId="{656940AD-5B4E-7147-B7C7-070CE9953A05}"/>
          </ac:picMkLst>
        </pc:picChg>
        <pc:picChg chg="add mod">
          <ac:chgData name="Wencai Zhang" userId="4a86a1d0-2108-4707-8228-1110f3c1be85" providerId="ADAL" clId="{A45B31E0-981A-6046-8AF7-6AF718FF8717}" dt="2022-05-02T00:59:00.600" v="958" actId="1036"/>
          <ac:picMkLst>
            <pc:docMk/>
            <pc:sldMk cId="3497662403" sldId="290"/>
            <ac:picMk id="12" creationId="{2865353E-EC3E-754C-AFCE-9B8F80DCFE5C}"/>
          </ac:picMkLst>
        </pc:picChg>
        <pc:picChg chg="add mod">
          <ac:chgData name="Wencai Zhang" userId="4a86a1d0-2108-4707-8228-1110f3c1be85" providerId="ADAL" clId="{A45B31E0-981A-6046-8AF7-6AF718FF8717}" dt="2022-05-02T01:01:08.505" v="992" actId="1038"/>
          <ac:picMkLst>
            <pc:docMk/>
            <pc:sldMk cId="3497662403" sldId="290"/>
            <ac:picMk id="13" creationId="{B3920610-759A-A843-AF3E-E253DF6C2BEC}"/>
          </ac:picMkLst>
        </pc:picChg>
        <pc:picChg chg="add mod">
          <ac:chgData name="Wencai Zhang" userId="4a86a1d0-2108-4707-8228-1110f3c1be85" providerId="ADAL" clId="{A45B31E0-981A-6046-8AF7-6AF718FF8717}" dt="2022-05-02T00:59:00.600" v="958" actId="1036"/>
          <ac:picMkLst>
            <pc:docMk/>
            <pc:sldMk cId="3497662403" sldId="290"/>
            <ac:picMk id="14" creationId="{DCD5C993-002B-1E4F-9A81-5BF283E0F3A0}"/>
          </ac:picMkLst>
        </pc:picChg>
        <pc:picChg chg="add mod">
          <ac:chgData name="Wencai Zhang" userId="4a86a1d0-2108-4707-8228-1110f3c1be85" providerId="ADAL" clId="{A45B31E0-981A-6046-8AF7-6AF718FF8717}" dt="2022-05-02T00:59:00.600" v="958" actId="1036"/>
          <ac:picMkLst>
            <pc:docMk/>
            <pc:sldMk cId="3497662403" sldId="290"/>
            <ac:picMk id="15" creationId="{EC2F7D94-7E38-E84C-BF57-60163E961BE2}"/>
          </ac:picMkLst>
        </pc:picChg>
        <pc:picChg chg="add mod">
          <ac:chgData name="Wencai Zhang" userId="4a86a1d0-2108-4707-8228-1110f3c1be85" providerId="ADAL" clId="{A45B31E0-981A-6046-8AF7-6AF718FF8717}" dt="2022-05-02T01:00:01.236" v="982" actId="1038"/>
          <ac:picMkLst>
            <pc:docMk/>
            <pc:sldMk cId="3497662403" sldId="290"/>
            <ac:picMk id="18" creationId="{AD7970BA-A711-9E44-AA50-A93070FFA9D4}"/>
          </ac:picMkLst>
        </pc:picChg>
        <pc:picChg chg="add mod">
          <ac:chgData name="Wencai Zhang" userId="4a86a1d0-2108-4707-8228-1110f3c1be85" providerId="ADAL" clId="{A45B31E0-981A-6046-8AF7-6AF718FF8717}" dt="2022-05-02T01:00:01.236" v="982" actId="1038"/>
          <ac:picMkLst>
            <pc:docMk/>
            <pc:sldMk cId="3497662403" sldId="290"/>
            <ac:picMk id="19" creationId="{3C0A5302-14DF-D54E-A342-3BB12C35E2C3}"/>
          </ac:picMkLst>
        </pc:picChg>
        <pc:picChg chg="add mod">
          <ac:chgData name="Wencai Zhang" userId="4a86a1d0-2108-4707-8228-1110f3c1be85" providerId="ADAL" clId="{A45B31E0-981A-6046-8AF7-6AF718FF8717}" dt="2022-05-02T00:59:37.410" v="965"/>
          <ac:picMkLst>
            <pc:docMk/>
            <pc:sldMk cId="3497662403" sldId="290"/>
            <ac:picMk id="20" creationId="{DFDDCBD1-FF1A-5343-99EC-E6DE556CF052}"/>
          </ac:picMkLst>
        </pc:picChg>
        <pc:picChg chg="add mod">
          <ac:chgData name="Wencai Zhang" userId="4a86a1d0-2108-4707-8228-1110f3c1be85" providerId="ADAL" clId="{A45B31E0-981A-6046-8AF7-6AF718FF8717}" dt="2022-05-02T01:01:37.372" v="1007" actId="1038"/>
          <ac:picMkLst>
            <pc:docMk/>
            <pc:sldMk cId="3497662403" sldId="290"/>
            <ac:picMk id="21" creationId="{A67CA55E-1A12-7742-82EC-64F1C6D74AEE}"/>
          </ac:picMkLst>
        </pc:picChg>
      </pc:sldChg>
      <pc:sldChg chg="addSp delSp modSp mod ord">
        <pc:chgData name="Wencai Zhang" userId="4a86a1d0-2108-4707-8228-1110f3c1be85" providerId="ADAL" clId="{A45B31E0-981A-6046-8AF7-6AF718FF8717}" dt="2022-05-01T01:22:56.048" v="727" actId="20577"/>
        <pc:sldMkLst>
          <pc:docMk/>
          <pc:sldMk cId="4133689721" sldId="291"/>
        </pc:sldMkLst>
        <pc:spChg chg="mod">
          <ac:chgData name="Wencai Zhang" userId="4a86a1d0-2108-4707-8228-1110f3c1be85" providerId="ADAL" clId="{A45B31E0-981A-6046-8AF7-6AF718FF8717}" dt="2022-05-01T01:17:06.400" v="649" actId="20577"/>
          <ac:spMkLst>
            <pc:docMk/>
            <pc:sldMk cId="4133689721" sldId="291"/>
            <ac:spMk id="17" creationId="{649CC280-8498-5F47-A7C8-A30278508115}"/>
          </ac:spMkLst>
        </pc:spChg>
        <pc:spChg chg="mod">
          <ac:chgData name="Wencai Zhang" userId="4a86a1d0-2108-4707-8228-1110f3c1be85" providerId="ADAL" clId="{A45B31E0-981A-6046-8AF7-6AF718FF8717}" dt="2022-05-01T01:19:14.462" v="726" actId="1037"/>
          <ac:spMkLst>
            <pc:docMk/>
            <pc:sldMk cId="4133689721" sldId="291"/>
            <ac:spMk id="49" creationId="{393B87F7-0301-414F-A165-54A34714662C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53" creationId="{3D350C17-0DE6-ED4E-9BFC-456C406D86E0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57" creationId="{92B9BF22-2E03-4145-A99C-E336F9301AF2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62" creationId="{69BD8DC7-A18D-5B46-B8C1-820DC41A18B8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63" creationId="{28602894-AD05-D145-B42A-02830051BA05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64" creationId="{F0288BB7-CE51-E145-B29B-E4BAB1981314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71" creationId="{B374758E-F00A-4241-BB9E-0D85038713F6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73" creationId="{3E74BA67-9FF1-C74A-BAED-15E8E85EC296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74" creationId="{9558CB7F-065C-A542-A745-927E6BCF4346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76" creationId="{C45111EC-F0A0-5943-96E4-09196A7F17DF}"/>
          </ac:spMkLst>
        </pc:spChg>
        <pc:spChg chg="del mod">
          <ac:chgData name="Wencai Zhang" userId="4a86a1d0-2108-4707-8228-1110f3c1be85" providerId="ADAL" clId="{A45B31E0-981A-6046-8AF7-6AF718FF8717}" dt="2022-04-28T23:52:01.967" v="211" actId="478"/>
          <ac:spMkLst>
            <pc:docMk/>
            <pc:sldMk cId="4133689721" sldId="291"/>
            <ac:spMk id="77" creationId="{270151C4-714F-7C49-979A-305C27C29894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78" creationId="{26FB9E45-966D-314A-8358-9C15BE9D9176}"/>
          </ac:spMkLst>
        </pc:spChg>
        <pc:spChg chg="del mod topLvl">
          <ac:chgData name="Wencai Zhang" userId="4a86a1d0-2108-4707-8228-1110f3c1be85" providerId="ADAL" clId="{A45B31E0-981A-6046-8AF7-6AF718FF8717}" dt="2022-04-28T23:52:03.439" v="212" actId="478"/>
          <ac:spMkLst>
            <pc:docMk/>
            <pc:sldMk cId="4133689721" sldId="291"/>
            <ac:spMk id="79" creationId="{1A9AA523-DB0C-614F-82BE-CB2D94ED6504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80" creationId="{A433F24B-E908-2545-8CFC-27AD35847741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83" creationId="{E8CE507A-F3DB-3F42-A34B-80C576581F70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86" creationId="{B022141C-481D-AE4E-86E8-2C9267D0615B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88" creationId="{BED3237E-EB4F-D348-892F-02F34EDC01FD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89" creationId="{0AA3302E-C0BD-6B44-83DC-1ED06F5AB55C}"/>
          </ac:spMkLst>
        </pc:spChg>
        <pc:spChg chg="del mod">
          <ac:chgData name="Wencai Zhang" userId="4a86a1d0-2108-4707-8228-1110f3c1be85" providerId="ADAL" clId="{A45B31E0-981A-6046-8AF7-6AF718FF8717}" dt="2022-04-28T23:51:54.005" v="210" actId="478"/>
          <ac:spMkLst>
            <pc:docMk/>
            <pc:sldMk cId="4133689721" sldId="291"/>
            <ac:spMk id="92" creationId="{75BB503E-40A5-8545-B1A1-C451A3AAB58C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96" creationId="{936DBA25-C5B8-5C48-ABC1-72428939BDAD}"/>
          </ac:spMkLst>
        </pc:spChg>
        <pc:spChg chg="del mod">
          <ac:chgData name="Wencai Zhang" userId="4a86a1d0-2108-4707-8228-1110f3c1be85" providerId="ADAL" clId="{A45B31E0-981A-6046-8AF7-6AF718FF8717}" dt="2022-04-28T23:51:49.882" v="209" actId="478"/>
          <ac:spMkLst>
            <pc:docMk/>
            <pc:sldMk cId="4133689721" sldId="291"/>
            <ac:spMk id="97" creationId="{EB986C2A-DDB0-6847-A51F-7F5E83C4A06C}"/>
          </ac:spMkLst>
        </pc:spChg>
        <pc:spChg chg="del">
          <ac:chgData name="Wencai Zhang" userId="4a86a1d0-2108-4707-8228-1110f3c1be85" providerId="ADAL" clId="{A45B31E0-981A-6046-8AF7-6AF718FF8717}" dt="2022-04-29T00:00:34.510" v="347" actId="478"/>
          <ac:spMkLst>
            <pc:docMk/>
            <pc:sldMk cId="4133689721" sldId="291"/>
            <ac:spMk id="98" creationId="{E64C069D-59EA-B54F-BEC8-16B484C87FCA}"/>
          </ac:spMkLst>
        </pc:spChg>
        <pc:spChg chg="mod">
          <ac:chgData name="Wencai Zhang" userId="4a86a1d0-2108-4707-8228-1110f3c1be85" providerId="ADAL" clId="{A45B31E0-981A-6046-8AF7-6AF718FF8717}" dt="2022-04-28T23:49:48.504" v="16"/>
          <ac:spMkLst>
            <pc:docMk/>
            <pc:sldMk cId="4133689721" sldId="291"/>
            <ac:spMk id="99" creationId="{ADED19B6-A914-5B40-BAD0-EBC312EBBF5D}"/>
          </ac:spMkLst>
        </pc:spChg>
        <pc:spChg chg="mod">
          <ac:chgData name="Wencai Zhang" userId="4a86a1d0-2108-4707-8228-1110f3c1be85" providerId="ADAL" clId="{A45B31E0-981A-6046-8AF7-6AF718FF8717}" dt="2022-04-28T23:49:48.504" v="16"/>
          <ac:spMkLst>
            <pc:docMk/>
            <pc:sldMk cId="4133689721" sldId="291"/>
            <ac:spMk id="100" creationId="{A194126A-B883-EE49-BD9C-D29997C638ED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101" creationId="{61693130-9305-994A-93F4-E4C3C7A5BEC7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102" creationId="{E6099F5A-491A-1C45-B4D5-5196122D1C07}"/>
          </ac:spMkLst>
        </pc:spChg>
        <pc:spChg chg="add mod">
          <ac:chgData name="Wencai Zhang" userId="4a86a1d0-2108-4707-8228-1110f3c1be85" providerId="ADAL" clId="{A45B31E0-981A-6046-8AF7-6AF718FF8717}" dt="2022-04-29T00:13:13.605" v="486" actId="1037"/>
          <ac:spMkLst>
            <pc:docMk/>
            <pc:sldMk cId="4133689721" sldId="291"/>
            <ac:spMk id="103" creationId="{829636E0-B151-9C4B-B072-849BA50CD111}"/>
          </ac:spMkLst>
        </pc:spChg>
        <pc:spChg chg="add mod">
          <ac:chgData name="Wencai Zhang" userId="4a86a1d0-2108-4707-8228-1110f3c1be85" providerId="ADAL" clId="{A45B31E0-981A-6046-8AF7-6AF718FF8717}" dt="2022-04-28T23:50:38.263" v="18" actId="164"/>
          <ac:spMkLst>
            <pc:docMk/>
            <pc:sldMk cId="4133689721" sldId="291"/>
            <ac:spMk id="104" creationId="{46E8C437-6181-B441-BAAC-0AF1F08C8C0A}"/>
          </ac:spMkLst>
        </pc:spChg>
        <pc:spChg chg="del mod topLvl">
          <ac:chgData name="Wencai Zhang" userId="4a86a1d0-2108-4707-8228-1110f3c1be85" providerId="ADAL" clId="{A45B31E0-981A-6046-8AF7-6AF718FF8717}" dt="2022-04-28T23:52:53.612" v="250" actId="478"/>
          <ac:spMkLst>
            <pc:docMk/>
            <pc:sldMk cId="4133689721" sldId="291"/>
            <ac:spMk id="109" creationId="{C268D3E6-1DBA-1342-BCA5-CD4DFDBAC637}"/>
          </ac:spMkLst>
        </pc:spChg>
        <pc:spChg chg="add del mod topLvl">
          <ac:chgData name="Wencai Zhang" userId="4a86a1d0-2108-4707-8228-1110f3c1be85" providerId="ADAL" clId="{A45B31E0-981A-6046-8AF7-6AF718FF8717}" dt="2022-05-01T01:22:56.048" v="727" actId="20577"/>
          <ac:spMkLst>
            <pc:docMk/>
            <pc:sldMk cId="4133689721" sldId="291"/>
            <ac:spMk id="110" creationId="{AB81831C-0E3B-A341-AB01-CD9573CDF5D3}"/>
          </ac:spMkLst>
        </pc:spChg>
        <pc:spChg chg="del mod">
          <ac:chgData name="Wencai Zhang" userId="4a86a1d0-2108-4707-8228-1110f3c1be85" providerId="ADAL" clId="{A45B31E0-981A-6046-8AF7-6AF718FF8717}" dt="2022-04-28T23:52:51.931" v="249" actId="478"/>
          <ac:spMkLst>
            <pc:docMk/>
            <pc:sldMk cId="4133689721" sldId="291"/>
            <ac:spMk id="111" creationId="{6B67D6C7-23EA-7348-AD1B-E893E5CF807F}"/>
          </ac:spMkLst>
        </pc:spChg>
        <pc:spChg chg="del mod">
          <ac:chgData name="Wencai Zhang" userId="4a86a1d0-2108-4707-8228-1110f3c1be85" providerId="ADAL" clId="{A45B31E0-981A-6046-8AF7-6AF718FF8717}" dt="2022-04-28T23:52:56.926" v="252" actId="478"/>
          <ac:spMkLst>
            <pc:docMk/>
            <pc:sldMk cId="4133689721" sldId="291"/>
            <ac:spMk id="113" creationId="{4CFCAB3C-0E6C-6641-BFB0-2F458DAE50A2}"/>
          </ac:spMkLst>
        </pc:spChg>
        <pc:spChg chg="del mod">
          <ac:chgData name="Wencai Zhang" userId="4a86a1d0-2108-4707-8228-1110f3c1be85" providerId="ADAL" clId="{A45B31E0-981A-6046-8AF7-6AF718FF8717}" dt="2022-04-28T23:52:59.023" v="253" actId="478"/>
          <ac:spMkLst>
            <pc:docMk/>
            <pc:sldMk cId="4133689721" sldId="291"/>
            <ac:spMk id="114" creationId="{B3514C46-D965-6240-AE15-79BCD9D2CFE7}"/>
          </ac:spMkLst>
        </pc:spChg>
        <pc:spChg chg="mod topLvl">
          <ac:chgData name="Wencai Zhang" userId="4a86a1d0-2108-4707-8228-1110f3c1be85" providerId="ADAL" clId="{A45B31E0-981A-6046-8AF7-6AF718FF8717}" dt="2022-04-28T23:59:47.281" v="340" actId="164"/>
          <ac:spMkLst>
            <pc:docMk/>
            <pc:sldMk cId="4133689721" sldId="291"/>
            <ac:spMk id="115" creationId="{BE804F81-D37C-5540-B6CC-474FF87EC360}"/>
          </ac:spMkLst>
        </pc:spChg>
        <pc:spChg chg="del">
          <ac:chgData name="Wencai Zhang" userId="4a86a1d0-2108-4707-8228-1110f3c1be85" providerId="ADAL" clId="{A45B31E0-981A-6046-8AF7-6AF718FF8717}" dt="2022-04-29T00:00:37.184" v="348" actId="478"/>
          <ac:spMkLst>
            <pc:docMk/>
            <pc:sldMk cId="4133689721" sldId="291"/>
            <ac:spMk id="116" creationId="{CA1A6BA0-F60B-C946-B5C2-0DB8667822B9}"/>
          </ac:spMkLst>
        </pc:spChg>
        <pc:spChg chg="mod topLvl">
          <ac:chgData name="Wencai Zhang" userId="4a86a1d0-2108-4707-8228-1110f3c1be85" providerId="ADAL" clId="{A45B31E0-981A-6046-8AF7-6AF718FF8717}" dt="2022-04-28T23:59:47.281" v="340" actId="164"/>
          <ac:spMkLst>
            <pc:docMk/>
            <pc:sldMk cId="4133689721" sldId="291"/>
            <ac:spMk id="117" creationId="{58DF98B3-8AA8-7B47-B72B-F63E5305D53F}"/>
          </ac:spMkLst>
        </pc:spChg>
        <pc:spChg chg="mod">
          <ac:chgData name="Wencai Zhang" userId="4a86a1d0-2108-4707-8228-1110f3c1be85" providerId="ADAL" clId="{A45B31E0-981A-6046-8AF7-6AF718FF8717}" dt="2022-04-28T23:51:35.327" v="204" actId="20577"/>
          <ac:spMkLst>
            <pc:docMk/>
            <pc:sldMk cId="4133689721" sldId="291"/>
            <ac:spMk id="119" creationId="{7206E7C8-24E1-A84F-817A-4230500597B9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0" creationId="{DCBBD579-C337-9E45-97E6-24D7B35395D0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2" creationId="{1FF430B9-C097-4141-955B-464AF1FFF3AC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3" creationId="{84199DB4-AFAA-D841-94D2-967E0D596016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26" creationId="{0B892A3B-7635-E74A-9CAD-43BFC9EC9AE4}"/>
          </ac:spMkLst>
        </pc:spChg>
        <pc:spChg chg="mod">
          <ac:chgData name="Wencai Zhang" userId="4a86a1d0-2108-4707-8228-1110f3c1be85" providerId="ADAL" clId="{A45B31E0-981A-6046-8AF7-6AF718FF8717}" dt="2022-04-29T00:13:07.376" v="480" actId="1037"/>
          <ac:spMkLst>
            <pc:docMk/>
            <pc:sldMk cId="4133689721" sldId="291"/>
            <ac:spMk id="129" creationId="{6914B16E-392B-BE4C-BF2B-1C5AD8C41EA6}"/>
          </ac:spMkLst>
        </pc:spChg>
        <pc:spChg chg="mod">
          <ac:chgData name="Wencai Zhang" userId="4a86a1d0-2108-4707-8228-1110f3c1be85" providerId="ADAL" clId="{A45B31E0-981A-6046-8AF7-6AF718FF8717}" dt="2022-04-28T23:50:50.672" v="19"/>
          <ac:spMkLst>
            <pc:docMk/>
            <pc:sldMk cId="4133689721" sldId="291"/>
            <ac:spMk id="130" creationId="{27044503-B167-564C-A0AC-F7A3DF136385}"/>
          </ac:spMkLst>
        </pc:spChg>
        <pc:spChg chg="del mod">
          <ac:chgData name="Wencai Zhang" userId="4a86a1d0-2108-4707-8228-1110f3c1be85" providerId="ADAL" clId="{A45B31E0-981A-6046-8AF7-6AF718FF8717}" dt="2022-04-28T23:53:04.984" v="256" actId="478"/>
          <ac:spMkLst>
            <pc:docMk/>
            <pc:sldMk cId="4133689721" sldId="291"/>
            <ac:spMk id="135" creationId="{0AE3FE0F-AE83-0F4E-99A5-CE24BDB0CDEE}"/>
          </ac:spMkLst>
        </pc:spChg>
        <pc:spChg chg="del mod topLvl">
          <ac:chgData name="Wencai Zhang" userId="4a86a1d0-2108-4707-8228-1110f3c1be85" providerId="ADAL" clId="{A45B31E0-981A-6046-8AF7-6AF718FF8717}" dt="2022-04-28T23:53:06.329" v="257" actId="478"/>
          <ac:spMkLst>
            <pc:docMk/>
            <pc:sldMk cId="4133689721" sldId="291"/>
            <ac:spMk id="136" creationId="{C789E5F4-6E81-3640-BE26-803BFF780361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137" creationId="{3850AE4E-26F5-2C41-8C36-CD7B40861046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139" creationId="{3EEACB96-9DA9-1440-AE79-C7B4E68E9A27}"/>
          </ac:spMkLst>
        </pc:spChg>
        <pc:spChg chg="del mod">
          <ac:chgData name="Wencai Zhang" userId="4a86a1d0-2108-4707-8228-1110f3c1be85" providerId="ADAL" clId="{A45B31E0-981A-6046-8AF7-6AF718FF8717}" dt="2022-04-28T23:53:08.255" v="258" actId="478"/>
          <ac:spMkLst>
            <pc:docMk/>
            <pc:sldMk cId="4133689721" sldId="291"/>
            <ac:spMk id="140" creationId="{1D8F5666-839C-584A-9DEB-E73467A3618D}"/>
          </ac:spMkLst>
        </pc:spChg>
        <pc:spChg chg="del mod">
          <ac:chgData name="Wencai Zhang" userId="4a86a1d0-2108-4707-8228-1110f3c1be85" providerId="ADAL" clId="{A45B31E0-981A-6046-8AF7-6AF718FF8717}" dt="2022-04-28T23:53:09.838" v="259" actId="478"/>
          <ac:spMkLst>
            <pc:docMk/>
            <pc:sldMk cId="4133689721" sldId="291"/>
            <ac:spMk id="141" creationId="{E46D3D47-4D26-6843-9EC0-886D789EECD9}"/>
          </ac:spMkLst>
        </pc:spChg>
        <pc:spChg chg="mod topLvl">
          <ac:chgData name="Wencai Zhang" userId="4a86a1d0-2108-4707-8228-1110f3c1be85" providerId="ADAL" clId="{A45B31E0-981A-6046-8AF7-6AF718FF8717}" dt="2022-04-29T00:00:47.765" v="384" actId="1035"/>
          <ac:spMkLst>
            <pc:docMk/>
            <pc:sldMk cId="4133689721" sldId="291"/>
            <ac:spMk id="143" creationId="{A4E87F98-4561-4140-8FC8-5F1362F55559}"/>
          </ac:spMkLst>
        </pc:spChg>
        <pc:spChg chg="mod">
          <ac:chgData name="Wencai Zhang" userId="4a86a1d0-2108-4707-8228-1110f3c1be85" providerId="ADAL" clId="{A45B31E0-981A-6046-8AF7-6AF718FF8717}" dt="2022-04-28T23:51:38.108" v="206" actId="20577"/>
          <ac:spMkLst>
            <pc:docMk/>
            <pc:sldMk cId="4133689721" sldId="291"/>
            <ac:spMk id="148" creationId="{B2280CD2-F78A-DF41-8901-0988A769ABF2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49" creationId="{C16F9C31-F900-E944-8F84-FB86BD3C4A83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0" creationId="{40E734D8-C3AB-B941-937B-2D7607C9C0B4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1" creationId="{E9A82B24-AFD7-DE4C-BD1D-95B4E826145D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2" creationId="{54B545FE-DCBD-7F40-BC9A-366DACBFE8F2}"/>
          </ac:spMkLst>
        </pc:spChg>
        <pc:spChg chg="mod">
          <ac:chgData name="Wencai Zhang" userId="4a86a1d0-2108-4707-8228-1110f3c1be85" providerId="ADAL" clId="{A45B31E0-981A-6046-8AF7-6AF718FF8717}" dt="2022-04-29T00:13:02.117" v="474" actId="1037"/>
          <ac:spMkLst>
            <pc:docMk/>
            <pc:sldMk cId="4133689721" sldId="291"/>
            <ac:spMk id="153" creationId="{D95D849D-C8F9-5F44-9E3B-6416A913C63F}"/>
          </ac:spMkLst>
        </pc:spChg>
        <pc:spChg chg="mod">
          <ac:chgData name="Wencai Zhang" userId="4a86a1d0-2108-4707-8228-1110f3c1be85" providerId="ADAL" clId="{A45B31E0-981A-6046-8AF7-6AF718FF8717}" dt="2022-04-28T23:51:08.193" v="103"/>
          <ac:spMkLst>
            <pc:docMk/>
            <pc:sldMk cId="4133689721" sldId="291"/>
            <ac:spMk id="154" creationId="{CF5AEA1B-EDFB-D144-9B8D-AB6E251C3D31}"/>
          </ac:spMkLst>
        </pc:s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32" creationId="{63E51CC7-304E-4544-A17F-8764C97284B8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33" creationId="{16B9B9D2-EC14-0B44-B8FE-4DD8246EB54F}"/>
          </ac:grpSpMkLst>
        </pc:grpChg>
        <pc:grpChg chg="add del mod">
          <ac:chgData name="Wencai Zhang" userId="4a86a1d0-2108-4707-8228-1110f3c1be85" providerId="ADAL" clId="{A45B31E0-981A-6046-8AF7-6AF718FF8717}" dt="2022-04-28T23:52:03.439" v="212" actId="478"/>
          <ac:grpSpMkLst>
            <pc:docMk/>
            <pc:sldMk cId="4133689721" sldId="291"/>
            <ac:grpSpMk id="75" creationId="{3D5846F4-1E97-DE45-93F8-57A378DD2191}"/>
          </ac:grpSpMkLst>
        </pc:grpChg>
        <pc:grpChg chg="del">
          <ac:chgData name="Wencai Zhang" userId="4a86a1d0-2108-4707-8228-1110f3c1be85" providerId="ADAL" clId="{A45B31E0-981A-6046-8AF7-6AF718FF8717}" dt="2022-04-29T00:00:34.510" v="347" actId="478"/>
          <ac:grpSpMkLst>
            <pc:docMk/>
            <pc:sldMk cId="4133689721" sldId="291"/>
            <ac:grpSpMk id="90" creationId="{AA12D019-BE12-0240-B0DD-1AAAD8EA483F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91" creationId="{0A430BC3-98C3-7C45-9210-D17A39E83C0A}"/>
          </ac:grpSpMkLst>
        </pc:grpChg>
        <pc:grpChg chg="add del mod">
          <ac:chgData name="Wencai Zhang" userId="4a86a1d0-2108-4707-8228-1110f3c1be85" providerId="ADAL" clId="{A45B31E0-981A-6046-8AF7-6AF718FF8717}" dt="2022-04-28T23:52:53.612" v="250" actId="478"/>
          <ac:grpSpMkLst>
            <pc:docMk/>
            <pc:sldMk cId="4133689721" sldId="291"/>
            <ac:grpSpMk id="108" creationId="{C97A99D7-202A-F541-90A8-2677526652C9}"/>
          </ac:grpSpMkLst>
        </pc:grpChg>
        <pc:grpChg chg="add del mod">
          <ac:chgData name="Wencai Zhang" userId="4a86a1d0-2108-4707-8228-1110f3c1be85" providerId="ADAL" clId="{A45B31E0-981A-6046-8AF7-6AF718FF8717}" dt="2022-04-28T23:58:52.706" v="311" actId="165"/>
          <ac:grpSpMkLst>
            <pc:docMk/>
            <pc:sldMk cId="4133689721" sldId="291"/>
            <ac:grpSpMk id="112" creationId="{5ADCC206-BD7F-D647-AB96-9356C894A566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118" creationId="{9FA4F76E-902F-7D49-A4B1-3541D2F69600}"/>
          </ac:grpSpMkLst>
        </pc:grpChg>
        <pc:grpChg chg="add del mod">
          <ac:chgData name="Wencai Zhang" userId="4a86a1d0-2108-4707-8228-1110f3c1be85" providerId="ADAL" clId="{A45B31E0-981A-6046-8AF7-6AF718FF8717}" dt="2022-04-28T23:53:06.329" v="257" actId="478"/>
          <ac:grpSpMkLst>
            <pc:docMk/>
            <pc:sldMk cId="4133689721" sldId="291"/>
            <ac:grpSpMk id="134" creationId="{BAB7AED6-89E0-4140-B509-04B311AEF9FC}"/>
          </ac:grpSpMkLst>
        </pc:grpChg>
        <pc:grpChg chg="add del mod">
          <ac:chgData name="Wencai Zhang" userId="4a86a1d0-2108-4707-8228-1110f3c1be85" providerId="ADAL" clId="{A45B31E0-981A-6046-8AF7-6AF718FF8717}" dt="2022-04-28T23:58:47.511" v="310" actId="165"/>
          <ac:grpSpMkLst>
            <pc:docMk/>
            <pc:sldMk cId="4133689721" sldId="291"/>
            <ac:grpSpMk id="138" creationId="{643CE01C-F3E7-1546-90B7-016D6A13CBB6}"/>
          </ac:grpSpMkLst>
        </pc:grpChg>
        <pc:grpChg chg="del">
          <ac:chgData name="Wencai Zhang" userId="4a86a1d0-2108-4707-8228-1110f3c1be85" providerId="ADAL" clId="{A45B31E0-981A-6046-8AF7-6AF718FF8717}" dt="2022-04-29T00:00:34.510" v="347" actId="478"/>
          <ac:grpSpMkLst>
            <pc:docMk/>
            <pc:sldMk cId="4133689721" sldId="291"/>
            <ac:grpSpMk id="142" creationId="{D2C00862-C2DF-724F-9111-6676E2CF585A}"/>
          </ac:grpSpMkLst>
        </pc:grpChg>
        <pc:grpChg chg="add mod">
          <ac:chgData name="Wencai Zhang" userId="4a86a1d0-2108-4707-8228-1110f3c1be85" providerId="ADAL" clId="{A45B31E0-981A-6046-8AF7-6AF718FF8717}" dt="2022-04-29T00:00:47.765" v="384" actId="1035"/>
          <ac:grpSpMkLst>
            <pc:docMk/>
            <pc:sldMk cId="4133689721" sldId="291"/>
            <ac:grpSpMk id="144" creationId="{63D90920-050D-D147-8B55-7D8A86079DCD}"/>
          </ac:grpSpMkLst>
        </pc:grpChg>
        <pc:picChg chg="add mod modCrop">
          <ac:chgData name="Wencai Zhang" userId="4a86a1d0-2108-4707-8228-1110f3c1be85" providerId="ADAL" clId="{A45B31E0-981A-6046-8AF7-6AF718FF8717}" dt="2022-04-29T00:00:47.765" v="384" actId="1035"/>
          <ac:picMkLst>
            <pc:docMk/>
            <pc:sldMk cId="4133689721" sldId="291"/>
            <ac:picMk id="105" creationId="{B2E451D6-3C7D-F84B-9EED-879061C9FCBF}"/>
          </ac:picMkLst>
        </pc:picChg>
        <pc:picChg chg="add del mod">
          <ac:chgData name="Wencai Zhang" userId="4a86a1d0-2108-4707-8228-1110f3c1be85" providerId="ADAL" clId="{A45B31E0-981A-6046-8AF7-6AF718FF8717}" dt="2022-04-28T23:51:45.280" v="207" actId="478"/>
          <ac:picMkLst>
            <pc:docMk/>
            <pc:sldMk cId="4133689721" sldId="291"/>
            <ac:picMk id="106" creationId="{BD3A29F3-17BC-6143-8791-DD64B6303BB4}"/>
          </ac:picMkLst>
        </pc:picChg>
        <pc:picChg chg="add del mod">
          <ac:chgData name="Wencai Zhang" userId="4a86a1d0-2108-4707-8228-1110f3c1be85" providerId="ADAL" clId="{A45B31E0-981A-6046-8AF7-6AF718FF8717}" dt="2022-04-28T23:51:47.107" v="208" actId="478"/>
          <ac:picMkLst>
            <pc:docMk/>
            <pc:sldMk cId="4133689721" sldId="291"/>
            <ac:picMk id="107" creationId="{F14D1060-B831-9E4C-9C5F-63CDEB7BAA0F}"/>
          </ac:picMkLst>
        </pc:picChg>
        <pc:picChg chg="add del mod">
          <ac:chgData name="Wencai Zhang" userId="4a86a1d0-2108-4707-8228-1110f3c1be85" providerId="ADAL" clId="{A45B31E0-981A-6046-8AF7-6AF718FF8717}" dt="2022-04-28T23:52:37.133" v="220" actId="478"/>
          <ac:picMkLst>
            <pc:docMk/>
            <pc:sldMk cId="4133689721" sldId="291"/>
            <ac:picMk id="131" creationId="{5DBF83C1-3642-3B44-878C-6ECB3F2E6B1F}"/>
          </ac:picMkLst>
        </pc:picChg>
        <pc:picChg chg="add mod modCrop">
          <ac:chgData name="Wencai Zhang" userId="4a86a1d0-2108-4707-8228-1110f3c1be85" providerId="ADAL" clId="{A45B31E0-981A-6046-8AF7-6AF718FF8717}" dt="2022-04-29T00:00:47.765" v="384" actId="1035"/>
          <ac:picMkLst>
            <pc:docMk/>
            <pc:sldMk cId="4133689721" sldId="291"/>
            <ac:picMk id="132" creationId="{D3B2D56B-4674-B54F-A1B5-3E6709DB3DF9}"/>
          </ac:picMkLst>
        </pc:picChg>
        <pc:picChg chg="add del mod">
          <ac:chgData name="Wencai Zhang" userId="4a86a1d0-2108-4707-8228-1110f3c1be85" providerId="ADAL" clId="{A45B31E0-981A-6046-8AF7-6AF718FF8717}" dt="2022-04-28T23:52:55.084" v="251" actId="478"/>
          <ac:picMkLst>
            <pc:docMk/>
            <pc:sldMk cId="4133689721" sldId="291"/>
            <ac:picMk id="133" creationId="{88FC0DEB-D435-4F45-9C85-678807FD69B9}"/>
          </ac:picMkLst>
        </pc:picChg>
        <pc:picChg chg="add del mod">
          <ac:chgData name="Wencai Zhang" userId="4a86a1d0-2108-4707-8228-1110f3c1be85" providerId="ADAL" clId="{A45B31E0-981A-6046-8AF7-6AF718FF8717}" dt="2022-04-28T23:53:01.443" v="254" actId="478"/>
          <ac:picMkLst>
            <pc:docMk/>
            <pc:sldMk cId="4133689721" sldId="291"/>
            <ac:picMk id="155" creationId="{558F4369-0C9E-D749-A607-81E44BB132A3}"/>
          </ac:picMkLst>
        </pc:picChg>
        <pc:picChg chg="add del mod">
          <ac:chgData name="Wencai Zhang" userId="4a86a1d0-2108-4707-8228-1110f3c1be85" providerId="ADAL" clId="{A45B31E0-981A-6046-8AF7-6AF718FF8717}" dt="2022-04-28T23:53:02.831" v="255" actId="478"/>
          <ac:picMkLst>
            <pc:docMk/>
            <pc:sldMk cId="4133689721" sldId="291"/>
            <ac:picMk id="156" creationId="{ED594311-632E-D943-ADCD-F38F43818277}"/>
          </ac:picMkLst>
        </pc:picChg>
        <pc:picChg chg="add mod modCrop">
          <ac:chgData name="Wencai Zhang" userId="4a86a1d0-2108-4707-8228-1110f3c1be85" providerId="ADAL" clId="{A45B31E0-981A-6046-8AF7-6AF718FF8717}" dt="2022-04-29T00:00:47.765" v="384" actId="1035"/>
          <ac:picMkLst>
            <pc:docMk/>
            <pc:sldMk cId="4133689721" sldId="291"/>
            <ac:picMk id="157" creationId="{EA5EC223-7E36-0E49-99F4-D47CF3D977DA}"/>
          </ac:picMkLst>
        </pc:picChg>
        <pc:cxnChg chg="add mod">
          <ac:chgData name="Wencai Zhang" userId="4a86a1d0-2108-4707-8228-1110f3c1be85" providerId="ADAL" clId="{A45B31E0-981A-6046-8AF7-6AF718FF8717}" dt="2022-04-29T00:12:01.596" v="459" actId="14100"/>
          <ac:cxnSpMkLst>
            <pc:docMk/>
            <pc:sldMk cId="4133689721" sldId="291"/>
            <ac:cxnSpMk id="158" creationId="{07A50D90-43C3-1B45-A38D-387C870AE5A8}"/>
          </ac:cxnSpMkLst>
        </pc:cxnChg>
        <pc:cxnChg chg="add mod">
          <ac:chgData name="Wencai Zhang" userId="4a86a1d0-2108-4707-8228-1110f3c1be85" providerId="ADAL" clId="{A45B31E0-981A-6046-8AF7-6AF718FF8717}" dt="2022-04-29T00:12:34.993" v="464" actId="1037"/>
          <ac:cxnSpMkLst>
            <pc:docMk/>
            <pc:sldMk cId="4133689721" sldId="291"/>
            <ac:cxnSpMk id="159" creationId="{2C49C4D6-3E0F-8C45-981A-B94C9A3CE2AA}"/>
          </ac:cxnSpMkLst>
        </pc:cxnChg>
        <pc:cxnChg chg="add mod">
          <ac:chgData name="Wencai Zhang" userId="4a86a1d0-2108-4707-8228-1110f3c1be85" providerId="ADAL" clId="{A45B31E0-981A-6046-8AF7-6AF718FF8717}" dt="2022-04-29T00:12:46.481" v="468" actId="1036"/>
          <ac:cxnSpMkLst>
            <pc:docMk/>
            <pc:sldMk cId="4133689721" sldId="291"/>
            <ac:cxnSpMk id="160" creationId="{03EDABF2-6CE5-394F-AEB9-82C7B0842800}"/>
          </ac:cxnSpMkLst>
        </pc:cxnChg>
      </pc:sldChg>
      <pc:sldChg chg="addSp delSp modSp mod">
        <pc:chgData name="Wencai Zhang" userId="4a86a1d0-2108-4707-8228-1110f3c1be85" providerId="ADAL" clId="{A45B31E0-981A-6046-8AF7-6AF718FF8717}" dt="2022-05-02T01:13:36.365" v="1074" actId="20577"/>
        <pc:sldMkLst>
          <pc:docMk/>
          <pc:sldMk cId="472844202" sldId="292"/>
        </pc:sldMkLst>
        <pc:spChg chg="add mod">
          <ac:chgData name="Wencai Zhang" userId="4a86a1d0-2108-4707-8228-1110f3c1be85" providerId="ADAL" clId="{A45B31E0-981A-6046-8AF7-6AF718FF8717}" dt="2022-05-01T12:55:19.827" v="851" actId="20577"/>
          <ac:spMkLst>
            <pc:docMk/>
            <pc:sldMk cId="472844202" sldId="292"/>
            <ac:spMk id="29" creationId="{8159EBA0-1456-A543-93EF-520D59E0E826}"/>
          </ac:spMkLst>
        </pc:spChg>
        <pc:spChg chg="add mod">
          <ac:chgData name="Wencai Zhang" userId="4a86a1d0-2108-4707-8228-1110f3c1be85" providerId="ADAL" clId="{A45B31E0-981A-6046-8AF7-6AF718FF8717}" dt="2022-05-02T01:13:36.365" v="1074" actId="20577"/>
          <ac:spMkLst>
            <pc:docMk/>
            <pc:sldMk cId="472844202" sldId="292"/>
            <ac:spMk id="32" creationId="{62C6F7E6-04DF-1548-BD3C-454D15C0CE2C}"/>
          </ac:spMkLst>
        </pc:spChg>
        <pc:spChg chg="mod">
          <ac:chgData name="Wencai Zhang" userId="4a86a1d0-2108-4707-8228-1110f3c1be85" providerId="ADAL" clId="{A45B31E0-981A-6046-8AF7-6AF718FF8717}" dt="2022-04-29T12:30:35.592" v="644" actId="113"/>
          <ac:spMkLst>
            <pc:docMk/>
            <pc:sldMk cId="472844202" sldId="292"/>
            <ac:spMk id="53" creationId="{1C7AE62F-7331-6A4F-BD62-30EDB06168D1}"/>
          </ac:spMkLst>
        </pc:spChg>
        <pc:spChg chg="mod">
          <ac:chgData name="Wencai Zhang" userId="4a86a1d0-2108-4707-8228-1110f3c1be85" providerId="ADAL" clId="{A45B31E0-981A-6046-8AF7-6AF718FF8717}" dt="2022-05-01T12:45:44.277" v="804" actId="1037"/>
          <ac:spMkLst>
            <pc:docMk/>
            <pc:sldMk cId="472844202" sldId="292"/>
            <ac:spMk id="56" creationId="{6E8B1600-BDFD-3F4E-8D21-B3C5CD3B5C91}"/>
          </ac:spMkLst>
        </pc:spChg>
        <pc:spChg chg="mod">
          <ac:chgData name="Wencai Zhang" userId="4a86a1d0-2108-4707-8228-1110f3c1be85" providerId="ADAL" clId="{A45B31E0-981A-6046-8AF7-6AF718FF8717}" dt="2022-05-01T12:48:24.960" v="837" actId="1036"/>
          <ac:spMkLst>
            <pc:docMk/>
            <pc:sldMk cId="472844202" sldId="292"/>
            <ac:spMk id="57" creationId="{537D2475-2420-534A-872B-3D280AEF39BE}"/>
          </ac:spMkLst>
        </pc:spChg>
        <pc:spChg chg="del mod">
          <ac:chgData name="Wencai Zhang" userId="4a86a1d0-2108-4707-8228-1110f3c1be85" providerId="ADAL" clId="{A45B31E0-981A-6046-8AF7-6AF718FF8717}" dt="2022-05-01T12:47:28.360" v="805" actId="478"/>
          <ac:spMkLst>
            <pc:docMk/>
            <pc:sldMk cId="472844202" sldId="292"/>
            <ac:spMk id="78" creationId="{A3D17023-AF8D-F74C-942C-B55AB093F91C}"/>
          </ac:spMkLst>
        </pc:spChg>
        <pc:spChg chg="mod">
          <ac:chgData name="Wencai Zhang" userId="4a86a1d0-2108-4707-8228-1110f3c1be85" providerId="ADAL" clId="{A45B31E0-981A-6046-8AF7-6AF718FF8717}" dt="2022-05-01T12:56:34.235" v="881" actId="20577"/>
          <ac:spMkLst>
            <pc:docMk/>
            <pc:sldMk cId="472844202" sldId="292"/>
            <ac:spMk id="79" creationId="{2E7F0FDE-E91E-7B48-BBE0-E424286AD541}"/>
          </ac:spMkLst>
        </pc:spChg>
        <pc:spChg chg="mod">
          <ac:chgData name="Wencai Zhang" userId="4a86a1d0-2108-4707-8228-1110f3c1be85" providerId="ADAL" clId="{A45B31E0-981A-6046-8AF7-6AF718FF8717}" dt="2022-05-02T01:13:30.131" v="1072" actId="20577"/>
          <ac:spMkLst>
            <pc:docMk/>
            <pc:sldMk cId="472844202" sldId="292"/>
            <ac:spMk id="81" creationId="{869179CE-BA14-5D41-9FF2-43903C401B9E}"/>
          </ac:spMkLst>
        </pc:spChg>
        <pc:spChg chg="mod">
          <ac:chgData name="Wencai Zhang" userId="4a86a1d0-2108-4707-8228-1110f3c1be85" providerId="ADAL" clId="{A45B31E0-981A-6046-8AF7-6AF718FF8717}" dt="2022-04-29T12:30:39.019" v="645" actId="113"/>
          <ac:spMkLst>
            <pc:docMk/>
            <pc:sldMk cId="472844202" sldId="292"/>
            <ac:spMk id="93" creationId="{06F92ECF-BE52-A646-9686-645E20F75B35}"/>
          </ac:spMkLst>
        </pc:spChg>
        <pc:spChg chg="mod">
          <ac:chgData name="Wencai Zhang" userId="4a86a1d0-2108-4707-8228-1110f3c1be85" providerId="ADAL" clId="{A45B31E0-981A-6046-8AF7-6AF718FF8717}" dt="2022-05-01T12:56:01.331" v="861" actId="20577"/>
          <ac:spMkLst>
            <pc:docMk/>
            <pc:sldMk cId="472844202" sldId="292"/>
            <ac:spMk id="103" creationId="{79C76ECA-1330-8D4F-8837-45A7FDEE4ACD}"/>
          </ac:spMkLst>
        </pc:spChg>
        <pc:spChg chg="mod">
          <ac:chgData name="Wencai Zhang" userId="4a86a1d0-2108-4707-8228-1110f3c1be85" providerId="ADAL" clId="{A45B31E0-981A-6046-8AF7-6AF718FF8717}" dt="2022-05-01T12:56:24.517" v="880" actId="20577"/>
          <ac:spMkLst>
            <pc:docMk/>
            <pc:sldMk cId="472844202" sldId="292"/>
            <ac:spMk id="104" creationId="{6214CD0E-DAD8-0043-8967-B2C91555E0E7}"/>
          </ac:spMkLst>
        </pc:spChg>
        <pc:grpChg chg="add mod">
          <ac:chgData name="Wencai Zhang" userId="4a86a1d0-2108-4707-8228-1110f3c1be85" providerId="ADAL" clId="{A45B31E0-981A-6046-8AF7-6AF718FF8717}" dt="2022-05-01T12:48:09.644" v="835" actId="164"/>
          <ac:grpSpMkLst>
            <pc:docMk/>
            <pc:sldMk cId="472844202" sldId="292"/>
            <ac:grpSpMk id="2" creationId="{AE49079E-C419-4540-AA34-4C5B434D9A8F}"/>
          </ac:grpSpMkLst>
        </pc:grpChg>
        <pc:grpChg chg="mod">
          <ac:chgData name="Wencai Zhang" userId="4a86a1d0-2108-4707-8228-1110f3c1be85" providerId="ADAL" clId="{A45B31E0-981A-6046-8AF7-6AF718FF8717}" dt="2022-05-01T12:48:09.644" v="835" actId="164"/>
          <ac:grpSpMkLst>
            <pc:docMk/>
            <pc:sldMk cId="472844202" sldId="292"/>
            <ac:grpSpMk id="49" creationId="{A073D633-CCD7-FA46-A35F-914773CDEC7D}"/>
          </ac:grpSpMkLst>
        </pc:grpChg>
        <pc:grpChg chg="del">
          <ac:chgData name="Wencai Zhang" userId="4a86a1d0-2108-4707-8228-1110f3c1be85" providerId="ADAL" clId="{A45B31E0-981A-6046-8AF7-6AF718FF8717}" dt="2022-05-01T12:47:28.360" v="805" actId="478"/>
          <ac:grpSpMkLst>
            <pc:docMk/>
            <pc:sldMk cId="472844202" sldId="292"/>
            <ac:grpSpMk id="77" creationId="{FAAF95AE-CFBC-614E-9E64-D89A0D7E096F}"/>
          </ac:grpSpMkLst>
        </pc:grpChg>
        <pc:grpChg chg="mod">
          <ac:chgData name="Wencai Zhang" userId="4a86a1d0-2108-4707-8228-1110f3c1be85" providerId="ADAL" clId="{A45B31E0-981A-6046-8AF7-6AF718FF8717}" dt="2022-05-01T01:18:42.938" v="696" actId="1037"/>
          <ac:grpSpMkLst>
            <pc:docMk/>
            <pc:sldMk cId="472844202" sldId="292"/>
            <ac:grpSpMk id="82" creationId="{95834E53-3BA1-0749-9321-A5634C20B413}"/>
          </ac:grpSpMkLst>
        </pc:grpChg>
        <pc:picChg chg="mod">
          <ac:chgData name="Wencai Zhang" userId="4a86a1d0-2108-4707-8228-1110f3c1be85" providerId="ADAL" clId="{A45B31E0-981A-6046-8AF7-6AF718FF8717}" dt="2022-05-01T12:45:17.744" v="796"/>
          <ac:picMkLst>
            <pc:docMk/>
            <pc:sldMk cId="472844202" sldId="292"/>
            <ac:picMk id="99" creationId="{DFA00951-0BF3-584A-90F2-D71313D5C9CF}"/>
          </ac:picMkLst>
        </pc:picChg>
      </pc:sldChg>
      <pc:sldChg chg="addSp delSp modSp mod">
        <pc:chgData name="Wencai Zhang" userId="4a86a1d0-2108-4707-8228-1110f3c1be85" providerId="ADAL" clId="{A45B31E0-981A-6046-8AF7-6AF718FF8717}" dt="2022-05-01T01:17:31.771" v="652" actId="20577"/>
        <pc:sldMkLst>
          <pc:docMk/>
          <pc:sldMk cId="492363108" sldId="293"/>
        </pc:sldMkLst>
        <pc:spChg chg="mod">
          <ac:chgData name="Wencai Zhang" userId="4a86a1d0-2108-4707-8228-1110f3c1be85" providerId="ADAL" clId="{A45B31E0-981A-6046-8AF7-6AF718FF8717}" dt="2022-05-01T01:17:31.771" v="652" actId="20577"/>
          <ac:spMkLst>
            <pc:docMk/>
            <pc:sldMk cId="492363108" sldId="293"/>
            <ac:spMk id="17" creationId="{649CC280-8498-5F47-A7C8-A30278508115}"/>
          </ac:spMkLst>
        </pc:spChg>
        <pc:spChg chg="mod">
          <ac:chgData name="Wencai Zhang" userId="4a86a1d0-2108-4707-8228-1110f3c1be85" providerId="ADAL" clId="{A45B31E0-981A-6046-8AF7-6AF718FF8717}" dt="2022-05-01T01:17:25.985" v="650" actId="20577"/>
          <ac:spMkLst>
            <pc:docMk/>
            <pc:sldMk cId="492363108" sldId="293"/>
            <ac:spMk id="49" creationId="{393B87F7-0301-414F-A165-54A34714662C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53" creationId="{3D350C17-0DE6-ED4E-9BFC-456C406D86E0}"/>
          </ac:spMkLst>
        </pc:spChg>
        <pc:spChg chg="mod">
          <ac:chgData name="Wencai Zhang" userId="4a86a1d0-2108-4707-8228-1110f3c1be85" providerId="ADAL" clId="{A45B31E0-981A-6046-8AF7-6AF718FF8717}" dt="2022-04-29T00:06:11.390" v="433" actId="1036"/>
          <ac:spMkLst>
            <pc:docMk/>
            <pc:sldMk cId="492363108" sldId="293"/>
            <ac:spMk id="57" creationId="{92B9BF22-2E03-4145-A99C-E336F9301AF2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62" creationId="{69BD8DC7-A18D-5B46-B8C1-820DC41A18B8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63" creationId="{28602894-AD05-D145-B42A-02830051BA05}"/>
          </ac:spMkLst>
        </pc:spChg>
        <pc:spChg chg="del">
          <ac:chgData name="Wencai Zhang" userId="4a86a1d0-2108-4707-8228-1110f3c1be85" providerId="ADAL" clId="{A45B31E0-981A-6046-8AF7-6AF718FF8717}" dt="2022-04-29T00:15:45.460" v="487" actId="478"/>
          <ac:spMkLst>
            <pc:docMk/>
            <pc:sldMk cId="492363108" sldId="293"/>
            <ac:spMk id="64" creationId="{F0288BB7-CE51-E145-B29B-E4BAB1981314}"/>
          </ac:spMkLst>
        </pc:spChg>
        <pc:spChg chg="mod">
          <ac:chgData name="Wencai Zhang" userId="4a86a1d0-2108-4707-8228-1110f3c1be85" providerId="ADAL" clId="{A45B31E0-981A-6046-8AF7-6AF718FF8717}" dt="2022-04-29T00:17:51.739" v="639" actId="1035"/>
          <ac:spMkLst>
            <pc:docMk/>
            <pc:sldMk cId="492363108" sldId="293"/>
            <ac:spMk id="71" creationId="{B374758E-F00A-4241-BB9E-0D85038713F6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73" creationId="{3E74BA67-9FF1-C74A-BAED-15E8E85EC296}"/>
          </ac:spMkLst>
        </pc:spChg>
        <pc:spChg chg="mod">
          <ac:chgData name="Wencai Zhang" userId="4a86a1d0-2108-4707-8228-1110f3c1be85" providerId="ADAL" clId="{A45B31E0-981A-6046-8AF7-6AF718FF8717}" dt="2022-04-29T00:06:11.390" v="433" actId="1036"/>
          <ac:spMkLst>
            <pc:docMk/>
            <pc:sldMk cId="492363108" sldId="293"/>
            <ac:spMk id="76" creationId="{C45111EC-F0A0-5943-96E4-09196A7F17DF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86" creationId="{B022141C-481D-AE4E-86E8-2C9267D0615B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88" creationId="{BED3237E-EB4F-D348-892F-02F34EDC01FD}"/>
          </ac:spMkLst>
        </pc:spChg>
        <pc:spChg chg="del">
          <ac:chgData name="Wencai Zhang" userId="4a86a1d0-2108-4707-8228-1110f3c1be85" providerId="ADAL" clId="{A45B31E0-981A-6046-8AF7-6AF718FF8717}" dt="2022-04-29T00:16:08.963" v="490" actId="478"/>
          <ac:spMkLst>
            <pc:docMk/>
            <pc:sldMk cId="492363108" sldId="293"/>
            <ac:spMk id="89" creationId="{0AA3302E-C0BD-6B44-83DC-1ED06F5AB55C}"/>
          </ac:spMkLst>
        </pc:spChg>
        <pc:spChg chg="mod topLvl">
          <ac:chgData name="Wencai Zhang" userId="4a86a1d0-2108-4707-8228-1110f3c1be85" providerId="ADAL" clId="{A45B31E0-981A-6046-8AF7-6AF718FF8717}" dt="2022-04-29T00:03:17.231" v="390" actId="164"/>
          <ac:spMkLst>
            <pc:docMk/>
            <pc:sldMk cId="492363108" sldId="293"/>
            <ac:spMk id="93" creationId="{03B3531F-F26C-5147-A1C0-6A669DE2D705}"/>
          </ac:spMkLst>
        </pc:spChg>
        <pc:spChg chg="mod topLvl">
          <ac:chgData name="Wencai Zhang" userId="4a86a1d0-2108-4707-8228-1110f3c1be85" providerId="ADAL" clId="{A45B31E0-981A-6046-8AF7-6AF718FF8717}" dt="2022-04-29T00:03:17.231" v="390" actId="164"/>
          <ac:spMkLst>
            <pc:docMk/>
            <pc:sldMk cId="492363108" sldId="293"/>
            <ac:spMk id="94" creationId="{72B6AF2F-34CF-C748-98C0-0A03A4376F79}"/>
          </ac:spMkLst>
        </pc:spChg>
        <pc:spChg chg="mod topLvl">
          <ac:chgData name="Wencai Zhang" userId="4a86a1d0-2108-4707-8228-1110f3c1be85" providerId="ADAL" clId="{A45B31E0-981A-6046-8AF7-6AF718FF8717}" dt="2022-04-29T00:03:11.872" v="389" actId="165"/>
          <ac:spMkLst>
            <pc:docMk/>
            <pc:sldMk cId="492363108" sldId="293"/>
            <ac:spMk id="95" creationId="{1EAE1973-EC4B-5246-9CCA-6A660F268071}"/>
          </ac:spMkLst>
        </pc:spChg>
        <pc:spChg chg="mod">
          <ac:chgData name="Wencai Zhang" userId="4a86a1d0-2108-4707-8228-1110f3c1be85" providerId="ADAL" clId="{A45B31E0-981A-6046-8AF7-6AF718FF8717}" dt="2022-04-29T00:17:45.533" v="635" actId="1035"/>
          <ac:spMkLst>
            <pc:docMk/>
            <pc:sldMk cId="492363108" sldId="293"/>
            <ac:spMk id="96" creationId="{936DBA25-C5B8-5C48-ABC1-72428939BDAD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98" creationId="{E64C069D-59EA-B54F-BEC8-16B484C87FCA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99" creationId="{B77BCAC4-276B-5F4C-8EE4-A12AE5D8B252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100" creationId="{D0443241-C675-8E44-9665-CAAAB0EA907A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101" creationId="{C7A7A52F-7BC1-7B47-82D4-47F8B04F86CC}"/>
          </ac:spMkLst>
        </pc:spChg>
        <pc:spChg chg="mod">
          <ac:chgData name="Wencai Zhang" userId="4a86a1d0-2108-4707-8228-1110f3c1be85" providerId="ADAL" clId="{A45B31E0-981A-6046-8AF7-6AF718FF8717}" dt="2022-04-29T00:15:46.431" v="488"/>
          <ac:spMkLst>
            <pc:docMk/>
            <pc:sldMk cId="492363108" sldId="293"/>
            <ac:spMk id="102" creationId="{AB7B5236-FA90-5F45-BB57-903BBBF0CDAE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06" creationId="{E4761DA1-5287-9F40-93CD-C83F76A18BF7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107" creationId="{F393D83C-06E7-C24C-B7C7-1FC995136C1C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108" creationId="{33C4E2A0-AB1C-BD4B-AD9D-7818CF0169CD}"/>
          </ac:spMkLst>
        </pc:spChg>
        <pc:spChg chg="mod">
          <ac:chgData name="Wencai Zhang" userId="4a86a1d0-2108-4707-8228-1110f3c1be85" providerId="ADAL" clId="{A45B31E0-981A-6046-8AF7-6AF718FF8717}" dt="2022-04-29T00:16:24.932" v="491" actId="164"/>
          <ac:spMkLst>
            <pc:docMk/>
            <pc:sldMk cId="492363108" sldId="293"/>
            <ac:spMk id="109" creationId="{F54ED270-1D3C-C340-8A9C-A148C0FAD655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10" creationId="{6FC2F49D-A940-2D45-9CB9-FE943E630228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11" creationId="{6CF9B93F-D90B-5946-A87C-243DBD7E672F}"/>
          </ac:spMkLst>
        </pc:spChg>
        <pc:spChg chg="mod">
          <ac:chgData name="Wencai Zhang" userId="4a86a1d0-2108-4707-8228-1110f3c1be85" providerId="ADAL" clId="{A45B31E0-981A-6046-8AF7-6AF718FF8717}" dt="2022-04-29T00:16:47.992" v="494"/>
          <ac:spMkLst>
            <pc:docMk/>
            <pc:sldMk cId="492363108" sldId="293"/>
            <ac:spMk id="112" creationId="{7CCA67CA-80F6-634D-A824-FFDFCCCD697B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4" creationId="{7CC4D659-77FF-7F49-BCD2-93A6745AB79A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5" creationId="{1524E56F-2444-E941-A82B-F64DCB79B30F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7" creationId="{129FF497-9F0B-B046-93DA-BA451EA7A57E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18" creationId="{F56F3AC5-7BED-D649-88B1-AC6C8F24AF83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19" creationId="{35CFCAA0-B52C-CE42-9CE5-E6D6CDBBF189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22" creationId="{0E211FD0-7445-CB49-82DE-79C013741B54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23" creationId="{0B93AAD8-5108-494F-8CD7-FF29968C0FFA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26" creationId="{AEFE0ACF-39FC-9A43-BFB7-A65F6FD0CD34}"/>
          </ac:spMkLst>
        </pc:spChg>
        <pc:spChg chg="mod">
          <ac:chgData name="Wencai Zhang" userId="4a86a1d0-2108-4707-8228-1110f3c1be85" providerId="ADAL" clId="{A45B31E0-981A-6046-8AF7-6AF718FF8717}" dt="2022-04-29T00:17:07.917" v="552"/>
          <ac:spMkLst>
            <pc:docMk/>
            <pc:sldMk cId="492363108" sldId="293"/>
            <ac:spMk id="130" creationId="{1EAADBE5-1F20-7145-A532-9984B50D3E09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32" creationId="{BBC77043-615E-044C-B621-BE7E0519A1FB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33" creationId="{2AC73E87-EFB3-9941-93B7-33BD189F296C}"/>
          </ac:spMkLst>
        </pc:spChg>
        <pc:spChg chg="del">
          <ac:chgData name="Wencai Zhang" userId="4a86a1d0-2108-4707-8228-1110f3c1be85" providerId="ADAL" clId="{A45B31E0-981A-6046-8AF7-6AF718FF8717}" dt="2022-04-29T00:16:35.359" v="493" actId="478"/>
          <ac:spMkLst>
            <pc:docMk/>
            <pc:sldMk cId="492363108" sldId="293"/>
            <ac:spMk id="134" creationId="{A53A9AE6-32BE-0D47-ACCD-EA61CFD330CB}"/>
          </ac:spMkLst>
        </pc:spChg>
        <pc:spChg chg="mod">
          <ac:chgData name="Wencai Zhang" userId="4a86a1d0-2108-4707-8228-1110f3c1be85" providerId="ADAL" clId="{A45B31E0-981A-6046-8AF7-6AF718FF8717}" dt="2022-04-29T00:17:58.020" v="643" actId="1036"/>
          <ac:spMkLst>
            <pc:docMk/>
            <pc:sldMk cId="492363108" sldId="293"/>
            <ac:spMk id="141" creationId="{9BEAAF36-C230-344B-ADE6-EF4D247BFDA5}"/>
          </ac:spMkLst>
        </pc:spChg>
        <pc:spChg chg="mod topLvl">
          <ac:chgData name="Wencai Zhang" userId="4a86a1d0-2108-4707-8228-1110f3c1be85" providerId="ADAL" clId="{A45B31E0-981A-6046-8AF7-6AF718FF8717}" dt="2022-04-29T00:03:04.909" v="388" actId="164"/>
          <ac:spMkLst>
            <pc:docMk/>
            <pc:sldMk cId="492363108" sldId="293"/>
            <ac:spMk id="145" creationId="{B11FF997-995C-8049-B29F-5007AD6A2341}"/>
          </ac:spMkLst>
        </pc:spChg>
        <pc:spChg chg="mod topLvl">
          <ac:chgData name="Wencai Zhang" userId="4a86a1d0-2108-4707-8228-1110f3c1be85" providerId="ADAL" clId="{A45B31E0-981A-6046-8AF7-6AF718FF8717}" dt="2022-04-29T00:03:04.909" v="388" actId="164"/>
          <ac:spMkLst>
            <pc:docMk/>
            <pc:sldMk cId="492363108" sldId="293"/>
            <ac:spMk id="146" creationId="{D0519B28-BB21-5741-9AFE-EE53F920D693}"/>
          </ac:spMkLst>
        </pc:spChg>
        <pc:spChg chg="mod topLvl">
          <ac:chgData name="Wencai Zhang" userId="4a86a1d0-2108-4707-8228-1110f3c1be85" providerId="ADAL" clId="{A45B31E0-981A-6046-8AF7-6AF718FF8717}" dt="2022-04-29T00:02:58.513" v="387" actId="165"/>
          <ac:spMkLst>
            <pc:docMk/>
            <pc:sldMk cId="492363108" sldId="293"/>
            <ac:spMk id="147" creationId="{364D17C7-902F-4F43-96D0-650E0DE2DFF4}"/>
          </ac:spMkLst>
        </pc:spChg>
        <pc:grpChg chg="add mod">
          <ac:chgData name="Wencai Zhang" userId="4a86a1d0-2108-4707-8228-1110f3c1be85" providerId="ADAL" clId="{A45B31E0-981A-6046-8AF7-6AF718FF8717}" dt="2022-04-29T00:06:11.390" v="433" actId="1036"/>
          <ac:grpSpMkLst>
            <pc:docMk/>
            <pc:sldMk cId="492363108" sldId="293"/>
            <ac:grpSpMk id="32" creationId="{1F70B7E6-865E-FE4E-A24C-65DF62C62C5F}"/>
          </ac:grpSpMkLst>
        </pc:grpChg>
        <pc:grpChg chg="add mod">
          <ac:chgData name="Wencai Zhang" userId="4a86a1d0-2108-4707-8228-1110f3c1be85" providerId="ADAL" clId="{A45B31E0-981A-6046-8AF7-6AF718FF8717}" dt="2022-04-29T00:06:11.390" v="433" actId="1036"/>
          <ac:grpSpMkLst>
            <pc:docMk/>
            <pc:sldMk cId="492363108" sldId="293"/>
            <ac:grpSpMk id="33" creationId="{15FA01C5-AA9D-F042-B936-3E80A5DFD434}"/>
          </ac:grpSpMkLst>
        </pc:grpChg>
        <pc:grpChg chg="add mod">
          <ac:chgData name="Wencai Zhang" userId="4a86a1d0-2108-4707-8228-1110f3c1be85" providerId="ADAL" clId="{A45B31E0-981A-6046-8AF7-6AF718FF8717}" dt="2022-04-29T00:16:29.024" v="492" actId="1076"/>
          <ac:grpSpMkLst>
            <pc:docMk/>
            <pc:sldMk cId="492363108" sldId="293"/>
            <ac:grpSpMk id="34" creationId="{E47D2EDA-C3CA-A748-A7D9-3A377DD9E68C}"/>
          </ac:grpSpMkLst>
        </pc:grpChg>
        <pc:grpChg chg="del">
          <ac:chgData name="Wencai Zhang" userId="4a86a1d0-2108-4707-8228-1110f3c1be85" providerId="ADAL" clId="{A45B31E0-981A-6046-8AF7-6AF718FF8717}" dt="2022-04-29T00:03:11.872" v="389" actId="165"/>
          <ac:grpSpMkLst>
            <pc:docMk/>
            <pc:sldMk cId="492363108" sldId="293"/>
            <ac:grpSpMk id="90" creationId="{AA12D019-BE12-0240-B0DD-1AAAD8EA483F}"/>
          </ac:grpSpMkLst>
        </pc:grpChg>
        <pc:grpChg chg="add mod">
          <ac:chgData name="Wencai Zhang" userId="4a86a1d0-2108-4707-8228-1110f3c1be85" providerId="ADAL" clId="{A45B31E0-981A-6046-8AF7-6AF718FF8717}" dt="2022-04-29T00:16:02.362" v="489" actId="1076"/>
          <ac:grpSpMkLst>
            <pc:docMk/>
            <pc:sldMk cId="492363108" sldId="293"/>
            <ac:grpSpMk id="97" creationId="{FE66648E-44FB-1A4A-B4CD-116E7A6FF695}"/>
          </ac:grpSpMkLst>
        </pc:grpChg>
        <pc:grpChg chg="add mod">
          <ac:chgData name="Wencai Zhang" userId="4a86a1d0-2108-4707-8228-1110f3c1be85" providerId="ADAL" clId="{A45B31E0-981A-6046-8AF7-6AF718FF8717}" dt="2022-04-29T00:17:02.062" v="551" actId="1038"/>
          <ac:grpSpMkLst>
            <pc:docMk/>
            <pc:sldMk cId="492363108" sldId="293"/>
            <ac:grpSpMk id="104" creationId="{8FB0CC18-C7C5-7845-862E-DBE1AC74FEB3}"/>
          </ac:grpSpMkLst>
        </pc:grpChg>
        <pc:grpChg chg="add mod">
          <ac:chgData name="Wencai Zhang" userId="4a86a1d0-2108-4707-8228-1110f3c1be85" providerId="ADAL" clId="{A45B31E0-981A-6046-8AF7-6AF718FF8717}" dt="2022-04-29T00:17:24.911" v="624" actId="1038"/>
          <ac:grpSpMkLst>
            <pc:docMk/>
            <pc:sldMk cId="492363108" sldId="293"/>
            <ac:grpSpMk id="113" creationId="{82FD9FF6-35A7-5444-8781-EF176B614926}"/>
          </ac:grpSpMkLst>
        </pc:grpChg>
        <pc:grpChg chg="add mod">
          <ac:chgData name="Wencai Zhang" userId="4a86a1d0-2108-4707-8228-1110f3c1be85" providerId="ADAL" clId="{A45B31E0-981A-6046-8AF7-6AF718FF8717}" dt="2022-04-29T00:17:36.852" v="630" actId="1037"/>
          <ac:grpSpMkLst>
            <pc:docMk/>
            <pc:sldMk cId="492363108" sldId="293"/>
            <ac:grpSpMk id="120" creationId="{AB69554B-C1C4-C140-AE1B-4BEF79FC51FC}"/>
          </ac:grpSpMkLst>
        </pc:grpChg>
        <pc:grpChg chg="del">
          <ac:chgData name="Wencai Zhang" userId="4a86a1d0-2108-4707-8228-1110f3c1be85" providerId="ADAL" clId="{A45B31E0-981A-6046-8AF7-6AF718FF8717}" dt="2022-04-29T00:02:58.513" v="387" actId="165"/>
          <ac:grpSpMkLst>
            <pc:docMk/>
            <pc:sldMk cId="492363108" sldId="293"/>
            <ac:grpSpMk id="142" creationId="{D2C00862-C2DF-724F-9111-6676E2CF585A}"/>
          </ac:grpSpMkLst>
        </pc:grpChg>
        <pc:picChg chg="mod modCrop">
          <ac:chgData name="Wencai Zhang" userId="4a86a1d0-2108-4707-8228-1110f3c1be85" providerId="ADAL" clId="{A45B31E0-981A-6046-8AF7-6AF718FF8717}" dt="2022-04-29T00:06:36.608" v="435" actId="732"/>
          <ac:picMkLst>
            <pc:docMk/>
            <pc:sldMk cId="492363108" sldId="293"/>
            <ac:picMk id="54" creationId="{C0CB6ABD-8B3D-B145-B7FC-F88644741EC1}"/>
          </ac:picMkLst>
        </pc:picChg>
        <pc:picChg chg="mod modCrop">
          <ac:chgData name="Wencai Zhang" userId="4a86a1d0-2108-4707-8228-1110f3c1be85" providerId="ADAL" clId="{A45B31E0-981A-6046-8AF7-6AF718FF8717}" dt="2022-04-29T00:06:26.256" v="434" actId="732"/>
          <ac:picMkLst>
            <pc:docMk/>
            <pc:sldMk cId="492363108" sldId="293"/>
            <ac:picMk id="75" creationId="{2331D386-E1C3-B246-B8A8-197098E47CF1}"/>
          </ac:picMkLst>
        </pc:picChg>
        <pc:picChg chg="mod modCrop">
          <ac:chgData name="Wencai Zhang" userId="4a86a1d0-2108-4707-8228-1110f3c1be85" providerId="ADAL" clId="{A45B31E0-981A-6046-8AF7-6AF718FF8717}" dt="2022-04-29T00:05:16.554" v="428" actId="732"/>
          <ac:picMkLst>
            <pc:docMk/>
            <pc:sldMk cId="492363108" sldId="293"/>
            <ac:picMk id="103" creationId="{9870E93B-6C4B-2C4B-8D77-BB5CFD1397F6}"/>
          </ac:picMkLst>
        </pc:picChg>
        <pc:picChg chg="mod modCrop">
          <ac:chgData name="Wencai Zhang" userId="4a86a1d0-2108-4707-8228-1110f3c1be85" providerId="ADAL" clId="{A45B31E0-981A-6046-8AF7-6AF718FF8717}" dt="2022-04-29T00:05:07.566" v="427" actId="732"/>
          <ac:picMkLst>
            <pc:docMk/>
            <pc:sldMk cId="492363108" sldId="293"/>
            <ac:picMk id="129" creationId="{2BD61A97-DEC8-DD4C-84C9-0EAC6A03CDC5}"/>
          </ac:picMkLst>
        </pc:picChg>
      </pc:sldChg>
    </pc:docChg>
  </pc:docChgLst>
  <pc:docChgLst>
    <pc:chgData name="Wencai Zhang" userId="4a86a1d0-2108-4707-8228-1110f3c1be85" providerId="ADAL" clId="{D4FDBF6D-7B63-FD46-B677-DD3873AF8B82}"/>
    <pc:docChg chg="undo custSel modSld">
      <pc:chgData name="Wencai Zhang" userId="4a86a1d0-2108-4707-8228-1110f3c1be85" providerId="ADAL" clId="{D4FDBF6D-7B63-FD46-B677-DD3873AF8B82}" dt="2021-09-10T19:19:54.103" v="198" actId="1038"/>
      <pc:docMkLst>
        <pc:docMk/>
      </pc:docMkLst>
      <pc:sldChg chg="addSp delSp modSp">
        <pc:chgData name="Wencai Zhang" userId="4a86a1d0-2108-4707-8228-1110f3c1be85" providerId="ADAL" clId="{D4FDBF6D-7B63-FD46-B677-DD3873AF8B82}" dt="2021-09-10T19:19:54.103" v="198" actId="1038"/>
        <pc:sldMkLst>
          <pc:docMk/>
          <pc:sldMk cId="1997077850" sldId="279"/>
        </pc:sldMkLst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6" creationId="{F3DB81E6-B77D-A343-8DE3-1FFFD129AA77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22" creationId="{0CC7DB87-FD1B-9A46-95DD-3CB778F2DEFB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23" creationId="{F8879FD2-5F0B-ED4B-9872-81F5DD67350C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0" creationId="{4ACB04AC-6584-F145-ADEB-8DCE33FFED73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1" creationId="{EE2F4E35-1C90-FC4B-A1EF-38D6074BBB14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2" creationId="{EA247580-D60C-CC44-AD96-F72D39815C41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3" creationId="{6492B21C-2371-A240-8008-081FEE14107E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6" creationId="{B6F5231E-3128-434A-B4BA-793D62577317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7" creationId="{A8F89C04-90D8-9440-B0F8-8FFCA9BFD855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8" creationId="{5C89201E-6609-654B-977D-63BA903881E0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69" creationId="{317683C1-D6CE-E746-BE57-2D817D93B423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198" creationId="{EF53831F-FAC6-B74D-9E68-DBBEA9D481FA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3" creationId="{1069A7EB-D519-314B-B073-8E217A616EB9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4" creationId="{7957ABCD-52EA-574E-8E5F-1847FF566FE1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5" creationId="{672C5019-AE7E-294E-9673-34EA7EC0E9D9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26" creationId="{A863BAE8-AA5D-E74A-B2AA-2B41B71E0322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32" creationId="{20C039F8-4FE6-4ED7-B690-81C56CA93C6B}"/>
          </ac:spMkLst>
        </pc:spChg>
        <pc:spChg chg="mod topLvl">
          <ac:chgData name="Wencai Zhang" userId="4a86a1d0-2108-4707-8228-1110f3c1be85" providerId="ADAL" clId="{D4FDBF6D-7B63-FD46-B677-DD3873AF8B82}" dt="2021-09-10T19:17:51.579" v="162" actId="164"/>
          <ac:spMkLst>
            <pc:docMk/>
            <pc:sldMk cId="1997077850" sldId="279"/>
            <ac:spMk id="233" creationId="{F839E342-6FD4-469F-825B-8828C7EC5CD3}"/>
          </ac:spMkLst>
        </pc:spChg>
        <pc:spChg chg="mod topLvl">
          <ac:chgData name="Wencai Zhang" userId="4a86a1d0-2108-4707-8228-1110f3c1be85" providerId="ADAL" clId="{D4FDBF6D-7B63-FD46-B677-DD3873AF8B82}" dt="2021-09-10T19:17:44.086" v="161" actId="1035"/>
          <ac:spMkLst>
            <pc:docMk/>
            <pc:sldMk cId="1997077850" sldId="279"/>
            <ac:spMk id="235" creationId="{A0A80919-6654-4084-A5B4-EB95DE3617D2}"/>
          </ac:spMkLst>
        </pc:spChg>
        <pc:spChg chg="mod topLvl">
          <ac:chgData name="Wencai Zhang" userId="4a86a1d0-2108-4707-8228-1110f3c1be85" providerId="ADAL" clId="{D4FDBF6D-7B63-FD46-B677-DD3873AF8B82}" dt="2021-09-10T19:19:18.079" v="191" actId="164"/>
          <ac:spMkLst>
            <pc:docMk/>
            <pc:sldMk cId="1997077850" sldId="279"/>
            <ac:spMk id="236" creationId="{D9FFA7F4-798C-4839-A861-E847F8726B1F}"/>
          </ac:spMkLst>
        </pc:spChg>
        <pc:spChg chg="mod topLvl">
          <ac:chgData name="Wencai Zhang" userId="4a86a1d0-2108-4707-8228-1110f3c1be85" providerId="ADAL" clId="{D4FDBF6D-7B63-FD46-B677-DD3873AF8B82}" dt="2021-09-10T19:17:51.579" v="162" actId="164"/>
          <ac:spMkLst>
            <pc:docMk/>
            <pc:sldMk cId="1997077850" sldId="279"/>
            <ac:spMk id="240" creationId="{7E45722A-8A48-4967-91CC-C5143A8CFEFE}"/>
          </ac:spMkLst>
        </pc:spChg>
        <pc:spChg chg="mod">
          <ac:chgData name="Wencai Zhang" userId="4a86a1d0-2108-4707-8228-1110f3c1be85" providerId="ADAL" clId="{D4FDBF6D-7B63-FD46-B677-DD3873AF8B82}" dt="2021-09-10T19:15:44.652" v="106" actId="1037"/>
          <ac:spMkLst>
            <pc:docMk/>
            <pc:sldMk cId="1997077850" sldId="279"/>
            <ac:spMk id="245" creationId="{6685693A-A025-2C4B-ABF4-5B2FFF9B1AFB}"/>
          </ac:spMkLst>
        </pc:spChg>
        <pc:spChg chg="mod">
          <ac:chgData name="Wencai Zhang" userId="4a86a1d0-2108-4707-8228-1110f3c1be85" providerId="ADAL" clId="{D4FDBF6D-7B63-FD46-B677-DD3873AF8B82}" dt="2021-09-10T19:19:54.103" v="198" actId="1038"/>
          <ac:spMkLst>
            <pc:docMk/>
            <pc:sldMk cId="1997077850" sldId="279"/>
            <ac:spMk id="254" creationId="{B45BB2E0-9CE2-0B4F-A328-A728DE931561}"/>
          </ac:spMkLst>
        </pc:spChg>
        <pc:spChg chg="mod">
          <ac:chgData name="Wencai Zhang" userId="4a86a1d0-2108-4707-8228-1110f3c1be85" providerId="ADAL" clId="{D4FDBF6D-7B63-FD46-B677-DD3873AF8B82}" dt="2021-09-10T19:15:40.020" v="98" actId="1037"/>
          <ac:spMkLst>
            <pc:docMk/>
            <pc:sldMk cId="1997077850" sldId="279"/>
            <ac:spMk id="258" creationId="{DE24DF3C-173D-D644-9B05-F5FCC6B6FD9C}"/>
          </ac:spMkLst>
        </pc:spChg>
        <pc:spChg chg="mod topLvl">
          <ac:chgData name="Wencai Zhang" userId="4a86a1d0-2108-4707-8228-1110f3c1be85" providerId="ADAL" clId="{D4FDBF6D-7B63-FD46-B677-DD3873AF8B82}" dt="2021-09-10T19:17:37.414" v="145" actId="164"/>
          <ac:spMkLst>
            <pc:docMk/>
            <pc:sldMk cId="1997077850" sldId="279"/>
            <ac:spMk id="268" creationId="{421BA127-217C-4AAD-9D5E-ED813DBA8669}"/>
          </ac:spMkLst>
        </pc:s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" creationId="{68179CDE-26CC-AE46-A792-A605CA655776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5" creationId="{DF93B195-F799-DC4D-9017-9227DFD88F27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8" creationId="{447B76B8-20C0-6D42-949E-E331C653DE5F}"/>
          </ac:grpSpMkLst>
        </pc:grpChg>
        <pc:grpChg chg="del mod topLvl">
          <ac:chgData name="Wencai Zhang" userId="4a86a1d0-2108-4707-8228-1110f3c1be85" providerId="ADAL" clId="{D4FDBF6D-7B63-FD46-B677-DD3873AF8B82}" dt="2021-09-10T19:00:36.475" v="4" actId="165"/>
          <ac:grpSpMkLst>
            <pc:docMk/>
            <pc:sldMk cId="1997077850" sldId="279"/>
            <ac:grpSpMk id="10" creationId="{51D0DDE7-5A35-9C47-816B-D24198872E22}"/>
          </ac:grpSpMkLst>
        </pc:grpChg>
        <pc:grpChg chg="del mod">
          <ac:chgData name="Wencai Zhang" userId="4a86a1d0-2108-4707-8228-1110f3c1be85" providerId="ADAL" clId="{D4FDBF6D-7B63-FD46-B677-DD3873AF8B82}" dt="2021-09-10T19:00:29.579" v="3" actId="165"/>
          <ac:grpSpMkLst>
            <pc:docMk/>
            <pc:sldMk cId="1997077850" sldId="279"/>
            <ac:grpSpMk id="16" creationId="{F76CB15A-F552-E94C-A4AE-2DC679784160}"/>
          </ac:grpSpMkLst>
        </pc:grpChg>
        <pc:grpChg chg="add del mod">
          <ac:chgData name="Wencai Zhang" userId="4a86a1d0-2108-4707-8228-1110f3c1be85" providerId="ADAL" clId="{D4FDBF6D-7B63-FD46-B677-DD3873AF8B82}" dt="2021-09-10T19:16:49.437" v="112" actId="165"/>
          <ac:grpSpMkLst>
            <pc:docMk/>
            <pc:sldMk cId="1997077850" sldId="279"/>
            <ac:grpSpMk id="17" creationId="{8E55BAF4-2F88-3A4C-8EDD-B853C712F5AA}"/>
          </ac:grpSpMkLst>
        </pc:grpChg>
        <pc:grpChg chg="add mod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" creationId="{195A3B47-E418-DC45-91B5-0D6EE931A316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1" creationId="{E22E3874-2990-6341-842B-A7CB8CDF9CF3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2" creationId="{583683FF-350F-534B-A8B6-93A4E9F3CC81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3" creationId="{BFCE707F-5725-FC41-A3B0-057D21D414EC}"/>
          </ac:grpSpMkLst>
        </pc:grpChg>
        <pc:grpChg chg="add mod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4" creationId="{89A7D3DD-3D93-A84C-B48A-23282A3DE11F}"/>
          </ac:grpSpMkLst>
        </pc:grpChg>
        <pc:grpChg chg="add mod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5" creationId="{10601630-C7D1-0F4B-B3C8-E7057DEB1D4F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55" creationId="{8CA149AD-4572-E64D-B4EA-7329D2DC2F84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0" creationId="{1F56A997-5B1D-0E42-8166-3B7495A9F80E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1" creationId="{A711D4DC-5BDA-6F4E-96ED-F10DF2924F64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2" creationId="{04F75B7C-4C5B-EC44-94F0-80A48FD8E8E3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3" creationId="{EB191E7E-12D3-6144-AD4E-5EB77CC64589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74" creationId="{4A64262C-29B0-0F4F-9F5D-2F04A33294A9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3" creationId="{2C962FB6-4588-664E-9502-4552389B770B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4" creationId="{7FEC941E-0C3D-F14C-8227-0EAEBFE4D084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5" creationId="{A80E09AE-7C92-484B-AD81-E52463D9452A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6" creationId="{3A6C2602-B4F6-9E4E-9ECF-CEE8F8F9D38C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197" creationId="{0D998B61-A34F-B04E-BF80-CC347A427353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52" creationId="{6E3E3AF6-E4A4-D947-8EBA-29486007CF2F}"/>
          </ac:grpSpMkLst>
        </pc:grpChg>
        <pc:grpChg chg="mod topLvl">
          <ac:chgData name="Wencai Zhang" userId="4a86a1d0-2108-4707-8228-1110f3c1be85" providerId="ADAL" clId="{D4FDBF6D-7B63-FD46-B677-DD3873AF8B82}" dt="2021-09-10T19:19:18.079" v="191" actId="164"/>
          <ac:grpSpMkLst>
            <pc:docMk/>
            <pc:sldMk cId="1997077850" sldId="279"/>
            <ac:grpSpMk id="263" creationId="{B947E33E-5CBB-0E48-875E-1E09E8D5987A}"/>
          </ac:grpSpMkLst>
        </pc:grpChg>
        <pc:graphicFrameChg chg="del mod topLvl">
          <ac:chgData name="Wencai Zhang" userId="4a86a1d0-2108-4707-8228-1110f3c1be85" providerId="ADAL" clId="{D4FDBF6D-7B63-FD46-B677-DD3873AF8B82}" dt="2021-09-10T19:07:26.177" v="80" actId="478"/>
          <ac:graphicFrameMkLst>
            <pc:docMk/>
            <pc:sldMk cId="1997077850" sldId="279"/>
            <ac:graphicFrameMk id="227" creationId="{4FD31E4B-C0F6-9C42-9C4A-07D16B71CE78}"/>
          </ac:graphicFrameMkLst>
        </pc:graphicFrameChg>
        <pc:graphicFrameChg chg="del mod topLvl">
          <ac:chgData name="Wencai Zhang" userId="4a86a1d0-2108-4707-8228-1110f3c1be85" providerId="ADAL" clId="{D4FDBF6D-7B63-FD46-B677-DD3873AF8B82}" dt="2021-09-10T19:07:26.177" v="80" actId="478"/>
          <ac:graphicFrameMkLst>
            <pc:docMk/>
            <pc:sldMk cId="1997077850" sldId="279"/>
            <ac:graphicFrameMk id="228" creationId="{26773B13-850E-2B46-866A-BC441E3DCA24}"/>
          </ac:graphicFrameMkLst>
        </pc:graphicFrameChg>
        <pc:graphicFrameChg chg="mod topLvl">
          <ac:chgData name="Wencai Zhang" userId="4a86a1d0-2108-4707-8228-1110f3c1be85" providerId="ADAL" clId="{D4FDBF6D-7B63-FD46-B677-DD3873AF8B82}" dt="2021-09-10T19:19:18.079" v="191" actId="164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mod topLvl">
          <ac:chgData name="Wencai Zhang" userId="4a86a1d0-2108-4707-8228-1110f3c1be85" providerId="ADAL" clId="{D4FDBF6D-7B63-FD46-B677-DD3873AF8B82}" dt="2021-09-10T19:19:18.079" v="191" actId="164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picChg chg="add del mod">
          <ac:chgData name="Wencai Zhang" userId="4a86a1d0-2108-4707-8228-1110f3c1be85" providerId="ADAL" clId="{D4FDBF6D-7B63-FD46-B677-DD3873AF8B82}" dt="2021-09-10T19:07:26.177" v="80" actId="478"/>
          <ac:picMkLst>
            <pc:docMk/>
            <pc:sldMk cId="1997077850" sldId="279"/>
            <ac:picMk id="11" creationId="{CEC7D667-67BA-E248-BF79-9E69B0BE662A}"/>
          </ac:picMkLst>
        </pc:picChg>
        <pc:picChg chg="add 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2" creationId="{8D48EFAF-0B0B-614C-94DF-D55F672F6773}"/>
          </ac:picMkLst>
        </pc:picChg>
        <pc:picChg chg="add del mod">
          <ac:chgData name="Wencai Zhang" userId="4a86a1d0-2108-4707-8228-1110f3c1be85" providerId="ADAL" clId="{D4FDBF6D-7B63-FD46-B677-DD3873AF8B82}" dt="2021-09-10T19:07:26.177" v="80" actId="478"/>
          <ac:picMkLst>
            <pc:docMk/>
            <pc:sldMk cId="1997077850" sldId="279"/>
            <ac:picMk id="13" creationId="{C71A4BC7-CDC8-1341-9709-8E588E5506AF}"/>
          </ac:picMkLst>
        </pc:picChg>
        <pc:picChg chg="add 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4" creationId="{64717BB5-8A3B-C847-9C0E-331DCF4393DE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5" creationId="{9CCBEE8A-65FE-7A4C-A5DE-75F4D2587227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192" creationId="{743A4CB2-B735-4783-B94E-910AE870C15F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31" creationId="{DA8C3D4F-1C6A-324F-96EA-B2FBBB842E89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34" creationId="{8ECD7F06-6619-6948-975E-4874003590B8}"/>
          </ac:picMkLst>
        </pc:picChg>
        <pc:picChg chg="mod topLvl">
          <ac:chgData name="Wencai Zhang" userId="4a86a1d0-2108-4707-8228-1110f3c1be85" providerId="ADAL" clId="{D4FDBF6D-7B63-FD46-B677-DD3873AF8B82}" dt="2021-09-10T19:17:51.579" v="162" actId="164"/>
          <ac:picMkLst>
            <pc:docMk/>
            <pc:sldMk cId="1997077850" sldId="279"/>
            <ac:picMk id="237" creationId="{DB524C63-1BDC-4AFB-8504-645D6BBD2E96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38" creationId="{B360B700-1DD9-3544-BE20-BABFB3ACAB69}"/>
          </ac:picMkLst>
        </pc:picChg>
        <pc:picChg chg="mod topLvl">
          <ac:chgData name="Wencai Zhang" userId="4a86a1d0-2108-4707-8228-1110f3c1be85" providerId="ADAL" clId="{D4FDBF6D-7B63-FD46-B677-DD3873AF8B82}" dt="2021-09-10T19:17:37.414" v="145" actId="164"/>
          <ac:picMkLst>
            <pc:docMk/>
            <pc:sldMk cId="1997077850" sldId="279"/>
            <ac:picMk id="241" creationId="{10093908-948F-4C27-B057-DC3F75727BF5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42" creationId="{0DADD5D4-55AF-5442-9E75-0AA5DDA4D1BA}"/>
          </ac:picMkLst>
        </pc:picChg>
        <pc:picChg chg="mod topLvl">
          <ac:chgData name="Wencai Zhang" userId="4a86a1d0-2108-4707-8228-1110f3c1be85" providerId="ADAL" clId="{D4FDBF6D-7B63-FD46-B677-DD3873AF8B82}" dt="2021-09-10T19:19:18.079" v="191" actId="164"/>
          <ac:picMkLst>
            <pc:docMk/>
            <pc:sldMk cId="1997077850" sldId="279"/>
            <ac:picMk id="267" creationId="{6303280E-8560-614F-99A9-CD6BBF21DDF2}"/>
          </ac:picMkLst>
        </pc:picChg>
      </pc:sldChg>
    </pc:docChg>
  </pc:docChgLst>
  <pc:docChgLst>
    <pc:chgData name="Wencai Zhang" userId="4a86a1d0-2108-4707-8228-1110f3c1be85" providerId="ADAL" clId="{43FB2902-FB1B-0741-9691-4004D89E1DCE}"/>
    <pc:docChg chg="undo custSel addSld delSld modSld">
      <pc:chgData name="Wencai Zhang" userId="4a86a1d0-2108-4707-8228-1110f3c1be85" providerId="ADAL" clId="{43FB2902-FB1B-0741-9691-4004D89E1DCE}" dt="2021-04-14T15:48:18.689" v="929" actId="1076"/>
      <pc:docMkLst>
        <pc:docMk/>
      </pc:docMkLst>
      <pc:sldChg chg="addSp delSp modSp mod">
        <pc:chgData name="Wencai Zhang" userId="4a86a1d0-2108-4707-8228-1110f3c1be85" providerId="ADAL" clId="{43FB2902-FB1B-0741-9691-4004D89E1DCE}" dt="2021-04-14T11:38:12.917" v="614" actId="1076"/>
        <pc:sldMkLst>
          <pc:docMk/>
          <pc:sldMk cId="3242017852" sldId="272"/>
        </pc:sldMkLst>
        <pc:spChg chg="add del mod">
          <ac:chgData name="Wencai Zhang" userId="4a86a1d0-2108-4707-8228-1110f3c1be85" providerId="ADAL" clId="{43FB2902-FB1B-0741-9691-4004D89E1DCE}" dt="2021-04-13T01:21:22.131" v="114"/>
          <ac:spMkLst>
            <pc:docMk/>
            <pc:sldMk cId="3242017852" sldId="272"/>
            <ac:spMk id="2" creationId="{15C6547B-028C-4347-B69A-5557DEB19E71}"/>
          </ac:spMkLst>
        </pc:spChg>
        <pc:spChg chg="add del mod">
          <ac:chgData name="Wencai Zhang" userId="4a86a1d0-2108-4707-8228-1110f3c1be85" providerId="ADAL" clId="{43FB2902-FB1B-0741-9691-4004D89E1DCE}" dt="2021-04-14T01:18:25.164" v="267" actId="478"/>
          <ac:spMkLst>
            <pc:docMk/>
            <pc:sldMk cId="3242017852" sldId="272"/>
            <ac:spMk id="2" creationId="{799756E5-24CE-314C-83D1-F082E588C693}"/>
          </ac:spMkLst>
        </pc:spChg>
        <pc:spChg chg="add del mod">
          <ac:chgData name="Wencai Zhang" userId="4a86a1d0-2108-4707-8228-1110f3c1be85" providerId="ADAL" clId="{43FB2902-FB1B-0741-9691-4004D89E1DCE}" dt="2021-04-14T01:18:52.616" v="271" actId="478"/>
          <ac:spMkLst>
            <pc:docMk/>
            <pc:sldMk cId="3242017852" sldId="272"/>
            <ac:spMk id="5" creationId="{572E23BF-FB20-3A45-AC74-F020E1A61759}"/>
          </ac:spMkLst>
        </pc:spChg>
        <pc:spChg chg="add mod">
          <ac:chgData name="Wencai Zhang" userId="4a86a1d0-2108-4707-8228-1110f3c1be85" providerId="ADAL" clId="{43FB2902-FB1B-0741-9691-4004D89E1DCE}" dt="2021-04-14T11:37:22.378" v="601" actId="20577"/>
          <ac:spMkLst>
            <pc:docMk/>
            <pc:sldMk cId="3242017852" sldId="272"/>
            <ac:spMk id="6" creationId="{25E80C11-7600-E44D-81B5-5295CE52183F}"/>
          </ac:spMkLst>
        </pc:spChg>
        <pc:spChg chg="add mod">
          <ac:chgData name="Wencai Zhang" userId="4a86a1d0-2108-4707-8228-1110f3c1be85" providerId="ADAL" clId="{43FB2902-FB1B-0741-9691-4004D89E1DCE}" dt="2021-04-14T11:36:14.943" v="580" actId="2711"/>
          <ac:spMkLst>
            <pc:docMk/>
            <pc:sldMk cId="3242017852" sldId="272"/>
            <ac:spMk id="10" creationId="{37E76EB7-6695-2942-A4DD-33687AD229BE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7" creationId="{CB4579CA-6AFC-B04C-B28E-A5261FE7AAB3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8" creationId="{B7D96F43-3E5F-F745-A4F2-20E7BB7E4DBA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2" creationId="{E7D8A89C-5DD3-434D-B0F9-4FFE362E8493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3" creationId="{AD8D757C-C30A-EB43-B121-3175844E2FA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4" creationId="{5F985DB3-3403-4941-9802-68C8B7909CD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5" creationId="{0B95831C-C370-F744-8A10-16CF3693E325}"/>
          </ac:spMkLst>
        </pc:spChg>
        <pc:spChg chg="add mod">
          <ac:chgData name="Wencai Zhang" userId="4a86a1d0-2108-4707-8228-1110f3c1be85" providerId="ADAL" clId="{43FB2902-FB1B-0741-9691-4004D89E1DCE}" dt="2021-04-14T11:38:05.805" v="612" actId="1076"/>
          <ac:spMkLst>
            <pc:docMk/>
            <pc:sldMk cId="3242017852" sldId="272"/>
            <ac:spMk id="37" creationId="{6D4E8A38-6E93-F342-83D7-BD131B090C89}"/>
          </ac:spMkLst>
        </pc:spChg>
        <pc:spChg chg="add mod">
          <ac:chgData name="Wencai Zhang" userId="4a86a1d0-2108-4707-8228-1110f3c1be85" providerId="ADAL" clId="{43FB2902-FB1B-0741-9691-4004D89E1DCE}" dt="2021-04-14T11:37:59.549" v="611" actId="1076"/>
          <ac:spMkLst>
            <pc:docMk/>
            <pc:sldMk cId="3242017852" sldId="272"/>
            <ac:spMk id="38" creationId="{98E3AEB7-E4F5-9641-BA6E-0981E5B19A0C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78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4T11:27:19.980" v="545" actId="1076"/>
          <ac:spMkLst>
            <pc:docMk/>
            <pc:sldMk cId="3242017852" sldId="272"/>
            <ac:spMk id="79" creationId="{F0A85EFF-8CA7-4595-8ED1-A933E3DC9B9B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86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35:54.772" v="564" actId="478"/>
          <ac:spMkLst>
            <pc:docMk/>
            <pc:sldMk cId="3242017852" sldId="272"/>
            <ac:spMk id="89" creationId="{6E5A03CE-B9DE-49E3-AFE2-5A0DD790B873}"/>
          </ac:spMkLst>
        </pc:spChg>
        <pc:spChg chg="del mod">
          <ac:chgData name="Wencai Zhang" userId="4a86a1d0-2108-4707-8228-1110f3c1be85" providerId="ADAL" clId="{43FB2902-FB1B-0741-9691-4004D89E1DCE}" dt="2021-04-14T11:36:47.453" v="591" actId="478"/>
          <ac:spMkLst>
            <pc:docMk/>
            <pc:sldMk cId="3242017852" sldId="272"/>
            <ac:spMk id="104" creationId="{73A0757A-AC74-43FC-BBB2-E91DD12F5CD5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2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4" creationId="{00000000-0000-0000-0000-000000000000}"/>
          </ac:spMkLst>
        </pc:spChg>
        <pc:grpChg chg="del mod">
          <ac:chgData name="Wencai Zhang" userId="4a86a1d0-2108-4707-8228-1110f3c1be85" providerId="ADAL" clId="{43FB2902-FB1B-0741-9691-4004D89E1DCE}" dt="2021-04-14T11:25:37.493" v="529" actId="478"/>
          <ac:grpSpMkLst>
            <pc:docMk/>
            <pc:sldMk cId="3242017852" sldId="272"/>
            <ac:grpSpMk id="17" creationId="{00000000-0000-0000-0000-000000000000}"/>
          </ac:grpSpMkLst>
        </pc:grpChg>
        <pc:grpChg chg="mod">
          <ac:chgData name="Wencai Zhang" userId="4a86a1d0-2108-4707-8228-1110f3c1be85" providerId="ADAL" clId="{43FB2902-FB1B-0741-9691-4004D89E1DCE}" dt="2021-04-14T11:23:19.128" v="471" actId="1035"/>
          <ac:grpSpMkLst>
            <pc:docMk/>
            <pc:sldMk cId="3242017852" sldId="272"/>
            <ac:grpSpMk id="20" creationId="{FB81241A-3117-4851-B42E-B4314B35BAC6}"/>
          </ac:grpSpMkLst>
        </pc:grpChg>
        <pc:grpChg chg="add del mod">
          <ac:chgData name="Wencai Zhang" userId="4a86a1d0-2108-4707-8228-1110f3c1be85" providerId="ADAL" clId="{43FB2902-FB1B-0741-9691-4004D89E1DCE}" dt="2021-04-14T11:34:39.464" v="547" actId="478"/>
          <ac:grpSpMkLst>
            <pc:docMk/>
            <pc:sldMk cId="3242017852" sldId="272"/>
            <ac:grpSpMk id="25" creationId="{7748A604-9B09-4843-A910-ED5CE437CC69}"/>
          </ac:grpSpMkLst>
        </pc:grpChg>
        <pc:graphicFrameChg chg="mod modGraphic">
          <ac:chgData name="Wencai Zhang" userId="4a86a1d0-2108-4707-8228-1110f3c1be85" providerId="ADAL" clId="{43FB2902-FB1B-0741-9691-4004D89E1DCE}" dt="2021-04-14T11:37:26.709" v="602" actId="1076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 mod">
          <ac:chgData name="Wencai Zhang" userId="4a86a1d0-2108-4707-8228-1110f3c1be85" providerId="ADAL" clId="{43FB2902-FB1B-0741-9691-4004D89E1DCE}" dt="2021-04-14T11:23:24.829" v="472" actId="478"/>
          <ac:graphicFrameMkLst>
            <pc:docMk/>
            <pc:sldMk cId="3242017852" sldId="272"/>
            <ac:graphicFrameMk id="96" creationId="{E74EAD87-5684-4581-85FC-05AAE537F489}"/>
          </ac:graphicFrameMkLst>
        </pc:graphicFrameChg>
        <pc:picChg chg="mod">
          <ac:chgData name="Wencai Zhang" userId="4a86a1d0-2108-4707-8228-1110f3c1be85" providerId="ADAL" clId="{43FB2902-FB1B-0741-9691-4004D89E1DCE}" dt="2021-04-14T11:27:23.704" v="546" actId="1076"/>
          <ac:picMkLst>
            <pc:docMk/>
            <pc:sldMk cId="3242017852" sldId="272"/>
            <ac:picMk id="3" creationId="{EF3166B8-C08A-AF42-A649-D0150A40BB2F}"/>
          </ac:picMkLst>
        </pc:picChg>
        <pc:picChg chg="add mod">
          <ac:chgData name="Wencai Zhang" userId="4a86a1d0-2108-4707-8228-1110f3c1be85" providerId="ADAL" clId="{43FB2902-FB1B-0741-9691-4004D89E1DCE}" dt="2021-04-14T11:38:12.917" v="614" actId="1076"/>
          <ac:picMkLst>
            <pc:docMk/>
            <pc:sldMk cId="3242017852" sldId="272"/>
            <ac:picMk id="7" creationId="{3282D958-FD04-084F-A1CB-FC81411CF5CF}"/>
          </ac:picMkLst>
        </pc:picChg>
        <pc:picChg chg="add del mod">
          <ac:chgData name="Wencai Zhang" userId="4a86a1d0-2108-4707-8228-1110f3c1be85" providerId="ADAL" clId="{43FB2902-FB1B-0741-9691-4004D89E1DCE}" dt="2021-04-14T11:24:18.029" v="498" actId="478"/>
          <ac:picMkLst>
            <pc:docMk/>
            <pc:sldMk cId="3242017852" sldId="272"/>
            <ac:picMk id="8" creationId="{99AE7F9C-301B-764C-8510-C93CA54F58FF}"/>
          </ac:picMkLst>
        </pc:picChg>
        <pc:picChg chg="add mod">
          <ac:chgData name="Wencai Zhang" userId="4a86a1d0-2108-4707-8228-1110f3c1be85" providerId="ADAL" clId="{43FB2902-FB1B-0741-9691-4004D89E1DCE}" dt="2021-04-14T11:37:54.193" v="609" actId="1076"/>
          <ac:picMkLst>
            <pc:docMk/>
            <pc:sldMk cId="3242017852" sldId="272"/>
            <ac:picMk id="9" creationId="{7CD51EEB-0F0E-8542-9C48-FB9B0B640A5D}"/>
          </ac:picMkLst>
        </pc:picChg>
        <pc:picChg chg="add mod">
          <ac:chgData name="Wencai Zhang" userId="4a86a1d0-2108-4707-8228-1110f3c1be85" providerId="ADAL" clId="{43FB2902-FB1B-0741-9691-4004D89E1DCE}" dt="2021-04-14T11:35:56.675" v="565" actId="1076"/>
          <ac:picMkLst>
            <pc:docMk/>
            <pc:sldMk cId="3242017852" sldId="272"/>
            <ac:picMk id="29" creationId="{5B0F2DD1-555C-3E49-8D07-EE27C32E8FAC}"/>
          </ac:picMkLst>
        </pc:picChg>
        <pc:picChg chg="add del mod">
          <ac:chgData name="Wencai Zhang" userId="4a86a1d0-2108-4707-8228-1110f3c1be85" providerId="ADAL" clId="{43FB2902-FB1B-0741-9691-4004D89E1DCE}" dt="2021-04-14T11:35:20.511" v="550" actId="478"/>
          <ac:picMkLst>
            <pc:docMk/>
            <pc:sldMk cId="3242017852" sldId="272"/>
            <ac:picMk id="30" creationId="{D0E20300-04A3-6441-91BC-063D0B703661}"/>
          </ac:picMkLst>
        </pc:picChg>
        <pc:picChg chg="add mod">
          <ac:chgData name="Wencai Zhang" userId="4a86a1d0-2108-4707-8228-1110f3c1be85" providerId="ADAL" clId="{43FB2902-FB1B-0741-9691-4004D89E1DCE}" dt="2021-04-14T11:23:19.128" v="471" actId="1035"/>
          <ac:picMkLst>
            <pc:docMk/>
            <pc:sldMk cId="3242017852" sldId="272"/>
            <ac:picMk id="36" creationId="{28EA12E2-17C6-7745-9E2A-9138B1617D0C}"/>
          </ac:picMkLst>
        </pc:picChg>
        <pc:picChg chg="add del mod">
          <ac:chgData name="Wencai Zhang" userId="4a86a1d0-2108-4707-8228-1110f3c1be85" providerId="ADAL" clId="{43FB2902-FB1B-0741-9691-4004D89E1DCE}" dt="2021-04-14T11:26:55.581" v="542" actId="478"/>
          <ac:picMkLst>
            <pc:docMk/>
            <pc:sldMk cId="3242017852" sldId="272"/>
            <ac:picMk id="39" creationId="{14C7F237-8B6D-1D4F-9D1B-FBC7485DA8E5}"/>
          </ac:picMkLst>
        </pc:picChg>
        <pc:picChg chg="add mod">
          <ac:chgData name="Wencai Zhang" userId="4a86a1d0-2108-4707-8228-1110f3c1be85" providerId="ADAL" clId="{43FB2902-FB1B-0741-9691-4004D89E1DCE}" dt="2021-04-14T11:26:59.438" v="543" actId="1076"/>
          <ac:picMkLst>
            <pc:docMk/>
            <pc:sldMk cId="3242017852" sldId="272"/>
            <ac:picMk id="40" creationId="{5CFBCABC-16A3-9847-9416-3CD86F952992}"/>
          </ac:picMkLst>
        </pc:picChg>
      </pc:sldChg>
      <pc:sldChg chg="addSp delSp modSp new mod">
        <pc:chgData name="Wencai Zhang" userId="4a86a1d0-2108-4707-8228-1110f3c1be85" providerId="ADAL" clId="{43FB2902-FB1B-0741-9691-4004D89E1DCE}" dt="2021-04-14T15:48:18.689" v="929" actId="1076"/>
        <pc:sldMkLst>
          <pc:docMk/>
          <pc:sldMk cId="3709575207" sldId="273"/>
        </pc:sldMkLst>
        <pc:spChg chg="mod">
          <ac:chgData name="Wencai Zhang" userId="4a86a1d0-2108-4707-8228-1110f3c1be85" providerId="ADAL" clId="{43FB2902-FB1B-0741-9691-4004D89E1DCE}" dt="2021-04-14T15:33:30.970" v="635" actId="20577"/>
          <ac:spMkLst>
            <pc:docMk/>
            <pc:sldMk cId="3709575207" sldId="273"/>
            <ac:spMk id="2" creationId="{DF4EB8F7-811E-2347-A32F-435A6C3F752D}"/>
          </ac:spMkLst>
        </pc:spChg>
        <pc:spChg chg="del">
          <ac:chgData name="Wencai Zhang" userId="4a86a1d0-2108-4707-8228-1110f3c1be85" providerId="ADAL" clId="{43FB2902-FB1B-0741-9691-4004D89E1DCE}" dt="2021-04-14T15:33:41.026" v="636" actId="478"/>
          <ac:spMkLst>
            <pc:docMk/>
            <pc:sldMk cId="3709575207" sldId="273"/>
            <ac:spMk id="3" creationId="{D4D43170-B23C-7E4F-A786-1A8880F6ECB1}"/>
          </ac:spMkLst>
        </pc:spChg>
        <pc:spChg chg="add mod">
          <ac:chgData name="Wencai Zhang" userId="4a86a1d0-2108-4707-8228-1110f3c1be85" providerId="ADAL" clId="{43FB2902-FB1B-0741-9691-4004D89E1DCE}" dt="2021-04-14T15:41:17.700" v="742" actId="1076"/>
          <ac:spMkLst>
            <pc:docMk/>
            <pc:sldMk cId="3709575207" sldId="273"/>
            <ac:spMk id="4" creationId="{9E166061-8EB8-B546-BCC5-48EBCAF27E35}"/>
          </ac:spMkLst>
        </pc:spChg>
        <pc:spChg chg="add del mod">
          <ac:chgData name="Wencai Zhang" userId="4a86a1d0-2108-4707-8228-1110f3c1be85" providerId="ADAL" clId="{43FB2902-FB1B-0741-9691-4004D89E1DCE}" dt="2021-04-14T15:36:01.409" v="679" actId="478"/>
          <ac:spMkLst>
            <pc:docMk/>
            <pc:sldMk cId="3709575207" sldId="273"/>
            <ac:spMk id="5" creationId="{5DB98CBA-49B2-CC42-9875-232A2F0F633E}"/>
          </ac:spMkLst>
        </pc:spChg>
        <pc:spChg chg="add mod">
          <ac:chgData name="Wencai Zhang" userId="4a86a1d0-2108-4707-8228-1110f3c1be85" providerId="ADAL" clId="{43FB2902-FB1B-0741-9691-4004D89E1DCE}" dt="2021-04-14T15:36:18.394" v="687" actId="207"/>
          <ac:spMkLst>
            <pc:docMk/>
            <pc:sldMk cId="3709575207" sldId="273"/>
            <ac:spMk id="6" creationId="{D7B9655D-6ADC-0944-A92D-0A407BD48C3F}"/>
          </ac:spMkLst>
        </pc:spChg>
        <pc:spChg chg="add mod">
          <ac:chgData name="Wencai Zhang" userId="4a86a1d0-2108-4707-8228-1110f3c1be85" providerId="ADAL" clId="{43FB2902-FB1B-0741-9691-4004D89E1DCE}" dt="2021-04-14T15:36:05.724" v="680" actId="1076"/>
          <ac:spMkLst>
            <pc:docMk/>
            <pc:sldMk cId="3709575207" sldId="273"/>
            <ac:spMk id="7" creationId="{360DABC1-3E85-B942-874C-26527BBA47C2}"/>
          </ac:spMkLst>
        </pc:spChg>
        <pc:spChg chg="add mod">
          <ac:chgData name="Wencai Zhang" userId="4a86a1d0-2108-4707-8228-1110f3c1be85" providerId="ADAL" clId="{43FB2902-FB1B-0741-9691-4004D89E1DCE}" dt="2021-04-14T15:36:32.482" v="690" actId="207"/>
          <ac:spMkLst>
            <pc:docMk/>
            <pc:sldMk cId="3709575207" sldId="273"/>
            <ac:spMk id="8" creationId="{82B8DD38-6605-B848-828A-A64FC840458B}"/>
          </ac:spMkLst>
        </pc:spChg>
        <pc:spChg chg="add mod">
          <ac:chgData name="Wencai Zhang" userId="4a86a1d0-2108-4707-8228-1110f3c1be85" providerId="ADAL" clId="{43FB2902-FB1B-0741-9691-4004D89E1DCE}" dt="2021-04-14T15:39:29.961" v="733" actId="207"/>
          <ac:spMkLst>
            <pc:docMk/>
            <pc:sldMk cId="3709575207" sldId="273"/>
            <ac:spMk id="9" creationId="{9ABDE6BC-F81C-E045-B203-9270F1294F67}"/>
          </ac:spMkLst>
        </pc:spChg>
        <pc:spChg chg="add mod">
          <ac:chgData name="Wencai Zhang" userId="4a86a1d0-2108-4707-8228-1110f3c1be85" providerId="ADAL" clId="{43FB2902-FB1B-0741-9691-4004D89E1DCE}" dt="2021-04-14T15:39:32.738" v="734" actId="207"/>
          <ac:spMkLst>
            <pc:docMk/>
            <pc:sldMk cId="3709575207" sldId="273"/>
            <ac:spMk id="10" creationId="{2BD617AA-B888-5A41-97DD-B90B92250379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1" creationId="{5C15A8B3-0866-C745-813F-0C8EBD15868D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2" creationId="{CEC8A3D3-D4B1-7749-8307-0EC85110AAEB}"/>
          </ac:spMkLst>
        </pc:spChg>
        <pc:spChg chg="add mod">
          <ac:chgData name="Wencai Zhang" userId="4a86a1d0-2108-4707-8228-1110f3c1be85" providerId="ADAL" clId="{43FB2902-FB1B-0741-9691-4004D89E1DCE}" dt="2021-04-14T15:44:22.292" v="847" actId="1076"/>
          <ac:spMkLst>
            <pc:docMk/>
            <pc:sldMk cId="3709575207" sldId="273"/>
            <ac:spMk id="13" creationId="{9033725D-E063-FF48-9A02-F5DFF9B2E91D}"/>
          </ac:spMkLst>
        </pc:spChg>
        <pc:spChg chg="add mod">
          <ac:chgData name="Wencai Zhang" userId="4a86a1d0-2108-4707-8228-1110f3c1be85" providerId="ADAL" clId="{43FB2902-FB1B-0741-9691-4004D89E1DCE}" dt="2021-04-14T15:41:58.403" v="783" actId="1076"/>
          <ac:spMkLst>
            <pc:docMk/>
            <pc:sldMk cId="3709575207" sldId="273"/>
            <ac:spMk id="14" creationId="{37598052-7BDE-994A-8E06-CFA2DFF08D6E}"/>
          </ac:spMkLst>
        </pc:spChg>
        <pc:spChg chg="add mod">
          <ac:chgData name="Wencai Zhang" userId="4a86a1d0-2108-4707-8228-1110f3c1be85" providerId="ADAL" clId="{43FB2902-FB1B-0741-9691-4004D89E1DCE}" dt="2021-04-14T15:42:17.301" v="807" actId="1035"/>
          <ac:spMkLst>
            <pc:docMk/>
            <pc:sldMk cId="3709575207" sldId="273"/>
            <ac:spMk id="15" creationId="{8E69EFBF-C3ED-5948-AC10-13DA7537A787}"/>
          </ac:spMkLst>
        </pc:spChg>
        <pc:spChg chg="add mod">
          <ac:chgData name="Wencai Zhang" userId="4a86a1d0-2108-4707-8228-1110f3c1be85" providerId="ADAL" clId="{43FB2902-FB1B-0741-9691-4004D89E1DCE}" dt="2021-04-14T15:44:14.619" v="846" actId="1076"/>
          <ac:spMkLst>
            <pc:docMk/>
            <pc:sldMk cId="3709575207" sldId="273"/>
            <ac:spMk id="16" creationId="{CE0F719C-3D1A-C64C-B907-CC5A3F1DED76}"/>
          </ac:spMkLst>
        </pc:spChg>
        <pc:spChg chg="add mod">
          <ac:chgData name="Wencai Zhang" userId="4a86a1d0-2108-4707-8228-1110f3c1be85" providerId="ADAL" clId="{43FB2902-FB1B-0741-9691-4004D89E1DCE}" dt="2021-04-14T15:44:07.566" v="845" actId="1076"/>
          <ac:spMkLst>
            <pc:docMk/>
            <pc:sldMk cId="3709575207" sldId="273"/>
            <ac:spMk id="17" creationId="{7BB0C0AA-6C7F-104D-9663-255956DC3BB6}"/>
          </ac:spMkLst>
        </pc:spChg>
        <pc:spChg chg="add mod">
          <ac:chgData name="Wencai Zhang" userId="4a86a1d0-2108-4707-8228-1110f3c1be85" providerId="ADAL" clId="{43FB2902-FB1B-0741-9691-4004D89E1DCE}" dt="2021-04-14T15:47:56.291" v="920" actId="20577"/>
          <ac:spMkLst>
            <pc:docMk/>
            <pc:sldMk cId="3709575207" sldId="273"/>
            <ac:spMk id="18" creationId="{49281567-D8BA-9E45-A0A4-3C529A30620F}"/>
          </ac:spMkLst>
        </pc:spChg>
        <pc:spChg chg="add mod">
          <ac:chgData name="Wencai Zhang" userId="4a86a1d0-2108-4707-8228-1110f3c1be85" providerId="ADAL" clId="{43FB2902-FB1B-0741-9691-4004D89E1DCE}" dt="2021-04-14T15:44:46.963" v="882" actId="1076"/>
          <ac:spMkLst>
            <pc:docMk/>
            <pc:sldMk cId="3709575207" sldId="273"/>
            <ac:spMk id="19" creationId="{01879D99-8F20-C74A-A620-64B4987A39EF}"/>
          </ac:spMkLst>
        </pc:spChg>
        <pc:spChg chg="add mod">
          <ac:chgData name="Wencai Zhang" userId="4a86a1d0-2108-4707-8228-1110f3c1be85" providerId="ADAL" clId="{43FB2902-FB1B-0741-9691-4004D89E1DCE}" dt="2021-04-14T15:47:20.323" v="915" actId="1076"/>
          <ac:spMkLst>
            <pc:docMk/>
            <pc:sldMk cId="3709575207" sldId="273"/>
            <ac:spMk id="20" creationId="{466C51AE-00DD-6648-9A39-3319993B7739}"/>
          </ac:spMkLst>
        </pc:spChg>
        <pc:spChg chg="add mod">
          <ac:chgData name="Wencai Zhang" userId="4a86a1d0-2108-4707-8228-1110f3c1be85" providerId="ADAL" clId="{43FB2902-FB1B-0741-9691-4004D89E1DCE}" dt="2021-04-14T15:47:44.985" v="916" actId="207"/>
          <ac:spMkLst>
            <pc:docMk/>
            <pc:sldMk cId="3709575207" sldId="273"/>
            <ac:spMk id="21" creationId="{76D1FA81-E445-1C46-8660-6CBF13DCCCDC}"/>
          </ac:spMkLst>
        </pc:spChg>
        <pc:spChg chg="add mod">
          <ac:chgData name="Wencai Zhang" userId="4a86a1d0-2108-4707-8228-1110f3c1be85" providerId="ADAL" clId="{43FB2902-FB1B-0741-9691-4004D89E1DCE}" dt="2021-04-14T15:48:18.689" v="929" actId="1076"/>
          <ac:spMkLst>
            <pc:docMk/>
            <pc:sldMk cId="3709575207" sldId="273"/>
            <ac:spMk id="22" creationId="{54028C83-4997-A241-947D-09C45AE7141C}"/>
          </ac:spMkLst>
        </pc:spChg>
      </pc:sldChg>
      <pc:sldChg chg="del">
        <pc:chgData name="Wencai Zhang" userId="4a86a1d0-2108-4707-8228-1110f3c1be85" providerId="ADAL" clId="{43FB2902-FB1B-0741-9691-4004D89E1DCE}" dt="2021-04-14T11:38:28.739" v="615" actId="2696"/>
        <pc:sldMkLst>
          <pc:docMk/>
          <pc:sldMk cId="4260941644" sldId="273"/>
        </pc:sldMkLst>
      </pc:sldChg>
    </pc:docChg>
  </pc:docChgLst>
  <pc:docChgLst>
    <pc:chgData name="Wencai Zhang" userId="c9beb00e4a0b55dd" providerId="LiveId" clId="{E6BB7AD8-FE2A-4669-974C-5427E5D4478E}"/>
    <pc:docChg chg="undo delSld modSld">
      <pc:chgData name="Wencai Zhang" userId="c9beb00e4a0b55dd" providerId="LiveId" clId="{E6BB7AD8-FE2A-4669-974C-5427E5D4478E}" dt="2017-12-18T19:02:15.762" v="366" actId="1076"/>
      <pc:docMkLst>
        <pc:docMk/>
      </pc:docMkLst>
      <pc:sldChg chg="delSp modSp">
        <pc:chgData name="Wencai Zhang" userId="c9beb00e4a0b55dd" providerId="LiveId" clId="{E6BB7AD8-FE2A-4669-974C-5427E5D4478E}" dt="2017-12-18T19:02:15.762" v="366" actId="1076"/>
        <pc:sldMkLst>
          <pc:docMk/>
          <pc:sldMk cId="1237803182" sldId="271"/>
        </pc:sldMkLst>
        <pc:spChg chg="mod">
          <ac:chgData name="Wencai Zhang" userId="c9beb00e4a0b55dd" providerId="LiveId" clId="{E6BB7AD8-FE2A-4669-974C-5427E5D4478E}" dt="2017-11-26T20:26:59.364" v="120" actId="1036"/>
          <ac:spMkLst>
            <pc:docMk/>
            <pc:sldMk cId="1237803182" sldId="271"/>
            <ac:spMk id="22" creationId="{119C059E-C733-4742-A0D4-D02B0A0755A1}"/>
          </ac:spMkLst>
        </pc:spChg>
        <pc:spChg chg="mod">
          <ac:chgData name="Wencai Zhang" userId="c9beb00e4a0b55dd" providerId="LiveId" clId="{E6BB7AD8-FE2A-4669-974C-5427E5D4478E}" dt="2017-11-26T20:27:08.265" v="128" actId="1036"/>
          <ac:spMkLst>
            <pc:docMk/>
            <pc:sldMk cId="1237803182" sldId="271"/>
            <ac:spMk id="26" creationId="{C4308320-9356-44DD-9CD7-D86A1D1F07E5}"/>
          </ac:spMkLst>
        </pc:spChg>
        <pc:spChg chg="mod">
          <ac:chgData name="Wencai Zhang" userId="c9beb00e4a0b55dd" providerId="LiveId" clId="{E6BB7AD8-FE2A-4669-974C-5427E5D4478E}" dt="2017-12-18T19:02:15.762" v="366" actId="1076"/>
          <ac:spMkLst>
            <pc:docMk/>
            <pc:sldMk cId="1237803182" sldId="271"/>
            <ac:spMk id="58" creationId="{00000000-0000-0000-0000-000000000000}"/>
          </ac:spMkLst>
        </pc:spChg>
        <pc:grpChg chg="mod">
          <ac:chgData name="Wencai Zhang" userId="c9beb00e4a0b55dd" providerId="LiveId" clId="{E6BB7AD8-FE2A-4669-974C-5427E5D4478E}" dt="2017-11-26T20:23:09.784" v="86" actId="14100"/>
          <ac:grpSpMkLst>
            <pc:docMk/>
            <pc:sldMk cId="1237803182" sldId="271"/>
            <ac:grpSpMk id="20" creationId="{FB81241A-3117-4851-B42E-B4314B35BAC6}"/>
          </ac:grpSpMkLst>
        </pc:grpChg>
        <pc:graphicFrameChg chg="del mod">
          <ac:chgData name="Wencai Zhang" userId="c9beb00e4a0b55dd" providerId="LiveId" clId="{E6BB7AD8-FE2A-4669-974C-5427E5D4478E}" dt="2017-12-18T19:00:48.438" v="190" actId="478"/>
          <ac:graphicFrameMkLst>
            <pc:docMk/>
            <pc:sldMk cId="1237803182" sldId="271"/>
            <ac:graphicFrameMk id="8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50.242" v="363" actId="1038"/>
          <ac:graphicFrameMkLst>
            <pc:docMk/>
            <pc:sldMk cId="1237803182" sldId="271"/>
            <ac:graphicFrameMk id="9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40.397" v="345" actId="1038"/>
          <ac:graphicFrameMkLst>
            <pc:docMk/>
            <pc:sldMk cId="1237803182" sldId="271"/>
            <ac:graphicFrameMk id="77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19:34.671" v="15" actId="14100"/>
          <ac:graphicFrameMkLst>
            <pc:docMk/>
            <pc:sldMk cId="1237803182" sldId="271"/>
            <ac:graphicFrameMk id="80" creationId="{00000000-0000-0000-0000-000000000000}"/>
          </ac:graphicFrameMkLst>
        </pc:graphicFrameChg>
        <pc:graphicFrameChg chg="del mod">
          <ac:chgData name="Wencai Zhang" userId="c9beb00e4a0b55dd" providerId="LiveId" clId="{E6BB7AD8-FE2A-4669-974C-5427E5D4478E}" dt="2017-12-18T19:01:29.439" v="282" actId="478"/>
          <ac:graphicFrameMkLst>
            <pc:docMk/>
            <pc:sldMk cId="1237803182" sldId="271"/>
            <ac:graphicFrameMk id="81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22:56.325" v="84" actId="1035"/>
          <ac:graphicFrameMkLst>
            <pc:docMk/>
            <pc:sldMk cId="1237803182" sldId="271"/>
            <ac:graphicFrameMk id="90" creationId="{00000000-0008-0000-0000-00000E000000}"/>
          </ac:graphicFrameMkLst>
        </pc:graphicFrameChg>
        <pc:graphicFrameChg chg="mod">
          <ac:chgData name="Wencai Zhang" userId="c9beb00e4a0b55dd" providerId="LiveId" clId="{E6BB7AD8-FE2A-4669-974C-5427E5D4478E}" dt="2017-11-26T20:28:17.138" v="172" actId="404"/>
          <ac:graphicFrameMkLst>
            <pc:docMk/>
            <pc:sldMk cId="1237803182" sldId="271"/>
            <ac:graphicFrameMk id="95" creationId="{00000000-0000-0000-0000-000000000000}"/>
          </ac:graphicFrameMkLst>
        </pc:graphicFrameChg>
        <pc:graphicFrameChg chg="del">
          <ac:chgData name="Wencai Zhang" userId="c9beb00e4a0b55dd" providerId="LiveId" clId="{E6BB7AD8-FE2A-4669-974C-5427E5D4478E}" dt="2017-11-26T20:16:52.903" v="5" actId="478"/>
          <ac:graphicFrameMkLst>
            <pc:docMk/>
            <pc:sldMk cId="1237803182" sldId="271"/>
            <ac:graphicFrameMk id="101" creationId="{00000000-0000-0000-0000-000000000000}"/>
          </ac:graphicFrameMkLst>
        </pc:graphicFrameChg>
      </pc:sldChg>
    </pc:docChg>
  </pc:docChgLst>
  <pc:docChgLst>
    <pc:chgData name="Fareesa Aftab" clId="Web-{00C93C2C-67CD-4611-8CA5-0D7FBA826CF6}"/>
    <pc:docChg chg="modSld">
      <pc:chgData name="Fareesa Aftab" userId="" providerId="" clId="Web-{00C93C2C-67CD-4611-8CA5-0D7FBA826CF6}" dt="2021-06-16T19:14:22.941" v="46" actId="1076"/>
      <pc:docMkLst>
        <pc:docMk/>
      </pc:docMkLst>
      <pc:sldChg chg="addSp delSp modSp">
        <pc:chgData name="Fareesa Aftab" userId="" providerId="" clId="Web-{00C93C2C-67CD-4611-8CA5-0D7FBA826CF6}" dt="2021-06-16T19:14:22.941" v="46" actId="1076"/>
        <pc:sldMkLst>
          <pc:docMk/>
          <pc:sldMk cId="1997077850" sldId="279"/>
        </pc:sldMkLst>
        <pc:grpChg chg="add del">
          <ac:chgData name="Fareesa Aftab" userId="" providerId="" clId="Web-{00C93C2C-67CD-4611-8CA5-0D7FBA826CF6}" dt="2021-06-16T18:57:44.512" v="15"/>
          <ac:grpSpMkLst>
            <pc:docMk/>
            <pc:sldMk cId="1997077850" sldId="279"/>
            <ac:grpSpMk id="10" creationId="{51D0DDE7-5A35-9C47-816B-D24198872E22}"/>
          </ac:grpSpMkLst>
        </pc:grpChg>
        <pc:picChg chg="add del mod">
          <ac:chgData name="Fareesa Aftab" userId="" providerId="" clId="Web-{00C93C2C-67CD-4611-8CA5-0D7FBA826CF6}" dt="2021-06-16T18:55:00.711" v="1"/>
          <ac:picMkLst>
            <pc:docMk/>
            <pc:sldMk cId="1997077850" sldId="279"/>
            <ac:picMk id="11" creationId="{394561D2-C158-467F-BF0D-CC0B3D41CE45}"/>
          </ac:picMkLst>
        </pc:picChg>
        <pc:picChg chg="add del mod">
          <ac:chgData name="Fareesa Aftab" userId="" providerId="" clId="Web-{00C93C2C-67CD-4611-8CA5-0D7FBA826CF6}" dt="2021-06-16T18:55:17.102" v="3"/>
          <ac:picMkLst>
            <pc:docMk/>
            <pc:sldMk cId="1997077850" sldId="279"/>
            <ac:picMk id="12" creationId="{FBE9EE5E-7589-4C68-893D-EA6E6F3B1C05}"/>
          </ac:picMkLst>
        </pc:picChg>
        <pc:picChg chg="add del mod">
          <ac:chgData name="Fareesa Aftab" userId="" providerId="" clId="Web-{00C93C2C-67CD-4611-8CA5-0D7FBA826CF6}" dt="2021-06-16T18:55:25.930" v="5"/>
          <ac:picMkLst>
            <pc:docMk/>
            <pc:sldMk cId="1997077850" sldId="279"/>
            <ac:picMk id="13" creationId="{9504EB9E-6AB7-4CD4-8A7C-412663279D19}"/>
          </ac:picMkLst>
        </pc:picChg>
        <pc:picChg chg="add del mod">
          <ac:chgData name="Fareesa Aftab" userId="" providerId="" clId="Web-{00C93C2C-67CD-4611-8CA5-0D7FBA826CF6}" dt="2021-06-16T18:55:33.837" v="7"/>
          <ac:picMkLst>
            <pc:docMk/>
            <pc:sldMk cId="1997077850" sldId="279"/>
            <ac:picMk id="14" creationId="{75689B2C-C312-4473-B906-A70E9189A9BE}"/>
          </ac:picMkLst>
        </pc:picChg>
        <pc:picChg chg="add del mod">
          <ac:chgData name="Fareesa Aftab" userId="" providerId="" clId="Web-{00C93C2C-67CD-4611-8CA5-0D7FBA826CF6}" dt="2021-06-16T18:56:04.337" v="9"/>
          <ac:picMkLst>
            <pc:docMk/>
            <pc:sldMk cId="1997077850" sldId="279"/>
            <ac:picMk id="15" creationId="{AFEE1B03-07C1-4E91-B027-261FDD53BB39}"/>
          </ac:picMkLst>
        </pc:picChg>
        <pc:picChg chg="add del mod modCrop">
          <ac:chgData name="Fareesa Aftab" userId="" providerId="" clId="Web-{00C93C2C-67CD-4611-8CA5-0D7FBA826CF6}" dt="2021-06-16T19:13:22.596" v="37"/>
          <ac:picMkLst>
            <pc:docMk/>
            <pc:sldMk cId="1997077850" sldId="279"/>
            <ac:picMk id="16" creationId="{4DE14798-9CBA-470F-B75D-9B0B13D7A74D}"/>
          </ac:picMkLst>
        </pc:picChg>
        <pc:picChg chg="add mod modCrop">
          <ac:chgData name="Fareesa Aftab" userId="" providerId="" clId="Web-{00C93C2C-67CD-4611-8CA5-0D7FBA826CF6}" dt="2021-06-16T19:14:22.941" v="46" actId="1076"/>
          <ac:picMkLst>
            <pc:docMk/>
            <pc:sldMk cId="1997077850" sldId="279"/>
            <ac:picMk id="17" creationId="{7451D55C-EA96-4A64-943B-8EE96CFCD229}"/>
          </ac:picMkLst>
        </pc:picChg>
        <pc:picChg chg="del">
          <ac:chgData name="Fareesa Aftab" userId="" providerId="" clId="Web-{00C93C2C-67CD-4611-8CA5-0D7FBA826CF6}" dt="2021-06-16T18:57:55.231" v="16"/>
          <ac:picMkLst>
            <pc:docMk/>
            <pc:sldMk cId="1997077850" sldId="279"/>
            <ac:picMk id="147" creationId="{40619D9C-9239-C84E-B369-2C612572AF11}"/>
          </ac:picMkLst>
        </pc:picChg>
      </pc:sldChg>
    </pc:docChg>
  </pc:docChgLst>
  <pc:docChgLst>
    <pc:chgData name="Nicholas Skiados" clId="Web-{1BBDE042-AA55-4082-A5A3-6D4CAC317154}"/>
    <pc:docChg chg="modSld">
      <pc:chgData name="Nicholas Skiados" userId="" providerId="" clId="Web-{1BBDE042-AA55-4082-A5A3-6D4CAC317154}" dt="2021-06-17T03:04:44.697" v="39" actId="14100"/>
      <pc:docMkLst>
        <pc:docMk/>
      </pc:docMkLst>
      <pc:sldChg chg="addSp delSp modSp">
        <pc:chgData name="Nicholas Skiados" userId="" providerId="" clId="Web-{1BBDE042-AA55-4082-A5A3-6D4CAC317154}" dt="2021-06-17T02:56:56.107" v="7"/>
        <pc:sldMkLst>
          <pc:docMk/>
          <pc:sldMk cId="2771812490" sldId="275"/>
        </pc:sldMkLst>
        <pc:spChg chg="add del mod">
          <ac:chgData name="Nicholas Skiados" userId="" providerId="" clId="Web-{1BBDE042-AA55-4082-A5A3-6D4CAC317154}" dt="2021-06-17T02:56:56.107" v="7"/>
          <ac:spMkLst>
            <pc:docMk/>
            <pc:sldMk cId="2771812490" sldId="275"/>
            <ac:spMk id="4" creationId="{F908C892-2029-4A9F-A3C4-A8EF5B1C938B}"/>
          </ac:spMkLst>
        </pc:spChg>
      </pc:sldChg>
      <pc:sldChg chg="addSp delSp modSp">
        <pc:chgData name="Nicholas Skiados" userId="" providerId="" clId="Web-{1BBDE042-AA55-4082-A5A3-6D4CAC317154}" dt="2021-06-17T03:04:44.697" v="39" actId="14100"/>
        <pc:sldMkLst>
          <pc:docMk/>
          <pc:sldMk cId="1997077850" sldId="279"/>
        </pc:sldMkLst>
        <pc:spChg chg="add del mod">
          <ac:chgData name="Nicholas Skiados" userId="" providerId="" clId="Web-{1BBDE042-AA55-4082-A5A3-6D4CAC317154}" dt="2021-06-17T03:04:44.697" v="39" actId="14100"/>
          <ac:spMkLst>
            <pc:docMk/>
            <pc:sldMk cId="1997077850" sldId="279"/>
            <ac:spMk id="120" creationId="{BED92353-28E4-4643-90D3-4560DD628D3F}"/>
          </ac:spMkLst>
        </pc:spChg>
      </pc:sldChg>
    </pc:docChg>
  </pc:docChgLst>
  <pc:docChgLst>
    <pc:chgData name="Wencai Zhang" userId="4a86a1d0-2108-4707-8228-1110f3c1be85" providerId="ADAL" clId="{FC53F833-B66A-4F4A-A8C4-3EA264DF2A7D}"/>
    <pc:docChg chg="undo custSel modSld">
      <pc:chgData name="Wencai Zhang" userId="4a86a1d0-2108-4707-8228-1110f3c1be85" providerId="ADAL" clId="{FC53F833-B66A-4F4A-A8C4-3EA264DF2A7D}" dt="2022-05-26T23:23:21.586" v="109" actId="1037"/>
      <pc:docMkLst>
        <pc:docMk/>
      </pc:docMkLst>
      <pc:sldChg chg="modSp mod">
        <pc:chgData name="Wencai Zhang" userId="4a86a1d0-2108-4707-8228-1110f3c1be85" providerId="ADAL" clId="{FC53F833-B66A-4F4A-A8C4-3EA264DF2A7D}" dt="2022-05-26T23:20:40.938" v="97" actId="1037"/>
        <pc:sldMkLst>
          <pc:docMk/>
          <pc:sldMk cId="2771812490" sldId="275"/>
        </pc:sldMkLst>
        <pc:spChg chg="mod">
          <ac:chgData name="Wencai Zhang" userId="4a86a1d0-2108-4707-8228-1110f3c1be85" providerId="ADAL" clId="{FC53F833-B66A-4F4A-A8C4-3EA264DF2A7D}" dt="2022-05-24T12:55:07.190" v="57" actId="1037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FC53F833-B66A-4F4A-A8C4-3EA264DF2A7D}" dt="2022-05-24T12:55:13.725" v="58" actId="1076"/>
          <ac:spMkLst>
            <pc:docMk/>
            <pc:sldMk cId="2771812490" sldId="275"/>
            <ac:spMk id="32" creationId="{3E547D2F-565F-A84D-A2CA-22C354291393}"/>
          </ac:spMkLst>
        </pc:spChg>
        <pc:grpChg chg="mod">
          <ac:chgData name="Wencai Zhang" userId="4a86a1d0-2108-4707-8228-1110f3c1be85" providerId="ADAL" clId="{FC53F833-B66A-4F4A-A8C4-3EA264DF2A7D}" dt="2022-05-26T23:20:40.938" v="97" actId="1037"/>
          <ac:grpSpMkLst>
            <pc:docMk/>
            <pc:sldMk cId="2771812490" sldId="275"/>
            <ac:grpSpMk id="31" creationId="{3BFBB084-5CE7-8F41-A2EF-B6E2D67C36D2}"/>
          </ac:grpSpMkLst>
        </pc:grpChg>
      </pc:sldChg>
      <pc:sldChg chg="modSp mod">
        <pc:chgData name="Wencai Zhang" userId="4a86a1d0-2108-4707-8228-1110f3c1be85" providerId="ADAL" clId="{FC53F833-B66A-4F4A-A8C4-3EA264DF2A7D}" dt="2022-05-24T12:54:56.308" v="46" actId="1076"/>
        <pc:sldMkLst>
          <pc:docMk/>
          <pc:sldMk cId="1043719466" sldId="281"/>
        </pc:sldMkLst>
        <pc:spChg chg="mod">
          <ac:chgData name="Wencai Zhang" userId="4a86a1d0-2108-4707-8228-1110f3c1be85" providerId="ADAL" clId="{FC53F833-B66A-4F4A-A8C4-3EA264DF2A7D}" dt="2022-05-24T12:54:50.336" v="45" actId="1037"/>
          <ac:spMkLst>
            <pc:docMk/>
            <pc:sldMk cId="1043719466" sldId="281"/>
            <ac:spMk id="2" creationId="{51F54C20-E8DC-D04F-BBA3-37DC2057E256}"/>
          </ac:spMkLst>
        </pc:spChg>
        <pc:spChg chg="mod">
          <ac:chgData name="Wencai Zhang" userId="4a86a1d0-2108-4707-8228-1110f3c1be85" providerId="ADAL" clId="{FC53F833-B66A-4F4A-A8C4-3EA264DF2A7D}" dt="2022-05-24T12:54:56.308" v="46" actId="1076"/>
          <ac:spMkLst>
            <pc:docMk/>
            <pc:sldMk cId="1043719466" sldId="281"/>
            <ac:spMk id="5" creationId="{A61503D3-A798-A843-99DC-C0890B8EB90D}"/>
          </ac:spMkLst>
        </pc:spChg>
      </pc:sldChg>
      <pc:sldChg chg="modSp mod">
        <pc:chgData name="Wencai Zhang" userId="4a86a1d0-2108-4707-8228-1110f3c1be85" providerId="ADAL" clId="{FC53F833-B66A-4F4A-A8C4-3EA264DF2A7D}" dt="2022-05-24T12:55:27.406" v="65" actId="1076"/>
        <pc:sldMkLst>
          <pc:docMk/>
          <pc:sldMk cId="3497662403" sldId="290"/>
        </pc:sldMkLst>
        <pc:spChg chg="mod">
          <ac:chgData name="Wencai Zhang" userId="4a86a1d0-2108-4707-8228-1110f3c1be85" providerId="ADAL" clId="{FC53F833-B66A-4F4A-A8C4-3EA264DF2A7D}" dt="2022-05-24T12:55:27.406" v="65" actId="1076"/>
          <ac:spMkLst>
            <pc:docMk/>
            <pc:sldMk cId="3497662403" sldId="290"/>
            <ac:spMk id="8" creationId="{A4F20A6F-D30A-9040-ACD4-2B63464D1625}"/>
          </ac:spMkLst>
        </pc:spChg>
        <pc:spChg chg="mod">
          <ac:chgData name="Wencai Zhang" userId="4a86a1d0-2108-4707-8228-1110f3c1be85" providerId="ADAL" clId="{FC53F833-B66A-4F4A-A8C4-3EA264DF2A7D}" dt="2022-05-24T12:55:22.791" v="64" actId="1037"/>
          <ac:spMkLst>
            <pc:docMk/>
            <pc:sldMk cId="3497662403" sldId="290"/>
            <ac:spMk id="11" creationId="{D0DA81A9-2BB4-2740-B8BB-D967AA6C6C1E}"/>
          </ac:spMkLst>
        </pc:spChg>
      </pc:sldChg>
      <pc:sldChg chg="modSp mod">
        <pc:chgData name="Wencai Zhang" userId="4a86a1d0-2108-4707-8228-1110f3c1be85" providerId="ADAL" clId="{FC53F833-B66A-4F4A-A8C4-3EA264DF2A7D}" dt="2022-05-26T23:23:21.586" v="109" actId="1037"/>
        <pc:sldMkLst>
          <pc:docMk/>
          <pc:sldMk cId="4133689721" sldId="291"/>
        </pc:sldMkLst>
        <pc:spChg chg="mod">
          <ac:chgData name="Wencai Zhang" userId="4a86a1d0-2108-4707-8228-1110f3c1be85" providerId="ADAL" clId="{FC53F833-B66A-4F4A-A8C4-3EA264DF2A7D}" dt="2022-05-24T12:54:09.011" v="0" actId="1076"/>
          <ac:spMkLst>
            <pc:docMk/>
            <pc:sldMk cId="4133689721" sldId="291"/>
            <ac:spMk id="17" creationId="{649CC280-8498-5F47-A7C8-A30278508115}"/>
          </ac:spMkLst>
        </pc:spChg>
        <pc:spChg chg="mod">
          <ac:chgData name="Wencai Zhang" userId="4a86a1d0-2108-4707-8228-1110f3c1be85" providerId="ADAL" clId="{FC53F833-B66A-4F4A-A8C4-3EA264DF2A7D}" dt="2022-05-26T23:23:21.586" v="109" actId="1037"/>
          <ac:spMkLst>
            <pc:docMk/>
            <pc:sldMk cId="4133689721" sldId="291"/>
            <ac:spMk id="49" creationId="{393B87F7-0301-414F-A165-54A34714662C}"/>
          </ac:spMkLst>
        </pc:spChg>
        <pc:spChg chg="mod">
          <ac:chgData name="Wencai Zhang" userId="4a86a1d0-2108-4707-8228-1110f3c1be85" providerId="ADAL" clId="{FC53F833-B66A-4F4A-A8C4-3EA264DF2A7D}" dt="2022-05-26T23:22:54.528" v="100" actId="5793"/>
          <ac:spMkLst>
            <pc:docMk/>
            <pc:sldMk cId="4133689721" sldId="291"/>
            <ac:spMk id="78" creationId="{26FB9E45-966D-314A-8358-9C15BE9D9176}"/>
          </ac:spMkLst>
        </pc:spChg>
      </pc:sldChg>
      <pc:sldChg chg="modSp mod">
        <pc:chgData name="Wencai Zhang" userId="4a86a1d0-2108-4707-8228-1110f3c1be85" providerId="ADAL" clId="{FC53F833-B66A-4F4A-A8C4-3EA264DF2A7D}" dt="2022-05-24T12:55:42.180" v="72" actId="1037"/>
        <pc:sldMkLst>
          <pc:docMk/>
          <pc:sldMk cId="472844202" sldId="292"/>
        </pc:sldMkLst>
        <pc:spChg chg="mod">
          <ac:chgData name="Wencai Zhang" userId="4a86a1d0-2108-4707-8228-1110f3c1be85" providerId="ADAL" clId="{FC53F833-B66A-4F4A-A8C4-3EA264DF2A7D}" dt="2022-05-24T12:55:38.451" v="67" actId="1076"/>
          <ac:spMkLst>
            <pc:docMk/>
            <pc:sldMk cId="472844202" sldId="292"/>
            <ac:spMk id="32" creationId="{62C6F7E6-04DF-1548-BD3C-454D15C0CE2C}"/>
          </ac:spMkLst>
        </pc:spChg>
        <pc:spChg chg="mod">
          <ac:chgData name="Wencai Zhang" userId="4a86a1d0-2108-4707-8228-1110f3c1be85" providerId="ADAL" clId="{FC53F833-B66A-4F4A-A8C4-3EA264DF2A7D}" dt="2022-05-24T12:55:42.180" v="72" actId="1037"/>
          <ac:spMkLst>
            <pc:docMk/>
            <pc:sldMk cId="472844202" sldId="292"/>
            <ac:spMk id="81" creationId="{869179CE-BA14-5D41-9FF2-43903C401B9E}"/>
          </ac:spMkLst>
        </pc:spChg>
      </pc:sldChg>
      <pc:sldChg chg="modSp mod">
        <pc:chgData name="Wencai Zhang" userId="4a86a1d0-2108-4707-8228-1110f3c1be85" providerId="ADAL" clId="{FC53F833-B66A-4F4A-A8C4-3EA264DF2A7D}" dt="2022-05-26T20:11:00.524" v="78" actId="5793"/>
        <pc:sldMkLst>
          <pc:docMk/>
          <pc:sldMk cId="492363108" sldId="293"/>
        </pc:sldMkLst>
        <pc:spChg chg="mod">
          <ac:chgData name="Wencai Zhang" userId="4a86a1d0-2108-4707-8228-1110f3c1be85" providerId="ADAL" clId="{FC53F833-B66A-4F4A-A8C4-3EA264DF2A7D}" dt="2022-05-24T12:54:28.854" v="16" actId="1076"/>
          <ac:spMkLst>
            <pc:docMk/>
            <pc:sldMk cId="492363108" sldId="293"/>
            <ac:spMk id="17" creationId="{649CC280-8498-5F47-A7C8-A30278508115}"/>
          </ac:spMkLst>
        </pc:spChg>
        <pc:spChg chg="mod">
          <ac:chgData name="Wencai Zhang" userId="4a86a1d0-2108-4707-8228-1110f3c1be85" providerId="ADAL" clId="{FC53F833-B66A-4F4A-A8C4-3EA264DF2A7D}" dt="2022-05-24T12:54:35.716" v="25" actId="1037"/>
          <ac:spMkLst>
            <pc:docMk/>
            <pc:sldMk cId="492363108" sldId="293"/>
            <ac:spMk id="49" creationId="{393B87F7-0301-414F-A165-54A34714662C}"/>
          </ac:spMkLst>
        </pc:spChg>
        <pc:spChg chg="mod">
          <ac:chgData name="Wencai Zhang" userId="4a86a1d0-2108-4707-8228-1110f3c1be85" providerId="ADAL" clId="{FC53F833-B66A-4F4A-A8C4-3EA264DF2A7D}" dt="2022-05-26T20:11:00.524" v="78" actId="5793"/>
          <ac:spMkLst>
            <pc:docMk/>
            <pc:sldMk cId="492363108" sldId="293"/>
            <ac:spMk id="57" creationId="{92B9BF22-2E03-4145-A99C-E336F9301AF2}"/>
          </ac:spMkLst>
        </pc:spChg>
        <pc:spChg chg="mod">
          <ac:chgData name="Wencai Zhang" userId="4a86a1d0-2108-4707-8228-1110f3c1be85" providerId="ADAL" clId="{FC53F833-B66A-4F4A-A8C4-3EA264DF2A7D}" dt="2022-05-26T20:10:55.676" v="75" actId="5793"/>
          <ac:spMkLst>
            <pc:docMk/>
            <pc:sldMk cId="492363108" sldId="293"/>
            <ac:spMk id="105" creationId="{87CA0DA1-7C85-1E43-BB31-4F7DFF1B556A}"/>
          </ac:spMkLst>
        </pc:spChg>
      </pc:sldChg>
    </pc:docChg>
  </pc:docChgLst>
  <pc:docChgLst>
    <pc:chgData name="Wencai Zhang" userId="4a86a1d0-2108-4707-8228-1110f3c1be85" providerId="ADAL" clId="{96B399D4-EF7B-6745-A04C-9FDC38403CFE}"/>
    <pc:docChg chg="custSel modSld">
      <pc:chgData name="Wencai Zhang" userId="4a86a1d0-2108-4707-8228-1110f3c1be85" providerId="ADAL" clId="{96B399D4-EF7B-6745-A04C-9FDC38403CFE}" dt="2022-06-15T19:43:57.863" v="8" actId="478"/>
      <pc:docMkLst>
        <pc:docMk/>
      </pc:docMkLst>
      <pc:sldChg chg="delSp">
        <pc:chgData name="Wencai Zhang" userId="4a86a1d0-2108-4707-8228-1110f3c1be85" providerId="ADAL" clId="{96B399D4-EF7B-6745-A04C-9FDC38403CFE}" dt="2022-06-15T19:43:50.426" v="6" actId="478"/>
        <pc:sldMkLst>
          <pc:docMk/>
          <pc:sldMk cId="2771812490" sldId="275"/>
        </pc:sldMkLst>
        <pc:spChg chg="del">
          <ac:chgData name="Wencai Zhang" userId="4a86a1d0-2108-4707-8228-1110f3c1be85" providerId="ADAL" clId="{96B399D4-EF7B-6745-A04C-9FDC38403CFE}" dt="2022-06-15T19:43:50.426" v="6" actId="478"/>
          <ac:spMkLst>
            <pc:docMk/>
            <pc:sldMk cId="2771812490" sldId="275"/>
            <ac:spMk id="32" creationId="{3E547D2F-565F-A84D-A2CA-22C354291393}"/>
          </ac:spMkLst>
        </pc:spChg>
        <pc:grpChg chg="del">
          <ac:chgData name="Wencai Zhang" userId="4a86a1d0-2108-4707-8228-1110f3c1be85" providerId="ADAL" clId="{96B399D4-EF7B-6745-A04C-9FDC38403CFE}" dt="2022-06-15T19:43:50.426" v="6" actId="478"/>
          <ac:grpSpMkLst>
            <pc:docMk/>
            <pc:sldMk cId="2771812490" sldId="275"/>
            <ac:grpSpMk id="30" creationId="{4C2F5E41-1829-A144-AC15-D2A2437327F8}"/>
          </ac:grpSpMkLst>
        </pc:grpChg>
        <pc:grpChg chg="del">
          <ac:chgData name="Wencai Zhang" userId="4a86a1d0-2108-4707-8228-1110f3c1be85" providerId="ADAL" clId="{96B399D4-EF7B-6745-A04C-9FDC38403CFE}" dt="2022-06-15T19:43:48.906" v="5" actId="478"/>
          <ac:grpSpMkLst>
            <pc:docMk/>
            <pc:sldMk cId="2771812490" sldId="275"/>
            <ac:grpSpMk id="31" creationId="{3BFBB084-5CE7-8F41-A2EF-B6E2D67C36D2}"/>
          </ac:grpSpMkLst>
        </pc:grpChg>
        <pc:picChg chg="del">
          <ac:chgData name="Wencai Zhang" userId="4a86a1d0-2108-4707-8228-1110f3c1be85" providerId="ADAL" clId="{96B399D4-EF7B-6745-A04C-9FDC38403CFE}" dt="2022-06-15T19:43:50.426" v="6" actId="478"/>
          <ac:picMkLst>
            <pc:docMk/>
            <pc:sldMk cId="2771812490" sldId="275"/>
            <ac:picMk id="3" creationId="{838C87E9-E1E0-1C42-B55B-D40D7516F38C}"/>
          </ac:picMkLst>
        </pc:picChg>
      </pc:sldChg>
      <pc:sldChg chg="delSp">
        <pc:chgData name="Wencai Zhang" userId="4a86a1d0-2108-4707-8228-1110f3c1be85" providerId="ADAL" clId="{96B399D4-EF7B-6745-A04C-9FDC38403CFE}" dt="2022-06-15T19:43:45.577" v="4" actId="478"/>
        <pc:sldMkLst>
          <pc:docMk/>
          <pc:sldMk cId="1043719466" sldId="281"/>
        </pc:sldMkLst>
        <pc:spChg chg="del">
          <ac:chgData name="Wencai Zhang" userId="4a86a1d0-2108-4707-8228-1110f3c1be85" providerId="ADAL" clId="{96B399D4-EF7B-6745-A04C-9FDC38403CFE}" dt="2022-06-15T19:43:45.577" v="4" actId="478"/>
          <ac:spMkLst>
            <pc:docMk/>
            <pc:sldMk cId="1043719466" sldId="281"/>
            <ac:spMk id="5" creationId="{A61503D3-A798-A843-99DC-C0890B8EB90D}"/>
          </ac:spMkLst>
        </pc:spChg>
      </pc:sldChg>
      <pc:sldChg chg="delSp">
        <pc:chgData name="Wencai Zhang" userId="4a86a1d0-2108-4707-8228-1110f3c1be85" providerId="ADAL" clId="{96B399D4-EF7B-6745-A04C-9FDC38403CFE}" dt="2022-06-15T19:43:54.791" v="7" actId="478"/>
        <pc:sldMkLst>
          <pc:docMk/>
          <pc:sldMk cId="3497662403" sldId="290"/>
        </pc:sldMkLst>
        <pc:spChg chg="del">
          <ac:chgData name="Wencai Zhang" userId="4a86a1d0-2108-4707-8228-1110f3c1be85" providerId="ADAL" clId="{96B399D4-EF7B-6745-A04C-9FDC38403CFE}" dt="2022-06-15T19:43:54.791" v="7" actId="478"/>
          <ac:spMkLst>
            <pc:docMk/>
            <pc:sldMk cId="3497662403" sldId="290"/>
            <ac:spMk id="8" creationId="{A4F20A6F-D30A-9040-ACD4-2B63464D1625}"/>
          </ac:spMkLst>
        </pc:spChg>
      </pc:sldChg>
      <pc:sldChg chg="delSp">
        <pc:chgData name="Wencai Zhang" userId="4a86a1d0-2108-4707-8228-1110f3c1be85" providerId="ADAL" clId="{96B399D4-EF7B-6745-A04C-9FDC38403CFE}" dt="2022-06-15T19:43:36.409" v="1" actId="478"/>
        <pc:sldMkLst>
          <pc:docMk/>
          <pc:sldMk cId="4133689721" sldId="291"/>
        </pc:sldMkLst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2" creationId="{531A11DB-C16A-474F-B52F-315BD512D038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3" creationId="{0E974834-8482-4440-809E-90B06CCA30F4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" creationId="{02092AE9-CFD4-4AC6-A393-F3990B5343F2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6" creationId="{89E84565-00A9-4750-B41B-2E8C35E6E19E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7" creationId="{28103BD3-1973-4A86-86AF-E873CD0F2C5B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8" creationId="{8F2B740F-1420-4373-B1FC-3589A02F06D8}"/>
          </ac:spMkLst>
        </pc:spChg>
        <pc:spChg chg="del">
          <ac:chgData name="Wencai Zhang" userId="4a86a1d0-2108-4707-8228-1110f3c1be85" providerId="ADAL" clId="{96B399D4-EF7B-6745-A04C-9FDC38403CFE}" dt="2022-06-15T19:43:33.892" v="0" actId="478"/>
          <ac:spMkLst>
            <pc:docMk/>
            <pc:sldMk cId="4133689721" sldId="291"/>
            <ac:spMk id="17" creationId="{649CC280-8498-5F47-A7C8-A30278508115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22" creationId="{4FBC6A88-627F-407D-A159-D386F6F67CF7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31" creationId="{FA424362-9542-421D-95CE-97EF263215FD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3" creationId="{2AA9094F-D7AB-4950-B7FC-5E87D4F75296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4" creationId="{1620750B-9206-4AD3-BA74-C9087006A6EA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45" creationId="{17320253-C946-43AF-9A81-5DE075E93EE8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52" creationId="{378F9693-E488-4D49-906F-28E2A437446B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82" creationId="{64CE77AD-5AE7-486C-BB91-85E1CD16181D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87" creationId="{10943836-76F0-4359-8724-99CA98811398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1" creationId="{D6CB511F-139C-41D4-8250-3CE8C1C529A2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4" creationId="{9DD241D0-FA5A-46DA-805C-C56E7116101A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5" creationId="{5949CED8-518B-4502-9EFE-E1900364B0C4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7" creationId="{855AF6B0-3ACF-44FA-9737-1415FC3FF6CF}"/>
          </ac:spMkLst>
        </pc:spChg>
        <pc:spChg chg="del">
          <ac:chgData name="Wencai Zhang" userId="4a86a1d0-2108-4707-8228-1110f3c1be85" providerId="ADAL" clId="{96B399D4-EF7B-6745-A04C-9FDC38403CFE}" dt="2022-06-15T19:43:36.409" v="1" actId="478"/>
          <ac:spMkLst>
            <pc:docMk/>
            <pc:sldMk cId="4133689721" sldId="291"/>
            <ac:spMk id="128" creationId="{E1E6E364-D220-4501-AFB7-E5A4AE205604}"/>
          </ac:spMkLst>
        </pc:s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0" creationId="{5FFDB581-28EA-4CF8-9D80-C21FAA8AD78B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1" creationId="{9B6EA788-4148-4A0F-B9B5-A47882718B60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2" creationId="{3AF54EC6-A750-467B-91D8-C4F39AB6EC99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3" creationId="{EFFB9AEE-3FB8-499F-8081-641918985D0B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14" creationId="{D5F7F827-893F-4BC5-B898-F40FAFF99A29}"/>
          </ac:grpSpMkLst>
        </pc:grpChg>
        <pc:grpChg chg="del">
          <ac:chgData name="Wencai Zhang" userId="4a86a1d0-2108-4707-8228-1110f3c1be85" providerId="ADAL" clId="{96B399D4-EF7B-6745-A04C-9FDC38403CFE}" dt="2022-06-15T19:43:36.409" v="1" actId="478"/>
          <ac:grpSpMkLst>
            <pc:docMk/>
            <pc:sldMk cId="4133689721" sldId="291"/>
            <ac:grpSpMk id="36" creationId="{00308009-BF9B-40C1-BBA6-2AF3C82A16A4}"/>
          </ac:grpSpMkLst>
        </pc:grp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5" creationId="{22F69510-3952-44E9-A333-35C4129A0F35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9" creationId="{3258128A-403C-4AE9-8E99-C30DA2F06EF5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50" creationId="{65742105-94B2-48B2-935D-134AAF44401E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81" creationId="{BE92BD88-DCA3-4340-A32C-86E24907DA79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84" creationId="{9F2AA289-39DA-4F8F-A3F6-9329A4DB85F7}"/>
          </ac:picMkLst>
        </pc:picChg>
        <pc:picChg chg="del">
          <ac:chgData name="Wencai Zhang" userId="4a86a1d0-2108-4707-8228-1110f3c1be85" providerId="ADAL" clId="{96B399D4-EF7B-6745-A04C-9FDC38403CFE}" dt="2022-06-15T19:43:36.409" v="1" actId="478"/>
          <ac:picMkLst>
            <pc:docMk/>
            <pc:sldMk cId="4133689721" sldId="291"/>
            <ac:picMk id="85" creationId="{BC52D881-4878-435B-835B-02EB8A51FBC2}"/>
          </ac:picMkLst>
        </pc:picChg>
      </pc:sldChg>
      <pc:sldChg chg="delSp">
        <pc:chgData name="Wencai Zhang" userId="4a86a1d0-2108-4707-8228-1110f3c1be85" providerId="ADAL" clId="{96B399D4-EF7B-6745-A04C-9FDC38403CFE}" dt="2022-06-15T19:43:57.863" v="8" actId="478"/>
        <pc:sldMkLst>
          <pc:docMk/>
          <pc:sldMk cId="472844202" sldId="292"/>
        </pc:sldMkLst>
        <pc:spChg chg="del">
          <ac:chgData name="Wencai Zhang" userId="4a86a1d0-2108-4707-8228-1110f3c1be85" providerId="ADAL" clId="{96B399D4-EF7B-6745-A04C-9FDC38403CFE}" dt="2022-06-15T19:43:57.863" v="8" actId="478"/>
          <ac:spMkLst>
            <pc:docMk/>
            <pc:sldMk cId="472844202" sldId="292"/>
            <ac:spMk id="32" creationId="{62C6F7E6-04DF-1548-BD3C-454D15C0CE2C}"/>
          </ac:spMkLst>
        </pc:spChg>
      </pc:sldChg>
      <pc:sldChg chg="delSp">
        <pc:chgData name="Wencai Zhang" userId="4a86a1d0-2108-4707-8228-1110f3c1be85" providerId="ADAL" clId="{96B399D4-EF7B-6745-A04C-9FDC38403CFE}" dt="2022-06-15T19:43:41.392" v="3" actId="478"/>
        <pc:sldMkLst>
          <pc:docMk/>
          <pc:sldMk cId="492363108" sldId="293"/>
        </pc:sldMkLst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2" creationId="{531A11DB-C16A-474F-B52F-315BD512D038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3" creationId="{0E974834-8482-4440-809E-90B06CCA30F4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" creationId="{02092AE9-CFD4-4AC6-A393-F3990B5343F2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6" creationId="{89E84565-00A9-4750-B41B-2E8C35E6E19E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7" creationId="{28103BD3-1973-4A86-86AF-E873CD0F2C5B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8" creationId="{8F2B740F-1420-4373-B1FC-3589A02F06D8}"/>
          </ac:spMkLst>
        </pc:spChg>
        <pc:spChg chg="del">
          <ac:chgData name="Wencai Zhang" userId="4a86a1d0-2108-4707-8228-1110f3c1be85" providerId="ADAL" clId="{96B399D4-EF7B-6745-A04C-9FDC38403CFE}" dt="2022-06-15T19:43:41.392" v="3" actId="478"/>
          <ac:spMkLst>
            <pc:docMk/>
            <pc:sldMk cId="492363108" sldId="293"/>
            <ac:spMk id="17" creationId="{649CC280-8498-5F47-A7C8-A30278508115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22" creationId="{4FBC6A88-627F-407D-A159-D386F6F67CF7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31" creationId="{FA424362-9542-421D-95CE-97EF263215FD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3" creationId="{2AA9094F-D7AB-4950-B7FC-5E87D4F75296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4" creationId="{1620750B-9206-4AD3-BA74-C9087006A6EA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45" creationId="{17320253-C946-43AF-9A81-5DE075E93EE8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52" creationId="{378F9693-E488-4D49-906F-28E2A437446B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82" creationId="{64CE77AD-5AE7-486C-BB91-85E1CD16181D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87" creationId="{10943836-76F0-4359-8724-99CA98811398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1" creationId="{D6CB511F-139C-41D4-8250-3CE8C1C529A2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4" creationId="{9DD241D0-FA5A-46DA-805C-C56E7116101A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5" creationId="{5949CED8-518B-4502-9EFE-E1900364B0C4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7" creationId="{855AF6B0-3ACF-44FA-9737-1415FC3FF6CF}"/>
          </ac:spMkLst>
        </pc:spChg>
        <pc:spChg chg="del">
          <ac:chgData name="Wencai Zhang" userId="4a86a1d0-2108-4707-8228-1110f3c1be85" providerId="ADAL" clId="{96B399D4-EF7B-6745-A04C-9FDC38403CFE}" dt="2022-06-15T19:43:39.490" v="2" actId="478"/>
          <ac:spMkLst>
            <pc:docMk/>
            <pc:sldMk cId="492363108" sldId="293"/>
            <ac:spMk id="128" creationId="{E1E6E364-D220-4501-AFB7-E5A4AE205604}"/>
          </ac:spMkLst>
        </pc:s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0" creationId="{5FFDB581-28EA-4CF8-9D80-C21FAA8AD78B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1" creationId="{9B6EA788-4148-4A0F-B9B5-A47882718B60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2" creationId="{3AF54EC6-A750-467B-91D8-C4F39AB6EC99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3" creationId="{EFFB9AEE-3FB8-499F-8081-641918985D0B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14" creationId="{D5F7F827-893F-4BC5-B898-F40FAFF99A29}"/>
          </ac:grpSpMkLst>
        </pc:grpChg>
        <pc:grpChg chg="del">
          <ac:chgData name="Wencai Zhang" userId="4a86a1d0-2108-4707-8228-1110f3c1be85" providerId="ADAL" clId="{96B399D4-EF7B-6745-A04C-9FDC38403CFE}" dt="2022-06-15T19:43:41.392" v="3" actId="478"/>
          <ac:grpSpMkLst>
            <pc:docMk/>
            <pc:sldMk cId="492363108" sldId="293"/>
            <ac:grpSpMk id="34" creationId="{E47D2EDA-C3CA-A748-A7D9-3A377DD9E68C}"/>
          </ac:grpSpMkLst>
        </pc:grpChg>
        <pc:grpChg chg="del">
          <ac:chgData name="Wencai Zhang" userId="4a86a1d0-2108-4707-8228-1110f3c1be85" providerId="ADAL" clId="{96B399D4-EF7B-6745-A04C-9FDC38403CFE}" dt="2022-06-15T19:43:39.490" v="2" actId="478"/>
          <ac:grpSpMkLst>
            <pc:docMk/>
            <pc:sldMk cId="492363108" sldId="293"/>
            <ac:grpSpMk id="36" creationId="{00308009-BF9B-40C1-BBA6-2AF3C82A16A4}"/>
          </ac:grpSpMkLst>
        </pc:grp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5" creationId="{22F69510-3952-44E9-A333-35C4129A0F35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9" creationId="{3258128A-403C-4AE9-8E99-C30DA2F06EF5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50" creationId="{65742105-94B2-48B2-935D-134AAF44401E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81" creationId="{BE92BD88-DCA3-4340-A32C-86E24907DA79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84" creationId="{9F2AA289-39DA-4F8F-A3F6-9329A4DB85F7}"/>
          </ac:picMkLst>
        </pc:picChg>
        <pc:picChg chg="del">
          <ac:chgData name="Wencai Zhang" userId="4a86a1d0-2108-4707-8228-1110f3c1be85" providerId="ADAL" clId="{96B399D4-EF7B-6745-A04C-9FDC38403CFE}" dt="2022-06-15T19:43:39.490" v="2" actId="478"/>
          <ac:picMkLst>
            <pc:docMk/>
            <pc:sldMk cId="492363108" sldId="293"/>
            <ac:picMk id="85" creationId="{BC52D881-4878-435B-835B-02EB8A51FBC2}"/>
          </ac:picMkLst>
        </pc:picChg>
      </pc:sldChg>
    </pc:docChg>
  </pc:docChgLst>
  <pc:docChgLst>
    <pc:chgData name="Wencai Zhang" userId="4a86a1d0-2108-4707-8228-1110f3c1be85" providerId="ADAL" clId="{75BEC149-D62E-5D48-803F-577443322235}"/>
    <pc:docChg chg="undo redo custSel modSld sldOrd">
      <pc:chgData name="Wencai Zhang" userId="4a86a1d0-2108-4707-8228-1110f3c1be85" providerId="ADAL" clId="{75BEC149-D62E-5D48-803F-577443322235}" dt="2022-04-21T16:33:37.757" v="1372" actId="1076"/>
      <pc:docMkLst>
        <pc:docMk/>
      </pc:docMkLst>
      <pc:sldChg chg="addSp delSp modSp ord">
        <pc:chgData name="Wencai Zhang" userId="4a86a1d0-2108-4707-8228-1110f3c1be85" providerId="ADAL" clId="{75BEC149-D62E-5D48-803F-577443322235}" dt="2022-04-21T16:15:48.094" v="957"/>
        <pc:sldMkLst>
          <pc:docMk/>
          <pc:sldMk cId="2771812490" sldId="275"/>
        </pc:sldMkLst>
        <pc:spChg chg="add mod">
          <ac:chgData name="Wencai Zhang" userId="4a86a1d0-2108-4707-8228-1110f3c1be85" providerId="ADAL" clId="{75BEC149-D62E-5D48-803F-577443322235}" dt="2022-04-20T13:53:57.098" v="332" actId="2711"/>
          <ac:spMkLst>
            <pc:docMk/>
            <pc:sldMk cId="2771812490" sldId="275"/>
            <ac:spMk id="4" creationId="{BC602CB3-8CBB-2844-9912-39B8A0172194}"/>
          </ac:spMkLst>
        </pc:spChg>
        <pc:spChg chg="mod">
          <ac:chgData name="Wencai Zhang" userId="4a86a1d0-2108-4707-8228-1110f3c1be85" providerId="ADAL" clId="{75BEC149-D62E-5D48-803F-577443322235}" dt="2022-04-20T13:27:09.784" v="97" actId="1035"/>
          <ac:spMkLst>
            <pc:docMk/>
            <pc:sldMk cId="2771812490" sldId="275"/>
            <ac:spMk id="23" creationId="{95FD9F0A-26F5-4149-89EC-4E909A353725}"/>
          </ac:spMkLst>
        </pc:spChg>
        <pc:spChg chg="del">
          <ac:chgData name="Wencai Zhang" userId="4a86a1d0-2108-4707-8228-1110f3c1be85" providerId="ADAL" clId="{75BEC149-D62E-5D48-803F-577443322235}" dt="2022-04-20T13:27:16.138" v="98" actId="478"/>
          <ac:spMkLst>
            <pc:docMk/>
            <pc:sldMk cId="2771812490" sldId="275"/>
            <ac:spMk id="24" creationId="{BF95736E-AF10-6E42-89C3-BC9C45E298BB}"/>
          </ac:spMkLst>
        </pc:spChg>
        <pc:spChg chg="mod">
          <ac:chgData name="Wencai Zhang" userId="4a86a1d0-2108-4707-8228-1110f3c1be85" providerId="ADAL" clId="{75BEC149-D62E-5D48-803F-577443322235}" dt="2022-04-20T13:32:08.222" v="100"/>
          <ac:spMkLst>
            <pc:docMk/>
            <pc:sldMk cId="2771812490" sldId="275"/>
            <ac:spMk id="32" creationId="{3E547D2F-565F-A84D-A2CA-22C354291393}"/>
          </ac:spMkLst>
        </pc:spChg>
        <pc:spChg chg="mod topLvl">
          <ac:chgData name="Wencai Zhang" userId="4a86a1d0-2108-4707-8228-1110f3c1be85" providerId="ADAL" clId="{75BEC149-D62E-5D48-803F-577443322235}" dt="2022-04-20T13:43:43.463" v="101" actId="165"/>
          <ac:spMkLst>
            <pc:docMk/>
            <pc:sldMk cId="2771812490" sldId="275"/>
            <ac:spMk id="33" creationId="{CEA624C1-1221-BC49-A143-8E4CFF8B66F4}"/>
          </ac:spMkLst>
        </pc:spChg>
        <pc:spChg chg="mod topLvl">
          <ac:chgData name="Wencai Zhang" userId="4a86a1d0-2108-4707-8228-1110f3c1be85" providerId="ADAL" clId="{75BEC149-D62E-5D48-803F-577443322235}" dt="2022-04-20T13:43:43.463" v="101" actId="165"/>
          <ac:spMkLst>
            <pc:docMk/>
            <pc:sldMk cId="2771812490" sldId="275"/>
            <ac:spMk id="34" creationId="{E0DFD16F-74D2-A54D-9BBA-F47CA120E99E}"/>
          </ac:spMkLst>
        </pc:spChg>
        <pc:spChg chg="add del mod">
          <ac:chgData name="Wencai Zhang" userId="4a86a1d0-2108-4707-8228-1110f3c1be85" providerId="ADAL" clId="{75BEC149-D62E-5D48-803F-577443322235}" dt="2022-04-20T13:49:00.520" v="120" actId="478"/>
          <ac:spMkLst>
            <pc:docMk/>
            <pc:sldMk cId="2771812490" sldId="275"/>
            <ac:spMk id="47" creationId="{258D60A8-BFA1-3F45-AEF6-D7037BE05686}"/>
          </ac:spMkLst>
        </pc:spChg>
        <pc:spChg chg="add del mod">
          <ac:chgData name="Wencai Zhang" userId="4a86a1d0-2108-4707-8228-1110f3c1be85" providerId="ADAL" clId="{75BEC149-D62E-5D48-803F-577443322235}" dt="2022-04-20T13:49:00.520" v="120" actId="478"/>
          <ac:spMkLst>
            <pc:docMk/>
            <pc:sldMk cId="2771812490" sldId="275"/>
            <ac:spMk id="48" creationId="{235B9F5B-2DFC-9A40-9BA7-25F5A04C2FF8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1" creationId="{EFE8703C-0A67-7A46-ABCA-DA3A4735065D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2" creationId="{D430265C-3C68-B84B-81A3-4A6D0FD150A3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4" creationId="{6B43ABE1-5370-E042-917F-BC4B8869CC0A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5" creationId="{14212895-2C6E-5540-961C-FB932297D560}"/>
          </ac:spMkLst>
        </pc:spChg>
        <pc:spChg chg="add del mod">
          <ac:chgData name="Wencai Zhang" userId="4a86a1d0-2108-4707-8228-1110f3c1be85" providerId="ADAL" clId="{75BEC149-D62E-5D48-803F-577443322235}" dt="2022-04-20T13:53:10.668" v="323" actId="478"/>
          <ac:spMkLst>
            <pc:docMk/>
            <pc:sldMk cId="2771812490" sldId="275"/>
            <ac:spMk id="56" creationId="{49C4FFDD-AE99-CD42-8359-283CA5A2B271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0" creationId="{30C7F6F5-E0DF-CF48-AA88-7341707410B8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1" creationId="{81745A2C-9606-4143-9842-FEC9D8F8CF91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4" creationId="{6757ABC1-26F0-7E45-AAB7-8CF75B64D5CB}"/>
          </ac:spMkLst>
        </pc:spChg>
        <pc:spChg chg="add del mod">
          <ac:chgData name="Wencai Zhang" userId="4a86a1d0-2108-4707-8228-1110f3c1be85" providerId="ADAL" clId="{75BEC149-D62E-5D48-803F-577443322235}" dt="2022-04-20T13:56:40.740" v="333" actId="478"/>
          <ac:spMkLst>
            <pc:docMk/>
            <pc:sldMk cId="2771812490" sldId="275"/>
            <ac:spMk id="65" creationId="{4FE5AD57-C723-3945-B290-B4C986A2D6AA}"/>
          </ac:spMkLst>
        </pc:spChg>
        <pc:spChg chg="add del">
          <ac:chgData name="Wencai Zhang" userId="4a86a1d0-2108-4707-8228-1110f3c1be85" providerId="ADAL" clId="{75BEC149-D62E-5D48-803F-577443322235}" dt="2022-04-20T13:56:45.744" v="335"/>
          <ac:spMkLst>
            <pc:docMk/>
            <pc:sldMk cId="2771812490" sldId="275"/>
            <ac:spMk id="67" creationId="{4C3662A5-21A8-8145-9103-D19B50AC4365}"/>
          </ac:spMkLst>
        </pc:spChg>
        <pc:spChg chg="add del">
          <ac:chgData name="Wencai Zhang" userId="4a86a1d0-2108-4707-8228-1110f3c1be85" providerId="ADAL" clId="{75BEC149-D62E-5D48-803F-577443322235}" dt="2022-04-20T13:56:45.744" v="335"/>
          <ac:spMkLst>
            <pc:docMk/>
            <pc:sldMk cId="2771812490" sldId="275"/>
            <ac:spMk id="68" creationId="{72AA77F7-D919-9E4D-854E-E63BF92C516D}"/>
          </ac:spMkLst>
        </pc:spChg>
        <pc:spChg chg="add del">
          <ac:chgData name="Wencai Zhang" userId="4a86a1d0-2108-4707-8228-1110f3c1be85" providerId="ADAL" clId="{75BEC149-D62E-5D48-803F-577443322235}" dt="2022-04-20T13:56:45.744" v="335"/>
          <ac:spMkLst>
            <pc:docMk/>
            <pc:sldMk cId="2771812490" sldId="275"/>
            <ac:spMk id="71" creationId="{28B07F93-8914-F149-95A5-6AF31EED7B91}"/>
          </ac:spMkLst>
        </pc:spChg>
        <pc:spChg chg="add mod">
          <ac:chgData name="Wencai Zhang" userId="4a86a1d0-2108-4707-8228-1110f3c1be85" providerId="ADAL" clId="{75BEC149-D62E-5D48-803F-577443322235}" dt="2022-04-20T13:57:11.050" v="422" actId="1035"/>
          <ac:spMkLst>
            <pc:docMk/>
            <pc:sldMk cId="2771812490" sldId="275"/>
            <ac:spMk id="74" creationId="{365539E0-2BF1-1442-A044-71AE3ADDC3BD}"/>
          </ac:spMkLst>
        </pc:spChg>
        <pc:spChg chg="add mod">
          <ac:chgData name="Wencai Zhang" userId="4a86a1d0-2108-4707-8228-1110f3c1be85" providerId="ADAL" clId="{75BEC149-D62E-5D48-803F-577443322235}" dt="2022-04-20T13:57:11.050" v="422" actId="1035"/>
          <ac:spMkLst>
            <pc:docMk/>
            <pc:sldMk cId="2771812490" sldId="275"/>
            <ac:spMk id="75" creationId="{22C01380-BB16-3249-958D-36C2C8A18AF5}"/>
          </ac:spMkLst>
        </pc:spChg>
        <pc:spChg chg="add mod">
          <ac:chgData name="Wencai Zhang" userId="4a86a1d0-2108-4707-8228-1110f3c1be85" providerId="ADAL" clId="{75BEC149-D62E-5D48-803F-577443322235}" dt="2022-04-20T13:57:23.087" v="437" actId="1038"/>
          <ac:spMkLst>
            <pc:docMk/>
            <pc:sldMk cId="2771812490" sldId="275"/>
            <ac:spMk id="78" creationId="{62ACFE0D-E2AB-6741-8325-4F584FDECD58}"/>
          </ac:spMkLst>
        </pc:spChg>
        <pc:spChg chg="add mod">
          <ac:chgData name="Wencai Zhang" userId="4a86a1d0-2108-4707-8228-1110f3c1be85" providerId="ADAL" clId="{75BEC149-D62E-5D48-803F-577443322235}" dt="2022-04-20T13:57:23.087" v="437" actId="1038"/>
          <ac:spMkLst>
            <pc:docMk/>
            <pc:sldMk cId="2771812490" sldId="275"/>
            <ac:spMk id="79" creationId="{BC77567E-3CF9-EA45-B16D-00A7ADE1EE5D}"/>
          </ac:spMkLst>
        </pc:spChg>
        <pc:grpChg chg="del">
          <ac:chgData name="Wencai Zhang" userId="4a86a1d0-2108-4707-8228-1110f3c1be85" providerId="ADAL" clId="{75BEC149-D62E-5D48-803F-577443322235}" dt="2022-04-20T13:43:43.463" v="101" actId="165"/>
          <ac:grpSpMkLst>
            <pc:docMk/>
            <pc:sldMk cId="2771812490" sldId="275"/>
            <ac:grpSpMk id="2" creationId="{44A38F47-97D3-0A4D-BCD9-2FD70A1DB48D}"/>
          </ac:grpSpMkLst>
        </pc:grpChg>
        <pc:grpChg chg="mod topLvl">
          <ac:chgData name="Wencai Zhang" userId="4a86a1d0-2108-4707-8228-1110f3c1be85" providerId="ADAL" clId="{75BEC149-D62E-5D48-803F-577443322235}" dt="2022-04-20T13:48:37.262" v="119" actId="1076"/>
          <ac:grpSpMkLst>
            <pc:docMk/>
            <pc:sldMk cId="2771812490" sldId="275"/>
            <ac:grpSpMk id="30" creationId="{4C2F5E41-1829-A144-AC15-D2A2437327F8}"/>
          </ac:grpSpMkLst>
        </pc:grpChg>
        <pc:grpChg chg="mod topLvl">
          <ac:chgData name="Wencai Zhang" userId="4a86a1d0-2108-4707-8228-1110f3c1be85" providerId="ADAL" clId="{75BEC149-D62E-5D48-803F-577443322235}" dt="2022-04-20T13:43:48.832" v="102" actId="1076"/>
          <ac:grpSpMkLst>
            <pc:docMk/>
            <pc:sldMk cId="2771812490" sldId="275"/>
            <ac:grpSpMk id="31" creationId="{3BFBB084-5CE7-8F41-A2EF-B6E2D67C36D2}"/>
          </ac:grpSpMkLst>
        </pc:grpChg>
        <pc:grpChg chg="add del mod">
          <ac:chgData name="Wencai Zhang" userId="4a86a1d0-2108-4707-8228-1110f3c1be85" providerId="ADAL" clId="{75BEC149-D62E-5D48-803F-577443322235}" dt="2022-04-20T14:45:01.784" v="438" actId="478"/>
          <ac:grpSpMkLst>
            <pc:docMk/>
            <pc:sldMk cId="2771812490" sldId="275"/>
            <ac:grpSpMk id="35" creationId="{995353F9-AB45-1046-9CCE-6E2F00A2FD62}"/>
          </ac:grpSpMkLst>
        </pc:grpChg>
        <pc:graphicFrameChg chg="add del mod">
          <ac:chgData name="Wencai Zhang" userId="4a86a1d0-2108-4707-8228-1110f3c1be85" providerId="ADAL" clId="{75BEC149-D62E-5D48-803F-577443322235}" dt="2022-04-20T13:49:00.520" v="120" actId="478"/>
          <ac:graphicFrameMkLst>
            <pc:docMk/>
            <pc:sldMk cId="2771812490" sldId="275"/>
            <ac:graphicFrameMk id="46" creationId="{25872379-0BEC-F54C-9127-572022DA984D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3:10.668" v="323" actId="478"/>
          <ac:graphicFrameMkLst>
            <pc:docMk/>
            <pc:sldMk cId="2771812490" sldId="275"/>
            <ac:graphicFrameMk id="50" creationId="{FEBF70A9-84A2-8644-91CD-C458556B1F3F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3:10.668" v="323" actId="478"/>
          <ac:graphicFrameMkLst>
            <pc:docMk/>
            <pc:sldMk cId="2771812490" sldId="275"/>
            <ac:graphicFrameMk id="53" creationId="{00501B44-9414-7143-A25C-B5C770DDAB41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6:40.740" v="333" actId="478"/>
          <ac:graphicFrameMkLst>
            <pc:docMk/>
            <pc:sldMk cId="2771812490" sldId="275"/>
            <ac:graphicFrameMk id="59" creationId="{98E94B8E-0033-E044-9EC9-1C8DAD3D9BEE}"/>
          </ac:graphicFrameMkLst>
        </pc:graphicFrameChg>
        <pc:graphicFrameChg chg="add del mod">
          <ac:chgData name="Wencai Zhang" userId="4a86a1d0-2108-4707-8228-1110f3c1be85" providerId="ADAL" clId="{75BEC149-D62E-5D48-803F-577443322235}" dt="2022-04-20T13:56:40.740" v="333" actId="478"/>
          <ac:graphicFrameMkLst>
            <pc:docMk/>
            <pc:sldMk cId="2771812490" sldId="275"/>
            <ac:graphicFrameMk id="63" creationId="{9BA732F8-1E1E-3A41-9CBE-ADD6E2732EC2}"/>
          </ac:graphicFrameMkLst>
        </pc:graphicFrameChg>
        <pc:graphicFrameChg chg="add del">
          <ac:chgData name="Wencai Zhang" userId="4a86a1d0-2108-4707-8228-1110f3c1be85" providerId="ADAL" clId="{75BEC149-D62E-5D48-803F-577443322235}" dt="2022-04-20T13:56:45.744" v="335"/>
          <ac:graphicFrameMkLst>
            <pc:docMk/>
            <pc:sldMk cId="2771812490" sldId="275"/>
            <ac:graphicFrameMk id="70" creationId="{46426D0C-3AF2-D84C-BF55-F69F9F0748BB}"/>
          </ac:graphicFrameMkLst>
        </pc:graphicFrameChg>
        <pc:graphicFrameChg chg="add del">
          <ac:chgData name="Wencai Zhang" userId="4a86a1d0-2108-4707-8228-1110f3c1be85" providerId="ADAL" clId="{75BEC149-D62E-5D48-803F-577443322235}" dt="2022-04-20T13:56:45.744" v="335"/>
          <ac:graphicFrameMkLst>
            <pc:docMk/>
            <pc:sldMk cId="2771812490" sldId="275"/>
            <ac:graphicFrameMk id="72" creationId="{47EC0916-9248-9945-998E-A650BDF67B3F}"/>
          </ac:graphicFrameMkLst>
        </pc:graphicFrameChg>
        <pc:graphicFrameChg chg="add mod">
          <ac:chgData name="Wencai Zhang" userId="4a86a1d0-2108-4707-8228-1110f3c1be85" providerId="ADAL" clId="{75BEC149-D62E-5D48-803F-577443322235}" dt="2022-04-20T13:57:23.087" v="437" actId="1038"/>
          <ac:graphicFrameMkLst>
            <pc:docMk/>
            <pc:sldMk cId="2771812490" sldId="275"/>
            <ac:graphicFrameMk id="77" creationId="{AAAA6111-807F-D54A-8BC0-61474EE0AA26}"/>
          </ac:graphicFrameMkLst>
        </pc:graphicFrameChg>
        <pc:graphicFrameChg chg="add mod">
          <ac:chgData name="Wencai Zhang" userId="4a86a1d0-2108-4707-8228-1110f3c1be85" providerId="ADAL" clId="{75BEC149-D62E-5D48-803F-577443322235}" dt="2022-04-20T13:57:11.050" v="422" actId="1035"/>
          <ac:graphicFrameMkLst>
            <pc:docMk/>
            <pc:sldMk cId="2771812490" sldId="275"/>
            <ac:graphicFrameMk id="80" creationId="{13FBA6AA-37E8-B640-96B5-91E7FDE707B7}"/>
          </ac:graphicFrameMkLst>
        </pc:graphicFrameChg>
        <pc:picChg chg="mod topLvl">
          <ac:chgData name="Wencai Zhang" userId="4a86a1d0-2108-4707-8228-1110f3c1be85" providerId="ADAL" clId="{75BEC149-D62E-5D48-803F-577443322235}" dt="2022-04-20T13:48:37.262" v="119" actId="1076"/>
          <ac:picMkLst>
            <pc:docMk/>
            <pc:sldMk cId="2771812490" sldId="275"/>
            <ac:picMk id="3" creationId="{838C87E9-E1E0-1C42-B55B-D40D7516F38C}"/>
          </ac:picMkLst>
        </pc:picChg>
        <pc:picChg chg="add del mod">
          <ac:chgData name="Wencai Zhang" userId="4a86a1d0-2108-4707-8228-1110f3c1be85" providerId="ADAL" clId="{75BEC149-D62E-5D48-803F-577443322235}" dt="2022-04-20T13:49:00.520" v="120" actId="478"/>
          <ac:picMkLst>
            <pc:docMk/>
            <pc:sldMk cId="2771812490" sldId="275"/>
            <ac:picMk id="45" creationId="{48858192-D713-5748-8BE1-23CD293A1009}"/>
          </ac:picMkLst>
        </pc:picChg>
        <pc:picChg chg="add del mod">
          <ac:chgData name="Wencai Zhang" userId="4a86a1d0-2108-4707-8228-1110f3c1be85" providerId="ADAL" clId="{75BEC149-D62E-5D48-803F-577443322235}" dt="2022-04-20T13:53:10.668" v="323" actId="478"/>
          <ac:picMkLst>
            <pc:docMk/>
            <pc:sldMk cId="2771812490" sldId="275"/>
            <ac:picMk id="49" creationId="{9433846F-7499-F542-85F7-5C1CAA20726C}"/>
          </ac:picMkLst>
        </pc:picChg>
        <pc:picChg chg="add del mod">
          <ac:chgData name="Wencai Zhang" userId="4a86a1d0-2108-4707-8228-1110f3c1be85" providerId="ADAL" clId="{75BEC149-D62E-5D48-803F-577443322235}" dt="2022-04-20T13:53:10.668" v="323" actId="478"/>
          <ac:picMkLst>
            <pc:docMk/>
            <pc:sldMk cId="2771812490" sldId="275"/>
            <ac:picMk id="57" creationId="{7219EAE5-AA75-934F-8866-D3F5659B72FF}"/>
          </ac:picMkLst>
        </pc:picChg>
        <pc:picChg chg="add del mod">
          <ac:chgData name="Wencai Zhang" userId="4a86a1d0-2108-4707-8228-1110f3c1be85" providerId="ADAL" clId="{75BEC149-D62E-5D48-803F-577443322235}" dt="2022-04-20T13:56:40.740" v="333" actId="478"/>
          <ac:picMkLst>
            <pc:docMk/>
            <pc:sldMk cId="2771812490" sldId="275"/>
            <ac:picMk id="58" creationId="{DD0D322B-51DD-784E-BF42-A39F51123EE0}"/>
          </ac:picMkLst>
        </pc:picChg>
        <pc:picChg chg="add del mod">
          <ac:chgData name="Wencai Zhang" userId="4a86a1d0-2108-4707-8228-1110f3c1be85" providerId="ADAL" clId="{75BEC149-D62E-5D48-803F-577443322235}" dt="2022-04-20T13:56:40.740" v="333" actId="478"/>
          <ac:picMkLst>
            <pc:docMk/>
            <pc:sldMk cId="2771812490" sldId="275"/>
            <ac:picMk id="62" creationId="{009DC65B-2485-6A40-A3DC-2C4B2466482C}"/>
          </ac:picMkLst>
        </pc:picChg>
        <pc:picChg chg="add del">
          <ac:chgData name="Wencai Zhang" userId="4a86a1d0-2108-4707-8228-1110f3c1be85" providerId="ADAL" clId="{75BEC149-D62E-5D48-803F-577443322235}" dt="2022-04-20T13:56:45.744" v="335"/>
          <ac:picMkLst>
            <pc:docMk/>
            <pc:sldMk cId="2771812490" sldId="275"/>
            <ac:picMk id="66" creationId="{9DFD797A-03D5-9B4E-BB9B-91F50A437471}"/>
          </ac:picMkLst>
        </pc:picChg>
        <pc:picChg chg="add del">
          <ac:chgData name="Wencai Zhang" userId="4a86a1d0-2108-4707-8228-1110f3c1be85" providerId="ADAL" clId="{75BEC149-D62E-5D48-803F-577443322235}" dt="2022-04-20T13:56:45.744" v="335"/>
          <ac:picMkLst>
            <pc:docMk/>
            <pc:sldMk cId="2771812490" sldId="275"/>
            <ac:picMk id="69" creationId="{8E16E772-E74A-E149-BB57-A34BDBB69CD7}"/>
          </ac:picMkLst>
        </pc:picChg>
        <pc:picChg chg="add mod">
          <ac:chgData name="Wencai Zhang" userId="4a86a1d0-2108-4707-8228-1110f3c1be85" providerId="ADAL" clId="{75BEC149-D62E-5D48-803F-577443322235}" dt="2022-04-20T13:57:11.050" v="422" actId="1035"/>
          <ac:picMkLst>
            <pc:docMk/>
            <pc:sldMk cId="2771812490" sldId="275"/>
            <ac:picMk id="73" creationId="{FA6DE939-28C5-EA4A-8057-993CD534D645}"/>
          </ac:picMkLst>
        </pc:picChg>
        <pc:picChg chg="add mod">
          <ac:chgData name="Wencai Zhang" userId="4a86a1d0-2108-4707-8228-1110f3c1be85" providerId="ADAL" clId="{75BEC149-D62E-5D48-803F-577443322235}" dt="2022-04-20T13:57:23.087" v="437" actId="1038"/>
          <ac:picMkLst>
            <pc:docMk/>
            <pc:sldMk cId="2771812490" sldId="275"/>
            <ac:picMk id="76" creationId="{D37B6108-D39B-CD49-9ABA-31BA9FB6454B}"/>
          </ac:picMkLst>
        </pc:picChg>
      </pc:sldChg>
      <pc:sldChg chg="addSp delSp modSp">
        <pc:chgData name="Wencai Zhang" userId="4a86a1d0-2108-4707-8228-1110f3c1be85" providerId="ADAL" clId="{75BEC149-D62E-5D48-803F-577443322235}" dt="2022-04-20T16:08:39.199" v="951" actId="1076"/>
        <pc:sldMkLst>
          <pc:docMk/>
          <pc:sldMk cId="1997077850" sldId="279"/>
        </pc:sldMkLst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6" creationId="{F3DB81E6-B77D-A343-8DE3-1FFFD129AA77}"/>
          </ac:spMkLst>
        </pc:spChg>
        <pc:spChg chg="mod">
          <ac:chgData name="Wencai Zhang" userId="4a86a1d0-2108-4707-8228-1110f3c1be85" providerId="ADAL" clId="{75BEC149-D62E-5D48-803F-577443322235}" dt="2022-04-20T15:50:36.275" v="508" actId="14100"/>
          <ac:spMkLst>
            <pc:docMk/>
            <pc:sldMk cId="1997077850" sldId="279"/>
            <ac:spMk id="114" creationId="{1F05BE06-5426-114D-88A9-20E85CD03830}"/>
          </ac:spMkLst>
        </pc:spChg>
        <pc:spChg chg="mod">
          <ac:chgData name="Wencai Zhang" userId="4a86a1d0-2108-4707-8228-1110f3c1be85" providerId="ADAL" clId="{75BEC149-D62E-5D48-803F-577443322235}" dt="2022-04-20T16:00:59.126" v="672" actId="1076"/>
          <ac:spMkLst>
            <pc:docMk/>
            <pc:sldMk cId="1997077850" sldId="279"/>
            <ac:spMk id="120" creationId="{BED92353-28E4-4643-90D3-4560DD628D3F}"/>
          </ac:spMkLst>
        </pc:spChg>
        <pc:spChg chg="mod">
          <ac:chgData name="Wencai Zhang" userId="4a86a1d0-2108-4707-8228-1110f3c1be85" providerId="ADAL" clId="{75BEC149-D62E-5D48-803F-577443322235}" dt="2022-04-20T15:57:43.811" v="666" actId="1038"/>
          <ac:spMkLst>
            <pc:docMk/>
            <pc:sldMk cId="1997077850" sldId="279"/>
            <ac:spMk id="122" creationId="{0CC7DB87-FD1B-9A46-95DD-3CB778F2DEFB}"/>
          </ac:spMkLst>
        </pc:spChg>
        <pc:spChg chg="mod">
          <ac:chgData name="Wencai Zhang" userId="4a86a1d0-2108-4707-8228-1110f3c1be85" providerId="ADAL" clId="{75BEC149-D62E-5D48-803F-577443322235}" dt="2022-04-20T15:57:28.081" v="645" actId="1037"/>
          <ac:spMkLst>
            <pc:docMk/>
            <pc:sldMk cId="1997077850" sldId="279"/>
            <ac:spMk id="123" creationId="{F8879FD2-5F0B-ED4B-9872-81F5DD67350C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0" creationId="{4ACB04AC-6584-F145-ADEB-8DCE33FFED73}"/>
          </ac:spMkLst>
        </pc:spChg>
        <pc:spChg chg="mod">
          <ac:chgData name="Wencai Zhang" userId="4a86a1d0-2108-4707-8228-1110f3c1be85" providerId="ADAL" clId="{75BEC149-D62E-5D48-803F-577443322235}" dt="2022-04-20T15:56:16.790" v="555" actId="1037"/>
          <ac:spMkLst>
            <pc:docMk/>
            <pc:sldMk cId="1997077850" sldId="279"/>
            <ac:spMk id="161" creationId="{EE2F4E35-1C90-FC4B-A1EF-38D6074BBB14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2" creationId="{EA247580-D60C-CC44-AD96-F72D39815C41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3" creationId="{6492B21C-2371-A240-8008-081FEE14107E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6" creationId="{B6F5231E-3128-434A-B4BA-793D62577317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7" creationId="{A8F89C04-90D8-9440-B0F8-8FFCA9BFD855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8" creationId="{5C89201E-6609-654B-977D-63BA903881E0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69" creationId="{317683C1-D6CE-E746-BE57-2D817D93B423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198" creationId="{EF53831F-FAC6-B74D-9E68-DBBEA9D481FA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3" creationId="{1069A7EB-D519-314B-B073-8E217A616EB9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4" creationId="{7957ABCD-52EA-574E-8E5F-1847FF566FE1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5" creationId="{672C5019-AE7E-294E-9673-34EA7EC0E9D9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26" creationId="{A863BAE8-AA5D-E74A-B2AA-2B41B71E0322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32" creationId="{20C039F8-4FE6-4ED7-B690-81C56CA93C6B}"/>
          </ac:spMkLst>
        </pc:spChg>
        <pc:spChg chg="mod">
          <ac:chgData name="Wencai Zhang" userId="4a86a1d0-2108-4707-8228-1110f3c1be85" providerId="ADAL" clId="{75BEC149-D62E-5D48-803F-577443322235}" dt="2022-04-20T16:08:27.617" v="948" actId="1036"/>
          <ac:spMkLst>
            <pc:docMk/>
            <pc:sldMk cId="1997077850" sldId="279"/>
            <ac:spMk id="236" creationId="{D9FFA7F4-798C-4839-A861-E847F8726B1F}"/>
          </ac:spMkLst>
        </pc:spChg>
        <pc:spChg chg="mod">
          <ac:chgData name="Wencai Zhang" userId="4a86a1d0-2108-4707-8228-1110f3c1be85" providerId="ADAL" clId="{75BEC149-D62E-5D48-803F-577443322235}" dt="2022-04-20T15:56:53.782" v="605" actId="1035"/>
          <ac:spMkLst>
            <pc:docMk/>
            <pc:sldMk cId="1997077850" sldId="279"/>
            <ac:spMk id="239" creationId="{F4EF3E84-FACC-7341-9DCE-995B327369E3}"/>
          </ac:spMkLst>
        </pc:spChg>
        <pc:spChg chg="mod">
          <ac:chgData name="Wencai Zhang" userId="4a86a1d0-2108-4707-8228-1110f3c1be85" providerId="ADAL" clId="{75BEC149-D62E-5D48-803F-577443322235}" dt="2022-04-20T15:57:00.521" v="620" actId="1037"/>
          <ac:spMkLst>
            <pc:docMk/>
            <pc:sldMk cId="1997077850" sldId="279"/>
            <ac:spMk id="271" creationId="{A6AACC31-4535-E344-A881-01882F907DBE}"/>
          </ac:spMkLst>
        </pc:spChg>
        <pc:spChg chg="add mod">
          <ac:chgData name="Wencai Zhang" userId="4a86a1d0-2108-4707-8228-1110f3c1be85" providerId="ADAL" clId="{75BEC149-D62E-5D48-803F-577443322235}" dt="2022-04-20T16:05:47.757" v="899" actId="1038"/>
          <ac:spMkLst>
            <pc:docMk/>
            <pc:sldMk cId="1997077850" sldId="279"/>
            <ac:spMk id="279" creationId="{4FAF0AD1-0B87-2741-B8C2-3C91CF44A68D}"/>
          </ac:spMkLst>
        </pc:spChg>
        <pc:spChg chg="add mod">
          <ac:chgData name="Wencai Zhang" userId="4a86a1d0-2108-4707-8228-1110f3c1be85" providerId="ADAL" clId="{75BEC149-D62E-5D48-803F-577443322235}" dt="2022-04-20T16:03:18.164" v="818" actId="1036"/>
          <ac:spMkLst>
            <pc:docMk/>
            <pc:sldMk cId="1997077850" sldId="279"/>
            <ac:spMk id="282" creationId="{4547362A-9D9E-A243-845E-59670FE14E5B}"/>
          </ac:spMkLst>
        </pc:spChg>
        <pc:spChg chg="mod">
          <ac:chgData name="Wencai Zhang" userId="4a86a1d0-2108-4707-8228-1110f3c1be85" providerId="ADAL" clId="{75BEC149-D62E-5D48-803F-577443322235}" dt="2022-04-20T12:58:26.994" v="13" actId="1036"/>
          <ac:spMkLst>
            <pc:docMk/>
            <pc:sldMk cId="1997077850" sldId="279"/>
            <ac:spMk id="298" creationId="{F03955AB-400D-9A4B-9A39-F1F3CEA1FC01}"/>
          </ac:spMkLst>
        </pc:s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5" creationId="{DF93B195-F799-DC4D-9017-9227DFD88F27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8" creationId="{447B76B8-20C0-6D42-949E-E331C653DE5F}"/>
          </ac:grpSpMkLst>
        </pc:grpChg>
        <pc:grpChg chg="mod">
          <ac:chgData name="Wencai Zhang" userId="4a86a1d0-2108-4707-8228-1110f3c1be85" providerId="ADAL" clId="{75BEC149-D62E-5D48-803F-577443322235}" dt="2022-04-20T15:57:43.811" v="666" actId="1038"/>
          <ac:grpSpMkLst>
            <pc:docMk/>
            <pc:sldMk cId="1997077850" sldId="279"/>
            <ac:grpSpMk id="10" creationId="{1B523065-556E-D94A-B8C0-DB5FF1F9710E}"/>
          </ac:grpSpMkLst>
        </pc:grpChg>
        <pc:grpChg chg="mod">
          <ac:chgData name="Wencai Zhang" userId="4a86a1d0-2108-4707-8228-1110f3c1be85" providerId="ADAL" clId="{75BEC149-D62E-5D48-803F-577443322235}" dt="2022-04-20T15:57:37.190" v="656" actId="1037"/>
          <ac:grpSpMkLst>
            <pc:docMk/>
            <pc:sldMk cId="1997077850" sldId="279"/>
            <ac:grpSpMk id="11" creationId="{A976ED9E-9E74-114A-AC13-9E39131E6EBE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" creationId="{17D41CD5-132C-7D41-88B0-C32B45B35F78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" creationId="{195A3B47-E418-DC45-91B5-0D6EE931A316}"/>
          </ac:grpSpMkLst>
        </pc:grpChg>
        <pc:grpChg chg="add del mod">
          <ac:chgData name="Wencai Zhang" userId="4a86a1d0-2108-4707-8228-1110f3c1be85" providerId="ADAL" clId="{75BEC149-D62E-5D48-803F-577443322235}" dt="2022-04-20T16:01:13.252" v="674" actId="165"/>
          <ac:grpSpMkLst>
            <pc:docMk/>
            <pc:sldMk cId="1997077850" sldId="279"/>
            <ac:grpSpMk id="20" creationId="{2FEFF4FC-34EB-4C43-B75A-23BB0633B0F5}"/>
          </ac:grpSpMkLst>
        </pc:grpChg>
        <pc:grpChg chg="add mod">
          <ac:chgData name="Wencai Zhang" userId="4a86a1d0-2108-4707-8228-1110f3c1be85" providerId="ADAL" clId="{75BEC149-D62E-5D48-803F-577443322235}" dt="2022-04-20T16:05:04.647" v="851" actId="1035"/>
          <ac:grpSpMkLst>
            <pc:docMk/>
            <pc:sldMk cId="1997077850" sldId="279"/>
            <ac:grpSpMk id="22" creationId="{B05BB5C9-1699-684A-912A-702460E1570F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4" creationId="{89A7D3DD-3D93-A84C-B48A-23282A3DE11F}"/>
          </ac:grpSpMkLst>
        </pc:grpChg>
        <pc:grpChg chg="add mod">
          <ac:chgData name="Wencai Zhang" userId="4a86a1d0-2108-4707-8228-1110f3c1be85" providerId="ADAL" clId="{75BEC149-D62E-5D48-803F-577443322235}" dt="2022-04-20T16:05:24.543" v="853" actId="14100"/>
          <ac:grpSpMkLst>
            <pc:docMk/>
            <pc:sldMk cId="1997077850" sldId="279"/>
            <ac:grpSpMk id="25" creationId="{AD9A5DAE-FE9B-5549-B60C-71AA747CE4F0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6" creationId="{DC3A6F18-42A4-2648-9DE2-7817988EE9EB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55" creationId="{8CA149AD-4572-E64D-B4EA-7329D2DC2F84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0" creationId="{1F56A997-5B1D-0E42-8166-3B7495A9F80E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1" creationId="{A711D4DC-5BDA-6F4E-96ED-F10DF2924F64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2" creationId="{04F75B7C-4C5B-EC44-94F0-80A48FD8E8E3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3" creationId="{EB191E7E-12D3-6144-AD4E-5EB77CC64589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74" creationId="{4A64262C-29B0-0F4F-9F5D-2F04A33294A9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3" creationId="{2C962FB6-4588-664E-9502-4552389B770B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4" creationId="{7FEC941E-0C3D-F14C-8227-0EAEBFE4D084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5" creationId="{A80E09AE-7C92-484B-AD81-E52463D9452A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6" creationId="{3A6C2602-B4F6-9E4E-9ECF-CEE8F8F9D38C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197" creationId="{0D998B61-A34F-B04E-BF80-CC347A427353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63" creationId="{B947E33E-5CBB-0E48-875E-1E09E8D5987A}"/>
          </ac:grpSpMkLst>
        </pc:grpChg>
        <pc:grpChg chg="mod">
          <ac:chgData name="Wencai Zhang" userId="4a86a1d0-2108-4707-8228-1110f3c1be85" providerId="ADAL" clId="{75BEC149-D62E-5D48-803F-577443322235}" dt="2022-04-20T16:08:27.617" v="948" actId="1036"/>
          <ac:grpSpMkLst>
            <pc:docMk/>
            <pc:sldMk cId="1997077850" sldId="279"/>
            <ac:grpSpMk id="296" creationId="{CAC570FD-0345-7044-AB2C-8B2ACD0023B4}"/>
          </ac:grpSpMkLst>
        </pc:grpChg>
        <pc:graphicFrameChg chg="mod">
          <ac:chgData name="Wencai Zhang" userId="4a86a1d0-2108-4707-8228-1110f3c1be85" providerId="ADAL" clId="{75BEC149-D62E-5D48-803F-577443322235}" dt="2022-04-20T16:08:39.199" v="951" actId="1076"/>
          <ac:graphicFrameMkLst>
            <pc:docMk/>
            <pc:sldMk cId="1997077850" sldId="279"/>
            <ac:graphicFrameMk id="229" creationId="{745251DB-EA71-BA44-831D-D3584A8B4233}"/>
          </ac:graphicFrameMkLst>
        </pc:graphicFrameChg>
        <pc:graphicFrameChg chg="mod">
          <ac:chgData name="Wencai Zhang" userId="4a86a1d0-2108-4707-8228-1110f3c1be85" providerId="ADAL" clId="{75BEC149-D62E-5D48-803F-577443322235}" dt="2022-04-20T16:08:39.199" v="951" actId="1076"/>
          <ac:graphicFrameMkLst>
            <pc:docMk/>
            <pc:sldMk cId="1997077850" sldId="279"/>
            <ac:graphicFrameMk id="230" creationId="{822E918A-4287-9D40-8C4D-122E3AA50153}"/>
          </ac:graphicFrameMkLst>
        </pc:graphicFrameChg>
        <pc:graphicFrameChg chg="del mod">
          <ac:chgData name="Wencai Zhang" userId="4a86a1d0-2108-4707-8228-1110f3c1be85" providerId="ADAL" clId="{75BEC149-D62E-5D48-803F-577443322235}" dt="2022-04-20T13:04:02.065" v="50" actId="478"/>
          <ac:graphicFrameMkLst>
            <pc:docMk/>
            <pc:sldMk cId="1997077850" sldId="279"/>
            <ac:graphicFrameMk id="295" creationId="{FE607F22-4EC2-5348-95FB-D3D643439361}"/>
          </ac:graphicFrameMkLst>
        </pc:graphicFrame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12" creationId="{8D48EFAF-0B0B-614C-94DF-D55F672F6773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14" creationId="{64717BB5-8A3B-C847-9C0E-331DCF4393DE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15" creationId="{9CCBEE8A-65FE-7A4C-A5DE-75F4D2587227}"/>
          </ac:picMkLst>
        </pc:picChg>
        <pc:picChg chg="add del mod">
          <ac:chgData name="Wencai Zhang" userId="4a86a1d0-2108-4707-8228-1110f3c1be85" providerId="ADAL" clId="{75BEC149-D62E-5D48-803F-577443322235}" dt="2022-04-20T13:04:02.065" v="50" actId="478"/>
          <ac:picMkLst>
            <pc:docMk/>
            <pc:sldMk cId="1997077850" sldId="279"/>
            <ac:picMk id="20" creationId="{54E2F443-3902-E845-BEED-4B3EBF55A366}"/>
          </ac:picMkLst>
        </pc:picChg>
        <pc:picChg chg="add 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21" creationId="{8715F9B0-F678-A043-9E1D-272F3B299417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242" creationId="{0DADD5D4-55AF-5442-9E75-0AA5DDA4D1BA}"/>
          </ac:picMkLst>
        </pc:picChg>
        <pc:picChg chg="mod">
          <ac:chgData name="Wencai Zhang" userId="4a86a1d0-2108-4707-8228-1110f3c1be85" providerId="ADAL" clId="{75BEC149-D62E-5D48-803F-577443322235}" dt="2022-04-20T16:08:27.617" v="948" actId="1036"/>
          <ac:picMkLst>
            <pc:docMk/>
            <pc:sldMk cId="1997077850" sldId="279"/>
            <ac:picMk id="267" creationId="{6303280E-8560-614F-99A9-CD6BBF21DDF2}"/>
          </ac:picMkLst>
        </pc:picChg>
        <pc:picChg chg="add mod topLvl modCrop">
          <ac:chgData name="Wencai Zhang" userId="4a86a1d0-2108-4707-8228-1110f3c1be85" providerId="ADAL" clId="{75BEC149-D62E-5D48-803F-577443322235}" dt="2022-04-20T16:07:40.530" v="908" actId="1035"/>
          <ac:picMkLst>
            <pc:docMk/>
            <pc:sldMk cId="1997077850" sldId="279"/>
            <ac:picMk id="274" creationId="{2AC1D887-E705-F040-9201-64BA37DD995F}"/>
          </ac:picMkLst>
        </pc:picChg>
        <pc:picChg chg="add mod topLvl modCrop">
          <ac:chgData name="Wencai Zhang" userId="4a86a1d0-2108-4707-8228-1110f3c1be85" providerId="ADAL" clId="{75BEC149-D62E-5D48-803F-577443322235}" dt="2022-04-20T16:07:40.530" v="908" actId="1035"/>
          <ac:picMkLst>
            <pc:docMk/>
            <pc:sldMk cId="1997077850" sldId="279"/>
            <ac:picMk id="275" creationId="{D8545B0E-AEE1-A347-A2CA-B8939DE312F5}"/>
          </ac:picMkLst>
        </pc:picChg>
        <pc:picChg chg="add mod topLvl modCrop">
          <ac:chgData name="Wencai Zhang" userId="4a86a1d0-2108-4707-8228-1110f3c1be85" providerId="ADAL" clId="{75BEC149-D62E-5D48-803F-577443322235}" dt="2022-04-20T16:07:40.530" v="908" actId="1035"/>
          <ac:picMkLst>
            <pc:docMk/>
            <pc:sldMk cId="1997077850" sldId="279"/>
            <ac:picMk id="276" creationId="{8B12EB27-0162-C441-9156-300A7FACEC6F}"/>
          </ac:picMkLst>
        </pc:picChg>
        <pc:picChg chg="add mod topLvl">
          <ac:chgData name="Wencai Zhang" userId="4a86a1d0-2108-4707-8228-1110f3c1be85" providerId="ADAL" clId="{75BEC149-D62E-5D48-803F-577443322235}" dt="2022-04-20T16:01:15.619" v="675" actId="1076"/>
          <ac:picMkLst>
            <pc:docMk/>
            <pc:sldMk cId="1997077850" sldId="279"/>
            <ac:picMk id="277" creationId="{AEEF61E3-1190-5647-B769-EF2B53660EA3}"/>
          </ac:picMkLst>
        </pc:picChg>
        <pc:picChg chg="add mod">
          <ac:chgData name="Wencai Zhang" userId="4a86a1d0-2108-4707-8228-1110f3c1be85" providerId="ADAL" clId="{75BEC149-D62E-5D48-803F-577443322235}" dt="2022-04-20T16:06:46.229" v="903" actId="14100"/>
          <ac:picMkLst>
            <pc:docMk/>
            <pc:sldMk cId="1997077850" sldId="279"/>
            <ac:picMk id="278" creationId="{183201BA-0C87-D44D-9CDD-4EB7065A07D8}"/>
          </ac:picMkLst>
        </pc:picChg>
        <pc:picChg chg="mod modCrop">
          <ac:chgData name="Wencai Zhang" userId="4a86a1d0-2108-4707-8228-1110f3c1be85" providerId="ADAL" clId="{75BEC149-D62E-5D48-803F-577443322235}" dt="2022-04-20T13:09:19.215" v="51" actId="732"/>
          <ac:picMkLst>
            <pc:docMk/>
            <pc:sldMk cId="1997077850" sldId="279"/>
            <ac:picMk id="297" creationId="{D0C8E8CB-5A29-2049-96C9-DEBBDB50A062}"/>
          </ac:picMkLst>
        </pc:picChg>
        <pc:cxnChg chg="add mod">
          <ac:chgData name="Wencai Zhang" userId="4a86a1d0-2108-4707-8228-1110f3c1be85" providerId="ADAL" clId="{75BEC149-D62E-5D48-803F-577443322235}" dt="2022-04-20T16:07:21.661" v="905" actId="14100"/>
          <ac:cxnSpMkLst>
            <pc:docMk/>
            <pc:sldMk cId="1997077850" sldId="279"/>
            <ac:cxnSpMk id="280" creationId="{D2268898-2518-4747-B752-EED283A18727}"/>
          </ac:cxnSpMkLst>
        </pc:cxnChg>
        <pc:cxnChg chg="add mod">
          <ac:chgData name="Wencai Zhang" userId="4a86a1d0-2108-4707-8228-1110f3c1be85" providerId="ADAL" clId="{75BEC149-D62E-5D48-803F-577443322235}" dt="2022-04-20T16:06:28.600" v="900" actId="14100"/>
          <ac:cxnSpMkLst>
            <pc:docMk/>
            <pc:sldMk cId="1997077850" sldId="279"/>
            <ac:cxnSpMk id="281" creationId="{F6EC7CA5-DC14-8B4D-8FCE-D07269FB5F75}"/>
          </ac:cxnSpMkLst>
        </pc:cxnChg>
      </pc:sldChg>
      <pc:sldChg chg="addSp modSp">
        <pc:chgData name="Wencai Zhang" userId="4a86a1d0-2108-4707-8228-1110f3c1be85" providerId="ADAL" clId="{75BEC149-D62E-5D48-803F-577443322235}" dt="2022-04-21T16:33:37.757" v="1372" actId="1076"/>
        <pc:sldMkLst>
          <pc:docMk/>
          <pc:sldMk cId="1043719466" sldId="281"/>
        </pc:sldMkLst>
        <pc:spChg chg="add mod">
          <ac:chgData name="Wencai Zhang" userId="4a86a1d0-2108-4707-8228-1110f3c1be85" providerId="ADAL" clId="{75BEC149-D62E-5D48-803F-577443322235}" dt="2022-04-21T16:33:37.757" v="1372" actId="1076"/>
          <ac:spMkLst>
            <pc:docMk/>
            <pc:sldMk cId="1043719466" sldId="281"/>
            <ac:spMk id="2" creationId="{51F54C20-E8DC-D04F-BBA3-37DC2057E256}"/>
          </ac:spMkLst>
        </pc:spChg>
        <pc:spChg chg="mod">
          <ac:chgData name="Wencai Zhang" userId="4a86a1d0-2108-4707-8228-1110f3c1be85" providerId="ADAL" clId="{75BEC149-D62E-5D48-803F-577443322235}" dt="2022-04-21T16:15:24.410" v="954" actId="20577"/>
          <ac:spMkLst>
            <pc:docMk/>
            <pc:sldMk cId="1043719466" sldId="281"/>
            <ac:spMk id="5" creationId="{A61503D3-A798-A843-99DC-C0890B8EB90D}"/>
          </ac:spMkLst>
        </pc:spChg>
        <pc:grpChg chg="mod">
          <ac:chgData name="Wencai Zhang" userId="4a86a1d0-2108-4707-8228-1110f3c1be85" providerId="ADAL" clId="{75BEC149-D62E-5D48-803F-577443322235}" dt="2022-04-21T16:33:30.717" v="1371" actId="1038"/>
          <ac:grpSpMkLst>
            <pc:docMk/>
            <pc:sldMk cId="1043719466" sldId="281"/>
            <ac:grpSpMk id="3" creationId="{8D389290-6337-6040-8C38-CCDA20CAB5A5}"/>
          </ac:grpSpMkLst>
        </pc:grpChg>
      </pc:sldChg>
      <pc:sldChg chg="addSp delSp modSp ord">
        <pc:chgData name="Wencai Zhang" userId="4a86a1d0-2108-4707-8228-1110f3c1be85" providerId="ADAL" clId="{75BEC149-D62E-5D48-803F-577443322235}" dt="2022-04-21T16:33:15.662" v="1350" actId="404"/>
        <pc:sldMkLst>
          <pc:docMk/>
          <pc:sldMk cId="4133689721" sldId="291"/>
        </pc:sldMkLst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2" creationId="{531A11DB-C16A-474F-B52F-315BD512D038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3" creationId="{0E974834-8482-4440-809E-90B06CCA30F4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" creationId="{02092AE9-CFD4-4AC6-A393-F3990B5343F2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" creationId="{89E84565-00A9-4750-B41B-2E8C35E6E19E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7" creationId="{28103BD3-1973-4A86-86AF-E873CD0F2C5B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" creationId="{8F2B740F-1420-4373-B1FC-3589A02F06D8}"/>
          </ac:spMkLst>
        </pc:spChg>
        <pc:spChg chg="add mod">
          <ac:chgData name="Wencai Zhang" userId="4a86a1d0-2108-4707-8228-1110f3c1be85" providerId="ADAL" clId="{75BEC149-D62E-5D48-803F-577443322235}" dt="2022-04-21T16:33:15.662" v="1350" actId="404"/>
          <ac:spMkLst>
            <pc:docMk/>
            <pc:sldMk cId="4133689721" sldId="291"/>
            <ac:spMk id="17" creationId="{649CC280-8498-5F47-A7C8-A30278508115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22" creationId="{4FBC6A88-627F-407D-A159-D386F6F67CF7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31" creationId="{FA424362-9542-421D-95CE-97EF263215FD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3" creationId="{2AA9094F-D7AB-4950-B7FC-5E87D4F75296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4" creationId="{1620750B-9206-4AD3-BA74-C9087006A6EA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45" creationId="{17320253-C946-43AF-9A81-5DE075E93EE8}"/>
          </ac:spMkLst>
        </pc:spChg>
        <pc:spChg chg="add mod">
          <ac:chgData name="Wencai Zhang" userId="4a86a1d0-2108-4707-8228-1110f3c1be85" providerId="ADAL" clId="{75BEC149-D62E-5D48-803F-577443322235}" dt="2022-04-21T16:18:08.566" v="1013" actId="1038"/>
          <ac:spMkLst>
            <pc:docMk/>
            <pc:sldMk cId="4133689721" sldId="291"/>
            <ac:spMk id="49" creationId="{393B87F7-0301-414F-A165-54A34714662C}"/>
          </ac:spMkLst>
        </pc:spChg>
        <pc:spChg chg="add del">
          <ac:chgData name="Wencai Zhang" userId="4a86a1d0-2108-4707-8228-1110f3c1be85" providerId="ADAL" clId="{75BEC149-D62E-5D48-803F-577443322235}" dt="2022-04-21T16:17:00.622" v="967" actId="478"/>
          <ac:spMkLst>
            <pc:docMk/>
            <pc:sldMk cId="4133689721" sldId="291"/>
            <ac:spMk id="51" creationId="{AC22F8E3-9474-E444-9E07-F4A41EE98A8F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52" creationId="{378F9693-E488-4D49-906F-28E2A437446B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53" creationId="{3D350C17-0DE6-ED4E-9BFC-456C406D86E0}"/>
          </ac:spMkLst>
        </pc:spChg>
        <pc:spChg chg="add del mod">
          <ac:chgData name="Wencai Zhang" userId="4a86a1d0-2108-4707-8228-1110f3c1be85" providerId="ADAL" clId="{75BEC149-D62E-5D48-803F-577443322235}" dt="2022-04-21T16:18:28.358" v="1017" actId="478"/>
          <ac:spMkLst>
            <pc:docMk/>
            <pc:sldMk cId="4133689721" sldId="291"/>
            <ac:spMk id="56" creationId="{BAD38B82-6C0D-5946-ACD1-8E7334FB132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57" creationId="{92B9BF22-2E03-4145-A99C-E336F9301AF2}"/>
          </ac:spMkLst>
        </pc:spChg>
        <pc:spChg chg="add del mod">
          <ac:chgData name="Wencai Zhang" userId="4a86a1d0-2108-4707-8228-1110f3c1be85" providerId="ADAL" clId="{75BEC149-D62E-5D48-803F-577443322235}" dt="2022-04-21T16:18:30.788" v="1018" actId="478"/>
          <ac:spMkLst>
            <pc:docMk/>
            <pc:sldMk cId="4133689721" sldId="291"/>
            <ac:spMk id="60" creationId="{7DB02D82-89CB-3B4E-83A3-4B2FEF97946E}"/>
          </ac:spMkLst>
        </pc:spChg>
        <pc:spChg chg="add del mod">
          <ac:chgData name="Wencai Zhang" userId="4a86a1d0-2108-4707-8228-1110f3c1be85" providerId="ADAL" clId="{75BEC149-D62E-5D48-803F-577443322235}" dt="2022-04-21T16:18:32.981" v="1019" actId="478"/>
          <ac:spMkLst>
            <pc:docMk/>
            <pc:sldMk cId="4133689721" sldId="291"/>
            <ac:spMk id="61" creationId="{6F21CF5D-3101-1B48-A2C8-C64C72C96AE0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2" creationId="{69BD8DC7-A18D-5B46-B8C1-820DC41A18B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3" creationId="{28602894-AD05-D145-B42A-02830051BA05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64" creationId="{F0288BB7-CE51-E145-B29B-E4BAB1981314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71" creationId="{B374758E-F00A-4241-BB9E-0D85038713F6}"/>
          </ac:spMkLst>
        </pc:spChg>
        <pc:spChg chg="add del mod">
          <ac:chgData name="Wencai Zhang" userId="4a86a1d0-2108-4707-8228-1110f3c1be85" providerId="ADAL" clId="{75BEC149-D62E-5D48-803F-577443322235}" dt="2022-04-21T16:18:18.559" v="1016" actId="478"/>
          <ac:spMkLst>
            <pc:docMk/>
            <pc:sldMk cId="4133689721" sldId="291"/>
            <ac:spMk id="72" creationId="{635454D2-320D-E341-ADB8-64B39EEB7462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73" creationId="{3E74BA67-9FF1-C74A-BAED-15E8E85EC296}"/>
          </ac:spMkLst>
        </pc:spChg>
        <pc:spChg chg="add mod">
          <ac:chgData name="Wencai Zhang" userId="4a86a1d0-2108-4707-8228-1110f3c1be85" providerId="ADAL" clId="{75BEC149-D62E-5D48-803F-577443322235}" dt="2022-04-21T16:23:23.288" v="1143" actId="1035"/>
          <ac:spMkLst>
            <pc:docMk/>
            <pc:sldMk cId="4133689721" sldId="291"/>
            <ac:spMk id="76" creationId="{C45111EC-F0A0-5943-96E4-09196A7F17DF}"/>
          </ac:spMkLst>
        </pc:spChg>
        <pc:spChg chg="add del mod">
          <ac:chgData name="Wencai Zhang" userId="4a86a1d0-2108-4707-8228-1110f3c1be85" providerId="ADAL" clId="{75BEC149-D62E-5D48-803F-577443322235}" dt="2022-04-21T16:20:52.797" v="1104" actId="478"/>
          <ac:spMkLst>
            <pc:docMk/>
            <pc:sldMk cId="4133689721" sldId="291"/>
            <ac:spMk id="77" creationId="{59A090A3-926C-AC41-B4F4-9F2707145011}"/>
          </ac:spMkLst>
        </pc:spChg>
        <pc:spChg chg="add del mod">
          <ac:chgData name="Wencai Zhang" userId="4a86a1d0-2108-4707-8228-1110f3c1be85" providerId="ADAL" clId="{75BEC149-D62E-5D48-803F-577443322235}" dt="2022-04-21T16:20:56.115" v="1105" actId="478"/>
          <ac:spMkLst>
            <pc:docMk/>
            <pc:sldMk cId="4133689721" sldId="291"/>
            <ac:spMk id="80" creationId="{2C460154-E099-4948-8ED3-025D808F46AE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2" creationId="{64CE77AD-5AE7-486C-BB91-85E1CD16181D}"/>
          </ac:spMkLst>
        </pc:spChg>
        <pc:spChg chg="add del mod">
          <ac:chgData name="Wencai Zhang" userId="4a86a1d0-2108-4707-8228-1110f3c1be85" providerId="ADAL" clId="{75BEC149-D62E-5D48-803F-577443322235}" dt="2022-04-21T16:20:56.115" v="1105" actId="478"/>
          <ac:spMkLst>
            <pc:docMk/>
            <pc:sldMk cId="4133689721" sldId="291"/>
            <ac:spMk id="83" creationId="{27CA199B-8309-1743-810E-D6E667A19383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6" creationId="{B022141C-481D-AE4E-86E8-2C9267D0615B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7" creationId="{10943836-76F0-4359-8724-99CA9881139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8" creationId="{BED3237E-EB4F-D348-892F-02F34EDC01FD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89" creationId="{0AA3302E-C0BD-6B44-83DC-1ED06F5AB55C}"/>
          </ac:spMkLst>
        </pc:spChg>
        <pc:spChg chg="del">
          <ac:chgData name="Wencai Zhang" userId="4a86a1d0-2108-4707-8228-1110f3c1be85" providerId="ADAL" clId="{75BEC149-D62E-5D48-803F-577443322235}" dt="2022-04-21T16:22:47.694" v="1121" actId="478"/>
          <ac:spMkLst>
            <pc:docMk/>
            <pc:sldMk cId="4133689721" sldId="291"/>
            <ac:spMk id="91" creationId="{4F8124EB-DC63-0943-954B-D6F7CD64EC44}"/>
          </ac:spMkLst>
        </pc:spChg>
        <pc:spChg chg="del">
          <ac:chgData name="Wencai Zhang" userId="4a86a1d0-2108-4707-8228-1110f3c1be85" providerId="ADAL" clId="{75BEC149-D62E-5D48-803F-577443322235}" dt="2022-04-21T16:22:45.488" v="1120" actId="478"/>
          <ac:spMkLst>
            <pc:docMk/>
            <pc:sldMk cId="4133689721" sldId="291"/>
            <ac:spMk id="92" creationId="{B592F8F7-E08D-C745-81AB-5FA584CCFCFB}"/>
          </ac:spMkLst>
        </pc:spChg>
        <pc:spChg chg="mod">
          <ac:chgData name="Wencai Zhang" userId="4a86a1d0-2108-4707-8228-1110f3c1be85" providerId="ADAL" clId="{75BEC149-D62E-5D48-803F-577443322235}" dt="2022-04-21T16:23:12.781" v="1128" actId="20577"/>
          <ac:spMkLst>
            <pc:docMk/>
            <pc:sldMk cId="4133689721" sldId="291"/>
            <ac:spMk id="93" creationId="{03B3531F-F26C-5147-A1C0-6A669DE2D705}"/>
          </ac:spMkLst>
        </pc:spChg>
        <pc:spChg chg="add mod">
          <ac:chgData name="Wencai Zhang" userId="4a86a1d0-2108-4707-8228-1110f3c1be85" providerId="ADAL" clId="{75BEC149-D62E-5D48-803F-577443322235}" dt="2022-04-21T16:18:12.427" v="1015" actId="20577"/>
          <ac:spMkLst>
            <pc:docMk/>
            <pc:sldMk cId="4133689721" sldId="291"/>
            <ac:spMk id="96" creationId="{936DBA25-C5B8-5C48-ABC1-72428939BDAD}"/>
          </ac:spMkLst>
        </pc:spChg>
        <pc:spChg chg="add del mod">
          <ac:chgData name="Wencai Zhang" userId="4a86a1d0-2108-4707-8228-1110f3c1be85" providerId="ADAL" clId="{75BEC149-D62E-5D48-803F-577443322235}" dt="2022-04-21T16:18:18.559" v="1016" actId="478"/>
          <ac:spMkLst>
            <pc:docMk/>
            <pc:sldMk cId="4133689721" sldId="291"/>
            <ac:spMk id="97" creationId="{09122A5D-7D81-854B-B131-092BD76FD18D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98" creationId="{E64C069D-59EA-B54F-BEC8-16B484C87FCA}"/>
          </ac:spMkLst>
        </pc:spChg>
        <pc:spChg chg="add del mod">
          <ac:chgData name="Wencai Zhang" userId="4a86a1d0-2108-4707-8228-1110f3c1be85" providerId="ADAL" clId="{75BEC149-D62E-5D48-803F-577443322235}" dt="2022-04-21T16:21:31.823" v="1109" actId="478"/>
          <ac:spMkLst>
            <pc:docMk/>
            <pc:sldMk cId="4133689721" sldId="291"/>
            <ac:spMk id="101" creationId="{6E53FE6E-7405-3444-9B9A-465EB676765D}"/>
          </ac:spMkLst>
        </pc:spChg>
        <pc:spChg chg="add del mod">
          <ac:chgData name="Wencai Zhang" userId="4a86a1d0-2108-4707-8228-1110f3c1be85" providerId="ADAL" clId="{75BEC149-D62E-5D48-803F-577443322235}" dt="2022-04-21T16:21:29.495" v="1108" actId="478"/>
          <ac:spMkLst>
            <pc:docMk/>
            <pc:sldMk cId="4133689721" sldId="291"/>
            <ac:spMk id="102" creationId="{EA8C38D1-3246-7A4D-9AFF-1F5577AC3595}"/>
          </ac:spMkLst>
        </pc:spChg>
        <pc:spChg chg="add mod">
          <ac:chgData name="Wencai Zhang" userId="4a86a1d0-2108-4707-8228-1110f3c1be85" providerId="ADAL" clId="{75BEC149-D62E-5D48-803F-577443322235}" dt="2022-04-21T16:25:44.714" v="1183" actId="1076"/>
          <ac:spMkLst>
            <pc:docMk/>
            <pc:sldMk cId="4133689721" sldId="291"/>
            <ac:spMk id="105" creationId="{87CA0DA1-7C85-1E43-BB31-4F7DFF1B556A}"/>
          </ac:spMkLst>
        </pc:spChg>
        <pc:spChg chg="add del mod">
          <ac:chgData name="Wencai Zhang" userId="4a86a1d0-2108-4707-8228-1110f3c1be85" providerId="ADAL" clId="{75BEC149-D62E-5D48-803F-577443322235}" dt="2022-04-21T16:21:34.501" v="1110" actId="478"/>
          <ac:spMkLst>
            <pc:docMk/>
            <pc:sldMk cId="4133689721" sldId="291"/>
            <ac:spMk id="106" creationId="{3239AC24-CF8E-7641-8736-BBDB14C6F7A4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07" creationId="{F393D83C-06E7-C24C-B7C7-1FC995136C1C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08" creationId="{33C4E2A0-AB1C-BD4B-AD9D-7818CF0169CD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09" creationId="{F54ED270-1D3C-C340-8A9C-A148C0FAD655}"/>
          </ac:spMkLst>
        </pc:spChg>
        <pc:spChg chg="add mod">
          <ac:chgData name="Wencai Zhang" userId="4a86a1d0-2108-4707-8228-1110f3c1be85" providerId="ADAL" clId="{75BEC149-D62E-5D48-803F-577443322235}" dt="2022-04-21T16:28:36.557" v="1336" actId="20577"/>
          <ac:spMkLst>
            <pc:docMk/>
            <pc:sldMk cId="4133689721" sldId="291"/>
            <ac:spMk id="116" creationId="{CA1A6BA0-F60B-C946-B5C2-0DB8667822B9}"/>
          </ac:spMkLst>
        </pc:spChg>
        <pc:spChg chg="add del mod">
          <ac:chgData name="Wencai Zhang" userId="4a86a1d0-2108-4707-8228-1110f3c1be85" providerId="ADAL" clId="{75BEC149-D62E-5D48-803F-577443322235}" dt="2022-04-21T16:18:18.559" v="1016" actId="478"/>
          <ac:spMkLst>
            <pc:docMk/>
            <pc:sldMk cId="4133689721" sldId="291"/>
            <ac:spMk id="117" creationId="{C849E0B0-E553-A842-A4DF-A08A508A8A88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18" creationId="{F56F3AC5-7BED-D649-88B1-AC6C8F24AF83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1" creationId="{D6CB511F-139C-41D4-8250-3CE8C1C529A2}"/>
          </ac:spMkLst>
        </pc:spChg>
        <pc:spChg chg="add del mod">
          <ac:chgData name="Wencai Zhang" userId="4a86a1d0-2108-4707-8228-1110f3c1be85" providerId="ADAL" clId="{75BEC149-D62E-5D48-803F-577443322235}" dt="2022-04-21T16:23:47.544" v="1144" actId="478"/>
          <ac:spMkLst>
            <pc:docMk/>
            <pc:sldMk cId="4133689721" sldId="291"/>
            <ac:spMk id="122" creationId="{81CDAF04-5B73-7045-9BFD-E499B56DE643}"/>
          </ac:spMkLst>
        </pc:spChg>
        <pc:spChg chg="add del mod">
          <ac:chgData name="Wencai Zhang" userId="4a86a1d0-2108-4707-8228-1110f3c1be85" providerId="ADAL" clId="{75BEC149-D62E-5D48-803F-577443322235}" dt="2022-04-21T16:23:47.544" v="1144" actId="478"/>
          <ac:spMkLst>
            <pc:docMk/>
            <pc:sldMk cId="4133689721" sldId="291"/>
            <ac:spMk id="123" creationId="{251598AB-CD01-8043-8947-8F45FF59C895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4" creationId="{9DD241D0-FA5A-46DA-805C-C56E7116101A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5" creationId="{5949CED8-518B-4502-9EFE-E1900364B0C4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7" creationId="{855AF6B0-3ACF-44FA-9737-1415FC3FF6CF}"/>
          </ac:spMkLst>
        </pc:spChg>
        <pc:spChg chg="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28" creationId="{E1E6E364-D220-4501-AFB7-E5A4AE205604}"/>
          </ac:spMkLst>
        </pc:spChg>
        <pc:spChg chg="add del mod">
          <ac:chgData name="Wencai Zhang" userId="4a86a1d0-2108-4707-8228-1110f3c1be85" providerId="ADAL" clId="{75BEC149-D62E-5D48-803F-577443322235}" dt="2022-04-21T16:23:47.544" v="1144" actId="478"/>
          <ac:spMkLst>
            <pc:docMk/>
            <pc:sldMk cId="4133689721" sldId="291"/>
            <ac:spMk id="130" creationId="{8C516AEE-52FB-524B-A211-837D6D817905}"/>
          </ac:spMkLst>
        </pc:spChg>
        <pc:spChg chg="add mod">
          <ac:chgData name="Wencai Zhang" userId="4a86a1d0-2108-4707-8228-1110f3c1be85" providerId="ADAL" clId="{75BEC149-D62E-5D48-803F-577443322235}" dt="2022-04-21T16:27:55.677" v="1291" actId="1076"/>
          <ac:spMkLst>
            <pc:docMk/>
            <pc:sldMk cId="4133689721" sldId="291"/>
            <ac:spMk id="131" creationId="{69FF5C3B-B7EA-D64A-8ADB-24EA315DDE63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32" creationId="{BBC77043-615E-044C-B621-BE7E0519A1FB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33" creationId="{2AC73E87-EFB3-9941-93B7-33BD189F296C}"/>
          </ac:spMkLst>
        </pc:spChg>
        <pc:spChg chg="add mod">
          <ac:chgData name="Wencai Zhang" userId="4a86a1d0-2108-4707-8228-1110f3c1be85" providerId="ADAL" clId="{75BEC149-D62E-5D48-803F-577443322235}" dt="2022-04-21T16:18:02.458" v="998" actId="1036"/>
          <ac:spMkLst>
            <pc:docMk/>
            <pc:sldMk cId="4133689721" sldId="291"/>
            <ac:spMk id="134" creationId="{A53A9AE6-32BE-0D47-ACCD-EA61CFD330CB}"/>
          </ac:spMkLst>
        </pc:spChg>
        <pc:spChg chg="del">
          <ac:chgData name="Wencai Zhang" userId="4a86a1d0-2108-4707-8228-1110f3c1be85" providerId="ADAL" clId="{75BEC149-D62E-5D48-803F-577443322235}" dt="2022-04-21T16:25:15.868" v="1180" actId="478"/>
          <ac:spMkLst>
            <pc:docMk/>
            <pc:sldMk cId="4133689721" sldId="291"/>
            <ac:spMk id="136" creationId="{349659D6-718A-054D-9FC0-EB95578C5BA0}"/>
          </ac:spMkLst>
        </pc:spChg>
        <pc:spChg chg="mod">
          <ac:chgData name="Wencai Zhang" userId="4a86a1d0-2108-4707-8228-1110f3c1be85" providerId="ADAL" clId="{75BEC149-D62E-5D48-803F-577443322235}" dt="2022-04-21T16:28:10.013" v="1312" actId="1035"/>
          <ac:spMkLst>
            <pc:docMk/>
            <pc:sldMk cId="4133689721" sldId="291"/>
            <ac:spMk id="137" creationId="{C4CB0108-C5DC-3C4D-960E-73BC6432429E}"/>
          </ac:spMkLst>
        </pc:spChg>
        <pc:spChg chg="mod">
          <ac:chgData name="Wencai Zhang" userId="4a86a1d0-2108-4707-8228-1110f3c1be85" providerId="ADAL" clId="{75BEC149-D62E-5D48-803F-577443322235}" dt="2022-04-21T16:24:51.410" v="1172" actId="20577"/>
          <ac:spMkLst>
            <pc:docMk/>
            <pc:sldMk cId="4133689721" sldId="291"/>
            <ac:spMk id="138" creationId="{B7272C36-7D6E-0946-8B38-C94FB17B7FD8}"/>
          </ac:spMkLst>
        </pc:spChg>
        <pc:spChg chg="del">
          <ac:chgData name="Wencai Zhang" userId="4a86a1d0-2108-4707-8228-1110f3c1be85" providerId="ADAL" clId="{75BEC149-D62E-5D48-803F-577443322235}" dt="2022-04-21T16:24:54.076" v="1173" actId="478"/>
          <ac:spMkLst>
            <pc:docMk/>
            <pc:sldMk cId="4133689721" sldId="291"/>
            <ac:spMk id="139" creationId="{62D16248-CE88-914B-8C9B-BD90DBB6C089}"/>
          </ac:spMkLst>
        </pc:spChg>
        <pc:spChg chg="add mod">
          <ac:chgData name="Wencai Zhang" userId="4a86a1d0-2108-4707-8228-1110f3c1be85" providerId="ADAL" clId="{75BEC149-D62E-5D48-803F-577443322235}" dt="2022-04-21T16:28:40.158" v="1338" actId="20577"/>
          <ac:spMkLst>
            <pc:docMk/>
            <pc:sldMk cId="4133689721" sldId="291"/>
            <ac:spMk id="141" creationId="{9BEAAF36-C230-344B-ADE6-EF4D247BFDA5}"/>
          </ac:spMkLst>
        </pc:spChg>
        <pc:spChg chg="del">
          <ac:chgData name="Wencai Zhang" userId="4a86a1d0-2108-4707-8228-1110f3c1be85" providerId="ADAL" clId="{75BEC149-D62E-5D48-803F-577443322235}" dt="2022-04-21T16:22:24.642" v="1115" actId="478"/>
          <ac:spMkLst>
            <pc:docMk/>
            <pc:sldMk cId="4133689721" sldId="291"/>
            <ac:spMk id="143" creationId="{BB025291-D742-6A4D-9DCE-ECF1432E4919}"/>
          </ac:spMkLst>
        </pc:spChg>
        <pc:spChg chg="del">
          <ac:chgData name="Wencai Zhang" userId="4a86a1d0-2108-4707-8228-1110f3c1be85" providerId="ADAL" clId="{75BEC149-D62E-5D48-803F-577443322235}" dt="2022-04-21T16:22:22.021" v="1114" actId="478"/>
          <ac:spMkLst>
            <pc:docMk/>
            <pc:sldMk cId="4133689721" sldId="291"/>
            <ac:spMk id="144" creationId="{F0DC5620-A566-DB4B-8C85-6378CC84EEB9}"/>
          </ac:spMkLst>
        </pc:spChg>
        <pc:spChg chg="mod">
          <ac:chgData name="Wencai Zhang" userId="4a86a1d0-2108-4707-8228-1110f3c1be85" providerId="ADAL" clId="{75BEC149-D62E-5D48-803F-577443322235}" dt="2022-04-21T16:22:29.930" v="1119" actId="20577"/>
          <ac:spMkLst>
            <pc:docMk/>
            <pc:sldMk cId="4133689721" sldId="291"/>
            <ac:spMk id="145" creationId="{B11FF997-995C-8049-B29F-5007AD6A2341}"/>
          </ac:spMkLst>
        </pc:spChg>
        <pc:spChg chg="mod">
          <ac:chgData name="Wencai Zhang" userId="4a86a1d0-2108-4707-8228-1110f3c1be85" providerId="ADAL" clId="{75BEC149-D62E-5D48-803F-577443322235}" dt="2022-04-21T16:28:19.237" v="1332" actId="1035"/>
          <ac:spMkLst>
            <pc:docMk/>
            <pc:sldMk cId="4133689721" sldId="291"/>
            <ac:spMk id="149" creationId="{3179D4E1-86DC-BB47-91C9-37E8A02E3E47}"/>
          </ac:spMkLst>
        </pc:s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0" creationId="{5FFDB581-28EA-4CF8-9D80-C21FAA8AD78B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1" creationId="{9B6EA788-4148-4A0F-B9B5-A47882718B60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2" creationId="{3AF54EC6-A750-467B-91D8-C4F39AB6EC99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3" creationId="{EFFB9AEE-3FB8-499F-8081-641918985D0B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14" creationId="{D5F7F827-893F-4BC5-B898-F40FAFF99A29}"/>
          </ac:grpSpMkLst>
        </pc:grpChg>
        <pc:grpChg chg="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36" creationId="{00308009-BF9B-40C1-BBA6-2AF3C82A16A4}"/>
          </ac:grpSpMkLst>
        </pc:grpChg>
        <pc:grpChg chg="add del mod">
          <ac:chgData name="Wencai Zhang" userId="4a86a1d0-2108-4707-8228-1110f3c1be85" providerId="ADAL" clId="{75BEC149-D62E-5D48-803F-577443322235}" dt="2022-04-21T16:18:28.358" v="1017" actId="478"/>
          <ac:grpSpMkLst>
            <pc:docMk/>
            <pc:sldMk cId="4133689721" sldId="291"/>
            <ac:grpSpMk id="65" creationId="{6DA5C719-7DEF-C644-87A5-1817CE5DFEC7}"/>
          </ac:grpSpMkLst>
        </pc:grpChg>
        <pc:grpChg chg="add mod">
          <ac:chgData name="Wencai Zhang" userId="4a86a1d0-2108-4707-8228-1110f3c1be85" providerId="ADAL" clId="{75BEC149-D62E-5D48-803F-577443322235}" dt="2022-04-21T16:18:02.458" v="998" actId="1036"/>
          <ac:grpSpMkLst>
            <pc:docMk/>
            <pc:sldMk cId="4133689721" sldId="291"/>
            <ac:grpSpMk id="90" creationId="{AA12D019-BE12-0240-B0DD-1AAAD8EA483F}"/>
          </ac:grpSpMkLst>
        </pc:grpChg>
        <pc:grpChg chg="add del mod">
          <ac:chgData name="Wencai Zhang" userId="4a86a1d0-2108-4707-8228-1110f3c1be85" providerId="ADAL" clId="{75BEC149-D62E-5D48-803F-577443322235}" dt="2022-04-21T16:26:26.507" v="1186" actId="478"/>
          <ac:grpSpMkLst>
            <pc:docMk/>
            <pc:sldMk cId="4133689721" sldId="291"/>
            <ac:grpSpMk id="110" creationId="{292A0049-D379-9744-B840-6541FAFA6FF4}"/>
          </ac:grpSpMkLst>
        </pc:grpChg>
        <pc:grpChg chg="add mod">
          <ac:chgData name="Wencai Zhang" userId="4a86a1d0-2108-4707-8228-1110f3c1be85" providerId="ADAL" clId="{75BEC149-D62E-5D48-803F-577443322235}" dt="2022-04-21T16:27:23.799" v="1288" actId="1035"/>
          <ac:grpSpMkLst>
            <pc:docMk/>
            <pc:sldMk cId="4133689721" sldId="291"/>
            <ac:grpSpMk id="135" creationId="{7BFB725C-F2E7-974C-8C72-BBC0B2BFE55A}"/>
          </ac:grpSpMkLst>
        </pc:grpChg>
        <pc:grpChg chg="add mod">
          <ac:chgData name="Wencai Zhang" userId="4a86a1d0-2108-4707-8228-1110f3c1be85" providerId="ADAL" clId="{75BEC149-D62E-5D48-803F-577443322235}" dt="2022-04-21T16:20:00.832" v="1101" actId="1037"/>
          <ac:grpSpMkLst>
            <pc:docMk/>
            <pc:sldMk cId="4133689721" sldId="291"/>
            <ac:grpSpMk id="142" creationId="{D2C00862-C2DF-724F-9111-6676E2CF585A}"/>
          </ac:grpSpMkLst>
        </pc:grpChg>
        <pc:grpChg chg="add mod">
          <ac:chgData name="Wencai Zhang" userId="4a86a1d0-2108-4707-8228-1110f3c1be85" providerId="ADAL" clId="{75BEC149-D62E-5D48-803F-577443322235}" dt="2022-04-21T16:27:23.799" v="1288" actId="1035"/>
          <ac:grpSpMkLst>
            <pc:docMk/>
            <pc:sldMk cId="4133689721" sldId="291"/>
            <ac:grpSpMk id="148" creationId="{00FC342B-ADB8-C648-A8B2-C8ECB8FAB7F2}"/>
          </ac:grpSpMkLst>
        </pc:grp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5" creationId="{22F69510-3952-44E9-A333-35C4129A0F35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9" creationId="{3258128A-403C-4AE9-8E99-C30DA2F06EF5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50" creationId="{65742105-94B2-48B2-935D-134AAF44401E}"/>
          </ac:picMkLst>
        </pc:picChg>
        <pc:picChg chg="add mod modCrop">
          <ac:chgData name="Wencai Zhang" userId="4a86a1d0-2108-4707-8228-1110f3c1be85" providerId="ADAL" clId="{75BEC149-D62E-5D48-803F-577443322235}" dt="2022-04-21T16:29:25.811" v="1341" actId="732"/>
          <ac:picMkLst>
            <pc:docMk/>
            <pc:sldMk cId="4133689721" sldId="291"/>
            <ac:picMk id="54" creationId="{C0CB6ABD-8B3D-B145-B7FC-F88644741EC1}"/>
          </ac:picMkLst>
        </pc:picChg>
        <pc:picChg chg="add del mod">
          <ac:chgData name="Wencai Zhang" userId="4a86a1d0-2108-4707-8228-1110f3c1be85" providerId="ADAL" clId="{75BEC149-D62E-5D48-803F-577443322235}" dt="2022-04-21T16:18:28.358" v="1017" actId="478"/>
          <ac:picMkLst>
            <pc:docMk/>
            <pc:sldMk cId="4133689721" sldId="291"/>
            <ac:picMk id="55" creationId="{039B24DF-88B6-AC46-8392-4FA4EA39DF88}"/>
          </ac:picMkLst>
        </pc:picChg>
        <pc:picChg chg="add del mod">
          <ac:chgData name="Wencai Zhang" userId="4a86a1d0-2108-4707-8228-1110f3c1be85" providerId="ADAL" clId="{75BEC149-D62E-5D48-803F-577443322235}" dt="2022-04-21T16:18:30.788" v="1018" actId="478"/>
          <ac:picMkLst>
            <pc:docMk/>
            <pc:sldMk cId="4133689721" sldId="291"/>
            <ac:picMk id="58" creationId="{11965FC1-3068-614F-9452-0A81527B6304}"/>
          </ac:picMkLst>
        </pc:picChg>
        <pc:picChg chg="add del mod">
          <ac:chgData name="Wencai Zhang" userId="4a86a1d0-2108-4707-8228-1110f3c1be85" providerId="ADAL" clId="{75BEC149-D62E-5D48-803F-577443322235}" dt="2022-04-21T16:18:32.981" v="1019" actId="478"/>
          <ac:picMkLst>
            <pc:docMk/>
            <pc:sldMk cId="4133689721" sldId="291"/>
            <ac:picMk id="59" creationId="{192BA06F-5551-B64F-ABCA-22F1D6D0E677}"/>
          </ac:picMkLst>
        </pc:picChg>
        <pc:picChg chg="add del mod">
          <ac:chgData name="Wencai Zhang" userId="4a86a1d0-2108-4707-8228-1110f3c1be85" providerId="ADAL" clId="{75BEC149-D62E-5D48-803F-577443322235}" dt="2022-04-21T16:20:52.797" v="1104" actId="478"/>
          <ac:picMkLst>
            <pc:docMk/>
            <pc:sldMk cId="4133689721" sldId="291"/>
            <ac:picMk id="74" creationId="{0194FD0F-9E8C-0E4E-BA73-BE9379A259D4}"/>
          </ac:picMkLst>
        </pc:picChg>
        <pc:picChg chg="add mod modCrop">
          <ac:chgData name="Wencai Zhang" userId="4a86a1d0-2108-4707-8228-1110f3c1be85" providerId="ADAL" clId="{75BEC149-D62E-5D48-803F-577443322235}" dt="2022-04-21T16:29:15.519" v="1340" actId="732"/>
          <ac:picMkLst>
            <pc:docMk/>
            <pc:sldMk cId="4133689721" sldId="291"/>
            <ac:picMk id="75" creationId="{2331D386-E1C3-B246-B8A8-197098E47CF1}"/>
          </ac:picMkLst>
        </pc:picChg>
        <pc:picChg chg="add del mod">
          <ac:chgData name="Wencai Zhang" userId="4a86a1d0-2108-4707-8228-1110f3c1be85" providerId="ADAL" clId="{75BEC149-D62E-5D48-803F-577443322235}" dt="2022-04-21T16:20:56.115" v="1105" actId="478"/>
          <ac:picMkLst>
            <pc:docMk/>
            <pc:sldMk cId="4133689721" sldId="291"/>
            <ac:picMk id="78" creationId="{5852A9BC-427B-B744-AD4B-5B0470E7030F}"/>
          </ac:picMkLst>
        </pc:picChg>
        <pc:picChg chg="add del mod">
          <ac:chgData name="Wencai Zhang" userId="4a86a1d0-2108-4707-8228-1110f3c1be85" providerId="ADAL" clId="{75BEC149-D62E-5D48-803F-577443322235}" dt="2022-04-21T16:20:56.115" v="1105" actId="478"/>
          <ac:picMkLst>
            <pc:docMk/>
            <pc:sldMk cId="4133689721" sldId="291"/>
            <ac:picMk id="79" creationId="{DCFC3883-9A8F-F24F-9F1C-8E7D4265733D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81" creationId="{BE92BD88-DCA3-4340-A32C-86E24907DA79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84" creationId="{9F2AA289-39DA-4F8F-A3F6-9329A4DB85F7}"/>
          </ac:picMkLst>
        </pc:picChg>
        <pc:picChg chg="mod">
          <ac:chgData name="Wencai Zhang" userId="4a86a1d0-2108-4707-8228-1110f3c1be85" providerId="ADAL" clId="{75BEC149-D62E-5D48-803F-577443322235}" dt="2022-04-21T16:18:02.458" v="998" actId="1036"/>
          <ac:picMkLst>
            <pc:docMk/>
            <pc:sldMk cId="4133689721" sldId="291"/>
            <ac:picMk id="85" creationId="{BC52D881-4878-435B-835B-02EB8A51FBC2}"/>
          </ac:picMkLst>
        </pc:picChg>
        <pc:picChg chg="add del mod">
          <ac:chgData name="Wencai Zhang" userId="4a86a1d0-2108-4707-8228-1110f3c1be85" providerId="ADAL" clId="{75BEC149-D62E-5D48-803F-577443322235}" dt="2022-04-21T16:21:29.495" v="1108" actId="478"/>
          <ac:picMkLst>
            <pc:docMk/>
            <pc:sldMk cId="4133689721" sldId="291"/>
            <ac:picMk id="99" creationId="{27DC260C-E66C-DD42-8BC3-C4F802368C71}"/>
          </ac:picMkLst>
        </pc:picChg>
        <pc:picChg chg="add del mod">
          <ac:chgData name="Wencai Zhang" userId="4a86a1d0-2108-4707-8228-1110f3c1be85" providerId="ADAL" clId="{75BEC149-D62E-5D48-803F-577443322235}" dt="2022-04-21T16:21:31.823" v="1109" actId="478"/>
          <ac:picMkLst>
            <pc:docMk/>
            <pc:sldMk cId="4133689721" sldId="291"/>
            <ac:picMk id="100" creationId="{EBFF0A11-E6B0-3B4A-A3BE-39F7668196FE}"/>
          </ac:picMkLst>
        </pc:picChg>
        <pc:picChg chg="add mod modCrop">
          <ac:chgData name="Wencai Zhang" userId="4a86a1d0-2108-4707-8228-1110f3c1be85" providerId="ADAL" clId="{75BEC149-D62E-5D48-803F-577443322235}" dt="2022-04-21T16:27:12.639" v="1277" actId="18131"/>
          <ac:picMkLst>
            <pc:docMk/>
            <pc:sldMk cId="4133689721" sldId="291"/>
            <ac:picMk id="103" creationId="{9870E93B-6C4B-2C4B-8D77-BB5CFD1397F6}"/>
          </ac:picMkLst>
        </pc:picChg>
        <pc:picChg chg="add del mod">
          <ac:chgData name="Wencai Zhang" userId="4a86a1d0-2108-4707-8228-1110f3c1be85" providerId="ADAL" clId="{75BEC149-D62E-5D48-803F-577443322235}" dt="2022-04-21T16:21:34.501" v="1110" actId="478"/>
          <ac:picMkLst>
            <pc:docMk/>
            <pc:sldMk cId="4133689721" sldId="291"/>
            <ac:picMk id="104" creationId="{C9558671-8657-5A48-8711-B155212BCE54}"/>
          </ac:picMkLst>
        </pc:picChg>
        <pc:picChg chg="add del mod">
          <ac:chgData name="Wencai Zhang" userId="4a86a1d0-2108-4707-8228-1110f3c1be85" providerId="ADAL" clId="{75BEC149-D62E-5D48-803F-577443322235}" dt="2022-04-21T16:23:47.544" v="1144" actId="478"/>
          <ac:picMkLst>
            <pc:docMk/>
            <pc:sldMk cId="4133689721" sldId="291"/>
            <ac:picMk id="119" creationId="{8B1614F0-B1DE-1B4F-A1C9-2C7FFBCF4BCE}"/>
          </ac:picMkLst>
        </pc:picChg>
        <pc:picChg chg="add del mod">
          <ac:chgData name="Wencai Zhang" userId="4a86a1d0-2108-4707-8228-1110f3c1be85" providerId="ADAL" clId="{75BEC149-D62E-5D48-803F-577443322235}" dt="2022-04-21T16:23:47.544" v="1144" actId="478"/>
          <ac:picMkLst>
            <pc:docMk/>
            <pc:sldMk cId="4133689721" sldId="291"/>
            <ac:picMk id="120" creationId="{FFEB2522-2513-F24E-84E0-808B9A4D3B47}"/>
          </ac:picMkLst>
        </pc:picChg>
        <pc:picChg chg="add del mod">
          <ac:chgData name="Wencai Zhang" userId="4a86a1d0-2108-4707-8228-1110f3c1be85" providerId="ADAL" clId="{75BEC149-D62E-5D48-803F-577443322235}" dt="2022-04-21T16:23:47.544" v="1144" actId="478"/>
          <ac:picMkLst>
            <pc:docMk/>
            <pc:sldMk cId="4133689721" sldId="291"/>
            <ac:picMk id="126" creationId="{0A31FA93-9ABC-AA4E-BDBA-34BA3686DB82}"/>
          </ac:picMkLst>
        </pc:picChg>
        <pc:picChg chg="add mod modCrop">
          <ac:chgData name="Wencai Zhang" userId="4a86a1d0-2108-4707-8228-1110f3c1be85" providerId="ADAL" clId="{75BEC149-D62E-5D48-803F-577443322235}" dt="2022-04-21T16:29:39.334" v="1342" actId="732"/>
          <ac:picMkLst>
            <pc:docMk/>
            <pc:sldMk cId="4133689721" sldId="291"/>
            <ac:picMk id="129" creationId="{2BD61A97-DEC8-DD4C-84C9-0EAC6A03CDC5}"/>
          </ac:picMkLst>
        </pc:picChg>
      </pc:sldChg>
    </pc:docChg>
  </pc:docChgLst>
  <pc:docChgLst>
    <pc:chgData name="Wencai Zhang" userId="4a86a1d0-2108-4707-8228-1110f3c1be85" providerId="ADAL" clId="{5C5F0646-7A15-7D47-8C0D-14A5E0762118}"/>
    <pc:docChg chg="undo custSel addSld delSld modSld sldOrd">
      <pc:chgData name="Wencai Zhang" userId="4a86a1d0-2108-4707-8228-1110f3c1be85" providerId="ADAL" clId="{5C5F0646-7A15-7D47-8C0D-14A5E0762118}" dt="2021-06-15T01:34:55.679" v="5763" actId="20577"/>
      <pc:docMkLst>
        <pc:docMk/>
      </pc:docMkLst>
      <pc:sldChg chg="addSp delSp modSp mod">
        <pc:chgData name="Wencai Zhang" userId="4a86a1d0-2108-4707-8228-1110f3c1be85" providerId="ADAL" clId="{5C5F0646-7A15-7D47-8C0D-14A5E0762118}" dt="2021-06-08T11:41:38.119" v="3247" actId="1076"/>
        <pc:sldMkLst>
          <pc:docMk/>
          <pc:sldMk cId="3242017852" sldId="272"/>
        </pc:sldMkLst>
        <pc:spChg chg="add mod">
          <ac:chgData name="Wencai Zhang" userId="4a86a1d0-2108-4707-8228-1110f3c1be85" providerId="ADAL" clId="{5C5F0646-7A15-7D47-8C0D-14A5E0762118}" dt="2021-06-08T11:41:38.119" v="3247" actId="1076"/>
          <ac:spMkLst>
            <pc:docMk/>
            <pc:sldMk cId="3242017852" sldId="272"/>
            <ac:spMk id="2" creationId="{F7F732D5-FB4D-B54E-8D07-F640D71C9884}"/>
          </ac:spMkLst>
        </pc:spChg>
        <pc:spChg chg="de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5" creationId="{C9676FCD-1B75-674C-B612-D1EA39A39093}"/>
          </ac:spMkLst>
        </pc:spChg>
        <pc:spChg chg="del mod topLvl">
          <ac:chgData name="Wencai Zhang" userId="4a86a1d0-2108-4707-8228-1110f3c1be85" providerId="ADAL" clId="{5C5F0646-7A15-7D47-8C0D-14A5E0762118}" dt="2021-06-07T17:29:17.393" v="13" actId="478"/>
          <ac:spMkLst>
            <pc:docMk/>
            <pc:sldMk cId="3242017852" sldId="272"/>
            <ac:spMk id="11" creationId="{61353381-AC7D-E848-A714-0811467522BE}"/>
          </ac:spMkLst>
        </pc:spChg>
        <pc:spChg chg="add mod">
          <ac:chgData name="Wencai Zhang" userId="4a86a1d0-2108-4707-8228-1110f3c1be85" providerId="ADAL" clId="{5C5F0646-7A15-7D47-8C0D-14A5E0762118}" dt="2021-06-08T00:06:05.305" v="1394" actId="122"/>
          <ac:spMkLst>
            <pc:docMk/>
            <pc:sldMk cId="3242017852" sldId="272"/>
            <ac:spMk id="14" creationId="{819B5D32-AC6C-DA49-8D3B-E08FB417EB1F}"/>
          </ac:spMkLst>
        </pc:spChg>
        <pc:spChg chg="mod topLvl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15" creationId="{73A0757A-AC74-43FC-BBB2-E91DD12F5CD5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22" creationId="{119C059E-C733-4742-A0D4-D02B0A0755A1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23" creationId="{19318E2F-9580-484A-A2E4-97CB1BA629D3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24" creationId="{0743C9DB-C2C3-4D68-9AC6-CC11265D5C66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26" creationId="{C4308320-9356-44DD-9CD7-D86A1D1F07E5}"/>
          </ac:spMkLst>
        </pc:spChg>
        <pc:spChg chg="del mod topLvl">
          <ac:chgData name="Wencai Zhang" userId="4a86a1d0-2108-4707-8228-1110f3c1be85" providerId="ADAL" clId="{5C5F0646-7A15-7D47-8C0D-14A5E0762118}" dt="2021-06-07T17:29:17.393" v="13" actId="478"/>
          <ac:spMkLst>
            <pc:docMk/>
            <pc:sldMk cId="3242017852" sldId="272"/>
            <ac:spMk id="32" creationId="{E7D8A89C-5DD3-434D-B0F9-4FFE362E8493}"/>
          </ac:spMkLst>
        </pc:spChg>
        <pc:spChg chg="del mod topLvl">
          <ac:chgData name="Wencai Zhang" userId="4a86a1d0-2108-4707-8228-1110f3c1be85" providerId="ADAL" clId="{5C5F0646-7A15-7D47-8C0D-14A5E0762118}" dt="2021-06-07T17:29:17.393" v="13" actId="478"/>
          <ac:spMkLst>
            <pc:docMk/>
            <pc:sldMk cId="3242017852" sldId="272"/>
            <ac:spMk id="33" creationId="{AD8D757C-C30A-EB43-B121-3175844E2FA4}"/>
          </ac:spMkLst>
        </pc:spChg>
        <pc:spChg chg="del mod topLvl">
          <ac:chgData name="Wencai Zhang" userId="4a86a1d0-2108-4707-8228-1110f3c1be85" providerId="ADAL" clId="{5C5F0646-7A15-7D47-8C0D-14A5E0762118}" dt="2021-06-07T17:29:39.513" v="18" actId="478"/>
          <ac:spMkLst>
            <pc:docMk/>
            <pc:sldMk cId="3242017852" sldId="272"/>
            <ac:spMk id="39" creationId="{551B349F-03B8-DC44-85FE-1EE2F30F37B5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1" creationId="{05C57CC4-2015-234E-8A6B-3FD17DD61D9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2" creationId="{B6BBFF1F-DD97-8A45-A1BE-EFFC7A1DBE1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4" creationId="{89BCA8F2-1741-1740-A4FA-E39C34601ADF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5" creationId="{144FF4C7-47D0-254C-B9B6-542992DC4A4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6" creationId="{2FD6981F-D417-BF40-B127-245C841203C0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7" creationId="{7573BBB2-B64F-A649-A186-CB45101E4CA4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49" creationId="{D82F64E3-B693-3E47-B639-B6C918AB91CF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0" creationId="{A0C95532-2C22-7343-AC27-F297CE1BECB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1" creationId="{009F4F04-6D19-564F-9123-4184998AE4C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2" creationId="{4EBE9D99-D109-1544-BFB0-DCDC5827BCC9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54" creationId="{85EE4A3E-131F-154D-A684-CD6E595E2ADB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59" creationId="{EB44D005-E90D-074C-AD4E-F55FC9DDD341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1" creationId="{83D4EDD7-402D-C44E-8C12-80E5C60B6F18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2" creationId="{1E261997-15B1-5B47-9CD8-5196E34E590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63" creationId="{9B3209CC-5380-0F46-9A05-D1DAC4FEDF2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64" creationId="{B4837D33-AA29-F44E-B82F-CF018DE447A1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5" creationId="{3DFB711B-8B90-1240-B6A8-D19F09136C23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6" creationId="{FF517956-7D11-5045-BAB3-D0FBDAA68E18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7" creationId="{5A88E887-9896-2742-9FBE-A90372B280F9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8" creationId="{E76224F7-D762-6B4A-8132-BE95ED59A120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69" creationId="{1B56E517-81CF-064C-95B9-BB828A0B3D29}"/>
          </ac:spMkLst>
        </pc:spChg>
        <pc:spChg chg="mod topLvl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71" creationId="{9B63982C-9423-B641-9499-4AB2C87BF98E}"/>
          </ac:spMkLst>
        </pc:spChg>
        <pc:spChg chg="del mod topLvl">
          <ac:chgData name="Wencai Zhang" userId="4a86a1d0-2108-4707-8228-1110f3c1be85" providerId="ADAL" clId="{5C5F0646-7A15-7D47-8C0D-14A5E0762118}" dt="2021-06-07T21:32:52.355" v="1127" actId="478"/>
          <ac:spMkLst>
            <pc:docMk/>
            <pc:sldMk cId="3242017852" sldId="272"/>
            <ac:spMk id="76" creationId="{9A59F463-DF57-BD49-8378-B4332DE229CE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78" creationId="{4CA5DA5A-A6B5-B141-850D-A3D9742277BC}"/>
          </ac:spMkLst>
        </pc:spChg>
        <pc:spChg chg="mod topLvl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79" creationId="{F0A85EFF-8CA7-4595-8ED1-A933E3DC9B9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1" creationId="{FB416D89-ADA2-8E40-A639-5D4FC6FE1075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3" creationId="{B6BA3F67-07C4-2E43-B61A-70A5D59F196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5" creationId="{08BD4463-344C-AD42-BFF9-D2126DB12D85}"/>
          </ac:spMkLst>
        </pc:spChg>
        <pc:spChg chg="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86" creationId="{00000000-0000-0000-0000-000000000000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88" creationId="{EA35BA7A-194E-2B4D-BA54-51FA2F74DF46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2" creationId="{8B05DB7D-9BE7-8F4A-BF0F-B1DD9C85DA7D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4" creationId="{F1468978-1A99-DF42-B2DA-37AEC9EE9B6A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97" creationId="{12C7F373-6FDB-7245-A883-C55803F3ED93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7" creationId="{B827967C-2BC7-8C4D-BBC4-52F213E60DA9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8" creationId="{74880200-7BB5-E749-A573-0A31C9D273B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99" creationId="{757384F2-F6BF-F240-AAAD-73516C30413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00" creationId="{5CEABA1C-48AB-8647-8F28-62E420DDE202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01" creationId="{4B94BE8B-572F-5C4C-ABF9-ECCCD1ED3017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03" creationId="{49A8B912-C125-EB4C-9D89-4E536C209009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4" creationId="{560F9739-AE91-E14F-A72C-229CB273C2C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5" creationId="{CF6CD96D-1E3B-2648-B127-72770E0C05B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7" creationId="{7486C78F-C24F-9246-A8D3-C3B4808B817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19" creationId="{6AF6553F-3C31-EE44-8578-7CFE050FF54B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0" creationId="{2C4FD043-317B-A949-B9FD-AFD5D529F261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5" creationId="{B8241A98-BD3C-2B44-B42F-E00E91B351C9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6" creationId="{3B37581F-4FE7-2044-848A-A0B20CF5AF9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28" creationId="{5E907FC5-52AF-4643-9EC3-69405E989E4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31" creationId="{550FE903-1811-EF48-A1B8-FF735FB9F49C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32" creationId="{3DF5FE96-AD62-ED4E-91F2-27C62CC21035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34" creationId="{047EABF3-31AE-FB43-B5DD-1604602B48C7}"/>
          </ac:spMkLst>
        </pc:spChg>
        <pc:spChg chg="del mod topLvl">
          <ac:chgData name="Wencai Zhang" userId="4a86a1d0-2108-4707-8228-1110f3c1be85" providerId="ADAL" clId="{5C5F0646-7A15-7D47-8C0D-14A5E0762118}" dt="2021-06-07T17:29:36.490" v="17" actId="478"/>
          <ac:spMkLst>
            <pc:docMk/>
            <pc:sldMk cId="3242017852" sldId="272"/>
            <ac:spMk id="135" creationId="{B48D9B35-7E39-2E49-8EE5-821BFC4661C9}"/>
          </ac:spMkLst>
        </pc:spChg>
        <pc:spChg chg="del mod topLvl">
          <ac:chgData name="Wencai Zhang" userId="4a86a1d0-2108-4707-8228-1110f3c1be85" providerId="ADAL" clId="{5C5F0646-7A15-7D47-8C0D-14A5E0762118}" dt="2021-06-07T17:29:12.402" v="12" actId="478"/>
          <ac:spMkLst>
            <pc:docMk/>
            <pc:sldMk cId="3242017852" sldId="272"/>
            <ac:spMk id="136" creationId="{9346785B-AFE6-2144-BA16-D060A7E0DE3A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4" creationId="{26E32EED-1551-7448-A92A-85AE4FD33D86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5" creationId="{1C6065E1-6EF7-5D47-9010-FBAD30FA814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6" creationId="{0143FAEC-2918-7642-B01E-B1C62000098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49" creationId="{BDE54864-131E-C449-B5C3-100A2A0DD68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1" creationId="{8D588FF3-C5B7-EB4C-92AF-E20C07CDDD47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2" creationId="{B2996674-BD81-A944-A187-6112C872B32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4" creationId="{19BDB247-BCE1-DD40-8FDE-8E727BFCA7CE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5" creationId="{A98A02D4-5713-B941-9FEC-ED4FF54BD66C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7" creationId="{2CDE7BEB-9ED7-B64B-AFE7-6473F16F45F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59" creationId="{84AFAC13-E366-DE4C-AB5B-9B492483659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0" creationId="{F4B28066-6EC4-4F4B-BEDE-E392D7F685D9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2" creationId="{21D2D76C-1D04-C947-BDD6-0B1A2EDD76DD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4" creationId="{82DBD88E-2361-4D44-B048-37A892383F0A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5" creationId="{73FD3E4E-E4E8-454A-BCEB-B1A1CDF3702F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67" creationId="{A4CCA9F6-B1D3-0544-8359-DF7ABA905F4C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70" creationId="{53D34576-2342-5A4E-AFCD-084DEE683CE7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71" creationId="{2A6C052A-4168-414A-AC07-BC078F9103B3}"/>
          </ac:spMkLst>
        </pc:spChg>
        <pc:spChg chg="mod">
          <ac:chgData name="Wencai Zhang" userId="4a86a1d0-2108-4707-8228-1110f3c1be85" providerId="ADAL" clId="{5C5F0646-7A15-7D47-8C0D-14A5E0762118}" dt="2021-06-07T17:28:06.818" v="1" actId="165"/>
          <ac:spMkLst>
            <pc:docMk/>
            <pc:sldMk cId="3242017852" sldId="272"/>
            <ac:spMk id="172" creationId="{ED09868F-F3BC-F748-82C8-DE2537285D17}"/>
          </ac:spMkLst>
        </pc:spChg>
        <pc:spChg chg="del mod topLvl">
          <ac:chgData name="Wencai Zhang" userId="4a86a1d0-2108-4707-8228-1110f3c1be85" providerId="ADAL" clId="{5C5F0646-7A15-7D47-8C0D-14A5E0762118}" dt="2021-06-07T21:32:52.355" v="1127" actId="478"/>
          <ac:spMkLst>
            <pc:docMk/>
            <pc:sldMk cId="3242017852" sldId="272"/>
            <ac:spMk id="173" creationId="{E6F050D7-3FB5-B84C-A0A4-13CC5032B4BD}"/>
          </ac:spMkLst>
        </pc:spChg>
        <pc:spChg chg="del mod topLvl">
          <ac:chgData name="Wencai Zhang" userId="4a86a1d0-2108-4707-8228-1110f3c1be85" providerId="ADAL" clId="{5C5F0646-7A15-7D47-8C0D-14A5E0762118}" dt="2021-06-07T18:00:31.281" v="611" actId="478"/>
          <ac:spMkLst>
            <pc:docMk/>
            <pc:sldMk cId="3242017852" sldId="272"/>
            <ac:spMk id="174" creationId="{772C2F64-D0CB-794D-A688-AE5D87C04FC4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75" creationId="{0A4D0736-69FB-A241-BBB9-1C5D73309A51}"/>
          </ac:spMkLst>
        </pc:spChg>
        <pc:spChg chg="del mod topLvl">
          <ac:chgData name="Wencai Zhang" userId="4a86a1d0-2108-4707-8228-1110f3c1be85" providerId="ADAL" clId="{5C5F0646-7A15-7D47-8C0D-14A5E0762118}" dt="2021-06-07T17:29:39.513" v="18" actId="478"/>
          <ac:spMkLst>
            <pc:docMk/>
            <pc:sldMk cId="3242017852" sldId="272"/>
            <ac:spMk id="176" creationId="{8AC0A7E0-85AB-1B40-BF4F-68B6AC3286CC}"/>
          </ac:spMkLst>
        </pc:spChg>
        <pc:spChg chg="del mod topLvl">
          <ac:chgData name="Wencai Zhang" userId="4a86a1d0-2108-4707-8228-1110f3c1be85" providerId="ADAL" clId="{5C5F0646-7A15-7D47-8C0D-14A5E0762118}" dt="2021-06-07T17:29:39.513" v="18" actId="478"/>
          <ac:spMkLst>
            <pc:docMk/>
            <pc:sldMk cId="3242017852" sldId="272"/>
            <ac:spMk id="177" creationId="{7B9A2A0A-A737-8249-8285-20EEE828D37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80" creationId="{65144C8B-EE53-1E4C-ABB8-FCFC397D08F8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81" creationId="{4A10CFC8-E628-1345-9CC9-1E154CC7592B}"/>
          </ac:spMkLst>
        </pc:spChg>
        <pc:spChg chg="del mod topLvl">
          <ac:chgData name="Wencai Zhang" userId="4a86a1d0-2108-4707-8228-1110f3c1be85" providerId="ADAL" clId="{5C5F0646-7A15-7D47-8C0D-14A5E0762118}" dt="2021-06-07T17:29:22.049" v="14" actId="478"/>
          <ac:spMkLst>
            <pc:docMk/>
            <pc:sldMk cId="3242017852" sldId="272"/>
            <ac:spMk id="182" creationId="{3E61F479-3743-E445-8731-64B72FBA76CD}"/>
          </ac:spMkLst>
        </pc:spChg>
        <pc:spChg chg="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237" creationId="{EDCFD7CC-11F9-934C-BC9A-B9EA0F24D49B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0" creationId="{9F5D258F-77C5-8247-91CA-3BEEF339A700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1" creationId="{9E6841D7-D0C8-5449-B2CC-02D264A5F719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2" creationId="{5721E0A8-5C84-7748-A9B4-D78713F90B93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48" creationId="{2103224D-3AA4-F24C-9331-FD708BAC35DA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0" creationId="{8E874598-0095-2F46-9AE9-C03487B8B84D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1" creationId="{4A459D36-AFCD-9B4D-BCDF-83A3CA472BB6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3" creationId="{E86C0647-3CC8-4B47-8C79-B70ADCFA0A54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4" creationId="{87A725BF-3098-1841-8A71-5A5B87F77C5E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6" creationId="{0471AC9B-69E1-814F-8CF1-57C9992E1700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7" creationId="{CABE8F45-CE88-DA43-AD0C-97BA23FACA50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58" creationId="{FDE6EBE5-9372-E444-A042-A21861B538AC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0" creationId="{261F255E-ADE8-9B43-9C66-441194ADB959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1" creationId="{8E2E6AC8-DECF-1140-8E53-0A28EC5443D7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3" creationId="{E17EB0FD-7A2B-FB46-A006-0B4239F9033A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4" creationId="{B4BAB1AF-BD2E-D944-B61B-0AF5AEACD123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265" creationId="{4BEF20AA-05E4-6F44-8CD1-436E078A8596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266" creationId="{88C074BD-54A8-7245-8586-A8C381D78431}"/>
          </ac:spMkLst>
        </pc:spChg>
        <pc:spChg chg="add 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67" creationId="{FCA96061-7705-054F-AB8A-9D6E27D08D81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68" creationId="{E144F1F0-21E1-F94D-8E52-29D686001A0C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69" creationId="{9E136471-9244-9C49-AD90-71F4748D5BDD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0" creationId="{0340694B-3375-2E46-BE65-FA3414CA1526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1" creationId="{97FC0380-6FDF-C947-8D0F-FA0C63DDC294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2" creationId="{AB89F4FB-D60E-834A-9BA3-04EED04D8624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73" creationId="{CE024AE5-FB57-1D4A-B7D4-14351D560FA4}"/>
          </ac:spMkLst>
        </pc:spChg>
        <pc:spChg chg="add del mod">
          <ac:chgData name="Wencai Zhang" userId="4a86a1d0-2108-4707-8228-1110f3c1be85" providerId="ADAL" clId="{5C5F0646-7A15-7D47-8C0D-14A5E0762118}" dt="2021-06-07T18:08:40.678" v="639" actId="478"/>
          <ac:spMkLst>
            <pc:docMk/>
            <pc:sldMk cId="3242017852" sldId="272"/>
            <ac:spMk id="278" creationId="{43762AFA-98FF-0C45-A430-A37804D2DB0F}"/>
          </ac:spMkLst>
        </pc:spChg>
        <pc:spChg chg="add del mod">
          <ac:chgData name="Wencai Zhang" userId="4a86a1d0-2108-4707-8228-1110f3c1be85" providerId="ADAL" clId="{5C5F0646-7A15-7D47-8C0D-14A5E0762118}" dt="2021-06-07T18:08:49.607" v="641" actId="478"/>
          <ac:spMkLst>
            <pc:docMk/>
            <pc:sldMk cId="3242017852" sldId="272"/>
            <ac:spMk id="279" creationId="{6C780B3D-5AB3-9341-AC20-8FF5443751D2}"/>
          </ac:spMkLst>
        </pc:spChg>
        <pc:spChg chg="add del mod">
          <ac:chgData name="Wencai Zhang" userId="4a86a1d0-2108-4707-8228-1110f3c1be85" providerId="ADAL" clId="{5C5F0646-7A15-7D47-8C0D-14A5E0762118}" dt="2021-06-07T18:08:20.539" v="638" actId="478"/>
          <ac:spMkLst>
            <pc:docMk/>
            <pc:sldMk cId="3242017852" sldId="272"/>
            <ac:spMk id="280" creationId="{C7369404-A1D5-E144-9848-7B5B3DD75006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1" creationId="{02026582-ECBB-5643-A175-ED39E53767C7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2" creationId="{56A1161C-F7E9-2C47-8CED-AC85D8CD6BA9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3" creationId="{5D15EFB3-39E7-9243-9284-BECA3A099DC0}"/>
          </ac:spMkLst>
        </pc:spChg>
        <pc:spChg chg="add del mod">
          <ac:chgData name="Wencai Zhang" userId="4a86a1d0-2108-4707-8228-1110f3c1be85" providerId="ADAL" clId="{5C5F0646-7A15-7D47-8C0D-14A5E0762118}" dt="2021-06-07T18:15:53.494" v="707" actId="478"/>
          <ac:spMkLst>
            <pc:docMk/>
            <pc:sldMk cId="3242017852" sldId="272"/>
            <ac:spMk id="284" creationId="{0C36D5B0-D035-CF47-B11A-5891C467D89D}"/>
          </ac:spMkLst>
        </pc:spChg>
        <pc:spChg chg="mod topLvl">
          <ac:chgData name="Wencai Zhang" userId="4a86a1d0-2108-4707-8228-1110f3c1be85" providerId="ADAL" clId="{5C5F0646-7A15-7D47-8C0D-14A5E0762118}" dt="2021-06-07T21:22:50.815" v="998" actId="164"/>
          <ac:spMkLst>
            <pc:docMk/>
            <pc:sldMk cId="3242017852" sldId="272"/>
            <ac:spMk id="287" creationId="{7193C465-3095-4043-B79A-3739B626CF79}"/>
          </ac:spMkLst>
        </pc:spChg>
        <pc:spChg chg="mod topLvl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88" creationId="{A5601051-D5DE-8C44-85D0-F31E89548CB8}"/>
          </ac:spMkLst>
        </pc:spChg>
        <pc:spChg chg="mod topLvl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89" creationId="{F254A770-41FF-E443-9970-988622D62800}"/>
          </ac:spMkLst>
        </pc:spChg>
        <pc:spChg chg="mod topLvl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90" creationId="{21BE6DED-A6E3-D04B-B64A-63A20E4B23FF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96" creationId="{BF558EA2-F9CA-3E4F-9535-F7A8A97909EA}"/>
          </ac:spMkLst>
        </pc:spChg>
        <pc:spChg chg="mod">
          <ac:chgData name="Wencai Zhang" userId="4a86a1d0-2108-4707-8228-1110f3c1be85" providerId="ADAL" clId="{5C5F0646-7A15-7D47-8C0D-14A5E0762118}" dt="2021-06-07T20:37:23.379" v="976" actId="207"/>
          <ac:spMkLst>
            <pc:docMk/>
            <pc:sldMk cId="3242017852" sldId="272"/>
            <ac:spMk id="298" creationId="{29E8C61E-BC78-5446-89BE-A3D1A6FFBD65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299" creationId="{61703F19-B031-8743-A875-28A5A6320661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1" creationId="{DC0BA633-D172-C24F-A413-256B61525E0D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2" creationId="{9C69DBF0-EA27-B34F-B6C4-C1BFC5F65C4F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4" creationId="{2B13E8DD-6647-7B43-B16B-7F8EA7A4EDC4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5" creationId="{4088362F-6C6C-8740-A7B5-ACB41B6B46CB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6" creationId="{7E8C4413-5FAC-FD4D-90EA-28A00DA4FB58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8" creationId="{B85E3A82-3519-7445-BA93-50139C01B3DA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09" creationId="{AF469661-3480-DA43-AE91-B2E70F705FCF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11" creationId="{0C531AEF-AD05-5346-BB66-C31E310D3CBB}"/>
          </ac:spMkLst>
        </pc:spChg>
        <pc:spChg chg="mod">
          <ac:chgData name="Wencai Zhang" userId="4a86a1d0-2108-4707-8228-1110f3c1be85" providerId="ADAL" clId="{5C5F0646-7A15-7D47-8C0D-14A5E0762118}" dt="2021-06-07T18:20:21.026" v="711" actId="207"/>
          <ac:spMkLst>
            <pc:docMk/>
            <pc:sldMk cId="3242017852" sldId="272"/>
            <ac:spMk id="312" creationId="{1D982E3A-BFF4-9F4E-B553-0E6BE0930EA4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313" creationId="{2DAC1D6F-0B4B-F949-A1B9-5D64470684A7}"/>
          </ac:spMkLst>
        </pc:spChg>
        <pc:spChg chg="add mod">
          <ac:chgData name="Wencai Zhang" userId="4a86a1d0-2108-4707-8228-1110f3c1be85" providerId="ADAL" clId="{5C5F0646-7A15-7D47-8C0D-14A5E0762118}" dt="2021-06-08T00:14:59.143" v="1834" actId="1038"/>
          <ac:spMkLst>
            <pc:docMk/>
            <pc:sldMk cId="3242017852" sldId="272"/>
            <ac:spMk id="314" creationId="{6D3951E4-4F1B-2941-BEF6-6D70A6B4ED28}"/>
          </ac:spMkLst>
        </pc:spChg>
        <pc:spChg chg="mod">
          <ac:chgData name="Wencai Zhang" userId="4a86a1d0-2108-4707-8228-1110f3c1be85" providerId="ADAL" clId="{5C5F0646-7A15-7D47-8C0D-14A5E0762118}" dt="2021-06-07T19:45:37.537" v="723"/>
          <ac:spMkLst>
            <pc:docMk/>
            <pc:sldMk cId="3242017852" sldId="272"/>
            <ac:spMk id="319" creationId="{39D15733-EA4F-0247-B56E-55082461FCB4}"/>
          </ac:spMkLst>
        </pc:spChg>
        <pc:spChg chg="mod">
          <ac:chgData name="Wencai Zhang" userId="4a86a1d0-2108-4707-8228-1110f3c1be85" providerId="ADAL" clId="{5C5F0646-7A15-7D47-8C0D-14A5E0762118}" dt="2021-06-07T19:45:37.537" v="723"/>
          <ac:spMkLst>
            <pc:docMk/>
            <pc:sldMk cId="3242017852" sldId="272"/>
            <ac:spMk id="320" creationId="{D9567238-BB62-2E49-AFAF-1976F3B90511}"/>
          </ac:spMkLst>
        </pc:spChg>
        <pc:spChg chg="add mod">
          <ac:chgData name="Wencai Zhang" userId="4a86a1d0-2108-4707-8228-1110f3c1be85" providerId="ADAL" clId="{5C5F0646-7A15-7D47-8C0D-14A5E0762118}" dt="2021-06-08T00:05:56.825" v="1393" actId="122"/>
          <ac:spMkLst>
            <pc:docMk/>
            <pc:sldMk cId="3242017852" sldId="272"/>
            <ac:spMk id="325" creationId="{FA26CBE2-C079-C247-BA5B-41899846F7CE}"/>
          </ac:spMkLst>
        </pc:spChg>
        <pc:spChg chg="add mod">
          <ac:chgData name="Wencai Zhang" userId="4a86a1d0-2108-4707-8228-1110f3c1be85" providerId="ADAL" clId="{5C5F0646-7A15-7D47-8C0D-14A5E0762118}" dt="2021-06-08T00:17:57.405" v="1898" actId="1035"/>
          <ac:spMkLst>
            <pc:docMk/>
            <pc:sldMk cId="3242017852" sldId="272"/>
            <ac:spMk id="327" creationId="{C25C342B-1449-144B-A4B4-099276A7E7EB}"/>
          </ac:spMkLst>
        </pc:spChg>
        <pc:spChg chg="add mod">
          <ac:chgData name="Wencai Zhang" userId="4a86a1d0-2108-4707-8228-1110f3c1be85" providerId="ADAL" clId="{5C5F0646-7A15-7D47-8C0D-14A5E0762118}" dt="2021-06-08T00:17:50.150" v="1888" actId="1035"/>
          <ac:spMkLst>
            <pc:docMk/>
            <pc:sldMk cId="3242017852" sldId="272"/>
            <ac:spMk id="328" creationId="{572765A7-F85C-BE40-B290-3A1FCBE86C72}"/>
          </ac:spMkLst>
        </pc:spChg>
        <pc:grpChg chg="del mod topLvl">
          <ac:chgData name="Wencai Zhang" userId="4a86a1d0-2108-4707-8228-1110f3c1be85" providerId="ADAL" clId="{5C5F0646-7A15-7D47-8C0D-14A5E0762118}" dt="2021-06-07T17:29:39.513" v="18" actId="478"/>
          <ac:grpSpMkLst>
            <pc:docMk/>
            <pc:sldMk cId="3242017852" sldId="272"/>
            <ac:grpSpMk id="2" creationId="{96451E40-1371-C64D-9BFA-6472B2ABF063}"/>
          </ac:grpSpMkLst>
        </pc:grpChg>
        <pc:grpChg chg="add mod">
          <ac:chgData name="Wencai Zhang" userId="4a86a1d0-2108-4707-8228-1110f3c1be85" providerId="ADAL" clId="{5C5F0646-7A15-7D47-8C0D-14A5E0762118}" dt="2021-06-08T00:14:59.143" v="1834" actId="1038"/>
          <ac:grpSpMkLst>
            <pc:docMk/>
            <pc:sldMk cId="3242017852" sldId="272"/>
            <ac:grpSpMk id="4" creationId="{09F212C5-5FF3-274F-8DD0-F1C8012DC290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6" creationId="{5DE0A384-6B50-9B4B-9D28-E77FDAD02FE4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7" creationId="{B67ED541-0F3A-954A-B07B-8E70D40BC4F7}"/>
          </ac:grpSpMkLst>
        </pc:grpChg>
        <pc:grpChg chg="del mod topLvl">
          <ac:chgData name="Wencai Zhang" userId="4a86a1d0-2108-4707-8228-1110f3c1be85" providerId="ADAL" clId="{5C5F0646-7A15-7D47-8C0D-14A5E0762118}" dt="2021-06-07T17:29:12.402" v="12" actId="478"/>
          <ac:grpSpMkLst>
            <pc:docMk/>
            <pc:sldMk cId="3242017852" sldId="272"/>
            <ac:grpSpMk id="8" creationId="{63650F43-37FA-564D-A530-06A0FD37A9AC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9" creationId="{CC6DF5BE-0CBD-9A4A-85DC-9B8DD8E0D2D6}"/>
          </ac:grpSpMkLst>
        </pc:grpChg>
        <pc:grpChg chg="del mod topLvl">
          <ac:chgData name="Wencai Zhang" userId="4a86a1d0-2108-4707-8228-1110f3c1be85" providerId="ADAL" clId="{5C5F0646-7A15-7D47-8C0D-14A5E0762118}" dt="2021-06-07T17:29:12.402" v="12" actId="478"/>
          <ac:grpSpMkLst>
            <pc:docMk/>
            <pc:sldMk cId="3242017852" sldId="272"/>
            <ac:grpSpMk id="10" creationId="{A3DB4826-253E-FC4D-B80F-75E9B031D921}"/>
          </ac:grpSpMkLst>
        </pc:grpChg>
        <pc:grpChg chg="add mod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12" creationId="{A4DE68B5-ED1D-E14D-A174-A376809DDB51}"/>
          </ac:grpSpMkLst>
        </pc:grpChg>
        <pc:grpChg chg="del mod">
          <ac:chgData name="Wencai Zhang" userId="4a86a1d0-2108-4707-8228-1110f3c1be85" providerId="ADAL" clId="{5C5F0646-7A15-7D47-8C0D-14A5E0762118}" dt="2021-06-07T17:28:06.818" v="1" actId="165"/>
          <ac:grpSpMkLst>
            <pc:docMk/>
            <pc:sldMk cId="3242017852" sldId="272"/>
            <ac:grpSpMk id="13" creationId="{AC403E60-D88B-BB4F-B665-75038169A67A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19" creationId="{846E2EDE-3A92-C741-B355-62795F5E7EB3}"/>
          </ac:grpSpMkLst>
        </pc:grpChg>
        <pc:grpChg chg="de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20" creationId="{321DAD19-E9D0-234C-821C-5E044A313399}"/>
          </ac:grpSpMkLst>
        </pc:grpChg>
        <pc:grpChg chg="del">
          <ac:chgData name="Wencai Zhang" userId="4a86a1d0-2108-4707-8228-1110f3c1be85" providerId="ADAL" clId="{5C5F0646-7A15-7D47-8C0D-14A5E0762118}" dt="2021-06-07T17:29:32.283" v="15" actId="478"/>
          <ac:grpSpMkLst>
            <pc:docMk/>
            <pc:sldMk cId="3242017852" sldId="272"/>
            <ac:grpSpMk id="21" creationId="{610A4869-03EC-1B41-8D3D-3FB9BFEF5751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25" creationId="{E3B1D72A-ED0A-7540-AB53-5758AC5EFAFA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27" creationId="{A6D9618F-83CB-5146-9C56-CB9EF512ED08}"/>
          </ac:grpSpMkLst>
        </pc:grpChg>
        <pc:grpChg chg="add mod">
          <ac:chgData name="Wencai Zhang" userId="4a86a1d0-2108-4707-8228-1110f3c1be85" providerId="ADAL" clId="{5C5F0646-7A15-7D47-8C0D-14A5E0762118}" dt="2021-06-07T21:29:31.502" v="1056" actId="164"/>
          <ac:grpSpMkLst>
            <pc:docMk/>
            <pc:sldMk cId="3242017852" sldId="272"/>
            <ac:grpSpMk id="28" creationId="{0AC93AA2-30FF-0040-A888-262E00B90B5C}"/>
          </ac:grpSpMkLst>
        </pc:grpChg>
        <pc:grpChg chg="add mod">
          <ac:chgData name="Wencai Zhang" userId="4a86a1d0-2108-4707-8228-1110f3c1be85" providerId="ADAL" clId="{5C5F0646-7A15-7D47-8C0D-14A5E0762118}" dt="2021-06-08T00:18:31.748" v="1899" actId="1076"/>
          <ac:grpSpMkLst>
            <pc:docMk/>
            <pc:sldMk cId="3242017852" sldId="272"/>
            <ac:grpSpMk id="29" creationId="{1FAFC668-FFFC-7742-A517-4C1FF75E5E08}"/>
          </ac:grpSpMkLst>
        </pc:grpChg>
        <pc:grpChg chg="add mod">
          <ac:chgData name="Wencai Zhang" userId="4a86a1d0-2108-4707-8228-1110f3c1be85" providerId="ADAL" clId="{5C5F0646-7A15-7D47-8C0D-14A5E0762118}" dt="2021-06-08T00:16:59.863" v="1845" actId="14100"/>
          <ac:grpSpMkLst>
            <pc:docMk/>
            <pc:sldMk cId="3242017852" sldId="272"/>
            <ac:grpSpMk id="30" creationId="{3763D330-537A-8F4B-B707-45D265DDC8F5}"/>
          </ac:grpSpMkLst>
        </pc:grpChg>
        <pc:grpChg chg="add mod">
          <ac:chgData name="Wencai Zhang" userId="4a86a1d0-2108-4707-8228-1110f3c1be85" providerId="ADAL" clId="{5C5F0646-7A15-7D47-8C0D-14A5E0762118}" dt="2021-06-08T00:16:10.281" v="1841" actId="14100"/>
          <ac:grpSpMkLst>
            <pc:docMk/>
            <pc:sldMk cId="3242017852" sldId="272"/>
            <ac:grpSpMk id="31" creationId="{CBDC6863-0705-7C4B-9E12-7B224B426D55}"/>
          </ac:grpSpMkLst>
        </pc:grpChg>
        <pc:grpChg chg="del mod topLvl">
          <ac:chgData name="Wencai Zhang" userId="4a86a1d0-2108-4707-8228-1110f3c1be85" providerId="ADAL" clId="{5C5F0646-7A15-7D47-8C0D-14A5E0762118}" dt="2021-06-07T17:28:56.073" v="9" actId="478"/>
          <ac:grpSpMkLst>
            <pc:docMk/>
            <pc:sldMk cId="3242017852" sldId="272"/>
            <ac:grpSpMk id="72" creationId="{AD5D29D9-F224-7442-82B6-47A39739BDE3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13" creationId="{2CFCACE0-7922-9447-8B15-77999B4E56B8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18" creationId="{C1E4D236-88F6-DB40-85DC-62A33FB83DA5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23" creationId="{59F927BF-74AD-C041-96FC-5652C77AD954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29" creationId="{9A82BBAA-EAAC-F540-9A33-A6469F4B6949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42" creationId="{7E5599CF-FFA7-3C47-A32C-1C8928C6A9B1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5C5F0646-7A15-7D47-8C0D-14A5E0762118}" dt="2021-06-07T17:28:06.818" v="1" actId="165"/>
          <ac:grpSpMkLst>
            <pc:docMk/>
            <pc:sldMk cId="3242017852" sldId="272"/>
            <ac:grpSpMk id="148" creationId="{85FA1841-1F1B-6346-901B-3D9BA860663C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53" creationId="{20EA76E5-E707-784F-87C5-7744178C06FA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58" creationId="{A27194E5-D149-6A41-8DF8-77D640F31ED1}"/>
          </ac:grpSpMkLst>
        </pc:grpChg>
        <pc:grpChg chg="del mod topLvl">
          <ac:chgData name="Wencai Zhang" userId="4a86a1d0-2108-4707-8228-1110f3c1be85" providerId="ADAL" clId="{5C5F0646-7A15-7D47-8C0D-14A5E0762118}" dt="2021-06-07T17:29:22.049" v="14" actId="478"/>
          <ac:grpSpMkLst>
            <pc:docMk/>
            <pc:sldMk cId="3242017852" sldId="272"/>
            <ac:grpSpMk id="163" creationId="{01406731-5A2F-DE48-90BD-80BF3AE9D6A0}"/>
          </ac:grpSpMkLst>
        </pc:grpChg>
        <pc:grpChg chg="del mod topLvl">
          <ac:chgData name="Wencai Zhang" userId="4a86a1d0-2108-4707-8228-1110f3c1be85" providerId="ADAL" clId="{5C5F0646-7A15-7D47-8C0D-14A5E0762118}" dt="2021-06-07T17:29:39.513" v="18" actId="478"/>
          <ac:grpSpMkLst>
            <pc:docMk/>
            <pc:sldMk cId="3242017852" sldId="272"/>
            <ac:grpSpMk id="168" creationId="{A09C9EB4-CD43-1043-8733-F82B55937457}"/>
          </ac:grpSpMkLst>
        </pc:grpChg>
        <pc:grpChg chg="add mod">
          <ac:chgData name="Wencai Zhang" userId="4a86a1d0-2108-4707-8228-1110f3c1be85" providerId="ADAL" clId="{5C5F0646-7A15-7D47-8C0D-14A5E0762118}" dt="2021-06-07T18:00:44.922" v="614" actId="164"/>
          <ac:grpSpMkLst>
            <pc:docMk/>
            <pc:sldMk cId="3242017852" sldId="272"/>
            <ac:grpSpMk id="192" creationId="{2BAFDB35-2793-A345-A33D-6350A783D811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3" creationId="{5665FCB0-4AF5-F443-B23A-FD643A382B54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4" creationId="{DA0C34A8-ABA2-2741-8CE9-7B326E80C749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5" creationId="{29CE3A91-D47F-3C48-B889-531100A0A885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6" creationId="{FC042D8D-EEFC-D240-91F6-D9CE8A64F6D7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47" creationId="{6688B1D3-9DD5-BF4D-80DD-310B53E5D373}"/>
          </ac:grpSpMkLst>
        </pc:grpChg>
        <pc:grpChg chg="mod">
          <ac:chgData name="Wencai Zhang" userId="4a86a1d0-2108-4707-8228-1110f3c1be85" providerId="ADAL" clId="{5C5F0646-7A15-7D47-8C0D-14A5E0762118}" dt="2021-06-07T17:56:12.251" v="537"/>
          <ac:grpSpMkLst>
            <pc:docMk/>
            <pc:sldMk cId="3242017852" sldId="272"/>
            <ac:grpSpMk id="262" creationId="{C3C08D88-AF96-AA4C-986F-93E52CB20F64}"/>
          </ac:grpSpMkLst>
        </pc:grpChg>
        <pc:grpChg chg="add del mod">
          <ac:chgData name="Wencai Zhang" userId="4a86a1d0-2108-4707-8228-1110f3c1be85" providerId="ADAL" clId="{5C5F0646-7A15-7D47-8C0D-14A5E0762118}" dt="2021-06-07T18:09:35.404" v="645" actId="165"/>
          <ac:grpSpMkLst>
            <pc:docMk/>
            <pc:sldMk cId="3242017852" sldId="272"/>
            <ac:grpSpMk id="285" creationId="{547B96CC-5942-AE4E-B33A-FCA5FBFFC425}"/>
          </ac:grpSpMkLst>
        </pc:grpChg>
        <pc:grpChg chg="del mod topLvl">
          <ac:chgData name="Wencai Zhang" userId="4a86a1d0-2108-4707-8228-1110f3c1be85" providerId="ADAL" clId="{5C5F0646-7A15-7D47-8C0D-14A5E0762118}" dt="2021-06-07T18:09:55.288" v="658" actId="165"/>
          <ac:grpSpMkLst>
            <pc:docMk/>
            <pc:sldMk cId="3242017852" sldId="272"/>
            <ac:grpSpMk id="286" creationId="{5AFEC381-32D4-994A-9EA4-CFCDF724CAA3}"/>
          </ac:grpSpMkLst>
        </pc:grpChg>
        <pc:grpChg chg="mod topLvl">
          <ac:chgData name="Wencai Zhang" userId="4a86a1d0-2108-4707-8228-1110f3c1be85" providerId="ADAL" clId="{5C5F0646-7A15-7D47-8C0D-14A5E0762118}" dt="2021-06-07T21:22:50.815" v="998" actId="164"/>
          <ac:grpSpMkLst>
            <pc:docMk/>
            <pc:sldMk cId="3242017852" sldId="272"/>
            <ac:grpSpMk id="291" creationId="{91D3995B-73FE-2540-A741-0CBB730B185C}"/>
          </ac:grpSpMkLst>
        </pc:grpChg>
        <pc:grpChg chg="mod topLvl">
          <ac:chgData name="Wencai Zhang" userId="4a86a1d0-2108-4707-8228-1110f3c1be85" providerId="ADAL" clId="{5C5F0646-7A15-7D47-8C0D-14A5E0762118}" dt="2021-06-07T18:15:18.444" v="703" actId="164"/>
          <ac:grpSpMkLst>
            <pc:docMk/>
            <pc:sldMk cId="3242017852" sldId="272"/>
            <ac:grpSpMk id="292" creationId="{259D78C6-AB9D-3B45-8217-0471C002D17B}"/>
          </ac:grpSpMkLst>
        </pc:grpChg>
        <pc:grpChg chg="mod topLvl">
          <ac:chgData name="Wencai Zhang" userId="4a86a1d0-2108-4707-8228-1110f3c1be85" providerId="ADAL" clId="{5C5F0646-7A15-7D47-8C0D-14A5E0762118}" dt="2021-06-07T18:15:39.083" v="705" actId="164"/>
          <ac:grpSpMkLst>
            <pc:docMk/>
            <pc:sldMk cId="3242017852" sldId="272"/>
            <ac:grpSpMk id="293" creationId="{7AB34D66-C5A6-6A4D-9C67-1977845DD23B}"/>
          </ac:grpSpMkLst>
        </pc:grpChg>
        <pc:grpChg chg="mod topLvl">
          <ac:chgData name="Wencai Zhang" userId="4a86a1d0-2108-4707-8228-1110f3c1be85" providerId="ADAL" clId="{5C5F0646-7A15-7D47-8C0D-14A5E0762118}" dt="2021-06-07T18:15:47.017" v="706" actId="164"/>
          <ac:grpSpMkLst>
            <pc:docMk/>
            <pc:sldMk cId="3242017852" sldId="272"/>
            <ac:grpSpMk id="294" creationId="{62224A58-4D64-AA4B-8025-311616DAE2AF}"/>
          </ac:grpSpMkLst>
        </pc:grpChg>
        <pc:grpChg chg="mod topLvl">
          <ac:chgData name="Wencai Zhang" userId="4a86a1d0-2108-4707-8228-1110f3c1be85" providerId="ADAL" clId="{5C5F0646-7A15-7D47-8C0D-14A5E0762118}" dt="2021-06-07T18:15:29.909" v="704" actId="164"/>
          <ac:grpSpMkLst>
            <pc:docMk/>
            <pc:sldMk cId="3242017852" sldId="272"/>
            <ac:grpSpMk id="295" creationId="{B1820312-0E83-A74F-93A8-C20B012B0A37}"/>
          </ac:grpSpMkLst>
        </pc:grpChg>
        <pc:grpChg chg="mod">
          <ac:chgData name="Wencai Zhang" userId="4a86a1d0-2108-4707-8228-1110f3c1be85" providerId="ADAL" clId="{5C5F0646-7A15-7D47-8C0D-14A5E0762118}" dt="2021-06-07T18:09:55.288" v="658" actId="165"/>
          <ac:grpSpMkLst>
            <pc:docMk/>
            <pc:sldMk cId="3242017852" sldId="272"/>
            <ac:grpSpMk id="310" creationId="{7E3A8BC5-3C4C-1E45-8D59-5D82AB794919}"/>
          </ac:grpSpMkLst>
        </pc:grpChg>
        <pc:grpChg chg="add mod">
          <ac:chgData name="Wencai Zhang" userId="4a86a1d0-2108-4707-8228-1110f3c1be85" providerId="ADAL" clId="{5C5F0646-7A15-7D47-8C0D-14A5E0762118}" dt="2021-06-08T00:14:59.143" v="1834" actId="1038"/>
          <ac:grpSpMkLst>
            <pc:docMk/>
            <pc:sldMk cId="3242017852" sldId="272"/>
            <ac:grpSpMk id="317" creationId="{9E41850B-428F-AD48-A0A5-55EE77FE1719}"/>
          </ac:grpSpMkLst>
        </pc:grpChg>
        <pc:picChg chg="del mod topLvl">
          <ac:chgData name="Wencai Zhang" userId="4a86a1d0-2108-4707-8228-1110f3c1be85" providerId="ADAL" clId="{5C5F0646-7A15-7D47-8C0D-14A5E0762118}" dt="2021-06-07T17:29:02.433" v="11" actId="478"/>
          <ac:picMkLst>
            <pc:docMk/>
            <pc:sldMk cId="3242017852" sldId="272"/>
            <ac:picMk id="3" creationId="{EF3166B8-C08A-AF42-A649-D0150A40BB2F}"/>
          </ac:picMkLst>
        </pc:picChg>
        <pc:picChg chg="del mod topLvl">
          <ac:chgData name="Wencai Zhang" userId="4a86a1d0-2108-4707-8228-1110f3c1be85" providerId="ADAL" clId="{5C5F0646-7A15-7D47-8C0D-14A5E0762118}" dt="2021-06-07T17:29:00.885" v="10" actId="478"/>
          <ac:picMkLst>
            <pc:docMk/>
            <pc:sldMk cId="3242017852" sldId="272"/>
            <ac:picMk id="40" creationId="{5CFBCABC-16A3-9847-9416-3CD86F952992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5" creationId="{63F65AE1-44E9-354E-BE26-AA103449E57C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6" creationId="{BDB44C3F-FDD4-FE45-AC56-0381B726E574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7" creationId="{2CAC91D8-819A-3A43-9836-57CCE57CEE92}"/>
          </ac:picMkLst>
        </pc:picChg>
        <pc:picChg chg="del mod topLvl">
          <ac:chgData name="Wencai Zhang" userId="4a86a1d0-2108-4707-8228-1110f3c1be85" providerId="ADAL" clId="{5C5F0646-7A15-7D47-8C0D-14A5E0762118}" dt="2021-06-07T17:29:12.402" v="12" actId="478"/>
          <ac:picMkLst>
            <pc:docMk/>
            <pc:sldMk cId="3242017852" sldId="272"/>
            <ac:picMk id="58" creationId="{35932F72-055A-784A-B589-B30EEFC75F1A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75" creationId="{E62CEEFD-4CA1-864B-8692-4445BAA180CE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16" creationId="{842C16C1-2569-2B41-9BE7-A76C8801DE2F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21" creationId="{3832138C-BC52-E444-98C2-D355BA3C8434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24" creationId="{EE43A61C-6170-E24B-8AF5-77D6B46599E2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30" creationId="{65980DD0-A155-014F-ACE3-B39C7F3E2B32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43" creationId="{B4693310-C7E5-024B-8516-9417A988DDAB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50" creationId="{D5AB19CC-3D12-E641-AD09-16D58ADAEE64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56" creationId="{AFC9541E-22AC-6247-87F3-F8023E249043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61" creationId="{C2C57B83-5DBB-9C44-8647-89191A234E61}"/>
          </ac:picMkLst>
        </pc:picChg>
        <pc:picChg chg="mod">
          <ac:chgData name="Wencai Zhang" userId="4a86a1d0-2108-4707-8228-1110f3c1be85" providerId="ADAL" clId="{5C5F0646-7A15-7D47-8C0D-14A5E0762118}" dt="2021-06-07T17:28:06.818" v="1" actId="165"/>
          <ac:picMkLst>
            <pc:docMk/>
            <pc:sldMk cId="3242017852" sldId="272"/>
            <ac:picMk id="166" creationId="{5DE39962-B321-8847-83CF-4797A1FEFE2C}"/>
          </ac:picMkLst>
        </pc:picChg>
        <pc:picChg chg="del mod topLvl">
          <ac:chgData name="Wencai Zhang" userId="4a86a1d0-2108-4707-8228-1110f3c1be85" providerId="ADAL" clId="{5C5F0646-7A15-7D47-8C0D-14A5E0762118}" dt="2021-06-07T17:29:22.049" v="14" actId="478"/>
          <ac:picMkLst>
            <pc:docMk/>
            <pc:sldMk cId="3242017852" sldId="272"/>
            <ac:picMk id="179" creationId="{F7C78185-D3B8-504F-BCE0-FD60C3AB1152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49" creationId="{8A80ED78-E2CB-F643-8FC3-9E0B5A3FCC86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52" creationId="{DC4C6139-F38F-0D48-B49B-0A6E76457DFA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55" creationId="{84291F91-127B-6A48-99DA-DBE2E7BD1670}"/>
          </ac:picMkLst>
        </pc:picChg>
        <pc:picChg chg="mod">
          <ac:chgData name="Wencai Zhang" userId="4a86a1d0-2108-4707-8228-1110f3c1be85" providerId="ADAL" clId="{5C5F0646-7A15-7D47-8C0D-14A5E0762118}" dt="2021-06-07T17:56:12.251" v="537"/>
          <ac:picMkLst>
            <pc:docMk/>
            <pc:sldMk cId="3242017852" sldId="272"/>
            <ac:picMk id="259" creationId="{20C48547-B585-1547-A490-0CCB9FEB5AB2}"/>
          </ac:picMkLst>
        </pc:picChg>
        <pc:picChg chg="add mod">
          <ac:chgData name="Wencai Zhang" userId="4a86a1d0-2108-4707-8228-1110f3c1be85" providerId="ADAL" clId="{5C5F0646-7A15-7D47-8C0D-14A5E0762118}" dt="2021-06-07T18:15:47.017" v="706" actId="164"/>
          <ac:picMkLst>
            <pc:docMk/>
            <pc:sldMk cId="3242017852" sldId="272"/>
            <ac:picMk id="274" creationId="{906BAEFF-D6BB-1747-A493-77B65627BC34}"/>
          </ac:picMkLst>
        </pc:picChg>
        <pc:picChg chg="add mod">
          <ac:chgData name="Wencai Zhang" userId="4a86a1d0-2108-4707-8228-1110f3c1be85" providerId="ADAL" clId="{5C5F0646-7A15-7D47-8C0D-14A5E0762118}" dt="2021-06-07T18:15:39.083" v="705" actId="164"/>
          <ac:picMkLst>
            <pc:docMk/>
            <pc:sldMk cId="3242017852" sldId="272"/>
            <ac:picMk id="275" creationId="{8121254C-0B06-0F41-81E5-3C3C019406FD}"/>
          </ac:picMkLst>
        </pc:picChg>
        <pc:picChg chg="add mod">
          <ac:chgData name="Wencai Zhang" userId="4a86a1d0-2108-4707-8228-1110f3c1be85" providerId="ADAL" clId="{5C5F0646-7A15-7D47-8C0D-14A5E0762118}" dt="2021-06-07T18:15:29.909" v="704" actId="164"/>
          <ac:picMkLst>
            <pc:docMk/>
            <pc:sldMk cId="3242017852" sldId="272"/>
            <ac:picMk id="276" creationId="{88E3E285-BB9D-094A-BD37-F27014708EE1}"/>
          </ac:picMkLst>
        </pc:picChg>
        <pc:picChg chg="add mod">
          <ac:chgData name="Wencai Zhang" userId="4a86a1d0-2108-4707-8228-1110f3c1be85" providerId="ADAL" clId="{5C5F0646-7A15-7D47-8C0D-14A5E0762118}" dt="2021-06-07T18:15:18.444" v="703" actId="164"/>
          <ac:picMkLst>
            <pc:docMk/>
            <pc:sldMk cId="3242017852" sldId="272"/>
            <ac:picMk id="277" creationId="{5A6DAB29-B3F0-734D-8CAE-AE5B3BB0D3B2}"/>
          </ac:picMkLst>
        </pc:picChg>
        <pc:picChg chg="del mod">
          <ac:chgData name="Wencai Zhang" userId="4a86a1d0-2108-4707-8228-1110f3c1be85" providerId="ADAL" clId="{5C5F0646-7A15-7D47-8C0D-14A5E0762118}" dt="2021-06-07T18:13:10.914" v="687" actId="478"/>
          <ac:picMkLst>
            <pc:docMk/>
            <pc:sldMk cId="3242017852" sldId="272"/>
            <ac:picMk id="297" creationId="{F6439B98-BE57-894F-A36E-E92B7E519FCA}"/>
          </ac:picMkLst>
        </pc:picChg>
        <pc:picChg chg="del mod">
          <ac:chgData name="Wencai Zhang" userId="4a86a1d0-2108-4707-8228-1110f3c1be85" providerId="ADAL" clId="{5C5F0646-7A15-7D47-8C0D-14A5E0762118}" dt="2021-06-07T18:10:09.157" v="659" actId="478"/>
          <ac:picMkLst>
            <pc:docMk/>
            <pc:sldMk cId="3242017852" sldId="272"/>
            <ac:picMk id="300" creationId="{8A49547C-7560-E541-BEC2-6A8251498B89}"/>
          </ac:picMkLst>
        </pc:picChg>
        <pc:picChg chg="del mod">
          <ac:chgData name="Wencai Zhang" userId="4a86a1d0-2108-4707-8228-1110f3c1be85" providerId="ADAL" clId="{5C5F0646-7A15-7D47-8C0D-14A5E0762118}" dt="2021-06-07T18:10:54.823" v="671" actId="478"/>
          <ac:picMkLst>
            <pc:docMk/>
            <pc:sldMk cId="3242017852" sldId="272"/>
            <ac:picMk id="303" creationId="{A1309993-529F-5A47-B6AF-46DC33AE75E7}"/>
          </ac:picMkLst>
        </pc:picChg>
        <pc:picChg chg="del mod">
          <ac:chgData name="Wencai Zhang" userId="4a86a1d0-2108-4707-8228-1110f3c1be85" providerId="ADAL" clId="{5C5F0646-7A15-7D47-8C0D-14A5E0762118}" dt="2021-06-07T18:13:40.027" v="701" actId="478"/>
          <ac:picMkLst>
            <pc:docMk/>
            <pc:sldMk cId="3242017852" sldId="272"/>
            <ac:picMk id="307" creationId="{0F196E7A-7D5E-AE4A-BDFA-27A2E319FEB6}"/>
          </ac:picMkLst>
        </pc:picChg>
        <pc:picChg chg="add mod modCrop">
          <ac:chgData name="Wencai Zhang" userId="4a86a1d0-2108-4707-8228-1110f3c1be85" providerId="ADAL" clId="{5C5F0646-7A15-7D47-8C0D-14A5E0762118}" dt="2021-06-08T00:14:59.143" v="1834" actId="1038"/>
          <ac:picMkLst>
            <pc:docMk/>
            <pc:sldMk cId="3242017852" sldId="272"/>
            <ac:picMk id="315" creationId="{E1908A6C-BD0E-6E43-9753-2C031D3B30BC}"/>
          </ac:picMkLst>
        </pc:picChg>
        <pc:picChg chg="add del mod">
          <ac:chgData name="Wencai Zhang" userId="4a86a1d0-2108-4707-8228-1110f3c1be85" providerId="ADAL" clId="{5C5F0646-7A15-7D47-8C0D-14A5E0762118}" dt="2021-06-07T19:45:36.022" v="722" actId="478"/>
          <ac:picMkLst>
            <pc:docMk/>
            <pc:sldMk cId="3242017852" sldId="272"/>
            <ac:picMk id="316" creationId="{C3E7F1A3-BAC2-D445-A163-7F0571365765}"/>
          </ac:picMkLst>
        </pc:picChg>
        <pc:picChg chg="mod">
          <ac:chgData name="Wencai Zhang" userId="4a86a1d0-2108-4707-8228-1110f3c1be85" providerId="ADAL" clId="{5C5F0646-7A15-7D47-8C0D-14A5E0762118}" dt="2021-06-07T19:45:37.537" v="723"/>
          <ac:picMkLst>
            <pc:docMk/>
            <pc:sldMk cId="3242017852" sldId="272"/>
            <ac:picMk id="318" creationId="{CCABAC87-FE76-434F-A436-99720F24561F}"/>
          </ac:picMkLst>
        </pc:picChg>
        <pc:picChg chg="add del mod">
          <ac:chgData name="Wencai Zhang" userId="4a86a1d0-2108-4707-8228-1110f3c1be85" providerId="ADAL" clId="{5C5F0646-7A15-7D47-8C0D-14A5E0762118}" dt="2021-06-07T20:01:01.088" v="777" actId="478"/>
          <ac:picMkLst>
            <pc:docMk/>
            <pc:sldMk cId="3242017852" sldId="272"/>
            <ac:picMk id="321" creationId="{284711FF-8B8C-1A44-BFC9-AE8A9E8E6445}"/>
          </ac:picMkLst>
        </pc:picChg>
        <pc:picChg chg="add mod">
          <ac:chgData name="Wencai Zhang" userId="4a86a1d0-2108-4707-8228-1110f3c1be85" providerId="ADAL" clId="{5C5F0646-7A15-7D47-8C0D-14A5E0762118}" dt="2021-06-08T00:21:31.162" v="1929" actId="1037"/>
          <ac:picMkLst>
            <pc:docMk/>
            <pc:sldMk cId="3242017852" sldId="272"/>
            <ac:picMk id="322" creationId="{5F0967D3-F80C-1F4A-80F0-5123F3D5DC2C}"/>
          </ac:picMkLst>
        </pc:picChg>
        <pc:picChg chg="add mod">
          <ac:chgData name="Wencai Zhang" userId="4a86a1d0-2108-4707-8228-1110f3c1be85" providerId="ADAL" clId="{5C5F0646-7A15-7D47-8C0D-14A5E0762118}" dt="2021-06-08T00:17:24.443" v="1860" actId="1036"/>
          <ac:picMkLst>
            <pc:docMk/>
            <pc:sldMk cId="3242017852" sldId="272"/>
            <ac:picMk id="323" creationId="{452ABE4B-1408-A84B-ABB8-4BA60D88B50E}"/>
          </ac:picMkLst>
        </pc:picChg>
        <pc:picChg chg="add del mod">
          <ac:chgData name="Wencai Zhang" userId="4a86a1d0-2108-4707-8228-1110f3c1be85" providerId="ADAL" clId="{5C5F0646-7A15-7D47-8C0D-14A5E0762118}" dt="2021-06-07T20:12:32.988" v="950" actId="478"/>
          <ac:picMkLst>
            <pc:docMk/>
            <pc:sldMk cId="3242017852" sldId="272"/>
            <ac:picMk id="324" creationId="{68C77902-94E2-4947-99C3-23381666A2B0}"/>
          </ac:picMkLst>
        </pc:picChg>
        <pc:picChg chg="add mod">
          <ac:chgData name="Wencai Zhang" userId="4a86a1d0-2108-4707-8228-1110f3c1be85" providerId="ADAL" clId="{5C5F0646-7A15-7D47-8C0D-14A5E0762118}" dt="2021-06-08T00:17:24.443" v="1860" actId="1036"/>
          <ac:picMkLst>
            <pc:docMk/>
            <pc:sldMk cId="3242017852" sldId="272"/>
            <ac:picMk id="326" creationId="{C658AFA4-11EB-0946-86BD-EACEB2D81D82}"/>
          </ac:picMkLst>
        </pc:picChg>
        <pc:picChg chg="add mod">
          <ac:chgData name="Wencai Zhang" userId="4a86a1d0-2108-4707-8228-1110f3c1be85" providerId="ADAL" clId="{5C5F0646-7A15-7D47-8C0D-14A5E0762118}" dt="2021-06-08T00:21:12.352" v="1926" actId="1038"/>
          <ac:picMkLst>
            <pc:docMk/>
            <pc:sldMk cId="3242017852" sldId="272"/>
            <ac:picMk id="332" creationId="{F4B55D4C-0750-9142-B600-49E4A4ADDB32}"/>
          </ac:picMkLst>
        </pc:picChg>
        <pc:picChg chg="add mod modCrop">
          <ac:chgData name="Wencai Zhang" userId="4a86a1d0-2108-4707-8228-1110f3c1be85" providerId="ADAL" clId="{5C5F0646-7A15-7D47-8C0D-14A5E0762118}" dt="2021-06-08T00:14:59.143" v="1834" actId="1038"/>
          <ac:picMkLst>
            <pc:docMk/>
            <pc:sldMk cId="3242017852" sldId="272"/>
            <ac:picMk id="333" creationId="{9C3C2CDF-8E1C-434D-BDDF-0CFA955A4D75}"/>
          </ac:picMkLst>
        </pc:picChg>
        <pc:picChg chg="add mod">
          <ac:chgData name="Wencai Zhang" userId="4a86a1d0-2108-4707-8228-1110f3c1be85" providerId="ADAL" clId="{5C5F0646-7A15-7D47-8C0D-14A5E0762118}" dt="2021-06-08T00:21:47.493" v="1930" actId="1038"/>
          <ac:picMkLst>
            <pc:docMk/>
            <pc:sldMk cId="3242017852" sldId="272"/>
            <ac:picMk id="334" creationId="{B74DF2E4-2D23-FD41-A641-BF46DBF9580C}"/>
          </ac:picMkLst>
        </pc:picChg>
        <pc:picChg chg="add mod">
          <ac:chgData name="Wencai Zhang" userId="4a86a1d0-2108-4707-8228-1110f3c1be85" providerId="ADAL" clId="{5C5F0646-7A15-7D47-8C0D-14A5E0762118}" dt="2021-06-08T00:17:31.819" v="1870" actId="1035"/>
          <ac:picMkLst>
            <pc:docMk/>
            <pc:sldMk cId="3242017852" sldId="272"/>
            <ac:picMk id="335" creationId="{1394464F-8AB7-0940-80BA-66FFB8CEDB48}"/>
          </ac:picMkLst>
        </pc:picChg>
        <pc:picChg chg="add mod">
          <ac:chgData name="Wencai Zhang" userId="4a86a1d0-2108-4707-8228-1110f3c1be85" providerId="ADAL" clId="{5C5F0646-7A15-7D47-8C0D-14A5E0762118}" dt="2021-06-08T00:03:27.471" v="1287" actId="1036"/>
          <ac:picMkLst>
            <pc:docMk/>
            <pc:sldMk cId="3242017852" sldId="272"/>
            <ac:picMk id="336" creationId="{B4D051BF-E90A-F645-B904-86633C65040B}"/>
          </ac:picMkLst>
        </pc:picChg>
        <pc:picChg chg="add mod">
          <ac:chgData name="Wencai Zhang" userId="4a86a1d0-2108-4707-8228-1110f3c1be85" providerId="ADAL" clId="{5C5F0646-7A15-7D47-8C0D-14A5E0762118}" dt="2021-06-08T00:22:11.587" v="1935" actId="1035"/>
          <ac:picMkLst>
            <pc:docMk/>
            <pc:sldMk cId="3242017852" sldId="272"/>
            <ac:picMk id="337" creationId="{220EA5C3-3429-D940-911F-5AC977477BDF}"/>
          </ac:picMkLst>
        </pc:picChg>
        <pc:picChg chg="add del mod modCrop">
          <ac:chgData name="Wencai Zhang" userId="4a86a1d0-2108-4707-8228-1110f3c1be85" providerId="ADAL" clId="{5C5F0646-7A15-7D47-8C0D-14A5E0762118}" dt="2021-06-08T00:12:16.532" v="1634" actId="478"/>
          <ac:picMkLst>
            <pc:docMk/>
            <pc:sldMk cId="3242017852" sldId="272"/>
            <ac:picMk id="339" creationId="{F4715362-6FD6-B54E-9D62-CCFA39B6BD62}"/>
          </ac:picMkLst>
        </pc:picChg>
        <pc:cxnChg chg="add del mod">
          <ac:chgData name="Wencai Zhang" userId="4a86a1d0-2108-4707-8228-1110f3c1be85" providerId="ADAL" clId="{5C5F0646-7A15-7D47-8C0D-14A5E0762118}" dt="2021-06-07T21:23:50.078" v="1049" actId="478"/>
          <ac:cxnSpMkLst>
            <pc:docMk/>
            <pc:sldMk cId="3242017852" sldId="272"/>
            <ac:cxnSpMk id="18" creationId="{2663A624-837D-5343-B094-C95C380E4DC1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43" creationId="{C53D76DB-1155-F449-806E-53F568A2C4D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77" creationId="{5A7E62BA-C034-144E-8A6A-82CC38F0CF4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0" creationId="{A68C37E1-752F-7C4D-A462-101B4D123DFC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2" creationId="{20BA9E32-C552-6A47-A1E6-2635F0E9C27E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4" creationId="{27B71BF1-DE97-F648-8132-12A52C38A03A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7" creationId="{3A491FC2-8DFB-1241-87D5-23685ECAB70E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89" creationId="{D4CFF19D-24E4-6F43-9AE6-9F40BC969EEF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0" creationId="{455DAA09-CF83-8741-8D7E-8973DB4A7DD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1" creationId="{33792D80-0AF4-B54D-B8A6-F72F6BA2B113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3" creationId="{1D296288-8E52-C44E-825D-2C923756ECB4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5" creationId="{9E54B641-E0BC-C245-BCFC-A02A5F66F396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96" creationId="{F527164E-A74E-A446-B42B-21AE64DC9498}"/>
          </ac:cxnSpMkLst>
        </pc:cxnChg>
        <pc:cxnChg chg="del mod topLvl">
          <ac:chgData name="Wencai Zhang" userId="4a86a1d0-2108-4707-8228-1110f3c1be85" providerId="ADAL" clId="{5C5F0646-7A15-7D47-8C0D-14A5E0762118}" dt="2021-06-07T17:29:22.049" v="14" actId="478"/>
          <ac:cxnSpMkLst>
            <pc:docMk/>
            <pc:sldMk cId="3242017852" sldId="272"/>
            <ac:cxnSpMk id="102" creationId="{29B0EBBF-6CCF-B149-A3EE-15537DB1DB55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39" creationId="{BED8EE18-AED1-0540-B77C-18931F979303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5C5F0646-7A15-7D47-8C0D-14A5E0762118}" dt="2021-06-07T17:28:06.818" v="1" actId="165"/>
          <ac:cxnSpMkLst>
            <pc:docMk/>
            <pc:sldMk cId="3242017852" sldId="272"/>
            <ac:cxnSpMk id="178" creationId="{CEB9F77B-ACEE-1F40-8660-2BE6D852A4AA}"/>
          </ac:cxnSpMkLst>
        </pc:cxnChg>
        <pc:cxnChg chg="add mod">
          <ac:chgData name="Wencai Zhang" userId="4a86a1d0-2108-4707-8228-1110f3c1be85" providerId="ADAL" clId="{5C5F0646-7A15-7D47-8C0D-14A5E0762118}" dt="2021-06-08T00:21:01.886" v="1922" actId="1038"/>
          <ac:cxnSpMkLst>
            <pc:docMk/>
            <pc:sldMk cId="3242017852" sldId="272"/>
            <ac:cxnSpMk id="329" creationId="{3F792442-FC7E-F84E-A19C-D110A3859715}"/>
          </ac:cxnSpMkLst>
        </pc:cxnChg>
        <pc:cxnChg chg="add del mod">
          <ac:chgData name="Wencai Zhang" userId="4a86a1d0-2108-4707-8228-1110f3c1be85" providerId="ADAL" clId="{5C5F0646-7A15-7D47-8C0D-14A5E0762118}" dt="2021-06-07T21:25:11.137" v="1052" actId="478"/>
          <ac:cxnSpMkLst>
            <pc:docMk/>
            <pc:sldMk cId="3242017852" sldId="272"/>
            <ac:cxnSpMk id="330" creationId="{A4EB82A5-1280-7746-A301-80BA1D00407C}"/>
          </ac:cxnSpMkLst>
        </pc:cxnChg>
        <pc:cxnChg chg="add del mod">
          <ac:chgData name="Wencai Zhang" userId="4a86a1d0-2108-4707-8228-1110f3c1be85" providerId="ADAL" clId="{5C5F0646-7A15-7D47-8C0D-14A5E0762118}" dt="2021-06-07T21:25:00.663" v="1051" actId="478"/>
          <ac:cxnSpMkLst>
            <pc:docMk/>
            <pc:sldMk cId="3242017852" sldId="272"/>
            <ac:cxnSpMk id="331" creationId="{9F2C5567-8A8D-354B-AD93-16B83582BF4C}"/>
          </ac:cxnSpMkLst>
        </pc:cxnChg>
        <pc:cxnChg chg="add mod">
          <ac:chgData name="Wencai Zhang" userId="4a86a1d0-2108-4707-8228-1110f3c1be85" providerId="ADAL" clId="{5C5F0646-7A15-7D47-8C0D-14A5E0762118}" dt="2021-06-08T00:22:29.690" v="1955" actId="1036"/>
          <ac:cxnSpMkLst>
            <pc:docMk/>
            <pc:sldMk cId="3242017852" sldId="272"/>
            <ac:cxnSpMk id="338" creationId="{41136E04-6F06-EC4B-85B0-C32BCF28E502}"/>
          </ac:cxnSpMkLst>
        </pc:cxnChg>
      </pc:sldChg>
      <pc:sldChg chg="delSp mod">
        <pc:chgData name="Wencai Zhang" userId="4a86a1d0-2108-4707-8228-1110f3c1be85" providerId="ADAL" clId="{5C5F0646-7A15-7D47-8C0D-14A5E0762118}" dt="2021-06-07T17:28:23.487" v="3" actId="478"/>
        <pc:sldMkLst>
          <pc:docMk/>
          <pc:sldMk cId="1245431894" sldId="274"/>
        </pc:sldMkLst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" creationId="{C9676FCD-1B75-674C-B612-D1EA39A3909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11" creationId="{8B1765C8-9FB9-4242-ACE4-959BEBC359FE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12" creationId="{453A5F83-5877-764F-ADD5-5D6844B2FDF7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22" creationId="{119C059E-C733-4742-A0D4-D02B0A0755A1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23" creationId="{19318E2F-9580-484A-A2E4-97CB1BA629D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24" creationId="{0743C9DB-C2C3-4D68-9AC6-CC11265D5C66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32" creationId="{E7D8A89C-5DD3-434D-B0F9-4FFE362E849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33" creationId="{AD8D757C-C30A-EB43-B121-3175844E2FA4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41" creationId="{0D6658A2-778F-9740-94C6-A58514B11EB7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42" creationId="{908DF873-890F-4A4C-A816-4F309556B8B9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49" creationId="{FF95B0F2-7C17-7643-B9F6-6A1744873DF4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0" creationId="{1185AA34-8ABA-0647-95BE-BB701E60C952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1" creationId="{D6168116-A21A-4547-A3A6-874E4F2FC8F6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2" creationId="{58BD06B3-A6AC-3946-81BB-D7DB344761C7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59" creationId="{EB44D005-E90D-074C-AD4E-F55FC9DDD341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0" creationId="{3973D982-89C4-A14A-BEBC-B02DD2F41896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1" creationId="{83D4EDD7-402D-C44E-8C12-80E5C60B6F18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3" creationId="{C963CAC6-C6D1-CB4C-A32F-6FEF64826360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5" creationId="{3DFB711B-8B90-1240-B6A8-D19F09136C23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6" creationId="{FF517956-7D11-5045-BAB3-D0FBDAA68E18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7" creationId="{5A88E887-9896-2742-9FBE-A90372B280F9}"/>
          </ac:spMkLst>
        </pc:spChg>
        <pc:spChg chg="del">
          <ac:chgData name="Wencai Zhang" userId="4a86a1d0-2108-4707-8228-1110f3c1be85" providerId="ADAL" clId="{5C5F0646-7A15-7D47-8C0D-14A5E0762118}" dt="2021-06-07T17:28:23.487" v="3" actId="478"/>
          <ac:spMkLst>
            <pc:docMk/>
            <pc:sldMk cId="1245431894" sldId="274"/>
            <ac:spMk id="68" creationId="{E76224F7-D762-6B4A-8132-BE95ED59A120}"/>
          </ac:spMkLst>
        </pc:spChg>
        <pc:grpChg chg="del">
          <ac:chgData name="Wencai Zhang" userId="4a86a1d0-2108-4707-8228-1110f3c1be85" providerId="ADAL" clId="{5C5F0646-7A15-7D47-8C0D-14A5E0762118}" dt="2021-06-07T17:28:23.487" v="3" actId="478"/>
          <ac:grpSpMkLst>
            <pc:docMk/>
            <pc:sldMk cId="1245431894" sldId="274"/>
            <ac:grpSpMk id="2" creationId="{23522517-C292-8C40-8C84-B30913B1168A}"/>
          </ac:grpSpMkLst>
        </pc:grpChg>
        <pc:picChg chg="del">
          <ac:chgData name="Wencai Zhang" userId="4a86a1d0-2108-4707-8228-1110f3c1be85" providerId="ADAL" clId="{5C5F0646-7A15-7D47-8C0D-14A5E0762118}" dt="2021-06-07T17:28:23.487" v="3" actId="478"/>
          <ac:picMkLst>
            <pc:docMk/>
            <pc:sldMk cId="1245431894" sldId="274"/>
            <ac:picMk id="56" creationId="{BDB44C3F-FDD4-FE45-AC56-0381B726E574}"/>
          </ac:picMkLst>
        </pc:picChg>
        <pc:picChg chg="del">
          <ac:chgData name="Wencai Zhang" userId="4a86a1d0-2108-4707-8228-1110f3c1be85" providerId="ADAL" clId="{5C5F0646-7A15-7D47-8C0D-14A5E0762118}" dt="2021-06-07T17:28:23.487" v="3" actId="478"/>
          <ac:picMkLst>
            <pc:docMk/>
            <pc:sldMk cId="1245431894" sldId="274"/>
            <ac:picMk id="57" creationId="{2CAC91D8-819A-3A43-9836-57CCE57CEE92}"/>
          </ac:picMkLst>
        </pc:picChg>
        <pc:picChg chg="del">
          <ac:chgData name="Wencai Zhang" userId="4a86a1d0-2108-4707-8228-1110f3c1be85" providerId="ADAL" clId="{5C5F0646-7A15-7D47-8C0D-14A5E0762118}" dt="2021-06-07T17:28:23.487" v="3" actId="478"/>
          <ac:picMkLst>
            <pc:docMk/>
            <pc:sldMk cId="1245431894" sldId="274"/>
            <ac:picMk id="58" creationId="{35932F72-055A-784A-B589-B30EEFC75F1A}"/>
          </ac:picMkLst>
        </pc:picChg>
      </pc:sldChg>
      <pc:sldChg chg="delSp mod">
        <pc:chgData name="Wencai Zhang" userId="4a86a1d0-2108-4707-8228-1110f3c1be85" providerId="ADAL" clId="{5C5F0646-7A15-7D47-8C0D-14A5E0762118}" dt="2021-06-07T17:28:38.059" v="4" actId="478"/>
        <pc:sldMkLst>
          <pc:docMk/>
          <pc:sldMk cId="2222079663" sldId="275"/>
        </pc:sldMkLst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2" creationId="{39EDF6FE-038B-2745-A0B2-5DCDFD9FE626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3" creationId="{0445B0AA-E3C0-4143-9101-CCCF8F7A6354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87" creationId="{D0E9D44A-DBCD-4E4C-BCA9-99B7A06D6AF3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28" creationId="{7F039C8D-39AD-5745-B879-CC4D1E59CE15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29" creationId="{D9665304-5DCE-8A4C-970A-EF4BA349B357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30" creationId="{105330CD-5844-8846-9356-4974ED933874}"/>
          </ac:grpSpMkLst>
        </pc:grpChg>
        <pc:grpChg chg="del">
          <ac:chgData name="Wencai Zhang" userId="4a86a1d0-2108-4707-8228-1110f3c1be85" providerId="ADAL" clId="{5C5F0646-7A15-7D47-8C0D-14A5E0762118}" dt="2021-06-07T17:28:38.059" v="4" actId="478"/>
          <ac:grpSpMkLst>
            <pc:docMk/>
            <pc:sldMk cId="2222079663" sldId="275"/>
            <ac:grpSpMk id="131" creationId="{543F7BB7-6E74-2044-B2EB-EB016583A315}"/>
          </ac:grpSpMkLst>
        </pc:grpChg>
      </pc:sldChg>
      <pc:sldChg chg="del">
        <pc:chgData name="Wencai Zhang" userId="4a86a1d0-2108-4707-8228-1110f3c1be85" providerId="ADAL" clId="{5C5F0646-7A15-7D47-8C0D-14A5E0762118}" dt="2021-06-07T17:28:17.864" v="2" actId="2696"/>
        <pc:sldMkLst>
          <pc:docMk/>
          <pc:sldMk cId="1904142445" sldId="276"/>
        </pc:sldMkLst>
      </pc:sldChg>
      <pc:sldChg chg="addSp delSp modSp mod">
        <pc:chgData name="Wencai Zhang" userId="4a86a1d0-2108-4707-8228-1110f3c1be85" providerId="ADAL" clId="{5C5F0646-7A15-7D47-8C0D-14A5E0762118}" dt="2021-06-08T11:59:42.965" v="3919" actId="1038"/>
        <pc:sldMkLst>
          <pc:docMk/>
          <pc:sldMk cId="2045228985" sldId="278"/>
        </pc:sldMkLst>
        <pc:spChg chg="add mod">
          <ac:chgData name="Wencai Zhang" userId="4a86a1d0-2108-4707-8228-1110f3c1be85" providerId="ADAL" clId="{5C5F0646-7A15-7D47-8C0D-14A5E0762118}" dt="2021-06-08T11:50:17.202" v="3763" actId="164"/>
          <ac:spMkLst>
            <pc:docMk/>
            <pc:sldMk cId="2045228985" sldId="278"/>
            <ac:spMk id="2" creationId="{081498E4-5EC1-6B4B-89BD-DD07375FAA64}"/>
          </ac:spMkLst>
        </pc:spChg>
        <pc:spChg chg="add del mod">
          <ac:chgData name="Wencai Zhang" userId="4a86a1d0-2108-4707-8228-1110f3c1be85" providerId="ADAL" clId="{5C5F0646-7A15-7D47-8C0D-14A5E0762118}" dt="2021-06-07T17:28:45.293" v="7"/>
          <ac:spMkLst>
            <pc:docMk/>
            <pc:sldMk cId="2045228985" sldId="278"/>
            <ac:spMk id="2" creationId="{421CF5E6-8CEF-1F40-8E83-0D742E5868F1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3" creationId="{7C8F372B-FAE8-CE44-A95C-EFB214B632AE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29" creationId="{087FA4E2-17D9-574E-B2A0-44CC66183394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1" creationId="{5B763BC1-7959-2144-A8F2-D511FC66FD8A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32" creationId="{E2D5E3A3-AEE0-3442-AEA6-BE635EE18BC5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33" creationId="{7DAC45B8-7C9D-374E-BFE7-231E13FE27FF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4" creationId="{06B792A2-2887-6346-B380-8A90D681E903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6" creationId="{EC06F311-7B1F-114B-AF62-85683746E8B7}"/>
          </ac:spMkLst>
        </pc:spChg>
        <pc:spChg chg="add mod">
          <ac:chgData name="Wencai Zhang" userId="4a86a1d0-2108-4707-8228-1110f3c1be85" providerId="ADAL" clId="{5C5F0646-7A15-7D47-8C0D-14A5E0762118}" dt="2021-06-08T01:24:58.136" v="2886" actId="164"/>
          <ac:spMkLst>
            <pc:docMk/>
            <pc:sldMk cId="2045228985" sldId="278"/>
            <ac:spMk id="37" creationId="{D282B4D4-C164-694F-9EB4-256858B8B38E}"/>
          </ac:spMkLst>
        </pc:spChg>
        <pc:spChg chg="add mod">
          <ac:chgData name="Wencai Zhang" userId="4a86a1d0-2108-4707-8228-1110f3c1be85" providerId="ADAL" clId="{5C5F0646-7A15-7D47-8C0D-14A5E0762118}" dt="2021-06-08T01:25:21.401" v="2918" actId="164"/>
          <ac:spMkLst>
            <pc:docMk/>
            <pc:sldMk cId="2045228985" sldId="278"/>
            <ac:spMk id="38" creationId="{570B18ED-B8C7-3241-B3E2-E3A9CCCD2FEE}"/>
          </ac:spMkLst>
        </pc:spChg>
        <pc:spChg chg="add mod">
          <ac:chgData name="Wencai Zhang" userId="4a86a1d0-2108-4707-8228-1110f3c1be85" providerId="ADAL" clId="{5C5F0646-7A15-7D47-8C0D-14A5E0762118}" dt="2021-06-08T01:20:02.011" v="2587" actId="164"/>
          <ac:spMkLst>
            <pc:docMk/>
            <pc:sldMk cId="2045228985" sldId="278"/>
            <ac:spMk id="39" creationId="{0086EB54-E5D4-3444-9445-7911F88AB37A}"/>
          </ac:spMkLst>
        </pc:spChg>
        <pc:spChg chg="add mod">
          <ac:chgData name="Wencai Zhang" userId="4a86a1d0-2108-4707-8228-1110f3c1be85" providerId="ADAL" clId="{5C5F0646-7A15-7D47-8C0D-14A5E0762118}" dt="2021-06-08T01:20:02.011" v="2587" actId="164"/>
          <ac:spMkLst>
            <pc:docMk/>
            <pc:sldMk cId="2045228985" sldId="278"/>
            <ac:spMk id="41" creationId="{92A4960C-9923-ED40-B98F-A9398175E582}"/>
          </ac:spMkLst>
        </pc:spChg>
        <pc:spChg chg="add mod">
          <ac:chgData name="Wencai Zhang" userId="4a86a1d0-2108-4707-8228-1110f3c1be85" providerId="ADAL" clId="{5C5F0646-7A15-7D47-8C0D-14A5E0762118}" dt="2021-06-08T01:20:07.407" v="2600" actId="1037"/>
          <ac:spMkLst>
            <pc:docMk/>
            <pc:sldMk cId="2045228985" sldId="278"/>
            <ac:spMk id="42" creationId="{150C9E12-90ED-9146-8F64-5124A7BBBE87}"/>
          </ac:spMkLst>
        </pc:spChg>
        <pc:spChg chg="add mod">
          <ac:chgData name="Wencai Zhang" userId="4a86a1d0-2108-4707-8228-1110f3c1be85" providerId="ADAL" clId="{5C5F0646-7A15-7D47-8C0D-14A5E0762118}" dt="2021-06-08T01:20:24.411" v="2603" actId="164"/>
          <ac:spMkLst>
            <pc:docMk/>
            <pc:sldMk cId="2045228985" sldId="278"/>
            <ac:spMk id="43" creationId="{6C3627EF-07F7-4841-B1A5-DE24790D8495}"/>
          </ac:spMkLst>
        </pc:spChg>
        <pc:spChg chg="add mod">
          <ac:chgData name="Wencai Zhang" userId="4a86a1d0-2108-4707-8228-1110f3c1be85" providerId="ADAL" clId="{5C5F0646-7A15-7D47-8C0D-14A5E0762118}" dt="2021-06-08T11:50:36.977" v="3774" actId="14100"/>
          <ac:spMkLst>
            <pc:docMk/>
            <pc:sldMk cId="2045228985" sldId="278"/>
            <ac:spMk id="45" creationId="{3C5E5009-851C-CB45-9843-5356C522C267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46" creationId="{0B7ACEF5-D013-D840-8581-61C747C04761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48" creationId="{D3C38F97-625F-5842-B31B-32500998A458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49" creationId="{5D84001A-23E1-004F-A600-14E854FA58C3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0" creationId="{74D4D2D7-86DC-444A-8395-C142E8F6B1ED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1" creationId="{3D1CA23E-FDAC-904B-8ED6-B6CCF9F15411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2" creationId="{3A906FA0-D5A6-154D-BCE0-FD4B9B4ED8D0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53" creationId="{7E26C633-5159-5041-9816-4A887573CB2B}"/>
          </ac:spMkLst>
        </pc:spChg>
        <pc:spChg chg="add mod">
          <ac:chgData name="Wencai Zhang" userId="4a86a1d0-2108-4707-8228-1110f3c1be85" providerId="ADAL" clId="{5C5F0646-7A15-7D47-8C0D-14A5E0762118}" dt="2021-06-08T01:21:36.205" v="2668" actId="164"/>
          <ac:spMkLst>
            <pc:docMk/>
            <pc:sldMk cId="2045228985" sldId="278"/>
            <ac:spMk id="54" creationId="{A272C607-9214-464B-953F-500C28222462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5" creationId="{82C3FE6F-C4B1-954E-A2B1-2A502B8E9E2D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6" creationId="{C9C6BE3B-8498-6C4C-B589-0449740949F5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7" creationId="{F2469AFE-4A19-F348-AFE2-8B1F0B2A70C8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8" creationId="{0B27AAE0-1CA7-8D40-A2AD-19678610FB0B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59" creationId="{ABAC74D5-8899-E841-8063-0085C8E44E9A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0" creationId="{97DF2A18-2202-6848-A48E-3A8ECA310616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1" creationId="{ECD019EE-B87E-6D41-BA19-2D400F7F75D8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2" creationId="{8614C261-1EA5-E248-92C9-2FB186AA6BC7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63" creationId="{6CEBAD63-4D03-F740-9F6D-D79F3B96E035}"/>
          </ac:spMkLst>
        </pc:spChg>
        <pc:spChg chg="add mod">
          <ac:chgData name="Wencai Zhang" userId="4a86a1d0-2108-4707-8228-1110f3c1be85" providerId="ADAL" clId="{5C5F0646-7A15-7D47-8C0D-14A5E0762118}" dt="2021-06-08T01:20:24.411" v="2603" actId="164"/>
          <ac:spMkLst>
            <pc:docMk/>
            <pc:sldMk cId="2045228985" sldId="278"/>
            <ac:spMk id="64" creationId="{E469F8BB-9E9C-8A49-AC97-F37E7CDCE450}"/>
          </ac:spMkLst>
        </pc:spChg>
        <pc:spChg chg="add mod">
          <ac:chgData name="Wencai Zhang" userId="4a86a1d0-2108-4707-8228-1110f3c1be85" providerId="ADAL" clId="{5C5F0646-7A15-7D47-8C0D-14A5E0762118}" dt="2021-06-08T01:20:24.411" v="2603" actId="164"/>
          <ac:spMkLst>
            <pc:docMk/>
            <pc:sldMk cId="2045228985" sldId="278"/>
            <ac:spMk id="69" creationId="{D0B196F7-0B0A-CE41-9BE7-0B5471A9EA72}"/>
          </ac:spMkLst>
        </pc:spChg>
        <pc:spChg chg="add del mod">
          <ac:chgData name="Wencai Zhang" userId="4a86a1d0-2108-4707-8228-1110f3c1be85" providerId="ADAL" clId="{5C5F0646-7A15-7D47-8C0D-14A5E0762118}" dt="2021-06-07T17:38:04.333" v="94" actId="478"/>
          <ac:spMkLst>
            <pc:docMk/>
            <pc:sldMk cId="2045228985" sldId="278"/>
            <ac:spMk id="70" creationId="{630B3558-B572-2E44-8A3F-5C692D123BFD}"/>
          </ac:spMkLst>
        </pc:spChg>
        <pc:spChg chg="add del mod">
          <ac:chgData name="Wencai Zhang" userId="4a86a1d0-2108-4707-8228-1110f3c1be85" providerId="ADAL" clId="{5C5F0646-7A15-7D47-8C0D-14A5E0762118}" dt="2021-06-07T17:39:31.202" v="106" actId="478"/>
          <ac:spMkLst>
            <pc:docMk/>
            <pc:sldMk cId="2045228985" sldId="278"/>
            <ac:spMk id="71" creationId="{63107F41-FAEB-6C4B-A6E8-C7995D0707CB}"/>
          </ac:spMkLst>
        </pc:spChg>
        <pc:spChg chg="add mod">
          <ac:chgData name="Wencai Zhang" userId="4a86a1d0-2108-4707-8228-1110f3c1be85" providerId="ADAL" clId="{5C5F0646-7A15-7D47-8C0D-14A5E0762118}" dt="2021-06-08T10:41:18.702" v="2940" actId="164"/>
          <ac:spMkLst>
            <pc:docMk/>
            <pc:sldMk cId="2045228985" sldId="278"/>
            <ac:spMk id="71" creationId="{E3213822-3420-9642-B390-EE0B37D304BE}"/>
          </ac:spMkLst>
        </pc:spChg>
        <pc:spChg chg="add mod">
          <ac:chgData name="Wencai Zhang" userId="4a86a1d0-2108-4707-8228-1110f3c1be85" providerId="ADAL" clId="{5C5F0646-7A15-7D47-8C0D-14A5E0762118}" dt="2021-06-08T11:58:42.244" v="3888" actId="1035"/>
          <ac:spMkLst>
            <pc:docMk/>
            <pc:sldMk cId="2045228985" sldId="278"/>
            <ac:spMk id="72" creationId="{223FA3D5-BA87-E34A-B4DF-9CC0D6406B71}"/>
          </ac:spMkLst>
        </pc:spChg>
        <pc:spChg chg="add mod">
          <ac:chgData name="Wencai Zhang" userId="4a86a1d0-2108-4707-8228-1110f3c1be85" providerId="ADAL" clId="{5C5F0646-7A15-7D47-8C0D-14A5E0762118}" dt="2021-06-08T11:58:42.244" v="3888" actId="1035"/>
          <ac:spMkLst>
            <pc:docMk/>
            <pc:sldMk cId="2045228985" sldId="278"/>
            <ac:spMk id="73" creationId="{445E3C3A-3850-6D40-9AB1-17803152274D}"/>
          </ac:spMkLst>
        </pc:spChg>
        <pc:spChg chg="add mod">
          <ac:chgData name="Wencai Zhang" userId="4a86a1d0-2108-4707-8228-1110f3c1be85" providerId="ADAL" clId="{5C5F0646-7A15-7D47-8C0D-14A5E0762118}" dt="2021-06-08T11:59:13.097" v="3912" actId="1038"/>
          <ac:spMkLst>
            <pc:docMk/>
            <pc:sldMk cId="2045228985" sldId="278"/>
            <ac:spMk id="74" creationId="{C2791ACA-8F61-A44C-8156-2E191958E5DD}"/>
          </ac:spMkLst>
        </pc:spChg>
        <pc:spChg chg="add mod">
          <ac:chgData name="Wencai Zhang" userId="4a86a1d0-2108-4707-8228-1110f3c1be85" providerId="ADAL" clId="{5C5F0646-7A15-7D47-8C0D-14A5E0762118}" dt="2021-06-08T11:59:13.097" v="3912" actId="1038"/>
          <ac:spMkLst>
            <pc:docMk/>
            <pc:sldMk cId="2045228985" sldId="278"/>
            <ac:spMk id="75" creationId="{121DBF52-16E2-AD44-B39B-96DC93EEA8D3}"/>
          </ac:spMkLst>
        </pc:spChg>
        <pc:spChg chg="add mod">
          <ac:chgData name="Wencai Zhang" userId="4a86a1d0-2108-4707-8228-1110f3c1be85" providerId="ADAL" clId="{5C5F0646-7A15-7D47-8C0D-14A5E0762118}" dt="2021-06-08T01:23:38.685" v="2775" actId="164"/>
          <ac:spMkLst>
            <pc:docMk/>
            <pc:sldMk cId="2045228985" sldId="278"/>
            <ac:spMk id="76" creationId="{75A65D81-869D-8E42-B21F-041E458A0667}"/>
          </ac:spMkLst>
        </pc:spChg>
        <pc:spChg chg="add mod">
          <ac:chgData name="Wencai Zhang" userId="4a86a1d0-2108-4707-8228-1110f3c1be85" providerId="ADAL" clId="{5C5F0646-7A15-7D47-8C0D-14A5E0762118}" dt="2021-06-08T01:23:38.685" v="2775" actId="164"/>
          <ac:spMkLst>
            <pc:docMk/>
            <pc:sldMk cId="2045228985" sldId="278"/>
            <ac:spMk id="77" creationId="{857443FE-6C09-B242-9031-11D593269B69}"/>
          </ac:spMkLst>
        </pc:spChg>
        <pc:spChg chg="mod">
          <ac:chgData name="Wencai Zhang" userId="4a86a1d0-2108-4707-8228-1110f3c1be85" providerId="ADAL" clId="{5C5F0646-7A15-7D47-8C0D-14A5E0762118}" dt="2021-06-08T10:46:57.253" v="3158" actId="1038"/>
          <ac:spMkLst>
            <pc:docMk/>
            <pc:sldMk cId="2045228985" sldId="278"/>
            <ac:spMk id="79" creationId="{2D15FE00-0512-5944-9E83-41DD767BDEE6}"/>
          </ac:spMkLst>
        </pc:spChg>
        <pc:spChg chg="del mod">
          <ac:chgData name="Wencai Zhang" userId="4a86a1d0-2108-4707-8228-1110f3c1be85" providerId="ADAL" clId="{5C5F0646-7A15-7D47-8C0D-14A5E0762118}" dt="2021-06-08T10:44:46.134" v="2977" actId="478"/>
          <ac:spMkLst>
            <pc:docMk/>
            <pc:sldMk cId="2045228985" sldId="278"/>
            <ac:spMk id="81" creationId="{7A66FD3E-6766-2A42-915F-910ECA66B0FE}"/>
          </ac:spMkLst>
        </pc:spChg>
        <pc:spChg chg="mod">
          <ac:chgData name="Wencai Zhang" userId="4a86a1d0-2108-4707-8228-1110f3c1be85" providerId="ADAL" clId="{5C5F0646-7A15-7D47-8C0D-14A5E0762118}" dt="2021-06-08T10:41:29.374" v="2942"/>
          <ac:spMkLst>
            <pc:docMk/>
            <pc:sldMk cId="2045228985" sldId="278"/>
            <ac:spMk id="82" creationId="{65C824D1-31F5-1F42-91B5-75152B73ACF6}"/>
          </ac:spMkLst>
        </pc:spChg>
        <pc:spChg chg="del mod">
          <ac:chgData name="Wencai Zhang" userId="4a86a1d0-2108-4707-8228-1110f3c1be85" providerId="ADAL" clId="{5C5F0646-7A15-7D47-8C0D-14A5E0762118}" dt="2021-06-08T10:44:51.722" v="2978" actId="478"/>
          <ac:spMkLst>
            <pc:docMk/>
            <pc:sldMk cId="2045228985" sldId="278"/>
            <ac:spMk id="84" creationId="{A070A146-5F9B-0B40-B00E-6426B9D34608}"/>
          </ac:spMkLst>
        </pc:spChg>
        <pc:spChg chg="mod">
          <ac:chgData name="Wencai Zhang" userId="4a86a1d0-2108-4707-8228-1110f3c1be85" providerId="ADAL" clId="{5C5F0646-7A15-7D47-8C0D-14A5E0762118}" dt="2021-06-08T10:47:03.262" v="3179" actId="1035"/>
          <ac:spMkLst>
            <pc:docMk/>
            <pc:sldMk cId="2045228985" sldId="278"/>
            <ac:spMk id="86" creationId="{0224AFF7-2344-4142-A9FB-008C435F5638}"/>
          </ac:spMkLst>
        </pc:spChg>
        <pc:spChg chg="add del mod">
          <ac:chgData name="Wencai Zhang" userId="4a86a1d0-2108-4707-8228-1110f3c1be85" providerId="ADAL" clId="{5C5F0646-7A15-7D47-8C0D-14A5E0762118}" dt="2021-06-07T17:39:19.088" v="103" actId="478"/>
          <ac:spMkLst>
            <pc:docMk/>
            <pc:sldMk cId="2045228985" sldId="278"/>
            <ac:spMk id="86" creationId="{A53113E6-BF07-AC43-BE2C-659BBD6BC17A}"/>
          </ac:spMkLst>
        </pc:spChg>
        <pc:spChg chg="mod">
          <ac:chgData name="Wencai Zhang" userId="4a86a1d0-2108-4707-8228-1110f3c1be85" providerId="ADAL" clId="{5C5F0646-7A15-7D47-8C0D-14A5E0762118}" dt="2021-06-08T10:41:29.374" v="2942"/>
          <ac:spMkLst>
            <pc:docMk/>
            <pc:sldMk cId="2045228985" sldId="278"/>
            <ac:spMk id="87" creationId="{3CE0E168-EFDD-1C43-811C-8EE55390E481}"/>
          </ac:spMkLst>
        </pc:spChg>
        <pc:spChg chg="mod">
          <ac:chgData name="Wencai Zhang" userId="4a86a1d0-2108-4707-8228-1110f3c1be85" providerId="ADAL" clId="{5C5F0646-7A15-7D47-8C0D-14A5E0762118}" dt="2021-06-08T10:45:11.499" v="2990" actId="14100"/>
          <ac:spMkLst>
            <pc:docMk/>
            <pc:sldMk cId="2045228985" sldId="278"/>
            <ac:spMk id="88" creationId="{303924A6-833C-BF46-9BE8-918D6429D292}"/>
          </ac:spMkLst>
        </pc:spChg>
        <pc:spChg chg="mod">
          <ac:chgData name="Wencai Zhang" userId="4a86a1d0-2108-4707-8228-1110f3c1be85" providerId="ADAL" clId="{5C5F0646-7A15-7D47-8C0D-14A5E0762118}" dt="2021-06-08T10:41:29.374" v="2942"/>
          <ac:spMkLst>
            <pc:docMk/>
            <pc:sldMk cId="2045228985" sldId="278"/>
            <ac:spMk id="90" creationId="{C69FE730-1083-AA4A-BF8C-905492255487}"/>
          </ac:spMkLst>
        </pc:spChg>
        <pc:spChg chg="del mod">
          <ac:chgData name="Wencai Zhang" userId="4a86a1d0-2108-4707-8228-1110f3c1be85" providerId="ADAL" clId="{5C5F0646-7A15-7D47-8C0D-14A5E0762118}" dt="2021-06-08T10:45:43.061" v="3032" actId="478"/>
          <ac:spMkLst>
            <pc:docMk/>
            <pc:sldMk cId="2045228985" sldId="278"/>
            <ac:spMk id="92" creationId="{38113A9B-56D3-B445-9FB0-0F366CE5034F}"/>
          </ac:spMkLst>
        </pc:spChg>
        <pc:spChg chg="mod">
          <ac:chgData name="Wencai Zhang" userId="4a86a1d0-2108-4707-8228-1110f3c1be85" providerId="ADAL" clId="{5C5F0646-7A15-7D47-8C0D-14A5E0762118}" dt="2021-06-08T10:45:33.014" v="3031" actId="14100"/>
          <ac:spMkLst>
            <pc:docMk/>
            <pc:sldMk cId="2045228985" sldId="278"/>
            <ac:spMk id="93" creationId="{A71A78CE-A60D-5F4E-8113-980C84C8103F}"/>
          </ac:spMkLst>
        </pc:spChg>
        <pc:spChg chg="mod">
          <ac:chgData name="Wencai Zhang" userId="4a86a1d0-2108-4707-8228-1110f3c1be85" providerId="ADAL" clId="{5C5F0646-7A15-7D47-8C0D-14A5E0762118}" dt="2021-06-08T10:46:50.236" v="3132" actId="1035"/>
          <ac:spMkLst>
            <pc:docMk/>
            <pc:sldMk cId="2045228985" sldId="278"/>
            <ac:spMk id="94" creationId="{6810EC88-3A39-D14A-87EF-0AE63E9D570A}"/>
          </ac:spMkLst>
        </pc:spChg>
        <pc:spChg chg="add del mod">
          <ac:chgData name="Wencai Zhang" userId="4a86a1d0-2108-4707-8228-1110f3c1be85" providerId="ADAL" clId="{5C5F0646-7A15-7D47-8C0D-14A5E0762118}" dt="2021-06-07T17:39:15.335" v="102" actId="478"/>
          <ac:spMkLst>
            <pc:docMk/>
            <pc:sldMk cId="2045228985" sldId="278"/>
            <ac:spMk id="98" creationId="{6749E5C1-0F5E-1F44-9D94-4DDE9EAAE080}"/>
          </ac:spMkLst>
        </pc:spChg>
        <pc:spChg chg="del mod">
          <ac:chgData name="Wencai Zhang" userId="4a86a1d0-2108-4707-8228-1110f3c1be85" providerId="ADAL" clId="{5C5F0646-7A15-7D47-8C0D-14A5E0762118}" dt="2021-06-08T11:59:33.487" v="3913" actId="478"/>
          <ac:spMkLst>
            <pc:docMk/>
            <pc:sldMk cId="2045228985" sldId="278"/>
            <ac:spMk id="98" creationId="{AF56C818-050F-4249-A321-E028AC1E34C5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99" creationId="{E16D0CE1-AA5F-BA43-8A35-5AA6FA150428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100" creationId="{AEC18921-28C3-9C48-B482-105C24A8C64E}"/>
          </ac:spMkLst>
        </pc:spChg>
        <pc:spChg chg="add mod">
          <ac:chgData name="Wencai Zhang" userId="4a86a1d0-2108-4707-8228-1110f3c1be85" providerId="ADAL" clId="{5C5F0646-7A15-7D47-8C0D-14A5E0762118}" dt="2021-06-08T01:16:08.114" v="2387" actId="255"/>
          <ac:spMkLst>
            <pc:docMk/>
            <pc:sldMk cId="2045228985" sldId="278"/>
            <ac:spMk id="101" creationId="{D21D289D-C025-9449-8223-52D88B3EE886}"/>
          </ac:spMkLst>
        </pc:spChg>
        <pc:spChg chg="add del mod">
          <ac:chgData name="Wencai Zhang" userId="4a86a1d0-2108-4707-8228-1110f3c1be85" providerId="ADAL" clId="{5C5F0646-7A15-7D47-8C0D-14A5E0762118}" dt="2021-06-07T17:55:42.002" v="534" actId="478"/>
          <ac:spMkLst>
            <pc:docMk/>
            <pc:sldMk cId="2045228985" sldId="278"/>
            <ac:spMk id="103" creationId="{9C086AA5-BBBF-454F-98A6-EB8D670C341E}"/>
          </ac:spMkLst>
        </pc:spChg>
        <pc:spChg chg="mod">
          <ac:chgData name="Wencai Zhang" userId="4a86a1d0-2108-4707-8228-1110f3c1be85" providerId="ADAL" clId="{5C5F0646-7A15-7D47-8C0D-14A5E0762118}" dt="2021-06-08T11:49:06.350" v="3755" actId="1037"/>
          <ac:spMkLst>
            <pc:docMk/>
            <pc:sldMk cId="2045228985" sldId="278"/>
            <ac:spMk id="104" creationId="{765F1389-2585-6C49-B504-8C2EA8B7897C}"/>
          </ac:spMkLst>
        </pc:spChg>
        <pc:spChg chg="mod">
          <ac:chgData name="Wencai Zhang" userId="4a86a1d0-2108-4707-8228-1110f3c1be85" providerId="ADAL" clId="{5C5F0646-7A15-7D47-8C0D-14A5E0762118}" dt="2021-06-08T11:59:42.965" v="3919" actId="1038"/>
          <ac:spMkLst>
            <pc:docMk/>
            <pc:sldMk cId="2045228985" sldId="278"/>
            <ac:spMk id="105" creationId="{83EBEEEE-9971-7842-9451-CBDBF8776B8E}"/>
          </ac:spMkLst>
        </pc:spChg>
        <pc:spChg chg="del mod">
          <ac:chgData name="Wencai Zhang" userId="4a86a1d0-2108-4707-8228-1110f3c1be85" providerId="ADAL" clId="{5C5F0646-7A15-7D47-8C0D-14A5E0762118}" dt="2021-06-08T11:48:36.542" v="3734" actId="478"/>
          <ac:spMkLst>
            <pc:docMk/>
            <pc:sldMk cId="2045228985" sldId="278"/>
            <ac:spMk id="106" creationId="{34741228-EB91-DB44-95CA-3F38967C9350}"/>
          </ac:spMkLst>
        </pc:spChg>
        <pc:spChg chg="mod">
          <ac:chgData name="Wencai Zhang" userId="4a86a1d0-2108-4707-8228-1110f3c1be85" providerId="ADAL" clId="{5C5F0646-7A15-7D47-8C0D-14A5E0762118}" dt="2021-06-08T11:47:58.070" v="3695" actId="1038"/>
          <ac:spMkLst>
            <pc:docMk/>
            <pc:sldMk cId="2045228985" sldId="278"/>
            <ac:spMk id="107" creationId="{D1EDC430-2EF4-1C42-92EE-7258EA835BC2}"/>
          </ac:spMkLst>
        </pc:spChg>
        <pc:spChg chg="mod">
          <ac:chgData name="Wencai Zhang" userId="4a86a1d0-2108-4707-8228-1110f3c1be85" providerId="ADAL" clId="{5C5F0646-7A15-7D47-8C0D-14A5E0762118}" dt="2021-06-08T11:45:37.722" v="3519" actId="1037"/>
          <ac:spMkLst>
            <pc:docMk/>
            <pc:sldMk cId="2045228985" sldId="278"/>
            <ac:spMk id="108" creationId="{D0CE798E-F7CE-5F44-B0A0-58C746430465}"/>
          </ac:spMkLst>
        </pc:spChg>
        <pc:spChg chg="mod">
          <ac:chgData name="Wencai Zhang" userId="4a86a1d0-2108-4707-8228-1110f3c1be85" providerId="ADAL" clId="{5C5F0646-7A15-7D47-8C0D-14A5E0762118}" dt="2021-06-08T11:48:15.797" v="3719" actId="14100"/>
          <ac:spMkLst>
            <pc:docMk/>
            <pc:sldMk cId="2045228985" sldId="278"/>
            <ac:spMk id="110" creationId="{BFD65373-A8C1-3045-8262-BEBFB0F691F4}"/>
          </ac:spMkLst>
        </pc:spChg>
        <pc:spChg chg="mod">
          <ac:chgData name="Wencai Zhang" userId="4a86a1d0-2108-4707-8228-1110f3c1be85" providerId="ADAL" clId="{5C5F0646-7A15-7D47-8C0D-14A5E0762118}" dt="2021-06-08T10:49:18.115" v="3182"/>
          <ac:spMkLst>
            <pc:docMk/>
            <pc:sldMk cId="2045228985" sldId="278"/>
            <ac:spMk id="112" creationId="{79768528-A358-2D49-8809-E14A1220D416}"/>
          </ac:spMkLst>
        </pc:spChg>
        <pc:spChg chg="mod">
          <ac:chgData name="Wencai Zhang" userId="4a86a1d0-2108-4707-8228-1110f3c1be85" providerId="ADAL" clId="{5C5F0646-7A15-7D47-8C0D-14A5E0762118}" dt="2021-06-08T11:45:27.181" v="3477" actId="1037"/>
          <ac:spMkLst>
            <pc:docMk/>
            <pc:sldMk cId="2045228985" sldId="278"/>
            <ac:spMk id="113" creationId="{40661F04-C12C-444B-B019-7A6D2F092D11}"/>
          </ac:spMkLst>
        </pc:spChg>
        <pc:spChg chg="del mod">
          <ac:chgData name="Wencai Zhang" userId="4a86a1d0-2108-4707-8228-1110f3c1be85" providerId="ADAL" clId="{5C5F0646-7A15-7D47-8C0D-14A5E0762118}" dt="2021-06-08T11:46:57.768" v="3531" actId="478"/>
          <ac:spMkLst>
            <pc:docMk/>
            <pc:sldMk cId="2045228985" sldId="278"/>
            <ac:spMk id="114" creationId="{AEE39998-A9D7-4B4D-BDAD-4D4B838CC9D0}"/>
          </ac:spMkLst>
        </pc:spChg>
        <pc:spChg chg="mod">
          <ac:chgData name="Wencai Zhang" userId="4a86a1d0-2108-4707-8228-1110f3c1be85" providerId="ADAL" clId="{5C5F0646-7A15-7D47-8C0D-14A5E0762118}" dt="2021-06-08T11:48:27.365" v="3733" actId="14100"/>
          <ac:spMkLst>
            <pc:docMk/>
            <pc:sldMk cId="2045228985" sldId="278"/>
            <ac:spMk id="115" creationId="{8B0D4E29-5186-034D-8BD4-5A5AC419FEDE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16" creationId="{8DD2498C-F0E3-6342-A0F5-25324F8FED73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17" creationId="{FC33CF33-548D-E946-924C-B09E79AF305A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18" creationId="{E0813993-66DF-0840-8F4C-47DBBFD8966B}"/>
          </ac:spMkLst>
        </pc:spChg>
        <pc:spChg chg="add mod">
          <ac:chgData name="Wencai Zhang" userId="4a86a1d0-2108-4707-8228-1110f3c1be85" providerId="ADAL" clId="{5C5F0646-7A15-7D47-8C0D-14A5E0762118}" dt="2021-06-08T11:52:22.642" v="3807" actId="1035"/>
          <ac:spMkLst>
            <pc:docMk/>
            <pc:sldMk cId="2045228985" sldId="278"/>
            <ac:spMk id="119" creationId="{8643EBF5-093B-734B-9442-8B2AD6E3F52D}"/>
          </ac:spMkLst>
        </pc:spChg>
        <pc:spChg chg="add mod">
          <ac:chgData name="Wencai Zhang" userId="4a86a1d0-2108-4707-8228-1110f3c1be85" providerId="ADAL" clId="{5C5F0646-7A15-7D47-8C0D-14A5E0762118}" dt="2021-06-08T11:50:55.264" v="3799" actId="1038"/>
          <ac:spMkLst>
            <pc:docMk/>
            <pc:sldMk cId="2045228985" sldId="278"/>
            <ac:spMk id="120" creationId="{BED92353-28E4-4643-90D3-4560DD628D3F}"/>
          </ac:spMkLst>
        </pc:spChg>
        <pc:spChg chg="add mod">
          <ac:chgData name="Wencai Zhang" userId="4a86a1d0-2108-4707-8228-1110f3c1be85" providerId="ADAL" clId="{5C5F0646-7A15-7D47-8C0D-14A5E0762118}" dt="2021-06-08T11:51:34.968" v="3801" actId="1076"/>
          <ac:spMkLst>
            <pc:docMk/>
            <pc:sldMk cId="2045228985" sldId="278"/>
            <ac:spMk id="121" creationId="{DA452C9B-23D6-DC4F-9509-32DE6C78F7F5}"/>
          </ac:spMkLst>
        </pc:spChg>
        <pc:spChg chg="add mod">
          <ac:chgData name="Wencai Zhang" userId="4a86a1d0-2108-4707-8228-1110f3c1be85" providerId="ADAL" clId="{5C5F0646-7A15-7D47-8C0D-14A5E0762118}" dt="2021-06-08T11:57:23.246" v="3823" actId="1037"/>
          <ac:spMkLst>
            <pc:docMk/>
            <pc:sldMk cId="2045228985" sldId="278"/>
            <ac:spMk id="122" creationId="{0CC7DB87-FD1B-9A46-95DD-3CB778F2DEFB}"/>
          </ac:spMkLst>
        </pc:spChg>
        <pc:spChg chg="add mod">
          <ac:chgData name="Wencai Zhang" userId="4a86a1d0-2108-4707-8228-1110f3c1be85" providerId="ADAL" clId="{5C5F0646-7A15-7D47-8C0D-14A5E0762118}" dt="2021-06-08T11:57:16.231" v="3808"/>
          <ac:spMkLst>
            <pc:docMk/>
            <pc:sldMk cId="2045228985" sldId="278"/>
            <ac:spMk id="123" creationId="{F8879FD2-5F0B-ED4B-9872-81F5DD67350C}"/>
          </ac:spMkLst>
        </pc:spChg>
        <pc:grpChg chg="add mod">
          <ac:chgData name="Wencai Zhang" userId="4a86a1d0-2108-4707-8228-1110f3c1be85" providerId="ADAL" clId="{5C5F0646-7A15-7D47-8C0D-14A5E0762118}" dt="2021-06-08T11:50:17.202" v="3763" actId="164"/>
          <ac:grpSpMkLst>
            <pc:docMk/>
            <pc:sldMk cId="2045228985" sldId="278"/>
            <ac:grpSpMk id="4" creationId="{2881E2D2-A537-0E4A-9EFA-1161509D392E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5" creationId="{80BE336B-A0D3-9949-8CAD-CF17DF5B28FA}"/>
          </ac:grpSpMkLst>
        </pc:grpChg>
        <pc:grpChg chg="add mod">
          <ac:chgData name="Wencai Zhang" userId="4a86a1d0-2108-4707-8228-1110f3c1be85" providerId="ADAL" clId="{5C5F0646-7A15-7D47-8C0D-14A5E0762118}" dt="2021-06-08T11:50:17.202" v="3763" actId="164"/>
          <ac:grpSpMkLst>
            <pc:docMk/>
            <pc:sldMk cId="2045228985" sldId="278"/>
            <ac:grpSpMk id="6" creationId="{A796EEB1-AAA4-4648-95D5-F05612CB1F81}"/>
          </ac:grpSpMkLst>
        </pc:grpChg>
        <pc:grpChg chg="add mod">
          <ac:chgData name="Wencai Zhang" userId="4a86a1d0-2108-4707-8228-1110f3c1be85" providerId="ADAL" clId="{5C5F0646-7A15-7D47-8C0D-14A5E0762118}" dt="2021-06-08T11:50:17.202" v="3763" actId="164"/>
          <ac:grpSpMkLst>
            <pc:docMk/>
            <pc:sldMk cId="2045228985" sldId="278"/>
            <ac:grpSpMk id="7" creationId="{F416A38E-5E29-6642-A344-BFC2B9F755A8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8" creationId="{DBC43DD5-7B26-FA4C-A01E-ADF56FF5CFD6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9" creationId="{03CF96C0-9E8F-5B4B-ACEC-8AFED5A867C0}"/>
          </ac:grpSpMkLst>
        </pc:grpChg>
        <pc:grpChg chg="add mod">
          <ac:chgData name="Wencai Zhang" userId="4a86a1d0-2108-4707-8228-1110f3c1be85" providerId="ADAL" clId="{5C5F0646-7A15-7D47-8C0D-14A5E0762118}" dt="2021-06-08T10:41:18.702" v="2940" actId="164"/>
          <ac:grpSpMkLst>
            <pc:docMk/>
            <pc:sldMk cId="2045228985" sldId="278"/>
            <ac:grpSpMk id="10" creationId="{532EB402-200F-2844-86F8-9CBA5C88B0BD}"/>
          </ac:grpSpMkLst>
        </pc:grpChg>
        <pc:grpChg chg="del">
          <ac:chgData name="Wencai Zhang" userId="4a86a1d0-2108-4707-8228-1110f3c1be85" providerId="ADAL" clId="{5C5F0646-7A15-7D47-8C0D-14A5E0762118}" dt="2021-06-07T17:28:47.222" v="8" actId="478"/>
          <ac:grpSpMkLst>
            <pc:docMk/>
            <pc:sldMk cId="2045228985" sldId="278"/>
            <ac:grpSpMk id="10" creationId="{CBAE5C45-A501-B646-B027-69E1A9B7C103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11" creationId="{2ED4766E-103C-5A4C-9923-289E791A35BF}"/>
          </ac:grpSpMkLst>
        </pc:grpChg>
        <pc:grpChg chg="add mod">
          <ac:chgData name="Wencai Zhang" userId="4a86a1d0-2108-4707-8228-1110f3c1be85" providerId="ADAL" clId="{5C5F0646-7A15-7D47-8C0D-14A5E0762118}" dt="2021-06-07T17:55:21.706" v="533" actId="164"/>
          <ac:grpSpMkLst>
            <pc:docMk/>
            <pc:sldMk cId="2045228985" sldId="278"/>
            <ac:grpSpMk id="12" creationId="{825C48DF-C309-0A4C-BA03-D7AC1BD8B1B3}"/>
          </ac:grpSpMkLst>
        </pc:grpChg>
        <pc:grpChg chg="add mod">
          <ac:chgData name="Wencai Zhang" userId="4a86a1d0-2108-4707-8228-1110f3c1be85" providerId="ADAL" clId="{5C5F0646-7A15-7D47-8C0D-14A5E0762118}" dt="2021-06-07T17:55:53.455" v="535" actId="164"/>
          <ac:grpSpMkLst>
            <pc:docMk/>
            <pc:sldMk cId="2045228985" sldId="278"/>
            <ac:grpSpMk id="13" creationId="{E598268A-77CC-5446-B5EC-6C2E982E6F1B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4" creationId="{13303575-95DC-9C46-944A-55D1DD127963}"/>
          </ac:grpSpMkLst>
        </pc:grpChg>
        <pc:grpChg chg="add mod">
          <ac:chgData name="Wencai Zhang" userId="4a86a1d0-2108-4707-8228-1110f3c1be85" providerId="ADAL" clId="{5C5F0646-7A15-7D47-8C0D-14A5E0762118}" dt="2021-06-08T10:41:18.702" v="2940" actId="164"/>
          <ac:grpSpMkLst>
            <pc:docMk/>
            <pc:sldMk cId="2045228985" sldId="278"/>
            <ac:grpSpMk id="15" creationId="{6C820B00-9DC7-5341-8D47-ED870E5152F4}"/>
          </ac:grpSpMkLst>
        </pc:grpChg>
        <pc:grpChg chg="add mod">
          <ac:chgData name="Wencai Zhang" userId="4a86a1d0-2108-4707-8228-1110f3c1be85" providerId="ADAL" clId="{5C5F0646-7A15-7D47-8C0D-14A5E0762118}" dt="2021-06-08T10:41:18.702" v="2940" actId="164"/>
          <ac:grpSpMkLst>
            <pc:docMk/>
            <pc:sldMk cId="2045228985" sldId="278"/>
            <ac:grpSpMk id="16" creationId="{D5D0644F-D14F-0148-B455-94DE045A596D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7" creationId="{6E60DABA-1C1A-C040-85FC-ADEC9B0924CE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8" creationId="{C60C65AD-2EBD-BD46-858D-EAF4332E4B5B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19" creationId="{AF214937-88ED-FC4C-84F1-4262D7E51D4F}"/>
          </ac:grpSpMkLst>
        </pc:grpChg>
        <pc:grpChg chg="add mod">
          <ac:chgData name="Wencai Zhang" userId="4a86a1d0-2108-4707-8228-1110f3c1be85" providerId="ADAL" clId="{5C5F0646-7A15-7D47-8C0D-14A5E0762118}" dt="2021-06-08T10:47:16.415" v="3180" actId="164"/>
          <ac:grpSpMkLst>
            <pc:docMk/>
            <pc:sldMk cId="2045228985" sldId="278"/>
            <ac:grpSpMk id="78" creationId="{D7ECAB18-9483-D842-8C55-FB6BC4670F30}"/>
          </ac:grpSpMkLst>
        </pc:grpChg>
        <pc:grpChg chg="add mod">
          <ac:chgData name="Wencai Zhang" userId="4a86a1d0-2108-4707-8228-1110f3c1be85" providerId="ADAL" clId="{5C5F0646-7A15-7D47-8C0D-14A5E0762118}" dt="2021-06-08T10:47:16.415" v="3180" actId="164"/>
          <ac:grpSpMkLst>
            <pc:docMk/>
            <pc:sldMk cId="2045228985" sldId="278"/>
            <ac:grpSpMk id="83" creationId="{0FACEB98-10A6-3C48-938C-E5A67F6E37CB}"/>
          </ac:grpSpMkLst>
        </pc:grpChg>
        <pc:grpChg chg="add mod">
          <ac:chgData name="Wencai Zhang" userId="4a86a1d0-2108-4707-8228-1110f3c1be85" providerId="ADAL" clId="{5C5F0646-7A15-7D47-8C0D-14A5E0762118}" dt="2021-06-08T10:47:16.415" v="3180" actId="164"/>
          <ac:grpSpMkLst>
            <pc:docMk/>
            <pc:sldMk cId="2045228985" sldId="278"/>
            <ac:grpSpMk id="89" creationId="{5735C2EE-2235-7145-8F75-456025E86603}"/>
          </ac:grpSpMkLst>
        </pc:grpChg>
        <pc:grpChg chg="del">
          <ac:chgData name="Wencai Zhang" userId="4a86a1d0-2108-4707-8228-1110f3c1be85" providerId="ADAL" clId="{5C5F0646-7A15-7D47-8C0D-14A5E0762118}" dt="2021-06-07T17:28:47.222" v="8" actId="478"/>
          <ac:grpSpMkLst>
            <pc:docMk/>
            <pc:sldMk cId="2045228985" sldId="278"/>
            <ac:grpSpMk id="90" creationId="{928B9537-0813-2A4E-8322-595CDB2EC21B}"/>
          </ac:grpSpMkLst>
        </pc:grpChg>
        <pc:grpChg chg="add mod">
          <ac:chgData name="Wencai Zhang" userId="4a86a1d0-2108-4707-8228-1110f3c1be85" providerId="ADAL" clId="{5C5F0646-7A15-7D47-8C0D-14A5E0762118}" dt="2021-06-08T11:50:55.264" v="3799" actId="1038"/>
          <ac:grpSpMkLst>
            <pc:docMk/>
            <pc:sldMk cId="2045228985" sldId="278"/>
            <ac:grpSpMk id="95" creationId="{5A92389F-CB63-B84C-B2A1-0F4259666E50}"/>
          </ac:grpSpMkLst>
        </pc:grpChg>
        <pc:grpChg chg="mod">
          <ac:chgData name="Wencai Zhang" userId="4a86a1d0-2108-4707-8228-1110f3c1be85" providerId="ADAL" clId="{5C5F0646-7A15-7D47-8C0D-14A5E0762118}" dt="2021-06-08T10:49:18.115" v="3182"/>
          <ac:grpSpMkLst>
            <pc:docMk/>
            <pc:sldMk cId="2045228985" sldId="278"/>
            <ac:grpSpMk id="96" creationId="{E87C7B4E-9D94-CB4E-A494-CDA35ED62BDC}"/>
          </ac:grpSpMkLst>
        </pc:grpChg>
        <pc:grpChg chg="mod">
          <ac:chgData name="Wencai Zhang" userId="4a86a1d0-2108-4707-8228-1110f3c1be85" providerId="ADAL" clId="{5C5F0646-7A15-7D47-8C0D-14A5E0762118}" dt="2021-06-08T10:49:18.115" v="3182"/>
          <ac:grpSpMkLst>
            <pc:docMk/>
            <pc:sldMk cId="2045228985" sldId="278"/>
            <ac:grpSpMk id="97" creationId="{20F1B5F2-82FA-824E-B98E-1F8D4EBE6731}"/>
          </ac:grpSpMkLst>
        </pc:grpChg>
        <pc:grpChg chg="mod">
          <ac:chgData name="Wencai Zhang" userId="4a86a1d0-2108-4707-8228-1110f3c1be85" providerId="ADAL" clId="{5C5F0646-7A15-7D47-8C0D-14A5E0762118}" dt="2021-06-08T10:49:18.115" v="3182"/>
          <ac:grpSpMkLst>
            <pc:docMk/>
            <pc:sldMk cId="2045228985" sldId="278"/>
            <ac:grpSpMk id="102" creationId="{9C53E050-794A-B240-8A76-2501A1A5197E}"/>
          </ac:grpSpMkLst>
        </pc:grpChg>
        <pc:picChg chg="add mod">
          <ac:chgData name="Wencai Zhang" userId="4a86a1d0-2108-4707-8228-1110f3c1be85" providerId="ADAL" clId="{5C5F0646-7A15-7D47-8C0D-14A5E0762118}" dt="2021-06-08T01:24:58.136" v="2886" actId="164"/>
          <ac:picMkLst>
            <pc:docMk/>
            <pc:sldMk cId="2045228985" sldId="278"/>
            <ac:picMk id="30" creationId="{C818E5B3-773B-EE46-BFF1-A5608292A606}"/>
          </ac:picMkLst>
        </pc:picChg>
        <pc:picChg chg="add mod">
          <ac:chgData name="Wencai Zhang" userId="4a86a1d0-2108-4707-8228-1110f3c1be85" providerId="ADAL" clId="{5C5F0646-7A15-7D47-8C0D-14A5E0762118}" dt="2021-06-08T01:25:21.401" v="2918" actId="164"/>
          <ac:picMkLst>
            <pc:docMk/>
            <pc:sldMk cId="2045228985" sldId="278"/>
            <ac:picMk id="35" creationId="{AE61B484-3A61-824C-881D-9E6BF52DD788}"/>
          </ac:picMkLst>
        </pc:picChg>
        <pc:picChg chg="add mod">
          <ac:chgData name="Wencai Zhang" userId="4a86a1d0-2108-4707-8228-1110f3c1be85" providerId="ADAL" clId="{5C5F0646-7A15-7D47-8C0D-14A5E0762118}" dt="2021-06-08T01:20:02.011" v="2587" actId="164"/>
          <ac:picMkLst>
            <pc:docMk/>
            <pc:sldMk cId="2045228985" sldId="278"/>
            <ac:picMk id="40" creationId="{1CF072EE-D463-994C-B005-8C8EDDE5F73E}"/>
          </ac:picMkLst>
        </pc:picChg>
        <pc:picChg chg="add mod">
          <ac:chgData name="Wencai Zhang" userId="4a86a1d0-2108-4707-8228-1110f3c1be85" providerId="ADAL" clId="{5C5F0646-7A15-7D47-8C0D-14A5E0762118}" dt="2021-06-08T01:20:24.411" v="2603" actId="164"/>
          <ac:picMkLst>
            <pc:docMk/>
            <pc:sldMk cId="2045228985" sldId="278"/>
            <ac:picMk id="44" creationId="{17B1CC55-4E37-5542-A976-3B5705905445}"/>
          </ac:picMkLst>
        </pc:picChg>
        <pc:picChg chg="add mod">
          <ac:chgData name="Wencai Zhang" userId="4a86a1d0-2108-4707-8228-1110f3c1be85" providerId="ADAL" clId="{5C5F0646-7A15-7D47-8C0D-14A5E0762118}" dt="2021-06-08T01:21:36.205" v="2668" actId="164"/>
          <ac:picMkLst>
            <pc:docMk/>
            <pc:sldMk cId="2045228985" sldId="278"/>
            <ac:picMk id="47" creationId="{BE744EF5-D865-6046-96FB-231F8DA60AF6}"/>
          </ac:picMkLst>
        </pc:picChg>
        <pc:picChg chg="add mod modCrop">
          <ac:chgData name="Wencai Zhang" userId="4a86a1d0-2108-4707-8228-1110f3c1be85" providerId="ADAL" clId="{5C5F0646-7A15-7D47-8C0D-14A5E0762118}" dt="2021-06-07T17:48:37.638" v="255" actId="164"/>
          <ac:picMkLst>
            <pc:docMk/>
            <pc:sldMk cId="2045228985" sldId="278"/>
            <ac:picMk id="65" creationId="{435A8AB8-62ED-B142-84A0-6CE24DF457AD}"/>
          </ac:picMkLst>
        </pc:picChg>
        <pc:picChg chg="add mod modCrop">
          <ac:chgData name="Wencai Zhang" userId="4a86a1d0-2108-4707-8228-1110f3c1be85" providerId="ADAL" clId="{5C5F0646-7A15-7D47-8C0D-14A5E0762118}" dt="2021-06-07T17:48:31.247" v="254" actId="164"/>
          <ac:picMkLst>
            <pc:docMk/>
            <pc:sldMk cId="2045228985" sldId="278"/>
            <ac:picMk id="66" creationId="{31E91AA4-113D-3C4A-9006-DA0863C1D483}"/>
          </ac:picMkLst>
        </pc:picChg>
        <pc:picChg chg="add mod modCrop">
          <ac:chgData name="Wencai Zhang" userId="4a86a1d0-2108-4707-8228-1110f3c1be85" providerId="ADAL" clId="{5C5F0646-7A15-7D47-8C0D-14A5E0762118}" dt="2021-06-07T17:48:26.122" v="253" actId="164"/>
          <ac:picMkLst>
            <pc:docMk/>
            <pc:sldMk cId="2045228985" sldId="278"/>
            <ac:picMk id="67" creationId="{D7686E8E-AF5B-4145-830C-C53378B9E2E8}"/>
          </ac:picMkLst>
        </pc:picChg>
        <pc:picChg chg="add mod modCrop">
          <ac:chgData name="Wencai Zhang" userId="4a86a1d0-2108-4707-8228-1110f3c1be85" providerId="ADAL" clId="{5C5F0646-7A15-7D47-8C0D-14A5E0762118}" dt="2021-06-07T17:48:16.593" v="251" actId="164"/>
          <ac:picMkLst>
            <pc:docMk/>
            <pc:sldMk cId="2045228985" sldId="278"/>
            <ac:picMk id="68" creationId="{A7E5810E-1B2A-0643-813E-B157FEEC2A21}"/>
          </ac:picMkLst>
        </pc:picChg>
        <pc:picChg chg="add mod">
          <ac:chgData name="Wencai Zhang" userId="4a86a1d0-2108-4707-8228-1110f3c1be85" providerId="ADAL" clId="{5C5F0646-7A15-7D47-8C0D-14A5E0762118}" dt="2021-06-08T01:23:38.685" v="2775" actId="164"/>
          <ac:picMkLst>
            <pc:docMk/>
            <pc:sldMk cId="2045228985" sldId="278"/>
            <ac:picMk id="70" creationId="{4F969F2B-1BE1-5C42-89D3-C291460CAA91}"/>
          </ac:picMkLst>
        </pc:picChg>
        <pc:picChg chg="mod modCrop">
          <ac:chgData name="Wencai Zhang" userId="4a86a1d0-2108-4707-8228-1110f3c1be85" providerId="ADAL" clId="{5C5F0646-7A15-7D47-8C0D-14A5E0762118}" dt="2021-06-08T10:44:23.727" v="2976" actId="18131"/>
          <ac:picMkLst>
            <pc:docMk/>
            <pc:sldMk cId="2045228985" sldId="278"/>
            <ac:picMk id="80" creationId="{C1AC867E-F558-4B4F-945F-11FC4DC3DBE6}"/>
          </ac:picMkLst>
        </pc:picChg>
        <pc:picChg chg="mod modCrop">
          <ac:chgData name="Wencai Zhang" userId="4a86a1d0-2108-4707-8228-1110f3c1be85" providerId="ADAL" clId="{5C5F0646-7A15-7D47-8C0D-14A5E0762118}" dt="2021-06-08T10:43:13.297" v="2948" actId="732"/>
          <ac:picMkLst>
            <pc:docMk/>
            <pc:sldMk cId="2045228985" sldId="278"/>
            <ac:picMk id="85" creationId="{E729942D-1AC9-C14B-94F1-859BFE5BADF5}"/>
          </ac:picMkLst>
        </pc:picChg>
        <pc:picChg chg="mod modCrop">
          <ac:chgData name="Wencai Zhang" userId="4a86a1d0-2108-4707-8228-1110f3c1be85" providerId="ADAL" clId="{5C5F0646-7A15-7D47-8C0D-14A5E0762118}" dt="2021-06-08T11:45:13.949" v="3449" actId="1037"/>
          <ac:picMkLst>
            <pc:docMk/>
            <pc:sldMk cId="2045228985" sldId="278"/>
            <ac:picMk id="91" creationId="{9FDB131C-0D47-AD4B-BF03-E9E0826CE460}"/>
          </ac:picMkLst>
        </pc:picChg>
        <pc:picChg chg="add del mod">
          <ac:chgData name="Wencai Zhang" userId="4a86a1d0-2108-4707-8228-1110f3c1be85" providerId="ADAL" clId="{5C5F0646-7A15-7D47-8C0D-14A5E0762118}" dt="2021-06-07T17:55:42.002" v="534" actId="478"/>
          <ac:picMkLst>
            <pc:docMk/>
            <pc:sldMk cId="2045228985" sldId="278"/>
            <ac:picMk id="102" creationId="{D224BD53-BD81-B647-B113-665A418DFB65}"/>
          </ac:picMkLst>
        </pc:picChg>
        <pc:picChg chg="mod modCrop">
          <ac:chgData name="Wencai Zhang" userId="4a86a1d0-2108-4707-8228-1110f3c1be85" providerId="ADAL" clId="{5C5F0646-7A15-7D47-8C0D-14A5E0762118}" dt="2021-06-08T11:48:55.009" v="3736" actId="732"/>
          <ac:picMkLst>
            <pc:docMk/>
            <pc:sldMk cId="2045228985" sldId="278"/>
            <ac:picMk id="103" creationId="{542CEB86-8C97-5D46-AFEB-583EAC11B9CC}"/>
          </ac:picMkLst>
        </pc:picChg>
        <pc:picChg chg="mod modCrop">
          <ac:chgData name="Wencai Zhang" userId="4a86a1d0-2108-4707-8228-1110f3c1be85" providerId="ADAL" clId="{5C5F0646-7A15-7D47-8C0D-14A5E0762118}" dt="2021-06-08T11:47:43.683" v="3654" actId="1035"/>
          <ac:picMkLst>
            <pc:docMk/>
            <pc:sldMk cId="2045228985" sldId="278"/>
            <ac:picMk id="109" creationId="{549D7B5A-6C28-4C49-91BA-9E2E78758AE0}"/>
          </ac:picMkLst>
        </pc:picChg>
        <pc:picChg chg="mod modCrop">
          <ac:chgData name="Wencai Zhang" userId="4a86a1d0-2108-4707-8228-1110f3c1be85" providerId="ADAL" clId="{5C5F0646-7A15-7D47-8C0D-14A5E0762118}" dt="2021-06-08T10:49:43.227" v="3184" actId="732"/>
          <ac:picMkLst>
            <pc:docMk/>
            <pc:sldMk cId="2045228985" sldId="278"/>
            <ac:picMk id="111" creationId="{B0A817B9-7B93-364B-97A8-3729A26CF89F}"/>
          </ac:picMkLst>
        </pc:picChg>
      </pc:sldChg>
      <pc:sldChg chg="delSp modSp mod">
        <pc:chgData name="Wencai Zhang" userId="4a86a1d0-2108-4707-8228-1110f3c1be85" providerId="ADAL" clId="{5C5F0646-7A15-7D47-8C0D-14A5E0762118}" dt="2021-06-08T21:28:44.800" v="3922" actId="1076"/>
        <pc:sldMkLst>
          <pc:docMk/>
          <pc:sldMk cId="1997077850" sldId="279"/>
        </pc:sldMkLst>
        <pc:spChg chg="mod">
          <ac:chgData name="Wencai Zhang" userId="4a86a1d0-2108-4707-8228-1110f3c1be85" providerId="ADAL" clId="{5C5F0646-7A15-7D47-8C0D-14A5E0762118}" dt="2021-06-08T21:28:44.800" v="3922" actId="1076"/>
          <ac:spMkLst>
            <pc:docMk/>
            <pc:sldMk cId="1997077850" sldId="279"/>
            <ac:spMk id="3" creationId="{7C8F372B-FAE8-CE44-A95C-EFB214B632AE}"/>
          </ac:spMkLst>
        </pc:spChg>
        <pc:spChg chg="mod">
          <ac:chgData name="Wencai Zhang" userId="4a86a1d0-2108-4707-8228-1110f3c1be85" providerId="ADAL" clId="{5C5F0646-7A15-7D47-8C0D-14A5E0762118}" dt="2021-06-08T21:28:40.967" v="3921" actId="1076"/>
          <ac:spMkLst>
            <pc:docMk/>
            <pc:sldMk cId="1997077850" sldId="279"/>
            <ac:spMk id="120" creationId="{BED92353-28E4-4643-90D3-4560DD628D3F}"/>
          </ac:spMkLst>
        </pc:spChg>
        <pc:spChg chg="del">
          <ac:chgData name="Wencai Zhang" userId="4a86a1d0-2108-4707-8228-1110f3c1be85" providerId="ADAL" clId="{5C5F0646-7A15-7D47-8C0D-14A5E0762118}" dt="2021-06-08T21:26:53.440" v="3920" actId="478"/>
          <ac:spMkLst>
            <pc:docMk/>
            <pc:sldMk cId="1997077850" sldId="279"/>
            <ac:spMk id="246" creationId="{A6F3F460-1C39-4A41-B6EA-9B08EAA99A0D}"/>
          </ac:spMkLst>
        </pc:spChg>
      </pc:sldChg>
      <pc:sldChg chg="ord">
        <pc:chgData name="Wencai Zhang" userId="4a86a1d0-2108-4707-8228-1110f3c1be85" providerId="ADAL" clId="{5C5F0646-7A15-7D47-8C0D-14A5E0762118}" dt="2021-06-10T00:30:40.298" v="3923" actId="20578"/>
        <pc:sldMkLst>
          <pc:docMk/>
          <pc:sldMk cId="826150303" sldId="282"/>
        </pc:sldMkLst>
      </pc:sldChg>
      <pc:sldChg chg="addSp delSp modSp mod">
        <pc:chgData name="Wencai Zhang" userId="4a86a1d0-2108-4707-8228-1110f3c1be85" providerId="ADAL" clId="{5C5F0646-7A15-7D47-8C0D-14A5E0762118}" dt="2021-06-10T13:36:24.593" v="5424" actId="208"/>
        <pc:sldMkLst>
          <pc:docMk/>
          <pc:sldMk cId="1782915022" sldId="284"/>
        </pc:sldMkLst>
        <pc:spChg chg="add mod">
          <ac:chgData name="Wencai Zhang" userId="4a86a1d0-2108-4707-8228-1110f3c1be85" providerId="ADAL" clId="{5C5F0646-7A15-7D47-8C0D-14A5E0762118}" dt="2021-06-10T01:11:30.545" v="4161"/>
          <ac:spMkLst>
            <pc:docMk/>
            <pc:sldMk cId="1782915022" sldId="284"/>
            <ac:spMk id="14" creationId="{59F13EF4-42CE-4C43-A60F-51108FC49939}"/>
          </ac:spMkLst>
        </pc:spChg>
        <pc:spChg chg="add mod">
          <ac:chgData name="Wencai Zhang" userId="4a86a1d0-2108-4707-8228-1110f3c1be85" providerId="ADAL" clId="{5C5F0646-7A15-7D47-8C0D-14A5E0762118}" dt="2021-06-10T01:13:57.525" v="4180"/>
          <ac:spMkLst>
            <pc:docMk/>
            <pc:sldMk cId="1782915022" sldId="284"/>
            <ac:spMk id="15" creationId="{68219F1F-F6B5-014F-9D7E-CF0C88DA951A}"/>
          </ac:spMkLst>
        </pc:spChg>
        <pc:spChg chg="add del mod">
          <ac:chgData name="Wencai Zhang" userId="4a86a1d0-2108-4707-8228-1110f3c1be85" providerId="ADAL" clId="{5C5F0646-7A15-7D47-8C0D-14A5E0762118}" dt="2021-06-10T01:14:07.753" v="4183" actId="478"/>
          <ac:spMkLst>
            <pc:docMk/>
            <pc:sldMk cId="1782915022" sldId="284"/>
            <ac:spMk id="16" creationId="{443AE149-FA6B-A443-9541-3E1D1B4D0929}"/>
          </ac:spMkLst>
        </pc:spChg>
        <pc:spChg chg="add mod">
          <ac:chgData name="Wencai Zhang" userId="4a86a1d0-2108-4707-8228-1110f3c1be85" providerId="ADAL" clId="{5C5F0646-7A15-7D47-8C0D-14A5E0762118}" dt="2021-06-10T01:14:32.234" v="4187" actId="1076"/>
          <ac:spMkLst>
            <pc:docMk/>
            <pc:sldMk cId="1782915022" sldId="284"/>
            <ac:spMk id="17" creationId="{23B03EEB-5E10-9548-9910-1B99735BF7AA}"/>
          </ac:spMkLst>
        </pc:spChg>
        <pc:spChg chg="add mod">
          <ac:chgData name="Wencai Zhang" userId="4a86a1d0-2108-4707-8228-1110f3c1be85" providerId="ADAL" clId="{5C5F0646-7A15-7D47-8C0D-14A5E0762118}" dt="2021-06-10T13:31:30.483" v="5400" actId="20577"/>
          <ac:spMkLst>
            <pc:docMk/>
            <pc:sldMk cId="1782915022" sldId="284"/>
            <ac:spMk id="18" creationId="{48FE6B3E-2944-1240-BA2E-E892823E1BAD}"/>
          </ac:spMkLst>
        </pc:spChg>
        <pc:picChg chg="mod">
          <ac:chgData name="Wencai Zhang" userId="4a86a1d0-2108-4707-8228-1110f3c1be85" providerId="ADAL" clId="{5C5F0646-7A15-7D47-8C0D-14A5E0762118}" dt="2021-06-10T10:43:50.847" v="4620" actId="208"/>
          <ac:picMkLst>
            <pc:docMk/>
            <pc:sldMk cId="1782915022" sldId="284"/>
            <ac:picMk id="10" creationId="{1A850E40-855F-B34C-BD6A-070A89DC0389}"/>
          </ac:picMkLst>
        </pc:picChg>
        <pc:picChg chg="mod">
          <ac:chgData name="Wencai Zhang" userId="4a86a1d0-2108-4707-8228-1110f3c1be85" providerId="ADAL" clId="{5C5F0646-7A15-7D47-8C0D-14A5E0762118}" dt="2021-06-10T13:36:24.593" v="5424" actId="208"/>
          <ac:picMkLst>
            <pc:docMk/>
            <pc:sldMk cId="1782915022" sldId="284"/>
            <ac:picMk id="11" creationId="{E5F9C5FD-9AFC-7346-96E9-45B48C209323}"/>
          </ac:picMkLst>
        </pc:picChg>
        <pc:picChg chg="mod">
          <ac:chgData name="Wencai Zhang" userId="4a86a1d0-2108-4707-8228-1110f3c1be85" providerId="ADAL" clId="{5C5F0646-7A15-7D47-8C0D-14A5E0762118}" dt="2021-06-10T00:56:09.557" v="3953" actId="1037"/>
          <ac:picMkLst>
            <pc:docMk/>
            <pc:sldMk cId="1782915022" sldId="284"/>
            <ac:picMk id="13" creationId="{E52D5ED8-E1CA-4A48-9529-4B26A87788B4}"/>
          </ac:picMkLst>
        </pc:picChg>
        <pc:picChg chg="add mod">
          <ac:chgData name="Wencai Zhang" userId="4a86a1d0-2108-4707-8228-1110f3c1be85" providerId="ADAL" clId="{5C5F0646-7A15-7D47-8C0D-14A5E0762118}" dt="2021-06-10T13:24:02.537" v="4936" actId="1076"/>
          <ac:picMkLst>
            <pc:docMk/>
            <pc:sldMk cId="1782915022" sldId="284"/>
            <ac:picMk id="19" creationId="{205C7E53-46ED-4946-9C75-F4A2EDD976A6}"/>
          </ac:picMkLst>
        </pc:picChg>
        <pc:picChg chg="add mod">
          <ac:chgData name="Wencai Zhang" userId="4a86a1d0-2108-4707-8228-1110f3c1be85" providerId="ADAL" clId="{5C5F0646-7A15-7D47-8C0D-14A5E0762118}" dt="2021-06-10T13:35:18.116" v="5405" actId="1076"/>
          <ac:picMkLst>
            <pc:docMk/>
            <pc:sldMk cId="1782915022" sldId="284"/>
            <ac:picMk id="20" creationId="{21ACA564-43AF-AB46-9C78-BE078DB178C2}"/>
          </ac:picMkLst>
        </pc:picChg>
      </pc:sldChg>
      <pc:sldChg chg="addSp modSp add mod">
        <pc:chgData name="Wencai Zhang" userId="4a86a1d0-2108-4707-8228-1110f3c1be85" providerId="ADAL" clId="{5C5F0646-7A15-7D47-8C0D-14A5E0762118}" dt="2021-06-10T01:10:34.541" v="4160" actId="20577"/>
        <pc:sldMkLst>
          <pc:docMk/>
          <pc:sldMk cId="3018879732" sldId="287"/>
        </pc:sldMkLst>
        <pc:spChg chg="add mod">
          <ac:chgData name="Wencai Zhang" userId="4a86a1d0-2108-4707-8228-1110f3c1be85" providerId="ADAL" clId="{5C5F0646-7A15-7D47-8C0D-14A5E0762118}" dt="2021-06-10T01:10:34.541" v="4160" actId="20577"/>
          <ac:spMkLst>
            <pc:docMk/>
            <pc:sldMk cId="3018879732" sldId="287"/>
            <ac:spMk id="14" creationId="{78F31C00-F8CB-634E-9071-38E1FEF67AA7}"/>
          </ac:spMkLst>
        </pc:spChg>
        <pc:picChg chg="mod">
          <ac:chgData name="Wencai Zhang" userId="4a86a1d0-2108-4707-8228-1110f3c1be85" providerId="ADAL" clId="{5C5F0646-7A15-7D47-8C0D-14A5E0762118}" dt="2021-06-10T01:08:10.640" v="4150" actId="1038"/>
          <ac:picMkLst>
            <pc:docMk/>
            <pc:sldMk cId="3018879732" sldId="287"/>
            <ac:picMk id="3" creationId="{2566D67C-CDCD-2744-87B0-713B42FAC828}"/>
          </ac:picMkLst>
        </pc:picChg>
        <pc:picChg chg="mod">
          <ac:chgData name="Wencai Zhang" userId="4a86a1d0-2108-4707-8228-1110f3c1be85" providerId="ADAL" clId="{5C5F0646-7A15-7D47-8C0D-14A5E0762118}" dt="2021-06-10T01:08:10.640" v="4150" actId="1038"/>
          <ac:picMkLst>
            <pc:docMk/>
            <pc:sldMk cId="3018879732" sldId="287"/>
            <ac:picMk id="4" creationId="{BC9A9B2F-09B2-C448-8BAF-2F393BBCA1B6}"/>
          </ac:picMkLst>
        </pc:picChg>
        <pc:picChg chg="mod">
          <ac:chgData name="Wencai Zhang" userId="4a86a1d0-2108-4707-8228-1110f3c1be85" providerId="ADAL" clId="{5C5F0646-7A15-7D47-8C0D-14A5E0762118}" dt="2021-06-10T01:07:28.935" v="3996" actId="1076"/>
          <ac:picMkLst>
            <pc:docMk/>
            <pc:sldMk cId="3018879732" sldId="287"/>
            <ac:picMk id="6" creationId="{0BF710C7-4FF2-4A4B-B31B-1BBC852ED67E}"/>
          </ac:picMkLst>
        </pc:picChg>
        <pc:picChg chg="mod">
          <ac:chgData name="Wencai Zhang" userId="4a86a1d0-2108-4707-8228-1110f3c1be85" providerId="ADAL" clId="{5C5F0646-7A15-7D47-8C0D-14A5E0762118}" dt="2021-06-10T01:07:22.906" v="3995" actId="1037"/>
          <ac:picMkLst>
            <pc:docMk/>
            <pc:sldMk cId="3018879732" sldId="287"/>
            <ac:picMk id="7" creationId="{92FA73BC-DDF9-F04F-B100-825759AB81F1}"/>
          </ac:picMkLst>
        </pc:picChg>
        <pc:picChg chg="mod">
          <ac:chgData name="Wencai Zhang" userId="4a86a1d0-2108-4707-8228-1110f3c1be85" providerId="ADAL" clId="{5C5F0646-7A15-7D47-8C0D-14A5E0762118}" dt="2021-06-10T01:07:56.626" v="4106" actId="1037"/>
          <ac:picMkLst>
            <pc:docMk/>
            <pc:sldMk cId="3018879732" sldId="287"/>
            <ac:picMk id="9" creationId="{28A200BF-BCD6-5E4E-9A21-23542AB65BD1}"/>
          </ac:picMkLst>
        </pc:picChg>
      </pc:sldChg>
      <pc:sldChg chg="addSp delSp modSp new mod">
        <pc:chgData name="Wencai Zhang" userId="4a86a1d0-2108-4707-8228-1110f3c1be85" providerId="ADAL" clId="{5C5F0646-7A15-7D47-8C0D-14A5E0762118}" dt="2021-06-10T13:54:49.218" v="5582" actId="1076"/>
        <pc:sldMkLst>
          <pc:docMk/>
          <pc:sldMk cId="2618164597" sldId="288"/>
        </pc:sldMkLst>
        <pc:spChg chg="del">
          <ac:chgData name="Wencai Zhang" userId="4a86a1d0-2108-4707-8228-1110f3c1be85" providerId="ADAL" clId="{5C5F0646-7A15-7D47-8C0D-14A5E0762118}" dt="2021-06-10T13:37:40.670" v="5426" actId="478"/>
          <ac:spMkLst>
            <pc:docMk/>
            <pc:sldMk cId="2618164597" sldId="288"/>
            <ac:spMk id="2" creationId="{2FF52D7F-3031-8F47-A636-5CB4F5B7DB51}"/>
          </ac:spMkLst>
        </pc:spChg>
        <pc:spChg chg="del">
          <ac:chgData name="Wencai Zhang" userId="4a86a1d0-2108-4707-8228-1110f3c1be85" providerId="ADAL" clId="{5C5F0646-7A15-7D47-8C0D-14A5E0762118}" dt="2021-06-10T13:37:40.670" v="5426" actId="478"/>
          <ac:spMkLst>
            <pc:docMk/>
            <pc:sldMk cId="2618164597" sldId="288"/>
            <ac:spMk id="3" creationId="{7044CD36-47C4-554C-986D-EB60330B4E19}"/>
          </ac:spMkLst>
        </pc:spChg>
        <pc:spChg chg="add mod">
          <ac:chgData name="Wencai Zhang" userId="4a86a1d0-2108-4707-8228-1110f3c1be85" providerId="ADAL" clId="{5C5F0646-7A15-7D47-8C0D-14A5E0762118}" dt="2021-06-10T13:40:35.943" v="5441" actId="1076"/>
          <ac:spMkLst>
            <pc:docMk/>
            <pc:sldMk cId="2618164597" sldId="288"/>
            <ac:spMk id="8" creationId="{AD425D30-180C-F44B-BC0F-AB46C2288541}"/>
          </ac:spMkLst>
        </pc:spChg>
        <pc:spChg chg="add mod">
          <ac:chgData name="Wencai Zhang" userId="4a86a1d0-2108-4707-8228-1110f3c1be85" providerId="ADAL" clId="{5C5F0646-7A15-7D47-8C0D-14A5E0762118}" dt="2021-06-10T13:40:44.666" v="5447" actId="20577"/>
          <ac:spMkLst>
            <pc:docMk/>
            <pc:sldMk cId="2618164597" sldId="288"/>
            <ac:spMk id="9" creationId="{F5074D09-7D1B-9A4C-9F87-B89F5A8C0BDC}"/>
          </ac:spMkLst>
        </pc:spChg>
        <pc:spChg chg="add mod">
          <ac:chgData name="Wencai Zhang" userId="4a86a1d0-2108-4707-8228-1110f3c1be85" providerId="ADAL" clId="{5C5F0646-7A15-7D47-8C0D-14A5E0762118}" dt="2021-06-10T13:54:49.218" v="5582" actId="1076"/>
          <ac:spMkLst>
            <pc:docMk/>
            <pc:sldMk cId="2618164597" sldId="288"/>
            <ac:spMk id="10" creationId="{0AD59A7C-F730-5349-83F5-4D2F6E3A95C9}"/>
          </ac:spMkLst>
        </pc:spChg>
        <pc:spChg chg="add mod">
          <ac:chgData name="Wencai Zhang" userId="4a86a1d0-2108-4707-8228-1110f3c1be85" providerId="ADAL" clId="{5C5F0646-7A15-7D47-8C0D-14A5E0762118}" dt="2021-06-10T13:54:22.521" v="5579" actId="21"/>
          <ac:spMkLst>
            <pc:docMk/>
            <pc:sldMk cId="2618164597" sldId="288"/>
            <ac:spMk id="11" creationId="{B8FCA430-4CE4-0F41-BE81-45E048AA3622}"/>
          </ac:spMkLst>
        </pc:spChg>
        <pc:picChg chg="add mod">
          <ac:chgData name="Wencai Zhang" userId="4a86a1d0-2108-4707-8228-1110f3c1be85" providerId="ADAL" clId="{5C5F0646-7A15-7D47-8C0D-14A5E0762118}" dt="2021-06-10T13:39:53.355" v="5438" actId="1076"/>
          <ac:picMkLst>
            <pc:docMk/>
            <pc:sldMk cId="2618164597" sldId="288"/>
            <ac:picMk id="4" creationId="{A70378F2-6CD0-974D-A4C3-ABA532790D9B}"/>
          </ac:picMkLst>
        </pc:picChg>
        <pc:picChg chg="add mod">
          <ac:chgData name="Wencai Zhang" userId="4a86a1d0-2108-4707-8228-1110f3c1be85" providerId="ADAL" clId="{5C5F0646-7A15-7D47-8C0D-14A5E0762118}" dt="2021-06-10T13:39:53.355" v="5438" actId="1076"/>
          <ac:picMkLst>
            <pc:docMk/>
            <pc:sldMk cId="2618164597" sldId="288"/>
            <ac:picMk id="5" creationId="{FC2009B2-EA92-5E44-8B5A-9FEE474B56F7}"/>
          </ac:picMkLst>
        </pc:picChg>
        <pc:picChg chg="add mod">
          <ac:chgData name="Wencai Zhang" userId="4a86a1d0-2108-4707-8228-1110f3c1be85" providerId="ADAL" clId="{5C5F0646-7A15-7D47-8C0D-14A5E0762118}" dt="2021-06-10T13:40:22.651" v="5439" actId="1076"/>
          <ac:picMkLst>
            <pc:docMk/>
            <pc:sldMk cId="2618164597" sldId="288"/>
            <ac:picMk id="6" creationId="{407BB3E7-4046-6F4E-A52B-06BA09B282B6}"/>
          </ac:picMkLst>
        </pc:picChg>
        <pc:picChg chg="add mod">
          <ac:chgData name="Wencai Zhang" userId="4a86a1d0-2108-4707-8228-1110f3c1be85" providerId="ADAL" clId="{5C5F0646-7A15-7D47-8C0D-14A5E0762118}" dt="2021-06-10T13:40:22.651" v="5439" actId="1076"/>
          <ac:picMkLst>
            <pc:docMk/>
            <pc:sldMk cId="2618164597" sldId="288"/>
            <ac:picMk id="7" creationId="{BCB39BBF-C93F-1E46-A842-94EC72E6811D}"/>
          </ac:picMkLst>
        </pc:picChg>
        <pc:picChg chg="add mod">
          <ac:chgData name="Wencai Zhang" userId="4a86a1d0-2108-4707-8228-1110f3c1be85" providerId="ADAL" clId="{5C5F0646-7A15-7D47-8C0D-14A5E0762118}" dt="2021-06-10T13:51:05.449" v="5549" actId="1076"/>
          <ac:picMkLst>
            <pc:docMk/>
            <pc:sldMk cId="2618164597" sldId="288"/>
            <ac:picMk id="12" creationId="{88CCFCCA-6EA5-944C-BD29-5310C642C95A}"/>
          </ac:picMkLst>
        </pc:picChg>
        <pc:picChg chg="add mod">
          <ac:chgData name="Wencai Zhang" userId="4a86a1d0-2108-4707-8228-1110f3c1be85" providerId="ADAL" clId="{5C5F0646-7A15-7D47-8C0D-14A5E0762118}" dt="2021-06-10T13:50:39.839" v="5548" actId="1076"/>
          <ac:picMkLst>
            <pc:docMk/>
            <pc:sldMk cId="2618164597" sldId="288"/>
            <ac:picMk id="13" creationId="{12413FC3-E88D-1A4B-B4C6-BE3208E1A414}"/>
          </ac:picMkLst>
        </pc:picChg>
        <pc:picChg chg="add mod">
          <ac:chgData name="Wencai Zhang" userId="4a86a1d0-2108-4707-8228-1110f3c1be85" providerId="ADAL" clId="{5C5F0646-7A15-7D47-8C0D-14A5E0762118}" dt="2021-06-10T13:51:54.571" v="5553" actId="1076"/>
          <ac:picMkLst>
            <pc:docMk/>
            <pc:sldMk cId="2618164597" sldId="288"/>
            <ac:picMk id="14" creationId="{855AD729-0FA4-4B4A-95AC-7BC5C0283E08}"/>
          </ac:picMkLst>
        </pc:picChg>
        <pc:picChg chg="add mod">
          <ac:chgData name="Wencai Zhang" userId="4a86a1d0-2108-4707-8228-1110f3c1be85" providerId="ADAL" clId="{5C5F0646-7A15-7D47-8C0D-14A5E0762118}" dt="2021-06-10T13:52:55.346" v="5578" actId="1037"/>
          <ac:picMkLst>
            <pc:docMk/>
            <pc:sldMk cId="2618164597" sldId="288"/>
            <ac:picMk id="15" creationId="{5222F7E0-9FDB-474D-99B8-9E4023F43408}"/>
          </ac:picMkLst>
        </pc:picChg>
      </pc:sldChg>
      <pc:sldChg chg="addSp delSp modSp new mod">
        <pc:chgData name="Wencai Zhang" userId="4a86a1d0-2108-4707-8228-1110f3c1be85" providerId="ADAL" clId="{5C5F0646-7A15-7D47-8C0D-14A5E0762118}" dt="2021-06-15T01:34:55.679" v="5763" actId="20577"/>
        <pc:sldMkLst>
          <pc:docMk/>
          <pc:sldMk cId="3497662403" sldId="290"/>
        </pc:sldMkLst>
        <pc:spChg chg="del">
          <ac:chgData name="Wencai Zhang" userId="4a86a1d0-2108-4707-8228-1110f3c1be85" providerId="ADAL" clId="{5C5F0646-7A15-7D47-8C0D-14A5E0762118}" dt="2021-06-15T01:26:25.370" v="5584" actId="478"/>
          <ac:spMkLst>
            <pc:docMk/>
            <pc:sldMk cId="3497662403" sldId="290"/>
            <ac:spMk id="2" creationId="{46C55720-F602-4642-9F33-A2CC430E1DB3}"/>
          </ac:spMkLst>
        </pc:spChg>
        <pc:spChg chg="del">
          <ac:chgData name="Wencai Zhang" userId="4a86a1d0-2108-4707-8228-1110f3c1be85" providerId="ADAL" clId="{5C5F0646-7A15-7D47-8C0D-14A5E0762118}" dt="2021-06-15T01:26:25.370" v="5584" actId="478"/>
          <ac:spMkLst>
            <pc:docMk/>
            <pc:sldMk cId="3497662403" sldId="290"/>
            <ac:spMk id="3" creationId="{7D69229E-A35D-D242-9DA9-4380698B53C3}"/>
          </ac:spMkLst>
        </pc:spChg>
        <pc:spChg chg="add mod">
          <ac:chgData name="Wencai Zhang" userId="4a86a1d0-2108-4707-8228-1110f3c1be85" providerId="ADAL" clId="{5C5F0646-7A15-7D47-8C0D-14A5E0762118}" dt="2021-06-15T01:34:55.679" v="5763" actId="20577"/>
          <ac:spMkLst>
            <pc:docMk/>
            <pc:sldMk cId="3497662403" sldId="290"/>
            <ac:spMk id="8" creationId="{A4F20A6F-D30A-9040-ACD4-2B63464D1625}"/>
          </ac:spMkLst>
        </pc:spChg>
        <pc:spChg chg="add mod">
          <ac:chgData name="Wencai Zhang" userId="4a86a1d0-2108-4707-8228-1110f3c1be85" providerId="ADAL" clId="{5C5F0646-7A15-7D47-8C0D-14A5E0762118}" dt="2021-06-15T01:34:04.335" v="5758" actId="1038"/>
          <ac:spMkLst>
            <pc:docMk/>
            <pc:sldMk cId="3497662403" sldId="290"/>
            <ac:spMk id="9" creationId="{77B42230-FC3D-594E-A8D3-BB1B8D18B024}"/>
          </ac:spMkLst>
        </pc:spChg>
        <pc:spChg chg="add mod">
          <ac:chgData name="Wencai Zhang" userId="4a86a1d0-2108-4707-8228-1110f3c1be85" providerId="ADAL" clId="{5C5F0646-7A15-7D47-8C0D-14A5E0762118}" dt="2021-06-15T01:34:04.335" v="5758" actId="1038"/>
          <ac:spMkLst>
            <pc:docMk/>
            <pc:sldMk cId="3497662403" sldId="290"/>
            <ac:spMk id="10" creationId="{27FFFE77-146B-4F4E-9B85-F2D0A33445FA}"/>
          </ac:spMkLst>
        </pc:spChg>
        <pc:picChg chg="add mod modCrop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4" creationId="{D5F8969C-47D5-434A-8A0D-423C2F88D584}"/>
          </ac:picMkLst>
        </pc:picChg>
        <pc:picChg chg="add mod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5" creationId="{D144485F-EAA4-DA4E-B968-FF93264A69A5}"/>
          </ac:picMkLst>
        </pc:picChg>
        <pc:picChg chg="add mod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6" creationId="{EE7D6119-E5DE-244C-AF97-EA4FB4619828}"/>
          </ac:picMkLst>
        </pc:picChg>
        <pc:picChg chg="add mod">
          <ac:chgData name="Wencai Zhang" userId="4a86a1d0-2108-4707-8228-1110f3c1be85" providerId="ADAL" clId="{5C5F0646-7A15-7D47-8C0D-14A5E0762118}" dt="2021-06-15T01:34:04.335" v="5758" actId="1038"/>
          <ac:picMkLst>
            <pc:docMk/>
            <pc:sldMk cId="3497662403" sldId="290"/>
            <ac:picMk id="7" creationId="{656940AD-5B4E-7147-B7C7-070CE9953A05}"/>
          </ac:picMkLst>
        </pc:picChg>
      </pc:sldChg>
    </pc:docChg>
  </pc:docChgLst>
  <pc:docChgLst>
    <pc:chgData name="Nicholas Skiados" userId="gyL5hJDrj+hZHFpDSneZU1h6zJeED3y/2O9IVXLr5ag=" providerId="None" clId="Web-{B0C9E98B-56E0-4B7B-A7B2-22881B0E7D0C}"/>
    <pc:docChg chg="modSld">
      <pc:chgData name="Nicholas Skiados" userId="gyL5hJDrj+hZHFpDSneZU1h6zJeED3y/2O9IVXLr5ag=" providerId="None" clId="Web-{B0C9E98B-56E0-4B7B-A7B2-22881B0E7D0C}" dt="2021-06-17T16:05:58.077" v="18" actId="14100"/>
      <pc:docMkLst>
        <pc:docMk/>
      </pc:docMkLst>
      <pc:sldChg chg="addSp delSp modSp">
        <pc:chgData name="Nicholas Skiados" userId="gyL5hJDrj+hZHFpDSneZU1h6zJeED3y/2O9IVXLr5ag=" providerId="None" clId="Web-{B0C9E98B-56E0-4B7B-A7B2-22881B0E7D0C}" dt="2021-06-17T16:05:58.077" v="18" actId="14100"/>
        <pc:sldMkLst>
          <pc:docMk/>
          <pc:sldMk cId="4133689721" sldId="291"/>
        </pc:sldMkLst>
        <pc:spChg chg="del">
          <ac:chgData name="Nicholas Skiados" userId="gyL5hJDrj+hZHFpDSneZU1h6zJeED3y/2O9IVXLr5ag=" providerId="None" clId="Web-{B0C9E98B-56E0-4B7B-A7B2-22881B0E7D0C}" dt="2021-06-17T16:03:25.207" v="0"/>
          <ac:spMkLst>
            <pc:docMk/>
            <pc:sldMk cId="4133689721" sldId="291"/>
            <ac:spMk id="9" creationId="{100E022D-2076-479C-A701-6B009140F160}"/>
          </ac:spMkLst>
        </pc:spChg>
        <pc:spChg chg="add del mod">
          <ac:chgData name="Nicholas Skiados" userId="gyL5hJDrj+hZHFpDSneZU1h6zJeED3y/2O9IVXLr5ag=" providerId="None" clId="Web-{B0C9E98B-56E0-4B7B-A7B2-22881B0E7D0C}" dt="2021-06-17T16:03:41.724" v="3"/>
          <ac:spMkLst>
            <pc:docMk/>
            <pc:sldMk cId="4133689721" sldId="291"/>
            <ac:spMk id="42" creationId="{F522E395-D63F-440C-80A7-7D43B45C67DB}"/>
          </ac:spMkLst>
        </pc:spChg>
        <pc:spChg chg="add mod">
          <ac:chgData name="Nicholas Skiados" userId="gyL5hJDrj+hZHFpDSneZU1h6zJeED3y/2O9IVXLr5ag=" providerId="None" clId="Web-{B0C9E98B-56E0-4B7B-A7B2-22881B0E7D0C}" dt="2021-06-17T16:03:56.115" v="6" actId="1076"/>
          <ac:spMkLst>
            <pc:docMk/>
            <pc:sldMk cId="4133689721" sldId="291"/>
            <ac:spMk id="43" creationId="{2AA9094F-D7AB-4950-B7FC-5E87D4F75296}"/>
          </ac:spMkLst>
        </pc:spChg>
        <pc:picChg chg="add mod modCrop">
          <ac:chgData name="Nicholas Skiados" userId="gyL5hJDrj+hZHFpDSneZU1h6zJeED3y/2O9IVXLr5ag=" providerId="None" clId="Web-{B0C9E98B-56E0-4B7B-A7B2-22881B0E7D0C}" dt="2021-06-17T16:05:58.077" v="18" actId="14100"/>
          <ac:picMkLst>
            <pc:docMk/>
            <pc:sldMk cId="4133689721" sldId="291"/>
            <ac:picMk id="17" creationId="{90A3123D-C2FB-423C-A515-4FEAD3B6BCF7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B1E0C-5533-3B4C-96E7-B2A064C4ECAC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D0EA0A-6814-514A-BE49-C1EF962D1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0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91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1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968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94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971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5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685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03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782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15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054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11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8D389290-6337-6040-8C38-CCDA20CAB5A5}"/>
              </a:ext>
            </a:extLst>
          </p:cNvPr>
          <p:cNvGrpSpPr/>
          <p:nvPr/>
        </p:nvGrpSpPr>
        <p:grpSpPr>
          <a:xfrm>
            <a:off x="1333590" y="345996"/>
            <a:ext cx="4204307" cy="8256130"/>
            <a:chOff x="442050" y="345996"/>
            <a:chExt cx="4204307" cy="8256130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910FDAA-0D6B-234C-AFBB-45F00AB1CB15}"/>
                </a:ext>
              </a:extLst>
            </p:cNvPr>
            <p:cNvSpPr txBox="1"/>
            <p:nvPr/>
          </p:nvSpPr>
          <p:spPr>
            <a:xfrm rot="5400000">
              <a:off x="3416124" y="-35140"/>
              <a:ext cx="292388" cy="128016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Osimertinib (1 µM)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58FC33E-4323-AA45-B0A3-7A8CC5E9D87A}"/>
                </a:ext>
              </a:extLst>
            </p:cNvPr>
            <p:cNvSpPr txBox="1"/>
            <p:nvPr/>
          </p:nvSpPr>
          <p:spPr>
            <a:xfrm rot="5400000">
              <a:off x="1554392" y="-41165"/>
              <a:ext cx="292608" cy="128016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AICAR (1 </a:t>
              </a:r>
              <a:r>
                <a:rPr lang="en-US" sz="700" err="1">
                  <a:latin typeface="Arial" panose="020B0604020202020204" pitchFamily="34" charset="0"/>
                  <a:cs typeface="Arial" panose="020B0604020202020204" pitchFamily="34" charset="0"/>
                </a:rPr>
                <a:t>mM</a:t>
              </a:r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D4308A8-2240-2448-81D3-B5F43380ADFD}"/>
                </a:ext>
              </a:extLst>
            </p:cNvPr>
            <p:cNvSpPr txBox="1"/>
            <p:nvPr/>
          </p:nvSpPr>
          <p:spPr>
            <a:xfrm>
              <a:off x="442050" y="405897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2AC1D9B-603A-7640-A2F1-8A65E25A968E}"/>
                </a:ext>
              </a:extLst>
            </p:cNvPr>
            <p:cNvSpPr txBox="1"/>
            <p:nvPr/>
          </p:nvSpPr>
          <p:spPr>
            <a:xfrm>
              <a:off x="2538197" y="345996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20A9FC90-A594-4A4B-BC2A-3B78A5A61189}"/>
                </a:ext>
              </a:extLst>
            </p:cNvPr>
            <p:cNvGrpSpPr/>
            <p:nvPr/>
          </p:nvGrpSpPr>
          <p:grpSpPr>
            <a:xfrm>
              <a:off x="843792" y="738532"/>
              <a:ext cx="1564081" cy="7863278"/>
              <a:chOff x="810244" y="619243"/>
              <a:chExt cx="1564081" cy="8444441"/>
            </a:xfrm>
          </p:grpSpPr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36BCAD8B-DC06-E546-94F7-1797892BFE75}"/>
                  </a:ext>
                </a:extLst>
              </p:cNvPr>
              <p:cNvSpPr txBox="1"/>
              <p:nvPr/>
            </p:nvSpPr>
            <p:spPr>
              <a:xfrm>
                <a:off x="1081090" y="8848843"/>
                <a:ext cx="1172116" cy="214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>
                    <a:latin typeface="Arial" panose="020B0604020202020204" pitchFamily="34" charset="0"/>
                    <a:cs typeface="Arial" panose="020B0604020202020204" pitchFamily="34" charset="0"/>
                  </a:rPr>
                  <a:t>Cellular ROS Deep Red</a:t>
                </a:r>
              </a:p>
            </p:txBody>
          </p:sp>
          <p:cxnSp>
            <p:nvCxnSpPr>
              <p:cNvPr id="37" name="Straight Arrow Connector 36">
                <a:extLst>
                  <a:ext uri="{FF2B5EF4-FFF2-40B4-BE49-F238E27FC236}">
                    <a16:creationId xmlns:a16="http://schemas.microsoft.com/office/drawing/2014/main" id="{AE2C0C51-E322-FE4F-9E93-1CC05E5B9E90}"/>
                  </a:ext>
                </a:extLst>
              </p:cNvPr>
              <p:cNvCxnSpPr/>
              <p:nvPr/>
            </p:nvCxnSpPr>
            <p:spPr>
              <a:xfrm>
                <a:off x="1002725" y="8848843"/>
                <a:ext cx="13716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Arrow Connector 37">
                <a:extLst>
                  <a:ext uri="{FF2B5EF4-FFF2-40B4-BE49-F238E27FC236}">
                    <a16:creationId xmlns:a16="http://schemas.microsoft.com/office/drawing/2014/main" id="{4EC3A846-47BD-AF44-A355-26CBDF836BA5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-3108387" y="4734043"/>
                <a:ext cx="82296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81C04827-8CF7-8042-9DB3-B9C02F3E494F}"/>
                  </a:ext>
                </a:extLst>
              </p:cNvPr>
              <p:cNvSpPr txBox="1"/>
              <p:nvPr/>
            </p:nvSpPr>
            <p:spPr>
              <a:xfrm rot="16200000">
                <a:off x="672535" y="4410951"/>
                <a:ext cx="47547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>
                    <a:latin typeface="Arial" panose="020B0604020202020204" pitchFamily="34" charset="0"/>
                    <a:cs typeface="Arial" panose="020B0604020202020204" pitchFamily="34" charset="0"/>
                  </a:rPr>
                  <a:t>Count</a:t>
                </a:r>
              </a:p>
            </p:txBody>
          </p: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00E1E6B1-6FCB-A14C-AF72-9FD13F07BF02}"/>
                </a:ext>
              </a:extLst>
            </p:cNvPr>
            <p:cNvGrpSpPr/>
            <p:nvPr/>
          </p:nvGrpSpPr>
          <p:grpSpPr>
            <a:xfrm>
              <a:off x="2638317" y="738848"/>
              <a:ext cx="1564081" cy="7863278"/>
              <a:chOff x="810244" y="619243"/>
              <a:chExt cx="1564081" cy="8444441"/>
            </a:xfrm>
          </p:grpSpPr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A315C128-B9F9-0847-A821-612DDECB15D4}"/>
                  </a:ext>
                </a:extLst>
              </p:cNvPr>
              <p:cNvSpPr txBox="1"/>
              <p:nvPr/>
            </p:nvSpPr>
            <p:spPr>
              <a:xfrm>
                <a:off x="1072852" y="8848843"/>
                <a:ext cx="1172116" cy="214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>
                    <a:latin typeface="Arial" panose="020B0604020202020204" pitchFamily="34" charset="0"/>
                    <a:cs typeface="Arial" panose="020B0604020202020204" pitchFamily="34" charset="0"/>
                  </a:rPr>
                  <a:t>Cellular ROS Deep Red</a:t>
                </a:r>
              </a:p>
            </p:txBody>
          </p:sp>
          <p:cxnSp>
            <p:nvCxnSpPr>
              <p:cNvPr id="43" name="Straight Arrow Connector 42">
                <a:extLst>
                  <a:ext uri="{FF2B5EF4-FFF2-40B4-BE49-F238E27FC236}">
                    <a16:creationId xmlns:a16="http://schemas.microsoft.com/office/drawing/2014/main" id="{8F3C6198-2FF8-5248-8BEA-E4E59C3C64AF}"/>
                  </a:ext>
                </a:extLst>
              </p:cNvPr>
              <p:cNvCxnSpPr/>
              <p:nvPr/>
            </p:nvCxnSpPr>
            <p:spPr>
              <a:xfrm>
                <a:off x="1002725" y="8848843"/>
                <a:ext cx="13716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Arrow Connector 43">
                <a:extLst>
                  <a:ext uri="{FF2B5EF4-FFF2-40B4-BE49-F238E27FC236}">
                    <a16:creationId xmlns:a16="http://schemas.microsoft.com/office/drawing/2014/main" id="{3E191983-E340-8141-B440-6E0EEED95778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-3108387" y="4734043"/>
                <a:ext cx="82296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AD7D2E81-BD15-954F-B83A-EA6902809D5E}"/>
                  </a:ext>
                </a:extLst>
              </p:cNvPr>
              <p:cNvSpPr txBox="1"/>
              <p:nvPr/>
            </p:nvSpPr>
            <p:spPr>
              <a:xfrm rot="16200000">
                <a:off x="672535" y="4410951"/>
                <a:ext cx="47547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>
                    <a:latin typeface="Arial" panose="020B0604020202020204" pitchFamily="34" charset="0"/>
                    <a:cs typeface="Arial" panose="020B0604020202020204" pitchFamily="34" charset="0"/>
                  </a:rPr>
                  <a:t>Count</a:t>
                </a:r>
              </a:p>
            </p:txBody>
          </p: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15D8C616-F46D-8440-9626-1D70E781C42B}"/>
                </a:ext>
              </a:extLst>
            </p:cNvPr>
            <p:cNvGrpSpPr/>
            <p:nvPr/>
          </p:nvGrpSpPr>
          <p:grpSpPr>
            <a:xfrm>
              <a:off x="4110565" y="1133615"/>
              <a:ext cx="535792" cy="6686671"/>
              <a:chOff x="595674" y="1049872"/>
              <a:chExt cx="503620" cy="6686671"/>
            </a:xfrm>
          </p:grpSpPr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B78FE28C-BC4A-5540-94A2-004C5D22FDFC}"/>
                  </a:ext>
                </a:extLst>
              </p:cNvPr>
              <p:cNvSpPr txBox="1"/>
              <p:nvPr/>
            </p:nvSpPr>
            <p:spPr>
              <a:xfrm rot="5400000">
                <a:off x="703745" y="2264569"/>
                <a:ext cx="292388" cy="47815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2hr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AC93C394-E9A9-EC41-BEB0-61C70AD6CFA6}"/>
                  </a:ext>
                </a:extLst>
              </p:cNvPr>
              <p:cNvSpPr txBox="1"/>
              <p:nvPr/>
            </p:nvSpPr>
            <p:spPr>
              <a:xfrm rot="5400000">
                <a:off x="699353" y="3553308"/>
                <a:ext cx="292388" cy="47815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4hr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9B2B4651-50FA-7E4A-A006-4A1C6FEDA233}"/>
                  </a:ext>
                </a:extLst>
              </p:cNvPr>
              <p:cNvSpPr txBox="1"/>
              <p:nvPr/>
            </p:nvSpPr>
            <p:spPr>
              <a:xfrm rot="5400000">
                <a:off x="688555" y="4788542"/>
                <a:ext cx="292388" cy="47815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6hr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17ABAE6A-D181-2342-A9D0-281DE88FA40B}"/>
                  </a:ext>
                </a:extLst>
              </p:cNvPr>
              <p:cNvSpPr txBox="1"/>
              <p:nvPr/>
            </p:nvSpPr>
            <p:spPr>
              <a:xfrm rot="5400000">
                <a:off x="707236" y="6130968"/>
                <a:ext cx="292388" cy="47815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8hr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EA961B00-9378-424C-8E06-05C140A84F95}"/>
                  </a:ext>
                </a:extLst>
              </p:cNvPr>
              <p:cNvSpPr txBox="1"/>
              <p:nvPr/>
            </p:nvSpPr>
            <p:spPr>
              <a:xfrm rot="5400000">
                <a:off x="704972" y="7351274"/>
                <a:ext cx="292388" cy="47815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24hr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1B7AF82B-51B9-6B43-9EA6-A6A59E9BD638}"/>
                  </a:ext>
                </a:extLst>
              </p:cNvPr>
              <p:cNvSpPr txBox="1"/>
              <p:nvPr/>
            </p:nvSpPr>
            <p:spPr>
              <a:xfrm rot="5400000">
                <a:off x="714025" y="956991"/>
                <a:ext cx="292388" cy="47815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hr</a:t>
                </a:r>
              </a:p>
            </p:txBody>
          </p:sp>
        </p:grpSp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63819DC4-D49C-F449-98DC-3D527B9703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67" t="5208" r="767" b="5319"/>
            <a:stretch/>
          </p:blipFill>
          <p:spPr>
            <a:xfrm>
              <a:off x="1088352" y="729153"/>
              <a:ext cx="1243584" cy="1243584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A17934B8-99E0-3E46-A1B9-C2C685161D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67" t="5264" r="767" b="5264"/>
            <a:stretch/>
          </p:blipFill>
          <p:spPr>
            <a:xfrm>
              <a:off x="2899781" y="731038"/>
              <a:ext cx="1243584" cy="1243584"/>
            </a:xfrm>
            <a:prstGeom prst="rect">
              <a:avLst/>
            </a:prstGeom>
          </p:spPr>
        </p:pic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E87779B1-E25E-3B45-87CF-E635A8CD73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15" t="5294" r="1120" b="5232"/>
            <a:stretch/>
          </p:blipFill>
          <p:spPr>
            <a:xfrm>
              <a:off x="1088619" y="2027506"/>
              <a:ext cx="1243584" cy="1243584"/>
            </a:xfrm>
            <a:prstGeom prst="rect">
              <a:avLst/>
            </a:prstGeom>
          </p:spPr>
        </p:pic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3B94F0D8-B628-D748-AC62-CB64DAAAF9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91" t="4446" r="643" b="4887"/>
            <a:stretch/>
          </p:blipFill>
          <p:spPr>
            <a:xfrm>
              <a:off x="1083389" y="3278080"/>
              <a:ext cx="1243584" cy="1243584"/>
            </a:xfrm>
            <a:prstGeom prst="rect">
              <a:avLst/>
            </a:prstGeom>
          </p:spPr>
        </p:pic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78F69994-2141-8E45-B2DA-BFE1B272FF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767" t="4942" r="767" b="5584"/>
            <a:stretch/>
          </p:blipFill>
          <p:spPr>
            <a:xfrm>
              <a:off x="1084506" y="4528654"/>
              <a:ext cx="1243584" cy="1243584"/>
            </a:xfrm>
            <a:prstGeom prst="rect">
              <a:avLst/>
            </a:prstGeom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17360B66-DAD4-E54B-9765-51C47A0C5E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767" t="5264" r="767" b="5264"/>
            <a:stretch/>
          </p:blipFill>
          <p:spPr>
            <a:xfrm>
              <a:off x="1089924" y="5804998"/>
              <a:ext cx="1243584" cy="1243584"/>
            </a:xfrm>
            <a:prstGeom prst="rect">
              <a:avLst/>
            </a:prstGeom>
          </p:spPr>
        </p:pic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DE4F13E8-FA90-5E44-829B-55C64C3BD9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767" t="5264" r="767" b="5264"/>
            <a:stretch/>
          </p:blipFill>
          <p:spPr>
            <a:xfrm>
              <a:off x="1080685" y="7071978"/>
              <a:ext cx="1243584" cy="1243584"/>
            </a:xfrm>
            <a:prstGeom prst="rect">
              <a:avLst/>
            </a:prstGeom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A9EA0072-C7B0-F341-9C56-9CFF6AE958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767" t="5263" r="767" b="5263"/>
            <a:stretch/>
          </p:blipFill>
          <p:spPr>
            <a:xfrm>
              <a:off x="2894579" y="2009230"/>
              <a:ext cx="1243584" cy="1243584"/>
            </a:xfrm>
            <a:prstGeom prst="rect">
              <a:avLst/>
            </a:prstGeom>
          </p:spPr>
        </p:pic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5FDEAA58-144E-7E43-94C8-E5D327B109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767" t="5263" r="767" b="5263"/>
            <a:stretch/>
          </p:blipFill>
          <p:spPr>
            <a:xfrm>
              <a:off x="2888513" y="3278243"/>
              <a:ext cx="1243584" cy="1243584"/>
            </a:xfrm>
            <a:prstGeom prst="rect">
              <a:avLst/>
            </a:prstGeom>
          </p:spPr>
        </p:pic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5E788D42-A2C4-D546-92D2-42486BB2C0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767" t="5263" r="767" b="5263"/>
            <a:stretch/>
          </p:blipFill>
          <p:spPr>
            <a:xfrm>
              <a:off x="2899781" y="4525869"/>
              <a:ext cx="1243584" cy="1243584"/>
            </a:xfrm>
            <a:prstGeom prst="rect">
              <a:avLst/>
            </a:prstGeom>
          </p:spPr>
        </p:pic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C018E525-0524-1943-848F-4CC6BB4ADF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767" t="5263" r="767" b="5263"/>
            <a:stretch/>
          </p:blipFill>
          <p:spPr>
            <a:xfrm>
              <a:off x="2884447" y="5800480"/>
              <a:ext cx="1243584" cy="1243584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F31B81FD-13A0-804B-8EAF-DFB6555207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767" t="5263" r="767" b="5263"/>
            <a:stretch/>
          </p:blipFill>
          <p:spPr>
            <a:xfrm>
              <a:off x="2874108" y="7068087"/>
              <a:ext cx="1243584" cy="1243584"/>
            </a:xfrm>
            <a:prstGeom prst="rect">
              <a:avLst/>
            </a:prstGeom>
          </p:spPr>
        </p:pic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85758ED7-179F-D34D-AC84-D340A3B19340}"/>
                </a:ext>
              </a:extLst>
            </p:cNvPr>
            <p:cNvGrpSpPr/>
            <p:nvPr/>
          </p:nvGrpSpPr>
          <p:grpSpPr>
            <a:xfrm>
              <a:off x="2297973" y="1131685"/>
              <a:ext cx="541632" cy="6682637"/>
              <a:chOff x="604159" y="1049872"/>
              <a:chExt cx="509110" cy="6682637"/>
            </a:xfrm>
          </p:grpSpPr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C4F48574-5B08-3245-9ADE-2C21CEFC31E4}"/>
                  </a:ext>
                </a:extLst>
              </p:cNvPr>
              <p:cNvSpPr txBox="1"/>
              <p:nvPr/>
            </p:nvSpPr>
            <p:spPr>
              <a:xfrm rot="5400000">
                <a:off x="728000" y="2266498"/>
                <a:ext cx="292388" cy="47815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2hr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DC9B6FC2-76F9-9A4D-9658-385686304F65}"/>
                  </a:ext>
                </a:extLst>
              </p:cNvPr>
              <p:cNvSpPr txBox="1"/>
              <p:nvPr/>
            </p:nvSpPr>
            <p:spPr>
              <a:xfrm rot="5400000">
                <a:off x="698892" y="3545164"/>
                <a:ext cx="292388" cy="47815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4hr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BFCD2AAD-A335-EB4A-A313-C242CA8F467D}"/>
                  </a:ext>
                </a:extLst>
              </p:cNvPr>
              <p:cNvSpPr txBox="1"/>
              <p:nvPr/>
            </p:nvSpPr>
            <p:spPr>
              <a:xfrm rot="5400000">
                <a:off x="714025" y="4815425"/>
                <a:ext cx="292388" cy="47815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6hr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30283875-A937-AC40-8079-D37A3C976280}"/>
                  </a:ext>
                </a:extLst>
              </p:cNvPr>
              <p:cNvSpPr txBox="1"/>
              <p:nvPr/>
            </p:nvSpPr>
            <p:spPr>
              <a:xfrm rot="5400000">
                <a:off x="697040" y="6047500"/>
                <a:ext cx="292388" cy="47815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8hr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5BEB9EB0-79C2-C54E-B71F-F519C9569CB8}"/>
                  </a:ext>
                </a:extLst>
              </p:cNvPr>
              <p:cNvSpPr txBox="1"/>
              <p:nvPr/>
            </p:nvSpPr>
            <p:spPr>
              <a:xfrm rot="5400000">
                <a:off x="720452" y="7347240"/>
                <a:ext cx="292388" cy="47815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24hr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1C7C5084-2B78-8142-9223-444419A064B0}"/>
                  </a:ext>
                </a:extLst>
              </p:cNvPr>
              <p:cNvSpPr txBox="1"/>
              <p:nvPr/>
            </p:nvSpPr>
            <p:spPr>
              <a:xfrm rot="5400000">
                <a:off x="714025" y="956991"/>
                <a:ext cx="292388" cy="47815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0hr</a:t>
                </a:r>
              </a:p>
            </p:txBody>
          </p:sp>
        </p:grp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51F54C20-E8DC-D04F-BBA3-37DC2057E256}"/>
              </a:ext>
            </a:extLst>
          </p:cNvPr>
          <p:cNvSpPr/>
          <p:nvPr/>
        </p:nvSpPr>
        <p:spPr>
          <a:xfrm>
            <a:off x="3581498" y="80626"/>
            <a:ext cx="190789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3 </a:t>
            </a:r>
            <a:endParaRPr lang="en-US" sz="3200" b="1" dirty="0"/>
          </a:p>
        </p:txBody>
      </p:sp>
    </p:spTree>
    <p:extLst>
      <p:ext uri="{BB962C8B-B14F-4D97-AF65-F5344CB8AC3E}">
        <p14:creationId xmlns:p14="http://schemas.microsoft.com/office/powerpoint/2010/main" val="1043719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4</TotalTime>
  <Words>37</Words>
  <Application>Microsoft Macintosh PowerPoint</Application>
  <PresentationFormat>Letter Paper (8.5x11 in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MC</dc:creator>
  <cp:lastModifiedBy>Wencai Zhang</cp:lastModifiedBy>
  <cp:revision>1</cp:revision>
  <cp:lastPrinted>2022-05-26T23:23:28Z</cp:lastPrinted>
  <dcterms:created xsi:type="dcterms:W3CDTF">2016-03-04T20:57:06Z</dcterms:created>
  <dcterms:modified xsi:type="dcterms:W3CDTF">2022-06-23T12:26:07Z</dcterms:modified>
</cp:coreProperties>
</file>